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1" r:id="rId2"/>
    <p:sldId id="262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18080"/>
    <a:srgbClr val="9840DE"/>
    <a:srgbClr val="F90703"/>
    <a:srgbClr val="DE384D"/>
    <a:srgbClr val="02FFFF"/>
    <a:srgbClr val="4D4D4D"/>
    <a:srgbClr val="155D5D"/>
    <a:srgbClr val="1D8080"/>
    <a:srgbClr val="EF3800"/>
    <a:srgbClr val="FB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621"/>
    <p:restoredTop sz="94558"/>
  </p:normalViewPr>
  <p:slideViewPr>
    <p:cSldViewPr snapToGrid="0">
      <p:cViewPr varScale="1">
        <p:scale>
          <a:sx n="83" d="100"/>
          <a:sy n="83" d="100"/>
        </p:scale>
        <p:origin x="3424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za Amini Hounejani" userId="36cb0b73-58b2-4568-a1ab-00cd49301806" providerId="ADAL" clId="{4CDAD1F4-BE7B-5D48-B15A-B140FDFA0DAB}"/>
    <pc:docChg chg="custSel delSld modSld">
      <pc:chgData name="Reza Amini Hounejani" userId="36cb0b73-58b2-4568-a1ab-00cd49301806" providerId="ADAL" clId="{4CDAD1F4-BE7B-5D48-B15A-B140FDFA0DAB}" dt="2023-08-02T15:28:23.394" v="5" actId="478"/>
      <pc:docMkLst>
        <pc:docMk/>
      </pc:docMkLst>
      <pc:sldChg chg="del">
        <pc:chgData name="Reza Amini Hounejani" userId="36cb0b73-58b2-4568-a1ab-00cd49301806" providerId="ADAL" clId="{4CDAD1F4-BE7B-5D48-B15A-B140FDFA0DAB}" dt="2023-08-02T15:28:17.968" v="0" actId="2696"/>
        <pc:sldMkLst>
          <pc:docMk/>
          <pc:sldMk cId="1897538530" sldId="256"/>
        </pc:sldMkLst>
      </pc:sldChg>
      <pc:sldChg chg="del">
        <pc:chgData name="Reza Amini Hounejani" userId="36cb0b73-58b2-4568-a1ab-00cd49301806" providerId="ADAL" clId="{4CDAD1F4-BE7B-5D48-B15A-B140FDFA0DAB}" dt="2023-08-02T15:28:18.021" v="3" actId="2696"/>
        <pc:sldMkLst>
          <pc:docMk/>
          <pc:sldMk cId="3807795133" sldId="257"/>
        </pc:sldMkLst>
      </pc:sldChg>
      <pc:sldChg chg="del">
        <pc:chgData name="Reza Amini Hounejani" userId="36cb0b73-58b2-4568-a1ab-00cd49301806" providerId="ADAL" clId="{4CDAD1F4-BE7B-5D48-B15A-B140FDFA0DAB}" dt="2023-08-02T15:28:18.049" v="4" actId="2696"/>
        <pc:sldMkLst>
          <pc:docMk/>
          <pc:sldMk cId="2229082649" sldId="258"/>
        </pc:sldMkLst>
      </pc:sldChg>
      <pc:sldChg chg="del">
        <pc:chgData name="Reza Amini Hounejani" userId="36cb0b73-58b2-4568-a1ab-00cd49301806" providerId="ADAL" clId="{4CDAD1F4-BE7B-5D48-B15A-B140FDFA0DAB}" dt="2023-08-02T15:28:17.971" v="1" actId="2696"/>
        <pc:sldMkLst>
          <pc:docMk/>
          <pc:sldMk cId="715266389" sldId="259"/>
        </pc:sldMkLst>
      </pc:sldChg>
      <pc:sldChg chg="del">
        <pc:chgData name="Reza Amini Hounejani" userId="36cb0b73-58b2-4568-a1ab-00cd49301806" providerId="ADAL" clId="{4CDAD1F4-BE7B-5D48-B15A-B140FDFA0DAB}" dt="2023-08-02T15:28:17.978" v="2" actId="2696"/>
        <pc:sldMkLst>
          <pc:docMk/>
          <pc:sldMk cId="1578300178" sldId="260"/>
        </pc:sldMkLst>
      </pc:sldChg>
      <pc:sldChg chg="delSp mod">
        <pc:chgData name="Reza Amini Hounejani" userId="36cb0b73-58b2-4568-a1ab-00cd49301806" providerId="ADAL" clId="{4CDAD1F4-BE7B-5D48-B15A-B140FDFA0DAB}" dt="2023-08-02T15:28:23.394" v="5" actId="478"/>
        <pc:sldMkLst>
          <pc:docMk/>
          <pc:sldMk cId="1450487343" sldId="262"/>
        </pc:sldMkLst>
        <pc:grpChg chg="del">
          <ac:chgData name="Reza Amini Hounejani" userId="36cb0b73-58b2-4568-a1ab-00cd49301806" providerId="ADAL" clId="{4CDAD1F4-BE7B-5D48-B15A-B140FDFA0DAB}" dt="2023-08-02T15:28:23.394" v="5" actId="478"/>
          <ac:grpSpMkLst>
            <pc:docMk/>
            <pc:sldMk cId="1450487343" sldId="262"/>
            <ac:grpSpMk id="3" creationId="{628D7D5E-16C9-C466-0D18-502C2DAE3E9D}"/>
          </ac:grpSpMkLst>
        </pc:grpChg>
        <pc:grpChg chg="del">
          <ac:chgData name="Reza Amini Hounejani" userId="36cb0b73-58b2-4568-a1ab-00cd49301806" providerId="ADAL" clId="{4CDAD1F4-BE7B-5D48-B15A-B140FDFA0DAB}" dt="2023-08-02T15:28:23.394" v="5" actId="478"/>
          <ac:grpSpMkLst>
            <pc:docMk/>
            <pc:sldMk cId="1450487343" sldId="262"/>
            <ac:grpSpMk id="8" creationId="{163D0713-8990-3428-917B-E5DEEEDFC0E5}"/>
          </ac:grpSpMkLst>
        </pc:grpChg>
      </pc:sldChg>
    </pc:docChg>
  </pc:docChgLst>
  <pc:docChgLst>
    <pc:chgData name="Reza Amini Hounejani" userId="36cb0b73-58b2-4568-a1ab-00cd49301806" providerId="ADAL" clId="{84A10D71-B01E-9142-B24E-0E68A42C5837}"/>
    <pc:docChg chg="undo redo custSel modSld">
      <pc:chgData name="Reza Amini Hounejani" userId="36cb0b73-58b2-4568-a1ab-00cd49301806" providerId="ADAL" clId="{84A10D71-B01E-9142-B24E-0E68A42C5837}" dt="2023-02-05T11:38:40.625" v="1160" actId="1035"/>
      <pc:docMkLst>
        <pc:docMk/>
      </pc:docMkLst>
      <pc:sldChg chg="modSp mod">
        <pc:chgData name="Reza Amini Hounejani" userId="36cb0b73-58b2-4568-a1ab-00cd49301806" providerId="ADAL" clId="{84A10D71-B01E-9142-B24E-0E68A42C5837}" dt="2023-01-23T14:25:49.123" v="1050" actId="20577"/>
        <pc:sldMkLst>
          <pc:docMk/>
          <pc:sldMk cId="1897538530" sldId="256"/>
        </pc:sldMkLst>
        <pc:spChg chg="mod">
          <ac:chgData name="Reza Amini Hounejani" userId="36cb0b73-58b2-4568-a1ab-00cd49301806" providerId="ADAL" clId="{84A10D71-B01E-9142-B24E-0E68A42C5837}" dt="2023-01-23T14:25:49.123" v="1050" actId="20577"/>
          <ac:spMkLst>
            <pc:docMk/>
            <pc:sldMk cId="1897538530" sldId="256"/>
            <ac:spMk id="98" creationId="{0E3A8FA3-C11D-4C61-3AFB-B69205167F17}"/>
          </ac:spMkLst>
        </pc:spChg>
      </pc:sldChg>
      <pc:sldChg chg="modSp mod">
        <pc:chgData name="Reza Amini Hounejani" userId="36cb0b73-58b2-4568-a1ab-00cd49301806" providerId="ADAL" clId="{84A10D71-B01E-9142-B24E-0E68A42C5837}" dt="2023-01-23T14:25:42.649" v="1048" actId="20577"/>
        <pc:sldMkLst>
          <pc:docMk/>
          <pc:sldMk cId="3807795133" sldId="257"/>
        </pc:sldMkLst>
        <pc:spChg chg="mod">
          <ac:chgData name="Reza Amini Hounejani" userId="36cb0b73-58b2-4568-a1ab-00cd49301806" providerId="ADAL" clId="{84A10D71-B01E-9142-B24E-0E68A42C5837}" dt="2023-01-23T14:25:42.649" v="1048" actId="20577"/>
          <ac:spMkLst>
            <pc:docMk/>
            <pc:sldMk cId="3807795133" sldId="257"/>
            <ac:spMk id="102" creationId="{EEF5620F-420D-5557-1117-0DD3EC425541}"/>
          </ac:spMkLst>
        </pc:spChg>
      </pc:sldChg>
      <pc:sldChg chg="addSp modSp mod">
        <pc:chgData name="Reza Amini Hounejani" userId="36cb0b73-58b2-4568-a1ab-00cd49301806" providerId="ADAL" clId="{84A10D71-B01E-9142-B24E-0E68A42C5837}" dt="2023-01-23T16:01:07.734" v="1078" actId="1076"/>
        <pc:sldMkLst>
          <pc:docMk/>
          <pc:sldMk cId="2229082649" sldId="258"/>
        </pc:sldMkLst>
        <pc:spChg chg="add mod">
          <ac:chgData name="Reza Amini Hounejani" userId="36cb0b73-58b2-4568-a1ab-00cd49301806" providerId="ADAL" clId="{84A10D71-B01E-9142-B24E-0E68A42C5837}" dt="2023-01-23T16:01:07.734" v="1078" actId="1076"/>
          <ac:spMkLst>
            <pc:docMk/>
            <pc:sldMk cId="2229082649" sldId="258"/>
            <ac:spMk id="10" creationId="{C3DE65BE-E6F4-73DD-79EB-3D6807DF9826}"/>
          </ac:spMkLst>
        </pc:spChg>
        <pc:spChg chg="mod">
          <ac:chgData name="Reza Amini Hounejani" userId="36cb0b73-58b2-4568-a1ab-00cd49301806" providerId="ADAL" clId="{84A10D71-B01E-9142-B24E-0E68A42C5837}" dt="2023-01-23T15:59:43.575" v="1055" actId="571"/>
          <ac:spMkLst>
            <pc:docMk/>
            <pc:sldMk cId="2229082649" sldId="258"/>
            <ac:spMk id="54" creationId="{9919C0D0-E2C5-3060-5726-F5F04F0ACCAB}"/>
          </ac:spMkLst>
        </pc:spChg>
        <pc:spChg chg="mod">
          <ac:chgData name="Reza Amini Hounejani" userId="36cb0b73-58b2-4568-a1ab-00cd49301806" providerId="ADAL" clId="{84A10D71-B01E-9142-B24E-0E68A42C5837}" dt="2023-01-23T15:59:43.575" v="1055" actId="571"/>
          <ac:spMkLst>
            <pc:docMk/>
            <pc:sldMk cId="2229082649" sldId="258"/>
            <ac:spMk id="55" creationId="{FAFE58BC-C39A-5DA0-1374-4F14A0387135}"/>
          </ac:spMkLst>
        </pc:spChg>
        <pc:spChg chg="mod">
          <ac:chgData name="Reza Amini Hounejani" userId="36cb0b73-58b2-4568-a1ab-00cd49301806" providerId="ADAL" clId="{84A10D71-B01E-9142-B24E-0E68A42C5837}" dt="2023-01-23T15:59:43.575" v="1055" actId="571"/>
          <ac:spMkLst>
            <pc:docMk/>
            <pc:sldMk cId="2229082649" sldId="258"/>
            <ac:spMk id="56" creationId="{7B98D2B4-9377-968F-C63C-AE0411BBF510}"/>
          </ac:spMkLst>
        </pc:spChg>
        <pc:spChg chg="mod">
          <ac:chgData name="Reza Amini Hounejani" userId="36cb0b73-58b2-4568-a1ab-00cd49301806" providerId="ADAL" clId="{84A10D71-B01E-9142-B24E-0E68A42C5837}" dt="2023-01-23T15:59:43.575" v="1055" actId="571"/>
          <ac:spMkLst>
            <pc:docMk/>
            <pc:sldMk cId="2229082649" sldId="258"/>
            <ac:spMk id="57" creationId="{2269DAF7-94EA-327C-B605-F56AAA3284B6}"/>
          </ac:spMkLst>
        </pc:spChg>
        <pc:spChg chg="mod">
          <ac:chgData name="Reza Amini Hounejani" userId="36cb0b73-58b2-4568-a1ab-00cd49301806" providerId="ADAL" clId="{84A10D71-B01E-9142-B24E-0E68A42C5837}" dt="2023-01-23T15:59:43.575" v="1055" actId="571"/>
          <ac:spMkLst>
            <pc:docMk/>
            <pc:sldMk cId="2229082649" sldId="258"/>
            <ac:spMk id="60" creationId="{9C219929-4D65-F593-1B05-D3556347280A}"/>
          </ac:spMkLst>
        </pc:spChg>
        <pc:spChg chg="mod">
          <ac:chgData name="Reza Amini Hounejani" userId="36cb0b73-58b2-4568-a1ab-00cd49301806" providerId="ADAL" clId="{84A10D71-B01E-9142-B24E-0E68A42C5837}" dt="2023-01-23T15:59:43.575" v="1055" actId="571"/>
          <ac:spMkLst>
            <pc:docMk/>
            <pc:sldMk cId="2229082649" sldId="258"/>
            <ac:spMk id="62" creationId="{AAE03A7D-EA6E-15C9-A5B2-206E8E452AC3}"/>
          </ac:spMkLst>
        </pc:spChg>
        <pc:spChg chg="mod">
          <ac:chgData name="Reza Amini Hounejani" userId="36cb0b73-58b2-4568-a1ab-00cd49301806" providerId="ADAL" clId="{84A10D71-B01E-9142-B24E-0E68A42C5837}" dt="2023-01-23T15:59:43.575" v="1055" actId="571"/>
          <ac:spMkLst>
            <pc:docMk/>
            <pc:sldMk cId="2229082649" sldId="258"/>
            <ac:spMk id="63" creationId="{34553138-D708-D026-DA0F-689C20F32BCE}"/>
          </ac:spMkLst>
        </pc:spChg>
        <pc:spChg chg="mod">
          <ac:chgData name="Reza Amini Hounejani" userId="36cb0b73-58b2-4568-a1ab-00cd49301806" providerId="ADAL" clId="{84A10D71-B01E-9142-B24E-0E68A42C5837}" dt="2023-01-23T15:59:43.575" v="1055" actId="571"/>
          <ac:spMkLst>
            <pc:docMk/>
            <pc:sldMk cId="2229082649" sldId="258"/>
            <ac:spMk id="64" creationId="{78087EF0-8905-E0E1-72FF-D905E48EB186}"/>
          </ac:spMkLst>
        </pc:spChg>
        <pc:spChg chg="mod">
          <ac:chgData name="Reza Amini Hounejani" userId="36cb0b73-58b2-4568-a1ab-00cd49301806" providerId="ADAL" clId="{84A10D71-B01E-9142-B24E-0E68A42C5837}" dt="2023-01-23T15:59:43.575" v="1055" actId="571"/>
          <ac:spMkLst>
            <pc:docMk/>
            <pc:sldMk cId="2229082649" sldId="258"/>
            <ac:spMk id="65" creationId="{C5F06705-FD20-BBA0-CCFD-52840C228F27}"/>
          </ac:spMkLst>
        </pc:spChg>
        <pc:spChg chg="mod">
          <ac:chgData name="Reza Amini Hounejani" userId="36cb0b73-58b2-4568-a1ab-00cd49301806" providerId="ADAL" clId="{84A10D71-B01E-9142-B24E-0E68A42C5837}" dt="2023-01-23T15:59:43.575" v="1055" actId="571"/>
          <ac:spMkLst>
            <pc:docMk/>
            <pc:sldMk cId="2229082649" sldId="258"/>
            <ac:spMk id="66" creationId="{EFB86822-C26A-0562-0AA8-4064C6079857}"/>
          </ac:spMkLst>
        </pc:spChg>
        <pc:spChg chg="mod">
          <ac:chgData name="Reza Amini Hounejani" userId="36cb0b73-58b2-4568-a1ab-00cd49301806" providerId="ADAL" clId="{84A10D71-B01E-9142-B24E-0E68A42C5837}" dt="2023-01-23T15:59:40.206" v="1054" actId="1076"/>
          <ac:spMkLst>
            <pc:docMk/>
            <pc:sldMk cId="2229082649" sldId="258"/>
            <ac:spMk id="76" creationId="{6672E647-3019-68F5-991A-F0760513A02F}"/>
          </ac:spMkLst>
        </pc:spChg>
        <pc:spChg chg="mod">
          <ac:chgData name="Reza Amini Hounejani" userId="36cb0b73-58b2-4568-a1ab-00cd49301806" providerId="ADAL" clId="{84A10D71-B01E-9142-B24E-0E68A42C5837}" dt="2023-01-23T15:59:43.575" v="1055" actId="571"/>
          <ac:spMkLst>
            <pc:docMk/>
            <pc:sldMk cId="2229082649" sldId="258"/>
            <ac:spMk id="78" creationId="{5A7B63D4-8CFE-760B-2D71-8C7ECCBFC419}"/>
          </ac:spMkLst>
        </pc:spChg>
        <pc:spChg chg="mod">
          <ac:chgData name="Reza Amini Hounejani" userId="36cb0b73-58b2-4568-a1ab-00cd49301806" providerId="ADAL" clId="{84A10D71-B01E-9142-B24E-0E68A42C5837}" dt="2023-01-18T10:12:54.713" v="1017" actId="692"/>
          <ac:spMkLst>
            <pc:docMk/>
            <pc:sldMk cId="2229082649" sldId="258"/>
            <ac:spMk id="256" creationId="{D07CB2C9-AE57-3B51-C03B-8EE661D6038D}"/>
          </ac:spMkLst>
        </pc:spChg>
        <pc:spChg chg="mod">
          <ac:chgData name="Reza Amini Hounejani" userId="36cb0b73-58b2-4568-a1ab-00cd49301806" providerId="ADAL" clId="{84A10D71-B01E-9142-B24E-0E68A42C5837}" dt="2023-01-18T10:13:03.197" v="1018" actId="692"/>
          <ac:spMkLst>
            <pc:docMk/>
            <pc:sldMk cId="2229082649" sldId="258"/>
            <ac:spMk id="257" creationId="{FDE4D47C-E573-7138-D832-E6DCBF591473}"/>
          </ac:spMkLst>
        </pc:spChg>
        <pc:grpChg chg="mod">
          <ac:chgData name="Reza Amini Hounejani" userId="36cb0b73-58b2-4568-a1ab-00cd49301806" providerId="ADAL" clId="{84A10D71-B01E-9142-B24E-0E68A42C5837}" dt="2023-01-23T15:59:43.575" v="1055" actId="571"/>
          <ac:grpSpMkLst>
            <pc:docMk/>
            <pc:sldMk cId="2229082649" sldId="258"/>
            <ac:grpSpMk id="61" creationId="{80ABC437-3F84-67B2-F481-36009DC6AB49}"/>
          </ac:grpSpMkLst>
        </pc:grpChg>
        <pc:grpChg chg="mod">
          <ac:chgData name="Reza Amini Hounejani" userId="36cb0b73-58b2-4568-a1ab-00cd49301806" providerId="ADAL" clId="{84A10D71-B01E-9142-B24E-0E68A42C5837}" dt="2023-01-23T15:59:43.575" v="1055" actId="571"/>
          <ac:grpSpMkLst>
            <pc:docMk/>
            <pc:sldMk cId="2229082649" sldId="258"/>
            <ac:grpSpMk id="69" creationId="{1894084B-402F-55D0-DDA6-5D566BE56643}"/>
          </ac:grpSpMkLst>
        </pc:grpChg>
        <pc:grpChg chg="mod">
          <ac:chgData name="Reza Amini Hounejani" userId="36cb0b73-58b2-4568-a1ab-00cd49301806" providerId="ADAL" clId="{84A10D71-B01E-9142-B24E-0E68A42C5837}" dt="2023-01-23T15:59:43.575" v="1055" actId="571"/>
          <ac:grpSpMkLst>
            <pc:docMk/>
            <pc:sldMk cId="2229082649" sldId="258"/>
            <ac:grpSpMk id="75" creationId="{614A958B-5100-BCF9-B2B5-20998DE375FA}"/>
          </ac:grpSpMkLst>
        </pc:grpChg>
        <pc:grpChg chg="mod">
          <ac:chgData name="Reza Amini Hounejani" userId="36cb0b73-58b2-4568-a1ab-00cd49301806" providerId="ADAL" clId="{84A10D71-B01E-9142-B24E-0E68A42C5837}" dt="2023-01-23T15:59:43.575" v="1055" actId="571"/>
          <ac:grpSpMkLst>
            <pc:docMk/>
            <pc:sldMk cId="2229082649" sldId="258"/>
            <ac:grpSpMk id="157" creationId="{6B267AA3-410C-C08A-A4EC-478C88398CB0}"/>
          </ac:grpSpMkLst>
        </pc:grpChg>
        <pc:picChg chg="mod">
          <ac:chgData name="Reza Amini Hounejani" userId="36cb0b73-58b2-4568-a1ab-00cd49301806" providerId="ADAL" clId="{84A10D71-B01E-9142-B24E-0E68A42C5837}" dt="2023-01-23T15:59:43.575" v="1055" actId="571"/>
          <ac:picMkLst>
            <pc:docMk/>
            <pc:sldMk cId="2229082649" sldId="258"/>
            <ac:picMk id="73" creationId="{78D55AEA-3908-7A79-83DF-C8801F893D95}"/>
          </ac:picMkLst>
        </pc:picChg>
      </pc:sldChg>
      <pc:sldChg chg="addSp delSp modSp mod">
        <pc:chgData name="Reza Amini Hounejani" userId="36cb0b73-58b2-4568-a1ab-00cd49301806" providerId="ADAL" clId="{84A10D71-B01E-9142-B24E-0E68A42C5837}" dt="2023-02-05T11:38:40.625" v="1160" actId="1035"/>
        <pc:sldMkLst>
          <pc:docMk/>
          <pc:sldMk cId="715266389" sldId="259"/>
        </pc:sldMkLst>
        <pc:spChg chg="mod">
          <ac:chgData name="Reza Amini Hounejani" userId="36cb0b73-58b2-4568-a1ab-00cd49301806" providerId="ADAL" clId="{84A10D71-B01E-9142-B24E-0E68A42C5837}" dt="2023-01-12T12:07:31.358" v="78" actId="1076"/>
          <ac:spMkLst>
            <pc:docMk/>
            <pc:sldMk cId="715266389" sldId="259"/>
            <ac:spMk id="10" creationId="{13A089A5-562F-2C06-E2EC-BB73E2FCC13F}"/>
          </ac:spMkLst>
        </pc:spChg>
        <pc:spChg chg="del">
          <ac:chgData name="Reza Amini Hounejani" userId="36cb0b73-58b2-4568-a1ab-00cd49301806" providerId="ADAL" clId="{84A10D71-B01E-9142-B24E-0E68A42C5837}" dt="2023-02-05T11:36:06.744" v="1110" actId="478"/>
          <ac:spMkLst>
            <pc:docMk/>
            <pc:sldMk cId="715266389" sldId="259"/>
            <ac:spMk id="24" creationId="{C5F50F07-857A-7EB6-54D9-EE6CB76762DF}"/>
          </ac:spMkLst>
        </pc:spChg>
        <pc:spChg chg="add mod">
          <ac:chgData name="Reza Amini Hounejani" userId="36cb0b73-58b2-4568-a1ab-00cd49301806" providerId="ADAL" clId="{84A10D71-B01E-9142-B24E-0E68A42C5837}" dt="2023-02-05T11:36:23.395" v="1118" actId="1076"/>
          <ac:spMkLst>
            <pc:docMk/>
            <pc:sldMk cId="715266389" sldId="259"/>
            <ac:spMk id="26" creationId="{15FE9C99-0FBC-7449-4918-BD0044802123}"/>
          </ac:spMkLst>
        </pc:spChg>
        <pc:spChg chg="mod">
          <ac:chgData name="Reza Amini Hounejani" userId="36cb0b73-58b2-4568-a1ab-00cd49301806" providerId="ADAL" clId="{84A10D71-B01E-9142-B24E-0E68A42C5837}" dt="2023-01-12T11:36:31.219" v="55" actId="1076"/>
          <ac:spMkLst>
            <pc:docMk/>
            <pc:sldMk cId="715266389" sldId="259"/>
            <ac:spMk id="28" creationId="{083BE831-2F7D-31DE-09EE-CB56249D522A}"/>
          </ac:spMkLst>
        </pc:spChg>
        <pc:spChg chg="add mod">
          <ac:chgData name="Reza Amini Hounejani" userId="36cb0b73-58b2-4568-a1ab-00cd49301806" providerId="ADAL" clId="{84A10D71-B01E-9142-B24E-0E68A42C5837}" dt="2023-02-05T11:36:23.395" v="1118" actId="1076"/>
          <ac:spMkLst>
            <pc:docMk/>
            <pc:sldMk cId="715266389" sldId="259"/>
            <ac:spMk id="29" creationId="{6D4DC85E-5DE0-05B5-3EC3-999B62619B4E}"/>
          </ac:spMkLst>
        </pc:spChg>
        <pc:spChg chg="del mod">
          <ac:chgData name="Reza Amini Hounejani" userId="36cb0b73-58b2-4568-a1ab-00cd49301806" providerId="ADAL" clId="{84A10D71-B01E-9142-B24E-0E68A42C5837}" dt="2023-02-05T11:36:15.530" v="1116" actId="478"/>
          <ac:spMkLst>
            <pc:docMk/>
            <pc:sldMk cId="715266389" sldId="259"/>
            <ac:spMk id="31" creationId="{63A079C3-D6EF-82FA-76FA-AB8F24882CB2}"/>
          </ac:spMkLst>
        </pc:spChg>
        <pc:spChg chg="add mod">
          <ac:chgData name="Reza Amini Hounejani" userId="36cb0b73-58b2-4568-a1ab-00cd49301806" providerId="ADAL" clId="{84A10D71-B01E-9142-B24E-0E68A42C5837}" dt="2023-02-05T11:38:30.330" v="1157" actId="688"/>
          <ac:spMkLst>
            <pc:docMk/>
            <pc:sldMk cId="715266389" sldId="259"/>
            <ac:spMk id="34" creationId="{9EFD263D-64BB-C14D-2C51-346FA3BFA82B}"/>
          </ac:spMkLst>
        </pc:spChg>
        <pc:spChg chg="mod">
          <ac:chgData name="Reza Amini Hounejani" userId="36cb0b73-58b2-4568-a1ab-00cd49301806" providerId="ADAL" clId="{84A10D71-B01E-9142-B24E-0E68A42C5837}" dt="2023-01-13T15:32:01.045" v="156" actId="553"/>
          <ac:spMkLst>
            <pc:docMk/>
            <pc:sldMk cId="715266389" sldId="259"/>
            <ac:spMk id="81" creationId="{3D920564-D991-4FC5-BC05-553DAC8B2481}"/>
          </ac:spMkLst>
        </pc:spChg>
        <pc:spChg chg="del mod">
          <ac:chgData name="Reza Amini Hounejani" userId="36cb0b73-58b2-4568-a1ab-00cd49301806" providerId="ADAL" clId="{84A10D71-B01E-9142-B24E-0E68A42C5837}" dt="2023-02-05T11:38:14.096" v="1153" actId="478"/>
          <ac:spMkLst>
            <pc:docMk/>
            <pc:sldMk cId="715266389" sldId="259"/>
            <ac:spMk id="104" creationId="{5AD89DE3-2F7C-15CB-EECC-BD02AC83FD0F}"/>
          </ac:spMkLst>
        </pc:spChg>
        <pc:spChg chg="mod">
          <ac:chgData name="Reza Amini Hounejani" userId="36cb0b73-58b2-4568-a1ab-00cd49301806" providerId="ADAL" clId="{84A10D71-B01E-9142-B24E-0E68A42C5837}" dt="2023-01-13T09:42:46.689" v="93" actId="1076"/>
          <ac:spMkLst>
            <pc:docMk/>
            <pc:sldMk cId="715266389" sldId="259"/>
            <ac:spMk id="108" creationId="{731751E8-2999-1830-A31F-7F4F1ACDD594}"/>
          </ac:spMkLst>
        </pc:spChg>
        <pc:spChg chg="mod">
          <ac:chgData name="Reza Amini Hounejani" userId="36cb0b73-58b2-4568-a1ab-00cd49301806" providerId="ADAL" clId="{84A10D71-B01E-9142-B24E-0E68A42C5837}" dt="2023-02-05T11:36:29.122" v="1119" actId="1076"/>
          <ac:spMkLst>
            <pc:docMk/>
            <pc:sldMk cId="715266389" sldId="259"/>
            <ac:spMk id="109" creationId="{08B8EFC7-4744-F512-BCE7-A531F2E322C7}"/>
          </ac:spMkLst>
        </pc:spChg>
        <pc:spChg chg="mod">
          <ac:chgData name="Reza Amini Hounejani" userId="36cb0b73-58b2-4568-a1ab-00cd49301806" providerId="ADAL" clId="{84A10D71-B01E-9142-B24E-0E68A42C5837}" dt="2023-01-13T14:37:23.270" v="138" actId="20577"/>
          <ac:spMkLst>
            <pc:docMk/>
            <pc:sldMk cId="715266389" sldId="259"/>
            <ac:spMk id="114" creationId="{AC2AA66A-280F-6B5A-0EF3-777EEE4774D9}"/>
          </ac:spMkLst>
        </pc:spChg>
        <pc:spChg chg="mod">
          <ac:chgData name="Reza Amini Hounejani" userId="36cb0b73-58b2-4568-a1ab-00cd49301806" providerId="ADAL" clId="{84A10D71-B01E-9142-B24E-0E68A42C5837}" dt="2023-01-19T12:28:30.932" v="1039" actId="1036"/>
          <ac:spMkLst>
            <pc:docMk/>
            <pc:sldMk cId="715266389" sldId="259"/>
            <ac:spMk id="120" creationId="{46C07D9E-C45E-5FBC-D7F8-00D7AD2048C4}"/>
          </ac:spMkLst>
        </pc:spChg>
        <pc:spChg chg="mod">
          <ac:chgData name="Reza Amini Hounejani" userId="36cb0b73-58b2-4568-a1ab-00cd49301806" providerId="ADAL" clId="{84A10D71-B01E-9142-B24E-0E68A42C5837}" dt="2023-01-19T12:28:40.617" v="1045" actId="1036"/>
          <ac:spMkLst>
            <pc:docMk/>
            <pc:sldMk cId="715266389" sldId="259"/>
            <ac:spMk id="135" creationId="{61F9FB0F-21C1-394B-D249-42630D480F92}"/>
          </ac:spMkLst>
        </pc:spChg>
        <pc:spChg chg="mod">
          <ac:chgData name="Reza Amini Hounejani" userId="36cb0b73-58b2-4568-a1ab-00cd49301806" providerId="ADAL" clId="{84A10D71-B01E-9142-B24E-0E68A42C5837}" dt="2023-01-24T12:50:46.051" v="1108" actId="1036"/>
          <ac:spMkLst>
            <pc:docMk/>
            <pc:sldMk cId="715266389" sldId="259"/>
            <ac:spMk id="136" creationId="{4C90CE5E-5449-D741-31C7-1340B6E3BE15}"/>
          </ac:spMkLst>
        </pc:spChg>
        <pc:spChg chg="mod">
          <ac:chgData name="Reza Amini Hounejani" userId="36cb0b73-58b2-4568-a1ab-00cd49301806" providerId="ADAL" clId="{84A10D71-B01E-9142-B24E-0E68A42C5837}" dt="2023-01-24T12:50:42.823" v="1104" actId="1036"/>
          <ac:spMkLst>
            <pc:docMk/>
            <pc:sldMk cId="715266389" sldId="259"/>
            <ac:spMk id="137" creationId="{BD0E778B-C534-9FE1-1FFD-E5929002DC2B}"/>
          </ac:spMkLst>
        </pc:spChg>
        <pc:spChg chg="mod">
          <ac:chgData name="Reza Amini Hounejani" userId="36cb0b73-58b2-4568-a1ab-00cd49301806" providerId="ADAL" clId="{84A10D71-B01E-9142-B24E-0E68A42C5837}" dt="2023-01-24T12:50:39.874" v="1102" actId="1036"/>
          <ac:spMkLst>
            <pc:docMk/>
            <pc:sldMk cId="715266389" sldId="259"/>
            <ac:spMk id="138" creationId="{48D43CE3-A3D8-BF57-1D6D-ED7E5AAD7170}"/>
          </ac:spMkLst>
        </pc:spChg>
        <pc:grpChg chg="add del mod">
          <ac:chgData name="Reza Amini Hounejani" userId="36cb0b73-58b2-4568-a1ab-00cd49301806" providerId="ADAL" clId="{84A10D71-B01E-9142-B24E-0E68A42C5837}" dt="2023-01-24T12:39:14.073" v="1081" actId="478"/>
          <ac:grpSpMkLst>
            <pc:docMk/>
            <pc:sldMk cId="715266389" sldId="259"/>
            <ac:grpSpMk id="23" creationId="{92235EC8-203B-9919-0667-2779B28E5A3A}"/>
          </ac:grpSpMkLst>
        </pc:grpChg>
        <pc:grpChg chg="add mod">
          <ac:chgData name="Reza Amini Hounejani" userId="36cb0b73-58b2-4568-a1ab-00cd49301806" providerId="ADAL" clId="{84A10D71-B01E-9142-B24E-0E68A42C5837}" dt="2023-01-24T12:46:54.761" v="1098" actId="164"/>
          <ac:grpSpMkLst>
            <pc:docMk/>
            <pc:sldMk cId="715266389" sldId="259"/>
            <ac:grpSpMk id="27" creationId="{FE66B453-429E-EC9A-7E9D-BEA0A9791F74}"/>
          </ac:grpSpMkLst>
        </pc:grpChg>
        <pc:grpChg chg="mod topLvl">
          <ac:chgData name="Reza Amini Hounejani" userId="36cb0b73-58b2-4568-a1ab-00cd49301806" providerId="ADAL" clId="{84A10D71-B01E-9142-B24E-0E68A42C5837}" dt="2023-01-24T12:46:54.761" v="1098" actId="164"/>
          <ac:grpSpMkLst>
            <pc:docMk/>
            <pc:sldMk cId="715266389" sldId="259"/>
            <ac:grpSpMk id="142" creationId="{16726547-532C-DF24-68D1-1C99A80BCEA1}"/>
          </ac:grpSpMkLst>
        </pc:grpChg>
        <pc:picChg chg="add mod">
          <ac:chgData name="Reza Amini Hounejani" userId="36cb0b73-58b2-4568-a1ab-00cd49301806" providerId="ADAL" clId="{84A10D71-B01E-9142-B24E-0E68A42C5837}" dt="2023-02-05T11:36:23.395" v="1118" actId="1076"/>
          <ac:picMkLst>
            <pc:docMk/>
            <pc:sldMk cId="715266389" sldId="259"/>
            <ac:picMk id="3" creationId="{2555F2A0-B5D5-2DBC-550E-325CA588E7E8}"/>
          </ac:picMkLst>
        </pc:picChg>
        <pc:picChg chg="add del mod topLvl">
          <ac:chgData name="Reza Amini Hounejani" userId="36cb0b73-58b2-4568-a1ab-00cd49301806" providerId="ADAL" clId="{84A10D71-B01E-9142-B24E-0E68A42C5837}" dt="2023-01-24T12:39:14.073" v="1081" actId="478"/>
          <ac:picMkLst>
            <pc:docMk/>
            <pc:sldMk cId="715266389" sldId="259"/>
            <ac:picMk id="8" creationId="{4760BD29-7848-027D-0F19-0E8908F60076}"/>
          </ac:picMkLst>
        </pc:picChg>
        <pc:picChg chg="add mod">
          <ac:chgData name="Reza Amini Hounejani" userId="36cb0b73-58b2-4568-a1ab-00cd49301806" providerId="ADAL" clId="{84A10D71-B01E-9142-B24E-0E68A42C5837}" dt="2023-01-24T12:46:54.761" v="1098" actId="164"/>
          <ac:picMkLst>
            <pc:docMk/>
            <pc:sldMk cId="715266389" sldId="259"/>
            <ac:picMk id="9" creationId="{850EC570-16FD-49F7-3D0E-A4C18005067E}"/>
          </ac:picMkLst>
        </pc:picChg>
        <pc:picChg chg="del mod modCrop">
          <ac:chgData name="Reza Amini Hounejani" userId="36cb0b73-58b2-4568-a1ab-00cd49301806" providerId="ADAL" clId="{84A10D71-B01E-9142-B24E-0E68A42C5837}" dt="2023-01-13T15:28:49.635" v="139" actId="478"/>
          <ac:picMkLst>
            <pc:docMk/>
            <pc:sldMk cId="715266389" sldId="259"/>
            <ac:picMk id="9" creationId="{B23D0F72-C346-6F3D-E0AC-49B8A6BAC7E2}"/>
          </ac:picMkLst>
        </pc:picChg>
        <pc:picChg chg="del">
          <ac:chgData name="Reza Amini Hounejani" userId="36cb0b73-58b2-4568-a1ab-00cd49301806" providerId="ADAL" clId="{84A10D71-B01E-9142-B24E-0E68A42C5837}" dt="2023-02-05T11:36:05.602" v="1109" actId="478"/>
          <ac:picMkLst>
            <pc:docMk/>
            <pc:sldMk cId="715266389" sldId="259"/>
            <ac:picMk id="13" creationId="{9E6A2084-9BF0-D9CA-F3C0-9398B8CFEC57}"/>
          </ac:picMkLst>
        </pc:picChg>
        <pc:picChg chg="add mod modCrop">
          <ac:chgData name="Reza Amini Hounejani" userId="36cb0b73-58b2-4568-a1ab-00cd49301806" providerId="ADAL" clId="{84A10D71-B01E-9142-B24E-0E68A42C5837}" dt="2023-01-13T15:32:01.045" v="156" actId="553"/>
          <ac:picMkLst>
            <pc:docMk/>
            <pc:sldMk cId="715266389" sldId="259"/>
            <ac:picMk id="30" creationId="{781CAF4C-96FC-59D4-9BAE-38F61EDCD4A3}"/>
          </ac:picMkLst>
        </pc:picChg>
        <pc:picChg chg="mod">
          <ac:chgData name="Reza Amini Hounejani" userId="36cb0b73-58b2-4568-a1ab-00cd49301806" providerId="ADAL" clId="{84A10D71-B01E-9142-B24E-0E68A42C5837}" dt="2023-01-12T12:07:07.229" v="73" actId="14100"/>
          <ac:picMkLst>
            <pc:docMk/>
            <pc:sldMk cId="715266389" sldId="259"/>
            <ac:picMk id="78" creationId="{B5ABA07D-66B9-F95C-3747-9C23D97CA3A1}"/>
          </ac:picMkLst>
        </pc:picChg>
        <pc:picChg chg="mod">
          <ac:chgData name="Reza Amini Hounejani" userId="36cb0b73-58b2-4568-a1ab-00cd49301806" providerId="ADAL" clId="{84A10D71-B01E-9142-B24E-0E68A42C5837}" dt="2023-01-13T15:34:11.640" v="176" actId="1076"/>
          <ac:picMkLst>
            <pc:docMk/>
            <pc:sldMk cId="715266389" sldId="259"/>
            <ac:picMk id="79" creationId="{95A926AE-56B1-CBB6-CFF1-DCE96131D57C}"/>
          </ac:picMkLst>
        </pc:picChg>
        <pc:picChg chg="del">
          <ac:chgData name="Reza Amini Hounejani" userId="36cb0b73-58b2-4568-a1ab-00cd49301806" providerId="ADAL" clId="{84A10D71-B01E-9142-B24E-0E68A42C5837}" dt="2023-01-19T12:26:47.872" v="1021" actId="478"/>
          <ac:picMkLst>
            <pc:docMk/>
            <pc:sldMk cId="715266389" sldId="259"/>
            <ac:picMk id="100" creationId="{BACC2350-6819-BC72-1C57-71E672BF2317}"/>
          </ac:picMkLst>
        </pc:picChg>
        <pc:picChg chg="mod">
          <ac:chgData name="Reza Amini Hounejani" userId="36cb0b73-58b2-4568-a1ab-00cd49301806" providerId="ADAL" clId="{84A10D71-B01E-9142-B24E-0E68A42C5837}" dt="2023-02-05T11:36:40.216" v="1120" actId="14100"/>
          <ac:picMkLst>
            <pc:docMk/>
            <pc:sldMk cId="715266389" sldId="259"/>
            <ac:picMk id="103" creationId="{82F45378-B17D-07E7-299E-201229FC8BC0}"/>
          </ac:picMkLst>
        </pc:picChg>
        <pc:cxnChg chg="mod">
          <ac:chgData name="Reza Amini Hounejani" userId="36cb0b73-58b2-4568-a1ab-00cd49301806" providerId="ADAL" clId="{84A10D71-B01E-9142-B24E-0E68A42C5837}" dt="2023-01-13T15:32:08.220" v="157" actId="14100"/>
          <ac:cxnSpMkLst>
            <pc:docMk/>
            <pc:sldMk cId="715266389" sldId="259"/>
            <ac:cxnSpMk id="7" creationId="{AB5B0267-BC00-708C-3DCE-E56FA7E5709A}"/>
          </ac:cxnSpMkLst>
        </pc:cxnChg>
        <pc:cxnChg chg="add mod">
          <ac:chgData name="Reza Amini Hounejani" userId="36cb0b73-58b2-4568-a1ab-00cd49301806" providerId="ADAL" clId="{84A10D71-B01E-9142-B24E-0E68A42C5837}" dt="2023-02-05T11:36:23.395" v="1118" actId="1076"/>
          <ac:cxnSpMkLst>
            <pc:docMk/>
            <pc:sldMk cId="715266389" sldId="259"/>
            <ac:cxnSpMk id="8" creationId="{305B4F0B-875E-92F6-5D1A-0D84F10D5DB6}"/>
          </ac:cxnSpMkLst>
        </pc:cxnChg>
        <pc:cxnChg chg="mod">
          <ac:chgData name="Reza Amini Hounejani" userId="36cb0b73-58b2-4568-a1ab-00cd49301806" providerId="ADAL" clId="{84A10D71-B01E-9142-B24E-0E68A42C5837}" dt="2023-01-13T15:32:13.543" v="159" actId="14100"/>
          <ac:cxnSpMkLst>
            <pc:docMk/>
            <pc:sldMk cId="715266389" sldId="259"/>
            <ac:cxnSpMk id="11" creationId="{39BABF1A-BBF7-054C-6067-8AFB3695976B}"/>
          </ac:cxnSpMkLst>
        </pc:cxnChg>
        <pc:cxnChg chg="del">
          <ac:chgData name="Reza Amini Hounejani" userId="36cb0b73-58b2-4568-a1ab-00cd49301806" providerId="ADAL" clId="{84A10D71-B01E-9142-B24E-0E68A42C5837}" dt="2023-02-05T11:36:13.225" v="1114" actId="478"/>
          <ac:cxnSpMkLst>
            <pc:docMk/>
            <pc:sldMk cId="715266389" sldId="259"/>
            <ac:cxnSpMk id="19" creationId="{77A2E765-CF53-1DA8-2C8B-54B7702F803E}"/>
          </ac:cxnSpMkLst>
        </pc:cxnChg>
        <pc:cxnChg chg="del">
          <ac:chgData name="Reza Amini Hounejani" userId="36cb0b73-58b2-4568-a1ab-00cd49301806" providerId="ADAL" clId="{84A10D71-B01E-9142-B24E-0E68A42C5837}" dt="2023-02-05T11:36:07.410" v="1111" actId="478"/>
          <ac:cxnSpMkLst>
            <pc:docMk/>
            <pc:sldMk cId="715266389" sldId="259"/>
            <ac:cxnSpMk id="20" creationId="{8C9BC1CC-74AE-EA44-3A7B-3005E42EED7E}"/>
          </ac:cxnSpMkLst>
        </pc:cxnChg>
        <pc:cxnChg chg="del">
          <ac:chgData name="Reza Amini Hounejani" userId="36cb0b73-58b2-4568-a1ab-00cd49301806" providerId="ADAL" clId="{84A10D71-B01E-9142-B24E-0E68A42C5837}" dt="2023-02-05T11:36:10.866" v="1112" actId="478"/>
          <ac:cxnSpMkLst>
            <pc:docMk/>
            <pc:sldMk cId="715266389" sldId="259"/>
            <ac:cxnSpMk id="21" creationId="{5335BC14-43D9-D351-CCF9-1627D09B38C5}"/>
          </ac:cxnSpMkLst>
        </pc:cxnChg>
        <pc:cxnChg chg="add del">
          <ac:chgData name="Reza Amini Hounejani" userId="36cb0b73-58b2-4568-a1ab-00cd49301806" providerId="ADAL" clId="{84A10D71-B01E-9142-B24E-0E68A42C5837}" dt="2023-01-19T12:28:18.072" v="1038" actId="478"/>
          <ac:cxnSpMkLst>
            <pc:docMk/>
            <pc:sldMk cId="715266389" sldId="259"/>
            <ac:cxnSpMk id="22" creationId="{AE9BCCC2-C1D1-1AF1-343A-852F998845DF}"/>
          </ac:cxnSpMkLst>
        </pc:cxnChg>
        <pc:cxnChg chg="add mod">
          <ac:chgData name="Reza Amini Hounejani" userId="36cb0b73-58b2-4568-a1ab-00cd49301806" providerId="ADAL" clId="{84A10D71-B01E-9142-B24E-0E68A42C5837}" dt="2023-02-05T11:36:23.395" v="1118" actId="1076"/>
          <ac:cxnSpMkLst>
            <pc:docMk/>
            <pc:sldMk cId="715266389" sldId="259"/>
            <ac:cxnSpMk id="22" creationId="{D6DF895F-CFBB-DAFA-3584-8D78056E61F0}"/>
          </ac:cxnSpMkLst>
        </pc:cxnChg>
        <pc:cxnChg chg="add mod">
          <ac:chgData name="Reza Amini Hounejani" userId="36cb0b73-58b2-4568-a1ab-00cd49301806" providerId="ADAL" clId="{84A10D71-B01E-9142-B24E-0E68A42C5837}" dt="2023-02-05T11:36:23.395" v="1118" actId="1076"/>
          <ac:cxnSpMkLst>
            <pc:docMk/>
            <pc:sldMk cId="715266389" sldId="259"/>
            <ac:cxnSpMk id="23" creationId="{3962B015-CEDA-8B6C-EDC6-F6F84A7DEEBF}"/>
          </ac:cxnSpMkLst>
        </pc:cxnChg>
        <pc:cxnChg chg="add del">
          <ac:chgData name="Reza Amini Hounejani" userId="36cb0b73-58b2-4568-a1ab-00cd49301806" providerId="ADAL" clId="{84A10D71-B01E-9142-B24E-0E68A42C5837}" dt="2023-01-24T12:46:46.115" v="1097" actId="478"/>
          <ac:cxnSpMkLst>
            <pc:docMk/>
            <pc:sldMk cId="715266389" sldId="259"/>
            <ac:cxnSpMk id="26" creationId="{1B5BD1DE-C578-345F-B2F6-D3C86407FCCB}"/>
          </ac:cxnSpMkLst>
        </pc:cxnChg>
        <pc:cxnChg chg="add mod">
          <ac:chgData name="Reza Amini Hounejani" userId="36cb0b73-58b2-4568-a1ab-00cd49301806" providerId="ADAL" clId="{84A10D71-B01E-9142-B24E-0E68A42C5837}" dt="2023-02-05T11:36:23.395" v="1118" actId="1076"/>
          <ac:cxnSpMkLst>
            <pc:docMk/>
            <pc:sldMk cId="715266389" sldId="259"/>
            <ac:cxnSpMk id="32" creationId="{752F30BA-7121-CC29-D64B-22CC77FE4548}"/>
          </ac:cxnSpMkLst>
        </pc:cxnChg>
        <pc:cxnChg chg="del mod">
          <ac:chgData name="Reza Amini Hounejani" userId="36cb0b73-58b2-4568-a1ab-00cd49301806" providerId="ADAL" clId="{84A10D71-B01E-9142-B24E-0E68A42C5837}" dt="2023-02-05T11:36:12.239" v="1113" actId="478"/>
          <ac:cxnSpMkLst>
            <pc:docMk/>
            <pc:sldMk cId="715266389" sldId="259"/>
            <ac:cxnSpMk id="33" creationId="{23B8A696-FD47-AB74-B00D-EE81030CA530}"/>
          </ac:cxnSpMkLst>
        </pc:cxnChg>
        <pc:cxnChg chg="mod">
          <ac:chgData name="Reza Amini Hounejani" userId="36cb0b73-58b2-4568-a1ab-00cd49301806" providerId="ADAL" clId="{84A10D71-B01E-9142-B24E-0E68A42C5837}" dt="2023-02-05T11:37:06.801" v="1139" actId="1035"/>
          <ac:cxnSpMkLst>
            <pc:docMk/>
            <pc:sldMk cId="715266389" sldId="259"/>
            <ac:cxnSpMk id="105" creationId="{0499F95B-AD18-A4B3-160C-648E33ED3210}"/>
          </ac:cxnSpMkLst>
        </pc:cxnChg>
        <pc:cxnChg chg="mod">
          <ac:chgData name="Reza Amini Hounejani" userId="36cb0b73-58b2-4568-a1ab-00cd49301806" providerId="ADAL" clId="{84A10D71-B01E-9142-B24E-0E68A42C5837}" dt="2023-02-05T11:37:00.698" v="1134" actId="1035"/>
          <ac:cxnSpMkLst>
            <pc:docMk/>
            <pc:sldMk cId="715266389" sldId="259"/>
            <ac:cxnSpMk id="106" creationId="{8C8DF0E1-56F3-D4DD-78E8-94DBD4073B7F}"/>
          </ac:cxnSpMkLst>
        </pc:cxnChg>
        <pc:cxnChg chg="mod">
          <ac:chgData name="Reza Amini Hounejani" userId="36cb0b73-58b2-4568-a1ab-00cd49301806" providerId="ADAL" clId="{84A10D71-B01E-9142-B24E-0E68A42C5837}" dt="2023-02-05T11:36:56.115" v="1129" actId="1035"/>
          <ac:cxnSpMkLst>
            <pc:docMk/>
            <pc:sldMk cId="715266389" sldId="259"/>
            <ac:cxnSpMk id="107" creationId="{74A8FCA4-AE24-CB00-4CC1-9CA9B351D037}"/>
          </ac:cxnSpMkLst>
        </pc:cxnChg>
        <pc:cxnChg chg="mod">
          <ac:chgData name="Reza Amini Hounejani" userId="36cb0b73-58b2-4568-a1ab-00cd49301806" providerId="ADAL" clId="{84A10D71-B01E-9142-B24E-0E68A42C5837}" dt="2023-02-05T11:38:40.625" v="1160" actId="1035"/>
          <ac:cxnSpMkLst>
            <pc:docMk/>
            <pc:sldMk cId="715266389" sldId="259"/>
            <ac:cxnSpMk id="110" creationId="{BA30C40F-33B6-45B8-AEFF-5DB66781E79D}"/>
          </ac:cxnSpMkLst>
        </pc:cxnChg>
      </pc:sldChg>
      <pc:sldChg chg="addSp delSp modSp mod">
        <pc:chgData name="Reza Amini Hounejani" userId="36cb0b73-58b2-4568-a1ab-00cd49301806" providerId="ADAL" clId="{84A10D71-B01E-9142-B24E-0E68A42C5837}" dt="2023-01-17T12:44:26.644" v="1014" actId="478"/>
        <pc:sldMkLst>
          <pc:docMk/>
          <pc:sldMk cId="1578300178" sldId="260"/>
        </pc:sldMkLst>
        <pc:spChg chg="add mod">
          <ac:chgData name="Reza Amini Hounejani" userId="36cb0b73-58b2-4568-a1ab-00cd49301806" providerId="ADAL" clId="{84A10D71-B01E-9142-B24E-0E68A42C5837}" dt="2022-12-30T14:51:46.181" v="25" actId="1076"/>
          <ac:spMkLst>
            <pc:docMk/>
            <pc:sldMk cId="1578300178" sldId="260"/>
            <ac:spMk id="20" creationId="{5C0B04F5-AC1C-58FD-BF10-A2DFB644371F}"/>
          </ac:spMkLst>
        </pc:spChg>
        <pc:spChg chg="add mod">
          <ac:chgData name="Reza Amini Hounejani" userId="36cb0b73-58b2-4568-a1ab-00cd49301806" providerId="ADAL" clId="{84A10D71-B01E-9142-B24E-0E68A42C5837}" dt="2022-12-30T14:52:05.521" v="30" actId="1076"/>
          <ac:spMkLst>
            <pc:docMk/>
            <pc:sldMk cId="1578300178" sldId="260"/>
            <ac:spMk id="41" creationId="{C155425C-1201-8903-D87F-355B27E299BC}"/>
          </ac:spMkLst>
        </pc:spChg>
        <pc:spChg chg="add del">
          <ac:chgData name="Reza Amini Hounejani" userId="36cb0b73-58b2-4568-a1ab-00cd49301806" providerId="ADAL" clId="{84A10D71-B01E-9142-B24E-0E68A42C5837}" dt="2023-01-17T12:44:26.644" v="1014" actId="478"/>
          <ac:spMkLst>
            <pc:docMk/>
            <pc:sldMk cId="1578300178" sldId="260"/>
            <ac:spMk id="80" creationId="{0DEF2151-470A-BE79-6946-51D35C46D6F2}"/>
          </ac:spMkLst>
        </pc:spChg>
        <pc:cxnChg chg="add del">
          <ac:chgData name="Reza Amini Hounejani" userId="36cb0b73-58b2-4568-a1ab-00cd49301806" providerId="ADAL" clId="{84A10D71-B01E-9142-B24E-0E68A42C5837}" dt="2022-12-30T14:49:05.101" v="15" actId="478"/>
          <ac:cxnSpMkLst>
            <pc:docMk/>
            <pc:sldMk cId="1578300178" sldId="260"/>
            <ac:cxnSpMk id="16" creationId="{00A3CC6C-F11B-2FC3-9275-316A05E7F6DD}"/>
          </ac:cxnSpMkLst>
        </pc:cxnChg>
        <pc:cxnChg chg="add del">
          <ac:chgData name="Reza Amini Hounejani" userId="36cb0b73-58b2-4568-a1ab-00cd49301806" providerId="ADAL" clId="{84A10D71-B01E-9142-B24E-0E68A42C5837}" dt="2022-12-30T14:51:27.387" v="20" actId="478"/>
          <ac:cxnSpMkLst>
            <pc:docMk/>
            <pc:sldMk cId="1578300178" sldId="260"/>
            <ac:cxnSpMk id="23" creationId="{1C625443-3356-E632-BF8C-09E6EF3AAB31}"/>
          </ac:cxnSpMkLst>
        </pc:cxnChg>
      </pc:sldChg>
      <pc:sldChg chg="addSp delSp modSp mod">
        <pc:chgData name="Reza Amini Hounejani" userId="36cb0b73-58b2-4568-a1ab-00cd49301806" providerId="ADAL" clId="{84A10D71-B01E-9142-B24E-0E68A42C5837}" dt="2023-01-19T12:16:54.535" v="1020" actId="478"/>
        <pc:sldMkLst>
          <pc:docMk/>
          <pc:sldMk cId="269800214" sldId="261"/>
        </pc:sldMkLst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8" creationId="{4107B0A9-3BD7-3359-E9D8-CE39FA55F2C3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9" creationId="{28BBB0D4-A16B-4231-7D5D-F8FB27D4A52B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0" creationId="{A9218915-FDC9-F634-4E32-A64B61A392AD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2" creationId="{A9EAC924-BA3B-341A-8434-B18DA907D5C0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3" creationId="{556BC88D-2DF8-4F4B-33DC-15994BD950BE}"/>
          </ac:spMkLst>
        </pc:spChg>
        <pc:spChg chg="mod">
          <ac:chgData name="Reza Amini Hounejani" userId="36cb0b73-58b2-4568-a1ab-00cd49301806" providerId="ADAL" clId="{84A10D71-B01E-9142-B24E-0E68A42C5837}" dt="2023-01-17T11:06:57.332" v="881" actId="1036"/>
          <ac:spMkLst>
            <pc:docMk/>
            <pc:sldMk cId="269800214" sldId="261"/>
            <ac:spMk id="14" creationId="{6966B0C9-DD13-5D15-57D9-AF413EEE8299}"/>
          </ac:spMkLst>
        </pc:spChg>
        <pc:spChg chg="mod">
          <ac:chgData name="Reza Amini Hounejani" userId="36cb0b73-58b2-4568-a1ab-00cd49301806" providerId="ADAL" clId="{84A10D71-B01E-9142-B24E-0E68A42C5837}" dt="2023-01-17T10:39:02.089" v="677" actId="465"/>
          <ac:spMkLst>
            <pc:docMk/>
            <pc:sldMk cId="269800214" sldId="261"/>
            <ac:spMk id="15" creationId="{3759AD00-291B-3E41-D50B-AC51A150EFC2}"/>
          </ac:spMkLst>
        </pc:spChg>
        <pc:spChg chg="mod">
          <ac:chgData name="Reza Amini Hounejani" userId="36cb0b73-58b2-4568-a1ab-00cd49301806" providerId="ADAL" clId="{84A10D71-B01E-9142-B24E-0E68A42C5837}" dt="2023-01-17T10:39:02.089" v="677" actId="465"/>
          <ac:spMkLst>
            <pc:docMk/>
            <pc:sldMk cId="269800214" sldId="261"/>
            <ac:spMk id="16" creationId="{6C41E1E8-6169-945F-B897-F23B0B8ED97B}"/>
          </ac:spMkLst>
        </pc:spChg>
        <pc:spChg chg="mod">
          <ac:chgData name="Reza Amini Hounejani" userId="36cb0b73-58b2-4568-a1ab-00cd49301806" providerId="ADAL" clId="{84A10D71-B01E-9142-B24E-0E68A42C5837}" dt="2023-01-17T11:06:54.590" v="880" actId="1036"/>
          <ac:spMkLst>
            <pc:docMk/>
            <pc:sldMk cId="269800214" sldId="261"/>
            <ac:spMk id="17" creationId="{8BFF4042-363C-8DEB-E497-EB5B3E8ADDF8}"/>
          </ac:spMkLst>
        </pc:spChg>
        <pc:spChg chg="add 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21" creationId="{8FA5128A-FEE8-FF72-6037-C18517EE01C5}"/>
          </ac:spMkLst>
        </pc:spChg>
        <pc:spChg chg="add mod">
          <ac:chgData name="Reza Amini Hounejani" userId="36cb0b73-58b2-4568-a1ab-00cd49301806" providerId="ADAL" clId="{84A10D71-B01E-9142-B24E-0E68A42C5837}" dt="2023-01-17T10:39:02.089" v="677" actId="465"/>
          <ac:spMkLst>
            <pc:docMk/>
            <pc:sldMk cId="269800214" sldId="261"/>
            <ac:spMk id="23" creationId="{1BFA74D5-29E5-7580-FF3E-B3DB131A1645}"/>
          </ac:spMkLst>
        </pc:spChg>
        <pc:spChg chg="add mod">
          <ac:chgData name="Reza Amini Hounejani" userId="36cb0b73-58b2-4568-a1ab-00cd49301806" providerId="ADAL" clId="{84A10D71-B01E-9142-B24E-0E68A42C5837}" dt="2023-01-17T10:39:02.089" v="677" actId="465"/>
          <ac:spMkLst>
            <pc:docMk/>
            <pc:sldMk cId="269800214" sldId="261"/>
            <ac:spMk id="24" creationId="{F060A642-2007-4400-5240-8F3723D50B2D}"/>
          </ac:spMkLst>
        </pc:spChg>
        <pc:spChg chg="add mod">
          <ac:chgData name="Reza Amini Hounejani" userId="36cb0b73-58b2-4568-a1ab-00cd49301806" providerId="ADAL" clId="{84A10D71-B01E-9142-B24E-0E68A42C5837}" dt="2023-01-17T12:43:42.115" v="1012" actId="1038"/>
          <ac:spMkLst>
            <pc:docMk/>
            <pc:sldMk cId="269800214" sldId="261"/>
            <ac:spMk id="25" creationId="{F568064F-47CD-DBE3-0C0C-8B44A9AA1B03}"/>
          </ac:spMkLst>
        </pc:spChg>
        <pc:spChg chg="add mod">
          <ac:chgData name="Reza Amini Hounejani" userId="36cb0b73-58b2-4568-a1ab-00cd49301806" providerId="ADAL" clId="{84A10D71-B01E-9142-B24E-0E68A42C5837}" dt="2023-01-17T12:43:42.115" v="1012" actId="1038"/>
          <ac:spMkLst>
            <pc:docMk/>
            <pc:sldMk cId="269800214" sldId="261"/>
            <ac:spMk id="26" creationId="{AB1D4753-16C0-FBA9-DE6A-9ADE606378E2}"/>
          </ac:spMkLst>
        </pc:spChg>
        <pc:spChg chg="add mod">
          <ac:chgData name="Reza Amini Hounejani" userId="36cb0b73-58b2-4568-a1ab-00cd49301806" providerId="ADAL" clId="{84A10D71-B01E-9142-B24E-0E68A42C5837}" dt="2023-01-17T12:43:42.115" v="1012" actId="1038"/>
          <ac:spMkLst>
            <pc:docMk/>
            <pc:sldMk cId="269800214" sldId="261"/>
            <ac:spMk id="27" creationId="{DC3F9064-FF1E-EC4B-BBD8-4BA2D9A2E4C9}"/>
          </ac:spMkLst>
        </pc:spChg>
        <pc:spChg chg="add mod">
          <ac:chgData name="Reza Amini Hounejani" userId="36cb0b73-58b2-4568-a1ab-00cd49301806" providerId="ADAL" clId="{84A10D71-B01E-9142-B24E-0E68A42C5837}" dt="2023-01-17T11:09:51.524" v="926" actId="1038"/>
          <ac:spMkLst>
            <pc:docMk/>
            <pc:sldMk cId="269800214" sldId="261"/>
            <ac:spMk id="28" creationId="{4D5472F8-AD9A-EDD8-EAB0-482682EA287D}"/>
          </ac:spMkLst>
        </pc:spChg>
        <pc:spChg chg="add mod">
          <ac:chgData name="Reza Amini Hounejani" userId="36cb0b73-58b2-4568-a1ab-00cd49301806" providerId="ADAL" clId="{84A10D71-B01E-9142-B24E-0E68A42C5837}" dt="2023-01-17T11:09:51.524" v="926" actId="1038"/>
          <ac:spMkLst>
            <pc:docMk/>
            <pc:sldMk cId="269800214" sldId="261"/>
            <ac:spMk id="29" creationId="{1849EA63-FE75-4C13-646D-751DCEBF84C6}"/>
          </ac:spMkLst>
        </pc:spChg>
        <pc:spChg chg="add mod topLvl">
          <ac:chgData name="Reza Amini Hounejani" userId="36cb0b73-58b2-4568-a1ab-00cd49301806" providerId="ADAL" clId="{84A10D71-B01E-9142-B24E-0E68A42C5837}" dt="2023-01-17T12:43:42.115" v="1012" actId="1038"/>
          <ac:spMkLst>
            <pc:docMk/>
            <pc:sldMk cId="269800214" sldId="261"/>
            <ac:spMk id="30" creationId="{71C67A44-33D3-996A-FDE2-9C32F22046FC}"/>
          </ac:spMkLst>
        </pc:spChg>
        <pc:spChg chg="add mod topLvl">
          <ac:chgData name="Reza Amini Hounejani" userId="36cb0b73-58b2-4568-a1ab-00cd49301806" providerId="ADAL" clId="{84A10D71-B01E-9142-B24E-0E68A42C5837}" dt="2023-01-17T12:43:42.115" v="1012" actId="1038"/>
          <ac:spMkLst>
            <pc:docMk/>
            <pc:sldMk cId="269800214" sldId="261"/>
            <ac:spMk id="31" creationId="{66160A75-A3E9-D491-693B-FCDAEAD906B8}"/>
          </ac:spMkLst>
        </pc:spChg>
        <pc:spChg chg="add mod topLvl">
          <ac:chgData name="Reza Amini Hounejani" userId="36cb0b73-58b2-4568-a1ab-00cd49301806" providerId="ADAL" clId="{84A10D71-B01E-9142-B24E-0E68A42C5837}" dt="2023-01-17T12:43:42.115" v="1012" actId="1038"/>
          <ac:spMkLst>
            <pc:docMk/>
            <pc:sldMk cId="269800214" sldId="261"/>
            <ac:spMk id="32" creationId="{D4654BF1-D8FC-36B9-75E5-23DAEFA003F5}"/>
          </ac:spMkLst>
        </pc:spChg>
        <pc:spChg chg="add mod topLvl">
          <ac:chgData name="Reza Amini Hounejani" userId="36cb0b73-58b2-4568-a1ab-00cd49301806" providerId="ADAL" clId="{84A10D71-B01E-9142-B24E-0E68A42C5837}" dt="2023-01-17T11:09:51.524" v="926" actId="1038"/>
          <ac:spMkLst>
            <pc:docMk/>
            <pc:sldMk cId="269800214" sldId="261"/>
            <ac:spMk id="33" creationId="{701F7FBD-E1A0-05B1-4255-DBE6F9E3C77D}"/>
          </ac:spMkLst>
        </pc:spChg>
        <pc:spChg chg="add mod topLvl">
          <ac:chgData name="Reza Amini Hounejani" userId="36cb0b73-58b2-4568-a1ab-00cd49301806" providerId="ADAL" clId="{84A10D71-B01E-9142-B24E-0E68A42C5837}" dt="2023-01-17T11:09:51.524" v="926" actId="1038"/>
          <ac:spMkLst>
            <pc:docMk/>
            <pc:sldMk cId="269800214" sldId="261"/>
            <ac:spMk id="34" creationId="{C5B8DB23-28C0-E817-65B9-F12473F6AC5E}"/>
          </ac:spMkLst>
        </pc:spChg>
        <pc:spChg chg="add mod">
          <ac:chgData name="Reza Amini Hounejani" userId="36cb0b73-58b2-4568-a1ab-00cd49301806" providerId="ADAL" clId="{84A10D71-B01E-9142-B24E-0E68A42C5837}" dt="2023-01-17T10:45:40.888" v="862" actId="1038"/>
          <ac:spMkLst>
            <pc:docMk/>
            <pc:sldMk cId="269800214" sldId="261"/>
            <ac:spMk id="35" creationId="{50D3A2BC-6755-6A66-F09E-05C544AC8866}"/>
          </ac:spMkLst>
        </pc:spChg>
        <pc:spChg chg="add mod">
          <ac:chgData name="Reza Amini Hounejani" userId="36cb0b73-58b2-4568-a1ab-00cd49301806" providerId="ADAL" clId="{84A10D71-B01E-9142-B24E-0E68A42C5837}" dt="2023-01-17T10:45:45.800" v="865" actId="1036"/>
          <ac:spMkLst>
            <pc:docMk/>
            <pc:sldMk cId="269800214" sldId="261"/>
            <ac:spMk id="36" creationId="{7B069632-FC09-7BE7-28D9-3708BA9242D0}"/>
          </ac:spMkLst>
        </pc:spChg>
        <pc:spChg chg="add mod">
          <ac:chgData name="Reza Amini Hounejani" userId="36cb0b73-58b2-4568-a1ab-00cd49301806" providerId="ADAL" clId="{84A10D71-B01E-9142-B24E-0E68A42C5837}" dt="2023-01-17T11:15:38.228" v="972" actId="1035"/>
          <ac:spMkLst>
            <pc:docMk/>
            <pc:sldMk cId="269800214" sldId="261"/>
            <ac:spMk id="37" creationId="{917B6BE6-5A4F-56EE-56DB-8D794B7005D5}"/>
          </ac:spMkLst>
        </pc:spChg>
        <pc:spChg chg="add mod">
          <ac:chgData name="Reza Amini Hounejani" userId="36cb0b73-58b2-4568-a1ab-00cd49301806" providerId="ADAL" clId="{84A10D71-B01E-9142-B24E-0E68A42C5837}" dt="2023-01-17T10:46:15.395" v="867" actId="404"/>
          <ac:spMkLst>
            <pc:docMk/>
            <pc:sldMk cId="269800214" sldId="261"/>
            <ac:spMk id="38" creationId="{BAC20769-9E36-E28D-C42A-2C6AF98541FB}"/>
          </ac:spMkLst>
        </pc:spChg>
        <pc:spChg chg="add mod">
          <ac:chgData name="Reza Amini Hounejani" userId="36cb0b73-58b2-4568-a1ab-00cd49301806" providerId="ADAL" clId="{84A10D71-B01E-9142-B24E-0E68A42C5837}" dt="2023-01-17T10:46:15.395" v="867" actId="404"/>
          <ac:spMkLst>
            <pc:docMk/>
            <pc:sldMk cId="269800214" sldId="261"/>
            <ac:spMk id="45" creationId="{6D08FB89-A2DC-0BD3-E578-FB1E155EE7E3}"/>
          </ac:spMkLst>
        </pc:spChg>
        <pc:spChg chg="add mod">
          <ac:chgData name="Reza Amini Hounejani" userId="36cb0b73-58b2-4568-a1ab-00cd49301806" providerId="ADAL" clId="{84A10D71-B01E-9142-B24E-0E68A42C5837}" dt="2023-01-17T10:46:15.395" v="867" actId="404"/>
          <ac:spMkLst>
            <pc:docMk/>
            <pc:sldMk cId="269800214" sldId="261"/>
            <ac:spMk id="46" creationId="{FCC12FB6-58CB-2D10-DF24-6D09B679B5B2}"/>
          </ac:spMkLst>
        </pc:spChg>
        <pc:spChg chg="mod">
          <ac:chgData name="Reza Amini Hounejani" userId="36cb0b73-58b2-4568-a1ab-00cd49301806" providerId="ADAL" clId="{84A10D71-B01E-9142-B24E-0E68A42C5837}" dt="2023-01-17T10:46:19.936" v="869" actId="1036"/>
          <ac:spMkLst>
            <pc:docMk/>
            <pc:sldMk cId="269800214" sldId="261"/>
            <ac:spMk id="56" creationId="{7C937CE2-867F-6AFB-E8D4-BFA49A6EBD4C}"/>
          </ac:spMkLst>
        </pc:spChg>
        <pc:spChg chg="mod">
          <ac:chgData name="Reza Amini Hounejani" userId="36cb0b73-58b2-4568-a1ab-00cd49301806" providerId="ADAL" clId="{84A10D71-B01E-9142-B24E-0E68A42C5837}" dt="2023-01-17T11:07:55.056" v="900" actId="1035"/>
          <ac:spMkLst>
            <pc:docMk/>
            <pc:sldMk cId="269800214" sldId="261"/>
            <ac:spMk id="57" creationId="{65932EA0-2F2B-582B-0FF4-F5A22AADDF8A}"/>
          </ac:spMkLst>
        </pc:spChg>
        <pc:spChg chg="mod">
          <ac:chgData name="Reza Amini Hounejani" userId="36cb0b73-58b2-4568-a1ab-00cd49301806" providerId="ADAL" clId="{84A10D71-B01E-9142-B24E-0E68A42C5837}" dt="2023-01-17T10:39:02.089" v="677" actId="465"/>
          <ac:spMkLst>
            <pc:docMk/>
            <pc:sldMk cId="269800214" sldId="261"/>
            <ac:spMk id="58" creationId="{55F542B6-EEE9-FF89-5762-01CF36E8E860}"/>
          </ac:spMkLst>
        </pc:spChg>
        <pc:spChg chg="mod">
          <ac:chgData name="Reza Amini Hounejani" userId="36cb0b73-58b2-4568-a1ab-00cd49301806" providerId="ADAL" clId="{84A10D71-B01E-9142-B24E-0E68A42C5837}" dt="2023-01-17T10:39:02.089" v="677" actId="465"/>
          <ac:spMkLst>
            <pc:docMk/>
            <pc:sldMk cId="269800214" sldId="261"/>
            <ac:spMk id="59" creationId="{84F62275-2ED3-4A2A-D34E-E4E4A31D6C99}"/>
          </ac:spMkLst>
        </pc:spChg>
        <pc:spChg chg="mod">
          <ac:chgData name="Reza Amini Hounejani" userId="36cb0b73-58b2-4568-a1ab-00cd49301806" providerId="ADAL" clId="{84A10D71-B01E-9142-B24E-0E68A42C5837}" dt="2023-01-17T10:39:02.089" v="677" actId="465"/>
          <ac:spMkLst>
            <pc:docMk/>
            <pc:sldMk cId="269800214" sldId="261"/>
            <ac:spMk id="60" creationId="{0899B095-13CE-C4DF-D68D-DC4DAEAE2FC0}"/>
          </ac:spMkLst>
        </pc:spChg>
        <pc:spChg chg="mod">
          <ac:chgData name="Reza Amini Hounejani" userId="36cb0b73-58b2-4568-a1ab-00cd49301806" providerId="ADAL" clId="{84A10D71-B01E-9142-B24E-0E68A42C5837}" dt="2023-01-17T10:39:02.089" v="677" actId="465"/>
          <ac:spMkLst>
            <pc:docMk/>
            <pc:sldMk cId="269800214" sldId="261"/>
            <ac:spMk id="61" creationId="{0B24528A-D29F-1EF2-D421-DE45246BCAB1}"/>
          </ac:spMkLst>
        </pc:spChg>
        <pc:spChg chg="mod">
          <ac:chgData name="Reza Amini Hounejani" userId="36cb0b73-58b2-4568-a1ab-00cd49301806" providerId="ADAL" clId="{84A10D71-B01E-9142-B24E-0E68A42C5837}" dt="2023-01-17T10:39:02.089" v="677" actId="465"/>
          <ac:spMkLst>
            <pc:docMk/>
            <pc:sldMk cId="269800214" sldId="261"/>
            <ac:spMk id="62" creationId="{78DE8071-3648-34AB-B9D9-4E45E4A84927}"/>
          </ac:spMkLst>
        </pc:spChg>
        <pc:spChg chg="mod">
          <ac:chgData name="Reza Amini Hounejani" userId="36cb0b73-58b2-4568-a1ab-00cd49301806" providerId="ADAL" clId="{84A10D71-B01E-9142-B24E-0E68A42C5837}" dt="2023-01-17T10:39:02.089" v="677" actId="465"/>
          <ac:spMkLst>
            <pc:docMk/>
            <pc:sldMk cId="269800214" sldId="261"/>
            <ac:spMk id="63" creationId="{FA2699CD-F8D7-84A9-98D4-6FD51EC8D461}"/>
          </ac:spMkLst>
        </pc:spChg>
        <pc:spChg chg="del mod">
          <ac:chgData name="Reza Amini Hounejani" userId="36cb0b73-58b2-4568-a1ab-00cd49301806" providerId="ADAL" clId="{84A10D71-B01E-9142-B24E-0E68A42C5837}" dt="2023-01-17T09:15:00.904" v="423" actId="478"/>
          <ac:spMkLst>
            <pc:docMk/>
            <pc:sldMk cId="269800214" sldId="261"/>
            <ac:spMk id="65" creationId="{995AB49B-FE61-960A-84F8-F0A5A3C8312D}"/>
          </ac:spMkLst>
        </pc:spChg>
        <pc:spChg chg="del mod">
          <ac:chgData name="Reza Amini Hounejani" userId="36cb0b73-58b2-4568-a1ab-00cd49301806" providerId="ADAL" clId="{84A10D71-B01E-9142-B24E-0E68A42C5837}" dt="2023-01-17T09:15:02.894" v="424" actId="478"/>
          <ac:spMkLst>
            <pc:docMk/>
            <pc:sldMk cId="269800214" sldId="261"/>
            <ac:spMk id="67" creationId="{F719078E-E7E2-2DEB-9E1C-5CA6130DCCC4}"/>
          </ac:spMkLst>
        </pc:spChg>
        <pc:spChg chg="del mod">
          <ac:chgData name="Reza Amini Hounejani" userId="36cb0b73-58b2-4568-a1ab-00cd49301806" providerId="ADAL" clId="{84A10D71-B01E-9142-B24E-0E68A42C5837}" dt="2023-01-17T09:15:06.052" v="425" actId="478"/>
          <ac:spMkLst>
            <pc:docMk/>
            <pc:sldMk cId="269800214" sldId="261"/>
            <ac:spMk id="68" creationId="{543F45AD-3715-E79A-EFC8-94C9A38AA594}"/>
          </ac:spMkLst>
        </pc:spChg>
        <pc:spChg chg="del mod">
          <ac:chgData name="Reza Amini Hounejani" userId="36cb0b73-58b2-4568-a1ab-00cd49301806" providerId="ADAL" clId="{84A10D71-B01E-9142-B24E-0E68A42C5837}" dt="2023-01-17T09:15:09.603" v="426" actId="478"/>
          <ac:spMkLst>
            <pc:docMk/>
            <pc:sldMk cId="269800214" sldId="261"/>
            <ac:spMk id="69" creationId="{64591331-C874-2B95-99B8-5C3A4EF8A9D1}"/>
          </ac:spMkLst>
        </pc:spChg>
        <pc:spChg chg="mod">
          <ac:chgData name="Reza Amini Hounejani" userId="36cb0b73-58b2-4568-a1ab-00cd49301806" providerId="ADAL" clId="{84A10D71-B01E-9142-B24E-0E68A42C5837}" dt="2023-01-17T10:39:02.089" v="677" actId="465"/>
          <ac:spMkLst>
            <pc:docMk/>
            <pc:sldMk cId="269800214" sldId="261"/>
            <ac:spMk id="73" creationId="{82687445-DD90-0D8F-E1CB-774F75C3B686}"/>
          </ac:spMkLst>
        </pc:spChg>
        <pc:spChg chg="mod">
          <ac:chgData name="Reza Amini Hounejani" userId="36cb0b73-58b2-4568-a1ab-00cd49301806" providerId="ADAL" clId="{84A10D71-B01E-9142-B24E-0E68A42C5837}" dt="2023-01-17T11:10:03.429" v="929" actId="1037"/>
          <ac:spMkLst>
            <pc:docMk/>
            <pc:sldMk cId="269800214" sldId="261"/>
            <ac:spMk id="115" creationId="{63F97AB8-C9CD-67D8-6612-12AE8A178CB3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19" creationId="{CA781EB6-2506-661C-ABC4-013870D3D4AC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20" creationId="{47DC6C1E-BD95-1EE7-30A4-F4AA3EB6996F}"/>
          </ac:spMkLst>
        </pc:spChg>
        <pc:spChg chg="mod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21" creationId="{7367E09A-747F-07CA-6A79-CBA33EDB012A}"/>
          </ac:spMkLst>
        </pc:spChg>
        <pc:spChg chg="mod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22" creationId="{877284A1-C1C0-AA45-CB24-79306D9A8998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24" creationId="{9A5A2823-5D2E-6098-75C7-19AFB39682CB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25" creationId="{41911E68-5387-C85C-7347-5621EFC8695B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26" creationId="{EEBE429C-59D6-82D1-B119-77BF1B8DAE59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27" creationId="{4BB0F239-C14D-841D-097C-D32C26E3ACEC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29" creationId="{883E47B9-E2D6-63E2-96A9-9453D5808C86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31" creationId="{26687ACC-CFD0-1031-1A88-406829F5248C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33" creationId="{A5CD06CB-8095-7B9D-EE8E-7D73B22549F2}"/>
          </ac:spMkLst>
        </pc:spChg>
        <pc:spChg chg="mod topLvl">
          <ac:chgData name="Reza Amini Hounejani" userId="36cb0b73-58b2-4568-a1ab-00cd49301806" providerId="ADAL" clId="{84A10D71-B01E-9142-B24E-0E68A42C5837}" dt="2023-01-17T11:09:42.085" v="913" actId="165"/>
          <ac:spMkLst>
            <pc:docMk/>
            <pc:sldMk cId="269800214" sldId="261"/>
            <ac:spMk id="134" creationId="{13B655E6-08F6-FFBD-8255-BA625751B9D9}"/>
          </ac:spMkLst>
        </pc:spChg>
        <pc:grpChg chg="del">
          <ac:chgData name="Reza Amini Hounejani" userId="36cb0b73-58b2-4568-a1ab-00cd49301806" providerId="ADAL" clId="{84A10D71-B01E-9142-B24E-0E68A42C5837}" dt="2023-01-16T17:02:19.276" v="337" actId="165"/>
          <ac:grpSpMkLst>
            <pc:docMk/>
            <pc:sldMk cId="269800214" sldId="261"/>
            <ac:grpSpMk id="18" creationId="{B5AB4227-8BBA-E360-5A62-C6AD3BD14F55}"/>
          </ac:grpSpMkLst>
        </pc:grpChg>
        <pc:grpChg chg="del">
          <ac:chgData name="Reza Amini Hounejani" userId="36cb0b73-58b2-4568-a1ab-00cd49301806" providerId="ADAL" clId="{84A10D71-B01E-9142-B24E-0E68A42C5837}" dt="2023-01-16T17:02:23.816" v="338" actId="165"/>
          <ac:grpSpMkLst>
            <pc:docMk/>
            <pc:sldMk cId="269800214" sldId="261"/>
            <ac:grpSpMk id="19" creationId="{4B0F7488-0FAF-21C7-430E-F5FAFCD9E9C5}"/>
          </ac:grpSpMkLst>
        </pc:grpChg>
        <pc:grpChg chg="add del mod">
          <ac:chgData name="Reza Amini Hounejani" userId="36cb0b73-58b2-4568-a1ab-00cd49301806" providerId="ADAL" clId="{84A10D71-B01E-9142-B24E-0E68A42C5837}" dt="2023-01-17T11:07:16.066" v="884" actId="478"/>
          <ac:grpSpMkLst>
            <pc:docMk/>
            <pc:sldMk cId="269800214" sldId="261"/>
            <ac:grpSpMk id="22" creationId="{0DA1A556-DDAC-CF24-2E30-4465BF981F5F}"/>
          </ac:grpSpMkLst>
        </pc:grpChg>
        <pc:grpChg chg="mod topLvl">
          <ac:chgData name="Reza Amini Hounejani" userId="36cb0b73-58b2-4568-a1ab-00cd49301806" providerId="ADAL" clId="{84A10D71-B01E-9142-B24E-0E68A42C5837}" dt="2023-01-17T11:09:42.085" v="913" actId="165"/>
          <ac:grpSpMkLst>
            <pc:docMk/>
            <pc:sldMk cId="269800214" sldId="261"/>
            <ac:grpSpMk id="123" creationId="{9D57E546-3E19-32B2-1434-4D740B537761}"/>
          </ac:grpSpMkLst>
        </pc:grpChg>
        <pc:grpChg chg="del mod topLvl">
          <ac:chgData name="Reza Amini Hounejani" userId="36cb0b73-58b2-4568-a1ab-00cd49301806" providerId="ADAL" clId="{84A10D71-B01E-9142-B24E-0E68A42C5837}" dt="2023-01-17T11:09:42.085" v="913" actId="165"/>
          <ac:grpSpMkLst>
            <pc:docMk/>
            <pc:sldMk cId="269800214" sldId="261"/>
            <ac:grpSpMk id="135" creationId="{A286BC48-D662-2E8A-26D9-7CEE8EF0CD80}"/>
          </ac:grpSpMkLst>
        </pc:grpChg>
        <pc:grpChg chg="mod topLvl">
          <ac:chgData name="Reza Amini Hounejani" userId="36cb0b73-58b2-4568-a1ab-00cd49301806" providerId="ADAL" clId="{84A10D71-B01E-9142-B24E-0E68A42C5837}" dt="2023-01-17T10:39:02.089" v="677" actId="465"/>
          <ac:grpSpMkLst>
            <pc:docMk/>
            <pc:sldMk cId="269800214" sldId="261"/>
            <ac:grpSpMk id="191" creationId="{77DA745D-3DD7-2930-7E54-0ED8F48DC2DF}"/>
          </ac:grpSpMkLst>
        </pc:grpChg>
        <pc:picChg chg="del mod topLvl">
          <ac:chgData name="Reza Amini Hounejani" userId="36cb0b73-58b2-4568-a1ab-00cd49301806" providerId="ADAL" clId="{84A10D71-B01E-9142-B24E-0E68A42C5837}" dt="2023-01-19T12:16:54.535" v="1020" actId="478"/>
          <ac:picMkLst>
            <pc:docMk/>
            <pc:sldMk cId="269800214" sldId="261"/>
            <ac:picMk id="3" creationId="{57E94F07-EAD6-7D99-1223-C864EF8E547C}"/>
          </ac:picMkLst>
        </pc:picChg>
        <pc:picChg chg="add del mod topLvl">
          <ac:chgData name="Reza Amini Hounejani" userId="36cb0b73-58b2-4568-a1ab-00cd49301806" providerId="ADAL" clId="{84A10D71-B01E-9142-B24E-0E68A42C5837}" dt="2023-01-17T11:07:16.066" v="884" actId="478"/>
          <ac:picMkLst>
            <pc:docMk/>
            <pc:sldMk cId="269800214" sldId="261"/>
            <ac:picMk id="6" creationId="{6BE88DA3-6F6F-98CA-31A7-A48D8184A621}"/>
          </ac:picMkLst>
        </pc:picChg>
        <pc:picChg chg="del mod topLvl">
          <ac:chgData name="Reza Amini Hounejani" userId="36cb0b73-58b2-4568-a1ab-00cd49301806" providerId="ADAL" clId="{84A10D71-B01E-9142-B24E-0E68A42C5837}" dt="2023-01-19T12:16:47.073" v="1019" actId="478"/>
          <ac:picMkLst>
            <pc:docMk/>
            <pc:sldMk cId="269800214" sldId="261"/>
            <ac:picMk id="7" creationId="{DB642707-E22A-D4FC-EB27-382FC2623D5C}"/>
          </ac:picMkLst>
        </pc:picChg>
        <pc:picChg chg="add del mod">
          <ac:chgData name="Reza Amini Hounejani" userId="36cb0b73-58b2-4568-a1ab-00cd49301806" providerId="ADAL" clId="{84A10D71-B01E-9142-B24E-0E68A42C5837}" dt="2023-01-17T10:29:14.987" v="572" actId="478"/>
          <ac:picMkLst>
            <pc:docMk/>
            <pc:sldMk cId="269800214" sldId="261"/>
            <ac:picMk id="20" creationId="{C8C885C9-F6D2-0497-2BB1-07CAABD6270A}"/>
          </ac:picMkLst>
        </pc:picChg>
        <pc:picChg chg="add del mod">
          <ac:chgData name="Reza Amini Hounejani" userId="36cb0b73-58b2-4568-a1ab-00cd49301806" providerId="ADAL" clId="{84A10D71-B01E-9142-B24E-0E68A42C5837}" dt="2023-01-17T11:06:34.340" v="872" actId="478"/>
          <ac:picMkLst>
            <pc:docMk/>
            <pc:sldMk cId="269800214" sldId="261"/>
            <ac:picMk id="40" creationId="{1E466620-1268-604B-33EA-7E19DC3C5F81}"/>
          </ac:picMkLst>
        </pc:picChg>
        <pc:picChg chg="add del mod">
          <ac:chgData name="Reza Amini Hounejani" userId="36cb0b73-58b2-4568-a1ab-00cd49301806" providerId="ADAL" clId="{84A10D71-B01E-9142-B24E-0E68A42C5837}" dt="2023-01-17T11:30:38.563" v="991" actId="478"/>
          <ac:picMkLst>
            <pc:docMk/>
            <pc:sldMk cId="269800214" sldId="261"/>
            <ac:picMk id="48" creationId="{72E288EC-DA37-5006-48CF-999394477414}"/>
          </ac:picMkLst>
        </pc:picChg>
        <pc:picChg chg="add mod">
          <ac:chgData name="Reza Amini Hounejani" userId="36cb0b73-58b2-4568-a1ab-00cd49301806" providerId="ADAL" clId="{84A10D71-B01E-9142-B24E-0E68A42C5837}" dt="2023-01-17T11:07:49.656" v="897" actId="12789"/>
          <ac:picMkLst>
            <pc:docMk/>
            <pc:sldMk cId="269800214" sldId="261"/>
            <ac:picMk id="50" creationId="{C7469508-AB18-66AC-5DD7-7BD43406FCF3}"/>
          </ac:picMkLst>
        </pc:picChg>
        <pc:picChg chg="add mod">
          <ac:chgData name="Reza Amini Hounejani" userId="36cb0b73-58b2-4568-a1ab-00cd49301806" providerId="ADAL" clId="{84A10D71-B01E-9142-B24E-0E68A42C5837}" dt="2023-01-17T11:30:50.871" v="994" actId="1076"/>
          <ac:picMkLst>
            <pc:docMk/>
            <pc:sldMk cId="269800214" sldId="261"/>
            <ac:picMk id="52" creationId="{7483462C-D603-145D-A644-E4038B7B8A8B}"/>
          </ac:picMkLst>
        </pc:picChg>
        <pc:cxnChg chg="add del mod">
          <ac:chgData name="Reza Amini Hounejani" userId="36cb0b73-58b2-4568-a1ab-00cd49301806" providerId="ADAL" clId="{84A10D71-B01E-9142-B24E-0E68A42C5837}" dt="2023-01-17T10:29:42.889" v="581" actId="478"/>
          <ac:cxnSpMkLst>
            <pc:docMk/>
            <pc:sldMk cId="269800214" sldId="261"/>
            <ac:cxnSpMk id="42" creationId="{AD0E2EBB-F744-4F84-ADA9-E663B8CE666E}"/>
          </ac:cxnSpMkLst>
        </pc:cxnChg>
        <pc:cxnChg chg="add del">
          <ac:chgData name="Reza Amini Hounejani" userId="36cb0b73-58b2-4568-a1ab-00cd49301806" providerId="ADAL" clId="{84A10D71-B01E-9142-B24E-0E68A42C5837}" dt="2023-01-17T10:30:21.717" v="586" actId="478"/>
          <ac:cxnSpMkLst>
            <pc:docMk/>
            <pc:sldMk cId="269800214" sldId="261"/>
            <ac:cxnSpMk id="44" creationId="{B113F0E3-3B02-2AA8-56B6-D0DDDCE2F8BF}"/>
          </ac:cxnSpMkLst>
        </pc:cxnChg>
      </pc:sldChg>
      <pc:sldChg chg="addSp delSp modSp mod">
        <pc:chgData name="Reza Amini Hounejani" userId="36cb0b73-58b2-4568-a1ab-00cd49301806" providerId="ADAL" clId="{84A10D71-B01E-9142-B24E-0E68A42C5837}" dt="2023-01-17T12:16:25.167" v="998" actId="1037"/>
        <pc:sldMkLst>
          <pc:docMk/>
          <pc:sldMk cId="1450487343" sldId="262"/>
        </pc:sldMkLst>
        <pc:spChg chg="mod">
          <ac:chgData name="Reza Amini Hounejani" userId="36cb0b73-58b2-4568-a1ab-00cd49301806" providerId="ADAL" clId="{84A10D71-B01E-9142-B24E-0E68A42C5837}" dt="2023-01-17T11:14:35.082" v="954" actId="12789"/>
          <ac:spMkLst>
            <pc:docMk/>
            <pc:sldMk cId="1450487343" sldId="262"/>
            <ac:spMk id="10" creationId="{D62BBA95-E77D-1D32-0C34-8B0AB0979219}"/>
          </ac:spMkLst>
        </pc:spChg>
        <pc:spChg chg="del mod">
          <ac:chgData name="Reza Amini Hounejani" userId="36cb0b73-58b2-4568-a1ab-00cd49301806" providerId="ADAL" clId="{84A10D71-B01E-9142-B24E-0E68A42C5837}" dt="2023-01-17T11:14:14.260" v="948" actId="478"/>
          <ac:spMkLst>
            <pc:docMk/>
            <pc:sldMk cId="1450487343" sldId="262"/>
            <ac:spMk id="11" creationId="{75B4F4A2-4BE2-2FBB-BBB9-E53E09196D91}"/>
          </ac:spMkLst>
        </pc:spChg>
        <pc:spChg chg="mod">
          <ac:chgData name="Reza Amini Hounejani" userId="36cb0b73-58b2-4568-a1ab-00cd49301806" providerId="ADAL" clId="{84A10D71-B01E-9142-B24E-0E68A42C5837}" dt="2023-01-17T11:14:35.082" v="954" actId="12789"/>
          <ac:spMkLst>
            <pc:docMk/>
            <pc:sldMk cId="1450487343" sldId="262"/>
            <ac:spMk id="12" creationId="{CC1F71CD-8B72-0C51-DE63-86E1F0987F03}"/>
          </ac:spMkLst>
        </pc:spChg>
        <pc:spChg chg="del mod">
          <ac:chgData name="Reza Amini Hounejani" userId="36cb0b73-58b2-4568-a1ab-00cd49301806" providerId="ADAL" clId="{84A10D71-B01E-9142-B24E-0E68A42C5837}" dt="2023-01-17T11:14:17.044" v="949" actId="478"/>
          <ac:spMkLst>
            <pc:docMk/>
            <pc:sldMk cId="1450487343" sldId="262"/>
            <ac:spMk id="13" creationId="{26CA9CD0-59E2-F3B0-377C-28F39CA5CC7B}"/>
          </ac:spMkLst>
        </pc:spChg>
        <pc:spChg chg="mod">
          <ac:chgData name="Reza Amini Hounejani" userId="36cb0b73-58b2-4568-a1ab-00cd49301806" providerId="ADAL" clId="{84A10D71-B01E-9142-B24E-0E68A42C5837}" dt="2023-01-17T11:14:35.082" v="954" actId="12789"/>
          <ac:spMkLst>
            <pc:docMk/>
            <pc:sldMk cId="1450487343" sldId="262"/>
            <ac:spMk id="14" creationId="{0000FD60-39C0-6724-4065-A1A98A557EFE}"/>
          </ac:spMkLst>
        </pc:spChg>
        <pc:spChg chg="del mod">
          <ac:chgData name="Reza Amini Hounejani" userId="36cb0b73-58b2-4568-a1ab-00cd49301806" providerId="ADAL" clId="{84A10D71-B01E-9142-B24E-0E68A42C5837}" dt="2023-01-17T11:14:19.731" v="950" actId="478"/>
          <ac:spMkLst>
            <pc:docMk/>
            <pc:sldMk cId="1450487343" sldId="262"/>
            <ac:spMk id="15" creationId="{78A155B6-4D0C-AD48-B1CA-31C45EA7CB46}"/>
          </ac:spMkLst>
        </pc:spChg>
        <pc:spChg chg="mod">
          <ac:chgData name="Reza Amini Hounejani" userId="36cb0b73-58b2-4568-a1ab-00cd49301806" providerId="ADAL" clId="{84A10D71-B01E-9142-B24E-0E68A42C5837}" dt="2023-01-17T09:42:51.222" v="523" actId="1035"/>
          <ac:spMkLst>
            <pc:docMk/>
            <pc:sldMk cId="1450487343" sldId="262"/>
            <ac:spMk id="16" creationId="{8E84C809-232F-F3F7-6312-EED254F19AA8}"/>
          </ac:spMkLst>
        </pc:spChg>
        <pc:spChg chg="mod">
          <ac:chgData name="Reza Amini Hounejani" userId="36cb0b73-58b2-4568-a1ab-00cd49301806" providerId="ADAL" clId="{84A10D71-B01E-9142-B24E-0E68A42C5837}" dt="2023-01-17T09:42:56.490" v="526" actId="1035"/>
          <ac:spMkLst>
            <pc:docMk/>
            <pc:sldMk cId="1450487343" sldId="262"/>
            <ac:spMk id="17" creationId="{F40F6B45-C845-0667-C12D-EC3BBA0CF75D}"/>
          </ac:spMkLst>
        </pc:spChg>
        <pc:spChg chg="mod">
          <ac:chgData name="Reza Amini Hounejani" userId="36cb0b73-58b2-4568-a1ab-00cd49301806" providerId="ADAL" clId="{84A10D71-B01E-9142-B24E-0E68A42C5837}" dt="2023-01-17T09:42:29.700" v="513" actId="408"/>
          <ac:spMkLst>
            <pc:docMk/>
            <pc:sldMk cId="1450487343" sldId="262"/>
            <ac:spMk id="18" creationId="{23D40A93-DD1B-35E0-79A5-72FD8A78FDBA}"/>
          </ac:spMkLst>
        </pc:spChg>
        <pc:spChg chg="mod">
          <ac:chgData name="Reza Amini Hounejani" userId="36cb0b73-58b2-4568-a1ab-00cd49301806" providerId="ADAL" clId="{84A10D71-B01E-9142-B24E-0E68A42C5837}" dt="2023-01-17T09:42:29.700" v="513" actId="408"/>
          <ac:spMkLst>
            <pc:docMk/>
            <pc:sldMk cId="1450487343" sldId="262"/>
            <ac:spMk id="19" creationId="{9C099E10-0926-A347-CFDE-45E9E9C3F03C}"/>
          </ac:spMkLst>
        </pc:spChg>
        <pc:spChg chg="mod">
          <ac:chgData name="Reza Amini Hounejani" userId="36cb0b73-58b2-4568-a1ab-00cd49301806" providerId="ADAL" clId="{84A10D71-B01E-9142-B24E-0E68A42C5837}" dt="2023-01-17T09:42:29.700" v="513" actId="408"/>
          <ac:spMkLst>
            <pc:docMk/>
            <pc:sldMk cId="1450487343" sldId="262"/>
            <ac:spMk id="20" creationId="{21EEFC56-BD2C-2D67-502A-75DEF5403B69}"/>
          </ac:spMkLst>
        </pc:spChg>
        <pc:spChg chg="mod">
          <ac:chgData name="Reza Amini Hounejani" userId="36cb0b73-58b2-4568-a1ab-00cd49301806" providerId="ADAL" clId="{84A10D71-B01E-9142-B24E-0E68A42C5837}" dt="2023-01-17T11:14:53.554" v="969" actId="1036"/>
          <ac:spMkLst>
            <pc:docMk/>
            <pc:sldMk cId="1450487343" sldId="262"/>
            <ac:spMk id="21" creationId="{976FFA13-1AC7-4B6E-6054-78DDC2114909}"/>
          </ac:spMkLst>
        </pc:spChg>
        <pc:spChg chg="mod">
          <ac:chgData name="Reza Amini Hounejani" userId="36cb0b73-58b2-4568-a1ab-00cd49301806" providerId="ADAL" clId="{84A10D71-B01E-9142-B24E-0E68A42C5837}" dt="2023-01-17T11:14:50.512" v="968" actId="1036"/>
          <ac:spMkLst>
            <pc:docMk/>
            <pc:sldMk cId="1450487343" sldId="262"/>
            <ac:spMk id="22" creationId="{71544578-ABEE-BC0F-7CE9-1590E780AF4C}"/>
          </ac:spMkLst>
        </pc:spChg>
        <pc:spChg chg="mod">
          <ac:chgData name="Reza Amini Hounejani" userId="36cb0b73-58b2-4568-a1ab-00cd49301806" providerId="ADAL" clId="{84A10D71-B01E-9142-B24E-0E68A42C5837}" dt="2023-01-17T11:14:46.700" v="962" actId="1036"/>
          <ac:spMkLst>
            <pc:docMk/>
            <pc:sldMk cId="1450487343" sldId="262"/>
            <ac:spMk id="23" creationId="{25182A02-EEB0-00C6-9539-342138AE9218}"/>
          </ac:spMkLst>
        </pc:spChg>
        <pc:spChg chg="mod">
          <ac:chgData name="Reza Amini Hounejani" userId="36cb0b73-58b2-4568-a1ab-00cd49301806" providerId="ADAL" clId="{84A10D71-B01E-9142-B24E-0E68A42C5837}" dt="2023-01-17T09:42:29.700" v="513" actId="408"/>
          <ac:spMkLst>
            <pc:docMk/>
            <pc:sldMk cId="1450487343" sldId="262"/>
            <ac:spMk id="25" creationId="{B1E790A6-6204-2D16-2AF0-D74A475BB3AA}"/>
          </ac:spMkLst>
        </pc:spChg>
        <pc:spChg chg="mod">
          <ac:chgData name="Reza Amini Hounejani" userId="36cb0b73-58b2-4568-a1ab-00cd49301806" providerId="ADAL" clId="{84A10D71-B01E-9142-B24E-0E68A42C5837}" dt="2023-01-17T09:42:29.700" v="513" actId="408"/>
          <ac:spMkLst>
            <pc:docMk/>
            <pc:sldMk cId="1450487343" sldId="262"/>
            <ac:spMk id="26" creationId="{87141DBD-170F-B444-AE70-F44CDCBAE271}"/>
          </ac:spMkLst>
        </pc:spChg>
        <pc:spChg chg="mod">
          <ac:chgData name="Reza Amini Hounejani" userId="36cb0b73-58b2-4568-a1ab-00cd49301806" providerId="ADAL" clId="{84A10D71-B01E-9142-B24E-0E68A42C5837}" dt="2023-01-17T09:42:29.700" v="513" actId="408"/>
          <ac:spMkLst>
            <pc:docMk/>
            <pc:sldMk cId="1450487343" sldId="262"/>
            <ac:spMk id="28" creationId="{CB1A8611-47BC-F73D-0F19-9B1580AA1F93}"/>
          </ac:spMkLst>
        </pc:spChg>
        <pc:spChg chg="mod">
          <ac:chgData name="Reza Amini Hounejani" userId="36cb0b73-58b2-4568-a1ab-00cd49301806" providerId="ADAL" clId="{84A10D71-B01E-9142-B24E-0E68A42C5837}" dt="2023-01-17T09:42:29.700" v="513" actId="408"/>
          <ac:spMkLst>
            <pc:docMk/>
            <pc:sldMk cId="1450487343" sldId="262"/>
            <ac:spMk id="29" creationId="{F61C94EC-88D9-090B-863F-9A28FE07677A}"/>
          </ac:spMkLst>
        </pc:spChg>
        <pc:spChg chg="mod">
          <ac:chgData name="Reza Amini Hounejani" userId="36cb0b73-58b2-4568-a1ab-00cd49301806" providerId="ADAL" clId="{84A10D71-B01E-9142-B24E-0E68A42C5837}" dt="2023-01-17T12:16:25.167" v="998" actId="1037"/>
          <ac:spMkLst>
            <pc:docMk/>
            <pc:sldMk cId="1450487343" sldId="262"/>
            <ac:spMk id="35" creationId="{93FF6C11-D71E-5EE1-87E3-EBE8A56F8714}"/>
          </ac:spMkLst>
        </pc:spChg>
        <pc:spChg chg="mod">
          <ac:chgData name="Reza Amini Hounejani" userId="36cb0b73-58b2-4568-a1ab-00cd49301806" providerId="ADAL" clId="{84A10D71-B01E-9142-B24E-0E68A42C5837}" dt="2023-01-17T12:16:25.167" v="998" actId="1037"/>
          <ac:spMkLst>
            <pc:docMk/>
            <pc:sldMk cId="1450487343" sldId="262"/>
            <ac:spMk id="36" creationId="{A4F2C3F0-E7C3-5932-9009-DA1599B48A4C}"/>
          </ac:spMkLst>
        </pc:spChg>
        <pc:spChg chg="mod">
          <ac:chgData name="Reza Amini Hounejani" userId="36cb0b73-58b2-4568-a1ab-00cd49301806" providerId="ADAL" clId="{84A10D71-B01E-9142-B24E-0E68A42C5837}" dt="2023-01-17T12:16:25.167" v="998" actId="1037"/>
          <ac:spMkLst>
            <pc:docMk/>
            <pc:sldMk cId="1450487343" sldId="262"/>
            <ac:spMk id="37" creationId="{F2C628D0-4F0E-6023-BD5D-319929CCA183}"/>
          </ac:spMkLst>
        </pc:spChg>
        <pc:spChg chg="mod">
          <ac:chgData name="Reza Amini Hounejani" userId="36cb0b73-58b2-4568-a1ab-00cd49301806" providerId="ADAL" clId="{84A10D71-B01E-9142-B24E-0E68A42C5837}" dt="2023-01-17T12:16:25.167" v="998" actId="1037"/>
          <ac:spMkLst>
            <pc:docMk/>
            <pc:sldMk cId="1450487343" sldId="262"/>
            <ac:spMk id="38" creationId="{9115BBED-D935-50D3-6647-65B8E9FF0B22}"/>
          </ac:spMkLst>
        </pc:spChg>
        <pc:spChg chg="mod">
          <ac:chgData name="Reza Amini Hounejani" userId="36cb0b73-58b2-4568-a1ab-00cd49301806" providerId="ADAL" clId="{84A10D71-B01E-9142-B24E-0E68A42C5837}" dt="2023-01-17T12:16:25.167" v="998" actId="1037"/>
          <ac:spMkLst>
            <pc:docMk/>
            <pc:sldMk cId="1450487343" sldId="262"/>
            <ac:spMk id="39" creationId="{47016499-94DF-455D-3473-7A5050E818A9}"/>
          </ac:spMkLst>
        </pc:spChg>
        <pc:spChg chg="mod">
          <ac:chgData name="Reza Amini Hounejani" userId="36cb0b73-58b2-4568-a1ab-00cd49301806" providerId="ADAL" clId="{84A10D71-B01E-9142-B24E-0E68A42C5837}" dt="2023-01-17T12:16:25.167" v="998" actId="1037"/>
          <ac:spMkLst>
            <pc:docMk/>
            <pc:sldMk cId="1450487343" sldId="262"/>
            <ac:spMk id="40" creationId="{B9CC7B9B-69C7-298E-1F45-CE7881FB4B3F}"/>
          </ac:spMkLst>
        </pc:spChg>
        <pc:spChg chg="mod">
          <ac:chgData name="Reza Amini Hounejani" userId="36cb0b73-58b2-4568-a1ab-00cd49301806" providerId="ADAL" clId="{84A10D71-B01E-9142-B24E-0E68A42C5837}" dt="2022-12-30T13:40:43.419" v="13" actId="1038"/>
          <ac:spMkLst>
            <pc:docMk/>
            <pc:sldMk cId="1450487343" sldId="262"/>
            <ac:spMk id="63" creationId="{465D20F9-5A8F-CD00-A944-6A52EFEBE4E9}"/>
          </ac:spMkLst>
        </pc:spChg>
        <pc:spChg chg="mod">
          <ac:chgData name="Reza Amini Hounejani" userId="36cb0b73-58b2-4568-a1ab-00cd49301806" providerId="ADAL" clId="{84A10D71-B01E-9142-B24E-0E68A42C5837}" dt="2022-12-30T13:40:30.492" v="3" actId="1035"/>
          <ac:spMkLst>
            <pc:docMk/>
            <pc:sldMk cId="1450487343" sldId="262"/>
            <ac:spMk id="66" creationId="{63A4D2BD-0492-0FDD-C0BA-A934D43F6419}"/>
          </ac:spMkLst>
        </pc:spChg>
        <pc:spChg chg="mod">
          <ac:chgData name="Reza Amini Hounejani" userId="36cb0b73-58b2-4568-a1ab-00cd49301806" providerId="ADAL" clId="{84A10D71-B01E-9142-B24E-0E68A42C5837}" dt="2022-12-30T13:40:30.492" v="3" actId="1035"/>
          <ac:spMkLst>
            <pc:docMk/>
            <pc:sldMk cId="1450487343" sldId="262"/>
            <ac:spMk id="67" creationId="{6D6E2B44-468B-8F64-45CA-FE059975932A}"/>
          </ac:spMkLst>
        </pc:spChg>
        <pc:spChg chg="add mod">
          <ac:chgData name="Reza Amini Hounejani" userId="36cb0b73-58b2-4568-a1ab-00cd49301806" providerId="ADAL" clId="{84A10D71-B01E-9142-B24E-0E68A42C5837}" dt="2023-01-16T15:47:29.168" v="302" actId="12788"/>
          <ac:spMkLst>
            <pc:docMk/>
            <pc:sldMk cId="1450487343" sldId="262"/>
            <ac:spMk id="71" creationId="{E059F69C-AD42-F8DD-6350-F6137C731FA5}"/>
          </ac:spMkLst>
        </pc:spChg>
        <pc:spChg chg="add mod">
          <ac:chgData name="Reza Amini Hounejani" userId="36cb0b73-58b2-4568-a1ab-00cd49301806" providerId="ADAL" clId="{84A10D71-B01E-9142-B24E-0E68A42C5837}" dt="2023-01-16T15:49:19.726" v="333" actId="20577"/>
          <ac:spMkLst>
            <pc:docMk/>
            <pc:sldMk cId="1450487343" sldId="262"/>
            <ac:spMk id="72" creationId="{30A799FA-4C73-1ECC-C923-4A9C988D8CD4}"/>
          </ac:spMkLst>
        </pc:spChg>
        <pc:spChg chg="add mod">
          <ac:chgData name="Reza Amini Hounejani" userId="36cb0b73-58b2-4568-a1ab-00cd49301806" providerId="ADAL" clId="{84A10D71-B01E-9142-B24E-0E68A42C5837}" dt="2023-01-16T15:47:29.168" v="302" actId="12788"/>
          <ac:spMkLst>
            <pc:docMk/>
            <pc:sldMk cId="1450487343" sldId="262"/>
            <ac:spMk id="75" creationId="{77AE3919-50B9-F752-C3E2-06825A6F7CA3}"/>
          </ac:spMkLst>
        </pc:spChg>
        <pc:spChg chg="add mod">
          <ac:chgData name="Reza Amini Hounejani" userId="36cb0b73-58b2-4568-a1ab-00cd49301806" providerId="ADAL" clId="{84A10D71-B01E-9142-B24E-0E68A42C5837}" dt="2023-01-16T15:49:17.987" v="330" actId="20577"/>
          <ac:spMkLst>
            <pc:docMk/>
            <pc:sldMk cId="1450487343" sldId="262"/>
            <ac:spMk id="76" creationId="{625D02DC-CACC-F0E1-D3AF-52624C82E629}"/>
          </ac:spMkLst>
        </pc:spChg>
        <pc:spChg chg="add del mod">
          <ac:chgData name="Reza Amini Hounejani" userId="36cb0b73-58b2-4568-a1ab-00cd49301806" providerId="ADAL" clId="{84A10D71-B01E-9142-B24E-0E68A42C5837}" dt="2023-01-17T11:14:08.933" v="947" actId="478"/>
          <ac:spMkLst>
            <pc:docMk/>
            <pc:sldMk cId="1450487343" sldId="262"/>
            <ac:spMk id="81" creationId="{6466E634-F6A6-ED2F-E852-CC1361BED5B6}"/>
          </ac:spMkLst>
        </pc:spChg>
        <pc:spChg chg="add mod">
          <ac:chgData name="Reza Amini Hounejani" userId="36cb0b73-58b2-4568-a1ab-00cd49301806" providerId="ADAL" clId="{84A10D71-B01E-9142-B24E-0E68A42C5837}" dt="2023-01-17T11:14:35.082" v="954" actId="12789"/>
          <ac:spMkLst>
            <pc:docMk/>
            <pc:sldMk cId="1450487343" sldId="262"/>
            <ac:spMk id="82" creationId="{90D0B963-579F-4986-B53C-C831609F3386}"/>
          </ac:spMkLst>
        </pc:spChg>
        <pc:grpChg chg="mod topLvl">
          <ac:chgData name="Reza Amini Hounejani" userId="36cb0b73-58b2-4568-a1ab-00cd49301806" providerId="ADAL" clId="{84A10D71-B01E-9142-B24E-0E68A42C5837}" dt="2023-01-17T09:42:29.700" v="513" actId="408"/>
          <ac:grpSpMkLst>
            <pc:docMk/>
            <pc:sldMk cId="1450487343" sldId="262"/>
            <ac:grpSpMk id="8" creationId="{8E8107F5-1AA2-9E1B-625B-2466673DACC9}"/>
          </ac:grpSpMkLst>
        </pc:grpChg>
        <pc:grpChg chg="mod">
          <ac:chgData name="Reza Amini Hounejani" userId="36cb0b73-58b2-4568-a1ab-00cd49301806" providerId="ADAL" clId="{84A10D71-B01E-9142-B24E-0E68A42C5837}" dt="2023-01-17T09:42:29.700" v="513" actId="408"/>
          <ac:grpSpMkLst>
            <pc:docMk/>
            <pc:sldMk cId="1450487343" sldId="262"/>
            <ac:grpSpMk id="9" creationId="{CF9E55A9-60A6-FC93-7EA5-CEA473C8C5AF}"/>
          </ac:grpSpMkLst>
        </pc:grpChg>
        <pc:grpChg chg="mod">
          <ac:chgData name="Reza Amini Hounejani" userId="36cb0b73-58b2-4568-a1ab-00cd49301806" providerId="ADAL" clId="{84A10D71-B01E-9142-B24E-0E68A42C5837}" dt="2023-01-17T09:42:29.700" v="513" actId="408"/>
          <ac:grpSpMkLst>
            <pc:docMk/>
            <pc:sldMk cId="1450487343" sldId="262"/>
            <ac:grpSpMk id="24" creationId="{30557901-5FF3-DF03-7E2A-0A7150210D69}"/>
          </ac:grpSpMkLst>
        </pc:grpChg>
        <pc:grpChg chg="add del mod">
          <ac:chgData name="Reza Amini Hounejani" userId="36cb0b73-58b2-4568-a1ab-00cd49301806" providerId="ADAL" clId="{84A10D71-B01E-9142-B24E-0E68A42C5837}" dt="2023-01-17T09:31:48.822" v="466" actId="478"/>
          <ac:grpSpMkLst>
            <pc:docMk/>
            <pc:sldMk cId="1450487343" sldId="262"/>
            <ac:grpSpMk id="30" creationId="{3286BFC5-2491-30E1-59F8-EB16C713CE40}"/>
          </ac:grpSpMkLst>
        </pc:grpChg>
        <pc:picChg chg="add del mod topLvl">
          <ac:chgData name="Reza Amini Hounejani" userId="36cb0b73-58b2-4568-a1ab-00cd49301806" providerId="ADAL" clId="{84A10D71-B01E-9142-B24E-0E68A42C5837}" dt="2023-01-17T09:31:48.822" v="466" actId="478"/>
          <ac:picMkLst>
            <pc:docMk/>
            <pc:sldMk cId="1450487343" sldId="262"/>
            <ac:picMk id="3" creationId="{869B06ED-114A-EBC4-0EC1-424C2E17080E}"/>
          </ac:picMkLst>
        </pc:picChg>
        <pc:picChg chg="del">
          <ac:chgData name="Reza Amini Hounejani" userId="36cb0b73-58b2-4568-a1ab-00cd49301806" providerId="ADAL" clId="{84A10D71-B01E-9142-B24E-0E68A42C5837}" dt="2023-01-16T15:38:03.271" v="177" actId="478"/>
          <ac:picMkLst>
            <pc:docMk/>
            <pc:sldMk cId="1450487343" sldId="262"/>
            <ac:picMk id="27" creationId="{3DB39F34-348C-0783-FFEF-54FDB5AC84E7}"/>
          </ac:picMkLst>
        </pc:picChg>
        <pc:picChg chg="add del mod">
          <ac:chgData name="Reza Amini Hounejani" userId="36cb0b73-58b2-4568-a1ab-00cd49301806" providerId="ADAL" clId="{84A10D71-B01E-9142-B24E-0E68A42C5837}" dt="2023-01-17T11:13:19.276" v="937" actId="478"/>
          <ac:picMkLst>
            <pc:docMk/>
            <pc:sldMk cId="1450487343" sldId="262"/>
            <ac:picMk id="78" creationId="{0487C4C7-7F6C-4F12-D2D9-5218877E33B2}"/>
          </ac:picMkLst>
        </pc:picChg>
        <pc:picChg chg="add mod">
          <ac:chgData name="Reza Amini Hounejani" userId="36cb0b73-58b2-4568-a1ab-00cd49301806" providerId="ADAL" clId="{84A10D71-B01E-9142-B24E-0E68A42C5837}" dt="2023-01-17T11:13:54.118" v="945" actId="1037"/>
          <ac:picMkLst>
            <pc:docMk/>
            <pc:sldMk cId="1450487343" sldId="262"/>
            <ac:picMk id="84" creationId="{00D5556E-6A1A-6CA0-5B1C-E3AEC9402146}"/>
          </ac:picMkLst>
        </pc:picChg>
        <pc:cxnChg chg="add del">
          <ac:chgData name="Reza Amini Hounejani" userId="36cb0b73-58b2-4568-a1ab-00cd49301806" providerId="ADAL" clId="{84A10D71-B01E-9142-B24E-0E68A42C5837}" dt="2023-01-16T15:42:42.540" v="236" actId="478"/>
          <ac:cxnSpMkLst>
            <pc:docMk/>
            <pc:sldMk cId="1450487343" sldId="262"/>
            <ac:cxnSpMk id="33" creationId="{6324701A-59E3-C31E-021F-F3580F2CEAA0}"/>
          </ac:cxnSpMkLst>
        </pc:cxnChg>
        <pc:cxnChg chg="mod">
          <ac:chgData name="Reza Amini Hounejani" userId="36cb0b73-58b2-4568-a1ab-00cd49301806" providerId="ADAL" clId="{84A10D71-B01E-9142-B24E-0E68A42C5837}" dt="2022-12-30T13:40:30.492" v="3" actId="1035"/>
          <ac:cxnSpMkLst>
            <pc:docMk/>
            <pc:sldMk cId="1450487343" sldId="262"/>
            <ac:cxnSpMk id="69" creationId="{DA68FB13-BB27-1CF7-1046-0F3612596237}"/>
          </ac:cxnSpMkLst>
        </pc:cxnChg>
        <pc:cxnChg chg="add del mod">
          <ac:chgData name="Reza Amini Hounejani" userId="36cb0b73-58b2-4568-a1ab-00cd49301806" providerId="ADAL" clId="{84A10D71-B01E-9142-B24E-0E68A42C5837}" dt="2023-01-16T15:44:43.697" v="262" actId="478"/>
          <ac:cxnSpMkLst>
            <pc:docMk/>
            <pc:sldMk cId="1450487343" sldId="262"/>
            <ac:cxnSpMk id="70" creationId="{BE07EA17-8139-B153-4AA9-FD46D18A5CD6}"/>
          </ac:cxnSpMkLst>
        </pc:cxnChg>
        <pc:cxnChg chg="mod">
          <ac:chgData name="Reza Amini Hounejani" userId="36cb0b73-58b2-4568-a1ab-00cd49301806" providerId="ADAL" clId="{84A10D71-B01E-9142-B24E-0E68A42C5837}" dt="2022-12-30T13:40:30.492" v="3" actId="1035"/>
          <ac:cxnSpMkLst>
            <pc:docMk/>
            <pc:sldMk cId="1450487343" sldId="262"/>
            <ac:cxnSpMk id="73" creationId="{AE7AEF68-9C65-CFE4-8BB3-6A0CAD168F71}"/>
          </ac:cxnSpMkLst>
        </pc:cxnChg>
        <pc:cxnChg chg="add del mod">
          <ac:chgData name="Reza Amini Hounejani" userId="36cb0b73-58b2-4568-a1ab-00cd49301806" providerId="ADAL" clId="{84A10D71-B01E-9142-B24E-0E68A42C5837}" dt="2023-01-17T09:36:11.003" v="485" actId="478"/>
          <ac:cxnSpMkLst>
            <pc:docMk/>
            <pc:sldMk cId="1450487343" sldId="262"/>
            <ac:cxnSpMk id="80" creationId="{86025C03-B3AB-2DB6-1A8A-D874A71EE19A}"/>
          </ac:cxnSpMkLst>
        </pc:cxnChg>
        <pc:cxnChg chg="add del">
          <ac:chgData name="Reza Amini Hounejani" userId="36cb0b73-58b2-4568-a1ab-00cd49301806" providerId="ADAL" clId="{84A10D71-B01E-9142-B24E-0E68A42C5837}" dt="2023-01-17T11:13:57.802" v="946" actId="478"/>
          <ac:cxnSpMkLst>
            <pc:docMk/>
            <pc:sldMk cId="1450487343" sldId="262"/>
            <ac:cxnSpMk id="86" creationId="{9AB3B1BA-A2AB-BFAF-9D90-C12B12B72756}"/>
          </ac:cxnSpMkLst>
        </pc:cxnChg>
      </pc:sldChg>
    </pc:docChg>
  </pc:docChgLst>
  <pc:docChgLst>
    <pc:chgData name="Reza Amini Hounejani - TNW" userId="36cb0b73-58b2-4568-a1ab-00cd49301806" providerId="ADAL" clId="{DA8FEA81-1A63-884F-A1C6-520C766F400F}"/>
    <pc:docChg chg="undo custSel modSld">
      <pc:chgData name="Reza Amini Hounejani - TNW" userId="36cb0b73-58b2-4568-a1ab-00cd49301806" providerId="ADAL" clId="{DA8FEA81-1A63-884F-A1C6-520C766F400F}" dt="2022-07-02T11:51:05.088" v="276" actId="1037"/>
      <pc:docMkLst>
        <pc:docMk/>
      </pc:docMkLst>
      <pc:sldChg chg="addSp modSp mod">
        <pc:chgData name="Reza Amini Hounejani - TNW" userId="36cb0b73-58b2-4568-a1ab-00cd49301806" providerId="ADAL" clId="{DA8FEA81-1A63-884F-A1C6-520C766F400F}" dt="2022-07-02T11:50:27.365" v="270" actId="1076"/>
        <pc:sldMkLst>
          <pc:docMk/>
          <pc:sldMk cId="1897538530" sldId="256"/>
        </pc:sldMkLst>
        <pc:spChg chg="add mod">
          <ac:chgData name="Reza Amini Hounejani - TNW" userId="36cb0b73-58b2-4568-a1ab-00cd49301806" providerId="ADAL" clId="{DA8FEA81-1A63-884F-A1C6-520C766F400F}" dt="2022-07-02T10:59:36.630" v="85" actId="207"/>
          <ac:spMkLst>
            <pc:docMk/>
            <pc:sldMk cId="1897538530" sldId="256"/>
            <ac:spMk id="2" creationId="{589EE059-95D0-112B-AB19-4C9C261EEE3C}"/>
          </ac:spMkLst>
        </pc:spChg>
        <pc:spChg chg="mod">
          <ac:chgData name="Reza Amini Hounejani - TNW" userId="36cb0b73-58b2-4568-a1ab-00cd49301806" providerId="ADAL" clId="{DA8FEA81-1A63-884F-A1C6-520C766F400F}" dt="2022-07-02T10:57:20.658" v="40" actId="164"/>
          <ac:spMkLst>
            <pc:docMk/>
            <pc:sldMk cId="1897538530" sldId="256"/>
            <ac:spMk id="5" creationId="{505E1DB5-624F-B6CA-9219-AE1C8EBF4DB0}"/>
          </ac:spMkLst>
        </pc:spChg>
        <pc:spChg chg="mod">
          <ac:chgData name="Reza Amini Hounejani - TNW" userId="36cb0b73-58b2-4568-a1ab-00cd49301806" providerId="ADAL" clId="{DA8FEA81-1A63-884F-A1C6-520C766F400F}" dt="2022-07-02T10:57:20.658" v="40" actId="164"/>
          <ac:spMkLst>
            <pc:docMk/>
            <pc:sldMk cId="1897538530" sldId="256"/>
            <ac:spMk id="6" creationId="{CA32E470-46AA-00CE-3615-D48914F812F9}"/>
          </ac:spMkLst>
        </pc:spChg>
        <pc:spChg chg="mod">
          <ac:chgData name="Reza Amini Hounejani - TNW" userId="36cb0b73-58b2-4568-a1ab-00cd49301806" providerId="ADAL" clId="{DA8FEA81-1A63-884F-A1C6-520C766F400F}" dt="2022-07-02T10:57:20.658" v="40" actId="164"/>
          <ac:spMkLst>
            <pc:docMk/>
            <pc:sldMk cId="1897538530" sldId="256"/>
            <ac:spMk id="7" creationId="{B043A7AC-519E-C97C-2AA3-1B5CE70C0862}"/>
          </ac:spMkLst>
        </pc:spChg>
        <pc:spChg chg="mod">
          <ac:chgData name="Reza Amini Hounejani - TNW" userId="36cb0b73-58b2-4568-a1ab-00cd49301806" providerId="ADAL" clId="{DA8FEA81-1A63-884F-A1C6-520C766F400F}" dt="2022-07-02T10:57:20.658" v="40" actId="164"/>
          <ac:spMkLst>
            <pc:docMk/>
            <pc:sldMk cId="1897538530" sldId="256"/>
            <ac:spMk id="8" creationId="{84A5F68A-6046-7122-C43A-995F0BED5A0B}"/>
          </ac:spMkLst>
        </pc:spChg>
        <pc:spChg chg="mod">
          <ac:chgData name="Reza Amini Hounejani - TNW" userId="36cb0b73-58b2-4568-a1ab-00cd49301806" providerId="ADAL" clId="{DA8FEA81-1A63-884F-A1C6-520C766F400F}" dt="2022-07-02T10:56:47.762" v="38" actId="164"/>
          <ac:spMkLst>
            <pc:docMk/>
            <pc:sldMk cId="1897538530" sldId="256"/>
            <ac:spMk id="9" creationId="{090AD67B-A437-F4BC-E6AF-C57DC8490D84}"/>
          </ac:spMkLst>
        </pc:spChg>
        <pc:spChg chg="mod">
          <ac:chgData name="Reza Amini Hounejani - TNW" userId="36cb0b73-58b2-4568-a1ab-00cd49301806" providerId="ADAL" clId="{DA8FEA81-1A63-884F-A1C6-520C766F400F}" dt="2022-07-02T10:56:47.762" v="38" actId="164"/>
          <ac:spMkLst>
            <pc:docMk/>
            <pc:sldMk cId="1897538530" sldId="256"/>
            <ac:spMk id="10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50:21.637" v="269" actId="1035"/>
          <ac:spMkLst>
            <pc:docMk/>
            <pc:sldMk cId="1897538530" sldId="256"/>
            <ac:spMk id="11" creationId="{769CB33A-8F1B-0BB0-F422-DAABE806D33D}"/>
          </ac:spMkLst>
        </pc:spChg>
        <pc:spChg chg="mod">
          <ac:chgData name="Reza Amini Hounejani - TNW" userId="36cb0b73-58b2-4568-a1ab-00cd49301806" providerId="ADAL" clId="{DA8FEA81-1A63-884F-A1C6-520C766F400F}" dt="2022-07-02T10:56:47.762" v="38" actId="164"/>
          <ac:spMkLst>
            <pc:docMk/>
            <pc:sldMk cId="1897538530" sldId="256"/>
            <ac:spMk id="22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0:56:47.762" v="38" actId="164"/>
          <ac:spMkLst>
            <pc:docMk/>
            <pc:sldMk cId="1897538530" sldId="256"/>
            <ac:spMk id="23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0:57:32.889" v="42" actId="1076"/>
          <ac:spMkLst>
            <pc:docMk/>
            <pc:sldMk cId="1897538530" sldId="256"/>
            <ac:spMk id="24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71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4:18.147" v="243" actId="1076"/>
          <ac:spMkLst>
            <pc:docMk/>
            <pc:sldMk cId="1897538530" sldId="256"/>
            <ac:spMk id="72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73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74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75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76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77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78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98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99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13:46.750" v="162" actId="1076"/>
          <ac:spMkLst>
            <pc:docMk/>
            <pc:sldMk cId="1897538530" sldId="256"/>
            <ac:spMk id="100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05:59.483" v="126" actId="1076"/>
          <ac:spMkLst>
            <pc:docMk/>
            <pc:sldMk cId="1897538530" sldId="256"/>
            <ac:spMk id="101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05:59.483" v="126" actId="1076"/>
          <ac:spMkLst>
            <pc:docMk/>
            <pc:sldMk cId="1897538530" sldId="256"/>
            <ac:spMk id="102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13:46.750" v="162" actId="1076"/>
          <ac:spMkLst>
            <pc:docMk/>
            <pc:sldMk cId="1897538530" sldId="256"/>
            <ac:spMk id="107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13:46.750" v="162" actId="1076"/>
          <ac:spMkLst>
            <pc:docMk/>
            <pc:sldMk cId="1897538530" sldId="256"/>
            <ac:spMk id="108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13:46.750" v="162" actId="1076"/>
          <ac:spMkLst>
            <pc:docMk/>
            <pc:sldMk cId="1897538530" sldId="256"/>
            <ac:spMk id="109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14:25.817" v="183" actId="1037"/>
          <ac:spMkLst>
            <pc:docMk/>
            <pc:sldMk cId="1897538530" sldId="256"/>
            <ac:spMk id="111" creationId="{29FAE0B7-002A-12D2-CB48-182F56221F1B}"/>
          </ac:spMkLst>
        </pc:spChg>
        <pc:spChg chg="mod">
          <ac:chgData name="Reza Amini Hounejani - TNW" userId="36cb0b73-58b2-4568-a1ab-00cd49301806" providerId="ADAL" clId="{DA8FEA81-1A63-884F-A1C6-520C766F400F}" dt="2022-07-02T11:13:46.750" v="162" actId="1076"/>
          <ac:spMkLst>
            <pc:docMk/>
            <pc:sldMk cId="1897538530" sldId="256"/>
            <ac:spMk id="112" creationId="{0E0F9144-43C6-8FBB-8A21-50B0472AA7FB}"/>
          </ac:spMkLst>
        </pc:spChg>
        <pc:spChg chg="mod">
          <ac:chgData name="Reza Amini Hounejani - TNW" userId="36cb0b73-58b2-4568-a1ab-00cd49301806" providerId="ADAL" clId="{DA8FEA81-1A63-884F-A1C6-520C766F400F}" dt="2022-07-02T11:13:46.750" v="162" actId="1076"/>
          <ac:spMkLst>
            <pc:docMk/>
            <pc:sldMk cId="1897538530" sldId="256"/>
            <ac:spMk id="114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04:34.220" v="88" actId="1076"/>
          <ac:spMkLst>
            <pc:docMk/>
            <pc:sldMk cId="1897538530" sldId="256"/>
            <ac:spMk id="115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7:01.733" v="254" actId="1076"/>
          <ac:spMkLst>
            <pc:docMk/>
            <pc:sldMk cId="1897538530" sldId="256"/>
            <ac:spMk id="116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2:51.388" v="222" actId="1036"/>
          <ac:spMkLst>
            <pc:docMk/>
            <pc:sldMk cId="1897538530" sldId="256"/>
            <ac:spMk id="117" creationId="{B6DB756B-85E9-14FD-3288-B366DFFE1DDC}"/>
          </ac:spMkLst>
        </pc:spChg>
        <pc:spChg chg="mod">
          <ac:chgData name="Reza Amini Hounejani - TNW" userId="36cb0b73-58b2-4568-a1ab-00cd49301806" providerId="ADAL" clId="{DA8FEA81-1A63-884F-A1C6-520C766F400F}" dt="2022-07-02T11:22:20.195" v="215" actId="553"/>
          <ac:spMkLst>
            <pc:docMk/>
            <pc:sldMk cId="1897538530" sldId="256"/>
            <ac:spMk id="120" creationId="{BEC9A2A9-9593-0507-9628-629F19E4CB85}"/>
          </ac:spMkLst>
        </pc:spChg>
        <pc:spChg chg="mod">
          <ac:chgData name="Reza Amini Hounejani - TNW" userId="36cb0b73-58b2-4568-a1ab-00cd49301806" providerId="ADAL" clId="{DA8FEA81-1A63-884F-A1C6-520C766F400F}" dt="2022-07-02T11:22:20.195" v="215" actId="553"/>
          <ac:spMkLst>
            <pc:docMk/>
            <pc:sldMk cId="1897538530" sldId="256"/>
            <ac:spMk id="121" creationId="{00C12F5B-2AF5-BD5C-41AA-75B0583A169C}"/>
          </ac:spMkLst>
        </pc:spChg>
        <pc:spChg chg="mod">
          <ac:chgData name="Reza Amini Hounejani - TNW" userId="36cb0b73-58b2-4568-a1ab-00cd49301806" providerId="ADAL" clId="{DA8FEA81-1A63-884F-A1C6-520C766F400F}" dt="2022-07-02T11:22:20.195" v="215" actId="553"/>
          <ac:spMkLst>
            <pc:docMk/>
            <pc:sldMk cId="1897538530" sldId="256"/>
            <ac:spMk id="122" creationId="{8F42A81C-EEF7-A4A8-316D-2495617E6F45}"/>
          </ac:spMkLst>
        </pc:spChg>
        <pc:spChg chg="add mod">
          <ac:chgData name="Reza Amini Hounejani - TNW" userId="36cb0b73-58b2-4568-a1ab-00cd49301806" providerId="ADAL" clId="{DA8FEA81-1A63-884F-A1C6-520C766F400F}" dt="2022-07-02T10:58:24.377" v="79" actId="1037"/>
          <ac:spMkLst>
            <pc:docMk/>
            <pc:sldMk cId="1897538530" sldId="256"/>
            <ac:spMk id="123" creationId="{146F7A48-564C-4B51-2F96-F57E8519AD59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124" creationId="{930335FC-659F-DD76-B5FA-836BD39F1BD5}"/>
          </ac:spMkLst>
        </pc:spChg>
        <pc:spChg chg="mod">
          <ac:chgData name="Reza Amini Hounejani - TNW" userId="36cb0b73-58b2-4568-a1ab-00cd49301806" providerId="ADAL" clId="{DA8FEA81-1A63-884F-A1C6-520C766F400F}" dt="2022-07-02T11:22:44.252" v="220" actId="1036"/>
          <ac:spMkLst>
            <pc:docMk/>
            <pc:sldMk cId="1897538530" sldId="256"/>
            <ac:spMk id="125" creationId="{00000000-0000-0000-0000-000000000000}"/>
          </ac:spMkLst>
        </pc:spChg>
        <pc:spChg chg="mod">
          <ac:chgData name="Reza Amini Hounejani - TNW" userId="36cb0b73-58b2-4568-a1ab-00cd49301806" providerId="ADAL" clId="{DA8FEA81-1A63-884F-A1C6-520C766F400F}" dt="2022-07-02T11:23:01.247" v="231" actId="1037"/>
          <ac:spMkLst>
            <pc:docMk/>
            <pc:sldMk cId="1897538530" sldId="256"/>
            <ac:spMk id="126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2:51.388" v="222" actId="1036"/>
          <ac:spMkLst>
            <pc:docMk/>
            <pc:sldMk cId="1897538530" sldId="256"/>
            <ac:spMk id="128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2:51.388" v="222" actId="1036"/>
          <ac:spMkLst>
            <pc:docMk/>
            <pc:sldMk cId="1897538530" sldId="256"/>
            <ac:spMk id="130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2:51.388" v="222" actId="1036"/>
          <ac:spMkLst>
            <pc:docMk/>
            <pc:sldMk cId="1897538530" sldId="256"/>
            <ac:spMk id="132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18:23.598" v="204" actId="1076"/>
          <ac:spMkLst>
            <pc:docMk/>
            <pc:sldMk cId="1897538530" sldId="256"/>
            <ac:spMk id="133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15:55.752" v="190" actId="1076"/>
          <ac:spMkLst>
            <pc:docMk/>
            <pc:sldMk cId="1897538530" sldId="256"/>
            <ac:spMk id="134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09:09.771" v="150" actId="164"/>
          <ac:spMkLst>
            <pc:docMk/>
            <pc:sldMk cId="1897538530" sldId="256"/>
            <ac:spMk id="135" creationId="{00000000-0000-0000-0000-000000000000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136" creationId="{630B5ACD-D41D-2739-8018-35EC0EF26891}"/>
          </ac:spMkLst>
        </pc:spChg>
        <pc:spChg chg="mod">
          <ac:chgData name="Reza Amini Hounejani - TNW" userId="36cb0b73-58b2-4568-a1ab-00cd49301806" providerId="ADAL" clId="{DA8FEA81-1A63-884F-A1C6-520C766F400F}" dt="2022-07-02T11:22:20.195" v="215" actId="553"/>
          <ac:spMkLst>
            <pc:docMk/>
            <pc:sldMk cId="1897538530" sldId="256"/>
            <ac:spMk id="137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2:20.195" v="215" actId="553"/>
          <ac:spMkLst>
            <pc:docMk/>
            <pc:sldMk cId="1897538530" sldId="256"/>
            <ac:spMk id="138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2:20.195" v="215" actId="553"/>
          <ac:spMkLst>
            <pc:docMk/>
            <pc:sldMk cId="1897538530" sldId="256"/>
            <ac:spMk id="139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2:20.195" v="215" actId="553"/>
          <ac:spMkLst>
            <pc:docMk/>
            <pc:sldMk cId="1897538530" sldId="256"/>
            <ac:spMk id="140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2:20.195" v="215" actId="553"/>
          <ac:spMkLst>
            <pc:docMk/>
            <pc:sldMk cId="1897538530" sldId="256"/>
            <ac:spMk id="141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5:16.809" v="248" actId="1076"/>
          <ac:spMkLst>
            <pc:docMk/>
            <pc:sldMk cId="1897538530" sldId="256"/>
            <ac:spMk id="142" creationId="{48047047-4ACF-D85E-067B-B7175D8E9997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143" creationId="{5D262CFA-0F69-5CBF-F348-2A9A812539EE}"/>
          </ac:spMkLst>
        </pc:spChg>
        <pc:spChg chg="add mod">
          <ac:chgData name="Reza Amini Hounejani - TNW" userId="36cb0b73-58b2-4568-a1ab-00cd49301806" providerId="ADAL" clId="{DA8FEA81-1A63-884F-A1C6-520C766F400F}" dt="2022-07-02T11:00:22.889" v="86" actId="207"/>
          <ac:spMkLst>
            <pc:docMk/>
            <pc:sldMk cId="1897538530" sldId="256"/>
            <ac:spMk id="144" creationId="{7EB04F13-5425-119D-607B-2A54E33D1E96}"/>
          </ac:spMkLst>
        </pc:spChg>
        <pc:spChg chg="mod">
          <ac:chgData name="Reza Amini Hounejani - TNW" userId="36cb0b73-58b2-4568-a1ab-00cd49301806" providerId="ADAL" clId="{DA8FEA81-1A63-884F-A1C6-520C766F400F}" dt="2022-07-02T11:14:25.817" v="183" actId="1037"/>
          <ac:spMkLst>
            <pc:docMk/>
            <pc:sldMk cId="1897538530" sldId="256"/>
            <ac:spMk id="145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14:25.817" v="183" actId="1037"/>
          <ac:spMkLst>
            <pc:docMk/>
            <pc:sldMk cId="1897538530" sldId="256"/>
            <ac:spMk id="146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14:15.992" v="168" actId="1076"/>
          <ac:spMkLst>
            <pc:docMk/>
            <pc:sldMk cId="1897538530" sldId="256"/>
            <ac:spMk id="147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7:07.868" v="255" actId="1076"/>
          <ac:spMkLst>
            <pc:docMk/>
            <pc:sldMk cId="1897538530" sldId="256"/>
            <ac:spMk id="148" creationId="{0E3A8FA3-C11D-4C61-3AFB-B69205167F17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150" creationId="{B99E9AB2-8FA5-22A2-8556-3C4C0189734C}"/>
          </ac:spMkLst>
        </pc:spChg>
        <pc:spChg chg="add mod">
          <ac:chgData name="Reza Amini Hounejani - TNW" userId="36cb0b73-58b2-4568-a1ab-00cd49301806" providerId="ADAL" clId="{DA8FEA81-1A63-884F-A1C6-520C766F400F}" dt="2022-07-02T11:00:32.505" v="87" actId="207"/>
          <ac:spMkLst>
            <pc:docMk/>
            <pc:sldMk cId="1897538530" sldId="256"/>
            <ac:spMk id="151" creationId="{A687D421-F050-DAD7-838A-A3154C6F835E}"/>
          </ac:spMkLst>
        </pc:spChg>
        <pc:spChg chg="add mod">
          <ac:chgData name="Reza Amini Hounejani - TNW" userId="36cb0b73-58b2-4568-a1ab-00cd49301806" providerId="ADAL" clId="{DA8FEA81-1A63-884F-A1C6-520C766F400F}" dt="2022-07-02T11:50:09.125" v="265" actId="14100"/>
          <ac:spMkLst>
            <pc:docMk/>
            <pc:sldMk cId="1897538530" sldId="256"/>
            <ac:spMk id="152" creationId="{4915224A-FE65-0DCD-DEEA-44DAA440410E}"/>
          </ac:spMkLst>
        </pc:spChg>
        <pc:spChg chg="mod">
          <ac:chgData name="Reza Amini Hounejani - TNW" userId="36cb0b73-58b2-4568-a1ab-00cd49301806" providerId="ADAL" clId="{DA8FEA81-1A63-884F-A1C6-520C766F400F}" dt="2022-07-02T11:50:27.365" v="270" actId="1076"/>
          <ac:spMkLst>
            <pc:docMk/>
            <pc:sldMk cId="1897538530" sldId="256"/>
            <ac:spMk id="154" creationId="{EDA71FA1-2411-B55C-19D8-C0FD34C28F29}"/>
          </ac:spMkLst>
        </pc:spChg>
        <pc:spChg chg="mod">
          <ac:chgData name="Reza Amini Hounejani - TNW" userId="36cb0b73-58b2-4568-a1ab-00cd49301806" providerId="ADAL" clId="{DA8FEA81-1A63-884F-A1C6-520C766F400F}" dt="2022-07-02T11:24:12.348" v="242" actId="1076"/>
          <ac:spMkLst>
            <pc:docMk/>
            <pc:sldMk cId="1897538530" sldId="256"/>
            <ac:spMk id="155" creationId="{F5AD87F5-2514-2E95-5B6F-61A2B5125971}"/>
          </ac:spMkLst>
        </pc:spChg>
        <pc:spChg chg="mod">
          <ac:chgData name="Reza Amini Hounejani - TNW" userId="36cb0b73-58b2-4568-a1ab-00cd49301806" providerId="ADAL" clId="{DA8FEA81-1A63-884F-A1C6-520C766F400F}" dt="2022-07-02T11:25:18.800" v="249" actId="1076"/>
          <ac:spMkLst>
            <pc:docMk/>
            <pc:sldMk cId="1897538530" sldId="256"/>
            <ac:spMk id="156" creationId="{5A5051A2-0B2B-84B0-D7DB-4216A86C687B}"/>
          </ac:spMkLst>
        </pc:spChg>
        <pc:spChg chg="mod">
          <ac:chgData name="Reza Amini Hounejani - TNW" userId="36cb0b73-58b2-4568-a1ab-00cd49301806" providerId="ADAL" clId="{DA8FEA81-1A63-884F-A1C6-520C766F400F}" dt="2022-07-02T11:50:13.574" v="266" actId="1076"/>
          <ac:spMkLst>
            <pc:docMk/>
            <pc:sldMk cId="1897538530" sldId="256"/>
            <ac:spMk id="157" creationId="{74BD0321-D7D2-D785-5553-4DC9CF66A128}"/>
          </ac:spMkLst>
        </pc:spChg>
        <pc:spChg chg="mod">
          <ac:chgData name="Reza Amini Hounejani - TNW" userId="36cb0b73-58b2-4568-a1ab-00cd49301806" providerId="ADAL" clId="{DA8FEA81-1A63-884F-A1C6-520C766F400F}" dt="2022-07-02T11:13:46.750" v="162" actId="1076"/>
          <ac:spMkLst>
            <pc:docMk/>
            <pc:sldMk cId="1897538530" sldId="256"/>
            <ac:spMk id="159" creationId="{86ACCBD4-48E2-9B99-46F5-49AF2F690C17}"/>
          </ac:spMkLst>
        </pc:spChg>
        <pc:spChg chg="mod">
          <ac:chgData name="Reza Amini Hounejani - TNW" userId="36cb0b73-58b2-4568-a1ab-00cd49301806" providerId="ADAL" clId="{DA8FEA81-1A63-884F-A1C6-520C766F400F}" dt="2022-07-02T11:13:46.750" v="162" actId="1076"/>
          <ac:spMkLst>
            <pc:docMk/>
            <pc:sldMk cId="1897538530" sldId="256"/>
            <ac:spMk id="160" creationId="{B26AF495-7735-BB05-3D93-6FAF7E87B732}"/>
          </ac:spMkLst>
        </pc:spChg>
        <pc:spChg chg="mod">
          <ac:chgData name="Reza Amini Hounejani - TNW" userId="36cb0b73-58b2-4568-a1ab-00cd49301806" providerId="ADAL" clId="{DA8FEA81-1A63-884F-A1C6-520C766F400F}" dt="2022-07-02T11:13:46.750" v="162" actId="1076"/>
          <ac:spMkLst>
            <pc:docMk/>
            <pc:sldMk cId="1897538530" sldId="256"/>
            <ac:spMk id="161" creationId="{21C253B9-B4A4-C96A-FDBC-74B93F80305A}"/>
          </ac:spMkLst>
        </pc:spChg>
        <pc:grpChg chg="add mod">
          <ac:chgData name="Reza Amini Hounejani - TNW" userId="36cb0b73-58b2-4568-a1ab-00cd49301806" providerId="ADAL" clId="{DA8FEA81-1A63-884F-A1C6-520C766F400F}" dt="2022-07-02T10:58:55.680" v="84" actId="1076"/>
          <ac:grpSpMkLst>
            <pc:docMk/>
            <pc:sldMk cId="1897538530" sldId="256"/>
            <ac:grpSpMk id="15" creationId="{0E0DE539-0821-FBD5-DDB3-8D36051C8870}"/>
          </ac:grpSpMkLst>
        </pc:grpChg>
        <pc:grpChg chg="add mod">
          <ac:chgData name="Reza Amini Hounejani - TNW" userId="36cb0b73-58b2-4568-a1ab-00cd49301806" providerId="ADAL" clId="{DA8FEA81-1A63-884F-A1C6-520C766F400F}" dt="2022-07-02T10:58:31.327" v="80" actId="1076"/>
          <ac:grpSpMkLst>
            <pc:docMk/>
            <pc:sldMk cId="1897538530" sldId="256"/>
            <ac:grpSpMk id="27" creationId="{5A30EF21-C5F4-DDFF-FBC7-2AD949288FC4}"/>
          </ac:grpSpMkLst>
        </pc:grpChg>
        <pc:grpChg chg="add mod">
          <ac:chgData name="Reza Amini Hounejani - TNW" userId="36cb0b73-58b2-4568-a1ab-00cd49301806" providerId="ADAL" clId="{DA8FEA81-1A63-884F-A1C6-520C766F400F}" dt="2022-07-02T11:09:09.771" v="150" actId="164"/>
          <ac:grpSpMkLst>
            <pc:docMk/>
            <pc:sldMk cId="1897538530" sldId="256"/>
            <ac:grpSpMk id="28" creationId="{212053BB-F745-B57A-8E70-A8A2DF139B15}"/>
          </ac:grpSpMkLst>
        </pc:grpChg>
        <pc:grpChg chg="add mod">
          <ac:chgData name="Reza Amini Hounejani - TNW" userId="36cb0b73-58b2-4568-a1ab-00cd49301806" providerId="ADAL" clId="{DA8FEA81-1A63-884F-A1C6-520C766F400F}" dt="2022-07-02T11:09:09.157" v="149" actId="164"/>
          <ac:grpSpMkLst>
            <pc:docMk/>
            <pc:sldMk cId="1897538530" sldId="256"/>
            <ac:grpSpMk id="29" creationId="{11648FB3-ACEF-20CC-F496-7DE89551EB3A}"/>
          </ac:grpSpMkLst>
        </pc:grpChg>
        <pc:grpChg chg="add mod">
          <ac:chgData name="Reza Amini Hounejani - TNW" userId="36cb0b73-58b2-4568-a1ab-00cd49301806" providerId="ADAL" clId="{DA8FEA81-1A63-884F-A1C6-520C766F400F}" dt="2022-07-02T11:26:51.962" v="253" actId="1076"/>
          <ac:grpSpMkLst>
            <pc:docMk/>
            <pc:sldMk cId="1897538530" sldId="256"/>
            <ac:grpSpMk id="30" creationId="{3888149E-BC7A-4F05-1EED-717EB2D18C3C}"/>
          </ac:grpSpMkLst>
        </pc:grpChg>
        <pc:grpChg chg="mod">
          <ac:chgData name="Reza Amini Hounejani - TNW" userId="36cb0b73-58b2-4568-a1ab-00cd49301806" providerId="ADAL" clId="{DA8FEA81-1A63-884F-A1C6-520C766F400F}" dt="2022-07-02T11:05:40.685" v="125" actId="1076"/>
          <ac:grpSpMkLst>
            <pc:docMk/>
            <pc:sldMk cId="1897538530" sldId="256"/>
            <ac:grpSpMk id="51" creationId="{46C2A38E-B780-76C6-E49E-0C103A01FC8B}"/>
          </ac:grpSpMkLst>
        </pc:grpChg>
        <pc:grpChg chg="mod">
          <ac:chgData name="Reza Amini Hounejani - TNW" userId="36cb0b73-58b2-4568-a1ab-00cd49301806" providerId="ADAL" clId="{DA8FEA81-1A63-884F-A1C6-520C766F400F}" dt="2022-07-02T11:24:12.348" v="242" actId="1076"/>
          <ac:grpSpMkLst>
            <pc:docMk/>
            <pc:sldMk cId="1897538530" sldId="256"/>
            <ac:grpSpMk id="92" creationId="{71349972-97BC-A30C-F6DB-CF00BA3B717F}"/>
          </ac:grpSpMkLst>
        </pc:grpChg>
        <pc:grpChg chg="mod">
          <ac:chgData name="Reza Amini Hounejani - TNW" userId="36cb0b73-58b2-4568-a1ab-00cd49301806" providerId="ADAL" clId="{DA8FEA81-1A63-884F-A1C6-520C766F400F}" dt="2022-07-02T11:09:22.316" v="152" actId="164"/>
          <ac:grpSpMkLst>
            <pc:docMk/>
            <pc:sldMk cId="1897538530" sldId="256"/>
            <ac:grpSpMk id="149" creationId="{00000000-0000-0000-0000-000000000000}"/>
          </ac:grpSpMkLst>
        </pc:grpChg>
        <pc:picChg chg="mod">
          <ac:chgData name="Reza Amini Hounejani - TNW" userId="36cb0b73-58b2-4568-a1ab-00cd49301806" providerId="ADAL" clId="{DA8FEA81-1A63-884F-A1C6-520C766F400F}" dt="2022-07-02T11:24:54.605" v="245" actId="14100"/>
          <ac:picMkLst>
            <pc:docMk/>
            <pc:sldMk cId="1897538530" sldId="256"/>
            <ac:picMk id="3" creationId="{5D098A37-6317-9736-34A9-A596995BB8C7}"/>
          </ac:picMkLst>
        </pc:picChg>
        <pc:picChg chg="mod modCrop">
          <ac:chgData name="Reza Amini Hounejani - TNW" userId="36cb0b73-58b2-4568-a1ab-00cd49301806" providerId="ADAL" clId="{DA8FEA81-1A63-884F-A1C6-520C766F400F}" dt="2022-07-02T10:56:47.762" v="38" actId="164"/>
          <ac:picMkLst>
            <pc:docMk/>
            <pc:sldMk cId="1897538530" sldId="256"/>
            <ac:picMk id="4" creationId="{4824BA92-6EA2-D0D4-B1F5-137E8D45454E}"/>
          </ac:picMkLst>
        </pc:picChg>
        <pc:picChg chg="mod">
          <ac:chgData name="Reza Amini Hounejani - TNW" userId="36cb0b73-58b2-4568-a1ab-00cd49301806" providerId="ADAL" clId="{DA8FEA81-1A63-884F-A1C6-520C766F400F}" dt="2022-07-02T11:24:54.605" v="245" actId="14100"/>
          <ac:picMkLst>
            <pc:docMk/>
            <pc:sldMk cId="1897538530" sldId="256"/>
            <ac:picMk id="14" creationId="{F3F7B853-6725-FEB8-CA7F-FA0C53EDC6D8}"/>
          </ac:picMkLst>
        </pc:picChg>
        <pc:picChg chg="mod">
          <ac:chgData name="Reza Amini Hounejani - TNW" userId="36cb0b73-58b2-4568-a1ab-00cd49301806" providerId="ADAL" clId="{DA8FEA81-1A63-884F-A1C6-520C766F400F}" dt="2022-07-02T11:16:12.073" v="196" actId="1038"/>
          <ac:picMkLst>
            <pc:docMk/>
            <pc:sldMk cId="1897538530" sldId="256"/>
            <ac:picMk id="25" creationId="{6B2C83D6-EA82-D3A2-495C-6CE88422B896}"/>
          </ac:picMkLst>
        </pc:picChg>
        <pc:picChg chg="mod">
          <ac:chgData name="Reza Amini Hounejani - TNW" userId="36cb0b73-58b2-4568-a1ab-00cd49301806" providerId="ADAL" clId="{DA8FEA81-1A63-884F-A1C6-520C766F400F}" dt="2022-07-02T11:24:54.605" v="245" actId="14100"/>
          <ac:picMkLst>
            <pc:docMk/>
            <pc:sldMk cId="1897538530" sldId="256"/>
            <ac:picMk id="26" creationId="{A705A029-0E17-7CDD-358B-78092A0670E0}"/>
          </ac:picMkLst>
        </pc:picChg>
        <pc:picChg chg="mod">
          <ac:chgData name="Reza Amini Hounejani - TNW" userId="36cb0b73-58b2-4568-a1ab-00cd49301806" providerId="ADAL" clId="{DA8FEA81-1A63-884F-A1C6-520C766F400F}" dt="2022-07-02T11:24:54.605" v="245" actId="14100"/>
          <ac:picMkLst>
            <pc:docMk/>
            <pc:sldMk cId="1897538530" sldId="256"/>
            <ac:picMk id="79" creationId="{0DC710D8-D5DD-C780-C469-0F9B8C9D4EDB}"/>
          </ac:picMkLst>
        </pc:picChg>
        <pc:picChg chg="mod">
          <ac:chgData name="Reza Amini Hounejani - TNW" userId="36cb0b73-58b2-4568-a1ab-00cd49301806" providerId="ADAL" clId="{DA8FEA81-1A63-884F-A1C6-520C766F400F}" dt="2022-07-02T11:24:54.605" v="245" actId="14100"/>
          <ac:picMkLst>
            <pc:docMk/>
            <pc:sldMk cId="1897538530" sldId="256"/>
            <ac:picMk id="82" creationId="{28628A61-6D40-4172-4954-59BF7F95D994}"/>
          </ac:picMkLst>
        </pc:picChg>
        <pc:picChg chg="mod">
          <ac:chgData name="Reza Amini Hounejani - TNW" userId="36cb0b73-58b2-4568-a1ab-00cd49301806" providerId="ADAL" clId="{DA8FEA81-1A63-884F-A1C6-520C766F400F}" dt="2022-07-02T11:48:49.229" v="257" actId="553"/>
          <ac:picMkLst>
            <pc:docMk/>
            <pc:sldMk cId="1897538530" sldId="256"/>
            <ac:picMk id="84" creationId="{A37523EA-7B41-0EE9-C877-3A73D6AC3CFC}"/>
          </ac:picMkLst>
        </pc:picChg>
        <pc:picChg chg="mod">
          <ac:chgData name="Reza Amini Hounejani - TNW" userId="36cb0b73-58b2-4568-a1ab-00cd49301806" providerId="ADAL" clId="{DA8FEA81-1A63-884F-A1C6-520C766F400F}" dt="2022-07-02T11:24:12.348" v="242" actId="1076"/>
          <ac:picMkLst>
            <pc:docMk/>
            <pc:sldMk cId="1897538530" sldId="256"/>
            <ac:picMk id="87" creationId="{DAE1C288-43A9-30C8-3594-A124A42FA9DC}"/>
          </ac:picMkLst>
        </pc:picChg>
        <pc:picChg chg="mod">
          <ac:chgData name="Reza Amini Hounejani - TNW" userId="36cb0b73-58b2-4568-a1ab-00cd49301806" providerId="ADAL" clId="{DA8FEA81-1A63-884F-A1C6-520C766F400F}" dt="2022-07-02T11:24:12.348" v="242" actId="1076"/>
          <ac:picMkLst>
            <pc:docMk/>
            <pc:sldMk cId="1897538530" sldId="256"/>
            <ac:picMk id="89" creationId="{0F436085-0BA3-8D68-B1B0-AF763068E6AD}"/>
          </ac:picMkLst>
        </pc:picChg>
        <pc:cxnChg chg="mod">
          <ac:chgData name="Reza Amini Hounejani - TNW" userId="36cb0b73-58b2-4568-a1ab-00cd49301806" providerId="ADAL" clId="{DA8FEA81-1A63-884F-A1C6-520C766F400F}" dt="2022-07-02T10:56:47.762" v="38" actId="164"/>
          <ac:cxnSpMkLst>
            <pc:docMk/>
            <pc:sldMk cId="1897538530" sldId="256"/>
            <ac:cxnSpMk id="12" creationId="{00000000-0000-0000-0000-000000000000}"/>
          </ac:cxnSpMkLst>
        </pc:cxnChg>
        <pc:cxnChg chg="mod">
          <ac:chgData name="Reza Amini Hounejani - TNW" userId="36cb0b73-58b2-4568-a1ab-00cd49301806" providerId="ADAL" clId="{DA8FEA81-1A63-884F-A1C6-520C766F400F}" dt="2022-07-02T10:56:47.762" v="38" actId="164"/>
          <ac:cxnSpMkLst>
            <pc:docMk/>
            <pc:sldMk cId="1897538530" sldId="256"/>
            <ac:cxnSpMk id="13" creationId="{00000000-0000-0000-0000-000000000000}"/>
          </ac:cxnSpMkLst>
        </pc:cxnChg>
        <pc:cxnChg chg="mod">
          <ac:chgData name="Reza Amini Hounejani - TNW" userId="36cb0b73-58b2-4568-a1ab-00cd49301806" providerId="ADAL" clId="{DA8FEA81-1A63-884F-A1C6-520C766F400F}" dt="2022-07-02T10:56:47.762" v="38" actId="164"/>
          <ac:cxnSpMkLst>
            <pc:docMk/>
            <pc:sldMk cId="1897538530" sldId="256"/>
            <ac:cxnSpMk id="16" creationId="{00000000-0000-0000-0000-000000000000}"/>
          </ac:cxnSpMkLst>
        </pc:cxnChg>
        <pc:cxnChg chg="mod">
          <ac:chgData name="Reza Amini Hounejani - TNW" userId="36cb0b73-58b2-4568-a1ab-00cd49301806" providerId="ADAL" clId="{DA8FEA81-1A63-884F-A1C6-520C766F400F}" dt="2022-07-02T10:56:47.762" v="38" actId="164"/>
          <ac:cxnSpMkLst>
            <pc:docMk/>
            <pc:sldMk cId="1897538530" sldId="256"/>
            <ac:cxnSpMk id="17" creationId="{00000000-0000-0000-0000-000000000000}"/>
          </ac:cxnSpMkLst>
        </pc:cxnChg>
        <pc:cxnChg chg="mod">
          <ac:chgData name="Reza Amini Hounejani - TNW" userId="36cb0b73-58b2-4568-a1ab-00cd49301806" providerId="ADAL" clId="{DA8FEA81-1A63-884F-A1C6-520C766F400F}" dt="2022-07-02T10:56:47.762" v="38" actId="164"/>
          <ac:cxnSpMkLst>
            <pc:docMk/>
            <pc:sldMk cId="1897538530" sldId="256"/>
            <ac:cxnSpMk id="18" creationId="{00000000-0000-0000-0000-000000000000}"/>
          </ac:cxnSpMkLst>
        </pc:cxnChg>
        <pc:cxnChg chg="mod">
          <ac:chgData name="Reza Amini Hounejani - TNW" userId="36cb0b73-58b2-4568-a1ab-00cd49301806" providerId="ADAL" clId="{DA8FEA81-1A63-884F-A1C6-520C766F400F}" dt="2022-07-02T10:56:47.762" v="38" actId="164"/>
          <ac:cxnSpMkLst>
            <pc:docMk/>
            <pc:sldMk cId="1897538530" sldId="256"/>
            <ac:cxnSpMk id="19" creationId="{00000000-0000-0000-0000-000000000000}"/>
          </ac:cxnSpMkLst>
        </pc:cxnChg>
        <pc:cxnChg chg="mod">
          <ac:chgData name="Reza Amini Hounejani - TNW" userId="36cb0b73-58b2-4568-a1ab-00cd49301806" providerId="ADAL" clId="{DA8FEA81-1A63-884F-A1C6-520C766F400F}" dt="2022-07-02T10:56:47.762" v="38" actId="164"/>
          <ac:cxnSpMkLst>
            <pc:docMk/>
            <pc:sldMk cId="1897538530" sldId="256"/>
            <ac:cxnSpMk id="20" creationId="{00000000-0000-0000-0000-000000000000}"/>
          </ac:cxnSpMkLst>
        </pc:cxnChg>
        <pc:cxnChg chg="mod">
          <ac:chgData name="Reza Amini Hounejani - TNW" userId="36cb0b73-58b2-4568-a1ab-00cd49301806" providerId="ADAL" clId="{DA8FEA81-1A63-884F-A1C6-520C766F400F}" dt="2022-07-02T10:56:47.762" v="38" actId="164"/>
          <ac:cxnSpMkLst>
            <pc:docMk/>
            <pc:sldMk cId="1897538530" sldId="256"/>
            <ac:cxnSpMk id="21" creationId="{00000000-0000-0000-0000-000000000000}"/>
          </ac:cxnSpMkLst>
        </pc:cxnChg>
        <pc:cxnChg chg="mod">
          <ac:chgData name="Reza Amini Hounejani - TNW" userId="36cb0b73-58b2-4568-a1ab-00cd49301806" providerId="ADAL" clId="{DA8FEA81-1A63-884F-A1C6-520C766F400F}" dt="2022-07-02T11:13:46.750" v="162" actId="1076"/>
          <ac:cxnSpMkLst>
            <pc:docMk/>
            <pc:sldMk cId="1897538530" sldId="256"/>
            <ac:cxnSpMk id="42" creationId="{983AE527-D1FF-CB46-A118-254BFD020E46}"/>
          </ac:cxnSpMkLst>
        </pc:cxnChg>
        <pc:cxnChg chg="mod">
          <ac:chgData name="Reza Amini Hounejani - TNW" userId="36cb0b73-58b2-4568-a1ab-00cd49301806" providerId="ADAL" clId="{DA8FEA81-1A63-884F-A1C6-520C766F400F}" dt="2022-07-02T11:25:09.130" v="247" actId="14100"/>
          <ac:cxnSpMkLst>
            <pc:docMk/>
            <pc:sldMk cId="1897538530" sldId="256"/>
            <ac:cxnSpMk id="43" creationId="{5B38A8BF-0480-6147-BA3B-68D5ABB4CFDE}"/>
          </ac:cxnSpMkLst>
        </pc:cxnChg>
        <pc:cxnChg chg="mod">
          <ac:chgData name="Reza Amini Hounejani - TNW" userId="36cb0b73-58b2-4568-a1ab-00cd49301806" providerId="ADAL" clId="{DA8FEA81-1A63-884F-A1C6-520C766F400F}" dt="2022-07-02T11:14:25.817" v="183" actId="1037"/>
          <ac:cxnSpMkLst>
            <pc:docMk/>
            <pc:sldMk cId="1897538530" sldId="256"/>
            <ac:cxnSpMk id="94" creationId="{528DC548-8DB9-5112-19D0-64DC270C059C}"/>
          </ac:cxnSpMkLst>
        </pc:cxnChg>
        <pc:cxnChg chg="mod">
          <ac:chgData name="Reza Amini Hounejani - TNW" userId="36cb0b73-58b2-4568-a1ab-00cd49301806" providerId="ADAL" clId="{DA8FEA81-1A63-884F-A1C6-520C766F400F}" dt="2022-07-02T11:05:59.483" v="126" actId="1076"/>
          <ac:cxnSpMkLst>
            <pc:docMk/>
            <pc:sldMk cId="1897538530" sldId="256"/>
            <ac:cxnSpMk id="103" creationId="{00000000-0000-0000-0000-000000000000}"/>
          </ac:cxnSpMkLst>
        </pc:cxnChg>
        <pc:cxnChg chg="mod">
          <ac:chgData name="Reza Amini Hounejani - TNW" userId="36cb0b73-58b2-4568-a1ab-00cd49301806" providerId="ADAL" clId="{DA8FEA81-1A63-884F-A1C6-520C766F400F}" dt="2022-07-02T11:05:59.483" v="126" actId="1076"/>
          <ac:cxnSpMkLst>
            <pc:docMk/>
            <pc:sldMk cId="1897538530" sldId="256"/>
            <ac:cxnSpMk id="104" creationId="{00000000-0000-0000-0000-000000000000}"/>
          </ac:cxnSpMkLst>
        </pc:cxnChg>
        <pc:cxnChg chg="mod">
          <ac:chgData name="Reza Amini Hounejani - TNW" userId="36cb0b73-58b2-4568-a1ab-00cd49301806" providerId="ADAL" clId="{DA8FEA81-1A63-884F-A1C6-520C766F400F}" dt="2022-07-02T11:26:01.338" v="252" actId="14100"/>
          <ac:cxnSpMkLst>
            <pc:docMk/>
            <pc:sldMk cId="1897538530" sldId="256"/>
            <ac:cxnSpMk id="113" creationId="{00000000-0000-0000-0000-000000000000}"/>
          </ac:cxnSpMkLst>
        </pc:cxnChg>
      </pc:sldChg>
      <pc:sldChg chg="modSp mod">
        <pc:chgData name="Reza Amini Hounejani - TNW" userId="36cb0b73-58b2-4568-a1ab-00cd49301806" providerId="ADAL" clId="{DA8FEA81-1A63-884F-A1C6-520C766F400F}" dt="2022-07-02T11:51:05.088" v="276" actId="1037"/>
        <pc:sldMkLst>
          <pc:docMk/>
          <pc:sldMk cId="3807795133" sldId="257"/>
        </pc:sldMkLst>
        <pc:spChg chg="mod">
          <ac:chgData name="Reza Amini Hounejani - TNW" userId="36cb0b73-58b2-4568-a1ab-00cd49301806" providerId="ADAL" clId="{DA8FEA81-1A63-884F-A1C6-520C766F400F}" dt="2022-07-02T11:50:57.347" v="274" actId="1076"/>
          <ac:spMkLst>
            <pc:docMk/>
            <pc:sldMk cId="3807795133" sldId="257"/>
            <ac:spMk id="42" creationId="{4A5DA2B5-FDBA-794B-81FE-28DBD099C84A}"/>
          </ac:spMkLst>
        </pc:spChg>
        <pc:spChg chg="mod">
          <ac:chgData name="Reza Amini Hounejani - TNW" userId="36cb0b73-58b2-4568-a1ab-00cd49301806" providerId="ADAL" clId="{DA8FEA81-1A63-884F-A1C6-520C766F400F}" dt="2022-07-02T11:50:59.671" v="275" actId="1076"/>
          <ac:spMkLst>
            <pc:docMk/>
            <pc:sldMk cId="3807795133" sldId="257"/>
            <ac:spMk id="43" creationId="{6CCDC557-FEE7-5841-9299-F50DDFD5B2CD}"/>
          </ac:spMkLst>
        </pc:spChg>
        <pc:spChg chg="mod">
          <ac:chgData name="Reza Amini Hounejani - TNW" userId="36cb0b73-58b2-4568-a1ab-00cd49301806" providerId="ADAL" clId="{DA8FEA81-1A63-884F-A1C6-520C766F400F}" dt="2022-07-01T13:49:44.267" v="9" actId="1076"/>
          <ac:spMkLst>
            <pc:docMk/>
            <pc:sldMk cId="3807795133" sldId="257"/>
            <ac:spMk id="80" creationId="{63E757AB-526F-4B8A-AC4A-C042B12F0808}"/>
          </ac:spMkLst>
        </pc:spChg>
        <pc:spChg chg="mod">
          <ac:chgData name="Reza Amini Hounejani - TNW" userId="36cb0b73-58b2-4568-a1ab-00cd49301806" providerId="ADAL" clId="{DA8FEA81-1A63-884F-A1C6-520C766F400F}" dt="2022-07-01T13:49:42.954" v="7" actId="1076"/>
          <ac:spMkLst>
            <pc:docMk/>
            <pc:sldMk cId="3807795133" sldId="257"/>
            <ac:spMk id="85" creationId="{12E07F16-2BF0-8B9A-1603-30BF93275D37}"/>
          </ac:spMkLst>
        </pc:spChg>
        <pc:grpChg chg="mod">
          <ac:chgData name="Reza Amini Hounejani - TNW" userId="36cb0b73-58b2-4568-a1ab-00cd49301806" providerId="ADAL" clId="{DA8FEA81-1A63-884F-A1C6-520C766F400F}" dt="2022-07-01T13:49:42.555" v="6" actId="1076"/>
          <ac:grpSpMkLst>
            <pc:docMk/>
            <pc:sldMk cId="3807795133" sldId="257"/>
            <ac:grpSpMk id="6" creationId="{91BA0912-FB72-44AE-DD43-D4881CC1EB85}"/>
          </ac:grpSpMkLst>
        </pc:grpChg>
        <pc:picChg chg="mod">
          <ac:chgData name="Reza Amini Hounejani - TNW" userId="36cb0b73-58b2-4568-a1ab-00cd49301806" providerId="ADAL" clId="{DA8FEA81-1A63-884F-A1C6-520C766F400F}" dt="2022-07-01T13:49:43.482" v="8" actId="1076"/>
          <ac:picMkLst>
            <pc:docMk/>
            <pc:sldMk cId="3807795133" sldId="257"/>
            <ac:picMk id="3" creationId="{68AC0835-4B2C-B482-765B-22DA70532A3E}"/>
          </ac:picMkLst>
        </pc:picChg>
        <pc:picChg chg="mod">
          <ac:chgData name="Reza Amini Hounejani - TNW" userId="36cb0b73-58b2-4568-a1ab-00cd49301806" providerId="ADAL" clId="{DA8FEA81-1A63-884F-A1C6-520C766F400F}" dt="2022-07-02T11:51:05.088" v="276" actId="1037"/>
          <ac:picMkLst>
            <pc:docMk/>
            <pc:sldMk cId="3807795133" sldId="257"/>
            <ac:picMk id="168" creationId="{BF01D7D8-0B99-55B9-00C2-0462B04BB0C2}"/>
          </ac:picMkLst>
        </pc:picChg>
      </pc:sldChg>
      <pc:sldChg chg="modSp mod">
        <pc:chgData name="Reza Amini Hounejani - TNW" userId="36cb0b73-58b2-4568-a1ab-00cd49301806" providerId="ADAL" clId="{DA8FEA81-1A63-884F-A1C6-520C766F400F}" dt="2022-07-01T14:28:04.799" v="10" actId="1076"/>
        <pc:sldMkLst>
          <pc:docMk/>
          <pc:sldMk cId="715266389" sldId="259"/>
        </pc:sldMkLst>
        <pc:spChg chg="mod">
          <ac:chgData name="Reza Amini Hounejani - TNW" userId="36cb0b73-58b2-4568-a1ab-00cd49301806" providerId="ADAL" clId="{DA8FEA81-1A63-884F-A1C6-520C766F400F}" dt="2022-07-01T14:28:04.799" v="10" actId="1076"/>
          <ac:spMkLst>
            <pc:docMk/>
            <pc:sldMk cId="715266389" sldId="259"/>
            <ac:spMk id="108" creationId="{731751E8-2999-1830-A31F-7F4F1ACDD594}"/>
          </ac:spMkLst>
        </pc:spChg>
      </pc:sldChg>
    </pc:docChg>
  </pc:docChgLst>
  <pc:docChgLst>
    <pc:chgData name="Reza Amini Hounejani" userId="36cb0b73-58b2-4568-a1ab-00cd49301806" providerId="ADAL" clId="{CDB08FBE-FC2E-B54F-83CA-353720C73635}"/>
    <pc:docChg chg="undo redo custSel modSld">
      <pc:chgData name="Reza Amini Hounejani" userId="36cb0b73-58b2-4568-a1ab-00cd49301806" providerId="ADAL" clId="{CDB08FBE-FC2E-B54F-83CA-353720C73635}" dt="2023-03-07T10:18:35.147" v="134" actId="165"/>
      <pc:docMkLst>
        <pc:docMk/>
      </pc:docMkLst>
      <pc:sldChg chg="addSp delSp modSp mod">
        <pc:chgData name="Reza Amini Hounejani" userId="36cb0b73-58b2-4568-a1ab-00cd49301806" providerId="ADAL" clId="{CDB08FBE-FC2E-B54F-83CA-353720C73635}" dt="2023-02-21T14:13:41.773" v="56" actId="2085"/>
        <pc:sldMkLst>
          <pc:docMk/>
          <pc:sldMk cId="1897538530" sldId="256"/>
        </pc:sldMkLst>
        <pc:spChg chg="add mod">
          <ac:chgData name="Reza Amini Hounejani" userId="36cb0b73-58b2-4568-a1ab-00cd49301806" providerId="ADAL" clId="{CDB08FBE-FC2E-B54F-83CA-353720C73635}" dt="2023-02-21T14:13:07.777" v="53" actId="1036"/>
          <ac:spMkLst>
            <pc:docMk/>
            <pc:sldMk cId="1897538530" sldId="256"/>
            <ac:spMk id="80" creationId="{58B3BA06-4CC0-9278-AB13-F5D5CDDD346E}"/>
          </ac:spMkLst>
        </pc:spChg>
        <pc:spChg chg="mod">
          <ac:chgData name="Reza Amini Hounejani" userId="36cb0b73-58b2-4568-a1ab-00cd49301806" providerId="ADAL" clId="{CDB08FBE-FC2E-B54F-83CA-353720C73635}" dt="2023-02-21T14:13:41.773" v="56" actId="2085"/>
          <ac:spMkLst>
            <pc:docMk/>
            <pc:sldMk cId="1897538530" sldId="256"/>
            <ac:spMk id="111" creationId="{29FAE0B7-002A-12D2-CB48-182F56221F1B}"/>
          </ac:spMkLst>
        </pc:spChg>
        <pc:spChg chg="mod">
          <ac:chgData name="Reza Amini Hounejani" userId="36cb0b73-58b2-4568-a1ab-00cd49301806" providerId="ADAL" clId="{CDB08FBE-FC2E-B54F-83CA-353720C73635}" dt="2023-02-21T14:12:44.926" v="40" actId="571"/>
          <ac:spMkLst>
            <pc:docMk/>
            <pc:sldMk cId="1897538530" sldId="256"/>
            <ac:spMk id="117" creationId="{B6DB756B-85E9-14FD-3288-B366DFFE1DDC}"/>
          </ac:spMkLst>
        </pc:spChg>
        <pc:spChg chg="mod">
          <ac:chgData name="Reza Amini Hounejani" userId="36cb0b73-58b2-4568-a1ab-00cd49301806" providerId="ADAL" clId="{CDB08FBE-FC2E-B54F-83CA-353720C73635}" dt="2023-02-21T14:13:03.738" v="47" actId="1036"/>
          <ac:spMkLst>
            <pc:docMk/>
            <pc:sldMk cId="1897538530" sldId="256"/>
            <ac:spMk id="120" creationId="{BEC9A2A9-9593-0507-9628-629F19E4CB85}"/>
          </ac:spMkLst>
        </pc:spChg>
        <pc:spChg chg="mod">
          <ac:chgData name="Reza Amini Hounejani" userId="36cb0b73-58b2-4568-a1ab-00cd49301806" providerId="ADAL" clId="{CDB08FBE-FC2E-B54F-83CA-353720C73635}" dt="2023-02-21T14:13:05.343" v="49" actId="1036"/>
          <ac:spMkLst>
            <pc:docMk/>
            <pc:sldMk cId="1897538530" sldId="256"/>
            <ac:spMk id="122" creationId="{8F42A81C-EEF7-A4A8-316D-2495617E6F45}"/>
          </ac:spMkLst>
        </pc:spChg>
        <pc:spChg chg="mod">
          <ac:chgData name="Reza Amini Hounejani" userId="36cb0b73-58b2-4568-a1ab-00cd49301806" providerId="ADAL" clId="{CDB08FBE-FC2E-B54F-83CA-353720C73635}" dt="2023-02-21T14:12:44.926" v="40" actId="571"/>
          <ac:spMkLst>
            <pc:docMk/>
            <pc:sldMk cId="1897538530" sldId="256"/>
            <ac:spMk id="125" creationId="{00000000-0000-0000-0000-000000000000}"/>
          </ac:spMkLst>
        </pc:spChg>
        <pc:spChg chg="mod">
          <ac:chgData name="Reza Amini Hounejani" userId="36cb0b73-58b2-4568-a1ab-00cd49301806" providerId="ADAL" clId="{CDB08FBE-FC2E-B54F-83CA-353720C73635}" dt="2023-02-21T14:12:44.926" v="40" actId="571"/>
          <ac:spMkLst>
            <pc:docMk/>
            <pc:sldMk cId="1897538530" sldId="256"/>
            <ac:spMk id="126" creationId="{0E3A8FA3-C11D-4C61-3AFB-B69205167F17}"/>
          </ac:spMkLst>
        </pc:spChg>
        <pc:spChg chg="mod">
          <ac:chgData name="Reza Amini Hounejani" userId="36cb0b73-58b2-4568-a1ab-00cd49301806" providerId="ADAL" clId="{CDB08FBE-FC2E-B54F-83CA-353720C73635}" dt="2023-02-21T14:12:44.926" v="40" actId="571"/>
          <ac:spMkLst>
            <pc:docMk/>
            <pc:sldMk cId="1897538530" sldId="256"/>
            <ac:spMk id="128" creationId="{0E3A8FA3-C11D-4C61-3AFB-B69205167F17}"/>
          </ac:spMkLst>
        </pc:spChg>
        <pc:spChg chg="mod">
          <ac:chgData name="Reza Amini Hounejani" userId="36cb0b73-58b2-4568-a1ab-00cd49301806" providerId="ADAL" clId="{CDB08FBE-FC2E-B54F-83CA-353720C73635}" dt="2023-02-21T14:12:44.926" v="40" actId="571"/>
          <ac:spMkLst>
            <pc:docMk/>
            <pc:sldMk cId="1897538530" sldId="256"/>
            <ac:spMk id="130" creationId="{0E3A8FA3-C11D-4C61-3AFB-B69205167F17}"/>
          </ac:spMkLst>
        </pc:spChg>
        <pc:spChg chg="mod">
          <ac:chgData name="Reza Amini Hounejani" userId="36cb0b73-58b2-4568-a1ab-00cd49301806" providerId="ADAL" clId="{CDB08FBE-FC2E-B54F-83CA-353720C73635}" dt="2023-02-21T14:12:44.926" v="40" actId="571"/>
          <ac:spMkLst>
            <pc:docMk/>
            <pc:sldMk cId="1897538530" sldId="256"/>
            <ac:spMk id="132" creationId="{0E3A8FA3-C11D-4C61-3AFB-B69205167F17}"/>
          </ac:spMkLst>
        </pc:spChg>
        <pc:spChg chg="mod">
          <ac:chgData name="Reza Amini Hounejani" userId="36cb0b73-58b2-4568-a1ab-00cd49301806" providerId="ADAL" clId="{CDB08FBE-FC2E-B54F-83CA-353720C73635}" dt="2023-02-21T14:13:22.857" v="54" actId="1076"/>
          <ac:spMkLst>
            <pc:docMk/>
            <pc:sldMk cId="1897538530" sldId="256"/>
            <ac:spMk id="133" creationId="{0E3A8FA3-C11D-4C61-3AFB-B69205167F17}"/>
          </ac:spMkLst>
        </pc:spChg>
        <pc:spChg chg="mod">
          <ac:chgData name="Reza Amini Hounejani" userId="36cb0b73-58b2-4568-a1ab-00cd49301806" providerId="ADAL" clId="{CDB08FBE-FC2E-B54F-83CA-353720C73635}" dt="2023-02-21T14:12:44.926" v="40" actId="571"/>
          <ac:spMkLst>
            <pc:docMk/>
            <pc:sldMk cId="1897538530" sldId="256"/>
            <ac:spMk id="134" creationId="{0E3A8FA3-C11D-4C61-3AFB-B69205167F17}"/>
          </ac:spMkLst>
        </pc:spChg>
        <pc:spChg chg="mod">
          <ac:chgData name="Reza Amini Hounejani" userId="36cb0b73-58b2-4568-a1ab-00cd49301806" providerId="ADAL" clId="{CDB08FBE-FC2E-B54F-83CA-353720C73635}" dt="2023-02-21T14:12:44.926" v="40" actId="571"/>
          <ac:spMkLst>
            <pc:docMk/>
            <pc:sldMk cId="1897538530" sldId="256"/>
            <ac:spMk id="135" creationId="{00000000-0000-0000-0000-000000000000}"/>
          </ac:spMkLst>
        </pc:spChg>
        <pc:spChg chg="mod">
          <ac:chgData name="Reza Amini Hounejani" userId="36cb0b73-58b2-4568-a1ab-00cd49301806" providerId="ADAL" clId="{CDB08FBE-FC2E-B54F-83CA-353720C73635}" dt="2023-02-21T14:12:56.947" v="43" actId="553"/>
          <ac:spMkLst>
            <pc:docMk/>
            <pc:sldMk cId="1897538530" sldId="256"/>
            <ac:spMk id="139" creationId="{0E3A8FA3-C11D-4C61-3AFB-B69205167F17}"/>
          </ac:spMkLst>
        </pc:spChg>
        <pc:spChg chg="mod">
          <ac:chgData name="Reza Amini Hounejani" userId="36cb0b73-58b2-4568-a1ab-00cd49301806" providerId="ADAL" clId="{CDB08FBE-FC2E-B54F-83CA-353720C73635}" dt="2023-02-21T14:12:44.926" v="40" actId="571"/>
          <ac:spMkLst>
            <pc:docMk/>
            <pc:sldMk cId="1897538530" sldId="256"/>
            <ac:spMk id="145" creationId="{0E3A8FA3-C11D-4C61-3AFB-B69205167F17}"/>
          </ac:spMkLst>
        </pc:spChg>
        <pc:spChg chg="mod">
          <ac:chgData name="Reza Amini Hounejani" userId="36cb0b73-58b2-4568-a1ab-00cd49301806" providerId="ADAL" clId="{CDB08FBE-FC2E-B54F-83CA-353720C73635}" dt="2023-02-21T14:12:44.926" v="40" actId="571"/>
          <ac:spMkLst>
            <pc:docMk/>
            <pc:sldMk cId="1897538530" sldId="256"/>
            <ac:spMk id="146" creationId="{0E3A8FA3-C11D-4C61-3AFB-B69205167F17}"/>
          </ac:spMkLst>
        </pc:spChg>
        <pc:spChg chg="mod">
          <ac:chgData name="Reza Amini Hounejani" userId="36cb0b73-58b2-4568-a1ab-00cd49301806" providerId="ADAL" clId="{CDB08FBE-FC2E-B54F-83CA-353720C73635}" dt="2023-02-21T14:12:44.926" v="40" actId="571"/>
          <ac:spMkLst>
            <pc:docMk/>
            <pc:sldMk cId="1897538530" sldId="256"/>
            <ac:spMk id="180" creationId="{9135A554-678B-8028-0E46-54D53ABDD4E1}"/>
          </ac:spMkLst>
        </pc:spChg>
        <pc:grpChg chg="mod">
          <ac:chgData name="Reza Amini Hounejani" userId="36cb0b73-58b2-4568-a1ab-00cd49301806" providerId="ADAL" clId="{CDB08FBE-FC2E-B54F-83CA-353720C73635}" dt="2023-02-21T14:12:44.926" v="40" actId="571"/>
          <ac:grpSpMkLst>
            <pc:docMk/>
            <pc:sldMk cId="1897538530" sldId="256"/>
            <ac:grpSpMk id="30" creationId="{3888149E-BC7A-4F05-1EED-717EB2D18C3C}"/>
          </ac:grpSpMkLst>
        </pc:grpChg>
        <pc:grpChg chg="add del">
          <ac:chgData name="Reza Amini Hounejani" userId="36cb0b73-58b2-4568-a1ab-00cd49301806" providerId="ADAL" clId="{CDB08FBE-FC2E-B54F-83CA-353720C73635}" dt="2023-02-21T14:11:15.259" v="13" actId="478"/>
          <ac:grpSpMkLst>
            <pc:docMk/>
            <pc:sldMk cId="1897538530" sldId="256"/>
            <ac:grpSpMk id="31" creationId="{B7714048-14E7-562F-54FF-0EF23EA56E6C}"/>
          </ac:grpSpMkLst>
        </pc:grpChg>
        <pc:grpChg chg="mod">
          <ac:chgData name="Reza Amini Hounejani" userId="36cb0b73-58b2-4568-a1ab-00cd49301806" providerId="ADAL" clId="{CDB08FBE-FC2E-B54F-83CA-353720C73635}" dt="2023-02-21T14:12:44.926" v="40" actId="571"/>
          <ac:grpSpMkLst>
            <pc:docMk/>
            <pc:sldMk cId="1897538530" sldId="256"/>
            <ac:grpSpMk id="149" creationId="{00000000-0000-0000-0000-000000000000}"/>
          </ac:grpSpMkLst>
        </pc:grpChg>
        <pc:grpChg chg="mod">
          <ac:chgData name="Reza Amini Hounejani" userId="36cb0b73-58b2-4568-a1ab-00cd49301806" providerId="ADAL" clId="{CDB08FBE-FC2E-B54F-83CA-353720C73635}" dt="2023-02-21T14:12:44.926" v="40" actId="571"/>
          <ac:grpSpMkLst>
            <pc:docMk/>
            <pc:sldMk cId="1897538530" sldId="256"/>
            <ac:grpSpMk id="185" creationId="{1D2B04C5-B583-998D-193E-03D7A8BA57B3}"/>
          </ac:grpSpMkLst>
        </pc:grpChg>
        <pc:picChg chg="add del mod">
          <ac:chgData name="Reza Amini Hounejani" userId="36cb0b73-58b2-4568-a1ab-00cd49301806" providerId="ADAL" clId="{CDB08FBE-FC2E-B54F-83CA-353720C73635}" dt="2023-02-21T14:11:15.259" v="13" actId="478"/>
          <ac:picMkLst>
            <pc:docMk/>
            <pc:sldMk cId="1897538530" sldId="256"/>
            <ac:picMk id="29" creationId="{BDC7F90A-B887-0C93-6F35-2DEEEE6040D9}"/>
          </ac:picMkLst>
        </pc:picChg>
        <pc:picChg chg="add del mod">
          <ac:chgData name="Reza Amini Hounejani" userId="36cb0b73-58b2-4568-a1ab-00cd49301806" providerId="ADAL" clId="{CDB08FBE-FC2E-B54F-83CA-353720C73635}" dt="2023-02-21T14:11:01.751" v="11"/>
          <ac:picMkLst>
            <pc:docMk/>
            <pc:sldMk cId="1897538530" sldId="256"/>
            <ac:picMk id="34" creationId="{72BADD23-2C2D-B6DF-AD81-20A561C0221B}"/>
          </ac:picMkLst>
        </pc:picChg>
        <pc:picChg chg="add mod">
          <ac:chgData name="Reza Amini Hounejani" userId="36cb0b73-58b2-4568-a1ab-00cd49301806" providerId="ADAL" clId="{CDB08FBE-FC2E-B54F-83CA-353720C73635}" dt="2023-02-21T14:12:29.838" v="35" actId="1076"/>
          <ac:picMkLst>
            <pc:docMk/>
            <pc:sldMk cId="1897538530" sldId="256"/>
            <ac:picMk id="70" creationId="{3750D4A6-94E6-2858-8A8B-48DBD43808C4}"/>
          </ac:picMkLst>
        </pc:picChg>
        <pc:cxnChg chg="mod">
          <ac:chgData name="Reza Amini Hounejani" userId="36cb0b73-58b2-4568-a1ab-00cd49301806" providerId="ADAL" clId="{CDB08FBE-FC2E-B54F-83CA-353720C73635}" dt="2023-02-21T14:12:44.926" v="40" actId="571"/>
          <ac:cxnSpMkLst>
            <pc:docMk/>
            <pc:sldMk cId="1897538530" sldId="256"/>
            <ac:cxnSpMk id="94" creationId="{528DC548-8DB9-5112-19D0-64DC270C059C}"/>
          </ac:cxnSpMkLst>
        </pc:cxnChg>
      </pc:sldChg>
      <pc:sldChg chg="addSp delSp modSp mod">
        <pc:chgData name="Reza Amini Hounejani" userId="36cb0b73-58b2-4568-a1ab-00cd49301806" providerId="ADAL" clId="{CDB08FBE-FC2E-B54F-83CA-353720C73635}" dt="2023-02-23T15:31:37.575" v="131" actId="14100"/>
        <pc:sldMkLst>
          <pc:docMk/>
          <pc:sldMk cId="715266389" sldId="259"/>
        </pc:sldMkLst>
        <pc:spChg chg="mod">
          <ac:chgData name="Reza Amini Hounejani" userId="36cb0b73-58b2-4568-a1ab-00cd49301806" providerId="ADAL" clId="{CDB08FBE-FC2E-B54F-83CA-353720C73635}" dt="2023-02-23T15:30:46.126" v="123" actId="1076"/>
          <ac:spMkLst>
            <pc:docMk/>
            <pc:sldMk cId="715266389" sldId="259"/>
            <ac:spMk id="115" creationId="{BCE0C066-DCE1-59E7-948B-E44D47D19FA0}"/>
          </ac:spMkLst>
        </pc:spChg>
        <pc:spChg chg="mod">
          <ac:chgData name="Reza Amini Hounejani" userId="36cb0b73-58b2-4568-a1ab-00cd49301806" providerId="ADAL" clId="{CDB08FBE-FC2E-B54F-83CA-353720C73635}" dt="2023-02-23T15:31:37.575" v="131" actId="14100"/>
          <ac:spMkLst>
            <pc:docMk/>
            <pc:sldMk cId="715266389" sldId="259"/>
            <ac:spMk id="120" creationId="{46C07D9E-C45E-5FBC-D7F8-00D7AD2048C4}"/>
          </ac:spMkLst>
        </pc:spChg>
        <pc:spChg chg="mod">
          <ac:chgData name="Reza Amini Hounejani" userId="36cb0b73-58b2-4568-a1ab-00cd49301806" providerId="ADAL" clId="{CDB08FBE-FC2E-B54F-83CA-353720C73635}" dt="2023-02-23T15:31:07.205" v="127" actId="12788"/>
          <ac:spMkLst>
            <pc:docMk/>
            <pc:sldMk cId="715266389" sldId="259"/>
            <ac:spMk id="134" creationId="{35890859-0E28-4264-52A2-01F209D622AC}"/>
          </ac:spMkLst>
        </pc:spChg>
        <pc:spChg chg="mod">
          <ac:chgData name="Reza Amini Hounejani" userId="36cb0b73-58b2-4568-a1ab-00cd49301806" providerId="ADAL" clId="{CDB08FBE-FC2E-B54F-83CA-353720C73635}" dt="2023-02-23T15:31:07.205" v="127" actId="12788"/>
          <ac:spMkLst>
            <pc:docMk/>
            <pc:sldMk cId="715266389" sldId="259"/>
            <ac:spMk id="135" creationId="{61F9FB0F-21C1-394B-D249-42630D480F92}"/>
          </ac:spMkLst>
        </pc:spChg>
        <pc:spChg chg="mod">
          <ac:chgData name="Reza Amini Hounejani" userId="36cb0b73-58b2-4568-a1ab-00cd49301806" providerId="ADAL" clId="{CDB08FBE-FC2E-B54F-83CA-353720C73635}" dt="2023-02-23T15:31:07.205" v="127" actId="12788"/>
          <ac:spMkLst>
            <pc:docMk/>
            <pc:sldMk cId="715266389" sldId="259"/>
            <ac:spMk id="136" creationId="{4C90CE5E-5449-D741-31C7-1340B6E3BE15}"/>
          </ac:spMkLst>
        </pc:spChg>
        <pc:spChg chg="mod">
          <ac:chgData name="Reza Amini Hounejani" userId="36cb0b73-58b2-4568-a1ab-00cd49301806" providerId="ADAL" clId="{CDB08FBE-FC2E-B54F-83CA-353720C73635}" dt="2023-02-23T15:31:07.205" v="127" actId="12788"/>
          <ac:spMkLst>
            <pc:docMk/>
            <pc:sldMk cId="715266389" sldId="259"/>
            <ac:spMk id="137" creationId="{BD0E778B-C534-9FE1-1FFD-E5929002DC2B}"/>
          </ac:spMkLst>
        </pc:spChg>
        <pc:spChg chg="mod">
          <ac:chgData name="Reza Amini Hounejani" userId="36cb0b73-58b2-4568-a1ab-00cd49301806" providerId="ADAL" clId="{CDB08FBE-FC2E-B54F-83CA-353720C73635}" dt="2023-02-23T15:31:07.205" v="127" actId="12788"/>
          <ac:spMkLst>
            <pc:docMk/>
            <pc:sldMk cId="715266389" sldId="259"/>
            <ac:spMk id="138" creationId="{48D43CE3-A3D8-BF57-1D6D-ED7E5AAD7170}"/>
          </ac:spMkLst>
        </pc:spChg>
        <pc:grpChg chg="add mod">
          <ac:chgData name="Reza Amini Hounejani" userId="36cb0b73-58b2-4568-a1ab-00cd49301806" providerId="ADAL" clId="{CDB08FBE-FC2E-B54F-83CA-353720C73635}" dt="2023-02-23T15:31:27.106" v="130" actId="1076"/>
          <ac:grpSpMkLst>
            <pc:docMk/>
            <pc:sldMk cId="715266389" sldId="259"/>
            <ac:grpSpMk id="24" creationId="{D8E02C2D-B8A3-17A0-59CC-E69D5EAE69A2}"/>
          </ac:grpSpMkLst>
        </pc:grpChg>
        <pc:grpChg chg="add del">
          <ac:chgData name="Reza Amini Hounejani" userId="36cb0b73-58b2-4568-a1ab-00cd49301806" providerId="ADAL" clId="{CDB08FBE-FC2E-B54F-83CA-353720C73635}" dt="2023-02-23T15:29:34.820" v="84" actId="478"/>
          <ac:grpSpMkLst>
            <pc:docMk/>
            <pc:sldMk cId="715266389" sldId="259"/>
            <ac:grpSpMk id="27" creationId="{FE66B453-429E-EC9A-7E9D-BEA0A9791F74}"/>
          </ac:grpSpMkLst>
        </pc:grpChg>
        <pc:grpChg chg="mod topLvl">
          <ac:chgData name="Reza Amini Hounejani" userId="36cb0b73-58b2-4568-a1ab-00cd49301806" providerId="ADAL" clId="{CDB08FBE-FC2E-B54F-83CA-353720C73635}" dt="2023-02-23T15:31:19.343" v="128" actId="164"/>
          <ac:grpSpMkLst>
            <pc:docMk/>
            <pc:sldMk cId="715266389" sldId="259"/>
            <ac:grpSpMk id="142" creationId="{16726547-532C-DF24-68D1-1C99A80BCEA1}"/>
          </ac:grpSpMkLst>
        </pc:grpChg>
        <pc:picChg chg="add del topLvl">
          <ac:chgData name="Reza Amini Hounejani" userId="36cb0b73-58b2-4568-a1ab-00cd49301806" providerId="ADAL" clId="{CDB08FBE-FC2E-B54F-83CA-353720C73635}" dt="2023-02-23T15:29:34.820" v="84" actId="478"/>
          <ac:picMkLst>
            <pc:docMk/>
            <pc:sldMk cId="715266389" sldId="259"/>
            <ac:picMk id="9" creationId="{850EC570-16FD-49F7-3D0E-A4C18005067E}"/>
          </ac:picMkLst>
        </pc:picChg>
        <pc:picChg chg="add del mod">
          <ac:chgData name="Reza Amini Hounejani" userId="36cb0b73-58b2-4568-a1ab-00cd49301806" providerId="ADAL" clId="{CDB08FBE-FC2E-B54F-83CA-353720C73635}" dt="2023-02-23T15:31:19.343" v="128" actId="164"/>
          <ac:picMkLst>
            <pc:docMk/>
            <pc:sldMk cId="715266389" sldId="259"/>
            <ac:picMk id="19" creationId="{B0515E3B-93A6-4177-59E7-D10774A9A075}"/>
          </ac:picMkLst>
        </pc:picChg>
        <pc:cxnChg chg="add del mod">
          <ac:chgData name="Reza Amini Hounejani" userId="36cb0b73-58b2-4568-a1ab-00cd49301806" providerId="ADAL" clId="{CDB08FBE-FC2E-B54F-83CA-353720C73635}" dt="2023-02-23T15:30:33.739" v="117" actId="478"/>
          <ac:cxnSpMkLst>
            <pc:docMk/>
            <pc:sldMk cId="715266389" sldId="259"/>
            <ac:cxnSpMk id="21" creationId="{CDA2D396-6A90-4967-0A36-AACEE0772264}"/>
          </ac:cxnSpMkLst>
        </pc:cxnChg>
      </pc:sldChg>
      <pc:sldChg chg="modSp mod">
        <pc:chgData name="Reza Amini Hounejani" userId="36cb0b73-58b2-4568-a1ab-00cd49301806" providerId="ADAL" clId="{CDB08FBE-FC2E-B54F-83CA-353720C73635}" dt="2023-02-21T17:55:24.495" v="72" actId="20577"/>
        <pc:sldMkLst>
          <pc:docMk/>
          <pc:sldMk cId="269800214" sldId="261"/>
        </pc:sldMkLst>
        <pc:spChg chg="mod">
          <ac:chgData name="Reza Amini Hounejani" userId="36cb0b73-58b2-4568-a1ab-00cd49301806" providerId="ADAL" clId="{CDB08FBE-FC2E-B54F-83CA-353720C73635}" dt="2023-02-21T17:54:50.764" v="68" actId="20577"/>
          <ac:spMkLst>
            <pc:docMk/>
            <pc:sldMk cId="269800214" sldId="261"/>
            <ac:spMk id="30" creationId="{71C67A44-33D3-996A-FDE2-9C32F22046FC}"/>
          </ac:spMkLst>
        </pc:spChg>
        <pc:spChg chg="mod">
          <ac:chgData name="Reza Amini Hounejani" userId="36cb0b73-58b2-4568-a1ab-00cd49301806" providerId="ADAL" clId="{CDB08FBE-FC2E-B54F-83CA-353720C73635}" dt="2023-02-21T17:55:24.495" v="72" actId="20577"/>
          <ac:spMkLst>
            <pc:docMk/>
            <pc:sldMk cId="269800214" sldId="261"/>
            <ac:spMk id="32" creationId="{D4654BF1-D8FC-36B9-75E5-23DAEFA003F5}"/>
          </ac:spMkLst>
        </pc:spChg>
        <pc:spChg chg="mod">
          <ac:chgData name="Reza Amini Hounejani" userId="36cb0b73-58b2-4568-a1ab-00cd49301806" providerId="ADAL" clId="{CDB08FBE-FC2E-B54F-83CA-353720C73635}" dt="2023-02-21T17:55:00.731" v="70" actId="20577"/>
          <ac:spMkLst>
            <pc:docMk/>
            <pc:sldMk cId="269800214" sldId="261"/>
            <ac:spMk id="38" creationId="{BAC20769-9E36-E28D-C42A-2C6AF98541FB}"/>
          </ac:spMkLst>
        </pc:spChg>
      </pc:sldChg>
      <pc:sldChg chg="addSp delSp modSp mod">
        <pc:chgData name="Reza Amini Hounejani" userId="36cb0b73-58b2-4568-a1ab-00cd49301806" providerId="ADAL" clId="{CDB08FBE-FC2E-B54F-83CA-353720C73635}" dt="2023-03-07T10:18:35.147" v="134" actId="165"/>
        <pc:sldMkLst>
          <pc:docMk/>
          <pc:sldMk cId="1450487343" sldId="262"/>
        </pc:sldMkLst>
        <pc:spChg chg="add del mod">
          <ac:chgData name="Reza Amini Hounejani" userId="36cb0b73-58b2-4568-a1ab-00cd49301806" providerId="ADAL" clId="{CDB08FBE-FC2E-B54F-83CA-353720C73635}" dt="2023-02-21T14:28:33.502" v="65" actId="1076"/>
          <ac:spMkLst>
            <pc:docMk/>
            <pc:sldMk cId="1450487343" sldId="262"/>
            <ac:spMk id="2" creationId="{2B227EA7-2802-6E8B-12DA-D2D22078B99B}"/>
          </ac:spMkLst>
        </pc:spChg>
        <pc:spChg chg="del mod">
          <ac:chgData name="Reza Amini Hounejani" userId="36cb0b73-58b2-4568-a1ab-00cd49301806" providerId="ADAL" clId="{CDB08FBE-FC2E-B54F-83CA-353720C73635}" dt="2023-02-21T14:28:49.337" v="66" actId="478"/>
          <ac:spMkLst>
            <pc:docMk/>
            <pc:sldMk cId="1450487343" sldId="262"/>
            <ac:spMk id="6" creationId="{4BE5E06E-05AC-1B9B-DE4B-4AF7FCBC4F5D}"/>
          </ac:spMkLst>
        </pc:spChg>
        <pc:spChg chg="del mod">
          <ac:chgData name="Reza Amini Hounejani" userId="36cb0b73-58b2-4568-a1ab-00cd49301806" providerId="ADAL" clId="{CDB08FBE-FC2E-B54F-83CA-353720C73635}" dt="2023-02-21T14:28:49.337" v="66" actId="478"/>
          <ac:spMkLst>
            <pc:docMk/>
            <pc:sldMk cId="1450487343" sldId="262"/>
            <ac:spMk id="7" creationId="{0918E1AF-96E9-F808-7E8C-7A6DC93EC111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30" creationId="{6F0FCD9E-E4BD-EB8A-0BF1-5267C593C5F7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32" creationId="{063EE53F-39DA-9B18-1358-D2818E6F12ED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33" creationId="{5DC7CD94-56A9-8482-8D75-22A32729C7AD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68" creationId="{E32CFE8D-F329-A777-8E4F-295C3170BF77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70" creationId="{40632707-9327-85B5-8F42-9AE90452BF02}"/>
          </ac:spMkLst>
        </pc:spChg>
        <pc:spChg chg="del mod">
          <ac:chgData name="Reza Amini Hounejani" userId="36cb0b73-58b2-4568-a1ab-00cd49301806" providerId="ADAL" clId="{CDB08FBE-FC2E-B54F-83CA-353720C73635}" dt="2023-02-21T14:28:49.337" v="66" actId="478"/>
          <ac:spMkLst>
            <pc:docMk/>
            <pc:sldMk cId="1450487343" sldId="262"/>
            <ac:spMk id="71" creationId="{E059F69C-AD42-F8DD-6350-F6137C731FA5}"/>
          </ac:spMkLst>
        </pc:spChg>
        <pc:spChg chg="del mod">
          <ac:chgData name="Reza Amini Hounejani" userId="36cb0b73-58b2-4568-a1ab-00cd49301806" providerId="ADAL" clId="{CDB08FBE-FC2E-B54F-83CA-353720C73635}" dt="2023-02-21T14:28:49.337" v="66" actId="478"/>
          <ac:spMkLst>
            <pc:docMk/>
            <pc:sldMk cId="1450487343" sldId="262"/>
            <ac:spMk id="72" creationId="{30A799FA-4C73-1ECC-C923-4A9C988D8CD4}"/>
          </ac:spMkLst>
        </pc:spChg>
        <pc:spChg chg="del mod">
          <ac:chgData name="Reza Amini Hounejani" userId="36cb0b73-58b2-4568-a1ab-00cd49301806" providerId="ADAL" clId="{CDB08FBE-FC2E-B54F-83CA-353720C73635}" dt="2023-02-21T14:28:49.337" v="66" actId="478"/>
          <ac:spMkLst>
            <pc:docMk/>
            <pc:sldMk cId="1450487343" sldId="262"/>
            <ac:spMk id="75" creationId="{77AE3919-50B9-F752-C3E2-06825A6F7CA3}"/>
          </ac:spMkLst>
        </pc:spChg>
        <pc:spChg chg="del mod">
          <ac:chgData name="Reza Amini Hounejani" userId="36cb0b73-58b2-4568-a1ab-00cd49301806" providerId="ADAL" clId="{CDB08FBE-FC2E-B54F-83CA-353720C73635}" dt="2023-02-21T14:28:49.337" v="66" actId="478"/>
          <ac:spMkLst>
            <pc:docMk/>
            <pc:sldMk cId="1450487343" sldId="262"/>
            <ac:spMk id="76" creationId="{625D02DC-CACC-F0E1-D3AF-52624C82E629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77" creationId="{B706E0BF-45E5-4F40-FCFC-29837C3A3D6B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79" creationId="{6975A149-AE01-4E87-F15E-11344C40F241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80" creationId="{AA5F3D60-60DE-2210-C49D-DDFE11474642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88" creationId="{FF55A648-B878-13CD-A50E-107566F087E6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89" creationId="{F5591EF2-B130-E4C0-C773-34AABECDB787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90" creationId="{27C809F8-9B78-B68F-EE62-C6A360E65CBC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91" creationId="{000589F2-4210-46CA-1914-DA39812334FE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92" creationId="{EBD5B438-F1AB-9319-A643-B2410409FEA3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93" creationId="{50BBE679-75AB-33F6-7FC5-41609B49E685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94" creationId="{959E279B-6D9D-B7B8-BC30-250695F200A7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95" creationId="{5F2D840A-0172-46A7-6D8D-7437CF69F1AB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96" creationId="{216A1BE5-5977-AFC3-013C-06F5153CA50B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97" creationId="{3368C6E5-2F75-BBC0-0821-725F6BA32A2F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98" creationId="{8E5FC36E-E98D-2E9A-1440-46B377FC5945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100" creationId="{72FE6FEF-D438-2A9D-9B28-91EBF1E9E7A5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101" creationId="{28FC32F1-1AEC-DD2B-8F98-FB8E4B397905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102" creationId="{C2625D45-381F-22EE-E304-65E01D398398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103" creationId="{33B53B92-35FD-63F7-D489-FBB698B2FCF4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104" creationId="{36F0174A-95B1-3143-5216-EEADC399632C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105" creationId="{4B0C4D32-DE76-C220-F9C0-C7357A37C16F}"/>
          </ac:spMkLst>
        </pc:spChg>
        <pc:spChg chg="mod">
          <ac:chgData name="Reza Amini Hounejani" userId="36cb0b73-58b2-4568-a1ab-00cd49301806" providerId="ADAL" clId="{CDB08FBE-FC2E-B54F-83CA-353720C73635}" dt="2023-03-07T10:18:35.147" v="134" actId="165"/>
          <ac:spMkLst>
            <pc:docMk/>
            <pc:sldMk cId="1450487343" sldId="262"/>
            <ac:spMk id="106" creationId="{2DF016A5-157A-6ACE-B47C-5ACE7543801B}"/>
          </ac:spMkLst>
        </pc:spChg>
        <pc:spChg chg="add del mod">
          <ac:chgData name="Reza Amini Hounejani" userId="36cb0b73-58b2-4568-a1ab-00cd49301806" providerId="ADAL" clId="{CDB08FBE-FC2E-B54F-83CA-353720C73635}" dt="2023-02-21T14:28:33.502" v="65" actId="1076"/>
          <ac:spMkLst>
            <pc:docMk/>
            <pc:sldMk cId="1450487343" sldId="262"/>
            <ac:spMk id="107" creationId="{3D2720E9-347D-C9BA-544B-C63F2B5ED33F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10" creationId="{0A33AAAF-3B64-E409-5C7D-A1B8C30F69BC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11" creationId="{C769D494-CAE7-DF9B-354B-86FAEC87BBDD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12" creationId="{57E11962-BFD5-BB2F-9268-069864E3CB76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13" creationId="{35600AF2-0CD4-50BE-EE07-42A83835C5CD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17" creationId="{E6A72699-5BDE-094E-FA83-40F922784DBA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18" creationId="{343F39D4-364C-8A94-84F2-56541188C3B0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19" creationId="{E71A81A3-F38B-DD0A-2953-C8AACEBDB78E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20" creationId="{C6E052CA-3D9F-C8AB-E993-EEEF9C8DAFFC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21" creationId="{8B88FFEC-CB61-3AC1-BE8D-734921588CB5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22" creationId="{99148817-CBF1-E448-7AB4-12D1DA330433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23" creationId="{403EA154-3CC9-20E0-6AF4-543735297C35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24" creationId="{4B91B533-1760-660B-6290-66760706FB63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25" creationId="{19C41DC1-7351-F6B9-D452-638316CB3C9D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26" creationId="{04D59625-8861-C504-27DD-C3FF29700AF9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27" creationId="{C6A46D74-E27A-E48A-DC10-3599C1319171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28" creationId="{4608DCF4-A180-080D-033F-30AC6CD63B9B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30" creationId="{7C78835A-CB5F-3C81-5246-6A08D12E2B4B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31" creationId="{6282E8A0-13FD-5754-3475-D8671544CD6E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32" creationId="{0CBA386A-A42A-DA0C-3489-177D18D0A4D0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33" creationId="{033C397B-407E-4387-8FAD-A870D7D14C69}"/>
          </ac:spMkLst>
        </pc:spChg>
        <pc:spChg chg="add del mod">
          <ac:chgData name="Reza Amini Hounejani" userId="36cb0b73-58b2-4568-a1ab-00cd49301806" providerId="ADAL" clId="{CDB08FBE-FC2E-B54F-83CA-353720C73635}" dt="2023-02-21T14:28:33.502" v="65" actId="1076"/>
          <ac:spMkLst>
            <pc:docMk/>
            <pc:sldMk cId="1450487343" sldId="262"/>
            <ac:spMk id="134" creationId="{137E3415-C62C-3A05-FA06-739CB6BFC17B}"/>
          </ac:spMkLst>
        </pc:spChg>
        <pc:spChg chg="add del mod">
          <ac:chgData name="Reza Amini Hounejani" userId="36cb0b73-58b2-4568-a1ab-00cd49301806" providerId="ADAL" clId="{CDB08FBE-FC2E-B54F-83CA-353720C73635}" dt="2023-02-21T14:28:33.502" v="65" actId="1076"/>
          <ac:spMkLst>
            <pc:docMk/>
            <pc:sldMk cId="1450487343" sldId="262"/>
            <ac:spMk id="135" creationId="{B6513810-1310-54EB-EEBD-D5E82DAE7C04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39" creationId="{A44BEFCE-4304-F2FC-8FF4-CB31D174501C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40" creationId="{43EAC9C1-69EC-7F93-A3DF-99375907DE32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41" creationId="{80C1025C-6FB7-CAA5-CA9E-4E956F129FB3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42" creationId="{86C7C646-5C1F-2CB4-FEEB-0880F3210414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45" creationId="{27B4B3C5-1F92-A97F-56D5-219EBD969718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46" creationId="{096713DD-0B99-5880-D3AE-B4FE01ABB5E2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48" creationId="{C5773A15-C5F0-D819-0579-AED34A65CCF1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49" creationId="{879E807B-1D82-0522-5954-799AFA320529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50" creationId="{4913B31C-6F76-7F93-1D0B-78D60E4B5C5E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51" creationId="{6F3AA8DC-86EC-D919-367A-E6BD3463C7D7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52" creationId="{A38C4116-EA93-0501-6406-83DB1A960102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53" creationId="{BEE3E6D8-6169-05B9-F0DA-2609424AEA17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54" creationId="{F6B95231-1FA1-A1D1-D0E4-52D2A9121817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55" creationId="{1CDFE9AA-301F-A5D9-C72F-B4F3AC697E46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56" creationId="{4E831B51-4B18-ADCB-C9DE-9F018819F3B4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61" creationId="{3649AFB8-520E-2957-5F61-DFC584100DC2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64" creationId="{958EE9CD-76D7-0288-D620-D72CB4934AC3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65" creationId="{26A03A68-B8E7-220D-B8B2-6F86216EC667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66" creationId="{0398CC03-C88D-5CDF-910C-9C4F3103CDFE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67" creationId="{399908A8-B043-22C0-F770-3DA7897A8C3C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68" creationId="{1A1D8818-6399-CF5A-C9A8-D878B3BDE944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69" creationId="{373A9584-98AF-54DA-32DE-19C689938E9E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70" creationId="{86373483-A931-522E-8E74-689B2646C499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71" creationId="{220D110D-DD9D-0A62-72B9-58E94808343D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72" creationId="{13D901C5-0C99-17C2-EBCA-CE9117DB7253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73" creationId="{D9211BAD-4C38-9ABF-B72F-8C0B5E40F3A2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74" creationId="{3E6CF273-DF2D-55DC-D539-52DFE9BDDE43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75" creationId="{18C5A32F-9767-843D-2D54-F745C759AFA8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76" creationId="{20B187E3-23B4-06C8-C722-F59FF0C179AA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77" creationId="{8DC7E3F0-1165-1EC6-D22A-413DAEF0A634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78" creationId="{35936764-CBB5-C580-158E-2B357A5439A2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79" creationId="{173A25BE-6CDA-329B-7212-6391198A75A1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80" creationId="{10EDA352-3E05-C0FD-C60F-E5B4C121A865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81" creationId="{07673B8C-C67C-EFA2-3076-16FD5B8B0F44}"/>
          </ac:spMkLst>
        </pc:spChg>
        <pc:spChg chg="mod">
          <ac:chgData name="Reza Amini Hounejani" userId="36cb0b73-58b2-4568-a1ab-00cd49301806" providerId="ADAL" clId="{CDB08FBE-FC2E-B54F-83CA-353720C73635}" dt="2023-02-21T14:28:10.610" v="58"/>
          <ac:spMkLst>
            <pc:docMk/>
            <pc:sldMk cId="1450487343" sldId="262"/>
            <ac:spMk id="182" creationId="{8D6FF532-7FA3-119D-1F98-9E500C919877}"/>
          </ac:spMkLst>
        </pc:spChg>
        <pc:grpChg chg="add del mod">
          <ac:chgData name="Reza Amini Hounejani" userId="36cb0b73-58b2-4568-a1ab-00cd49301806" providerId="ADAL" clId="{CDB08FBE-FC2E-B54F-83CA-353720C73635}" dt="2023-03-07T10:18:35.147" v="134" actId="165"/>
          <ac:grpSpMkLst>
            <pc:docMk/>
            <pc:sldMk cId="1450487343" sldId="262"/>
            <ac:grpSpMk id="3" creationId="{628D7D5E-16C9-C466-0D18-502C2DAE3E9D}"/>
          </ac:grpSpMkLst>
        </pc:grpChg>
        <pc:grpChg chg="del mod">
          <ac:chgData name="Reza Amini Hounejani" userId="36cb0b73-58b2-4568-a1ab-00cd49301806" providerId="ADAL" clId="{CDB08FBE-FC2E-B54F-83CA-353720C73635}" dt="2023-02-21T14:28:49.337" v="66" actId="478"/>
          <ac:grpSpMkLst>
            <pc:docMk/>
            <pc:sldMk cId="1450487343" sldId="262"/>
            <ac:grpSpMk id="8" creationId="{8E8107F5-1AA2-9E1B-625B-2466673DACC9}"/>
          </ac:grpSpMkLst>
        </pc:grpChg>
        <pc:grpChg chg="mod topLvl">
          <ac:chgData name="Reza Amini Hounejani" userId="36cb0b73-58b2-4568-a1ab-00cd49301806" providerId="ADAL" clId="{CDB08FBE-FC2E-B54F-83CA-353720C73635}" dt="2023-03-07T10:18:35.147" v="134" actId="165"/>
          <ac:grpSpMkLst>
            <pc:docMk/>
            <pc:sldMk cId="1450487343" sldId="262"/>
            <ac:grpSpMk id="11" creationId="{018BF040-3927-3EB4-869B-23524D694200}"/>
          </ac:grpSpMkLst>
        </pc:grpChg>
        <pc:grpChg chg="mod">
          <ac:chgData name="Reza Amini Hounejani" userId="36cb0b73-58b2-4568-a1ab-00cd49301806" providerId="ADAL" clId="{CDB08FBE-FC2E-B54F-83CA-353720C73635}" dt="2023-03-07T10:18:35.147" v="134" actId="165"/>
          <ac:grpSpMkLst>
            <pc:docMk/>
            <pc:sldMk cId="1450487343" sldId="262"/>
            <ac:grpSpMk id="27" creationId="{C2FC8810-614E-E4A6-0067-B2D93B808744}"/>
          </ac:grpSpMkLst>
        </pc:grpChg>
        <pc:grpChg chg="del mod">
          <ac:chgData name="Reza Amini Hounejani" userId="36cb0b73-58b2-4568-a1ab-00cd49301806" providerId="ADAL" clId="{CDB08FBE-FC2E-B54F-83CA-353720C73635}" dt="2023-02-21T14:28:49.337" v="66" actId="478"/>
          <ac:grpSpMkLst>
            <pc:docMk/>
            <pc:sldMk cId="1450487343" sldId="262"/>
            <ac:grpSpMk id="74" creationId="{F3C39970-6813-AB0B-B58C-30640EFDC56A}"/>
          </ac:grpSpMkLst>
        </pc:grpChg>
        <pc:grpChg chg="mod">
          <ac:chgData name="Reza Amini Hounejani" userId="36cb0b73-58b2-4568-a1ab-00cd49301806" providerId="ADAL" clId="{CDB08FBE-FC2E-B54F-83CA-353720C73635}" dt="2023-03-07T10:18:35.147" v="134" actId="165"/>
          <ac:grpSpMkLst>
            <pc:docMk/>
            <pc:sldMk cId="1450487343" sldId="262"/>
            <ac:grpSpMk id="78" creationId="{862D36E9-5326-2A25-1379-F42E40E5F4A7}"/>
          </ac:grpSpMkLst>
        </pc:grpChg>
        <pc:grpChg chg="mod">
          <ac:chgData name="Reza Amini Hounejani" userId="36cb0b73-58b2-4568-a1ab-00cd49301806" providerId="ADAL" clId="{CDB08FBE-FC2E-B54F-83CA-353720C73635}" dt="2023-03-07T10:18:35.147" v="134" actId="165"/>
          <ac:grpSpMkLst>
            <pc:docMk/>
            <pc:sldMk cId="1450487343" sldId="262"/>
            <ac:grpSpMk id="81" creationId="{1E4A7B9B-FE74-108B-BA08-7A307F494819}"/>
          </ac:grpSpMkLst>
        </pc:grpChg>
        <pc:grpChg chg="mod">
          <ac:chgData name="Reza Amini Hounejani" userId="36cb0b73-58b2-4568-a1ab-00cd49301806" providerId="ADAL" clId="{CDB08FBE-FC2E-B54F-83CA-353720C73635}" dt="2023-03-07T10:18:35.147" v="134" actId="165"/>
          <ac:grpSpMkLst>
            <pc:docMk/>
            <pc:sldMk cId="1450487343" sldId="262"/>
            <ac:grpSpMk id="86" creationId="{48C9ABAB-A89F-C63C-95B7-47DFE52E95EA}"/>
          </ac:grpSpMkLst>
        </pc:grpChg>
        <pc:grpChg chg="mod">
          <ac:chgData name="Reza Amini Hounejani" userId="36cb0b73-58b2-4568-a1ab-00cd49301806" providerId="ADAL" clId="{CDB08FBE-FC2E-B54F-83CA-353720C73635}" dt="2023-03-07T10:18:35.147" v="134" actId="165"/>
          <ac:grpSpMkLst>
            <pc:docMk/>
            <pc:sldMk cId="1450487343" sldId="262"/>
            <ac:grpSpMk id="87" creationId="{FDD78951-72EA-F9DF-2C78-9DE53FB6CA0C}"/>
          </ac:grpSpMkLst>
        </pc:grpChg>
        <pc:grpChg chg="mod">
          <ac:chgData name="Reza Amini Hounejani" userId="36cb0b73-58b2-4568-a1ab-00cd49301806" providerId="ADAL" clId="{CDB08FBE-FC2E-B54F-83CA-353720C73635}" dt="2023-03-07T10:18:35.147" v="134" actId="165"/>
          <ac:grpSpMkLst>
            <pc:docMk/>
            <pc:sldMk cId="1450487343" sldId="262"/>
            <ac:grpSpMk id="99" creationId="{26BEB676-969F-208F-531B-60C072EA75FB}"/>
          </ac:grpSpMkLst>
        </pc:grpChg>
        <pc:grpChg chg="add del mod">
          <ac:chgData name="Reza Amini Hounejani" userId="36cb0b73-58b2-4568-a1ab-00cd49301806" providerId="ADAL" clId="{CDB08FBE-FC2E-B54F-83CA-353720C73635}" dt="2023-02-21T14:28:33.502" v="65" actId="1076"/>
          <ac:grpSpMkLst>
            <pc:docMk/>
            <pc:sldMk cId="1450487343" sldId="262"/>
            <ac:grpSpMk id="108" creationId="{935C5173-B608-1A14-6918-2331333547E5}"/>
          </ac:grpSpMkLst>
        </pc:grpChg>
        <pc:grpChg chg="mod">
          <ac:chgData name="Reza Amini Hounejani" userId="36cb0b73-58b2-4568-a1ab-00cd49301806" providerId="ADAL" clId="{CDB08FBE-FC2E-B54F-83CA-353720C73635}" dt="2023-02-21T14:28:10.610" v="58"/>
          <ac:grpSpMkLst>
            <pc:docMk/>
            <pc:sldMk cId="1450487343" sldId="262"/>
            <ac:grpSpMk id="109" creationId="{D3FE8EA8-1BDE-1D18-420A-EE09560041E9}"/>
          </ac:grpSpMkLst>
        </pc:grpChg>
        <pc:grpChg chg="mod">
          <ac:chgData name="Reza Amini Hounejani" userId="36cb0b73-58b2-4568-a1ab-00cd49301806" providerId="ADAL" clId="{CDB08FBE-FC2E-B54F-83CA-353720C73635}" dt="2023-02-21T14:28:10.610" v="58"/>
          <ac:grpSpMkLst>
            <pc:docMk/>
            <pc:sldMk cId="1450487343" sldId="262"/>
            <ac:grpSpMk id="115" creationId="{4CFB4101-D9F6-3327-D624-23E064AFFBA6}"/>
          </ac:grpSpMkLst>
        </pc:grpChg>
        <pc:grpChg chg="mod">
          <ac:chgData name="Reza Amini Hounejani" userId="36cb0b73-58b2-4568-a1ab-00cd49301806" providerId="ADAL" clId="{CDB08FBE-FC2E-B54F-83CA-353720C73635}" dt="2023-02-21T14:28:10.610" v="58"/>
          <ac:grpSpMkLst>
            <pc:docMk/>
            <pc:sldMk cId="1450487343" sldId="262"/>
            <ac:grpSpMk id="116" creationId="{8B1F7D6D-ACB7-F0ED-EEA9-166F75114C60}"/>
          </ac:grpSpMkLst>
        </pc:grpChg>
        <pc:grpChg chg="mod">
          <ac:chgData name="Reza Amini Hounejani" userId="36cb0b73-58b2-4568-a1ab-00cd49301806" providerId="ADAL" clId="{CDB08FBE-FC2E-B54F-83CA-353720C73635}" dt="2023-02-21T14:28:10.610" v="58"/>
          <ac:grpSpMkLst>
            <pc:docMk/>
            <pc:sldMk cId="1450487343" sldId="262"/>
            <ac:grpSpMk id="129" creationId="{A01D12B7-8001-19C5-A125-EDEB7B52BEE5}"/>
          </ac:grpSpMkLst>
        </pc:grpChg>
        <pc:grpChg chg="add del mod">
          <ac:chgData name="Reza Amini Hounejani" userId="36cb0b73-58b2-4568-a1ab-00cd49301806" providerId="ADAL" clId="{CDB08FBE-FC2E-B54F-83CA-353720C73635}" dt="2023-02-21T14:28:33.502" v="65" actId="1076"/>
          <ac:grpSpMkLst>
            <pc:docMk/>
            <pc:sldMk cId="1450487343" sldId="262"/>
            <ac:grpSpMk id="136" creationId="{FE3A3AD8-CD7F-2E68-EF1B-F2F8A02996BC}"/>
          </ac:grpSpMkLst>
        </pc:grpChg>
        <pc:grpChg chg="mod">
          <ac:chgData name="Reza Amini Hounejani" userId="36cb0b73-58b2-4568-a1ab-00cd49301806" providerId="ADAL" clId="{CDB08FBE-FC2E-B54F-83CA-353720C73635}" dt="2023-02-21T14:28:10.610" v="58"/>
          <ac:grpSpMkLst>
            <pc:docMk/>
            <pc:sldMk cId="1450487343" sldId="262"/>
            <ac:grpSpMk id="138" creationId="{CF2D9D61-80BF-DD6B-6C6B-9F6708647737}"/>
          </ac:grpSpMkLst>
        </pc:grpChg>
        <pc:grpChg chg="mod">
          <ac:chgData name="Reza Amini Hounejani" userId="36cb0b73-58b2-4568-a1ab-00cd49301806" providerId="ADAL" clId="{CDB08FBE-FC2E-B54F-83CA-353720C73635}" dt="2023-02-21T14:28:10.610" v="58"/>
          <ac:grpSpMkLst>
            <pc:docMk/>
            <pc:sldMk cId="1450487343" sldId="262"/>
            <ac:grpSpMk id="147" creationId="{51B69215-A93C-86AA-F285-4189C09CF088}"/>
          </ac:grpSpMkLst>
        </pc:grpChg>
        <pc:grpChg chg="add del mod">
          <ac:chgData name="Reza Amini Hounejani" userId="36cb0b73-58b2-4568-a1ab-00cd49301806" providerId="ADAL" clId="{CDB08FBE-FC2E-B54F-83CA-353720C73635}" dt="2023-02-21T14:28:33.502" v="65" actId="1076"/>
          <ac:grpSpMkLst>
            <pc:docMk/>
            <pc:sldMk cId="1450487343" sldId="262"/>
            <ac:grpSpMk id="157" creationId="{7D892962-0B6E-144B-39AA-FE6AA2AA47B8}"/>
          </ac:grpSpMkLst>
        </pc:grpChg>
        <pc:grpChg chg="mod">
          <ac:chgData name="Reza Amini Hounejani" userId="36cb0b73-58b2-4568-a1ab-00cd49301806" providerId="ADAL" clId="{CDB08FBE-FC2E-B54F-83CA-353720C73635}" dt="2023-02-21T14:28:10.610" v="58"/>
          <ac:grpSpMkLst>
            <pc:docMk/>
            <pc:sldMk cId="1450487343" sldId="262"/>
            <ac:grpSpMk id="159" creationId="{C6CCB6A2-3F0C-B356-4DBE-7BE17DD29FCD}"/>
          </ac:grpSpMkLst>
        </pc:grpChg>
        <pc:grpChg chg="mod">
          <ac:chgData name="Reza Amini Hounejani" userId="36cb0b73-58b2-4568-a1ab-00cd49301806" providerId="ADAL" clId="{CDB08FBE-FC2E-B54F-83CA-353720C73635}" dt="2023-02-21T14:28:10.610" v="58"/>
          <ac:grpSpMkLst>
            <pc:docMk/>
            <pc:sldMk cId="1450487343" sldId="262"/>
            <ac:grpSpMk id="160" creationId="{C8850AEC-6B54-DBBE-5E78-335483F751B0}"/>
          </ac:grpSpMkLst>
        </pc:grpChg>
        <pc:grpChg chg="mod">
          <ac:chgData name="Reza Amini Hounejani" userId="36cb0b73-58b2-4568-a1ab-00cd49301806" providerId="ADAL" clId="{CDB08FBE-FC2E-B54F-83CA-353720C73635}" dt="2023-02-21T14:28:10.610" v="58"/>
          <ac:grpSpMkLst>
            <pc:docMk/>
            <pc:sldMk cId="1450487343" sldId="262"/>
            <ac:grpSpMk id="163" creationId="{F911DED8-EFF0-65F6-0992-A37D0BA30A91}"/>
          </ac:grpSpMkLst>
        </pc:grpChg>
        <pc:picChg chg="mod">
          <ac:chgData name="Reza Amini Hounejani" userId="36cb0b73-58b2-4568-a1ab-00cd49301806" providerId="ADAL" clId="{CDB08FBE-FC2E-B54F-83CA-353720C73635}" dt="2023-03-07T10:18:35.147" v="134" actId="165"/>
          <ac:picMkLst>
            <pc:docMk/>
            <pc:sldMk cId="1450487343" sldId="262"/>
            <ac:picMk id="83" creationId="{0170B39B-A5FB-BA23-EAA0-2406B59158E7}"/>
          </ac:picMkLst>
        </pc:picChg>
        <pc:picChg chg="del mod">
          <ac:chgData name="Reza Amini Hounejani" userId="36cb0b73-58b2-4568-a1ab-00cd49301806" providerId="ADAL" clId="{CDB08FBE-FC2E-B54F-83CA-353720C73635}" dt="2023-02-21T14:28:49.337" v="66" actId="478"/>
          <ac:picMkLst>
            <pc:docMk/>
            <pc:sldMk cId="1450487343" sldId="262"/>
            <ac:picMk id="84" creationId="{00D5556E-6A1A-6CA0-5B1C-E3AEC9402146}"/>
          </ac:picMkLst>
        </pc:picChg>
        <pc:picChg chg="mod">
          <ac:chgData name="Reza Amini Hounejani" userId="36cb0b73-58b2-4568-a1ab-00cd49301806" providerId="ADAL" clId="{CDB08FBE-FC2E-B54F-83CA-353720C73635}" dt="2023-03-07T10:18:35.147" v="134" actId="165"/>
          <ac:picMkLst>
            <pc:docMk/>
            <pc:sldMk cId="1450487343" sldId="262"/>
            <ac:picMk id="85" creationId="{2DDC84FB-551A-7DC2-859B-DE99B9113508}"/>
          </ac:picMkLst>
        </pc:picChg>
        <pc:picChg chg="mod">
          <ac:chgData name="Reza Amini Hounejani" userId="36cb0b73-58b2-4568-a1ab-00cd49301806" providerId="ADAL" clId="{CDB08FBE-FC2E-B54F-83CA-353720C73635}" dt="2023-02-21T14:28:10.610" v="58"/>
          <ac:picMkLst>
            <pc:docMk/>
            <pc:sldMk cId="1450487343" sldId="262"/>
            <ac:picMk id="114" creationId="{BA437742-C493-CACE-5F83-3BFA4D186B69}"/>
          </ac:picMkLst>
        </pc:picChg>
        <pc:picChg chg="mod">
          <ac:chgData name="Reza Amini Hounejani" userId="36cb0b73-58b2-4568-a1ab-00cd49301806" providerId="ADAL" clId="{CDB08FBE-FC2E-B54F-83CA-353720C73635}" dt="2023-02-21T14:28:10.610" v="58"/>
          <ac:picMkLst>
            <pc:docMk/>
            <pc:sldMk cId="1450487343" sldId="262"/>
            <ac:picMk id="137" creationId="{C771407E-B30D-74FB-ADCD-2F607F236ECF}"/>
          </ac:picMkLst>
        </pc:picChg>
        <pc:picChg chg="mod">
          <ac:chgData name="Reza Amini Hounejani" userId="36cb0b73-58b2-4568-a1ab-00cd49301806" providerId="ADAL" clId="{CDB08FBE-FC2E-B54F-83CA-353720C73635}" dt="2023-02-21T14:28:10.610" v="58"/>
          <ac:picMkLst>
            <pc:docMk/>
            <pc:sldMk cId="1450487343" sldId="262"/>
            <ac:picMk id="158" creationId="{06652D08-FDC1-0AF3-C338-04F3C974010F}"/>
          </ac:picMkLst>
        </pc:picChg>
        <pc:cxnChg chg="mod topLvl">
          <ac:chgData name="Reza Amini Hounejani" userId="36cb0b73-58b2-4568-a1ab-00cd49301806" providerId="ADAL" clId="{CDB08FBE-FC2E-B54F-83CA-353720C73635}" dt="2023-03-07T10:18:35.147" v="134" actId="165"/>
          <ac:cxnSpMkLst>
            <pc:docMk/>
            <pc:sldMk cId="1450487343" sldId="262"/>
            <ac:cxnSpMk id="13" creationId="{00E27776-3B40-1FA8-D3D6-636A77C8FDA3}"/>
          </ac:cxnSpMkLst>
        </pc:cxnChg>
        <pc:cxnChg chg="mod topLvl">
          <ac:chgData name="Reza Amini Hounejani" userId="36cb0b73-58b2-4568-a1ab-00cd49301806" providerId="ADAL" clId="{CDB08FBE-FC2E-B54F-83CA-353720C73635}" dt="2023-03-07T10:18:35.147" v="134" actId="165"/>
          <ac:cxnSpMkLst>
            <pc:docMk/>
            <pc:sldMk cId="1450487343" sldId="262"/>
            <ac:cxnSpMk id="15" creationId="{0B6F6211-5773-FC66-F657-A5EBF702973A}"/>
          </ac:cxnSpMkLst>
        </pc:cxnChg>
        <pc:cxnChg chg="mod">
          <ac:chgData name="Reza Amini Hounejani" userId="36cb0b73-58b2-4568-a1ab-00cd49301806" providerId="ADAL" clId="{CDB08FBE-FC2E-B54F-83CA-353720C73635}" dt="2023-02-21T14:28:10.610" v="58"/>
          <ac:cxnSpMkLst>
            <pc:docMk/>
            <pc:sldMk cId="1450487343" sldId="262"/>
            <ac:cxnSpMk id="143" creationId="{A4850183-0AC6-EDB6-FF35-ED9B9081481B}"/>
          </ac:cxnSpMkLst>
        </pc:cxnChg>
        <pc:cxnChg chg="mod">
          <ac:chgData name="Reza Amini Hounejani" userId="36cb0b73-58b2-4568-a1ab-00cd49301806" providerId="ADAL" clId="{CDB08FBE-FC2E-B54F-83CA-353720C73635}" dt="2023-02-21T14:28:10.610" v="58"/>
          <ac:cxnSpMkLst>
            <pc:docMk/>
            <pc:sldMk cId="1450487343" sldId="262"/>
            <ac:cxnSpMk id="144" creationId="{B948EF85-C919-FDD1-DB4A-F06050D2EA95}"/>
          </ac:cxnSpMkLst>
        </pc:cxnChg>
        <pc:cxnChg chg="mod">
          <ac:chgData name="Reza Amini Hounejani" userId="36cb0b73-58b2-4568-a1ab-00cd49301806" providerId="ADAL" clId="{CDB08FBE-FC2E-B54F-83CA-353720C73635}" dt="2023-02-21T14:28:10.610" v="58"/>
          <ac:cxnSpMkLst>
            <pc:docMk/>
            <pc:sldMk cId="1450487343" sldId="262"/>
            <ac:cxnSpMk id="162" creationId="{82D5807E-1736-BFC0-1CDE-CFC5349EE497}"/>
          </ac:cxnSpMkLst>
        </pc:cxnChg>
      </pc:sldChg>
    </pc:docChg>
  </pc:docChgLst>
  <pc:docChgLst>
    <pc:chgData name="Reza Amini Hounejani" userId="36cb0b73-58b2-4568-a1ab-00cd49301806" providerId="ADAL" clId="{F94D5C4B-2E09-464B-9E44-6157F40B7C0C}"/>
    <pc:docChg chg="undo custSel modSld">
      <pc:chgData name="Reza Amini Hounejani" userId="36cb0b73-58b2-4568-a1ab-00cd49301806" providerId="ADAL" clId="{F94D5C4B-2E09-464B-9E44-6157F40B7C0C}" dt="2023-08-02T14:28:34.368" v="430" actId="1038"/>
      <pc:docMkLst>
        <pc:docMk/>
      </pc:docMkLst>
      <pc:sldChg chg="delSp mod">
        <pc:chgData name="Reza Amini Hounejani" userId="36cb0b73-58b2-4568-a1ab-00cd49301806" providerId="ADAL" clId="{F94D5C4B-2E09-464B-9E44-6157F40B7C0C}" dt="2023-08-01T09:40:01.126" v="373" actId="478"/>
        <pc:sldMkLst>
          <pc:docMk/>
          <pc:sldMk cId="1897538530" sldId="256"/>
        </pc:sldMkLst>
        <pc:spChg chg="del">
          <ac:chgData name="Reza Amini Hounejani" userId="36cb0b73-58b2-4568-a1ab-00cd49301806" providerId="ADAL" clId="{F94D5C4B-2E09-464B-9E44-6157F40B7C0C}" dt="2023-08-01T09:39:57.455" v="371" actId="478"/>
          <ac:spMkLst>
            <pc:docMk/>
            <pc:sldMk cId="1897538530" sldId="256"/>
            <ac:spMk id="154" creationId="{EDA71FA1-2411-B55C-19D8-C0FD34C28F29}"/>
          </ac:spMkLst>
        </pc:spChg>
        <pc:spChg chg="del">
          <ac:chgData name="Reza Amini Hounejani" userId="36cb0b73-58b2-4568-a1ab-00cd49301806" providerId="ADAL" clId="{F94D5C4B-2E09-464B-9E44-6157F40B7C0C}" dt="2023-08-01T09:39:55.748" v="370" actId="478"/>
          <ac:spMkLst>
            <pc:docMk/>
            <pc:sldMk cId="1897538530" sldId="256"/>
            <ac:spMk id="155" creationId="{F5AD87F5-2514-2E95-5B6F-61A2B5125971}"/>
          </ac:spMkLst>
        </pc:spChg>
        <pc:spChg chg="del">
          <ac:chgData name="Reza Amini Hounejani" userId="36cb0b73-58b2-4568-a1ab-00cd49301806" providerId="ADAL" clId="{F94D5C4B-2E09-464B-9E44-6157F40B7C0C}" dt="2023-08-01T09:39:58.600" v="372" actId="478"/>
          <ac:spMkLst>
            <pc:docMk/>
            <pc:sldMk cId="1897538530" sldId="256"/>
            <ac:spMk id="156" creationId="{5A5051A2-0B2B-84B0-D7DB-4216A86C687B}"/>
          </ac:spMkLst>
        </pc:spChg>
        <pc:spChg chg="del">
          <ac:chgData name="Reza Amini Hounejani" userId="36cb0b73-58b2-4568-a1ab-00cd49301806" providerId="ADAL" clId="{F94D5C4B-2E09-464B-9E44-6157F40B7C0C}" dt="2023-08-01T09:40:01.126" v="373" actId="478"/>
          <ac:spMkLst>
            <pc:docMk/>
            <pc:sldMk cId="1897538530" sldId="256"/>
            <ac:spMk id="157" creationId="{74BD0321-D7D2-D785-5553-4DC9CF66A128}"/>
          </ac:spMkLst>
        </pc:spChg>
      </pc:sldChg>
      <pc:sldChg chg="addSp delSp modSp mod">
        <pc:chgData name="Reza Amini Hounejani" userId="36cb0b73-58b2-4568-a1ab-00cd49301806" providerId="ADAL" clId="{F94D5C4B-2E09-464B-9E44-6157F40B7C0C}" dt="2023-08-01T09:40:18.184" v="379" actId="478"/>
        <pc:sldMkLst>
          <pc:docMk/>
          <pc:sldMk cId="3807795133" sldId="257"/>
        </pc:sldMkLst>
        <pc:spChg chg="del">
          <ac:chgData name="Reza Amini Hounejani" userId="36cb0b73-58b2-4568-a1ab-00cd49301806" providerId="ADAL" clId="{F94D5C4B-2E09-464B-9E44-6157F40B7C0C}" dt="2023-08-01T09:40:11.071" v="377" actId="478"/>
          <ac:spMkLst>
            <pc:docMk/>
            <pc:sldMk cId="3807795133" sldId="257"/>
            <ac:spMk id="116" creationId="{74C7C444-900A-2A4D-A478-D3244E7D277F}"/>
          </ac:spMkLst>
        </pc:spChg>
        <pc:spChg chg="del">
          <ac:chgData name="Reza Amini Hounejani" userId="36cb0b73-58b2-4568-a1ab-00cd49301806" providerId="ADAL" clId="{F94D5C4B-2E09-464B-9E44-6157F40B7C0C}" dt="2023-08-01T09:40:15.895" v="378" actId="478"/>
          <ac:spMkLst>
            <pc:docMk/>
            <pc:sldMk cId="3807795133" sldId="257"/>
            <ac:spMk id="117" creationId="{5EFA5620-F03D-8CEB-7B04-0CA1C8E01D6C}"/>
          </ac:spMkLst>
        </pc:spChg>
        <pc:spChg chg="del mod">
          <ac:chgData name="Reza Amini Hounejani" userId="36cb0b73-58b2-4568-a1ab-00cd49301806" providerId="ADAL" clId="{F94D5C4B-2E09-464B-9E44-6157F40B7C0C}" dt="2023-08-01T09:40:08.826" v="375" actId="478"/>
          <ac:spMkLst>
            <pc:docMk/>
            <pc:sldMk cId="3807795133" sldId="257"/>
            <ac:spMk id="120" creationId="{B28510EF-4059-9D6A-14A4-D474B99EB44C}"/>
          </ac:spMkLst>
        </pc:spChg>
        <pc:spChg chg="del">
          <ac:chgData name="Reza Amini Hounejani" userId="36cb0b73-58b2-4568-a1ab-00cd49301806" providerId="ADAL" clId="{F94D5C4B-2E09-464B-9E44-6157F40B7C0C}" dt="2023-08-01T09:40:18.184" v="379" actId="478"/>
          <ac:spMkLst>
            <pc:docMk/>
            <pc:sldMk cId="3807795133" sldId="257"/>
            <ac:spMk id="121" creationId="{D67E7A32-3F75-45C8-A552-E76573C7286C}"/>
          </ac:spMkLst>
        </pc:spChg>
        <pc:spChg chg="del">
          <ac:chgData name="Reza Amini Hounejani" userId="36cb0b73-58b2-4568-a1ab-00cd49301806" providerId="ADAL" clId="{F94D5C4B-2E09-464B-9E44-6157F40B7C0C}" dt="2023-08-01T09:40:08.008" v="374" actId="478"/>
          <ac:spMkLst>
            <pc:docMk/>
            <pc:sldMk cId="3807795133" sldId="257"/>
            <ac:spMk id="133" creationId="{029CE293-B2A1-8287-7B33-48F97F24AEFD}"/>
          </ac:spMkLst>
        </pc:spChg>
        <pc:spChg chg="del">
          <ac:chgData name="Reza Amini Hounejani" userId="36cb0b73-58b2-4568-a1ab-00cd49301806" providerId="ADAL" clId="{F94D5C4B-2E09-464B-9E44-6157F40B7C0C}" dt="2023-08-01T09:40:09.612" v="376" actId="478"/>
          <ac:spMkLst>
            <pc:docMk/>
            <pc:sldMk cId="3807795133" sldId="257"/>
            <ac:spMk id="141" creationId="{E51EB36D-9350-3764-F0B5-5D809C17C503}"/>
          </ac:spMkLst>
        </pc:spChg>
        <pc:grpChg chg="add del">
          <ac:chgData name="Reza Amini Hounejani" userId="36cb0b73-58b2-4568-a1ab-00cd49301806" providerId="ADAL" clId="{F94D5C4B-2E09-464B-9E44-6157F40B7C0C}" dt="2023-07-28T09:21:09.310" v="282" actId="478"/>
          <ac:grpSpMkLst>
            <pc:docMk/>
            <pc:sldMk cId="3807795133" sldId="257"/>
            <ac:grpSpMk id="6" creationId="{91BA0912-FB72-44AE-DD43-D4881CC1EB85}"/>
          </ac:grpSpMkLst>
        </pc:grpChg>
        <pc:grpChg chg="add mod">
          <ac:chgData name="Reza Amini Hounejani" userId="36cb0b73-58b2-4568-a1ab-00cd49301806" providerId="ADAL" clId="{F94D5C4B-2E09-464B-9E44-6157F40B7C0C}" dt="2023-07-28T09:21:33.731" v="289" actId="164"/>
          <ac:grpSpMkLst>
            <pc:docMk/>
            <pc:sldMk cId="3807795133" sldId="257"/>
            <ac:grpSpMk id="16" creationId="{197F24A6-3E3C-1074-6AE7-BA41B4DC27B4}"/>
          </ac:grpSpMkLst>
        </pc:grpChg>
        <pc:grpChg chg="mod">
          <ac:chgData name="Reza Amini Hounejani" userId="36cb0b73-58b2-4568-a1ab-00cd49301806" providerId="ADAL" clId="{F94D5C4B-2E09-464B-9E44-6157F40B7C0C}" dt="2023-07-28T09:21:33.731" v="289" actId="164"/>
          <ac:grpSpMkLst>
            <pc:docMk/>
            <pc:sldMk cId="3807795133" sldId="257"/>
            <ac:grpSpMk id="30" creationId="{D6BB755B-FB79-E2F2-45AE-EF0B59652CE8}"/>
          </ac:grpSpMkLst>
        </pc:grpChg>
        <pc:grpChg chg="mod">
          <ac:chgData name="Reza Amini Hounejani" userId="36cb0b73-58b2-4568-a1ab-00cd49301806" providerId="ADAL" clId="{F94D5C4B-2E09-464B-9E44-6157F40B7C0C}" dt="2023-07-28T09:20:52.235" v="279" actId="478"/>
          <ac:grpSpMkLst>
            <pc:docMk/>
            <pc:sldMk cId="3807795133" sldId="257"/>
            <ac:grpSpMk id="170" creationId="{CBD9AB49-6810-D4D2-D4E6-0B88D5A9AEC5}"/>
          </ac:grpSpMkLst>
        </pc:grpChg>
        <pc:picChg chg="add del mod">
          <ac:chgData name="Reza Amini Hounejani" userId="36cb0b73-58b2-4568-a1ab-00cd49301806" providerId="ADAL" clId="{F94D5C4B-2E09-464B-9E44-6157F40B7C0C}" dt="2023-07-28T09:21:09.310" v="282" actId="478"/>
          <ac:picMkLst>
            <pc:docMk/>
            <pc:sldMk cId="3807795133" sldId="257"/>
            <ac:picMk id="3" creationId="{68AC0835-4B2C-B482-765B-22DA70532A3E}"/>
          </ac:picMkLst>
        </pc:picChg>
        <pc:picChg chg="add mod">
          <ac:chgData name="Reza Amini Hounejani" userId="36cb0b73-58b2-4568-a1ab-00cd49301806" providerId="ADAL" clId="{F94D5C4B-2E09-464B-9E44-6157F40B7C0C}" dt="2023-07-28T09:21:33.731" v="289" actId="164"/>
          <ac:picMkLst>
            <pc:docMk/>
            <pc:sldMk cId="3807795133" sldId="257"/>
            <ac:picMk id="9" creationId="{359B01BD-E71F-63D2-D2C7-B10EDC7CDEE1}"/>
          </ac:picMkLst>
        </pc:picChg>
      </pc:sldChg>
      <pc:sldChg chg="modSp mod">
        <pc:chgData name="Reza Amini Hounejani" userId="36cb0b73-58b2-4568-a1ab-00cd49301806" providerId="ADAL" clId="{F94D5C4B-2E09-464B-9E44-6157F40B7C0C}" dt="2023-08-01T09:27:43.862" v="369" actId="1076"/>
        <pc:sldMkLst>
          <pc:docMk/>
          <pc:sldMk cId="2229082649" sldId="258"/>
        </pc:sldMkLst>
        <pc:spChg chg="mod">
          <ac:chgData name="Reza Amini Hounejani" userId="36cb0b73-58b2-4568-a1ab-00cd49301806" providerId="ADAL" clId="{F94D5C4B-2E09-464B-9E44-6157F40B7C0C}" dt="2023-08-01T09:27:43.862" v="369" actId="1076"/>
          <ac:spMkLst>
            <pc:docMk/>
            <pc:sldMk cId="2229082649" sldId="258"/>
            <ac:spMk id="3" creationId="{EEBACB06-9B98-0059-D61A-6E5969354BAC}"/>
          </ac:spMkLst>
        </pc:spChg>
        <pc:spChg chg="mod">
          <ac:chgData name="Reza Amini Hounejani" userId="36cb0b73-58b2-4568-a1ab-00cd49301806" providerId="ADAL" clId="{F94D5C4B-2E09-464B-9E44-6157F40B7C0C}" dt="2023-08-01T09:27:43.862" v="369" actId="1076"/>
          <ac:spMkLst>
            <pc:docMk/>
            <pc:sldMk cId="2229082649" sldId="258"/>
            <ac:spMk id="4" creationId="{F2EB4C31-F29C-5285-CDD1-7778E0FA1E63}"/>
          </ac:spMkLst>
        </pc:spChg>
        <pc:spChg chg="mod">
          <ac:chgData name="Reza Amini Hounejani" userId="36cb0b73-58b2-4568-a1ab-00cd49301806" providerId="ADAL" clId="{F94D5C4B-2E09-464B-9E44-6157F40B7C0C}" dt="2023-08-01T09:26:59.007" v="363" actId="552"/>
          <ac:spMkLst>
            <pc:docMk/>
            <pc:sldMk cId="2229082649" sldId="258"/>
            <ac:spMk id="13" creationId="{2AF3E4F1-1499-1065-CEB9-A14D716283B0}"/>
          </ac:spMkLst>
        </pc:spChg>
        <pc:spChg chg="mod">
          <ac:chgData name="Reza Amini Hounejani" userId="36cb0b73-58b2-4568-a1ab-00cd49301806" providerId="ADAL" clId="{F94D5C4B-2E09-464B-9E44-6157F40B7C0C}" dt="2023-08-01T09:26:59.007" v="363" actId="552"/>
          <ac:spMkLst>
            <pc:docMk/>
            <pc:sldMk cId="2229082649" sldId="258"/>
            <ac:spMk id="14" creationId="{3B58E536-25E8-2430-C140-583F2D869296}"/>
          </ac:spMkLst>
        </pc:spChg>
        <pc:spChg chg="mod">
          <ac:chgData name="Reza Amini Hounejani" userId="36cb0b73-58b2-4568-a1ab-00cd49301806" providerId="ADAL" clId="{F94D5C4B-2E09-464B-9E44-6157F40B7C0C}" dt="2023-08-01T09:27:26.540" v="366" actId="12789"/>
          <ac:spMkLst>
            <pc:docMk/>
            <pc:sldMk cId="2229082649" sldId="258"/>
            <ac:spMk id="15" creationId="{178C1CCF-C845-3889-DD41-C4ACAA9FD9CD}"/>
          </ac:spMkLst>
        </pc:spChg>
        <pc:spChg chg="mod">
          <ac:chgData name="Reza Amini Hounejani" userId="36cb0b73-58b2-4568-a1ab-00cd49301806" providerId="ADAL" clId="{F94D5C4B-2E09-464B-9E44-6157F40B7C0C}" dt="2023-08-01T09:27:26.540" v="366" actId="12789"/>
          <ac:spMkLst>
            <pc:docMk/>
            <pc:sldMk cId="2229082649" sldId="258"/>
            <ac:spMk id="18" creationId="{B9ED5E41-12FA-82E4-2E8D-FA3511646DAC}"/>
          </ac:spMkLst>
        </pc:spChg>
        <pc:grpChg chg="mod">
          <ac:chgData name="Reza Amini Hounejani" userId="36cb0b73-58b2-4568-a1ab-00cd49301806" providerId="ADAL" clId="{F94D5C4B-2E09-464B-9E44-6157F40B7C0C}" dt="2023-08-01T09:27:43.862" v="369" actId="1076"/>
          <ac:grpSpMkLst>
            <pc:docMk/>
            <pc:sldMk cId="2229082649" sldId="258"/>
            <ac:grpSpMk id="157" creationId="{6B267AA3-410C-C08A-A4EC-478C88398CB0}"/>
          </ac:grpSpMkLst>
        </pc:grpChg>
        <pc:grpChg chg="mod">
          <ac:chgData name="Reza Amini Hounejani" userId="36cb0b73-58b2-4568-a1ab-00cd49301806" providerId="ADAL" clId="{F94D5C4B-2E09-464B-9E44-6157F40B7C0C}" dt="2023-08-01T09:27:43.862" v="369" actId="1076"/>
          <ac:grpSpMkLst>
            <pc:docMk/>
            <pc:sldMk cId="2229082649" sldId="258"/>
            <ac:grpSpMk id="158" creationId="{9EC5AF0D-A162-B762-56C3-826CDA114AD6}"/>
          </ac:grpSpMkLst>
        </pc:grpChg>
        <pc:grpChg chg="mod">
          <ac:chgData name="Reza Amini Hounejani" userId="36cb0b73-58b2-4568-a1ab-00cd49301806" providerId="ADAL" clId="{F94D5C4B-2E09-464B-9E44-6157F40B7C0C}" dt="2023-08-01T09:27:43.862" v="369" actId="1076"/>
          <ac:grpSpMkLst>
            <pc:docMk/>
            <pc:sldMk cId="2229082649" sldId="258"/>
            <ac:grpSpMk id="159" creationId="{45FBD98D-3692-E2E3-821A-4089F87602B3}"/>
          </ac:grpSpMkLst>
        </pc:grpChg>
        <pc:grpChg chg="mod">
          <ac:chgData name="Reza Amini Hounejani" userId="36cb0b73-58b2-4568-a1ab-00cd49301806" providerId="ADAL" clId="{F94D5C4B-2E09-464B-9E44-6157F40B7C0C}" dt="2023-08-01T09:27:16.943" v="365" actId="12789"/>
          <ac:grpSpMkLst>
            <pc:docMk/>
            <pc:sldMk cId="2229082649" sldId="258"/>
            <ac:grpSpMk id="321" creationId="{A0EB5EA8-D87E-C2A6-815D-B12AB2A531C9}"/>
          </ac:grpSpMkLst>
        </pc:grpChg>
        <pc:grpChg chg="mod">
          <ac:chgData name="Reza Amini Hounejani" userId="36cb0b73-58b2-4568-a1ab-00cd49301806" providerId="ADAL" clId="{F94D5C4B-2E09-464B-9E44-6157F40B7C0C}" dt="2023-08-01T09:27:16.943" v="365" actId="12789"/>
          <ac:grpSpMkLst>
            <pc:docMk/>
            <pc:sldMk cId="2229082649" sldId="258"/>
            <ac:grpSpMk id="322" creationId="{60368697-6E00-27AB-BD96-66CBC3EA8D94}"/>
          </ac:grpSpMkLst>
        </pc:grpChg>
      </pc:sldChg>
      <pc:sldChg chg="addSp delSp modSp mod">
        <pc:chgData name="Reza Amini Hounejani" userId="36cb0b73-58b2-4568-a1ab-00cd49301806" providerId="ADAL" clId="{F94D5C4B-2E09-464B-9E44-6157F40B7C0C}" dt="2023-08-01T09:40:37.025" v="382" actId="478"/>
        <pc:sldMkLst>
          <pc:docMk/>
          <pc:sldMk cId="715266389" sldId="259"/>
        </pc:sldMkLst>
        <pc:spChg chg="del">
          <ac:chgData name="Reza Amini Hounejani" userId="36cb0b73-58b2-4568-a1ab-00cd49301806" providerId="ADAL" clId="{F94D5C4B-2E09-464B-9E44-6157F40B7C0C}" dt="2023-08-01T09:40:31.826" v="381" actId="478"/>
          <ac:spMkLst>
            <pc:docMk/>
            <pc:sldMk cId="715266389" sldId="259"/>
            <ac:spMk id="10" creationId="{13A089A5-562F-2C06-E2EC-BB73E2FCC13F}"/>
          </ac:spMkLst>
        </pc:spChg>
        <pc:spChg chg="del">
          <ac:chgData name="Reza Amini Hounejani" userId="36cb0b73-58b2-4568-a1ab-00cd49301806" providerId="ADAL" clId="{F94D5C4B-2E09-464B-9E44-6157F40B7C0C}" dt="2023-08-01T09:40:31.072" v="380" actId="478"/>
          <ac:spMkLst>
            <pc:docMk/>
            <pc:sldMk cId="715266389" sldId="259"/>
            <ac:spMk id="14" creationId="{0342B42E-46C5-193E-68D1-7D94112CE584}"/>
          </ac:spMkLst>
        </pc:spChg>
        <pc:spChg chg="del">
          <ac:chgData name="Reza Amini Hounejani" userId="36cb0b73-58b2-4568-a1ab-00cd49301806" providerId="ADAL" clId="{F94D5C4B-2E09-464B-9E44-6157F40B7C0C}" dt="2023-08-01T09:40:37.025" v="382" actId="478"/>
          <ac:spMkLst>
            <pc:docMk/>
            <pc:sldMk cId="715266389" sldId="259"/>
            <ac:spMk id="98" creationId="{AE1FE19B-F365-ABA0-AE40-1B65EB77B199}"/>
          </ac:spMkLst>
        </pc:spChg>
        <pc:grpChg chg="del">
          <ac:chgData name="Reza Amini Hounejani" userId="36cb0b73-58b2-4568-a1ab-00cd49301806" providerId="ADAL" clId="{F94D5C4B-2E09-464B-9E44-6157F40B7C0C}" dt="2023-07-27T08:17:08.177" v="262" actId="478"/>
          <ac:grpSpMkLst>
            <pc:docMk/>
            <pc:sldMk cId="715266389" sldId="259"/>
            <ac:grpSpMk id="24" creationId="{D8E02C2D-B8A3-17A0-59CC-E69D5EAE69A2}"/>
          </ac:grpSpMkLst>
        </pc:grpChg>
        <pc:grpChg chg="topLvl">
          <ac:chgData name="Reza Amini Hounejani" userId="36cb0b73-58b2-4568-a1ab-00cd49301806" providerId="ADAL" clId="{F94D5C4B-2E09-464B-9E44-6157F40B7C0C}" dt="2023-07-27T08:17:08.177" v="262" actId="478"/>
          <ac:grpSpMkLst>
            <pc:docMk/>
            <pc:sldMk cId="715266389" sldId="259"/>
            <ac:grpSpMk id="142" creationId="{16726547-532C-DF24-68D1-1C99A80BCEA1}"/>
          </ac:grpSpMkLst>
        </pc:grpChg>
        <pc:picChg chg="add del mod">
          <ac:chgData name="Reza Amini Hounejani" userId="36cb0b73-58b2-4568-a1ab-00cd49301806" providerId="ADAL" clId="{F94D5C4B-2E09-464B-9E44-6157F40B7C0C}" dt="2023-07-31T14:07:56.660" v="338" actId="478"/>
          <ac:picMkLst>
            <pc:docMk/>
            <pc:sldMk cId="715266389" sldId="259"/>
            <ac:picMk id="19" creationId="{97687093-A154-CFF4-7849-8C1516B08574}"/>
          </ac:picMkLst>
        </pc:picChg>
        <pc:picChg chg="del mod topLvl modCrop">
          <ac:chgData name="Reza Amini Hounejani" userId="36cb0b73-58b2-4568-a1ab-00cd49301806" providerId="ADAL" clId="{F94D5C4B-2E09-464B-9E44-6157F40B7C0C}" dt="2023-07-27T08:17:08.177" v="262" actId="478"/>
          <ac:picMkLst>
            <pc:docMk/>
            <pc:sldMk cId="715266389" sldId="259"/>
            <ac:picMk id="19" creationId="{B0515E3B-93A6-4177-59E7-D10774A9A075}"/>
          </ac:picMkLst>
        </pc:picChg>
        <pc:picChg chg="add mod">
          <ac:chgData name="Reza Amini Hounejani" userId="36cb0b73-58b2-4568-a1ab-00cd49301806" providerId="ADAL" clId="{F94D5C4B-2E09-464B-9E44-6157F40B7C0C}" dt="2023-07-31T14:11:55.477" v="360" actId="1037"/>
          <ac:picMkLst>
            <pc:docMk/>
            <pc:sldMk cId="715266389" sldId="259"/>
            <ac:picMk id="20" creationId="{25BE954B-3C94-690C-BAC6-E1563B4D538F}"/>
          </ac:picMkLst>
        </pc:picChg>
        <pc:picChg chg="add del mod">
          <ac:chgData name="Reza Amini Hounejani" userId="36cb0b73-58b2-4568-a1ab-00cd49301806" providerId="ADAL" clId="{F94D5C4B-2E09-464B-9E44-6157F40B7C0C}" dt="2023-07-31T14:03:06.766" v="291" actId="478"/>
          <ac:picMkLst>
            <pc:docMk/>
            <pc:sldMk cId="715266389" sldId="259"/>
            <ac:picMk id="20" creationId="{B2B6CDFC-EDCB-4613-8189-26D4374A4890}"/>
          </ac:picMkLst>
        </pc:picChg>
      </pc:sldChg>
      <pc:sldChg chg="delSp mod">
        <pc:chgData name="Reza Amini Hounejani" userId="36cb0b73-58b2-4568-a1ab-00cd49301806" providerId="ADAL" clId="{F94D5C4B-2E09-464B-9E44-6157F40B7C0C}" dt="2023-08-01T09:41:04.606" v="391" actId="478"/>
        <pc:sldMkLst>
          <pc:docMk/>
          <pc:sldMk cId="1578300178" sldId="260"/>
        </pc:sldMkLst>
        <pc:spChg chg="del">
          <ac:chgData name="Reza Amini Hounejani" userId="36cb0b73-58b2-4568-a1ab-00cd49301806" providerId="ADAL" clId="{F94D5C4B-2E09-464B-9E44-6157F40B7C0C}" dt="2023-08-01T09:40:44.110" v="383" actId="478"/>
          <ac:spMkLst>
            <pc:docMk/>
            <pc:sldMk cId="1578300178" sldId="260"/>
            <ac:spMk id="41" creationId="{C155425C-1201-8903-D87F-355B27E299BC}"/>
          </ac:spMkLst>
        </pc:spChg>
        <pc:spChg chg="del">
          <ac:chgData name="Reza Amini Hounejani" userId="36cb0b73-58b2-4568-a1ab-00cd49301806" providerId="ADAL" clId="{F94D5C4B-2E09-464B-9E44-6157F40B7C0C}" dt="2023-08-01T09:41:04.606" v="391" actId="478"/>
          <ac:spMkLst>
            <pc:docMk/>
            <pc:sldMk cId="1578300178" sldId="260"/>
            <ac:spMk id="63" creationId="{0E8F94DF-E45B-44CE-99DD-7812ABE3862C}"/>
          </ac:spMkLst>
        </pc:spChg>
        <pc:spChg chg="del">
          <ac:chgData name="Reza Amini Hounejani" userId="36cb0b73-58b2-4568-a1ab-00cd49301806" providerId="ADAL" clId="{F94D5C4B-2E09-464B-9E44-6157F40B7C0C}" dt="2023-08-01T09:41:02.964" v="390" actId="478"/>
          <ac:spMkLst>
            <pc:docMk/>
            <pc:sldMk cId="1578300178" sldId="260"/>
            <ac:spMk id="69" creationId="{69ED12F2-79FD-9708-B3BD-F723516BF512}"/>
          </ac:spMkLst>
        </pc:spChg>
        <pc:spChg chg="del">
          <ac:chgData name="Reza Amini Hounejani" userId="36cb0b73-58b2-4568-a1ab-00cd49301806" providerId="ADAL" clId="{F94D5C4B-2E09-464B-9E44-6157F40B7C0C}" dt="2023-08-01T09:40:48.778" v="385" actId="478"/>
          <ac:spMkLst>
            <pc:docMk/>
            <pc:sldMk cId="1578300178" sldId="260"/>
            <ac:spMk id="80" creationId="{0DEF2151-470A-BE79-6946-51D35C46D6F2}"/>
          </ac:spMkLst>
        </pc:spChg>
        <pc:spChg chg="del">
          <ac:chgData name="Reza Amini Hounejani" userId="36cb0b73-58b2-4568-a1ab-00cd49301806" providerId="ADAL" clId="{F94D5C4B-2E09-464B-9E44-6157F40B7C0C}" dt="2023-08-01T09:40:46.759" v="384" actId="478"/>
          <ac:spMkLst>
            <pc:docMk/>
            <pc:sldMk cId="1578300178" sldId="260"/>
            <ac:spMk id="84" creationId="{CCDE919E-FE4F-D09B-EA8B-F423F46B0BC6}"/>
          </ac:spMkLst>
        </pc:spChg>
        <pc:spChg chg="del">
          <ac:chgData name="Reza Amini Hounejani" userId="36cb0b73-58b2-4568-a1ab-00cd49301806" providerId="ADAL" clId="{F94D5C4B-2E09-464B-9E44-6157F40B7C0C}" dt="2023-08-01T09:40:52.072" v="386" actId="478"/>
          <ac:spMkLst>
            <pc:docMk/>
            <pc:sldMk cId="1578300178" sldId="260"/>
            <ac:spMk id="98" creationId="{B8CB5601-7207-9412-2E93-539A3B941F2B}"/>
          </ac:spMkLst>
        </pc:spChg>
        <pc:spChg chg="del">
          <ac:chgData name="Reza Amini Hounejani" userId="36cb0b73-58b2-4568-a1ab-00cd49301806" providerId="ADAL" clId="{F94D5C4B-2E09-464B-9E44-6157F40B7C0C}" dt="2023-08-01T09:40:54.692" v="387" actId="478"/>
          <ac:spMkLst>
            <pc:docMk/>
            <pc:sldMk cId="1578300178" sldId="260"/>
            <ac:spMk id="101" creationId="{5A361756-16EB-2ADA-C4FC-DACF0D6C4763}"/>
          </ac:spMkLst>
        </pc:spChg>
        <pc:spChg chg="del">
          <ac:chgData name="Reza Amini Hounejani" userId="36cb0b73-58b2-4568-a1ab-00cd49301806" providerId="ADAL" clId="{F94D5C4B-2E09-464B-9E44-6157F40B7C0C}" dt="2023-08-01T09:40:58.091" v="388" actId="478"/>
          <ac:spMkLst>
            <pc:docMk/>
            <pc:sldMk cId="1578300178" sldId="260"/>
            <ac:spMk id="110" creationId="{339FE3F8-820F-A962-FAFD-1D948FF556D3}"/>
          </ac:spMkLst>
        </pc:spChg>
        <pc:spChg chg="del">
          <ac:chgData name="Reza Amini Hounejani" userId="36cb0b73-58b2-4568-a1ab-00cd49301806" providerId="ADAL" clId="{F94D5C4B-2E09-464B-9E44-6157F40B7C0C}" dt="2023-08-01T09:40:59.882" v="389" actId="478"/>
          <ac:spMkLst>
            <pc:docMk/>
            <pc:sldMk cId="1578300178" sldId="260"/>
            <ac:spMk id="111" creationId="{22811382-9EDA-7A93-8D87-174565685876}"/>
          </ac:spMkLst>
        </pc:spChg>
      </pc:sldChg>
      <pc:sldChg chg="addSp delSp modSp mod">
        <pc:chgData name="Reza Amini Hounejani" userId="36cb0b73-58b2-4568-a1ab-00cd49301806" providerId="ADAL" clId="{F94D5C4B-2E09-464B-9E44-6157F40B7C0C}" dt="2023-08-02T14:28:34.368" v="430" actId="1038"/>
        <pc:sldMkLst>
          <pc:docMk/>
          <pc:sldMk cId="269800214" sldId="261"/>
        </pc:sldMkLst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8" creationId="{4107B0A9-3BD7-3359-E9D8-CE39FA55F2C3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9" creationId="{28BBB0D4-A16B-4231-7D5D-F8FB27D4A52B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10" creationId="{A9218915-FDC9-F634-4E32-A64B61A392AD}"/>
          </ac:spMkLst>
        </pc:spChg>
        <pc:spChg chg="add mod">
          <ac:chgData name="Reza Amini Hounejani" userId="36cb0b73-58b2-4568-a1ab-00cd49301806" providerId="ADAL" clId="{F94D5C4B-2E09-464B-9E44-6157F40B7C0C}" dt="2023-07-26T11:41:11.738" v="251" actId="20577"/>
          <ac:spMkLst>
            <pc:docMk/>
            <pc:sldMk cId="269800214" sldId="261"/>
            <ac:spMk id="11" creationId="{3334FAF7-842F-A2B9-C826-7A7D2EFC7402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12" creationId="{A9EAC924-BA3B-341A-8434-B18DA907D5C0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13" creationId="{556BC88D-2DF8-4F4B-33DC-15994BD950BE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14" creationId="{6966B0C9-DD13-5D15-57D9-AF413EEE8299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15" creationId="{3759AD00-291B-3E41-D50B-AC51A150EFC2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16" creationId="{6C41E1E8-6169-945F-B897-F23B0B8ED97B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17" creationId="{8BFF4042-363C-8DEB-E497-EB5B3E8ADDF8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21" creationId="{8FA5128A-FEE8-FF72-6037-C18517EE01C5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23" creationId="{1BFA74D5-29E5-7580-FF3E-B3DB131A1645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24" creationId="{F060A642-2007-4400-5240-8F3723D50B2D}"/>
          </ac:spMkLst>
        </pc:spChg>
        <pc:spChg chg="mod">
          <ac:chgData name="Reza Amini Hounejani" userId="36cb0b73-58b2-4568-a1ab-00cd49301806" providerId="ADAL" clId="{F94D5C4B-2E09-464B-9E44-6157F40B7C0C}" dt="2023-08-02T14:28:34.368" v="430" actId="1038"/>
          <ac:spMkLst>
            <pc:docMk/>
            <pc:sldMk cId="269800214" sldId="261"/>
            <ac:spMk id="25" creationId="{F568064F-47CD-DBE3-0C0C-8B44A9AA1B03}"/>
          </ac:spMkLst>
        </pc:spChg>
        <pc:spChg chg="mod">
          <ac:chgData name="Reza Amini Hounejani" userId="36cb0b73-58b2-4568-a1ab-00cd49301806" providerId="ADAL" clId="{F94D5C4B-2E09-464B-9E44-6157F40B7C0C}" dt="2023-08-02T14:28:34.368" v="430" actId="1038"/>
          <ac:spMkLst>
            <pc:docMk/>
            <pc:sldMk cId="269800214" sldId="261"/>
            <ac:spMk id="26" creationId="{AB1D4753-16C0-FBA9-DE6A-9ADE606378E2}"/>
          </ac:spMkLst>
        </pc:spChg>
        <pc:spChg chg="del">
          <ac:chgData name="Reza Amini Hounejani" userId="36cb0b73-58b2-4568-a1ab-00cd49301806" providerId="ADAL" clId="{F94D5C4B-2E09-464B-9E44-6157F40B7C0C}" dt="2023-07-24T12:19:43.450" v="69" actId="478"/>
          <ac:spMkLst>
            <pc:docMk/>
            <pc:sldMk cId="269800214" sldId="261"/>
            <ac:spMk id="27" creationId="{DC3F9064-FF1E-EC4B-BBD8-4BA2D9A2E4C9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28" creationId="{4D5472F8-AD9A-EDD8-EAB0-482682EA287D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29" creationId="{1849EA63-FE75-4C13-646D-751DCEBF84C6}"/>
          </ac:spMkLst>
        </pc:spChg>
        <pc:spChg chg="mod">
          <ac:chgData name="Reza Amini Hounejani" userId="36cb0b73-58b2-4568-a1ab-00cd49301806" providerId="ADAL" clId="{F94D5C4B-2E09-464B-9E44-6157F40B7C0C}" dt="2023-08-02T14:28:20.935" v="427" actId="1038"/>
          <ac:spMkLst>
            <pc:docMk/>
            <pc:sldMk cId="269800214" sldId="261"/>
            <ac:spMk id="30" creationId="{71C67A44-33D3-996A-FDE2-9C32F22046FC}"/>
          </ac:spMkLst>
        </pc:spChg>
        <pc:spChg chg="del">
          <ac:chgData name="Reza Amini Hounejani" userId="36cb0b73-58b2-4568-a1ab-00cd49301806" providerId="ADAL" clId="{F94D5C4B-2E09-464B-9E44-6157F40B7C0C}" dt="2023-07-24T12:19:39.220" v="68" actId="478"/>
          <ac:spMkLst>
            <pc:docMk/>
            <pc:sldMk cId="269800214" sldId="261"/>
            <ac:spMk id="31" creationId="{66160A75-A3E9-D491-693B-FCDAEAD906B8}"/>
          </ac:spMkLst>
        </pc:spChg>
        <pc:spChg chg="mod">
          <ac:chgData name="Reza Amini Hounejani" userId="36cb0b73-58b2-4568-a1ab-00cd49301806" providerId="ADAL" clId="{F94D5C4B-2E09-464B-9E44-6157F40B7C0C}" dt="2023-08-02T14:28:20.935" v="427" actId="1038"/>
          <ac:spMkLst>
            <pc:docMk/>
            <pc:sldMk cId="269800214" sldId="261"/>
            <ac:spMk id="32" creationId="{D4654BF1-D8FC-36B9-75E5-23DAEFA003F5}"/>
          </ac:spMkLst>
        </pc:spChg>
        <pc:spChg chg="mod">
          <ac:chgData name="Reza Amini Hounejani" userId="36cb0b73-58b2-4568-a1ab-00cd49301806" providerId="ADAL" clId="{F94D5C4B-2E09-464B-9E44-6157F40B7C0C}" dt="2023-08-02T14:27:48.840" v="415" actId="20577"/>
          <ac:spMkLst>
            <pc:docMk/>
            <pc:sldMk cId="269800214" sldId="261"/>
            <ac:spMk id="33" creationId="{701F7FBD-E1A0-05B1-4255-DBE6F9E3C77D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34" creationId="{C5B8DB23-28C0-E817-65B9-F12473F6AC5E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38" creationId="{BAC20769-9E36-E28D-C42A-2C6AF98541FB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45" creationId="{6D08FB89-A2DC-0BD3-E578-FB1E155EE7E3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46" creationId="{FCC12FB6-58CB-2D10-DF24-6D09B679B5B2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56" creationId="{7C937CE2-867F-6AFB-E8D4-BFA49A6EBD4C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57" creationId="{65932EA0-2F2B-582B-0FF4-F5A22AADDF8A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58" creationId="{55F542B6-EEE9-FF89-5762-01CF36E8E860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59" creationId="{84F62275-2ED3-4A2A-D34E-E4E4A31D6C99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60" creationId="{0899B095-13CE-C4DF-D68D-DC4DAEAE2FC0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61" creationId="{0B24528A-D29F-1EF2-D421-DE45246BCAB1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62" creationId="{78DE8071-3648-34AB-B9D9-4E45E4A84927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63" creationId="{FA2699CD-F8D7-84A9-98D4-6FD51EC8D461}"/>
          </ac:spMkLst>
        </pc:spChg>
        <pc:spChg chg="mod">
          <ac:chgData name="Reza Amini Hounejani" userId="36cb0b73-58b2-4568-a1ab-00cd49301806" providerId="ADAL" clId="{F94D5C4B-2E09-464B-9E44-6157F40B7C0C}" dt="2023-07-26T11:41:09.644" v="249" actId="571"/>
          <ac:spMkLst>
            <pc:docMk/>
            <pc:sldMk cId="269800214" sldId="261"/>
            <ac:spMk id="73" creationId="{82687445-DD90-0D8F-E1CB-774F75C3B686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119" creationId="{CA781EB6-2506-661C-ABC4-013870D3D4AC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120" creationId="{47DC6C1E-BD95-1EE7-30A4-F4AA3EB6996F}"/>
          </ac:spMkLst>
        </pc:spChg>
        <pc:spChg chg="mod">
          <ac:chgData name="Reza Amini Hounejani" userId="36cb0b73-58b2-4568-a1ab-00cd49301806" providerId="ADAL" clId="{F94D5C4B-2E09-464B-9E44-6157F40B7C0C}" dt="2023-07-24T12:19:15.967" v="60" actId="1035"/>
          <ac:spMkLst>
            <pc:docMk/>
            <pc:sldMk cId="269800214" sldId="261"/>
            <ac:spMk id="121" creationId="{7367E09A-747F-07CA-6A79-CBA33EDB012A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124" creationId="{9A5A2823-5D2E-6098-75C7-19AFB39682CB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125" creationId="{41911E68-5387-C85C-7347-5621EFC8695B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126" creationId="{EEBE429C-59D6-82D1-B119-77BF1B8DAE59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127" creationId="{4BB0F239-C14D-841D-097C-D32C26E3ACEC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129" creationId="{883E47B9-E2D6-63E2-96A9-9453D5808C86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131" creationId="{26687ACC-CFD0-1031-1A88-406829F5248C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133" creationId="{A5CD06CB-8095-7B9D-EE8E-7D73B22549F2}"/>
          </ac:spMkLst>
        </pc:spChg>
        <pc:spChg chg="mod">
          <ac:chgData name="Reza Amini Hounejani" userId="36cb0b73-58b2-4568-a1ab-00cd49301806" providerId="ADAL" clId="{F94D5C4B-2E09-464B-9E44-6157F40B7C0C}" dt="2023-07-26T11:41:35.873" v="255" actId="164"/>
          <ac:spMkLst>
            <pc:docMk/>
            <pc:sldMk cId="269800214" sldId="261"/>
            <ac:spMk id="134" creationId="{13B655E6-08F6-FFBD-8255-BA625751B9D9}"/>
          </ac:spMkLst>
        </pc:spChg>
        <pc:grpChg chg="add mod">
          <ac:chgData name="Reza Amini Hounejani" userId="36cb0b73-58b2-4568-a1ab-00cd49301806" providerId="ADAL" clId="{F94D5C4B-2E09-464B-9E44-6157F40B7C0C}" dt="2023-07-26T11:41:26.295" v="254" actId="164"/>
          <ac:grpSpMkLst>
            <pc:docMk/>
            <pc:sldMk cId="269800214" sldId="261"/>
            <ac:grpSpMk id="18" creationId="{72747FE3-7718-BF19-47A8-9DB8E340AF91}"/>
          </ac:grpSpMkLst>
        </pc:grpChg>
        <pc:grpChg chg="add mod">
          <ac:chgData name="Reza Amini Hounejani" userId="36cb0b73-58b2-4568-a1ab-00cd49301806" providerId="ADAL" clId="{F94D5C4B-2E09-464B-9E44-6157F40B7C0C}" dt="2023-07-26T11:41:45.421" v="256" actId="1076"/>
          <ac:grpSpMkLst>
            <pc:docMk/>
            <pc:sldMk cId="269800214" sldId="261"/>
            <ac:grpSpMk id="19" creationId="{24308102-C625-282C-2EB2-63959F71B0A5}"/>
          </ac:grpSpMkLst>
        </pc:grpChg>
        <pc:grpChg chg="mod">
          <ac:chgData name="Reza Amini Hounejani" userId="36cb0b73-58b2-4568-a1ab-00cd49301806" providerId="ADAL" clId="{F94D5C4B-2E09-464B-9E44-6157F40B7C0C}" dt="2023-07-26T11:41:35.873" v="255" actId="164"/>
          <ac:grpSpMkLst>
            <pc:docMk/>
            <pc:sldMk cId="269800214" sldId="261"/>
            <ac:grpSpMk id="123" creationId="{9D57E546-3E19-32B2-1434-4D740B537761}"/>
          </ac:grpSpMkLst>
        </pc:grpChg>
        <pc:grpChg chg="mod">
          <ac:chgData name="Reza Amini Hounejani" userId="36cb0b73-58b2-4568-a1ab-00cd49301806" providerId="ADAL" clId="{F94D5C4B-2E09-464B-9E44-6157F40B7C0C}" dt="2023-07-26T11:41:26.295" v="254" actId="164"/>
          <ac:grpSpMkLst>
            <pc:docMk/>
            <pc:sldMk cId="269800214" sldId="261"/>
            <ac:grpSpMk id="191" creationId="{77DA745D-3DD7-2930-7E54-0ED8F48DC2DF}"/>
          </ac:grpSpMkLst>
        </pc:grpChg>
        <pc:picChg chg="add mod">
          <ac:chgData name="Reza Amini Hounejani" userId="36cb0b73-58b2-4568-a1ab-00cd49301806" providerId="ADAL" clId="{F94D5C4B-2E09-464B-9E44-6157F40B7C0C}" dt="2023-07-27T08:18:52.374" v="273" actId="1036"/>
          <ac:picMkLst>
            <pc:docMk/>
            <pc:sldMk cId="269800214" sldId="261"/>
            <ac:picMk id="3" creationId="{257659CB-5E6C-4738-4BCE-8F79E2FC8DF7}"/>
          </ac:picMkLst>
        </pc:picChg>
        <pc:picChg chg="add mod">
          <ac:chgData name="Reza Amini Hounejani" userId="36cb0b73-58b2-4568-a1ab-00cd49301806" providerId="ADAL" clId="{F94D5C4B-2E09-464B-9E44-6157F40B7C0C}" dt="2023-07-26T11:41:26.295" v="254" actId="164"/>
          <ac:picMkLst>
            <pc:docMk/>
            <pc:sldMk cId="269800214" sldId="261"/>
            <ac:picMk id="7" creationId="{EAB0D053-FDE7-256D-DDD1-253E73E53025}"/>
          </ac:picMkLst>
        </pc:picChg>
        <pc:picChg chg="del mod">
          <ac:chgData name="Reza Amini Hounejani" userId="36cb0b73-58b2-4568-a1ab-00cd49301806" providerId="ADAL" clId="{F94D5C4B-2E09-464B-9E44-6157F40B7C0C}" dt="2023-07-26T11:40:04.154" v="228" actId="478"/>
          <ac:picMkLst>
            <pc:docMk/>
            <pc:sldMk cId="269800214" sldId="261"/>
            <ac:picMk id="50" creationId="{C7469508-AB18-66AC-5DD7-7BD43406FCF3}"/>
          </ac:picMkLst>
        </pc:picChg>
        <pc:picChg chg="add del">
          <ac:chgData name="Reza Amini Hounejani" userId="36cb0b73-58b2-4568-a1ab-00cd49301806" providerId="ADAL" clId="{F94D5C4B-2E09-464B-9E44-6157F40B7C0C}" dt="2023-07-24T12:10:42.632" v="13" actId="478"/>
          <ac:picMkLst>
            <pc:docMk/>
            <pc:sldMk cId="269800214" sldId="261"/>
            <ac:picMk id="52" creationId="{7483462C-D603-145D-A644-E4038B7B8A8B}"/>
          </ac:picMkLst>
        </pc:picChg>
      </pc:sldChg>
      <pc:sldChg chg="addSp delSp modSp mod">
        <pc:chgData name="Reza Amini Hounejani" userId="36cb0b73-58b2-4568-a1ab-00cd49301806" providerId="ADAL" clId="{F94D5C4B-2E09-464B-9E44-6157F40B7C0C}" dt="2023-07-26T12:06:08.164" v="259" actId="1076"/>
        <pc:sldMkLst>
          <pc:docMk/>
          <pc:sldMk cId="1450487343" sldId="262"/>
        </pc:sldMkLst>
        <pc:spChg chg="mod">
          <ac:chgData name="Reza Amini Hounejani" userId="36cb0b73-58b2-4568-a1ab-00cd49301806" providerId="ADAL" clId="{F94D5C4B-2E09-464B-9E44-6157F40B7C0C}" dt="2023-07-25T15:38:36.246" v="214" actId="14100"/>
          <ac:spMkLst>
            <pc:docMk/>
            <pc:sldMk cId="1450487343" sldId="262"/>
            <ac:spMk id="110" creationId="{0A33AAAF-3B64-E409-5C7D-A1B8C30F69BC}"/>
          </ac:spMkLst>
        </pc:spChg>
        <pc:spChg chg="mod">
          <ac:chgData name="Reza Amini Hounejani" userId="36cb0b73-58b2-4568-a1ab-00cd49301806" providerId="ADAL" clId="{F94D5C4B-2E09-464B-9E44-6157F40B7C0C}" dt="2023-07-24T09:27:08.143" v="2" actId="20577"/>
          <ac:spMkLst>
            <pc:docMk/>
            <pc:sldMk cId="1450487343" sldId="262"/>
            <ac:spMk id="133" creationId="{033C397B-407E-4387-8FAD-A870D7D14C69}"/>
          </ac:spMkLst>
        </pc:spChg>
        <pc:spChg chg="del">
          <ac:chgData name="Reza Amini Hounejani" userId="36cb0b73-58b2-4568-a1ab-00cd49301806" providerId="ADAL" clId="{F94D5C4B-2E09-464B-9E44-6157F40B7C0C}" dt="2023-07-26T12:06:04.080" v="258" actId="478"/>
          <ac:spMkLst>
            <pc:docMk/>
            <pc:sldMk cId="1450487343" sldId="262"/>
            <ac:spMk id="134" creationId="{137E3415-C62C-3A05-FA06-739CB6BFC17B}"/>
          </ac:spMkLst>
        </pc:spChg>
        <pc:spChg chg="del">
          <ac:chgData name="Reza Amini Hounejani" userId="36cb0b73-58b2-4568-a1ab-00cd49301806" providerId="ADAL" clId="{F94D5C4B-2E09-464B-9E44-6157F40B7C0C}" dt="2023-07-26T12:06:03.156" v="257" actId="478"/>
          <ac:spMkLst>
            <pc:docMk/>
            <pc:sldMk cId="1450487343" sldId="262"/>
            <ac:spMk id="135" creationId="{B6513810-1310-54EB-EEBD-D5E82DAE7C04}"/>
          </ac:spMkLst>
        </pc:spChg>
        <pc:spChg chg="mod">
          <ac:chgData name="Reza Amini Hounejani" userId="36cb0b73-58b2-4568-a1ab-00cd49301806" providerId="ADAL" clId="{F94D5C4B-2E09-464B-9E44-6157F40B7C0C}" dt="2023-07-25T12:53:10.893" v="128" actId="20577"/>
          <ac:spMkLst>
            <pc:docMk/>
            <pc:sldMk cId="1450487343" sldId="262"/>
            <ac:spMk id="139" creationId="{A44BEFCE-4304-F2FC-8FF4-CB31D174501C}"/>
          </ac:spMkLst>
        </pc:spChg>
        <pc:spChg chg="mod">
          <ac:chgData name="Reza Amini Hounejani" userId="36cb0b73-58b2-4568-a1ab-00cd49301806" providerId="ADAL" clId="{F94D5C4B-2E09-464B-9E44-6157F40B7C0C}" dt="2023-07-25T15:17:50.339" v="199" actId="20577"/>
          <ac:spMkLst>
            <pc:docMk/>
            <pc:sldMk cId="1450487343" sldId="262"/>
            <ac:spMk id="166" creationId="{0398CC03-C88D-5CDF-910C-9C4F3103CDFE}"/>
          </ac:spMkLst>
        </pc:spChg>
        <pc:spChg chg="mod">
          <ac:chgData name="Reza Amini Hounejani" userId="36cb0b73-58b2-4568-a1ab-00cd49301806" providerId="ADAL" clId="{F94D5C4B-2E09-464B-9E44-6157F40B7C0C}" dt="2023-07-25T15:16:30.580" v="168" actId="1035"/>
          <ac:spMkLst>
            <pc:docMk/>
            <pc:sldMk cId="1450487343" sldId="262"/>
            <ac:spMk id="171" creationId="{220D110D-DD9D-0A62-72B9-58E94808343D}"/>
          </ac:spMkLst>
        </pc:spChg>
        <pc:spChg chg="mod">
          <ac:chgData name="Reza Amini Hounejani" userId="36cb0b73-58b2-4568-a1ab-00cd49301806" providerId="ADAL" clId="{F94D5C4B-2E09-464B-9E44-6157F40B7C0C}" dt="2023-07-25T15:16:30.580" v="168" actId="1035"/>
          <ac:spMkLst>
            <pc:docMk/>
            <pc:sldMk cId="1450487343" sldId="262"/>
            <ac:spMk id="172" creationId="{13D901C5-0C99-17C2-EBCA-CE9117DB7253}"/>
          </ac:spMkLst>
        </pc:spChg>
        <pc:spChg chg="mod">
          <ac:chgData name="Reza Amini Hounejani" userId="36cb0b73-58b2-4568-a1ab-00cd49301806" providerId="ADAL" clId="{F94D5C4B-2E09-464B-9E44-6157F40B7C0C}" dt="2023-07-25T15:16:30.580" v="168" actId="1035"/>
          <ac:spMkLst>
            <pc:docMk/>
            <pc:sldMk cId="1450487343" sldId="262"/>
            <ac:spMk id="173" creationId="{D9211BAD-4C38-9ABF-B72F-8C0B5E40F3A2}"/>
          </ac:spMkLst>
        </pc:spChg>
        <pc:spChg chg="mod">
          <ac:chgData name="Reza Amini Hounejani" userId="36cb0b73-58b2-4568-a1ab-00cd49301806" providerId="ADAL" clId="{F94D5C4B-2E09-464B-9E44-6157F40B7C0C}" dt="2023-07-25T15:16:30.580" v="168" actId="1035"/>
          <ac:spMkLst>
            <pc:docMk/>
            <pc:sldMk cId="1450487343" sldId="262"/>
            <ac:spMk id="174" creationId="{3E6CF273-DF2D-55DC-D539-52DFE9BDDE43}"/>
          </ac:spMkLst>
        </pc:spChg>
        <pc:spChg chg="mod">
          <ac:chgData name="Reza Amini Hounejani" userId="36cb0b73-58b2-4568-a1ab-00cd49301806" providerId="ADAL" clId="{F94D5C4B-2E09-464B-9E44-6157F40B7C0C}" dt="2023-07-25T15:16:30.580" v="168" actId="1035"/>
          <ac:spMkLst>
            <pc:docMk/>
            <pc:sldMk cId="1450487343" sldId="262"/>
            <ac:spMk id="175" creationId="{18C5A32F-9767-843D-2D54-F745C759AFA8}"/>
          </ac:spMkLst>
        </pc:spChg>
        <pc:spChg chg="mod">
          <ac:chgData name="Reza Amini Hounejani" userId="36cb0b73-58b2-4568-a1ab-00cd49301806" providerId="ADAL" clId="{F94D5C4B-2E09-464B-9E44-6157F40B7C0C}" dt="2023-07-25T15:18:34.389" v="206" actId="553"/>
          <ac:spMkLst>
            <pc:docMk/>
            <pc:sldMk cId="1450487343" sldId="262"/>
            <ac:spMk id="176" creationId="{20B187E3-23B4-06C8-C722-F59FF0C179AA}"/>
          </ac:spMkLst>
        </pc:spChg>
        <pc:spChg chg="mod">
          <ac:chgData name="Reza Amini Hounejani" userId="36cb0b73-58b2-4568-a1ab-00cd49301806" providerId="ADAL" clId="{F94D5C4B-2E09-464B-9E44-6157F40B7C0C}" dt="2023-07-25T15:18:34.389" v="206" actId="553"/>
          <ac:spMkLst>
            <pc:docMk/>
            <pc:sldMk cId="1450487343" sldId="262"/>
            <ac:spMk id="177" creationId="{8DC7E3F0-1165-1EC6-D22A-413DAEF0A634}"/>
          </ac:spMkLst>
        </pc:spChg>
        <pc:spChg chg="mod">
          <ac:chgData name="Reza Amini Hounejani" userId="36cb0b73-58b2-4568-a1ab-00cd49301806" providerId="ADAL" clId="{F94D5C4B-2E09-464B-9E44-6157F40B7C0C}" dt="2023-07-25T15:18:34.389" v="206" actId="553"/>
          <ac:spMkLst>
            <pc:docMk/>
            <pc:sldMk cId="1450487343" sldId="262"/>
            <ac:spMk id="178" creationId="{35936764-CBB5-C580-158E-2B357A5439A2}"/>
          </ac:spMkLst>
        </pc:spChg>
        <pc:spChg chg="mod">
          <ac:chgData name="Reza Amini Hounejani" userId="36cb0b73-58b2-4568-a1ab-00cd49301806" providerId="ADAL" clId="{F94D5C4B-2E09-464B-9E44-6157F40B7C0C}" dt="2023-07-25T15:18:34.389" v="206" actId="553"/>
          <ac:spMkLst>
            <pc:docMk/>
            <pc:sldMk cId="1450487343" sldId="262"/>
            <ac:spMk id="179" creationId="{173A25BE-6CDA-329B-7212-6391198A75A1}"/>
          </ac:spMkLst>
        </pc:spChg>
        <pc:spChg chg="mod">
          <ac:chgData name="Reza Amini Hounejani" userId="36cb0b73-58b2-4568-a1ab-00cd49301806" providerId="ADAL" clId="{F94D5C4B-2E09-464B-9E44-6157F40B7C0C}" dt="2023-07-25T15:18:34.389" v="206" actId="553"/>
          <ac:spMkLst>
            <pc:docMk/>
            <pc:sldMk cId="1450487343" sldId="262"/>
            <ac:spMk id="180" creationId="{10EDA352-3E05-C0FD-C60F-E5B4C121A865}"/>
          </ac:spMkLst>
        </pc:spChg>
        <pc:spChg chg="mod">
          <ac:chgData name="Reza Amini Hounejani" userId="36cb0b73-58b2-4568-a1ab-00cd49301806" providerId="ADAL" clId="{F94D5C4B-2E09-464B-9E44-6157F40B7C0C}" dt="2023-07-25T15:18:34.389" v="206" actId="553"/>
          <ac:spMkLst>
            <pc:docMk/>
            <pc:sldMk cId="1450487343" sldId="262"/>
            <ac:spMk id="181" creationId="{07673B8C-C67C-EFA2-3076-16FD5B8B0F44}"/>
          </ac:spMkLst>
        </pc:spChg>
        <pc:spChg chg="mod">
          <ac:chgData name="Reza Amini Hounejani" userId="36cb0b73-58b2-4568-a1ab-00cd49301806" providerId="ADAL" clId="{F94D5C4B-2E09-464B-9E44-6157F40B7C0C}" dt="2023-07-25T15:18:34.389" v="206" actId="553"/>
          <ac:spMkLst>
            <pc:docMk/>
            <pc:sldMk cId="1450487343" sldId="262"/>
            <ac:spMk id="182" creationId="{8D6FF532-7FA3-119D-1F98-9E500C919877}"/>
          </ac:spMkLst>
        </pc:spChg>
        <pc:grpChg chg="mod">
          <ac:chgData name="Reza Amini Hounejani" userId="36cb0b73-58b2-4568-a1ab-00cd49301806" providerId="ADAL" clId="{F94D5C4B-2E09-464B-9E44-6157F40B7C0C}" dt="2023-07-26T11:35:49.146" v="215" actId="1076"/>
          <ac:grpSpMkLst>
            <pc:docMk/>
            <pc:sldMk cId="1450487343" sldId="262"/>
            <ac:grpSpMk id="3" creationId="{628D7D5E-16C9-C466-0D18-502C2DAE3E9D}"/>
          </ac:grpSpMkLst>
        </pc:grpChg>
        <pc:grpChg chg="add mod">
          <ac:chgData name="Reza Amini Hounejani" userId="36cb0b73-58b2-4568-a1ab-00cd49301806" providerId="ADAL" clId="{F94D5C4B-2E09-464B-9E44-6157F40B7C0C}" dt="2023-07-26T11:35:51.930" v="216" actId="1076"/>
          <ac:grpSpMkLst>
            <pc:docMk/>
            <pc:sldMk cId="1450487343" sldId="262"/>
            <ac:grpSpMk id="8" creationId="{163D0713-8990-3428-917B-E5DEEEDFC0E5}"/>
          </ac:grpSpMkLst>
        </pc:grpChg>
        <pc:grpChg chg="mod">
          <ac:chgData name="Reza Amini Hounejani" userId="36cb0b73-58b2-4568-a1ab-00cd49301806" providerId="ADAL" clId="{F94D5C4B-2E09-464B-9E44-6157F40B7C0C}" dt="2023-07-26T12:06:08.164" v="259" actId="1076"/>
          <ac:grpSpMkLst>
            <pc:docMk/>
            <pc:sldMk cId="1450487343" sldId="262"/>
            <ac:grpSpMk id="108" creationId="{935C5173-B608-1A14-6918-2331333547E5}"/>
          </ac:grpSpMkLst>
        </pc:grpChg>
        <pc:grpChg chg="mod">
          <ac:chgData name="Reza Amini Hounejani" userId="36cb0b73-58b2-4568-a1ab-00cd49301806" providerId="ADAL" clId="{F94D5C4B-2E09-464B-9E44-6157F40B7C0C}" dt="2023-07-26T11:35:56.208" v="217" actId="1076"/>
          <ac:grpSpMkLst>
            <pc:docMk/>
            <pc:sldMk cId="1450487343" sldId="262"/>
            <ac:grpSpMk id="136" creationId="{FE3A3AD8-CD7F-2E68-EF1B-F2F8A02996BC}"/>
          </ac:grpSpMkLst>
        </pc:grpChg>
        <pc:grpChg chg="del">
          <ac:chgData name="Reza Amini Hounejani" userId="36cb0b73-58b2-4568-a1ab-00cd49301806" providerId="ADAL" clId="{F94D5C4B-2E09-464B-9E44-6157F40B7C0C}" dt="2023-07-25T15:12:48.410" v="129" actId="478"/>
          <ac:grpSpMkLst>
            <pc:docMk/>
            <pc:sldMk cId="1450487343" sldId="262"/>
            <ac:grpSpMk id="157" creationId="{7D892962-0B6E-144B-39AA-FE6AA2AA47B8}"/>
          </ac:grpSpMkLst>
        </pc:grpChg>
        <pc:grpChg chg="mod topLvl">
          <ac:chgData name="Reza Amini Hounejani" userId="36cb0b73-58b2-4568-a1ab-00cd49301806" providerId="ADAL" clId="{F94D5C4B-2E09-464B-9E44-6157F40B7C0C}" dt="2023-07-25T15:19:04.438" v="207" actId="164"/>
          <ac:grpSpMkLst>
            <pc:docMk/>
            <pc:sldMk cId="1450487343" sldId="262"/>
            <ac:grpSpMk id="159" creationId="{C6CCB6A2-3F0C-B356-4DBE-7BE17DD29FCD}"/>
          </ac:grpSpMkLst>
        </pc:grpChg>
        <pc:picChg chg="add mod">
          <ac:chgData name="Reza Amini Hounejani" userId="36cb0b73-58b2-4568-a1ab-00cd49301806" providerId="ADAL" clId="{F94D5C4B-2E09-464B-9E44-6157F40B7C0C}" dt="2023-07-25T15:19:04.438" v="207" actId="164"/>
          <ac:picMkLst>
            <pc:docMk/>
            <pc:sldMk cId="1450487343" sldId="262"/>
            <ac:picMk id="7" creationId="{65674487-957E-1230-4457-4043ADFD8612}"/>
          </ac:picMkLst>
        </pc:picChg>
        <pc:picChg chg="mod">
          <ac:chgData name="Reza Amini Hounejani" userId="36cb0b73-58b2-4568-a1ab-00cd49301806" providerId="ADAL" clId="{F94D5C4B-2E09-464B-9E44-6157F40B7C0C}" dt="2023-07-25T12:33:11.011" v="112" actId="1076"/>
          <ac:picMkLst>
            <pc:docMk/>
            <pc:sldMk cId="1450487343" sldId="262"/>
            <ac:picMk id="137" creationId="{C771407E-B30D-74FB-ADCD-2F607F236ECF}"/>
          </ac:picMkLst>
        </pc:picChg>
        <pc:picChg chg="del topLvl">
          <ac:chgData name="Reza Amini Hounejani" userId="36cb0b73-58b2-4568-a1ab-00cd49301806" providerId="ADAL" clId="{F94D5C4B-2E09-464B-9E44-6157F40B7C0C}" dt="2023-07-25T15:12:48.410" v="129" actId="478"/>
          <ac:picMkLst>
            <pc:docMk/>
            <pc:sldMk cId="1450487343" sldId="262"/>
            <ac:picMk id="158" creationId="{06652D08-FDC1-0AF3-C338-04F3C974010F}"/>
          </ac:picMkLst>
        </pc:picChg>
      </pc:sldChg>
    </pc:docChg>
  </pc:docChgLst>
  <pc:docChgLst>
    <pc:chgData name="Marileen Dogterom - TNW" userId="2157bcc8-b33b-4836-b232-f87bf0db8ff8" providerId="ADAL" clId="{8A6264BD-EE9E-024C-9AF7-527221984F10}"/>
    <pc:docChg chg="modSld">
      <pc:chgData name="Marileen Dogterom - TNW" userId="2157bcc8-b33b-4836-b232-f87bf0db8ff8" providerId="ADAL" clId="{8A6264BD-EE9E-024C-9AF7-527221984F10}" dt="2022-11-30T13:41:02.007" v="0" actId="14100"/>
      <pc:docMkLst>
        <pc:docMk/>
      </pc:docMkLst>
      <pc:sldChg chg="modSp mod">
        <pc:chgData name="Marileen Dogterom - TNW" userId="2157bcc8-b33b-4836-b232-f87bf0db8ff8" providerId="ADAL" clId="{8A6264BD-EE9E-024C-9AF7-527221984F10}" dt="2022-11-30T13:41:02.007" v="0" actId="14100"/>
        <pc:sldMkLst>
          <pc:docMk/>
          <pc:sldMk cId="269800214" sldId="261"/>
        </pc:sldMkLst>
        <pc:picChg chg="mod">
          <ac:chgData name="Marileen Dogterom - TNW" userId="2157bcc8-b33b-4836-b232-f87bf0db8ff8" providerId="ADAL" clId="{8A6264BD-EE9E-024C-9AF7-527221984F10}" dt="2022-11-30T13:41:02.007" v="0" actId="14100"/>
          <ac:picMkLst>
            <pc:docMk/>
            <pc:sldMk cId="269800214" sldId="261"/>
            <ac:picMk id="3" creationId="{57E94F07-EAD6-7D99-1223-C864EF8E547C}"/>
          </ac:picMkLst>
        </pc:picChg>
      </pc:sldChg>
    </pc:docChg>
  </pc:docChgLst>
  <pc:docChgLst>
    <pc:chgData name="Reza Amini Hounejani" userId="36cb0b73-58b2-4568-a1ab-00cd49301806" providerId="ADAL" clId="{DA8FEA81-1A63-884F-A1C6-520C766F400F}"/>
    <pc:docChg chg="undo redo custSel addSld modSld">
      <pc:chgData name="Reza Amini Hounejani" userId="36cb0b73-58b2-4568-a1ab-00cd49301806" providerId="ADAL" clId="{DA8FEA81-1A63-884F-A1C6-520C766F400F}" dt="2022-11-25T13:19:33.907" v="11930" actId="732"/>
      <pc:docMkLst>
        <pc:docMk/>
      </pc:docMkLst>
      <pc:sldChg chg="addSp delSp modSp mod">
        <pc:chgData name="Reza Amini Hounejani" userId="36cb0b73-58b2-4568-a1ab-00cd49301806" providerId="ADAL" clId="{DA8FEA81-1A63-884F-A1C6-520C766F400F}" dt="2022-11-25T13:15:31.963" v="11902" actId="555"/>
        <pc:sldMkLst>
          <pc:docMk/>
          <pc:sldMk cId="1897538530" sldId="256"/>
        </pc:sldMkLst>
        <pc:spChg chg="mod">
          <ac:chgData name="Reza Amini Hounejani" userId="36cb0b73-58b2-4568-a1ab-00cd49301806" providerId="ADAL" clId="{DA8FEA81-1A63-884F-A1C6-520C766F400F}" dt="2022-11-16T12:38:27.132" v="8998" actId="571"/>
          <ac:spMkLst>
            <pc:docMk/>
            <pc:sldMk cId="1897538530" sldId="256"/>
            <ac:spMk id="9" creationId="{090AD67B-A437-F4BC-E6AF-C57DC8490D84}"/>
          </ac:spMkLst>
        </pc:spChg>
        <pc:spChg chg="mod">
          <ac:chgData name="Reza Amini Hounejani" userId="36cb0b73-58b2-4568-a1ab-00cd49301806" providerId="ADAL" clId="{DA8FEA81-1A63-884F-A1C6-520C766F400F}" dt="2022-11-16T12:38:27.132" v="8998" actId="571"/>
          <ac:spMkLst>
            <pc:docMk/>
            <pc:sldMk cId="1897538530" sldId="256"/>
            <ac:spMk id="10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09-30T14:10:48.888" v="3307" actId="1036"/>
          <ac:spMkLst>
            <pc:docMk/>
            <pc:sldMk cId="1897538530" sldId="256"/>
            <ac:spMk id="11" creationId="{769CB33A-8F1B-0BB0-F422-DAABE806D33D}"/>
          </ac:spMkLst>
        </pc:spChg>
        <pc:spChg chg="mod">
          <ac:chgData name="Reza Amini Hounejani" userId="36cb0b73-58b2-4568-a1ab-00cd49301806" providerId="ADAL" clId="{DA8FEA81-1A63-884F-A1C6-520C766F400F}" dt="2022-11-18T14:47:26.042" v="9775" actId="12788"/>
          <ac:spMkLst>
            <pc:docMk/>
            <pc:sldMk cId="1897538530" sldId="256"/>
            <ac:spMk id="22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8T14:47:26.042" v="9775" actId="12788"/>
          <ac:spMkLst>
            <pc:docMk/>
            <pc:sldMk cId="1897538530" sldId="256"/>
            <ac:spMk id="23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09-30T14:11:31.323" v="3308" actId="113"/>
          <ac:spMkLst>
            <pc:docMk/>
            <pc:sldMk cId="1897538530" sldId="256"/>
            <ac:spMk id="24" creationId="{0E3A8FA3-C11D-4C61-3AFB-B69205167F17}"/>
          </ac:spMkLst>
        </pc:spChg>
        <pc:spChg chg="add del mod">
          <ac:chgData name="Reza Amini Hounejani" userId="36cb0b73-58b2-4568-a1ab-00cd49301806" providerId="ADAL" clId="{DA8FEA81-1A63-884F-A1C6-520C766F400F}" dt="2022-11-09T11:31:37.382" v="7103" actId="478"/>
          <ac:spMkLst>
            <pc:docMk/>
            <pc:sldMk cId="1897538530" sldId="256"/>
            <ac:spMk id="25" creationId="{EAE44C57-4F9C-8A0D-F7BA-4825AEBA1506}"/>
          </ac:spMkLst>
        </pc:spChg>
        <pc:spChg chg="add 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32" creationId="{BFB14FA1-6024-BC04-67B7-A328EECEE3F9}"/>
          </ac:spMkLst>
        </pc:spChg>
        <pc:spChg chg="add 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33" creationId="{76C36BA4-DE0C-0EE1-F189-404066C84BA3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35" creationId="{8F1EFC11-C0EF-161B-2D16-C97B45987A57}"/>
          </ac:spMkLst>
        </pc:spChg>
        <pc:spChg chg="add del mod">
          <ac:chgData name="Reza Amini Hounejani" userId="36cb0b73-58b2-4568-a1ab-00cd49301806" providerId="ADAL" clId="{DA8FEA81-1A63-884F-A1C6-520C766F400F}" dt="2022-11-09T11:31:46.474" v="7108" actId="478"/>
          <ac:spMkLst>
            <pc:docMk/>
            <pc:sldMk cId="1897538530" sldId="256"/>
            <ac:spMk id="35" creationId="{D0B41E28-5092-80E8-4E29-53600B9E72E5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36" creationId="{6615B9D9-DF7A-520C-316E-99AACC5EB92B}"/>
          </ac:spMkLst>
        </pc:spChg>
        <pc:spChg chg="add del mod">
          <ac:chgData name="Reza Amini Hounejani" userId="36cb0b73-58b2-4568-a1ab-00cd49301806" providerId="ADAL" clId="{DA8FEA81-1A63-884F-A1C6-520C766F400F}" dt="2022-11-09T11:10:06.679" v="6887"/>
          <ac:spMkLst>
            <pc:docMk/>
            <pc:sldMk cId="1897538530" sldId="256"/>
            <ac:spMk id="36" creationId="{8E46F73F-1828-FFC9-2367-03553DE77D0A}"/>
          </ac:spMkLst>
        </pc:spChg>
        <pc:spChg chg="add 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37" creationId="{9A06CE26-1D57-7AFD-C39A-38F8DFBE6BBC}"/>
          </ac:spMkLst>
        </pc:spChg>
        <pc:spChg chg="add 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38" creationId="{530928D7-1C50-0402-0E9A-041B74D7E479}"/>
          </ac:spMkLst>
        </pc:spChg>
        <pc:spChg chg="add 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39" creationId="{A3F7AE5B-FE17-87B4-49DC-867EBEB22F8F}"/>
          </ac:spMkLst>
        </pc:spChg>
        <pc:spChg chg="add 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40" creationId="{2E11FBA7-D34F-86AE-672C-6EA8855B54A3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44" creationId="{1D301FBB-F609-0D49-DAE9-387F0172F1DD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45" creationId="{EC7E8C5C-69C4-F0E2-6A4E-40D473026521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45" creationId="{F2C009D0-BCD8-304F-F37C-90706406A1AD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46" creationId="{2048E403-25AE-92EB-09F2-C9CFE2DC65EA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46" creationId="{F6BB3575-A8C8-E3EF-0F4D-31BDC736F50D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47" creationId="{8F096CEF-776B-6214-4F9F-E19ACFD57766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47" creationId="{DAE16926-E971-CB8C-0B7D-B263BA920807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48" creationId="{0B570A7C-0109-E4D6-A450-5F9DDD84B73E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49" creationId="{2D03CCAD-2CF7-DA6C-7BA0-36C0E466ECA1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49" creationId="{420058BA-2BAA-BD23-BAC2-10332521F6A7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50" creationId="{4B7A0864-B08F-9D76-1710-428A02E2E981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50" creationId="{F12A586C-0AEB-6E1F-90AC-A794D596D61C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51" creationId="{09A36449-067B-EBF5-57EF-76F87473EB06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51" creationId="{E7D04698-DF94-7A16-53B3-86F55A3A138E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52" creationId="{6844C59E-05DC-AD6C-9205-5B9F731C7E65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52" creationId="{F1D93D86-0F15-675C-5D2A-604609E6DE79}"/>
          </ac:spMkLst>
        </pc:spChg>
        <pc:spChg chg="mod topLvl">
          <ac:chgData name="Reza Amini Hounejani" userId="36cb0b73-58b2-4568-a1ab-00cd49301806" providerId="ADAL" clId="{DA8FEA81-1A63-884F-A1C6-520C766F400F}" dt="2022-11-14T15:39:43.622" v="8433" actId="553"/>
          <ac:spMkLst>
            <pc:docMk/>
            <pc:sldMk cId="1897538530" sldId="256"/>
            <ac:spMk id="53" creationId="{89670E8E-6695-1FA3-216F-15A97E7B65ED}"/>
          </ac:spMkLst>
        </pc:spChg>
        <pc:spChg chg="mod topLvl">
          <ac:chgData name="Reza Amini Hounejani" userId="36cb0b73-58b2-4568-a1ab-00cd49301806" providerId="ADAL" clId="{DA8FEA81-1A63-884F-A1C6-520C766F400F}" dt="2022-11-14T15:39:43.622" v="8433" actId="553"/>
          <ac:spMkLst>
            <pc:docMk/>
            <pc:sldMk cId="1897538530" sldId="256"/>
            <ac:spMk id="54" creationId="{A094659F-E3AB-B837-40CA-1ECD3912AE8F}"/>
          </ac:spMkLst>
        </pc:spChg>
        <pc:spChg chg="mod topLvl">
          <ac:chgData name="Reza Amini Hounejani" userId="36cb0b73-58b2-4568-a1ab-00cd49301806" providerId="ADAL" clId="{DA8FEA81-1A63-884F-A1C6-520C766F400F}" dt="2022-11-14T15:39:43.622" v="8433" actId="553"/>
          <ac:spMkLst>
            <pc:docMk/>
            <pc:sldMk cId="1897538530" sldId="256"/>
            <ac:spMk id="55" creationId="{DDC6926D-24F2-4A92-BA18-2F53E2306B3E}"/>
          </ac:spMkLst>
        </pc:spChg>
        <pc:spChg chg="mod topLvl">
          <ac:chgData name="Reza Amini Hounejani" userId="36cb0b73-58b2-4568-a1ab-00cd49301806" providerId="ADAL" clId="{DA8FEA81-1A63-884F-A1C6-520C766F400F}" dt="2022-11-14T15:39:43.622" v="8433" actId="553"/>
          <ac:spMkLst>
            <pc:docMk/>
            <pc:sldMk cId="1897538530" sldId="256"/>
            <ac:spMk id="56" creationId="{4F3CD4FE-37E8-2669-E13A-2AF5E9870178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57" creationId="{6102B49A-FDA2-9B84-468D-614ED7508145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64" creationId="{46553D3C-3D9F-D1F7-4A54-5469C70C1F5C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64" creationId="{ED614FE4-51F1-E51F-A927-E70B57A9A8D2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65" creationId="{D49408FC-6A71-3A76-1E5B-9A8D313FC3EC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66" creationId="{9FD88247-A57D-8E6D-DBA5-E39874AFD437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66" creationId="{D7B24226-EDBC-1BFC-1747-820E26B1E201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67" creationId="{8BF81D1A-4C75-9A60-8B84-18D8EBAB31B1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67" creationId="{B2E31544-1281-D42A-2C7D-E4D7AD21BDAC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69" creationId="{0DDDC84A-FE06-8CEB-DDBC-4F1C3226446B}"/>
          </ac:spMkLst>
        </pc:spChg>
        <pc:spChg chg="add del">
          <ac:chgData name="Reza Amini Hounejani" userId="36cb0b73-58b2-4568-a1ab-00cd49301806" providerId="ADAL" clId="{DA8FEA81-1A63-884F-A1C6-520C766F400F}" dt="2022-11-14T15:21:49.056" v="8286" actId="478"/>
          <ac:spMkLst>
            <pc:docMk/>
            <pc:sldMk cId="1897538530" sldId="256"/>
            <ac:spMk id="69" creationId="{1988DDCE-CA35-9D0B-E39A-3260A5797245}"/>
          </ac:spMkLst>
        </pc:spChg>
        <pc:spChg chg="del mod">
          <ac:chgData name="Reza Amini Hounejani" userId="36cb0b73-58b2-4568-a1ab-00cd49301806" providerId="ADAL" clId="{DA8FEA81-1A63-884F-A1C6-520C766F400F}" dt="2022-11-10T11:08:26.265" v="7436" actId="478"/>
          <ac:spMkLst>
            <pc:docMk/>
            <pc:sldMk cId="1897538530" sldId="256"/>
            <ac:spMk id="69" creationId="{AEE739BA-7C13-8D12-2364-9077DDCF7A87}"/>
          </ac:spMkLst>
        </pc:spChg>
        <pc:spChg chg="mod">
          <ac:chgData name="Reza Amini Hounejani" userId="36cb0b73-58b2-4568-a1ab-00cd49301806" providerId="ADAL" clId="{DA8FEA81-1A63-884F-A1C6-520C766F400F}" dt="2022-11-16T12:38:20.352" v="8996" actId="571"/>
          <ac:spMkLst>
            <pc:docMk/>
            <pc:sldMk cId="1897538530" sldId="256"/>
            <ac:spMk id="70" creationId="{2632223B-A0D1-471E-07A8-1CE8D3D48890}"/>
          </ac:spMkLst>
        </pc:spChg>
        <pc:spChg chg="add del mod">
          <ac:chgData name="Reza Amini Hounejani" userId="36cb0b73-58b2-4568-a1ab-00cd49301806" providerId="ADAL" clId="{DA8FEA81-1A63-884F-A1C6-520C766F400F}" dt="2022-11-14T15:23:27.350" v="8305" actId="478"/>
          <ac:spMkLst>
            <pc:docMk/>
            <pc:sldMk cId="1897538530" sldId="256"/>
            <ac:spMk id="70" creationId="{2AB9FA23-95EF-CEE9-FA9C-DC04C0BA55B0}"/>
          </ac:spMkLst>
        </pc:spChg>
        <pc:spChg chg="del mod">
          <ac:chgData name="Reza Amini Hounejani" userId="36cb0b73-58b2-4568-a1ab-00cd49301806" providerId="ADAL" clId="{DA8FEA81-1A63-884F-A1C6-520C766F400F}" dt="2022-11-10T11:08:24.437" v="7435" actId="478"/>
          <ac:spMkLst>
            <pc:docMk/>
            <pc:sldMk cId="1897538530" sldId="256"/>
            <ac:spMk id="70" creationId="{475FD372-8207-EFD7-E6A1-ADFAAFEFC2E6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70" creationId="{54ED2621-FD99-5D41-0F6A-3907302B45AA}"/>
          </ac:spMkLst>
        </pc:spChg>
        <pc:spChg chg="mod">
          <ac:chgData name="Reza Amini Hounejani" userId="36cb0b73-58b2-4568-a1ab-00cd49301806" providerId="ADAL" clId="{DA8FEA81-1A63-884F-A1C6-520C766F400F}" dt="2022-11-15T12:52:03.913" v="8830" actId="1037"/>
          <ac:spMkLst>
            <pc:docMk/>
            <pc:sldMk cId="1897538530" sldId="256"/>
            <ac:spMk id="71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5T12:52:15.672" v="8840" actId="1038"/>
          <ac:spMkLst>
            <pc:docMk/>
            <pc:sldMk cId="1897538530" sldId="256"/>
            <ac:spMk id="72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5T12:52:03.913" v="8830" actId="1037"/>
          <ac:spMkLst>
            <pc:docMk/>
            <pc:sldMk cId="1897538530" sldId="256"/>
            <ac:spMk id="73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5T12:52:03.913" v="8830" actId="1037"/>
          <ac:spMkLst>
            <pc:docMk/>
            <pc:sldMk cId="1897538530" sldId="256"/>
            <ac:spMk id="74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5T12:52:03.913" v="8830" actId="1037"/>
          <ac:spMkLst>
            <pc:docMk/>
            <pc:sldMk cId="1897538530" sldId="256"/>
            <ac:spMk id="75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5T12:52:03.913" v="8830" actId="1037"/>
          <ac:spMkLst>
            <pc:docMk/>
            <pc:sldMk cId="1897538530" sldId="256"/>
            <ac:spMk id="76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5T12:52:03.913" v="8830" actId="1037"/>
          <ac:spMkLst>
            <pc:docMk/>
            <pc:sldMk cId="1897538530" sldId="256"/>
            <ac:spMk id="77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5T12:52:03.913" v="8830" actId="1037"/>
          <ac:spMkLst>
            <pc:docMk/>
            <pc:sldMk cId="1897538530" sldId="256"/>
            <ac:spMk id="78" creationId="{0E3A8FA3-C11D-4C61-3AFB-B69205167F17}"/>
          </ac:spMkLst>
        </pc:spChg>
        <pc:spChg chg="del mod">
          <ac:chgData name="Reza Amini Hounejani" userId="36cb0b73-58b2-4568-a1ab-00cd49301806" providerId="ADAL" clId="{DA8FEA81-1A63-884F-A1C6-520C766F400F}" dt="2022-11-10T11:08:20.312" v="7434" actId="478"/>
          <ac:spMkLst>
            <pc:docMk/>
            <pc:sldMk cId="1897538530" sldId="256"/>
            <ac:spMk id="80" creationId="{642B1B00-8C0F-05A4-4857-E5A88172D919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80" creationId="{7AD924DC-6963-05ED-3985-E1FCFC7C2229}"/>
          </ac:spMkLst>
        </pc:spChg>
        <pc:spChg chg="add del mod">
          <ac:chgData name="Reza Amini Hounejani" userId="36cb0b73-58b2-4568-a1ab-00cd49301806" providerId="ADAL" clId="{DA8FEA81-1A63-884F-A1C6-520C766F400F}" dt="2022-11-14T15:23:24.910" v="8303" actId="478"/>
          <ac:spMkLst>
            <pc:docMk/>
            <pc:sldMk cId="1897538530" sldId="256"/>
            <ac:spMk id="80" creationId="{95049796-5B77-14AB-8C64-09A0F1DED483}"/>
          </ac:spMkLst>
        </pc:spChg>
        <pc:spChg chg="mod">
          <ac:chgData name="Reza Amini Hounejani" userId="36cb0b73-58b2-4568-a1ab-00cd49301806" providerId="ADAL" clId="{DA8FEA81-1A63-884F-A1C6-520C766F400F}" dt="2022-11-16T12:38:20.352" v="8996" actId="571"/>
          <ac:spMkLst>
            <pc:docMk/>
            <pc:sldMk cId="1897538530" sldId="256"/>
            <ac:spMk id="80" creationId="{A2D51700-02FC-6C94-333B-5768D5D72C37}"/>
          </ac:spMkLst>
        </pc:spChg>
        <pc:spChg chg="del mod">
          <ac:chgData name="Reza Amini Hounejani" userId="36cb0b73-58b2-4568-a1ab-00cd49301806" providerId="ADAL" clId="{DA8FEA81-1A63-884F-A1C6-520C766F400F}" dt="2022-11-10T11:08:18.887" v="7433" actId="478"/>
          <ac:spMkLst>
            <pc:docMk/>
            <pc:sldMk cId="1897538530" sldId="256"/>
            <ac:spMk id="81" creationId="{056B676B-A7E3-BAAA-4971-01E8512EFAA2}"/>
          </ac:spMkLst>
        </pc:spChg>
        <pc:spChg chg="add del mod">
          <ac:chgData name="Reza Amini Hounejani" userId="36cb0b73-58b2-4568-a1ab-00cd49301806" providerId="ADAL" clId="{DA8FEA81-1A63-884F-A1C6-520C766F400F}" dt="2022-11-14T15:23:26.045" v="8304" actId="478"/>
          <ac:spMkLst>
            <pc:docMk/>
            <pc:sldMk cId="1897538530" sldId="256"/>
            <ac:spMk id="81" creationId="{215C674A-58BC-5885-4B97-53CCE809EE5F}"/>
          </ac:spMkLst>
        </pc:spChg>
        <pc:spChg chg="mod">
          <ac:chgData name="Reza Amini Hounejani" userId="36cb0b73-58b2-4568-a1ab-00cd49301806" providerId="ADAL" clId="{DA8FEA81-1A63-884F-A1C6-520C766F400F}" dt="2022-11-09T11:29:00.844" v="7073" actId="165"/>
          <ac:spMkLst>
            <pc:docMk/>
            <pc:sldMk cId="1897538530" sldId="256"/>
            <ac:spMk id="81" creationId="{FFA820A4-A437-361D-4297-1CBD4D469A27}"/>
          </ac:spMkLst>
        </pc:spChg>
        <pc:spChg chg="add mod topLvl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85" creationId="{5A866884-F18A-F524-0F8B-DE4F927D2AFD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85" creationId="{7A85E407-6D57-F9AC-CED3-FD5F0BAB4535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86" creationId="{B413B804-26A8-86E1-42BD-695D98D6AFF6}"/>
          </ac:spMkLst>
        </pc:spChg>
        <pc:spChg chg="add mod topLvl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86" creationId="{F159DB08-B7A9-79CF-C0E8-CE0E295D0155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88" creationId="{FFA159EC-350E-A9AF-F745-11622B199859}"/>
          </ac:spMkLst>
        </pc:spChg>
        <pc:spChg chg="add del mod">
          <ac:chgData name="Reza Amini Hounejani" userId="36cb0b73-58b2-4568-a1ab-00cd49301806" providerId="ADAL" clId="{DA8FEA81-1A63-884F-A1C6-520C766F400F}" dt="2022-11-14T15:23:23.270" v="8302" actId="478"/>
          <ac:spMkLst>
            <pc:docMk/>
            <pc:sldMk cId="1897538530" sldId="256"/>
            <ac:spMk id="90" creationId="{37AF4BA5-5BE5-F82F-9B6E-0C08A0864D6B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90" creationId="{B94E12D1-D43D-EA71-C680-6D3858FD796A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93" creationId="{81970E75-5542-BE28-34E2-5BAEACB0E8D1}"/>
          </ac:spMkLst>
        </pc:spChg>
        <pc:spChg chg="add del mod">
          <ac:chgData name="Reza Amini Hounejani" userId="36cb0b73-58b2-4568-a1ab-00cd49301806" providerId="ADAL" clId="{DA8FEA81-1A63-884F-A1C6-520C766F400F}" dt="2022-11-14T15:23:22.521" v="8301" actId="478"/>
          <ac:spMkLst>
            <pc:docMk/>
            <pc:sldMk cId="1897538530" sldId="256"/>
            <ac:spMk id="93" creationId="{90974F94-C26A-3F00-A4D9-AFD74D0FAE25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95" creationId="{40964173-447B-9B7B-7F03-4A6C95CB9C7C}"/>
          </ac:spMkLst>
        </pc:spChg>
        <pc:spChg chg="add del mod">
          <ac:chgData name="Reza Amini Hounejani" userId="36cb0b73-58b2-4568-a1ab-00cd49301806" providerId="ADAL" clId="{DA8FEA81-1A63-884F-A1C6-520C766F400F}" dt="2022-11-14T15:23:21.537" v="8300" actId="478"/>
          <ac:spMkLst>
            <pc:docMk/>
            <pc:sldMk cId="1897538530" sldId="256"/>
            <ac:spMk id="95" creationId="{44CA0233-7353-464D-200C-03BCA0B16AB1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96" creationId="{73BA751A-72C3-719D-74A9-BDD32D83D8B4}"/>
          </ac:spMkLst>
        </pc:spChg>
        <pc:spChg chg="add del">
          <ac:chgData name="Reza Amini Hounejani" userId="36cb0b73-58b2-4568-a1ab-00cd49301806" providerId="ADAL" clId="{DA8FEA81-1A63-884F-A1C6-520C766F400F}" dt="2022-11-14T15:24:46.967" v="8307" actId="478"/>
          <ac:spMkLst>
            <pc:docMk/>
            <pc:sldMk cId="1897538530" sldId="256"/>
            <ac:spMk id="96" creationId="{AFFD9794-B4C7-4F89-A81B-A52255D45B32}"/>
          </ac:spMkLst>
        </pc:spChg>
        <pc:spChg chg="add del">
          <ac:chgData name="Reza Amini Hounejani" userId="36cb0b73-58b2-4568-a1ab-00cd49301806" providerId="ADAL" clId="{DA8FEA81-1A63-884F-A1C6-520C766F400F}" dt="2022-11-14T15:26:05.357" v="8309" actId="478"/>
          <ac:spMkLst>
            <pc:docMk/>
            <pc:sldMk cId="1897538530" sldId="256"/>
            <ac:spMk id="97" creationId="{45C83988-4DE0-D146-5A17-6236B44F40C6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97" creationId="{985B7EC7-125D-82D5-E016-E3F37EDD8723}"/>
          </ac:spMkLst>
        </pc:spChg>
        <pc:spChg chg="mod">
          <ac:chgData name="Reza Amini Hounejani" userId="36cb0b73-58b2-4568-a1ab-00cd49301806" providerId="ADAL" clId="{DA8FEA81-1A63-884F-A1C6-520C766F400F}" dt="2022-10-17T12:57:24.884" v="3419" actId="12789"/>
          <ac:spMkLst>
            <pc:docMk/>
            <pc:sldMk cId="1897538530" sldId="256"/>
            <ac:spMk id="98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0-17T12:57:24.884" v="3419" actId="12789"/>
          <ac:spMkLst>
            <pc:docMk/>
            <pc:sldMk cId="1897538530" sldId="256"/>
            <ac:spMk id="99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09-30T14:10:35.897" v="3297" actId="1037"/>
          <ac:spMkLst>
            <pc:docMk/>
            <pc:sldMk cId="1897538530" sldId="256"/>
            <ac:spMk id="100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25T13:07:30.543" v="11882" actId="1037"/>
          <ac:spMkLst>
            <pc:docMk/>
            <pc:sldMk cId="1897538530" sldId="256"/>
            <ac:spMk id="101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25T13:07:35.626" v="11889" actId="1038"/>
          <ac:spMkLst>
            <pc:docMk/>
            <pc:sldMk cId="1897538530" sldId="256"/>
            <ac:spMk id="102" creationId="{0E3A8FA3-C11D-4C61-3AFB-B69205167F17}"/>
          </ac:spMkLst>
        </pc:spChg>
        <pc:spChg chg="add del">
          <ac:chgData name="Reza Amini Hounejani" userId="36cb0b73-58b2-4568-a1ab-00cd49301806" providerId="ADAL" clId="{DA8FEA81-1A63-884F-A1C6-520C766F400F}" dt="2022-11-14T15:26:17.990" v="8311" actId="478"/>
          <ac:spMkLst>
            <pc:docMk/>
            <pc:sldMk cId="1897538530" sldId="256"/>
            <ac:spMk id="105" creationId="{9D7125D0-16FE-1073-E203-85366AD5472C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06" creationId="{5C0580F6-A095-380D-C4A8-572CF41E5673}"/>
          </ac:spMkLst>
        </pc:spChg>
        <pc:spChg chg="add mod">
          <ac:chgData name="Reza Amini Hounejani" userId="36cb0b73-58b2-4568-a1ab-00cd49301806" providerId="ADAL" clId="{DA8FEA81-1A63-884F-A1C6-520C766F400F}" dt="2022-11-14T15:27:00.758" v="8320" actId="14100"/>
          <ac:spMkLst>
            <pc:docMk/>
            <pc:sldMk cId="1897538530" sldId="256"/>
            <ac:spMk id="106" creationId="{C38F056F-A8DE-C3A1-E292-FEAB149432D7}"/>
          </ac:spMkLst>
        </pc:spChg>
        <pc:spChg chg="mod">
          <ac:chgData name="Reza Amini Hounejani" userId="36cb0b73-58b2-4568-a1ab-00cd49301806" providerId="ADAL" clId="{DA8FEA81-1A63-884F-A1C6-520C766F400F}" dt="2022-10-18T09:17:51.892" v="4019" actId="20577"/>
          <ac:spMkLst>
            <pc:docMk/>
            <pc:sldMk cId="1897538530" sldId="256"/>
            <ac:spMk id="107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09-30T14:10:35.897" v="3297" actId="1037"/>
          <ac:spMkLst>
            <pc:docMk/>
            <pc:sldMk cId="1897538530" sldId="256"/>
            <ac:spMk id="108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09-30T14:10:35.897" v="3297" actId="1037"/>
          <ac:spMkLst>
            <pc:docMk/>
            <pc:sldMk cId="1897538530" sldId="256"/>
            <ac:spMk id="109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10" creationId="{003A260A-0FCD-E9EB-2347-A55141EB6489}"/>
          </ac:spMkLst>
        </pc:spChg>
        <pc:spChg chg="add mod">
          <ac:chgData name="Reza Amini Hounejani" userId="36cb0b73-58b2-4568-a1ab-00cd49301806" providerId="ADAL" clId="{DA8FEA81-1A63-884F-A1C6-520C766F400F}" dt="2022-11-14T15:27:06.540" v="8321" actId="571"/>
          <ac:spMkLst>
            <pc:docMk/>
            <pc:sldMk cId="1897538530" sldId="256"/>
            <ac:spMk id="110" creationId="{3C02EBBF-89BF-25DA-5091-3A5DC033B41B}"/>
          </ac:spMkLst>
        </pc:spChg>
        <pc:spChg chg="mod">
          <ac:chgData name="Reza Amini Hounejani" userId="36cb0b73-58b2-4568-a1ab-00cd49301806" providerId="ADAL" clId="{DA8FEA81-1A63-884F-A1C6-520C766F400F}" dt="2022-07-26T11:46:36.910" v="157" actId="1037"/>
          <ac:spMkLst>
            <pc:docMk/>
            <pc:sldMk cId="1897538530" sldId="256"/>
            <ac:spMk id="111" creationId="{29FAE0B7-002A-12D2-CB48-182F56221F1B}"/>
          </ac:spMkLst>
        </pc:spChg>
        <pc:spChg chg="mod">
          <ac:chgData name="Reza Amini Hounejani" userId="36cb0b73-58b2-4568-a1ab-00cd49301806" providerId="ADAL" clId="{DA8FEA81-1A63-884F-A1C6-520C766F400F}" dt="2022-09-30T14:10:35.897" v="3297" actId="1037"/>
          <ac:spMkLst>
            <pc:docMk/>
            <pc:sldMk cId="1897538530" sldId="256"/>
            <ac:spMk id="112" creationId="{0E0F9144-43C6-8FBB-8A21-50B0472AA7FB}"/>
          </ac:spMkLst>
        </pc:spChg>
        <pc:spChg chg="mod">
          <ac:chgData name="Reza Amini Hounejani" userId="36cb0b73-58b2-4568-a1ab-00cd49301806" providerId="ADAL" clId="{DA8FEA81-1A63-884F-A1C6-520C766F400F}" dt="2022-09-30T14:10:35.897" v="3297" actId="1037"/>
          <ac:spMkLst>
            <pc:docMk/>
            <pc:sldMk cId="1897538530" sldId="256"/>
            <ac:spMk id="114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09-30T14:11:31.323" v="3308" actId="113"/>
          <ac:spMkLst>
            <pc:docMk/>
            <pc:sldMk cId="1897538530" sldId="256"/>
            <ac:spMk id="115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09-30T14:11:31.323" v="3308" actId="113"/>
          <ac:spMkLst>
            <pc:docMk/>
            <pc:sldMk cId="1897538530" sldId="256"/>
            <ac:spMk id="116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4T15:18:32.549" v="8281" actId="1076"/>
          <ac:spMkLst>
            <pc:docMk/>
            <pc:sldMk cId="1897538530" sldId="256"/>
            <ac:spMk id="117" creationId="{B6DB756B-85E9-14FD-3288-B366DFFE1DDC}"/>
          </ac:spMkLst>
        </pc:spChg>
        <pc:spChg chg="mod">
          <ac:chgData name="Reza Amini Hounejani" userId="36cb0b73-58b2-4568-a1ab-00cd49301806" providerId="ADAL" clId="{DA8FEA81-1A63-884F-A1C6-520C766F400F}" dt="2022-07-26T11:59:14.430" v="311" actId="20577"/>
          <ac:spMkLst>
            <pc:docMk/>
            <pc:sldMk cId="1897538530" sldId="256"/>
            <ac:spMk id="119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4T15:17:59.387" v="8276" actId="553"/>
          <ac:spMkLst>
            <pc:docMk/>
            <pc:sldMk cId="1897538530" sldId="256"/>
            <ac:spMk id="120" creationId="{BEC9A2A9-9593-0507-9628-629F19E4CB85}"/>
          </ac:spMkLst>
        </pc:spChg>
        <pc:spChg chg="del">
          <ac:chgData name="Reza Amini Hounejani" userId="36cb0b73-58b2-4568-a1ab-00cd49301806" providerId="ADAL" clId="{DA8FEA81-1A63-884F-A1C6-520C766F400F}" dt="2022-07-26T11:47:35.665" v="183" actId="478"/>
          <ac:spMkLst>
            <pc:docMk/>
            <pc:sldMk cId="1897538530" sldId="256"/>
            <ac:spMk id="121" creationId="{00C12F5B-2AF5-BD5C-41AA-75B0583A169C}"/>
          </ac:spMkLst>
        </pc:spChg>
        <pc:spChg chg="add mod">
          <ac:chgData name="Reza Amini Hounejani" userId="36cb0b73-58b2-4568-a1ab-00cd49301806" providerId="ADAL" clId="{DA8FEA81-1A63-884F-A1C6-520C766F400F}" dt="2022-11-14T15:27:08.250" v="8322" actId="571"/>
          <ac:spMkLst>
            <pc:docMk/>
            <pc:sldMk cId="1897538530" sldId="256"/>
            <ac:spMk id="121" creationId="{2934FABB-CBB5-4B19-A9F8-C609BCA3466F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21" creationId="{948FA9CE-FFAE-4F89-0CFC-1907762F2E58}"/>
          </ac:spMkLst>
        </pc:spChg>
        <pc:spChg chg="mod">
          <ac:chgData name="Reza Amini Hounejani" userId="36cb0b73-58b2-4568-a1ab-00cd49301806" providerId="ADAL" clId="{DA8FEA81-1A63-884F-A1C6-520C766F400F}" dt="2022-11-14T15:43:36.236" v="8441" actId="1036"/>
          <ac:spMkLst>
            <pc:docMk/>
            <pc:sldMk cId="1897538530" sldId="256"/>
            <ac:spMk id="122" creationId="{8F42A81C-EEF7-A4A8-316D-2495617E6F45}"/>
          </ac:spMkLst>
        </pc:spChg>
        <pc:spChg chg="mod">
          <ac:chgData name="Reza Amini Hounejani" userId="36cb0b73-58b2-4568-a1ab-00cd49301806" providerId="ADAL" clId="{DA8FEA81-1A63-884F-A1C6-520C766F400F}" dt="2022-11-14T15:18:12.375" v="8279" actId="14100"/>
          <ac:spMkLst>
            <pc:docMk/>
            <pc:sldMk cId="1897538530" sldId="256"/>
            <ac:spMk id="125" creationId="{00000000-0000-0000-0000-000000000000}"/>
          </ac:spMkLst>
        </pc:spChg>
        <pc:spChg chg="mod">
          <ac:chgData name="Reza Amini Hounejani" userId="36cb0b73-58b2-4568-a1ab-00cd49301806" providerId="ADAL" clId="{DA8FEA81-1A63-884F-A1C6-520C766F400F}" dt="2022-11-14T15:18:49.102" v="8283" actId="1076"/>
          <ac:spMkLst>
            <pc:docMk/>
            <pc:sldMk cId="1897538530" sldId="256"/>
            <ac:spMk id="126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07-26T11:46:58.202" v="178" actId="1035"/>
          <ac:spMkLst>
            <pc:docMk/>
            <pc:sldMk cId="1897538530" sldId="256"/>
            <ac:spMk id="128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4T15:18:29.359" v="8280" actId="1076"/>
          <ac:spMkLst>
            <pc:docMk/>
            <pc:sldMk cId="1897538530" sldId="256"/>
            <ac:spMk id="130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4T15:18:39.414" v="8282" actId="1076"/>
          <ac:spMkLst>
            <pc:docMk/>
            <pc:sldMk cId="1897538530" sldId="256"/>
            <ac:spMk id="132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07-26T11:46:58.202" v="178" actId="1035"/>
          <ac:spMkLst>
            <pc:docMk/>
            <pc:sldMk cId="1897538530" sldId="256"/>
            <ac:spMk id="133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09-12T17:10:28.639" v="2283" actId="1037"/>
          <ac:spMkLst>
            <pc:docMk/>
            <pc:sldMk cId="1897538530" sldId="256"/>
            <ac:spMk id="134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4T15:18:06.702" v="8278" actId="14100"/>
          <ac:spMkLst>
            <pc:docMk/>
            <pc:sldMk cId="1897538530" sldId="256"/>
            <ac:spMk id="135" creationId="{00000000-0000-0000-0000-000000000000}"/>
          </ac:spMkLst>
        </pc:spChg>
        <pc:spChg chg="mod">
          <ac:chgData name="Reza Amini Hounejani" userId="36cb0b73-58b2-4568-a1ab-00cd49301806" providerId="ADAL" clId="{DA8FEA81-1A63-884F-A1C6-520C766F400F}" dt="2022-11-15T12:52:03.913" v="8830" actId="1037"/>
          <ac:spMkLst>
            <pc:docMk/>
            <pc:sldMk cId="1897538530" sldId="256"/>
            <ac:spMk id="136" creationId="{630B5ACD-D41D-2739-8018-35EC0EF26891}"/>
          </ac:spMkLst>
        </pc:spChg>
        <pc:spChg chg="del mod">
          <ac:chgData name="Reza Amini Hounejani" userId="36cb0b73-58b2-4568-a1ab-00cd49301806" providerId="ADAL" clId="{DA8FEA81-1A63-884F-A1C6-520C766F400F}" dt="2022-11-14T15:18:02.542" v="8277" actId="478"/>
          <ac:spMkLst>
            <pc:docMk/>
            <pc:sldMk cId="1897538530" sldId="256"/>
            <ac:spMk id="137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6T12:38:20.352" v="8996" actId="571"/>
          <ac:spMkLst>
            <pc:docMk/>
            <pc:sldMk cId="1897538530" sldId="256"/>
            <ac:spMk id="137" creationId="{D3F69B59-DA15-69C5-C220-C9ECF4955FCC}"/>
          </ac:spMkLst>
        </pc:spChg>
        <pc:spChg chg="del">
          <ac:chgData name="Reza Amini Hounejani" userId="36cb0b73-58b2-4568-a1ab-00cd49301806" providerId="ADAL" clId="{DA8FEA81-1A63-884F-A1C6-520C766F400F}" dt="2022-07-26T11:47:22.484" v="180" actId="478"/>
          <ac:spMkLst>
            <pc:docMk/>
            <pc:sldMk cId="1897538530" sldId="256"/>
            <ac:spMk id="138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38" creationId="{81DDCEFF-8896-4E07-9095-446CC2A37ABE}"/>
          </ac:spMkLst>
        </pc:spChg>
        <pc:spChg chg="add mod">
          <ac:chgData name="Reza Amini Hounejani" userId="36cb0b73-58b2-4568-a1ab-00cd49301806" providerId="ADAL" clId="{DA8FEA81-1A63-884F-A1C6-520C766F400F}" dt="2022-11-14T15:27:09.698" v="8323" actId="571"/>
          <ac:spMkLst>
            <pc:docMk/>
            <pc:sldMk cId="1897538530" sldId="256"/>
            <ac:spMk id="138" creationId="{B82D92F9-08EA-63F4-A006-4A729B6515AD}"/>
          </ac:spMkLst>
        </pc:spChg>
        <pc:spChg chg="mod">
          <ac:chgData name="Reza Amini Hounejani" userId="36cb0b73-58b2-4568-a1ab-00cd49301806" providerId="ADAL" clId="{DA8FEA81-1A63-884F-A1C6-520C766F400F}" dt="2022-11-14T15:17:59.387" v="8276" actId="553"/>
          <ac:spMkLst>
            <pc:docMk/>
            <pc:sldMk cId="1897538530" sldId="256"/>
            <ac:spMk id="139" creationId="{0E3A8FA3-C11D-4C61-3AFB-B69205167F17}"/>
          </ac:spMkLst>
        </pc:spChg>
        <pc:spChg chg="add mod">
          <ac:chgData name="Reza Amini Hounejani" userId="36cb0b73-58b2-4568-a1ab-00cd49301806" providerId="ADAL" clId="{DA8FEA81-1A63-884F-A1C6-520C766F400F}" dt="2022-11-14T15:27:16.622" v="8325" actId="1076"/>
          <ac:spMkLst>
            <pc:docMk/>
            <pc:sldMk cId="1897538530" sldId="256"/>
            <ac:spMk id="140" creationId="{0B126061-637B-CA4C-276E-786F44AC551E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40" creationId="{0DE10A15-0D72-9C72-16CB-BD15AC3CBCF2}"/>
          </ac:spMkLst>
        </pc:spChg>
        <pc:spChg chg="del">
          <ac:chgData name="Reza Amini Hounejani" userId="36cb0b73-58b2-4568-a1ab-00cd49301806" providerId="ADAL" clId="{DA8FEA81-1A63-884F-A1C6-520C766F400F}" dt="2022-07-26T11:47:32.890" v="182" actId="478"/>
          <ac:spMkLst>
            <pc:docMk/>
            <pc:sldMk cId="1897538530" sldId="256"/>
            <ac:spMk id="140" creationId="{0E3A8FA3-C11D-4C61-3AFB-B69205167F17}"/>
          </ac:spMkLst>
        </pc:spChg>
        <pc:spChg chg="del">
          <ac:chgData name="Reza Amini Hounejani" userId="36cb0b73-58b2-4568-a1ab-00cd49301806" providerId="ADAL" clId="{DA8FEA81-1A63-884F-A1C6-520C766F400F}" dt="2022-07-26T11:47:38.682" v="184" actId="478"/>
          <ac:spMkLst>
            <pc:docMk/>
            <pc:sldMk cId="1897538530" sldId="256"/>
            <ac:spMk id="141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41" creationId="{271994C3-8857-F70B-ECA7-9726A1A3420D}"/>
          </ac:spMkLst>
        </pc:spChg>
        <pc:spChg chg="add mod">
          <ac:chgData name="Reza Amini Hounejani" userId="36cb0b73-58b2-4568-a1ab-00cd49301806" providerId="ADAL" clId="{DA8FEA81-1A63-884F-A1C6-520C766F400F}" dt="2022-11-14T15:27:20.572" v="8328" actId="14100"/>
          <ac:spMkLst>
            <pc:docMk/>
            <pc:sldMk cId="1897538530" sldId="256"/>
            <ac:spMk id="141" creationId="{D16FF7C3-6039-67BC-7336-088BDC94A099}"/>
          </ac:spMkLst>
        </pc:spChg>
        <pc:spChg chg="mod">
          <ac:chgData name="Reza Amini Hounejani" userId="36cb0b73-58b2-4568-a1ab-00cd49301806" providerId="ADAL" clId="{DA8FEA81-1A63-884F-A1C6-520C766F400F}" dt="2022-09-30T14:10:35.897" v="3297" actId="1037"/>
          <ac:spMkLst>
            <pc:docMk/>
            <pc:sldMk cId="1897538530" sldId="256"/>
            <ac:spMk id="142" creationId="{48047047-4ACF-D85E-067B-B7175D8E9997}"/>
          </ac:spMkLst>
        </pc:spChg>
        <pc:spChg chg="mod">
          <ac:chgData name="Reza Amini Hounejani" userId="36cb0b73-58b2-4568-a1ab-00cd49301806" providerId="ADAL" clId="{DA8FEA81-1A63-884F-A1C6-520C766F400F}" dt="2022-11-15T12:52:03.913" v="8830" actId="1037"/>
          <ac:spMkLst>
            <pc:docMk/>
            <pc:sldMk cId="1897538530" sldId="256"/>
            <ac:spMk id="143" creationId="{5D262CFA-0F69-5CBF-F348-2A9A812539EE}"/>
          </ac:spMkLst>
        </pc:spChg>
        <pc:spChg chg="mod">
          <ac:chgData name="Reza Amini Hounejani" userId="36cb0b73-58b2-4568-a1ab-00cd49301806" providerId="ADAL" clId="{DA8FEA81-1A63-884F-A1C6-520C766F400F}" dt="2022-07-26T11:46:36.910" v="157" actId="1037"/>
          <ac:spMkLst>
            <pc:docMk/>
            <pc:sldMk cId="1897538530" sldId="256"/>
            <ac:spMk id="145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07-26T11:46:36.910" v="157" actId="1037"/>
          <ac:spMkLst>
            <pc:docMk/>
            <pc:sldMk cId="1897538530" sldId="256"/>
            <ac:spMk id="146" creationId="{0E3A8FA3-C11D-4C61-3AFB-B69205167F17}"/>
          </ac:spMkLst>
        </pc:spChg>
        <pc:spChg chg="del">
          <ac:chgData name="Reza Amini Hounejani" userId="36cb0b73-58b2-4568-a1ab-00cd49301806" providerId="ADAL" clId="{DA8FEA81-1A63-884F-A1C6-520C766F400F}" dt="2022-07-26T11:47:02.696" v="179" actId="478"/>
          <ac:spMkLst>
            <pc:docMk/>
            <pc:sldMk cId="1897538530" sldId="256"/>
            <ac:spMk id="147" creationId="{0E3A8FA3-C11D-4C61-3AFB-B69205167F17}"/>
          </ac:spMkLst>
        </pc:spChg>
        <pc:spChg chg="add mod">
          <ac:chgData name="Reza Amini Hounejani" userId="36cb0b73-58b2-4568-a1ab-00cd49301806" providerId="ADAL" clId="{DA8FEA81-1A63-884F-A1C6-520C766F400F}" dt="2022-11-14T15:27:25.923" v="8329" actId="571"/>
          <ac:spMkLst>
            <pc:docMk/>
            <pc:sldMk cId="1897538530" sldId="256"/>
            <ac:spMk id="147" creationId="{90E8D8F3-9762-6EEA-73B7-60BD1CF494B5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47" creationId="{C70F7C7C-3989-1470-75B0-8CC34F8A0F14}"/>
          </ac:spMkLst>
        </pc:spChg>
        <pc:spChg chg="mod">
          <ac:chgData name="Reza Amini Hounejani" userId="36cb0b73-58b2-4568-a1ab-00cd49301806" providerId="ADAL" clId="{DA8FEA81-1A63-884F-A1C6-520C766F400F}" dt="2022-09-30T14:11:31.323" v="3308" actId="113"/>
          <ac:spMkLst>
            <pc:docMk/>
            <pc:sldMk cId="1897538530" sldId="256"/>
            <ac:spMk id="148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0-17T12:57:24.884" v="3419" actId="12789"/>
          <ac:spMkLst>
            <pc:docMk/>
            <pc:sldMk cId="1897538530" sldId="256"/>
            <ac:spMk id="150" creationId="{B99E9AB2-8FA5-22A2-8556-3C4C0189734C}"/>
          </ac:spMkLst>
        </pc:spChg>
        <pc:spChg chg="mod">
          <ac:chgData name="Reza Amini Hounejani" userId="36cb0b73-58b2-4568-a1ab-00cd49301806" providerId="ADAL" clId="{DA8FEA81-1A63-884F-A1C6-520C766F400F}" dt="2022-11-25T13:15:31.963" v="11902" actId="555"/>
          <ac:spMkLst>
            <pc:docMk/>
            <pc:sldMk cId="1897538530" sldId="256"/>
            <ac:spMk id="152" creationId="{4915224A-FE65-0DCD-DEEA-44DAA440410E}"/>
          </ac:spMkLst>
        </pc:spChg>
        <pc:spChg chg="add mod">
          <ac:chgData name="Reza Amini Hounejani" userId="36cb0b73-58b2-4568-a1ab-00cd49301806" providerId="ADAL" clId="{DA8FEA81-1A63-884F-A1C6-520C766F400F}" dt="2022-11-14T15:27:29.377" v="8330" actId="571"/>
          <ac:spMkLst>
            <pc:docMk/>
            <pc:sldMk cId="1897538530" sldId="256"/>
            <ac:spMk id="153" creationId="{03EFA2E2-A9AB-E43A-D14A-73CE3164F7D7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53" creationId="{410E770B-295F-C6F0-89F4-57743624271D}"/>
          </ac:spMkLst>
        </pc:spChg>
        <pc:spChg chg="mod">
          <ac:chgData name="Reza Amini Hounejani" userId="36cb0b73-58b2-4568-a1ab-00cd49301806" providerId="ADAL" clId="{DA8FEA81-1A63-884F-A1C6-520C766F400F}" dt="2022-09-30T14:10:35.897" v="3297" actId="1037"/>
          <ac:spMkLst>
            <pc:docMk/>
            <pc:sldMk cId="1897538530" sldId="256"/>
            <ac:spMk id="154" creationId="{EDA71FA1-2411-B55C-19D8-C0FD34C28F29}"/>
          </ac:spMkLst>
        </pc:spChg>
        <pc:spChg chg="mod">
          <ac:chgData name="Reza Amini Hounejani" userId="36cb0b73-58b2-4568-a1ab-00cd49301806" providerId="ADAL" clId="{DA8FEA81-1A63-884F-A1C6-520C766F400F}" dt="2022-09-30T14:10:35.897" v="3297" actId="1037"/>
          <ac:spMkLst>
            <pc:docMk/>
            <pc:sldMk cId="1897538530" sldId="256"/>
            <ac:spMk id="156" creationId="{5A5051A2-0B2B-84B0-D7DB-4216A86C687B}"/>
          </ac:spMkLst>
        </pc:spChg>
        <pc:spChg chg="mod">
          <ac:chgData name="Reza Amini Hounejani" userId="36cb0b73-58b2-4568-a1ab-00cd49301806" providerId="ADAL" clId="{DA8FEA81-1A63-884F-A1C6-520C766F400F}" dt="2022-09-30T14:10:35.897" v="3297" actId="1037"/>
          <ac:spMkLst>
            <pc:docMk/>
            <pc:sldMk cId="1897538530" sldId="256"/>
            <ac:spMk id="157" creationId="{74BD0321-D7D2-D785-5553-4DC9CF66A128}"/>
          </ac:spMkLst>
        </pc:spChg>
        <pc:spChg chg="mod">
          <ac:chgData name="Reza Amini Hounejani" userId="36cb0b73-58b2-4568-a1ab-00cd49301806" providerId="ADAL" clId="{DA8FEA81-1A63-884F-A1C6-520C766F400F}" dt="2022-11-16T12:38:20.352" v="8996" actId="571"/>
          <ac:spMkLst>
            <pc:docMk/>
            <pc:sldMk cId="1897538530" sldId="256"/>
            <ac:spMk id="158" creationId="{2A050C37-52CB-7495-1A17-5229C47F3E72}"/>
          </ac:spMkLst>
        </pc:spChg>
        <pc:spChg chg="add del">
          <ac:chgData name="Reza Amini Hounejani" userId="36cb0b73-58b2-4568-a1ab-00cd49301806" providerId="ADAL" clId="{DA8FEA81-1A63-884F-A1C6-520C766F400F}" dt="2022-11-14T15:28:46.962" v="8333" actId="478"/>
          <ac:spMkLst>
            <pc:docMk/>
            <pc:sldMk cId="1897538530" sldId="256"/>
            <ac:spMk id="158" creationId="{6A88E61E-BE22-70C9-925B-CE2BBC000BF1}"/>
          </ac:spMkLst>
        </pc:spChg>
        <pc:spChg chg="mod">
          <ac:chgData name="Reza Amini Hounejani" userId="36cb0b73-58b2-4568-a1ab-00cd49301806" providerId="ADAL" clId="{DA8FEA81-1A63-884F-A1C6-520C766F400F}" dt="2022-09-30T14:10:35.897" v="3297" actId="1037"/>
          <ac:spMkLst>
            <pc:docMk/>
            <pc:sldMk cId="1897538530" sldId="256"/>
            <ac:spMk id="159" creationId="{86ACCBD4-48E2-9B99-46F5-49AF2F690C17}"/>
          </ac:spMkLst>
        </pc:spChg>
        <pc:spChg chg="mod">
          <ac:chgData name="Reza Amini Hounejani" userId="36cb0b73-58b2-4568-a1ab-00cd49301806" providerId="ADAL" clId="{DA8FEA81-1A63-884F-A1C6-520C766F400F}" dt="2022-10-18T09:17:55.181" v="4021" actId="20577"/>
          <ac:spMkLst>
            <pc:docMk/>
            <pc:sldMk cId="1897538530" sldId="256"/>
            <ac:spMk id="160" creationId="{B26AF495-7735-BB05-3D93-6FAF7E87B732}"/>
          </ac:spMkLst>
        </pc:spChg>
        <pc:spChg chg="mod">
          <ac:chgData name="Reza Amini Hounejani" userId="36cb0b73-58b2-4568-a1ab-00cd49301806" providerId="ADAL" clId="{DA8FEA81-1A63-884F-A1C6-520C766F400F}" dt="2022-09-30T14:10:35.897" v="3297" actId="1037"/>
          <ac:spMkLst>
            <pc:docMk/>
            <pc:sldMk cId="1897538530" sldId="256"/>
            <ac:spMk id="161" creationId="{21C253B9-B4A4-C96A-FDBC-74B93F80305A}"/>
          </ac:spMkLst>
        </pc:spChg>
        <pc:spChg chg="add mod">
          <ac:chgData name="Reza Amini Hounejani" userId="36cb0b73-58b2-4568-a1ab-00cd49301806" providerId="ADAL" clId="{DA8FEA81-1A63-884F-A1C6-520C766F400F}" dt="2022-11-14T15:37:13.013" v="8388" actId="1038"/>
          <ac:spMkLst>
            <pc:docMk/>
            <pc:sldMk cId="1897538530" sldId="256"/>
            <ac:spMk id="162" creationId="{B0E7EBEF-3E7E-C64D-135E-03020DF6D233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62" creationId="{BCC9DDE6-E501-7332-2006-D9A13904C6A5}"/>
          </ac:spMkLst>
        </pc:spChg>
        <pc:spChg chg="add mod">
          <ac:chgData name="Reza Amini Hounejani" userId="36cb0b73-58b2-4568-a1ab-00cd49301806" providerId="ADAL" clId="{DA8FEA81-1A63-884F-A1C6-520C766F400F}" dt="2022-11-14T15:37:02.881" v="8386" actId="1035"/>
          <ac:spMkLst>
            <pc:docMk/>
            <pc:sldMk cId="1897538530" sldId="256"/>
            <ac:spMk id="163" creationId="{813BDAAF-CABF-73D0-A718-25EC205028EE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63" creationId="{B462F23D-3C56-ABF9-71A6-C711E956CA73}"/>
          </ac:spMkLst>
        </pc:spChg>
        <pc:spChg chg="add mod">
          <ac:chgData name="Reza Amini Hounejani" userId="36cb0b73-58b2-4568-a1ab-00cd49301806" providerId="ADAL" clId="{DA8FEA81-1A63-884F-A1C6-520C766F400F}" dt="2022-11-14T15:33:04.186" v="8348" actId="208"/>
          <ac:spMkLst>
            <pc:docMk/>
            <pc:sldMk cId="1897538530" sldId="256"/>
            <ac:spMk id="164" creationId="{9869A9AF-F9E4-91E5-673E-3BC9664A6559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64" creationId="{D7CBDF1B-2A5D-78E7-96DD-5C92EE32159D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65" creationId="{C504E0EA-B021-AE48-B885-1CC003E4DF52}"/>
          </ac:spMkLst>
        </pc:spChg>
        <pc:spChg chg="add mod">
          <ac:chgData name="Reza Amini Hounejani" userId="36cb0b73-58b2-4568-a1ab-00cd49301806" providerId="ADAL" clId="{DA8FEA81-1A63-884F-A1C6-520C766F400F}" dt="2022-11-14T15:33:04.186" v="8348" actId="208"/>
          <ac:spMkLst>
            <pc:docMk/>
            <pc:sldMk cId="1897538530" sldId="256"/>
            <ac:spMk id="165" creationId="{EFB2264F-8D9C-F1F5-774C-0AC391D793AC}"/>
          </ac:spMkLst>
        </pc:spChg>
        <pc:spChg chg="add mod">
          <ac:chgData name="Reza Amini Hounejani" userId="36cb0b73-58b2-4568-a1ab-00cd49301806" providerId="ADAL" clId="{DA8FEA81-1A63-884F-A1C6-520C766F400F}" dt="2022-11-14T15:33:04.186" v="8348" actId="208"/>
          <ac:spMkLst>
            <pc:docMk/>
            <pc:sldMk cId="1897538530" sldId="256"/>
            <ac:spMk id="166" creationId="{22E5F631-9EA1-F528-5277-E5669FC96C41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66" creationId="{27243553-F9DA-39EF-C9A5-CEFDD9FD8F33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67" creationId="{07934A22-ABFE-6D52-D070-F4D9A2DC3CB8}"/>
          </ac:spMkLst>
        </pc:spChg>
        <pc:spChg chg="add mod">
          <ac:chgData name="Reza Amini Hounejani" userId="36cb0b73-58b2-4568-a1ab-00cd49301806" providerId="ADAL" clId="{DA8FEA81-1A63-884F-A1C6-520C766F400F}" dt="2022-11-14T15:33:04.186" v="8348" actId="208"/>
          <ac:spMkLst>
            <pc:docMk/>
            <pc:sldMk cId="1897538530" sldId="256"/>
            <ac:spMk id="167" creationId="{FE6A9BC6-A613-F5B5-BFDB-A8E115F6BAB4}"/>
          </ac:spMkLst>
        </pc:spChg>
        <pc:spChg chg="add mod">
          <ac:chgData name="Reza Amini Hounejani" userId="36cb0b73-58b2-4568-a1ab-00cd49301806" providerId="ADAL" clId="{DA8FEA81-1A63-884F-A1C6-520C766F400F}" dt="2022-11-16T12:38:34.929" v="9003" actId="1076"/>
          <ac:spMkLst>
            <pc:docMk/>
            <pc:sldMk cId="1897538530" sldId="256"/>
            <ac:spMk id="168" creationId="{6419CA56-8FDA-3E74-6C13-8AE4165B9833}"/>
          </ac:spMkLst>
        </pc:spChg>
        <pc:spChg chg="add del mod">
          <ac:chgData name="Reza Amini Hounejani" userId="36cb0b73-58b2-4568-a1ab-00cd49301806" providerId="ADAL" clId="{DA8FEA81-1A63-884F-A1C6-520C766F400F}" dt="2022-11-14T15:37:40.429" v="8392" actId="478"/>
          <ac:spMkLst>
            <pc:docMk/>
            <pc:sldMk cId="1897538530" sldId="256"/>
            <ac:spMk id="168" creationId="{BFCC63CF-AA7F-FB32-88D2-4058F1CA90BC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68" creationId="{FDC7CB98-8032-218F-ED1F-9D5D5CB4A6C2}"/>
          </ac:spMkLst>
        </pc:spChg>
        <pc:spChg chg="add mod">
          <ac:chgData name="Reza Amini Hounejani" userId="36cb0b73-58b2-4568-a1ab-00cd49301806" providerId="ADAL" clId="{DA8FEA81-1A63-884F-A1C6-520C766F400F}" dt="2022-11-14T15:37:13.013" v="8388" actId="1038"/>
          <ac:spMkLst>
            <pc:docMk/>
            <pc:sldMk cId="1897538530" sldId="256"/>
            <ac:spMk id="169" creationId="{213AE584-F3DE-4782-F3B2-3BDC5D341901}"/>
          </ac:spMkLst>
        </pc:spChg>
        <pc:spChg chg="mod">
          <ac:chgData name="Reza Amini Hounejani" userId="36cb0b73-58b2-4568-a1ab-00cd49301806" providerId="ADAL" clId="{DA8FEA81-1A63-884F-A1C6-520C766F400F}" dt="2022-11-09T11:17:29.255" v="6973" actId="165"/>
          <ac:spMkLst>
            <pc:docMk/>
            <pc:sldMk cId="1897538530" sldId="256"/>
            <ac:spMk id="169" creationId="{3119C1C8-4508-0849-B374-C1E269603157}"/>
          </ac:spMkLst>
        </pc:spChg>
        <pc:spChg chg="add mod">
          <ac:chgData name="Reza Amini Hounejani" userId="36cb0b73-58b2-4568-a1ab-00cd49301806" providerId="ADAL" clId="{DA8FEA81-1A63-884F-A1C6-520C766F400F}" dt="2022-11-14T15:37:02.881" v="8386" actId="1035"/>
          <ac:spMkLst>
            <pc:docMk/>
            <pc:sldMk cId="1897538530" sldId="256"/>
            <ac:spMk id="170" creationId="{1276A8C3-E24A-CC77-B92F-618A6BD8E076}"/>
          </ac:spMkLst>
        </pc:spChg>
        <pc:spChg chg="add mod">
          <ac:chgData name="Reza Amini Hounejani" userId="36cb0b73-58b2-4568-a1ab-00cd49301806" providerId="ADAL" clId="{DA8FEA81-1A63-884F-A1C6-520C766F400F}" dt="2022-11-14T15:34:32.609" v="8355" actId="571"/>
          <ac:spMkLst>
            <pc:docMk/>
            <pc:sldMk cId="1897538530" sldId="256"/>
            <ac:spMk id="171" creationId="{24E43050-FC3B-7CBE-9A82-533D29E4A493}"/>
          </ac:spMkLst>
        </pc:spChg>
        <pc:spChg chg="del mod topLvl">
          <ac:chgData name="Reza Amini Hounejani" userId="36cb0b73-58b2-4568-a1ab-00cd49301806" providerId="ADAL" clId="{DA8FEA81-1A63-884F-A1C6-520C766F400F}" dt="2022-11-09T11:29:54.958" v="7084" actId="478"/>
          <ac:spMkLst>
            <pc:docMk/>
            <pc:sldMk cId="1897538530" sldId="256"/>
            <ac:spMk id="171" creationId="{634E38F3-B63F-92BB-965B-FB2DE38F3D18}"/>
          </ac:spMkLst>
        </pc:spChg>
        <pc:spChg chg="add mod">
          <ac:chgData name="Reza Amini Hounejani" userId="36cb0b73-58b2-4568-a1ab-00cd49301806" providerId="ADAL" clId="{DA8FEA81-1A63-884F-A1C6-520C766F400F}" dt="2022-11-14T15:34:35.049" v="8356" actId="571"/>
          <ac:spMkLst>
            <pc:docMk/>
            <pc:sldMk cId="1897538530" sldId="256"/>
            <ac:spMk id="172" creationId="{7E29EE66-3CF5-7A66-D5EA-DCDE3B988975}"/>
          </ac:spMkLst>
        </pc:spChg>
        <pc:spChg chg="del mod topLvl">
          <ac:chgData name="Reza Amini Hounejani" userId="36cb0b73-58b2-4568-a1ab-00cd49301806" providerId="ADAL" clId="{DA8FEA81-1A63-884F-A1C6-520C766F400F}" dt="2022-11-09T11:29:54.958" v="7084" actId="478"/>
          <ac:spMkLst>
            <pc:docMk/>
            <pc:sldMk cId="1897538530" sldId="256"/>
            <ac:spMk id="172" creationId="{A74AE130-7F87-E008-975F-4311F07B24BD}"/>
          </ac:spMkLst>
        </pc:spChg>
        <pc:spChg chg="add mod">
          <ac:chgData name="Reza Amini Hounejani" userId="36cb0b73-58b2-4568-a1ab-00cd49301806" providerId="ADAL" clId="{DA8FEA81-1A63-884F-A1C6-520C766F400F}" dt="2022-11-14T15:34:37.089" v="8357" actId="571"/>
          <ac:spMkLst>
            <pc:docMk/>
            <pc:sldMk cId="1897538530" sldId="256"/>
            <ac:spMk id="173" creationId="{42C0C503-0809-5711-C414-01E4A509B361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73" creationId="{9B246493-9A1E-82CE-3251-A7A4F4E103B1}"/>
          </ac:spMkLst>
        </pc:spChg>
        <pc:spChg chg="add mod">
          <ac:chgData name="Reza Amini Hounejani" userId="36cb0b73-58b2-4568-a1ab-00cd49301806" providerId="ADAL" clId="{DA8FEA81-1A63-884F-A1C6-520C766F400F}" dt="2022-11-14T15:34:38.489" v="8358" actId="571"/>
          <ac:spMkLst>
            <pc:docMk/>
            <pc:sldMk cId="1897538530" sldId="256"/>
            <ac:spMk id="174" creationId="{6D20DA9B-A499-79D6-DC6F-651F03A6F4B8}"/>
          </ac:spMkLst>
        </pc:spChg>
        <pc:spChg chg="del mod topLvl">
          <ac:chgData name="Reza Amini Hounejani" userId="36cb0b73-58b2-4568-a1ab-00cd49301806" providerId="ADAL" clId="{DA8FEA81-1A63-884F-A1C6-520C766F400F}" dt="2022-11-09T11:29:54.958" v="7084" actId="478"/>
          <ac:spMkLst>
            <pc:docMk/>
            <pc:sldMk cId="1897538530" sldId="256"/>
            <ac:spMk id="174" creationId="{AD6EDF8B-27C2-C78D-64A6-49306B6FE71B}"/>
          </ac:spMkLst>
        </pc:spChg>
        <pc:spChg chg="add mod">
          <ac:chgData name="Reza Amini Hounejani" userId="36cb0b73-58b2-4568-a1ab-00cd49301806" providerId="ADAL" clId="{DA8FEA81-1A63-884F-A1C6-520C766F400F}" dt="2022-11-16T12:38:42.023" v="9008" actId="1076"/>
          <ac:spMkLst>
            <pc:docMk/>
            <pc:sldMk cId="1897538530" sldId="256"/>
            <ac:spMk id="175" creationId="{3B84193A-F947-CF2E-318F-8E87D0FF7FCA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75" creationId="{684EDC63-4D5A-665D-1BE8-27A662AB9B6A}"/>
          </ac:spMkLst>
        </pc:spChg>
        <pc:spChg chg="add del mod">
          <ac:chgData name="Reza Amini Hounejani" userId="36cb0b73-58b2-4568-a1ab-00cd49301806" providerId="ADAL" clId="{DA8FEA81-1A63-884F-A1C6-520C766F400F}" dt="2022-11-14T15:37:40.429" v="8392" actId="478"/>
          <ac:spMkLst>
            <pc:docMk/>
            <pc:sldMk cId="1897538530" sldId="256"/>
            <ac:spMk id="175" creationId="{90ADE5BF-DD3D-B208-01C4-8374EC05A17F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76" creationId="{3AA02668-FC17-1EDF-87D6-6A60A0216FC3}"/>
          </ac:spMkLst>
        </pc:spChg>
        <pc:spChg chg="add mod">
          <ac:chgData name="Reza Amini Hounejani" userId="36cb0b73-58b2-4568-a1ab-00cd49301806" providerId="ADAL" clId="{DA8FEA81-1A63-884F-A1C6-520C766F400F}" dt="2022-11-14T15:36:42.551" v="8382" actId="1076"/>
          <ac:spMkLst>
            <pc:docMk/>
            <pc:sldMk cId="1897538530" sldId="256"/>
            <ac:spMk id="176" creationId="{D69C2BD2-4CC0-67A0-E02D-8D3280851A38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77" creationId="{27F862A5-4B5C-173E-D816-9769696BCE9D}"/>
          </ac:spMkLst>
        </pc:spChg>
        <pc:spChg chg="add mod">
          <ac:chgData name="Reza Amini Hounejani" userId="36cb0b73-58b2-4568-a1ab-00cd49301806" providerId="ADAL" clId="{DA8FEA81-1A63-884F-A1C6-520C766F400F}" dt="2022-11-14T15:37:18.326" v="8389" actId="1035"/>
          <ac:spMkLst>
            <pc:docMk/>
            <pc:sldMk cId="1897538530" sldId="256"/>
            <ac:spMk id="177" creationId="{8643DB99-952F-3A6A-9AC7-4FF004A9C4D3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78" creationId="{9A2184DD-2531-49D9-10A6-92664C6FCEBE}"/>
          </ac:spMkLst>
        </pc:spChg>
        <pc:spChg chg="add mod">
          <ac:chgData name="Reza Amini Hounejani" userId="36cb0b73-58b2-4568-a1ab-00cd49301806" providerId="ADAL" clId="{DA8FEA81-1A63-884F-A1C6-520C766F400F}" dt="2022-11-14T15:36:42.551" v="8382" actId="1076"/>
          <ac:spMkLst>
            <pc:docMk/>
            <pc:sldMk cId="1897538530" sldId="256"/>
            <ac:spMk id="178" creationId="{EC8B6BAE-3FC8-7D8D-3244-C67A0568E2CE}"/>
          </ac:spMkLst>
        </pc:spChg>
        <pc:spChg chg="add mod">
          <ac:chgData name="Reza Amini Hounejani" userId="36cb0b73-58b2-4568-a1ab-00cd49301806" providerId="ADAL" clId="{DA8FEA81-1A63-884F-A1C6-520C766F400F}" dt="2022-11-14T15:37:08.410" v="8387" actId="1038"/>
          <ac:spMkLst>
            <pc:docMk/>
            <pc:sldMk cId="1897538530" sldId="256"/>
            <ac:spMk id="179" creationId="{05A8C652-89B3-5CB3-78A2-FA0B442BA0B3}"/>
          </ac:spMkLst>
        </pc:spChg>
        <pc:spChg chg="add mod">
          <ac:chgData name="Reza Amini Hounejani" userId="36cb0b73-58b2-4568-a1ab-00cd49301806" providerId="ADAL" clId="{DA8FEA81-1A63-884F-A1C6-520C766F400F}" dt="2022-11-16T12:40:14.926" v="9060" actId="164"/>
          <ac:spMkLst>
            <pc:docMk/>
            <pc:sldMk cId="1897538530" sldId="256"/>
            <ac:spMk id="180" creationId="{9135A554-678B-8028-0E46-54D53ABDD4E1}"/>
          </ac:spMkLst>
        </pc:spChg>
        <pc:spChg chg="add del mod">
          <ac:chgData name="Reza Amini Hounejani" userId="36cb0b73-58b2-4568-a1ab-00cd49301806" providerId="ADAL" clId="{DA8FEA81-1A63-884F-A1C6-520C766F400F}" dt="2022-11-14T15:35:59.547" v="8374" actId="478"/>
          <ac:spMkLst>
            <pc:docMk/>
            <pc:sldMk cId="1897538530" sldId="256"/>
            <ac:spMk id="180" creationId="{A33C9E82-D314-B84C-4FAD-D89DCB354D26}"/>
          </ac:spMkLst>
        </pc:spChg>
        <pc:spChg chg="del mod topLvl">
          <ac:chgData name="Reza Amini Hounejani" userId="36cb0b73-58b2-4568-a1ab-00cd49301806" providerId="ADAL" clId="{DA8FEA81-1A63-884F-A1C6-520C766F400F}" dt="2022-11-09T11:29:54.958" v="7084" actId="478"/>
          <ac:spMkLst>
            <pc:docMk/>
            <pc:sldMk cId="1897538530" sldId="256"/>
            <ac:spMk id="180" creationId="{F270B9AF-65A7-3042-F8B3-9D0C678F094D}"/>
          </ac:spMkLst>
        </pc:spChg>
        <pc:spChg chg="del mod topLvl">
          <ac:chgData name="Reza Amini Hounejani" userId="36cb0b73-58b2-4568-a1ab-00cd49301806" providerId="ADAL" clId="{DA8FEA81-1A63-884F-A1C6-520C766F400F}" dt="2022-11-09T11:29:54.958" v="7084" actId="478"/>
          <ac:spMkLst>
            <pc:docMk/>
            <pc:sldMk cId="1897538530" sldId="256"/>
            <ac:spMk id="181" creationId="{16C0F124-4D31-DD33-124F-45E1602E4526}"/>
          </ac:spMkLst>
        </pc:spChg>
        <pc:spChg chg="add mod">
          <ac:chgData name="Reza Amini Hounejani" userId="36cb0b73-58b2-4568-a1ab-00cd49301806" providerId="ADAL" clId="{DA8FEA81-1A63-884F-A1C6-520C766F400F}" dt="2022-11-14T15:37:21.879" v="8391" actId="1035"/>
          <ac:spMkLst>
            <pc:docMk/>
            <pc:sldMk cId="1897538530" sldId="256"/>
            <ac:spMk id="181" creationId="{9D6417A4-F3D2-F324-9AAB-45092B7746EE}"/>
          </ac:spMkLst>
        </pc:spChg>
        <pc:spChg chg="add mod">
          <ac:chgData name="Reza Amini Hounejani" userId="36cb0b73-58b2-4568-a1ab-00cd49301806" providerId="ADAL" clId="{DA8FEA81-1A63-884F-A1C6-520C766F400F}" dt="2022-11-14T15:36:19.039" v="8378" actId="571"/>
          <ac:spMkLst>
            <pc:docMk/>
            <pc:sldMk cId="1897538530" sldId="256"/>
            <ac:spMk id="182" creationId="{E76EA02C-8EF7-0E48-8D29-407BF1092C19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82" creationId="{FB65F958-A454-B098-F9DE-1CFFDA0072B1}"/>
          </ac:spMkLst>
        </pc:spChg>
        <pc:spChg chg="add mod">
          <ac:chgData name="Reza Amini Hounejani" userId="36cb0b73-58b2-4568-a1ab-00cd49301806" providerId="ADAL" clId="{DA8FEA81-1A63-884F-A1C6-520C766F400F}" dt="2022-11-14T15:36:22.321" v="8379" actId="571"/>
          <ac:spMkLst>
            <pc:docMk/>
            <pc:sldMk cId="1897538530" sldId="256"/>
            <ac:spMk id="183" creationId="{08A010B0-05CA-DBCB-89BF-2806F03F2287}"/>
          </ac:spMkLst>
        </pc:spChg>
        <pc:spChg chg="del mod topLvl">
          <ac:chgData name="Reza Amini Hounejani" userId="36cb0b73-58b2-4568-a1ab-00cd49301806" providerId="ADAL" clId="{DA8FEA81-1A63-884F-A1C6-520C766F400F}" dt="2022-11-09T11:29:54.958" v="7084" actId="478"/>
          <ac:spMkLst>
            <pc:docMk/>
            <pc:sldMk cId="1897538530" sldId="256"/>
            <ac:spMk id="183" creationId="{E1B23F1D-27E6-D9D6-20E4-E1756F9CEAEC}"/>
          </ac:spMkLst>
        </pc:spChg>
        <pc:spChg chg="add mod">
          <ac:chgData name="Reza Amini Hounejani" userId="36cb0b73-58b2-4568-a1ab-00cd49301806" providerId="ADAL" clId="{DA8FEA81-1A63-884F-A1C6-520C766F400F}" dt="2022-11-14T15:36:26.056" v="8380" actId="571"/>
          <ac:spMkLst>
            <pc:docMk/>
            <pc:sldMk cId="1897538530" sldId="256"/>
            <ac:spMk id="184" creationId="{60DBEAC3-CE9D-12B7-E8E6-07F978AEAAA3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84" creationId="{DAD384CA-7AEF-181A-9A35-81FCA68B972B}"/>
          </ac:spMkLst>
        </pc:spChg>
        <pc:spChg chg="add del mod">
          <ac:chgData name="Reza Amini Hounejani" userId="36cb0b73-58b2-4568-a1ab-00cd49301806" providerId="ADAL" clId="{DA8FEA81-1A63-884F-A1C6-520C766F400F}" dt="2022-11-14T15:37:40.429" v="8392" actId="478"/>
          <ac:spMkLst>
            <pc:docMk/>
            <pc:sldMk cId="1897538530" sldId="256"/>
            <ac:spMk id="185" creationId="{5F217CE9-09CD-7E21-EFE7-BF597D5932AF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85" creationId="{C3493562-B2B9-5D44-EE76-2729B3B091E9}"/>
          </ac:spMkLst>
        </pc:spChg>
        <pc:spChg chg="add mod">
          <ac:chgData name="Reza Amini Hounejani" userId="36cb0b73-58b2-4568-a1ab-00cd49301806" providerId="ADAL" clId="{DA8FEA81-1A63-884F-A1C6-520C766F400F}" dt="2022-11-14T15:39:07.220" v="8429" actId="1037"/>
          <ac:spMkLst>
            <pc:docMk/>
            <pc:sldMk cId="1897538530" sldId="256"/>
            <ac:spMk id="186" creationId="{06259346-CF5D-64BE-325F-45D19D887EAC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86" creationId="{AA3DA8BC-F0CB-7FDE-A090-15DC9CA87A7E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87" creationId="{24A01503-948F-D3B4-FD6D-ED18CB78DAD9}"/>
          </ac:spMkLst>
        </pc:spChg>
        <pc:spChg chg="add mod">
          <ac:chgData name="Reza Amini Hounejani" userId="36cb0b73-58b2-4568-a1ab-00cd49301806" providerId="ADAL" clId="{DA8FEA81-1A63-884F-A1C6-520C766F400F}" dt="2022-11-14T15:39:07.220" v="8429" actId="1037"/>
          <ac:spMkLst>
            <pc:docMk/>
            <pc:sldMk cId="1897538530" sldId="256"/>
            <ac:spMk id="187" creationId="{96AFFBD7-39B7-E86D-A785-72231DB4332C}"/>
          </ac:spMkLst>
        </pc:spChg>
        <pc:spChg chg="add mod">
          <ac:chgData name="Reza Amini Hounejani" userId="36cb0b73-58b2-4568-a1ab-00cd49301806" providerId="ADAL" clId="{DA8FEA81-1A63-884F-A1C6-520C766F400F}" dt="2022-11-14T15:39:07.220" v="8429" actId="1037"/>
          <ac:spMkLst>
            <pc:docMk/>
            <pc:sldMk cId="1897538530" sldId="256"/>
            <ac:spMk id="188" creationId="{76F61939-1780-4F13-997D-4A4A057FC632}"/>
          </ac:spMkLst>
        </pc:spChg>
        <pc:spChg chg="del mod topLvl">
          <ac:chgData name="Reza Amini Hounejani" userId="36cb0b73-58b2-4568-a1ab-00cd49301806" providerId="ADAL" clId="{DA8FEA81-1A63-884F-A1C6-520C766F400F}" dt="2022-11-09T11:29:54.958" v="7084" actId="478"/>
          <ac:spMkLst>
            <pc:docMk/>
            <pc:sldMk cId="1897538530" sldId="256"/>
            <ac:spMk id="189" creationId="{7B83306E-F4C3-FEB6-D56C-3E57BF6387DD}"/>
          </ac:spMkLst>
        </pc:spChg>
        <pc:spChg chg="add mod">
          <ac:chgData name="Reza Amini Hounejani" userId="36cb0b73-58b2-4568-a1ab-00cd49301806" providerId="ADAL" clId="{DA8FEA81-1A63-884F-A1C6-520C766F400F}" dt="2022-11-14T15:39:15.395" v="8430" actId="1076"/>
          <ac:spMkLst>
            <pc:docMk/>
            <pc:sldMk cId="1897538530" sldId="256"/>
            <ac:spMk id="189" creationId="{B07F58FF-3534-6543-5763-C017D24EFBB4}"/>
          </ac:spMkLst>
        </pc:spChg>
        <pc:spChg chg="del mod topLvl">
          <ac:chgData name="Reza Amini Hounejani" userId="36cb0b73-58b2-4568-a1ab-00cd49301806" providerId="ADAL" clId="{DA8FEA81-1A63-884F-A1C6-520C766F400F}" dt="2022-11-09T11:29:54.958" v="7084" actId="478"/>
          <ac:spMkLst>
            <pc:docMk/>
            <pc:sldMk cId="1897538530" sldId="256"/>
            <ac:spMk id="190" creationId="{EA0B0776-A5A1-273A-7044-660F00C6FAF8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91" creationId="{9F7B69DB-B387-2A3B-A377-7491626D48CE}"/>
          </ac:spMkLst>
        </pc:spChg>
        <pc:spChg chg="del mod topLvl">
          <ac:chgData name="Reza Amini Hounejani" userId="36cb0b73-58b2-4568-a1ab-00cd49301806" providerId="ADAL" clId="{DA8FEA81-1A63-884F-A1C6-520C766F400F}" dt="2022-11-09T11:29:54.958" v="7084" actId="478"/>
          <ac:spMkLst>
            <pc:docMk/>
            <pc:sldMk cId="1897538530" sldId="256"/>
            <ac:spMk id="192" creationId="{6F686166-6F79-ED47-F82A-95F6FD5AC638}"/>
          </ac:spMkLst>
        </pc:spChg>
        <pc:spChg chg="add mod">
          <ac:chgData name="Reza Amini Hounejani" userId="36cb0b73-58b2-4568-a1ab-00cd49301806" providerId="ADAL" clId="{DA8FEA81-1A63-884F-A1C6-520C766F400F}" dt="2022-11-14T16:36:52.560" v="8692" actId="1076"/>
          <ac:spMkLst>
            <pc:docMk/>
            <pc:sldMk cId="1897538530" sldId="256"/>
            <ac:spMk id="193" creationId="{B8FA1EF2-4A43-6F53-C118-EC6B502FE8EB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93" creationId="{F8343A16-DADD-ADB9-970C-C1750ACDD591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94" creationId="{4828177A-7FC7-5F7E-EEFE-1CEC6133EF54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95" creationId="{BC316C6F-7897-2370-A690-9B6839B292FF}"/>
          </ac:spMkLst>
        </pc:spChg>
        <pc:spChg chg="del mod topLvl">
          <ac:chgData name="Reza Amini Hounejani" userId="36cb0b73-58b2-4568-a1ab-00cd49301806" providerId="ADAL" clId="{DA8FEA81-1A63-884F-A1C6-520C766F400F}" dt="2022-11-09T11:13:41.085" v="6947" actId="478"/>
          <ac:spMkLst>
            <pc:docMk/>
            <pc:sldMk cId="1897538530" sldId="256"/>
            <ac:spMk id="196" creationId="{37834776-0476-7FD0-EF6F-37792C2693E6}"/>
          </ac:spMkLst>
        </pc:spChg>
        <pc:spChg chg="add del mod">
          <ac:chgData name="Reza Amini Hounejani" userId="36cb0b73-58b2-4568-a1ab-00cd49301806" providerId="ADAL" clId="{DA8FEA81-1A63-884F-A1C6-520C766F400F}" dt="2022-11-16T12:39:03.690" v="9009" actId="478"/>
          <ac:spMkLst>
            <pc:docMk/>
            <pc:sldMk cId="1897538530" sldId="256"/>
            <ac:spMk id="198" creationId="{343C4BF4-D0ED-6252-2817-043BD2CE3172}"/>
          </ac:spMkLst>
        </pc:spChg>
        <pc:spChg chg="add mod">
          <ac:chgData name="Reza Amini Hounejani" userId="36cb0b73-58b2-4568-a1ab-00cd49301806" providerId="ADAL" clId="{DA8FEA81-1A63-884F-A1C6-520C766F400F}" dt="2022-11-09T11:17:11.141" v="6971" actId="1076"/>
          <ac:spMkLst>
            <pc:docMk/>
            <pc:sldMk cId="1897538530" sldId="256"/>
            <ac:spMk id="201" creationId="{D086E09D-4A34-21E3-5ECD-67CFF5519930}"/>
          </ac:spMkLst>
        </pc:spChg>
        <pc:spChg chg="add del mod">
          <ac:chgData name="Reza Amini Hounejani" userId="36cb0b73-58b2-4568-a1ab-00cd49301806" providerId="ADAL" clId="{DA8FEA81-1A63-884F-A1C6-520C766F400F}" dt="2022-11-09T11:29:54.958" v="7084" actId="478"/>
          <ac:spMkLst>
            <pc:docMk/>
            <pc:sldMk cId="1897538530" sldId="256"/>
            <ac:spMk id="202" creationId="{5A3538BF-1AD2-2E1D-E516-1EB6C56EAF62}"/>
          </ac:spMkLst>
        </pc:spChg>
        <pc:spChg chg="add del mod">
          <ac:chgData name="Reza Amini Hounejani" userId="36cb0b73-58b2-4568-a1ab-00cd49301806" providerId="ADAL" clId="{DA8FEA81-1A63-884F-A1C6-520C766F400F}" dt="2022-11-09T11:29:54.958" v="7084" actId="478"/>
          <ac:spMkLst>
            <pc:docMk/>
            <pc:sldMk cId="1897538530" sldId="256"/>
            <ac:spMk id="203" creationId="{F754BD95-3CDF-309F-9A0C-FEB429E7BD51}"/>
          </ac:spMkLst>
        </pc:spChg>
        <pc:spChg chg="add del mod">
          <ac:chgData name="Reza Amini Hounejani" userId="36cb0b73-58b2-4568-a1ab-00cd49301806" providerId="ADAL" clId="{DA8FEA81-1A63-884F-A1C6-520C766F400F}" dt="2022-11-09T11:29:54.958" v="7084" actId="478"/>
          <ac:spMkLst>
            <pc:docMk/>
            <pc:sldMk cId="1897538530" sldId="256"/>
            <ac:spMk id="204" creationId="{1A76BC34-999B-A4B6-07EC-EB6DAB6DCF42}"/>
          </ac:spMkLst>
        </pc:spChg>
        <pc:spChg chg="add mod">
          <ac:chgData name="Reza Amini Hounejani" userId="36cb0b73-58b2-4568-a1ab-00cd49301806" providerId="ADAL" clId="{DA8FEA81-1A63-884F-A1C6-520C766F400F}" dt="2022-11-09T11:21:02.091" v="6992" actId="164"/>
          <ac:spMkLst>
            <pc:docMk/>
            <pc:sldMk cId="1897538530" sldId="256"/>
            <ac:spMk id="205" creationId="{84FADAC6-D1F6-E89F-7871-4FE951DB32CC}"/>
          </ac:spMkLst>
        </pc:spChg>
        <pc:spChg chg="add mod">
          <ac:chgData name="Reza Amini Hounejani" userId="36cb0b73-58b2-4568-a1ab-00cd49301806" providerId="ADAL" clId="{DA8FEA81-1A63-884F-A1C6-520C766F400F}" dt="2022-11-09T11:20:53.706" v="6990" actId="164"/>
          <ac:spMkLst>
            <pc:docMk/>
            <pc:sldMk cId="1897538530" sldId="256"/>
            <ac:spMk id="206" creationId="{C6E410B1-5768-B759-699E-41EF7574D8A4}"/>
          </ac:spMkLst>
        </pc:spChg>
        <pc:spChg chg="add mod">
          <ac:chgData name="Reza Amini Hounejani" userId="36cb0b73-58b2-4568-a1ab-00cd49301806" providerId="ADAL" clId="{DA8FEA81-1A63-884F-A1C6-520C766F400F}" dt="2022-11-09T11:20:53.706" v="6990" actId="164"/>
          <ac:spMkLst>
            <pc:docMk/>
            <pc:sldMk cId="1897538530" sldId="256"/>
            <ac:spMk id="207" creationId="{CE054E0A-7D2A-2574-ABB6-B378B82A3B79}"/>
          </ac:spMkLst>
        </pc:spChg>
        <pc:spChg chg="add mod">
          <ac:chgData name="Reza Amini Hounejani" userId="36cb0b73-58b2-4568-a1ab-00cd49301806" providerId="ADAL" clId="{DA8FEA81-1A63-884F-A1C6-520C766F400F}" dt="2022-11-09T11:21:02.091" v="6992" actId="164"/>
          <ac:spMkLst>
            <pc:docMk/>
            <pc:sldMk cId="1897538530" sldId="256"/>
            <ac:spMk id="208" creationId="{1A1F34CF-46B8-B938-BAB6-B334E0A1F004}"/>
          </ac:spMkLst>
        </pc:spChg>
        <pc:spChg chg="add del mod">
          <ac:chgData name="Reza Amini Hounejani" userId="36cb0b73-58b2-4568-a1ab-00cd49301806" providerId="ADAL" clId="{DA8FEA81-1A63-884F-A1C6-520C766F400F}" dt="2022-11-09T11:24:36.928" v="7032" actId="478"/>
          <ac:spMkLst>
            <pc:docMk/>
            <pc:sldMk cId="1897538530" sldId="256"/>
            <ac:spMk id="230" creationId="{E7634A6F-1FC6-2D8F-A8D3-1C3DF8A36C25}"/>
          </ac:spMkLst>
        </pc:spChg>
        <pc:spChg chg="add del mod">
          <ac:chgData name="Reza Amini Hounejani" userId="36cb0b73-58b2-4568-a1ab-00cd49301806" providerId="ADAL" clId="{DA8FEA81-1A63-884F-A1C6-520C766F400F}" dt="2022-11-09T11:24:12.006" v="7029" actId="478"/>
          <ac:spMkLst>
            <pc:docMk/>
            <pc:sldMk cId="1897538530" sldId="256"/>
            <ac:spMk id="231" creationId="{10975A7B-505C-64D3-3571-42AE95B88D51}"/>
          </ac:spMkLst>
        </pc:spChg>
        <pc:spChg chg="add del">
          <ac:chgData name="Reza Amini Hounejani" userId="36cb0b73-58b2-4568-a1ab-00cd49301806" providerId="ADAL" clId="{DA8FEA81-1A63-884F-A1C6-520C766F400F}" dt="2022-11-09T11:24:36.064" v="7031" actId="478"/>
          <ac:spMkLst>
            <pc:docMk/>
            <pc:sldMk cId="1897538530" sldId="256"/>
            <ac:spMk id="232" creationId="{CD3B20B7-EE86-A280-4885-F358003692F6}"/>
          </ac:spMkLst>
        </pc:spChg>
        <pc:spChg chg="add del mod">
          <ac:chgData name="Reza Amini Hounejani" userId="36cb0b73-58b2-4568-a1ab-00cd49301806" providerId="ADAL" clId="{DA8FEA81-1A63-884F-A1C6-520C766F400F}" dt="2022-11-09T11:30:16.637" v="7093" actId="478"/>
          <ac:spMkLst>
            <pc:docMk/>
            <pc:sldMk cId="1897538530" sldId="256"/>
            <ac:spMk id="236" creationId="{C8E3A56C-3840-B284-6EF2-11B73A394EBB}"/>
          </ac:spMkLst>
        </pc:spChg>
        <pc:spChg chg="del mod">
          <ac:chgData name="Reza Amini Hounejani" userId="36cb0b73-58b2-4568-a1ab-00cd49301806" providerId="ADAL" clId="{DA8FEA81-1A63-884F-A1C6-520C766F400F}" dt="2022-11-09T11:31:41.236" v="7106" actId="478"/>
          <ac:spMkLst>
            <pc:docMk/>
            <pc:sldMk cId="1897538530" sldId="256"/>
            <ac:spMk id="238" creationId="{14E4DB28-B98C-F9EE-603D-676769B274ED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39" creationId="{86CE6CE8-BF9C-1E1A-EC12-6A70BDAB7E48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40" creationId="{BC34DDC1-32B3-037C-B89A-5FB7EB4C1E94}"/>
          </ac:spMkLst>
        </pc:spChg>
        <pc:spChg chg="del mod">
          <ac:chgData name="Reza Amini Hounejani" userId="36cb0b73-58b2-4568-a1ab-00cd49301806" providerId="ADAL" clId="{DA8FEA81-1A63-884F-A1C6-520C766F400F}" dt="2022-11-09T11:31:47.715" v="7109" actId="478"/>
          <ac:spMkLst>
            <pc:docMk/>
            <pc:sldMk cId="1897538530" sldId="256"/>
            <ac:spMk id="241" creationId="{79C6E83E-1037-3F20-9D33-5883CF013DE3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42" creationId="{06F05550-8D63-D340-63B9-2EB2E57CB86D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43" creationId="{2E9D3970-ADD0-18A4-0550-17D715B23B7B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44" creationId="{A0749B26-F8F3-068F-6644-E9476302B522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45" creationId="{08C1F9F5-5728-7A85-3705-6350E8C05D81}"/>
          </ac:spMkLst>
        </pc:spChg>
        <pc:spChg chg="del mod">
          <ac:chgData name="Reza Amini Hounejani" userId="36cb0b73-58b2-4568-a1ab-00cd49301806" providerId="ADAL" clId="{DA8FEA81-1A63-884F-A1C6-520C766F400F}" dt="2022-11-09T11:31:42.664" v="7107" actId="478"/>
          <ac:spMkLst>
            <pc:docMk/>
            <pc:sldMk cId="1897538530" sldId="256"/>
            <ac:spMk id="247" creationId="{E0516B08-5EB0-23B4-360F-8FCF56D6749C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48" creationId="{1E269BD0-5894-16A3-D669-612AFA0214C1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49" creationId="{E51B0D72-030D-47C0-750D-58C6AC1AF46E}"/>
          </ac:spMkLst>
        </pc:spChg>
        <pc:spChg chg="del mod">
          <ac:chgData name="Reza Amini Hounejani" userId="36cb0b73-58b2-4568-a1ab-00cd49301806" providerId="ADAL" clId="{DA8FEA81-1A63-884F-A1C6-520C766F400F}" dt="2022-11-09T11:31:51.266" v="7110" actId="478"/>
          <ac:spMkLst>
            <pc:docMk/>
            <pc:sldMk cId="1897538530" sldId="256"/>
            <ac:spMk id="250" creationId="{5C746C9A-106D-56EF-4C71-DFD14D04068E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51" creationId="{2A908B53-5ADB-D846-1B78-B2DF3CEEEB20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52" creationId="{CDFC08AA-BC8A-1E59-1E68-8170385D9959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53" creationId="{ACFA4FB4-DF23-6905-3E63-6615765EFF75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54" creationId="{5BA21E30-4676-6D38-A891-C86848244BF5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60" creationId="{92EE5311-D78B-AB16-C439-6CF4A9039E41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61" creationId="{BB5427DA-D2EC-7E15-8B4F-381C7AB0BA70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62" creationId="{EA08449A-5DFE-58B2-998D-63C7EB91696F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63" creationId="{67417682-E3D7-5A62-7DB8-DE9299B2FA8C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64" creationId="{5ED4F4DF-09EC-3D21-19C7-1ACAE7729086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65" creationId="{60EC9568-DA6E-B886-AC13-5B26EFE8FB3B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66" creationId="{75367333-0AEE-5E3B-4CA8-96E4D41EEBA8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67" creationId="{B7498EF5-6BBB-2F7A-5B7F-D54C76DE5006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68" creationId="{AC79B676-3894-11BF-0EA0-6EF83703BDDA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69" creationId="{E4394C75-5AF8-4C1E-17F4-2504B722CAB6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70" creationId="{3C4BDB35-153B-B53D-CCFD-4B33EF456929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71" creationId="{4B8736C7-A9C3-FB95-3731-2554BDF3EC88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72" creationId="{E5356A77-64B2-EF04-B0C5-3401C868BADF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73" creationId="{72C444A6-7E56-084D-84B9-BD3F6CA05A0A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74" creationId="{7FD51230-736D-FD27-E418-360142226214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75" creationId="{4741DA92-EE96-A62D-7978-EA456A8BBB2D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76" creationId="{319A7A6D-8022-34F3-221C-9BFDD15B14F7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77" creationId="{B9C70BD2-DD83-5701-D205-7802E449D467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78" creationId="{E8C0019F-7E78-8B23-7772-5E2E53506CEF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79" creationId="{CA87FFCC-580C-53F8-240B-AE2AFA1BC4D4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80" creationId="{E8444213-494F-B497-3214-E10324315573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81" creationId="{FD61D101-D6C7-EFCE-6FEC-0B97031B6AD5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82" creationId="{04EA1785-3960-8CB4-FB46-BA448931BA70}"/>
          </ac:spMkLst>
        </pc:spChg>
        <pc:spChg chg="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83" creationId="{32C9789D-FE71-4DE8-94C4-B890B65DF212}"/>
          </ac:spMkLst>
        </pc:spChg>
        <pc:spChg chg="add 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84" creationId="{50A626DB-A0F4-E1EB-33C7-7BB712326C61}"/>
          </ac:spMkLst>
        </pc:spChg>
        <pc:spChg chg="add 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85" creationId="{D94EE163-437F-7222-73DC-CB85692B71F5}"/>
          </ac:spMkLst>
        </pc:spChg>
        <pc:spChg chg="add 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86" creationId="{2D82305E-D1ED-B98A-F804-04A40866DABB}"/>
          </ac:spMkLst>
        </pc:spChg>
        <pc:spChg chg="add 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87" creationId="{0BC9BB68-D1E9-E63C-9BF2-290484C7582F}"/>
          </ac:spMkLst>
        </pc:spChg>
        <pc:spChg chg="add 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88" creationId="{6A95CEA6-FF84-6E82-DF78-E3E7C4486CC4}"/>
          </ac:spMkLst>
        </pc:spChg>
        <pc:spChg chg="add mod">
          <ac:chgData name="Reza Amini Hounejani" userId="36cb0b73-58b2-4568-a1ab-00cd49301806" providerId="ADAL" clId="{DA8FEA81-1A63-884F-A1C6-520C766F400F}" dt="2022-11-14T16:32:11.399" v="8669" actId="1582"/>
          <ac:spMkLst>
            <pc:docMk/>
            <pc:sldMk cId="1897538530" sldId="256"/>
            <ac:spMk id="289" creationId="{C356052D-5840-50AE-FEE2-6BE2E44D93A0}"/>
          </ac:spMkLst>
        </pc:spChg>
        <pc:grpChg chg="mod">
          <ac:chgData name="Reza Amini Hounejani" userId="36cb0b73-58b2-4568-a1ab-00cd49301806" providerId="ADAL" clId="{DA8FEA81-1A63-884F-A1C6-520C766F400F}" dt="2022-11-16T12:38:27.132" v="8998" actId="571"/>
          <ac:grpSpMkLst>
            <pc:docMk/>
            <pc:sldMk cId="1897538530" sldId="256"/>
            <ac:grpSpMk id="15" creationId="{0E0DE539-0821-FBD5-DDB3-8D36051C8870}"/>
          </ac:grpSpMkLst>
        </pc:grpChg>
        <pc:grpChg chg="add mod topLvl">
          <ac:chgData name="Reza Amini Hounejani" userId="36cb0b73-58b2-4568-a1ab-00cd49301806" providerId="ADAL" clId="{DA8FEA81-1A63-884F-A1C6-520C766F400F}" dt="2022-11-14T15:40:23.734" v="8434" actId="165"/>
          <ac:grpSpMkLst>
            <pc:docMk/>
            <pc:sldMk cId="1897538530" sldId="256"/>
            <ac:grpSpMk id="25" creationId="{7F9EE5FB-F629-164B-E719-2BE11F30C057}"/>
          </ac:grpSpMkLst>
        </pc:grpChg>
        <pc:grpChg chg="mod">
          <ac:chgData name="Reza Amini Hounejani" userId="36cb0b73-58b2-4568-a1ab-00cd49301806" providerId="ADAL" clId="{DA8FEA81-1A63-884F-A1C6-520C766F400F}" dt="2022-07-26T11:39:44.450" v="116" actId="1037"/>
          <ac:grpSpMkLst>
            <pc:docMk/>
            <pc:sldMk cId="1897538530" sldId="256"/>
            <ac:grpSpMk id="27" creationId="{5A30EF21-C5F4-DDFF-FBC7-2AD949288FC4}"/>
          </ac:grpSpMkLst>
        </pc:grpChg>
        <pc:grpChg chg="mod">
          <ac:chgData name="Reza Amini Hounejani" userId="36cb0b73-58b2-4568-a1ab-00cd49301806" providerId="ADAL" clId="{DA8FEA81-1A63-884F-A1C6-520C766F400F}" dt="2022-09-12T17:10:45.263" v="2292" actId="164"/>
          <ac:grpSpMkLst>
            <pc:docMk/>
            <pc:sldMk cId="1897538530" sldId="256"/>
            <ac:grpSpMk id="30" creationId="{3888149E-BC7A-4F05-1EED-717EB2D18C3C}"/>
          </ac:grpSpMkLst>
        </pc:grpChg>
        <pc:grpChg chg="add mod">
          <ac:chgData name="Reza Amini Hounejani" userId="36cb0b73-58b2-4568-a1ab-00cd49301806" providerId="ADAL" clId="{DA8FEA81-1A63-884F-A1C6-520C766F400F}" dt="2022-11-16T12:40:14.926" v="9060" actId="164"/>
          <ac:grpSpMkLst>
            <pc:docMk/>
            <pc:sldMk cId="1897538530" sldId="256"/>
            <ac:grpSpMk id="31" creationId="{B7714048-14E7-562F-54FF-0EF23EA56E6C}"/>
          </ac:grpSpMkLst>
        </pc:grpChg>
        <pc:grpChg chg="add mod">
          <ac:chgData name="Reza Amini Hounejani" userId="36cb0b73-58b2-4568-a1ab-00cd49301806" providerId="ADAL" clId="{DA8FEA81-1A63-884F-A1C6-520C766F400F}" dt="2022-11-16T12:38:20.352" v="8996" actId="571"/>
          <ac:grpSpMkLst>
            <pc:docMk/>
            <pc:sldMk cId="1897538530" sldId="256"/>
            <ac:grpSpMk id="34" creationId="{D1DEF3DC-27B9-D4AD-BF50-2747E237BC90}"/>
          </ac:grpSpMkLst>
        </pc:grpChg>
        <pc:grpChg chg="add mod topLvl">
          <ac:chgData name="Reza Amini Hounejani" userId="36cb0b73-58b2-4568-a1ab-00cd49301806" providerId="ADAL" clId="{DA8FEA81-1A63-884F-A1C6-520C766F400F}" dt="2022-11-14T15:40:23.734" v="8434" actId="165"/>
          <ac:grpSpMkLst>
            <pc:docMk/>
            <pc:sldMk cId="1897538530" sldId="256"/>
            <ac:grpSpMk id="41" creationId="{FDF97C71-A051-3542-C955-2A7BF299EADC}"/>
          </ac:grpSpMkLst>
        </pc:grpChg>
        <pc:grpChg chg="add del mod topLvl">
          <ac:chgData name="Reza Amini Hounejani" userId="36cb0b73-58b2-4568-a1ab-00cd49301806" providerId="ADAL" clId="{DA8FEA81-1A63-884F-A1C6-520C766F400F}" dt="2022-11-09T11:29:04.480" v="7074" actId="478"/>
          <ac:grpSpMkLst>
            <pc:docMk/>
            <pc:sldMk cId="1897538530" sldId="256"/>
            <ac:grpSpMk id="44" creationId="{11F125C8-DC6F-F353-E9FD-AD095D78E15A}"/>
          </ac:grpSpMkLst>
        </pc:grpChg>
        <pc:grpChg chg="add mod">
          <ac:chgData name="Reza Amini Hounejani" userId="36cb0b73-58b2-4568-a1ab-00cd49301806" providerId="ADAL" clId="{DA8FEA81-1A63-884F-A1C6-520C766F400F}" dt="2022-11-14T15:40:23.734" v="8434" actId="165"/>
          <ac:grpSpMkLst>
            <pc:docMk/>
            <pc:sldMk cId="1897538530" sldId="256"/>
            <ac:grpSpMk id="48" creationId="{F9B1E01A-7F7C-C614-3C19-C9D897AB0A55}"/>
          </ac:grpSpMkLst>
        </pc:grpChg>
        <pc:grpChg chg="add del mod">
          <ac:chgData name="Reza Amini Hounejani" userId="36cb0b73-58b2-4568-a1ab-00cd49301806" providerId="ADAL" clId="{DA8FEA81-1A63-884F-A1C6-520C766F400F}" dt="2022-09-30T14:06:48.092" v="3214" actId="165"/>
          <ac:grpSpMkLst>
            <pc:docMk/>
            <pc:sldMk cId="1897538530" sldId="256"/>
            <ac:grpSpMk id="51" creationId="{46C2A38E-B780-76C6-E49E-0C103A01FC8B}"/>
          </ac:grpSpMkLst>
        </pc:grpChg>
        <pc:grpChg chg="add del mod topLvl">
          <ac:chgData name="Reza Amini Hounejani" userId="36cb0b73-58b2-4568-a1ab-00cd49301806" providerId="ADAL" clId="{DA8FEA81-1A63-884F-A1C6-520C766F400F}" dt="2022-11-09T11:29:05.390" v="7075" actId="478"/>
          <ac:grpSpMkLst>
            <pc:docMk/>
            <pc:sldMk cId="1897538530" sldId="256"/>
            <ac:grpSpMk id="57" creationId="{53013AC1-738B-F512-AC85-52B1C3576EFE}"/>
          </ac:grpSpMkLst>
        </pc:grpChg>
        <pc:grpChg chg="add mod">
          <ac:chgData name="Reza Amini Hounejani" userId="36cb0b73-58b2-4568-a1ab-00cd49301806" providerId="ADAL" clId="{DA8FEA81-1A63-884F-A1C6-520C766F400F}" dt="2022-11-14T15:40:23.734" v="8434" actId="165"/>
          <ac:grpSpMkLst>
            <pc:docMk/>
            <pc:sldMk cId="1897538530" sldId="256"/>
            <ac:grpSpMk id="65" creationId="{28A3E376-86B7-D3FD-289E-E04C845DA875}"/>
          </ac:grpSpMkLst>
        </pc:grpChg>
        <pc:grpChg chg="add mod">
          <ac:chgData name="Reza Amini Hounejani" userId="36cb0b73-58b2-4568-a1ab-00cd49301806" providerId="ADAL" clId="{DA8FEA81-1A63-884F-A1C6-520C766F400F}" dt="2022-11-09T11:17:29.255" v="6973" actId="165"/>
          <ac:grpSpMkLst>
            <pc:docMk/>
            <pc:sldMk cId="1897538530" sldId="256"/>
            <ac:grpSpMk id="83" creationId="{A03C9485-8829-A809-525D-1D83D6C121A2}"/>
          </ac:grpSpMkLst>
        </pc:grpChg>
        <pc:grpChg chg="add mod topLvl">
          <ac:chgData name="Reza Amini Hounejani" userId="36cb0b73-58b2-4568-a1ab-00cd49301806" providerId="ADAL" clId="{DA8FEA81-1A63-884F-A1C6-520C766F400F}" dt="2022-11-14T15:40:23.734" v="8434" actId="165"/>
          <ac:grpSpMkLst>
            <pc:docMk/>
            <pc:sldMk cId="1897538530" sldId="256"/>
            <ac:grpSpMk id="83" creationId="{B577A026-D897-EF8E-2082-19523D32CA18}"/>
          </ac:grpSpMkLst>
        </pc:grpChg>
        <pc:grpChg chg="add del mod">
          <ac:chgData name="Reza Amini Hounejani" userId="36cb0b73-58b2-4568-a1ab-00cd49301806" providerId="ADAL" clId="{DA8FEA81-1A63-884F-A1C6-520C766F400F}" dt="2022-11-14T15:40:23.734" v="8434" actId="165"/>
          <ac:grpSpMkLst>
            <pc:docMk/>
            <pc:sldMk cId="1897538530" sldId="256"/>
            <ac:grpSpMk id="88" creationId="{E3D3DB03-CC8E-9E23-E6B1-8A4943C34745}"/>
          </ac:grpSpMkLst>
        </pc:grpChg>
        <pc:grpChg chg="add mod">
          <ac:chgData name="Reza Amini Hounejani" userId="36cb0b73-58b2-4568-a1ab-00cd49301806" providerId="ADAL" clId="{DA8FEA81-1A63-884F-A1C6-520C766F400F}" dt="2022-11-09T11:17:29.255" v="6973" actId="165"/>
          <ac:grpSpMkLst>
            <pc:docMk/>
            <pc:sldMk cId="1897538530" sldId="256"/>
            <ac:grpSpMk id="105" creationId="{C7FE950E-679E-B12C-B4B9-AD2995A246BD}"/>
          </ac:grpSpMkLst>
        </pc:grpChg>
        <pc:grpChg chg="add mod">
          <ac:chgData name="Reza Amini Hounejani" userId="36cb0b73-58b2-4568-a1ab-00cd49301806" providerId="ADAL" clId="{DA8FEA81-1A63-884F-A1C6-520C766F400F}" dt="2022-11-09T11:17:29.255" v="6973" actId="165"/>
          <ac:grpSpMkLst>
            <pc:docMk/>
            <pc:sldMk cId="1897538530" sldId="256"/>
            <ac:grpSpMk id="158" creationId="{91474864-AB18-4CA6-508B-7734099226B6}"/>
          </ac:grpSpMkLst>
        </pc:grpChg>
        <pc:grpChg chg="add del mod">
          <ac:chgData name="Reza Amini Hounejani" userId="36cb0b73-58b2-4568-a1ab-00cd49301806" providerId="ADAL" clId="{DA8FEA81-1A63-884F-A1C6-520C766F400F}" dt="2022-11-09T11:13:35.317" v="6946" actId="165"/>
          <ac:grpSpMkLst>
            <pc:docMk/>
            <pc:sldMk cId="1897538530" sldId="256"/>
            <ac:grpSpMk id="170" creationId="{00C962B3-B3E3-B8FB-AF30-7AD81BEFEB5C}"/>
          </ac:grpSpMkLst>
        </pc:grpChg>
        <pc:grpChg chg="add del mod">
          <ac:chgData name="Reza Amini Hounejani" userId="36cb0b73-58b2-4568-a1ab-00cd49301806" providerId="ADAL" clId="{DA8FEA81-1A63-884F-A1C6-520C766F400F}" dt="2022-11-09T11:13:35.317" v="6946" actId="165"/>
          <ac:grpSpMkLst>
            <pc:docMk/>
            <pc:sldMk cId="1897538530" sldId="256"/>
            <ac:grpSpMk id="179" creationId="{2D9CF2BA-53A4-7FED-7C1B-53D471528A12}"/>
          </ac:grpSpMkLst>
        </pc:grpChg>
        <pc:grpChg chg="add mod">
          <ac:chgData name="Reza Amini Hounejani" userId="36cb0b73-58b2-4568-a1ab-00cd49301806" providerId="ADAL" clId="{DA8FEA81-1A63-884F-A1C6-520C766F400F}" dt="2022-11-16T12:40:14.926" v="9060" actId="164"/>
          <ac:grpSpMkLst>
            <pc:docMk/>
            <pc:sldMk cId="1897538530" sldId="256"/>
            <ac:grpSpMk id="185" creationId="{1D2B04C5-B583-998D-193E-03D7A8BA57B3}"/>
          </ac:grpSpMkLst>
        </pc:grpChg>
        <pc:grpChg chg="add del mod">
          <ac:chgData name="Reza Amini Hounejani" userId="36cb0b73-58b2-4568-a1ab-00cd49301806" providerId="ADAL" clId="{DA8FEA81-1A63-884F-A1C6-520C766F400F}" dt="2022-11-09T11:13:30.579" v="6945" actId="165"/>
          <ac:grpSpMkLst>
            <pc:docMk/>
            <pc:sldMk cId="1897538530" sldId="256"/>
            <ac:grpSpMk id="188" creationId="{A9AEE8CD-93BE-AFF9-73B2-B25F97748525}"/>
          </ac:grpSpMkLst>
        </pc:grpChg>
        <pc:grpChg chg="add del mod topLvl">
          <ac:chgData name="Reza Amini Hounejani" userId="36cb0b73-58b2-4568-a1ab-00cd49301806" providerId="ADAL" clId="{DA8FEA81-1A63-884F-A1C6-520C766F400F}" dt="2022-11-09T11:18:55.452" v="6980" actId="165"/>
          <ac:grpSpMkLst>
            <pc:docMk/>
            <pc:sldMk cId="1897538530" sldId="256"/>
            <ac:grpSpMk id="197" creationId="{A1F8410D-7EC6-4A9F-EF90-6FBC32FDD26C}"/>
          </ac:grpSpMkLst>
        </pc:grpChg>
        <pc:grpChg chg="add del mod topLvl">
          <ac:chgData name="Reza Amini Hounejani" userId="36cb0b73-58b2-4568-a1ab-00cd49301806" providerId="ADAL" clId="{DA8FEA81-1A63-884F-A1C6-520C766F400F}" dt="2022-11-09T11:29:00.844" v="7073" actId="165"/>
          <ac:grpSpMkLst>
            <pc:docMk/>
            <pc:sldMk cId="1897538530" sldId="256"/>
            <ac:grpSpMk id="198" creationId="{FAF37CA8-8345-25CB-3608-714AA920C104}"/>
          </ac:grpSpMkLst>
        </pc:grpChg>
        <pc:grpChg chg="add del mod topLvl">
          <ac:chgData name="Reza Amini Hounejani" userId="36cb0b73-58b2-4568-a1ab-00cd49301806" providerId="ADAL" clId="{DA8FEA81-1A63-884F-A1C6-520C766F400F}" dt="2022-11-09T11:29:48.477" v="7083" actId="478"/>
          <ac:grpSpMkLst>
            <pc:docMk/>
            <pc:sldMk cId="1897538530" sldId="256"/>
            <ac:grpSpMk id="199" creationId="{6E716DD2-158E-DAFA-BA33-718701BEC16B}"/>
          </ac:grpSpMkLst>
        </pc:grpChg>
        <pc:grpChg chg="add del mod">
          <ac:chgData name="Reza Amini Hounejani" userId="36cb0b73-58b2-4568-a1ab-00cd49301806" providerId="ADAL" clId="{DA8FEA81-1A63-884F-A1C6-520C766F400F}" dt="2022-11-09T11:17:29.255" v="6973" actId="165"/>
          <ac:grpSpMkLst>
            <pc:docMk/>
            <pc:sldMk cId="1897538530" sldId="256"/>
            <ac:grpSpMk id="200" creationId="{4ADD5E39-11F3-FC21-9ECC-20963640C6F3}"/>
          </ac:grpSpMkLst>
        </pc:grpChg>
        <pc:grpChg chg="add del mod">
          <ac:chgData name="Reza Amini Hounejani" userId="36cb0b73-58b2-4568-a1ab-00cd49301806" providerId="ADAL" clId="{DA8FEA81-1A63-884F-A1C6-520C766F400F}" dt="2022-11-09T11:30:16.637" v="7093" actId="478"/>
          <ac:grpSpMkLst>
            <pc:docMk/>
            <pc:sldMk cId="1897538530" sldId="256"/>
            <ac:grpSpMk id="209" creationId="{D75A4479-4FFC-6A77-9EDD-0DC57C49F963}"/>
          </ac:grpSpMkLst>
        </pc:grpChg>
        <pc:grpChg chg="add del mod">
          <ac:chgData name="Reza Amini Hounejani" userId="36cb0b73-58b2-4568-a1ab-00cd49301806" providerId="ADAL" clId="{DA8FEA81-1A63-884F-A1C6-520C766F400F}" dt="2022-11-09T11:30:16.637" v="7093" actId="478"/>
          <ac:grpSpMkLst>
            <pc:docMk/>
            <pc:sldMk cId="1897538530" sldId="256"/>
            <ac:grpSpMk id="210" creationId="{A86039E9-5A38-E6B5-C5BD-EBCFC5084C61}"/>
          </ac:grpSpMkLst>
        </pc:grpChg>
        <pc:grpChg chg="add mod topLvl">
          <ac:chgData name="Reza Amini Hounejani" userId="36cb0b73-58b2-4568-a1ab-00cd49301806" providerId="ADAL" clId="{DA8FEA81-1A63-884F-A1C6-520C766F400F}" dt="2022-11-14T15:40:23.734" v="8434" actId="165"/>
          <ac:grpSpMkLst>
            <pc:docMk/>
            <pc:sldMk cId="1897538530" sldId="256"/>
            <ac:grpSpMk id="237" creationId="{FAA9788B-B34A-65A1-8482-AE16185BA6C5}"/>
          </ac:grpSpMkLst>
        </pc:grpChg>
        <pc:grpChg chg="add mod topLvl">
          <ac:chgData name="Reza Amini Hounejani" userId="36cb0b73-58b2-4568-a1ab-00cd49301806" providerId="ADAL" clId="{DA8FEA81-1A63-884F-A1C6-520C766F400F}" dt="2022-11-14T15:40:23.734" v="8434" actId="165"/>
          <ac:grpSpMkLst>
            <pc:docMk/>
            <pc:sldMk cId="1897538530" sldId="256"/>
            <ac:grpSpMk id="246" creationId="{EAB89FE0-B730-75F1-5F69-151EFD0C1591}"/>
          </ac:grpSpMkLst>
        </pc:grpChg>
        <pc:grpChg chg="add del mod topLvl">
          <ac:chgData name="Reza Amini Hounejani" userId="36cb0b73-58b2-4568-a1ab-00cd49301806" providerId="ADAL" clId="{DA8FEA81-1A63-884F-A1C6-520C766F400F}" dt="2022-11-10T11:07:39.038" v="7422" actId="165"/>
          <ac:grpSpMkLst>
            <pc:docMk/>
            <pc:sldMk cId="1897538530" sldId="256"/>
            <ac:grpSpMk id="255" creationId="{8F1137D6-AE1B-8306-CBA1-E3C4486A0F30}"/>
          </ac:grpSpMkLst>
        </pc:grpChg>
        <pc:grpChg chg="add mod topLvl">
          <ac:chgData name="Reza Amini Hounejani" userId="36cb0b73-58b2-4568-a1ab-00cd49301806" providerId="ADAL" clId="{DA8FEA81-1A63-884F-A1C6-520C766F400F}" dt="2022-11-14T15:40:23.734" v="8434" actId="165"/>
          <ac:grpSpMkLst>
            <pc:docMk/>
            <pc:sldMk cId="1897538530" sldId="256"/>
            <ac:grpSpMk id="256" creationId="{06913B3E-C8B0-2DD3-D3DC-E79B77CCDCDF}"/>
          </ac:grpSpMkLst>
        </pc:grpChg>
        <pc:grpChg chg="mod">
          <ac:chgData name="Reza Amini Hounejani" userId="36cb0b73-58b2-4568-a1ab-00cd49301806" providerId="ADAL" clId="{DA8FEA81-1A63-884F-A1C6-520C766F400F}" dt="2022-11-14T15:40:23.734" v="8434" actId="165"/>
          <ac:grpSpMkLst>
            <pc:docMk/>
            <pc:sldMk cId="1897538530" sldId="256"/>
            <ac:grpSpMk id="257" creationId="{2949B78A-5813-4764-3D74-ED2A8BFEEBE9}"/>
          </ac:grpSpMkLst>
        </pc:grpChg>
        <pc:grpChg chg="mod">
          <ac:chgData name="Reza Amini Hounejani" userId="36cb0b73-58b2-4568-a1ab-00cd49301806" providerId="ADAL" clId="{DA8FEA81-1A63-884F-A1C6-520C766F400F}" dt="2022-11-14T15:40:23.734" v="8434" actId="165"/>
          <ac:grpSpMkLst>
            <pc:docMk/>
            <pc:sldMk cId="1897538530" sldId="256"/>
            <ac:grpSpMk id="258" creationId="{46F18E08-CF35-6CA2-1317-9848DFD5F4DE}"/>
          </ac:grpSpMkLst>
        </pc:grpChg>
        <pc:grpChg chg="mod">
          <ac:chgData name="Reza Amini Hounejani" userId="36cb0b73-58b2-4568-a1ab-00cd49301806" providerId="ADAL" clId="{DA8FEA81-1A63-884F-A1C6-520C766F400F}" dt="2022-11-14T15:40:23.734" v="8434" actId="165"/>
          <ac:grpSpMkLst>
            <pc:docMk/>
            <pc:sldMk cId="1897538530" sldId="256"/>
            <ac:grpSpMk id="259" creationId="{17D39B8B-7973-6313-342A-80467A0C1B9F}"/>
          </ac:grpSpMkLst>
        </pc:grpChg>
        <pc:grpChg chg="add mod topLvl">
          <ac:chgData name="Reza Amini Hounejani" userId="36cb0b73-58b2-4568-a1ab-00cd49301806" providerId="ADAL" clId="{DA8FEA81-1A63-884F-A1C6-520C766F400F}" dt="2022-11-14T15:40:43.320" v="8437" actId="207"/>
          <ac:grpSpMkLst>
            <pc:docMk/>
            <pc:sldMk cId="1897538530" sldId="256"/>
            <ac:grpSpMk id="290" creationId="{2A674371-F0CC-3F3E-9460-BE0A6020CC1B}"/>
          </ac:grpSpMkLst>
        </pc:grpChg>
        <pc:grpChg chg="add del mod">
          <ac:chgData name="Reza Amini Hounejani" userId="36cb0b73-58b2-4568-a1ab-00cd49301806" providerId="ADAL" clId="{DA8FEA81-1A63-884F-A1C6-520C766F400F}" dt="2022-11-10T11:07:31.578" v="7421" actId="165"/>
          <ac:grpSpMkLst>
            <pc:docMk/>
            <pc:sldMk cId="1897538530" sldId="256"/>
            <ac:grpSpMk id="291" creationId="{36043976-B580-6D3D-16B6-70F4DBB1BEE7}"/>
          </ac:grpSpMkLst>
        </pc:grpChg>
        <pc:picChg chg="mod">
          <ac:chgData name="Reza Amini Hounejani" userId="36cb0b73-58b2-4568-a1ab-00cd49301806" providerId="ADAL" clId="{DA8FEA81-1A63-884F-A1C6-520C766F400F}" dt="2022-09-30T14:10:35.897" v="3297" actId="1037"/>
          <ac:picMkLst>
            <pc:docMk/>
            <pc:sldMk cId="1897538530" sldId="256"/>
            <ac:picMk id="3" creationId="{5D098A37-6317-9736-34A9-A596995BB8C7}"/>
          </ac:picMkLst>
        </pc:picChg>
        <pc:picChg chg="mod">
          <ac:chgData name="Reza Amini Hounejani" userId="36cb0b73-58b2-4568-a1ab-00cd49301806" providerId="ADAL" clId="{DA8FEA81-1A63-884F-A1C6-520C766F400F}" dt="2022-11-16T12:38:27.132" v="8998" actId="571"/>
          <ac:picMkLst>
            <pc:docMk/>
            <pc:sldMk cId="1897538530" sldId="256"/>
            <ac:picMk id="4" creationId="{4824BA92-6EA2-D0D4-B1F5-137E8D45454E}"/>
          </ac:picMkLst>
        </pc:picChg>
        <pc:picChg chg="mod">
          <ac:chgData name="Reza Amini Hounejani" userId="36cb0b73-58b2-4568-a1ab-00cd49301806" providerId="ADAL" clId="{DA8FEA81-1A63-884F-A1C6-520C766F400F}" dt="2022-09-30T14:10:35.897" v="3297" actId="1037"/>
          <ac:picMkLst>
            <pc:docMk/>
            <pc:sldMk cId="1897538530" sldId="256"/>
            <ac:picMk id="14" creationId="{F3F7B853-6725-FEB8-CA7F-FA0C53EDC6D8}"/>
          </ac:picMkLst>
        </pc:picChg>
        <pc:picChg chg="del mod">
          <ac:chgData name="Reza Amini Hounejani" userId="36cb0b73-58b2-4568-a1ab-00cd49301806" providerId="ADAL" clId="{DA8FEA81-1A63-884F-A1C6-520C766F400F}" dt="2022-09-12T17:07:39.570" v="2250" actId="478"/>
          <ac:picMkLst>
            <pc:docMk/>
            <pc:sldMk cId="1897538530" sldId="256"/>
            <ac:picMk id="25" creationId="{6B2C83D6-EA82-D3A2-495C-6CE88422B896}"/>
          </ac:picMkLst>
        </pc:picChg>
        <pc:picChg chg="mod">
          <ac:chgData name="Reza Amini Hounejani" userId="36cb0b73-58b2-4568-a1ab-00cd49301806" providerId="ADAL" clId="{DA8FEA81-1A63-884F-A1C6-520C766F400F}" dt="2022-09-30T14:10:35.897" v="3297" actId="1037"/>
          <ac:picMkLst>
            <pc:docMk/>
            <pc:sldMk cId="1897538530" sldId="256"/>
            <ac:picMk id="26" creationId="{A705A029-0E17-7CDD-358B-78092A0670E0}"/>
          </ac:picMkLst>
        </pc:picChg>
        <pc:picChg chg="add del mod">
          <ac:chgData name="Reza Amini Hounejani" userId="36cb0b73-58b2-4568-a1ab-00cd49301806" providerId="ADAL" clId="{DA8FEA81-1A63-884F-A1C6-520C766F400F}" dt="2022-10-03T15:08:45.731" v="3331" actId="478"/>
          <ac:picMkLst>
            <pc:docMk/>
            <pc:sldMk cId="1897538530" sldId="256"/>
            <ac:picMk id="28" creationId="{1F3529FC-9173-31F8-6878-40E4EF6C1EB6}"/>
          </ac:picMkLst>
        </pc:picChg>
        <pc:picChg chg="add del mod modCrop">
          <ac:chgData name="Reza Amini Hounejani" userId="36cb0b73-58b2-4568-a1ab-00cd49301806" providerId="ADAL" clId="{DA8FEA81-1A63-884F-A1C6-520C766F400F}" dt="2022-11-24T08:32:39.889" v="11442" actId="478"/>
          <ac:picMkLst>
            <pc:docMk/>
            <pc:sldMk cId="1897538530" sldId="256"/>
            <ac:picMk id="28" creationId="{89BFFBE9-005C-C33D-AEB3-707C1FDB985D}"/>
          </ac:picMkLst>
        </pc:picChg>
        <pc:picChg chg="add mod">
          <ac:chgData name="Reza Amini Hounejani" userId="36cb0b73-58b2-4568-a1ab-00cd49301806" providerId="ADAL" clId="{DA8FEA81-1A63-884F-A1C6-520C766F400F}" dt="2022-11-14T15:14:35.327" v="8267" actId="1076"/>
          <ac:picMkLst>
            <pc:docMk/>
            <pc:sldMk cId="1897538530" sldId="256"/>
            <ac:picMk id="29" creationId="{BDC7F90A-B887-0C93-6F35-2DEEEE6040D9}"/>
          </ac:picMkLst>
        </pc:picChg>
        <pc:picChg chg="add del mod">
          <ac:chgData name="Reza Amini Hounejani" userId="36cb0b73-58b2-4568-a1ab-00cd49301806" providerId="ADAL" clId="{DA8FEA81-1A63-884F-A1C6-520C766F400F}" dt="2022-11-02T10:56:58.162" v="4080" actId="478"/>
          <ac:picMkLst>
            <pc:docMk/>
            <pc:sldMk cId="1897538530" sldId="256"/>
            <ac:picMk id="33" creationId="{76EFD941-57AE-080F-08F6-AFA2AD1EB6E1}"/>
          </ac:picMkLst>
        </pc:picChg>
        <pc:picChg chg="add del mod">
          <ac:chgData name="Reza Amini Hounejani" userId="36cb0b73-58b2-4568-a1ab-00cd49301806" providerId="ADAL" clId="{DA8FEA81-1A63-884F-A1C6-520C766F400F}" dt="2022-11-14T15:37:58.733" v="8394" actId="478"/>
          <ac:picMkLst>
            <pc:docMk/>
            <pc:sldMk cId="1897538530" sldId="256"/>
            <ac:picMk id="34" creationId="{AA16A7D2-29E2-B590-7327-630F5E07A8E6}"/>
          </ac:picMkLst>
        </pc:picChg>
        <pc:picChg chg="add del mod">
          <ac:chgData name="Reza Amini Hounejani" userId="36cb0b73-58b2-4568-a1ab-00cd49301806" providerId="ADAL" clId="{DA8FEA81-1A63-884F-A1C6-520C766F400F}" dt="2022-09-30T13:57:19.831" v="3148" actId="478"/>
          <ac:picMkLst>
            <pc:docMk/>
            <pc:sldMk cId="1897538530" sldId="256"/>
            <ac:picMk id="34" creationId="{D18AF729-6C07-1337-752A-37CE8EF3DBC0}"/>
          </ac:picMkLst>
        </pc:picChg>
        <pc:picChg chg="add del mod">
          <ac:chgData name="Reza Amini Hounejani" userId="36cb0b73-58b2-4568-a1ab-00cd49301806" providerId="ADAL" clId="{DA8FEA81-1A63-884F-A1C6-520C766F400F}" dt="2022-11-02T10:57:00.272" v="4081" actId="478"/>
          <ac:picMkLst>
            <pc:docMk/>
            <pc:sldMk cId="1897538530" sldId="256"/>
            <ac:picMk id="36" creationId="{C925493E-7853-8586-2285-6D9F014CD18A}"/>
          </ac:picMkLst>
        </pc:picChg>
        <pc:picChg chg="add del mod">
          <ac:chgData name="Reza Amini Hounejani" userId="36cb0b73-58b2-4568-a1ab-00cd49301806" providerId="ADAL" clId="{DA8FEA81-1A63-884F-A1C6-520C766F400F}" dt="2022-09-30T14:04:03.930" v="3165" actId="478"/>
          <ac:picMkLst>
            <pc:docMk/>
            <pc:sldMk cId="1897538530" sldId="256"/>
            <ac:picMk id="38" creationId="{38B32395-8DEA-D755-139F-5A83F8E42B8E}"/>
          </ac:picMkLst>
        </pc:picChg>
        <pc:picChg chg="add del mod modCrop">
          <ac:chgData name="Reza Amini Hounejani" userId="36cb0b73-58b2-4568-a1ab-00cd49301806" providerId="ADAL" clId="{DA8FEA81-1A63-884F-A1C6-520C766F400F}" dt="2022-10-03T15:02:00.248" v="3323" actId="478"/>
          <ac:picMkLst>
            <pc:docMk/>
            <pc:sldMk cId="1897538530" sldId="256"/>
            <ac:picMk id="40" creationId="{7C0CB3EE-B02D-8879-F77D-139ED1C341B0}"/>
          </ac:picMkLst>
        </pc:picChg>
        <pc:picChg chg="del mod">
          <ac:chgData name="Reza Amini Hounejani" userId="36cb0b73-58b2-4568-a1ab-00cd49301806" providerId="ADAL" clId="{DA8FEA81-1A63-884F-A1C6-520C766F400F}" dt="2022-09-30T13:55:48.217" v="3137" actId="478"/>
          <ac:picMkLst>
            <pc:docMk/>
            <pc:sldMk cId="1897538530" sldId="256"/>
            <ac:picMk id="52" creationId="{8E0EC208-A693-A5D8-A5B5-3E294CA0D579}"/>
          </ac:picMkLst>
        </pc:picChg>
        <pc:picChg chg="mod">
          <ac:chgData name="Reza Amini Hounejani" userId="36cb0b73-58b2-4568-a1ab-00cd49301806" providerId="ADAL" clId="{DA8FEA81-1A63-884F-A1C6-520C766F400F}" dt="2022-11-16T12:38:20.352" v="8996" actId="571"/>
          <ac:picMkLst>
            <pc:docMk/>
            <pc:sldMk cId="1897538530" sldId="256"/>
            <ac:picMk id="69" creationId="{0B741941-2797-1047-632F-4AA6FB7C1672}"/>
          </ac:picMkLst>
        </pc:picChg>
        <pc:picChg chg="mod">
          <ac:chgData name="Reza Amini Hounejani" userId="36cb0b73-58b2-4568-a1ab-00cd49301806" providerId="ADAL" clId="{DA8FEA81-1A63-884F-A1C6-520C766F400F}" dt="2022-09-30T14:10:35.897" v="3297" actId="1037"/>
          <ac:picMkLst>
            <pc:docMk/>
            <pc:sldMk cId="1897538530" sldId="256"/>
            <ac:picMk id="79" creationId="{0DC710D8-D5DD-C780-C469-0F9B8C9D4EDB}"/>
          </ac:picMkLst>
        </pc:picChg>
        <pc:picChg chg="mod">
          <ac:chgData name="Reza Amini Hounejani" userId="36cb0b73-58b2-4568-a1ab-00cd49301806" providerId="ADAL" clId="{DA8FEA81-1A63-884F-A1C6-520C766F400F}" dt="2022-09-30T14:10:35.897" v="3297" actId="1037"/>
          <ac:picMkLst>
            <pc:docMk/>
            <pc:sldMk cId="1897538530" sldId="256"/>
            <ac:picMk id="82" creationId="{28628A61-6D40-4172-4954-59BF7F95D994}"/>
          </ac:picMkLst>
        </pc:picChg>
        <pc:picChg chg="mod">
          <ac:chgData name="Reza Amini Hounejani" userId="36cb0b73-58b2-4568-a1ab-00cd49301806" providerId="ADAL" clId="{DA8FEA81-1A63-884F-A1C6-520C766F400F}" dt="2022-11-25T13:15:31.963" v="11902" actId="555"/>
          <ac:picMkLst>
            <pc:docMk/>
            <pc:sldMk cId="1897538530" sldId="256"/>
            <ac:picMk id="84" creationId="{A37523EA-7B41-0EE9-C877-3A73D6AC3CFC}"/>
          </ac:picMkLst>
        </pc:picChg>
        <pc:picChg chg="mod">
          <ac:chgData name="Reza Amini Hounejani" userId="36cb0b73-58b2-4568-a1ab-00cd49301806" providerId="ADAL" clId="{DA8FEA81-1A63-884F-A1C6-520C766F400F}" dt="2022-11-15T12:49:44.226" v="8763" actId="1035"/>
          <ac:picMkLst>
            <pc:docMk/>
            <pc:sldMk cId="1897538530" sldId="256"/>
            <ac:picMk id="87" creationId="{DAE1C288-43A9-30C8-3594-A124A42FA9DC}"/>
          </ac:picMkLst>
        </pc:picChg>
        <pc:picChg chg="mod">
          <ac:chgData name="Reza Amini Hounejani" userId="36cb0b73-58b2-4568-a1ab-00cd49301806" providerId="ADAL" clId="{DA8FEA81-1A63-884F-A1C6-520C766F400F}" dt="2022-11-15T12:50:05.189" v="8776" actId="1036"/>
          <ac:picMkLst>
            <pc:docMk/>
            <pc:sldMk cId="1897538530" sldId="256"/>
            <ac:picMk id="91" creationId="{94347403-C37C-F068-DBD6-11AC0B259B02}"/>
          </ac:picMkLst>
        </pc:picChg>
        <pc:cxnChg chg="mod">
          <ac:chgData name="Reza Amini Hounejani" userId="36cb0b73-58b2-4568-a1ab-00cd49301806" providerId="ADAL" clId="{DA8FEA81-1A63-884F-A1C6-520C766F400F}" dt="2022-11-16T12:38:27.132" v="8998" actId="571"/>
          <ac:cxnSpMkLst>
            <pc:docMk/>
            <pc:sldMk cId="1897538530" sldId="256"/>
            <ac:cxnSpMk id="12" creationId="{00000000-0000-0000-0000-000000000000}"/>
          </ac:cxnSpMkLst>
        </pc:cxnChg>
        <pc:cxnChg chg="mod">
          <ac:chgData name="Reza Amini Hounejani" userId="36cb0b73-58b2-4568-a1ab-00cd49301806" providerId="ADAL" clId="{DA8FEA81-1A63-884F-A1C6-520C766F400F}" dt="2022-11-16T12:38:27.132" v="8998" actId="571"/>
          <ac:cxnSpMkLst>
            <pc:docMk/>
            <pc:sldMk cId="1897538530" sldId="256"/>
            <ac:cxnSpMk id="13" creationId="{00000000-0000-0000-0000-000000000000}"/>
          </ac:cxnSpMkLst>
        </pc:cxnChg>
        <pc:cxnChg chg="mod">
          <ac:chgData name="Reza Amini Hounejani" userId="36cb0b73-58b2-4568-a1ab-00cd49301806" providerId="ADAL" clId="{DA8FEA81-1A63-884F-A1C6-520C766F400F}" dt="2022-11-16T12:38:27.132" v="8998" actId="571"/>
          <ac:cxnSpMkLst>
            <pc:docMk/>
            <pc:sldMk cId="1897538530" sldId="256"/>
            <ac:cxnSpMk id="16" creationId="{00000000-0000-0000-0000-000000000000}"/>
          </ac:cxnSpMkLst>
        </pc:cxnChg>
        <pc:cxnChg chg="mod">
          <ac:chgData name="Reza Amini Hounejani" userId="36cb0b73-58b2-4568-a1ab-00cd49301806" providerId="ADAL" clId="{DA8FEA81-1A63-884F-A1C6-520C766F400F}" dt="2022-11-16T12:38:27.132" v="8998" actId="571"/>
          <ac:cxnSpMkLst>
            <pc:docMk/>
            <pc:sldMk cId="1897538530" sldId="256"/>
            <ac:cxnSpMk id="17" creationId="{00000000-0000-0000-0000-000000000000}"/>
          </ac:cxnSpMkLst>
        </pc:cxnChg>
        <pc:cxnChg chg="mod">
          <ac:chgData name="Reza Amini Hounejani" userId="36cb0b73-58b2-4568-a1ab-00cd49301806" providerId="ADAL" clId="{DA8FEA81-1A63-884F-A1C6-520C766F400F}" dt="2022-11-16T12:38:27.132" v="8998" actId="571"/>
          <ac:cxnSpMkLst>
            <pc:docMk/>
            <pc:sldMk cId="1897538530" sldId="256"/>
            <ac:cxnSpMk id="18" creationId="{00000000-0000-0000-0000-000000000000}"/>
          </ac:cxnSpMkLst>
        </pc:cxnChg>
        <pc:cxnChg chg="mod">
          <ac:chgData name="Reza Amini Hounejani" userId="36cb0b73-58b2-4568-a1ab-00cd49301806" providerId="ADAL" clId="{DA8FEA81-1A63-884F-A1C6-520C766F400F}" dt="2022-11-16T12:38:27.132" v="8998" actId="571"/>
          <ac:cxnSpMkLst>
            <pc:docMk/>
            <pc:sldMk cId="1897538530" sldId="256"/>
            <ac:cxnSpMk id="19" creationId="{00000000-0000-0000-0000-000000000000}"/>
          </ac:cxnSpMkLst>
        </pc:cxnChg>
        <pc:cxnChg chg="mod">
          <ac:chgData name="Reza Amini Hounejani" userId="36cb0b73-58b2-4568-a1ab-00cd49301806" providerId="ADAL" clId="{DA8FEA81-1A63-884F-A1C6-520C766F400F}" dt="2022-11-16T12:38:27.132" v="8998" actId="571"/>
          <ac:cxnSpMkLst>
            <pc:docMk/>
            <pc:sldMk cId="1897538530" sldId="256"/>
            <ac:cxnSpMk id="20" creationId="{00000000-0000-0000-0000-000000000000}"/>
          </ac:cxnSpMkLst>
        </pc:cxnChg>
        <pc:cxnChg chg="mod">
          <ac:chgData name="Reza Amini Hounejani" userId="36cb0b73-58b2-4568-a1ab-00cd49301806" providerId="ADAL" clId="{DA8FEA81-1A63-884F-A1C6-520C766F400F}" dt="2022-11-16T12:38:27.132" v="8998" actId="571"/>
          <ac:cxnSpMkLst>
            <pc:docMk/>
            <pc:sldMk cId="1897538530" sldId="256"/>
            <ac:cxnSpMk id="21" creationId="{00000000-0000-0000-0000-000000000000}"/>
          </ac:cxnSpMkLst>
        </pc:cxnChg>
        <pc:cxnChg chg="mod">
          <ac:chgData name="Reza Amini Hounejani" userId="36cb0b73-58b2-4568-a1ab-00cd49301806" providerId="ADAL" clId="{DA8FEA81-1A63-884F-A1C6-520C766F400F}" dt="2022-09-30T14:10:35.897" v="3297" actId="1037"/>
          <ac:cxnSpMkLst>
            <pc:docMk/>
            <pc:sldMk cId="1897538530" sldId="256"/>
            <ac:cxnSpMk id="42" creationId="{983AE527-D1FF-CB46-A118-254BFD020E46}"/>
          </ac:cxnSpMkLst>
        </pc:cxnChg>
        <pc:cxnChg chg="mod">
          <ac:chgData name="Reza Amini Hounejani" userId="36cb0b73-58b2-4568-a1ab-00cd49301806" providerId="ADAL" clId="{DA8FEA81-1A63-884F-A1C6-520C766F400F}" dt="2022-09-30T14:10:35.897" v="3297" actId="1037"/>
          <ac:cxnSpMkLst>
            <pc:docMk/>
            <pc:sldMk cId="1897538530" sldId="256"/>
            <ac:cxnSpMk id="43" creationId="{5B38A8BF-0480-6147-BA3B-68D5ABB4CFDE}"/>
          </ac:cxnSpMkLst>
        </pc:cxnChg>
        <pc:cxnChg chg="del">
          <ac:chgData name="Reza Amini Hounejani" userId="36cb0b73-58b2-4568-a1ab-00cd49301806" providerId="ADAL" clId="{DA8FEA81-1A63-884F-A1C6-520C766F400F}" dt="2022-07-27T10:50:39.603" v="1608" actId="478"/>
          <ac:cxnSpMkLst>
            <pc:docMk/>
            <pc:sldMk cId="1897538530" sldId="256"/>
            <ac:cxnSpMk id="57" creationId="{800199B9-3BDE-8608-7539-F1177ED549D1}"/>
          </ac:cxnSpMkLst>
        </pc:cxnChg>
        <pc:cxnChg chg="mod">
          <ac:chgData name="Reza Amini Hounejani" userId="36cb0b73-58b2-4568-a1ab-00cd49301806" providerId="ADAL" clId="{DA8FEA81-1A63-884F-A1C6-520C766F400F}" dt="2022-11-16T12:38:20.352" v="8996" actId="571"/>
          <ac:cxnSpMkLst>
            <pc:docMk/>
            <pc:sldMk cId="1897538530" sldId="256"/>
            <ac:cxnSpMk id="81" creationId="{0A092B77-7CB5-7510-E44B-7789CAC50260}"/>
          </ac:cxnSpMkLst>
        </pc:cxnChg>
        <pc:cxnChg chg="mod">
          <ac:chgData name="Reza Amini Hounejani" userId="36cb0b73-58b2-4568-a1ab-00cd49301806" providerId="ADAL" clId="{DA8FEA81-1A63-884F-A1C6-520C766F400F}" dt="2022-11-16T12:38:20.352" v="8996" actId="571"/>
          <ac:cxnSpMkLst>
            <pc:docMk/>
            <pc:sldMk cId="1897538530" sldId="256"/>
            <ac:cxnSpMk id="88" creationId="{0960D8D3-A5A6-9AEF-2D19-F494685AC4EC}"/>
          </ac:cxnSpMkLst>
        </pc:cxnChg>
        <pc:cxnChg chg="mod">
          <ac:chgData name="Reza Amini Hounejani" userId="36cb0b73-58b2-4568-a1ab-00cd49301806" providerId="ADAL" clId="{DA8FEA81-1A63-884F-A1C6-520C766F400F}" dt="2022-11-16T12:38:20.352" v="8996" actId="571"/>
          <ac:cxnSpMkLst>
            <pc:docMk/>
            <pc:sldMk cId="1897538530" sldId="256"/>
            <ac:cxnSpMk id="90" creationId="{EA24DC54-C1D1-9B2B-B92E-C6DC127EF87E}"/>
          </ac:cxnSpMkLst>
        </pc:cxnChg>
        <pc:cxnChg chg="mod">
          <ac:chgData name="Reza Amini Hounejani" userId="36cb0b73-58b2-4568-a1ab-00cd49301806" providerId="ADAL" clId="{DA8FEA81-1A63-884F-A1C6-520C766F400F}" dt="2022-11-16T12:38:20.352" v="8996" actId="571"/>
          <ac:cxnSpMkLst>
            <pc:docMk/>
            <pc:sldMk cId="1897538530" sldId="256"/>
            <ac:cxnSpMk id="93" creationId="{A09216AF-EB39-7595-9358-ECD3F9FBB6E5}"/>
          </ac:cxnSpMkLst>
        </pc:cxnChg>
        <pc:cxnChg chg="mod">
          <ac:chgData name="Reza Amini Hounejani" userId="36cb0b73-58b2-4568-a1ab-00cd49301806" providerId="ADAL" clId="{DA8FEA81-1A63-884F-A1C6-520C766F400F}" dt="2022-09-30T14:28:45.788" v="3322" actId="13822"/>
          <ac:cxnSpMkLst>
            <pc:docMk/>
            <pc:sldMk cId="1897538530" sldId="256"/>
            <ac:cxnSpMk id="94" creationId="{528DC548-8DB9-5112-19D0-64DC270C059C}"/>
          </ac:cxnSpMkLst>
        </pc:cxnChg>
        <pc:cxnChg chg="mod">
          <ac:chgData name="Reza Amini Hounejani" userId="36cb0b73-58b2-4568-a1ab-00cd49301806" providerId="ADAL" clId="{DA8FEA81-1A63-884F-A1C6-520C766F400F}" dt="2022-11-16T12:38:20.352" v="8996" actId="571"/>
          <ac:cxnSpMkLst>
            <pc:docMk/>
            <pc:sldMk cId="1897538530" sldId="256"/>
            <ac:cxnSpMk id="95" creationId="{92442D50-ABE2-D00A-7D7A-FF4F681BBD44}"/>
          </ac:cxnSpMkLst>
        </pc:cxnChg>
        <pc:cxnChg chg="mod">
          <ac:chgData name="Reza Amini Hounejani" userId="36cb0b73-58b2-4568-a1ab-00cd49301806" providerId="ADAL" clId="{DA8FEA81-1A63-884F-A1C6-520C766F400F}" dt="2022-11-16T12:38:20.352" v="8996" actId="571"/>
          <ac:cxnSpMkLst>
            <pc:docMk/>
            <pc:sldMk cId="1897538530" sldId="256"/>
            <ac:cxnSpMk id="96" creationId="{8FBC7D0A-5631-E5A3-ADDB-C6F930541637}"/>
          </ac:cxnSpMkLst>
        </pc:cxnChg>
        <pc:cxnChg chg="mod">
          <ac:chgData name="Reza Amini Hounejani" userId="36cb0b73-58b2-4568-a1ab-00cd49301806" providerId="ADAL" clId="{DA8FEA81-1A63-884F-A1C6-520C766F400F}" dt="2022-11-16T12:38:20.352" v="8996" actId="571"/>
          <ac:cxnSpMkLst>
            <pc:docMk/>
            <pc:sldMk cId="1897538530" sldId="256"/>
            <ac:cxnSpMk id="97" creationId="{98B0E8C5-952C-EF69-1112-7112DCF237DE}"/>
          </ac:cxnSpMkLst>
        </pc:cxnChg>
        <pc:cxnChg chg="mod">
          <ac:chgData name="Reza Amini Hounejani" userId="36cb0b73-58b2-4568-a1ab-00cd49301806" providerId="ADAL" clId="{DA8FEA81-1A63-884F-A1C6-520C766F400F}" dt="2022-11-25T13:07:59.795" v="11893" actId="12789"/>
          <ac:cxnSpMkLst>
            <pc:docMk/>
            <pc:sldMk cId="1897538530" sldId="256"/>
            <ac:cxnSpMk id="103" creationId="{00000000-0000-0000-0000-000000000000}"/>
          </ac:cxnSpMkLst>
        </pc:cxnChg>
        <pc:cxnChg chg="mod">
          <ac:chgData name="Reza Amini Hounejani" userId="36cb0b73-58b2-4568-a1ab-00cd49301806" providerId="ADAL" clId="{DA8FEA81-1A63-884F-A1C6-520C766F400F}" dt="2022-11-25T13:07:59.795" v="11893" actId="12789"/>
          <ac:cxnSpMkLst>
            <pc:docMk/>
            <pc:sldMk cId="1897538530" sldId="256"/>
            <ac:cxnSpMk id="104" creationId="{00000000-0000-0000-0000-000000000000}"/>
          </ac:cxnSpMkLst>
        </pc:cxnChg>
        <pc:cxnChg chg="mod">
          <ac:chgData name="Reza Amini Hounejani" userId="36cb0b73-58b2-4568-a1ab-00cd49301806" providerId="ADAL" clId="{DA8FEA81-1A63-884F-A1C6-520C766F400F}" dt="2022-11-16T12:38:20.352" v="8996" actId="571"/>
          <ac:cxnSpMkLst>
            <pc:docMk/>
            <pc:sldMk cId="1897538530" sldId="256"/>
            <ac:cxnSpMk id="105" creationId="{AE8710A6-141B-57DF-86D2-6B9F31B025F8}"/>
          </ac:cxnSpMkLst>
        </pc:cxnChg>
        <pc:cxnChg chg="mod">
          <ac:chgData name="Reza Amini Hounejani" userId="36cb0b73-58b2-4568-a1ab-00cd49301806" providerId="ADAL" clId="{DA8FEA81-1A63-884F-A1C6-520C766F400F}" dt="2022-09-30T14:10:35.897" v="3297" actId="1037"/>
          <ac:cxnSpMkLst>
            <pc:docMk/>
            <pc:sldMk cId="1897538530" sldId="256"/>
            <ac:cxnSpMk id="113" creationId="{00000000-0000-0000-0000-000000000000}"/>
          </ac:cxnSpMkLst>
        </pc:cxnChg>
        <pc:cxnChg chg="add mod">
          <ac:chgData name="Reza Amini Hounejani" userId="36cb0b73-58b2-4568-a1ab-00cd49301806" providerId="ADAL" clId="{DA8FEA81-1A63-884F-A1C6-520C766F400F}" dt="2022-11-14T16:36:55.987" v="8694" actId="14100"/>
          <ac:cxnSpMkLst>
            <pc:docMk/>
            <pc:sldMk cId="1897538530" sldId="256"/>
            <ac:cxnSpMk id="190" creationId="{B8126891-B7FB-AA14-9377-E3A167799A0E}"/>
          </ac:cxnSpMkLst>
        </pc:cxnChg>
        <pc:cxnChg chg="add mod">
          <ac:chgData name="Reza Amini Hounejani" userId="36cb0b73-58b2-4568-a1ab-00cd49301806" providerId="ADAL" clId="{DA8FEA81-1A63-884F-A1C6-520C766F400F}" dt="2022-11-14T16:37:13.047" v="8696" actId="571"/>
          <ac:cxnSpMkLst>
            <pc:docMk/>
            <pc:sldMk cId="1897538530" sldId="256"/>
            <ac:cxnSpMk id="195" creationId="{3A91E561-E80A-A7C2-7D15-BA193688AC7A}"/>
          </ac:cxnSpMkLst>
        </pc:cxnChg>
        <pc:cxnChg chg="add del mod">
          <ac:chgData name="Reza Amini Hounejani" userId="36cb0b73-58b2-4568-a1ab-00cd49301806" providerId="ADAL" clId="{DA8FEA81-1A63-884F-A1C6-520C766F400F}" dt="2022-11-14T16:37:28.733" v="8702"/>
          <ac:cxnSpMkLst>
            <pc:docMk/>
            <pc:sldMk cId="1897538530" sldId="256"/>
            <ac:cxnSpMk id="196" creationId="{41E6994A-6723-BB7E-6860-8EFB63E8F879}"/>
          </ac:cxnSpMkLst>
        </pc:cxnChg>
        <pc:cxnChg chg="add mod">
          <ac:chgData name="Reza Amini Hounejani" userId="36cb0b73-58b2-4568-a1ab-00cd49301806" providerId="ADAL" clId="{DA8FEA81-1A63-884F-A1C6-520C766F400F}" dt="2022-11-15T12:49:57.993" v="8774" actId="1036"/>
          <ac:cxnSpMkLst>
            <pc:docMk/>
            <pc:sldMk cId="1897538530" sldId="256"/>
            <ac:cxnSpMk id="200" creationId="{E136BC80-749D-8603-E045-AE9EB51B47EF}"/>
          </ac:cxnSpMkLst>
        </pc:cxnChg>
        <pc:cxnChg chg="add mod">
          <ac:chgData name="Reza Amini Hounejani" userId="36cb0b73-58b2-4568-a1ab-00cd49301806" providerId="ADAL" clId="{DA8FEA81-1A63-884F-A1C6-520C766F400F}" dt="2022-11-15T12:50:48.361" v="8799" actId="1038"/>
          <ac:cxnSpMkLst>
            <pc:docMk/>
            <pc:sldMk cId="1897538530" sldId="256"/>
            <ac:cxnSpMk id="202" creationId="{83E8DCEB-A74D-187A-B337-69B3F95D104A}"/>
          </ac:cxnSpMkLst>
        </pc:cxnChg>
        <pc:cxnChg chg="add mod">
          <ac:chgData name="Reza Amini Hounejani" userId="36cb0b73-58b2-4568-a1ab-00cd49301806" providerId="ADAL" clId="{DA8FEA81-1A63-884F-A1C6-520C766F400F}" dt="2022-11-15T12:50:54.633" v="8800" actId="14100"/>
          <ac:cxnSpMkLst>
            <pc:docMk/>
            <pc:sldMk cId="1897538530" sldId="256"/>
            <ac:cxnSpMk id="203" creationId="{38AB73AE-EE47-0A85-175F-589B1D89426B}"/>
          </ac:cxnSpMkLst>
        </pc:cxnChg>
        <pc:cxnChg chg="add mod">
          <ac:chgData name="Reza Amini Hounejani" userId="36cb0b73-58b2-4568-a1ab-00cd49301806" providerId="ADAL" clId="{DA8FEA81-1A63-884F-A1C6-520C766F400F}" dt="2022-11-15T12:51:01.105" v="8801" actId="571"/>
          <ac:cxnSpMkLst>
            <pc:docMk/>
            <pc:sldMk cId="1897538530" sldId="256"/>
            <ac:cxnSpMk id="206" creationId="{7F586868-35EF-5858-E567-EF84EC9E6D4C}"/>
          </ac:cxnSpMkLst>
        </pc:cxnChg>
        <pc:cxnChg chg="add mod">
          <ac:chgData name="Reza Amini Hounejani" userId="36cb0b73-58b2-4568-a1ab-00cd49301806" providerId="ADAL" clId="{DA8FEA81-1A63-884F-A1C6-520C766F400F}" dt="2022-11-15T12:51:05.785" v="8802" actId="571"/>
          <ac:cxnSpMkLst>
            <pc:docMk/>
            <pc:sldMk cId="1897538530" sldId="256"/>
            <ac:cxnSpMk id="207" creationId="{2E4044E0-8D52-93BA-06EE-C8C8A88428E8}"/>
          </ac:cxnSpMkLst>
        </pc:cxnChg>
        <pc:cxnChg chg="add mod">
          <ac:chgData name="Reza Amini Hounejani" userId="36cb0b73-58b2-4568-a1ab-00cd49301806" providerId="ADAL" clId="{DA8FEA81-1A63-884F-A1C6-520C766F400F}" dt="2022-11-15T12:51:15.164" v="8806" actId="1036"/>
          <ac:cxnSpMkLst>
            <pc:docMk/>
            <pc:sldMk cId="1897538530" sldId="256"/>
            <ac:cxnSpMk id="208" creationId="{FCACE5DB-7034-9BF5-C054-6340D51F6211}"/>
          </ac:cxnSpMkLst>
        </pc:cxnChg>
        <pc:cxnChg chg="add mod">
          <ac:chgData name="Reza Amini Hounejani" userId="36cb0b73-58b2-4568-a1ab-00cd49301806" providerId="ADAL" clId="{DA8FEA81-1A63-884F-A1C6-520C766F400F}" dt="2022-11-15T12:51:21.520" v="8808" actId="1035"/>
          <ac:cxnSpMkLst>
            <pc:docMk/>
            <pc:sldMk cId="1897538530" sldId="256"/>
            <ac:cxnSpMk id="209" creationId="{96365AA7-E324-78FF-1851-C48A2FD9D85B}"/>
          </ac:cxnSpMkLst>
        </pc:cxnChg>
        <pc:cxnChg chg="add mod">
          <ac:chgData name="Reza Amini Hounejani" userId="36cb0b73-58b2-4568-a1ab-00cd49301806" providerId="ADAL" clId="{DA8FEA81-1A63-884F-A1C6-520C766F400F}" dt="2022-11-15T12:51:24.057" v="8809" actId="571"/>
          <ac:cxnSpMkLst>
            <pc:docMk/>
            <pc:sldMk cId="1897538530" sldId="256"/>
            <ac:cxnSpMk id="210" creationId="{C52270E0-53DE-CD60-6159-9E7C8C6C6312}"/>
          </ac:cxnSpMkLst>
        </pc:cxnChg>
        <pc:cxnChg chg="add del mod">
          <ac:chgData name="Reza Amini Hounejani" userId="36cb0b73-58b2-4568-a1ab-00cd49301806" providerId="ADAL" clId="{DA8FEA81-1A63-884F-A1C6-520C766F400F}" dt="2022-11-09T11:21:22.409" v="6997" actId="478"/>
          <ac:cxnSpMkLst>
            <pc:docMk/>
            <pc:sldMk cId="1897538530" sldId="256"/>
            <ac:cxnSpMk id="212" creationId="{F42AD8C0-1976-7DA3-81F3-47F4A67DB6DD}"/>
          </ac:cxnSpMkLst>
        </pc:cxnChg>
        <pc:cxnChg chg="add del mod">
          <ac:chgData name="Reza Amini Hounejani" userId="36cb0b73-58b2-4568-a1ab-00cd49301806" providerId="ADAL" clId="{DA8FEA81-1A63-884F-A1C6-520C766F400F}" dt="2022-11-09T11:23:19.769" v="7017" actId="478"/>
          <ac:cxnSpMkLst>
            <pc:docMk/>
            <pc:sldMk cId="1897538530" sldId="256"/>
            <ac:cxnSpMk id="215" creationId="{BEF0FF66-5AF9-8BBD-565E-CAB952140A26}"/>
          </ac:cxnSpMkLst>
        </pc:cxnChg>
        <pc:cxnChg chg="add del mod">
          <ac:chgData name="Reza Amini Hounejani" userId="36cb0b73-58b2-4568-a1ab-00cd49301806" providerId="ADAL" clId="{DA8FEA81-1A63-884F-A1C6-520C766F400F}" dt="2022-11-09T11:30:16.637" v="7093" actId="478"/>
          <ac:cxnSpMkLst>
            <pc:docMk/>
            <pc:sldMk cId="1897538530" sldId="256"/>
            <ac:cxnSpMk id="234" creationId="{86446095-18BB-2F3B-1F95-98567CC9BBCA}"/>
          </ac:cxnSpMkLst>
        </pc:cxnChg>
      </pc:sldChg>
      <pc:sldChg chg="addSp delSp modSp mod">
        <pc:chgData name="Reza Amini Hounejani" userId="36cb0b73-58b2-4568-a1ab-00cd49301806" providerId="ADAL" clId="{DA8FEA81-1A63-884F-A1C6-520C766F400F}" dt="2022-11-25T13:16:08.931" v="11906" actId="1076"/>
        <pc:sldMkLst>
          <pc:docMk/>
          <pc:sldMk cId="3807795133" sldId="257"/>
        </pc:sldMkLst>
        <pc:spChg chg="mod">
          <ac:chgData name="Reza Amini Hounejani" userId="36cb0b73-58b2-4568-a1ab-00cd49301806" providerId="ADAL" clId="{DA8FEA81-1A63-884F-A1C6-520C766F400F}" dt="2022-11-16T12:43:00.587" v="9135" actId="1076"/>
          <ac:spMkLst>
            <pc:docMk/>
            <pc:sldMk cId="3807795133" sldId="257"/>
            <ac:spMk id="4" creationId="{8BA677DE-3873-7D45-9D56-C80CF5FAD955}"/>
          </ac:spMkLst>
        </pc:spChg>
        <pc:spChg chg="mod">
          <ac:chgData name="Reza Amini Hounejani" userId="36cb0b73-58b2-4568-a1ab-00cd49301806" providerId="ADAL" clId="{DA8FEA81-1A63-884F-A1C6-520C766F400F}" dt="2022-11-16T12:41:55.276" v="9089" actId="1076"/>
          <ac:spMkLst>
            <pc:docMk/>
            <pc:sldMk cId="3807795133" sldId="257"/>
            <ac:spMk id="5" creationId="{69BE46E5-5F59-D94D-BFCD-1E5F12A26915}"/>
          </ac:spMkLst>
        </pc:spChg>
        <pc:spChg chg="mod">
          <ac:chgData name="Reza Amini Hounejani" userId="36cb0b73-58b2-4568-a1ab-00cd49301806" providerId="ADAL" clId="{DA8FEA81-1A63-884F-A1C6-520C766F400F}" dt="2022-10-17T13:00:01.939" v="3447" actId="465"/>
          <ac:spMkLst>
            <pc:docMk/>
            <pc:sldMk cId="3807795133" sldId="257"/>
            <ac:spMk id="11" creationId="{8C2C7F0C-9FA4-B04D-8AE4-F028F74A820C}"/>
          </ac:spMkLst>
        </pc:spChg>
        <pc:spChg chg="del">
          <ac:chgData name="Reza Amini Hounejani" userId="36cb0b73-58b2-4568-a1ab-00cd49301806" providerId="ADAL" clId="{DA8FEA81-1A63-884F-A1C6-520C766F400F}" dt="2022-07-26T14:31:08.956" v="616" actId="478"/>
          <ac:spMkLst>
            <pc:docMk/>
            <pc:sldMk cId="3807795133" sldId="257"/>
            <ac:spMk id="13" creationId="{4605513A-6516-3740-9802-28FDBAF724A9}"/>
          </ac:spMkLst>
        </pc:spChg>
        <pc:spChg chg="add mod">
          <ac:chgData name="Reza Amini Hounejani" userId="36cb0b73-58b2-4568-a1ab-00cd49301806" providerId="ADAL" clId="{DA8FEA81-1A63-884F-A1C6-520C766F400F}" dt="2022-11-16T12:40:07.970" v="9059" actId="164"/>
          <ac:spMkLst>
            <pc:docMk/>
            <pc:sldMk cId="3807795133" sldId="257"/>
            <ac:spMk id="27" creationId="{A39E879A-375A-2E71-712F-82908B71E6C2}"/>
          </ac:spMkLst>
        </pc:spChg>
        <pc:spChg chg="del mod">
          <ac:chgData name="Reza Amini Hounejani" userId="36cb0b73-58b2-4568-a1ab-00cd49301806" providerId="ADAL" clId="{DA8FEA81-1A63-884F-A1C6-520C766F400F}" dt="2022-09-12T17:11:19.743" v="2307" actId="478"/>
          <ac:spMkLst>
            <pc:docMk/>
            <pc:sldMk cId="3807795133" sldId="257"/>
            <ac:spMk id="29" creationId="{DBD4D7BF-8A67-C2F4-D65C-4C1658AD00E1}"/>
          </ac:spMkLst>
        </pc:spChg>
        <pc:spChg chg="add mod">
          <ac:chgData name="Reza Amini Hounejani" userId="36cb0b73-58b2-4568-a1ab-00cd49301806" providerId="ADAL" clId="{DA8FEA81-1A63-884F-A1C6-520C766F400F}" dt="2022-11-16T12:46:55.381" v="9186" actId="1076"/>
          <ac:spMkLst>
            <pc:docMk/>
            <pc:sldMk cId="3807795133" sldId="257"/>
            <ac:spMk id="31" creationId="{21B07873-4E3A-CB98-8BF3-901F3F5B3BB8}"/>
          </ac:spMkLst>
        </pc:spChg>
        <pc:spChg chg="mod">
          <ac:chgData name="Reza Amini Hounejani" userId="36cb0b73-58b2-4568-a1ab-00cd49301806" providerId="ADAL" clId="{DA8FEA81-1A63-884F-A1C6-520C766F400F}" dt="2022-10-17T13:00:01.939" v="3447" actId="465"/>
          <ac:spMkLst>
            <pc:docMk/>
            <pc:sldMk cId="3807795133" sldId="257"/>
            <ac:spMk id="32" creationId="{BC58D8A2-2B72-B908-C367-0B27D746D3F3}"/>
          </ac:spMkLst>
        </pc:spChg>
        <pc:spChg chg="mod">
          <ac:chgData name="Reza Amini Hounejani" userId="36cb0b73-58b2-4568-a1ab-00cd49301806" providerId="ADAL" clId="{DA8FEA81-1A63-884F-A1C6-520C766F400F}" dt="2022-09-19T08:45:03.012" v="2500" actId="20577"/>
          <ac:spMkLst>
            <pc:docMk/>
            <pc:sldMk cId="3807795133" sldId="257"/>
            <ac:spMk id="39" creationId="{5CCCE4B4-189F-9743-8857-17256EC52899}"/>
          </ac:spMkLst>
        </pc:spChg>
        <pc:spChg chg="mod">
          <ac:chgData name="Reza Amini Hounejani" userId="36cb0b73-58b2-4568-a1ab-00cd49301806" providerId="ADAL" clId="{DA8FEA81-1A63-884F-A1C6-520C766F400F}" dt="2022-09-19T08:45:28.531" v="2502" actId="20577"/>
          <ac:spMkLst>
            <pc:docMk/>
            <pc:sldMk cId="3807795133" sldId="257"/>
            <ac:spMk id="40" creationId="{365C1163-E908-094C-B56B-319A6D363881}"/>
          </ac:spMkLst>
        </pc:spChg>
        <pc:spChg chg="del">
          <ac:chgData name="Reza Amini Hounejani" userId="36cb0b73-58b2-4568-a1ab-00cd49301806" providerId="ADAL" clId="{DA8FEA81-1A63-884F-A1C6-520C766F400F}" dt="2022-09-19T08:27:42.096" v="2466" actId="478"/>
          <ac:spMkLst>
            <pc:docMk/>
            <pc:sldMk cId="3807795133" sldId="257"/>
            <ac:spMk id="41" creationId="{D1C06C31-6DD9-0849-9682-76FDDAC93B8B}"/>
          </ac:spMkLst>
        </pc:spChg>
        <pc:spChg chg="add mod">
          <ac:chgData name="Reza Amini Hounejani" userId="36cb0b73-58b2-4568-a1ab-00cd49301806" providerId="ADAL" clId="{DA8FEA81-1A63-884F-A1C6-520C766F400F}" dt="2022-11-16T12:46:42.330" v="9183" actId="1076"/>
          <ac:spMkLst>
            <pc:docMk/>
            <pc:sldMk cId="3807795133" sldId="257"/>
            <ac:spMk id="42" creationId="{3886E3CA-CAC6-E6B2-DAC9-9710956DAD09}"/>
          </ac:spMkLst>
        </pc:spChg>
        <pc:spChg chg="del">
          <ac:chgData name="Reza Amini Hounejani" userId="36cb0b73-58b2-4568-a1ab-00cd49301806" providerId="ADAL" clId="{DA8FEA81-1A63-884F-A1C6-520C766F400F}" dt="2022-09-19T08:27:34.375" v="2464" actId="478"/>
          <ac:spMkLst>
            <pc:docMk/>
            <pc:sldMk cId="3807795133" sldId="257"/>
            <ac:spMk id="42" creationId="{4A5DA2B5-FDBA-794B-81FE-28DBD099C84A}"/>
          </ac:spMkLst>
        </pc:spChg>
        <pc:spChg chg="mod">
          <ac:chgData name="Reza Amini Hounejani" userId="36cb0b73-58b2-4568-a1ab-00cd49301806" providerId="ADAL" clId="{DA8FEA81-1A63-884F-A1C6-520C766F400F}" dt="2022-09-19T08:27:38.077" v="2465" actId="1076"/>
          <ac:spMkLst>
            <pc:docMk/>
            <pc:sldMk cId="3807795133" sldId="257"/>
            <ac:spMk id="43" creationId="{6CCDC557-FEE7-5841-9299-F50DDFD5B2CD}"/>
          </ac:spMkLst>
        </pc:spChg>
        <pc:spChg chg="mod">
          <ac:chgData name="Reza Amini Hounejani" userId="36cb0b73-58b2-4568-a1ab-00cd49301806" providerId="ADAL" clId="{DA8FEA81-1A63-884F-A1C6-520C766F400F}" dt="2022-11-16T12:41:27.413" v="9061" actId="571"/>
          <ac:spMkLst>
            <pc:docMk/>
            <pc:sldMk cId="3807795133" sldId="257"/>
            <ac:spMk id="45" creationId="{8AB472DB-6524-E7A9-D720-890103907658}"/>
          </ac:spMkLst>
        </pc:spChg>
        <pc:spChg chg="mod">
          <ac:chgData name="Reza Amini Hounejani" userId="36cb0b73-58b2-4568-a1ab-00cd49301806" providerId="ADAL" clId="{DA8FEA81-1A63-884F-A1C6-520C766F400F}" dt="2022-11-16T12:41:27.413" v="9061" actId="571"/>
          <ac:spMkLst>
            <pc:docMk/>
            <pc:sldMk cId="3807795133" sldId="257"/>
            <ac:spMk id="46" creationId="{1FF60623-0CA8-C415-D25E-AB217F0F05DF}"/>
          </ac:spMkLst>
        </pc:spChg>
        <pc:spChg chg="mod">
          <ac:chgData name="Reza Amini Hounejani" userId="36cb0b73-58b2-4568-a1ab-00cd49301806" providerId="ADAL" clId="{DA8FEA81-1A63-884F-A1C6-520C766F400F}" dt="2022-11-16T12:41:27.413" v="9061" actId="571"/>
          <ac:spMkLst>
            <pc:docMk/>
            <pc:sldMk cId="3807795133" sldId="257"/>
            <ac:spMk id="47" creationId="{1395A6D3-4AEE-C25D-5F1E-CD8C1FBD4B7D}"/>
          </ac:spMkLst>
        </pc:spChg>
        <pc:spChg chg="mod">
          <ac:chgData name="Reza Amini Hounejani" userId="36cb0b73-58b2-4568-a1ab-00cd49301806" providerId="ADAL" clId="{DA8FEA81-1A63-884F-A1C6-520C766F400F}" dt="2022-11-16T12:41:27.413" v="9061" actId="571"/>
          <ac:spMkLst>
            <pc:docMk/>
            <pc:sldMk cId="3807795133" sldId="257"/>
            <ac:spMk id="52" creationId="{0C2399AA-D94B-71EC-E7B8-1BC18E13E67E}"/>
          </ac:spMkLst>
        </pc:spChg>
        <pc:spChg chg="mod">
          <ac:chgData name="Reza Amini Hounejani" userId="36cb0b73-58b2-4568-a1ab-00cd49301806" providerId="ADAL" clId="{DA8FEA81-1A63-884F-A1C6-520C766F400F}" dt="2022-11-16T12:41:27.413" v="9061" actId="571"/>
          <ac:spMkLst>
            <pc:docMk/>
            <pc:sldMk cId="3807795133" sldId="257"/>
            <ac:spMk id="55" creationId="{00000000-0000-0000-0000-000000000000}"/>
          </ac:spMkLst>
        </pc:spChg>
        <pc:spChg chg="mod">
          <ac:chgData name="Reza Amini Hounejani" userId="36cb0b73-58b2-4568-a1ab-00cd49301806" providerId="ADAL" clId="{DA8FEA81-1A63-884F-A1C6-520C766F400F}" dt="2022-11-16T12:41:27.413" v="9061" actId="571"/>
          <ac:spMkLst>
            <pc:docMk/>
            <pc:sldMk cId="3807795133" sldId="257"/>
            <ac:spMk id="56" creationId="{00000000-0000-0000-0000-000000000000}"/>
          </ac:spMkLst>
        </pc:spChg>
        <pc:spChg chg="mod">
          <ac:chgData name="Reza Amini Hounejani" userId="36cb0b73-58b2-4568-a1ab-00cd49301806" providerId="ADAL" clId="{DA8FEA81-1A63-884F-A1C6-520C766F400F}" dt="2022-11-16T12:41:27.413" v="9061" actId="571"/>
          <ac:spMkLst>
            <pc:docMk/>
            <pc:sldMk cId="3807795133" sldId="257"/>
            <ac:spMk id="57" creationId="{00000000-0000-0000-0000-000000000000}"/>
          </ac:spMkLst>
        </pc:spChg>
        <pc:spChg chg="mod">
          <ac:chgData name="Reza Amini Hounejani" userId="36cb0b73-58b2-4568-a1ab-00cd49301806" providerId="ADAL" clId="{DA8FEA81-1A63-884F-A1C6-520C766F400F}" dt="2022-11-16T12:41:27.413" v="9061" actId="571"/>
          <ac:spMkLst>
            <pc:docMk/>
            <pc:sldMk cId="3807795133" sldId="257"/>
            <ac:spMk id="58" creationId="{00000000-0000-0000-0000-000000000000}"/>
          </ac:spMkLst>
        </pc:spChg>
        <pc:spChg chg="mod">
          <ac:chgData name="Reza Amini Hounejani" userId="36cb0b73-58b2-4568-a1ab-00cd49301806" providerId="ADAL" clId="{DA8FEA81-1A63-884F-A1C6-520C766F400F}" dt="2022-11-16T12:41:27.413" v="9061" actId="571"/>
          <ac:spMkLst>
            <pc:docMk/>
            <pc:sldMk cId="3807795133" sldId="257"/>
            <ac:spMk id="59" creationId="{00000000-0000-0000-0000-000000000000}"/>
          </ac:spMkLst>
        </pc:spChg>
        <pc:spChg chg="mod">
          <ac:chgData name="Reza Amini Hounejani" userId="36cb0b73-58b2-4568-a1ab-00cd49301806" providerId="ADAL" clId="{DA8FEA81-1A63-884F-A1C6-520C766F400F}" dt="2022-11-16T12:41:27.413" v="9061" actId="571"/>
          <ac:spMkLst>
            <pc:docMk/>
            <pc:sldMk cId="3807795133" sldId="257"/>
            <ac:spMk id="60" creationId="{00000000-0000-0000-0000-000000000000}"/>
          </ac:spMkLst>
        </pc:spChg>
        <pc:spChg chg="mod">
          <ac:chgData name="Reza Amini Hounejani" userId="36cb0b73-58b2-4568-a1ab-00cd49301806" providerId="ADAL" clId="{DA8FEA81-1A63-884F-A1C6-520C766F400F}" dt="2022-11-16T12:41:27.413" v="9061" actId="571"/>
          <ac:spMkLst>
            <pc:docMk/>
            <pc:sldMk cId="3807795133" sldId="257"/>
            <ac:spMk id="63" creationId="{1395A6D3-4AEE-C25D-5F1E-CD8C1FBD4B7D}"/>
          </ac:spMkLst>
        </pc:spChg>
        <pc:spChg chg="mod">
          <ac:chgData name="Reza Amini Hounejani" userId="36cb0b73-58b2-4568-a1ab-00cd49301806" providerId="ADAL" clId="{DA8FEA81-1A63-884F-A1C6-520C766F400F}" dt="2022-11-16T12:41:27.413" v="9061" actId="571"/>
          <ac:spMkLst>
            <pc:docMk/>
            <pc:sldMk cId="3807795133" sldId="257"/>
            <ac:spMk id="64" creationId="{0C2399AA-D94B-71EC-E7B8-1BC18E13E67E}"/>
          </ac:spMkLst>
        </pc:spChg>
        <pc:spChg chg="add mod">
          <ac:chgData name="Reza Amini Hounejani" userId="36cb0b73-58b2-4568-a1ab-00cd49301806" providerId="ADAL" clId="{DA8FEA81-1A63-884F-A1C6-520C766F400F}" dt="2022-11-16T12:46:36.743" v="9182" actId="1076"/>
          <ac:spMkLst>
            <pc:docMk/>
            <pc:sldMk cId="3807795133" sldId="257"/>
            <ac:spMk id="65" creationId="{941CBDDA-6046-D1E6-EAD2-52CB29571D97}"/>
          </ac:spMkLst>
        </pc:spChg>
        <pc:spChg chg="del mod">
          <ac:chgData name="Reza Amini Hounejani" userId="36cb0b73-58b2-4568-a1ab-00cd49301806" providerId="ADAL" clId="{DA8FEA81-1A63-884F-A1C6-520C766F400F}" dt="2022-09-12T17:11:19.743" v="2307" actId="478"/>
          <ac:spMkLst>
            <pc:docMk/>
            <pc:sldMk cId="3807795133" sldId="257"/>
            <ac:spMk id="75" creationId="{E28037B0-61AA-FBCD-B041-822A2E57F20B}"/>
          </ac:spMkLst>
        </pc:spChg>
        <pc:spChg chg="del mod">
          <ac:chgData name="Reza Amini Hounejani" userId="36cb0b73-58b2-4568-a1ab-00cd49301806" providerId="ADAL" clId="{DA8FEA81-1A63-884F-A1C6-520C766F400F}" dt="2022-09-12T17:11:15.212" v="2306" actId="478"/>
          <ac:spMkLst>
            <pc:docMk/>
            <pc:sldMk cId="3807795133" sldId="257"/>
            <ac:spMk id="77" creationId="{0A1CEB19-9278-0853-AC02-204F81344699}"/>
          </ac:spMkLst>
        </pc:spChg>
        <pc:spChg chg="mod">
          <ac:chgData name="Reza Amini Hounejani" userId="36cb0b73-58b2-4568-a1ab-00cd49301806" providerId="ADAL" clId="{DA8FEA81-1A63-884F-A1C6-520C766F400F}" dt="2022-10-17T13:00:01.939" v="3447" actId="465"/>
          <ac:spMkLst>
            <pc:docMk/>
            <pc:sldMk cId="3807795133" sldId="257"/>
            <ac:spMk id="80" creationId="{63E757AB-526F-4B8A-AC4A-C042B12F0808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83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84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0-17T13:00:01.939" v="3447" actId="465"/>
          <ac:spMkLst>
            <pc:docMk/>
            <pc:sldMk cId="3807795133" sldId="257"/>
            <ac:spMk id="85" creationId="{12E07F16-2BF0-8B9A-1603-30BF93275D37}"/>
          </ac:spMkLst>
        </pc:spChg>
        <pc:spChg chg="mod">
          <ac:chgData name="Reza Amini Hounejani" userId="36cb0b73-58b2-4568-a1ab-00cd49301806" providerId="ADAL" clId="{DA8FEA81-1A63-884F-A1C6-520C766F400F}" dt="2022-10-17T13:00:01.939" v="3447" actId="465"/>
          <ac:spMkLst>
            <pc:docMk/>
            <pc:sldMk cId="3807795133" sldId="257"/>
            <ac:spMk id="88" creationId="{9C921241-A718-DAC6-D8E4-594C7E58D01C}"/>
          </ac:spMkLst>
        </pc:spChg>
        <pc:spChg chg="mod">
          <ac:chgData name="Reza Amini Hounejani" userId="36cb0b73-58b2-4568-a1ab-00cd49301806" providerId="ADAL" clId="{DA8FEA81-1A63-884F-A1C6-520C766F400F}" dt="2022-07-26T12:00:05.809" v="364" actId="20577"/>
          <ac:spMkLst>
            <pc:docMk/>
            <pc:sldMk cId="3807795133" sldId="257"/>
            <ac:spMk id="90" creationId="{0E3A8FA3-C11D-4C61-3AFB-B69205167F17}"/>
          </ac:spMkLst>
        </pc:spChg>
        <pc:spChg chg="mod">
          <ac:chgData name="Reza Amini Hounejani" userId="36cb0b73-58b2-4568-a1ab-00cd49301806" providerId="ADAL" clId="{DA8FEA81-1A63-884F-A1C6-520C766F400F}" dt="2022-10-17T13:00:01.939" v="3447" actId="465"/>
          <ac:spMkLst>
            <pc:docMk/>
            <pc:sldMk cId="3807795133" sldId="257"/>
            <ac:spMk id="91" creationId="{D6DB436F-09A0-0C86-975C-EE4B202ED862}"/>
          </ac:spMkLst>
        </pc:spChg>
        <pc:spChg chg="mod">
          <ac:chgData name="Reza Amini Hounejani" userId="36cb0b73-58b2-4568-a1ab-00cd49301806" providerId="ADAL" clId="{DA8FEA81-1A63-884F-A1C6-520C766F400F}" dt="2022-10-17T13:00:01.939" v="3447" actId="465"/>
          <ac:spMkLst>
            <pc:docMk/>
            <pc:sldMk cId="3807795133" sldId="257"/>
            <ac:spMk id="92" creationId="{498EDBFB-A6ED-6636-F4A4-B75CB877116C}"/>
          </ac:spMkLst>
        </pc:spChg>
        <pc:spChg chg="mod">
          <ac:chgData name="Reza Amini Hounejani" userId="36cb0b73-58b2-4568-a1ab-00cd49301806" providerId="ADAL" clId="{DA8FEA81-1A63-884F-A1C6-520C766F400F}" dt="2022-10-17T13:00:01.939" v="3447" actId="465"/>
          <ac:spMkLst>
            <pc:docMk/>
            <pc:sldMk cId="3807795133" sldId="257"/>
            <ac:spMk id="93" creationId="{ACA20924-00A4-C904-9376-8EB6B81F1590}"/>
          </ac:spMkLst>
        </pc:spChg>
        <pc:spChg chg="mod">
          <ac:chgData name="Reza Amini Hounejani" userId="36cb0b73-58b2-4568-a1ab-00cd49301806" providerId="ADAL" clId="{DA8FEA81-1A63-884F-A1C6-520C766F400F}" dt="2022-10-17T13:00:32.494" v="3457" actId="553"/>
          <ac:spMkLst>
            <pc:docMk/>
            <pc:sldMk cId="3807795133" sldId="257"/>
            <ac:spMk id="94" creationId="{23E63B4D-ED85-E34A-BAA5-18DD9B13BFA0}"/>
          </ac:spMkLst>
        </pc:spChg>
        <pc:spChg chg="mod">
          <ac:chgData name="Reza Amini Hounejani" userId="36cb0b73-58b2-4568-a1ab-00cd49301806" providerId="ADAL" clId="{DA8FEA81-1A63-884F-A1C6-520C766F400F}" dt="2022-10-17T13:00:32.494" v="3457" actId="553"/>
          <ac:spMkLst>
            <pc:docMk/>
            <pc:sldMk cId="3807795133" sldId="257"/>
            <ac:spMk id="95" creationId="{F3BAF562-E758-F420-8E1B-276BFEEDA723}"/>
          </ac:spMkLst>
        </pc:spChg>
        <pc:spChg chg="mod">
          <ac:chgData name="Reza Amini Hounejani" userId="36cb0b73-58b2-4568-a1ab-00cd49301806" providerId="ADAL" clId="{DA8FEA81-1A63-884F-A1C6-520C766F400F}" dt="2022-10-17T13:00:32.494" v="3457" actId="553"/>
          <ac:spMkLst>
            <pc:docMk/>
            <pc:sldMk cId="3807795133" sldId="257"/>
            <ac:spMk id="96" creationId="{1CAC377A-DA49-6FAF-AB23-33C0D7973093}"/>
          </ac:spMkLst>
        </pc:spChg>
        <pc:spChg chg="mod">
          <ac:chgData name="Reza Amini Hounejani" userId="36cb0b73-58b2-4568-a1ab-00cd49301806" providerId="ADAL" clId="{DA8FEA81-1A63-884F-A1C6-520C766F400F}" dt="2022-10-17T13:00:01.939" v="3447" actId="465"/>
          <ac:spMkLst>
            <pc:docMk/>
            <pc:sldMk cId="3807795133" sldId="257"/>
            <ac:spMk id="100" creationId="{8EB5D91D-24E9-D018-AA6F-FD2A5A2FD887}"/>
          </ac:spMkLst>
        </pc:spChg>
        <pc:spChg chg="mod">
          <ac:chgData name="Reza Amini Hounejani" userId="36cb0b73-58b2-4568-a1ab-00cd49301806" providerId="ADAL" clId="{DA8FEA81-1A63-884F-A1C6-520C766F400F}" dt="2022-11-16T12:42:45.248" v="9129" actId="1036"/>
          <ac:spMkLst>
            <pc:docMk/>
            <pc:sldMk cId="3807795133" sldId="257"/>
            <ac:spMk id="102" creationId="{EEF5620F-420D-5557-1117-0DD3EC425541}"/>
          </ac:spMkLst>
        </pc:spChg>
        <pc:spChg chg="mod">
          <ac:chgData name="Reza Amini Hounejani" userId="36cb0b73-58b2-4568-a1ab-00cd49301806" providerId="ADAL" clId="{DA8FEA81-1A63-884F-A1C6-520C766F400F}" dt="2022-11-16T12:42:45.248" v="9129" actId="1036"/>
          <ac:spMkLst>
            <pc:docMk/>
            <pc:sldMk cId="3807795133" sldId="257"/>
            <ac:spMk id="103" creationId="{8ADD5378-CF27-564C-1606-A0504A8791A0}"/>
          </ac:spMkLst>
        </pc:spChg>
        <pc:spChg chg="mod">
          <ac:chgData name="Reza Amini Hounejani" userId="36cb0b73-58b2-4568-a1ab-00cd49301806" providerId="ADAL" clId="{DA8FEA81-1A63-884F-A1C6-520C766F400F}" dt="2022-11-16T12:42:45.248" v="9129" actId="1036"/>
          <ac:spMkLst>
            <pc:docMk/>
            <pc:sldMk cId="3807795133" sldId="257"/>
            <ac:spMk id="104" creationId="{D2BAB149-F14F-8A41-3E71-B703901BAA1B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05" creationId="{9D3970CC-C233-BD3A-DB84-4EA962030C55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16" creationId="{74C7C444-900A-2A4D-A478-D3244E7D277F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17" creationId="{5EFA5620-F03D-8CEB-7B04-0CA1C8E01D6C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18" creationId="{29775CF6-0094-0796-E0F3-73AD982BC472}"/>
          </ac:spMkLst>
        </pc:spChg>
        <pc:spChg chg="mod">
          <ac:chgData name="Reza Amini Hounejani" userId="36cb0b73-58b2-4568-a1ab-00cd49301806" providerId="ADAL" clId="{DA8FEA81-1A63-884F-A1C6-520C766F400F}" dt="2022-11-16T12:42:45.248" v="9129" actId="1036"/>
          <ac:spMkLst>
            <pc:docMk/>
            <pc:sldMk cId="3807795133" sldId="257"/>
            <ac:spMk id="119" creationId="{39CE5D3E-6334-3B83-DD21-50631A1D545C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20" creationId="{B28510EF-4059-9D6A-14A4-D474B99EB44C}"/>
          </ac:spMkLst>
        </pc:spChg>
        <pc:spChg chg="mod">
          <ac:chgData name="Reza Amini Hounejani" userId="36cb0b73-58b2-4568-a1ab-00cd49301806" providerId="ADAL" clId="{DA8FEA81-1A63-884F-A1C6-520C766F400F}" dt="2022-11-16T12:42:45.248" v="9129" actId="1036"/>
          <ac:spMkLst>
            <pc:docMk/>
            <pc:sldMk cId="3807795133" sldId="257"/>
            <ac:spMk id="121" creationId="{D67E7A32-3F75-45C8-A552-E76573C7286C}"/>
          </ac:spMkLst>
        </pc:spChg>
        <pc:spChg chg="mod">
          <ac:chgData name="Reza Amini Hounejani" userId="36cb0b73-58b2-4568-a1ab-00cd49301806" providerId="ADAL" clId="{DA8FEA81-1A63-884F-A1C6-520C766F400F}" dt="2022-10-17T13:00:32.494" v="3457" actId="553"/>
          <ac:spMkLst>
            <pc:docMk/>
            <pc:sldMk cId="3807795133" sldId="257"/>
            <ac:spMk id="124" creationId="{3A20BC98-01F5-DF2C-E143-24A6198B06A2}"/>
          </ac:spMkLst>
        </pc:spChg>
        <pc:spChg chg="mod">
          <ac:chgData name="Reza Amini Hounejani" userId="36cb0b73-58b2-4568-a1ab-00cd49301806" providerId="ADAL" clId="{DA8FEA81-1A63-884F-A1C6-520C766F400F}" dt="2022-10-17T13:00:32.494" v="3457" actId="553"/>
          <ac:spMkLst>
            <pc:docMk/>
            <pc:sldMk cId="3807795133" sldId="257"/>
            <ac:spMk id="125" creationId="{257506DC-0463-8719-E77E-9F60A0833617}"/>
          </ac:spMkLst>
        </pc:spChg>
        <pc:spChg chg="mod">
          <ac:chgData name="Reza Amini Hounejani" userId="36cb0b73-58b2-4568-a1ab-00cd49301806" providerId="ADAL" clId="{DA8FEA81-1A63-884F-A1C6-520C766F400F}" dt="2022-10-17T13:00:32.494" v="3457" actId="553"/>
          <ac:spMkLst>
            <pc:docMk/>
            <pc:sldMk cId="3807795133" sldId="257"/>
            <ac:spMk id="128" creationId="{41CD90DA-34E5-2D42-513C-08A116D13CF8}"/>
          </ac:spMkLst>
        </pc:spChg>
        <pc:spChg chg="mod">
          <ac:chgData name="Reza Amini Hounejani" userId="36cb0b73-58b2-4568-a1ab-00cd49301806" providerId="ADAL" clId="{DA8FEA81-1A63-884F-A1C6-520C766F400F}" dt="2022-11-16T12:46:32.545" v="9180" actId="1076"/>
          <ac:spMkLst>
            <pc:docMk/>
            <pc:sldMk cId="3807795133" sldId="257"/>
            <ac:spMk id="130" creationId="{FF7AF054-6C2E-E7FC-2CCD-959B1F65C1E8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31" creationId="{E84FE0B5-160F-631A-82FA-E3971B0D5B04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32" creationId="{88B8D86E-BE7D-D8AE-01B5-4F601C99AA62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33" creationId="{029CE293-B2A1-8287-7B33-48F97F24AEFD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38" creationId="{93B9D700-E22B-D634-73F5-65CE7A1D4A3E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39" creationId="{0B583D7D-2054-C37D-36E2-2A1F96961FDE}"/>
          </ac:spMkLst>
        </pc:spChg>
        <pc:spChg chg="mod">
          <ac:chgData name="Reza Amini Hounejani" userId="36cb0b73-58b2-4568-a1ab-00cd49301806" providerId="ADAL" clId="{DA8FEA81-1A63-884F-A1C6-520C766F400F}" dt="2022-11-25T13:16:03.893" v="11905" actId="553"/>
          <ac:spMkLst>
            <pc:docMk/>
            <pc:sldMk cId="3807795133" sldId="257"/>
            <ac:spMk id="140" creationId="{0D0A8F49-FF21-E60F-C312-D7D6A18E5E7B}"/>
          </ac:spMkLst>
        </pc:spChg>
        <pc:spChg chg="mod">
          <ac:chgData name="Reza Amini Hounejani" userId="36cb0b73-58b2-4568-a1ab-00cd49301806" providerId="ADAL" clId="{DA8FEA81-1A63-884F-A1C6-520C766F400F}" dt="2022-11-25T13:16:08.931" v="11906" actId="1076"/>
          <ac:spMkLst>
            <pc:docMk/>
            <pc:sldMk cId="3807795133" sldId="257"/>
            <ac:spMk id="141" creationId="{E51EB36D-9350-3764-F0B5-5D809C17C503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51" creationId="{E38F4969-2547-221D-FD86-D20964C98BA9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52" creationId="{63811DB2-352A-AAD8-7195-96320ADE20A8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65" creationId="{84DE303E-259A-FA1B-75BE-792FB6743CEB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66" creationId="{4B70E5A2-28D1-E1FE-2E62-32E0A350CA93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88" creationId="{12D0E3F4-5C0C-D4A8-70E4-5C606352EB21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93" creationId="{2920B01A-0EF2-B6DA-7F3A-7C61E6853436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95" creationId="{98533860-4299-414D-4B8D-71F60117D3BD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96" creationId="{C0868157-689F-8424-FD1F-52E6C1EBF7FF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97" creationId="{C7818400-CF58-DC06-E17A-603C81013C84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98" creationId="{CB39F103-815C-D2DD-3DE4-8F5E134215EF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199" creationId="{1A404AFE-7C17-22A6-5838-601F3E4E0909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205" creationId="{9F2B51A1-9761-CB95-1CC5-0B563A7C9772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211" creationId="{B644D3C8-4342-5E08-5DD7-F58195F1546D}"/>
          </ac:spMkLst>
        </pc:spChg>
        <pc:spChg chg="mod">
          <ac:chgData name="Reza Amini Hounejani" userId="36cb0b73-58b2-4568-a1ab-00cd49301806" providerId="ADAL" clId="{DA8FEA81-1A63-884F-A1C6-520C766F400F}" dt="2022-11-16T12:42:20.165" v="9114" actId="1036"/>
          <ac:spMkLst>
            <pc:docMk/>
            <pc:sldMk cId="3807795133" sldId="257"/>
            <ac:spMk id="212" creationId="{4A0AA26D-2B49-1B2A-20D3-979D749617AD}"/>
          </ac:spMkLst>
        </pc:spChg>
        <pc:grpChg chg="mod">
          <ac:chgData name="Reza Amini Hounejani" userId="36cb0b73-58b2-4568-a1ab-00cd49301806" providerId="ADAL" clId="{DA8FEA81-1A63-884F-A1C6-520C766F400F}" dt="2022-11-16T12:40:07.970" v="9059" actId="164"/>
          <ac:grpSpMkLst>
            <pc:docMk/>
            <pc:sldMk cId="3807795133" sldId="257"/>
            <ac:grpSpMk id="6" creationId="{91BA0912-FB72-44AE-DD43-D4881CC1EB85}"/>
          </ac:grpSpMkLst>
        </pc:grpChg>
        <pc:grpChg chg="mod">
          <ac:chgData name="Reza Amini Hounejani" userId="36cb0b73-58b2-4568-a1ab-00cd49301806" providerId="ADAL" clId="{DA8FEA81-1A63-884F-A1C6-520C766F400F}" dt="2022-10-17T13:00:01.939" v="3447" actId="465"/>
          <ac:grpSpMkLst>
            <pc:docMk/>
            <pc:sldMk cId="3807795133" sldId="257"/>
            <ac:grpSpMk id="8" creationId="{065F466C-0FBA-5A40-A16A-EAF95BE386E2}"/>
          </ac:grpSpMkLst>
        </pc:grpChg>
        <pc:grpChg chg="add mod">
          <ac:chgData name="Reza Amini Hounejani" userId="36cb0b73-58b2-4568-a1ab-00cd49301806" providerId="ADAL" clId="{DA8FEA81-1A63-884F-A1C6-520C766F400F}" dt="2022-11-15T11:26:37.313" v="8745" actId="1076"/>
          <ac:grpSpMkLst>
            <pc:docMk/>
            <pc:sldMk cId="3807795133" sldId="257"/>
            <ac:grpSpMk id="15" creationId="{C84B2CAA-8B73-AD94-4AAB-7C88896E4D7A}"/>
          </ac:grpSpMkLst>
        </pc:grpChg>
        <pc:grpChg chg="mod">
          <ac:chgData name="Reza Amini Hounejani" userId="36cb0b73-58b2-4568-a1ab-00cd49301806" providerId="ADAL" clId="{DA8FEA81-1A63-884F-A1C6-520C766F400F}" dt="2022-11-16T12:42:20.165" v="9114" actId="1036"/>
          <ac:grpSpMkLst>
            <pc:docMk/>
            <pc:sldMk cId="3807795133" sldId="257"/>
            <ac:grpSpMk id="19" creationId="{82B5B672-5E64-ABDB-5DB1-C8BFBBD32D8C}"/>
          </ac:grpSpMkLst>
        </pc:grpChg>
        <pc:grpChg chg="add mod">
          <ac:chgData name="Reza Amini Hounejani" userId="36cb0b73-58b2-4568-a1ab-00cd49301806" providerId="ADAL" clId="{DA8FEA81-1A63-884F-A1C6-520C766F400F}" dt="2022-11-15T12:55:11.868" v="8872" actId="338"/>
          <ac:grpSpMkLst>
            <pc:docMk/>
            <pc:sldMk cId="3807795133" sldId="257"/>
            <ac:grpSpMk id="27" creationId="{65DD4465-0F0B-0ED8-5821-DE535E625D97}"/>
          </ac:grpSpMkLst>
        </pc:grpChg>
        <pc:grpChg chg="del">
          <ac:chgData name="Reza Amini Hounejani" userId="36cb0b73-58b2-4568-a1ab-00cd49301806" providerId="ADAL" clId="{DA8FEA81-1A63-884F-A1C6-520C766F400F}" dt="2022-09-12T17:11:19.743" v="2307" actId="478"/>
          <ac:grpSpMkLst>
            <pc:docMk/>
            <pc:sldMk cId="3807795133" sldId="257"/>
            <ac:grpSpMk id="30" creationId="{3D102283-BD35-3AF3-74C7-E447722B17D6}"/>
          </ac:grpSpMkLst>
        </pc:grpChg>
        <pc:grpChg chg="add mod">
          <ac:chgData name="Reza Amini Hounejani" userId="36cb0b73-58b2-4568-a1ab-00cd49301806" providerId="ADAL" clId="{DA8FEA81-1A63-884F-A1C6-520C766F400F}" dt="2022-11-16T12:40:07.970" v="9059" actId="164"/>
          <ac:grpSpMkLst>
            <pc:docMk/>
            <pc:sldMk cId="3807795133" sldId="257"/>
            <ac:grpSpMk id="30" creationId="{D6BB755B-FB79-E2F2-45AE-EF0B59652CE8}"/>
          </ac:grpSpMkLst>
        </pc:grpChg>
        <pc:grpChg chg="mod">
          <ac:chgData name="Reza Amini Hounejani" userId="36cb0b73-58b2-4568-a1ab-00cd49301806" providerId="ADAL" clId="{DA8FEA81-1A63-884F-A1C6-520C766F400F}" dt="2022-11-16T12:41:27.413" v="9061" actId="571"/>
          <ac:grpSpMkLst>
            <pc:docMk/>
            <pc:sldMk cId="3807795133" sldId="257"/>
            <ac:grpSpMk id="48" creationId="{38AE917F-27CC-BF71-4505-27A988EBF168}"/>
          </ac:grpSpMkLst>
        </pc:grpChg>
        <pc:grpChg chg="mod">
          <ac:chgData name="Reza Amini Hounejani" userId="36cb0b73-58b2-4568-a1ab-00cd49301806" providerId="ADAL" clId="{DA8FEA81-1A63-884F-A1C6-520C766F400F}" dt="2022-11-16T12:46:44.773" v="9185" actId="1076"/>
          <ac:grpSpMkLst>
            <pc:docMk/>
            <pc:sldMk cId="3807795133" sldId="257"/>
            <ac:grpSpMk id="114" creationId="{854B7728-D593-6273-BDEB-C7208C65AF65}"/>
          </ac:grpSpMkLst>
        </pc:grpChg>
        <pc:grpChg chg="del">
          <ac:chgData name="Reza Amini Hounejani" userId="36cb0b73-58b2-4568-a1ab-00cd49301806" providerId="ADAL" clId="{DA8FEA81-1A63-884F-A1C6-520C766F400F}" dt="2022-11-15T12:57:25.362" v="8902" actId="165"/>
          <ac:grpSpMkLst>
            <pc:docMk/>
            <pc:sldMk cId="3807795133" sldId="257"/>
            <ac:grpSpMk id="127" creationId="{58592A83-BDA1-F83A-DFA9-D43138E46E36}"/>
          </ac:grpSpMkLst>
        </pc:grpChg>
        <pc:grpChg chg="mod">
          <ac:chgData name="Reza Amini Hounejani" userId="36cb0b73-58b2-4568-a1ab-00cd49301806" providerId="ADAL" clId="{DA8FEA81-1A63-884F-A1C6-520C766F400F}" dt="2022-11-25T13:16:03.893" v="11905" actId="553"/>
          <ac:grpSpMkLst>
            <pc:docMk/>
            <pc:sldMk cId="3807795133" sldId="257"/>
            <ac:grpSpMk id="146" creationId="{028555C9-2DD8-73A5-FE94-D44D1A059458}"/>
          </ac:grpSpMkLst>
        </pc:grpChg>
        <pc:grpChg chg="del">
          <ac:chgData name="Reza Amini Hounejani" userId="36cb0b73-58b2-4568-a1ab-00cd49301806" providerId="ADAL" clId="{DA8FEA81-1A63-884F-A1C6-520C766F400F}" dt="2022-11-15T12:54:48.987" v="8869" actId="165"/>
          <ac:grpSpMkLst>
            <pc:docMk/>
            <pc:sldMk cId="3807795133" sldId="257"/>
            <ac:grpSpMk id="160" creationId="{A5B69715-A855-CE45-A641-038804999D5B}"/>
          </ac:grpSpMkLst>
        </pc:grpChg>
        <pc:grpChg chg="mod">
          <ac:chgData name="Reza Amini Hounejani" userId="36cb0b73-58b2-4568-a1ab-00cd49301806" providerId="ADAL" clId="{DA8FEA81-1A63-884F-A1C6-520C766F400F}" dt="2022-10-17T13:00:01.939" v="3447" actId="465"/>
          <ac:grpSpMkLst>
            <pc:docMk/>
            <pc:sldMk cId="3807795133" sldId="257"/>
            <ac:grpSpMk id="170" creationId="{CBD9AB49-6810-D4D2-D4E6-0B88D5A9AEC5}"/>
          </ac:grpSpMkLst>
        </pc:grpChg>
        <pc:grpChg chg="add del mod">
          <ac:chgData name="Reza Amini Hounejani" userId="36cb0b73-58b2-4568-a1ab-00cd49301806" providerId="ADAL" clId="{DA8FEA81-1A63-884F-A1C6-520C766F400F}" dt="2022-09-19T08:28:25.148" v="2492" actId="164"/>
          <ac:grpSpMkLst>
            <pc:docMk/>
            <pc:sldMk cId="3807795133" sldId="257"/>
            <ac:grpSpMk id="176" creationId="{398B3B8C-9D99-8DFF-6BF0-4EEC6025B184}"/>
          </ac:grpSpMkLst>
        </pc:grpChg>
        <pc:graphicFrameChg chg="del">
          <ac:chgData name="Reza Amini Hounejani" userId="36cb0b73-58b2-4568-a1ab-00cd49301806" providerId="ADAL" clId="{DA8FEA81-1A63-884F-A1C6-520C766F400F}" dt="2022-07-26T14:06:09.237" v="604" actId="478"/>
          <ac:graphicFrameMkLst>
            <pc:docMk/>
            <pc:sldMk cId="3807795133" sldId="257"/>
            <ac:graphicFrameMk id="53" creationId="{79322779-3582-5C36-9DAA-228768CCC352}"/>
          </ac:graphicFrameMkLst>
        </pc:graphicFrameChg>
        <pc:picChg chg="mod">
          <ac:chgData name="Reza Amini Hounejani" userId="36cb0b73-58b2-4568-a1ab-00cd49301806" providerId="ADAL" clId="{DA8FEA81-1A63-884F-A1C6-520C766F400F}" dt="2022-10-17T13:00:01.939" v="3447" actId="465"/>
          <ac:picMkLst>
            <pc:docMk/>
            <pc:sldMk cId="3807795133" sldId="257"/>
            <ac:picMk id="3" creationId="{68AC0835-4B2C-B482-765B-22DA70532A3E}"/>
          </ac:picMkLst>
        </pc:picChg>
        <pc:picChg chg="add mod modCrop">
          <ac:chgData name="Reza Amini Hounejani" userId="36cb0b73-58b2-4568-a1ab-00cd49301806" providerId="ADAL" clId="{DA8FEA81-1A63-884F-A1C6-520C766F400F}" dt="2022-09-19T08:28:25.148" v="2492" actId="164"/>
          <ac:picMkLst>
            <pc:docMk/>
            <pc:sldMk cId="3807795133" sldId="257"/>
            <ac:picMk id="10" creationId="{5B85FC4A-DA68-7C13-0921-45082C54CD1B}"/>
          </ac:picMkLst>
        </pc:picChg>
        <pc:picChg chg="mod">
          <ac:chgData name="Reza Amini Hounejani" userId="36cb0b73-58b2-4568-a1ab-00cd49301806" providerId="ADAL" clId="{DA8FEA81-1A63-884F-A1C6-520C766F400F}" dt="2022-11-16T12:42:45.248" v="9129" actId="1036"/>
          <ac:picMkLst>
            <pc:docMk/>
            <pc:sldMk cId="3807795133" sldId="257"/>
            <ac:picMk id="34" creationId="{5DA50423-2210-3E15-BCD6-042FAD5171BE}"/>
          </ac:picMkLst>
        </pc:picChg>
        <pc:picChg chg="mod">
          <ac:chgData name="Reza Amini Hounejani" userId="36cb0b73-58b2-4568-a1ab-00cd49301806" providerId="ADAL" clId="{DA8FEA81-1A63-884F-A1C6-520C766F400F}" dt="2022-11-16T12:42:45.248" v="9129" actId="1036"/>
          <ac:picMkLst>
            <pc:docMk/>
            <pc:sldMk cId="3807795133" sldId="257"/>
            <ac:picMk id="36" creationId="{0C003F63-D5DB-758C-21F4-BF655067E0AA}"/>
          </ac:picMkLst>
        </pc:picChg>
        <pc:picChg chg="mod">
          <ac:chgData name="Reza Amini Hounejani" userId="36cb0b73-58b2-4568-a1ab-00cd49301806" providerId="ADAL" clId="{DA8FEA81-1A63-884F-A1C6-520C766F400F}" dt="2022-11-16T12:42:45.248" v="9129" actId="1036"/>
          <ac:picMkLst>
            <pc:docMk/>
            <pc:sldMk cId="3807795133" sldId="257"/>
            <ac:picMk id="44" creationId="{E04F85A0-CAE9-24D9-0DD4-56543F3CA0C9}"/>
          </ac:picMkLst>
        </pc:picChg>
        <pc:picChg chg="mod">
          <ac:chgData name="Reza Amini Hounejani" userId="36cb0b73-58b2-4568-a1ab-00cd49301806" providerId="ADAL" clId="{DA8FEA81-1A63-884F-A1C6-520C766F400F}" dt="2022-11-16T12:42:20.165" v="9114" actId="1036"/>
          <ac:picMkLst>
            <pc:docMk/>
            <pc:sldMk cId="3807795133" sldId="257"/>
            <ac:picMk id="108" creationId="{49967FB9-88D6-EAA0-0F2C-9E4ECD9F6CF3}"/>
          </ac:picMkLst>
        </pc:picChg>
        <pc:picChg chg="mod">
          <ac:chgData name="Reza Amini Hounejani" userId="36cb0b73-58b2-4568-a1ab-00cd49301806" providerId="ADAL" clId="{DA8FEA81-1A63-884F-A1C6-520C766F400F}" dt="2022-11-16T12:42:20.165" v="9114" actId="1036"/>
          <ac:picMkLst>
            <pc:docMk/>
            <pc:sldMk cId="3807795133" sldId="257"/>
            <ac:picMk id="110" creationId="{0CB73E1F-05A5-0C1F-7875-14BF884F1AA3}"/>
          </ac:picMkLst>
        </pc:picChg>
        <pc:picChg chg="mod topLvl">
          <ac:chgData name="Reza Amini Hounejani" userId="36cb0b73-58b2-4568-a1ab-00cd49301806" providerId="ADAL" clId="{DA8FEA81-1A63-884F-A1C6-520C766F400F}" dt="2022-11-16T12:42:20.165" v="9114" actId="1036"/>
          <ac:picMkLst>
            <pc:docMk/>
            <pc:sldMk cId="3807795133" sldId="257"/>
            <ac:picMk id="123" creationId="{0680565A-89A0-B172-62BB-1A0AEC1B75ED}"/>
          </ac:picMkLst>
        </pc:picChg>
        <pc:picChg chg="mod">
          <ac:chgData name="Reza Amini Hounejani" userId="36cb0b73-58b2-4568-a1ab-00cd49301806" providerId="ADAL" clId="{DA8FEA81-1A63-884F-A1C6-520C766F400F}" dt="2022-11-16T12:42:20.165" v="9114" actId="1036"/>
          <ac:picMkLst>
            <pc:docMk/>
            <pc:sldMk cId="3807795133" sldId="257"/>
            <ac:picMk id="135" creationId="{47CCBAAF-984A-6510-7073-01EDD0B7C0C2}"/>
          </ac:picMkLst>
        </pc:picChg>
        <pc:picChg chg="mod">
          <ac:chgData name="Reza Amini Hounejani" userId="36cb0b73-58b2-4568-a1ab-00cd49301806" providerId="ADAL" clId="{DA8FEA81-1A63-884F-A1C6-520C766F400F}" dt="2022-11-16T12:42:20.165" v="9114" actId="1036"/>
          <ac:picMkLst>
            <pc:docMk/>
            <pc:sldMk cId="3807795133" sldId="257"/>
            <ac:picMk id="137" creationId="{B95F82F8-7E40-BAC4-E4F4-FCE8BA021A75}"/>
          </ac:picMkLst>
        </pc:picChg>
        <pc:picChg chg="mod">
          <ac:chgData name="Reza Amini Hounejani" userId="36cb0b73-58b2-4568-a1ab-00cd49301806" providerId="ADAL" clId="{DA8FEA81-1A63-884F-A1C6-520C766F400F}" dt="2022-11-16T12:42:20.165" v="9114" actId="1036"/>
          <ac:picMkLst>
            <pc:docMk/>
            <pc:sldMk cId="3807795133" sldId="257"/>
            <ac:picMk id="148" creationId="{49F98925-74BD-D349-EAB9-C8E37431BE79}"/>
          </ac:picMkLst>
        </pc:picChg>
        <pc:picChg chg="mod">
          <ac:chgData name="Reza Amini Hounejani" userId="36cb0b73-58b2-4568-a1ab-00cd49301806" providerId="ADAL" clId="{DA8FEA81-1A63-884F-A1C6-520C766F400F}" dt="2022-11-16T12:42:20.165" v="9114" actId="1036"/>
          <ac:picMkLst>
            <pc:docMk/>
            <pc:sldMk cId="3807795133" sldId="257"/>
            <ac:picMk id="150" creationId="{0D16E117-2A1D-2D08-BD1A-60FC744F8732}"/>
          </ac:picMkLst>
        </pc:picChg>
        <pc:picChg chg="mod topLvl">
          <ac:chgData name="Reza Amini Hounejani" userId="36cb0b73-58b2-4568-a1ab-00cd49301806" providerId="ADAL" clId="{DA8FEA81-1A63-884F-A1C6-520C766F400F}" dt="2022-11-16T12:42:20.165" v="9114" actId="1036"/>
          <ac:picMkLst>
            <pc:docMk/>
            <pc:sldMk cId="3807795133" sldId="257"/>
            <ac:picMk id="159" creationId="{9BCD7266-4DC7-FEE7-E9F5-7EB20D10E7B2}"/>
          </ac:picMkLst>
        </pc:picChg>
        <pc:picChg chg="mod">
          <ac:chgData name="Reza Amini Hounejani" userId="36cb0b73-58b2-4568-a1ab-00cd49301806" providerId="ADAL" clId="{DA8FEA81-1A63-884F-A1C6-520C766F400F}" dt="2022-11-16T12:42:20.165" v="9114" actId="1036"/>
          <ac:picMkLst>
            <pc:docMk/>
            <pc:sldMk cId="3807795133" sldId="257"/>
            <ac:picMk id="162" creationId="{A2C4E785-170D-84AA-8F6A-65477800B705}"/>
          </ac:picMkLst>
        </pc:picChg>
        <pc:picChg chg="mod">
          <ac:chgData name="Reza Amini Hounejani" userId="36cb0b73-58b2-4568-a1ab-00cd49301806" providerId="ADAL" clId="{DA8FEA81-1A63-884F-A1C6-520C766F400F}" dt="2022-11-16T12:42:20.165" v="9114" actId="1036"/>
          <ac:picMkLst>
            <pc:docMk/>
            <pc:sldMk cId="3807795133" sldId="257"/>
            <ac:picMk id="164" creationId="{7A7A998C-D13A-EBA5-F10B-3EDCAE9A43D2}"/>
          </ac:picMkLst>
        </pc:picChg>
        <pc:picChg chg="del">
          <ac:chgData name="Reza Amini Hounejani" userId="36cb0b73-58b2-4568-a1ab-00cd49301806" providerId="ADAL" clId="{DA8FEA81-1A63-884F-A1C6-520C766F400F}" dt="2022-09-19T08:26:14.816" v="2450" actId="478"/>
          <ac:picMkLst>
            <pc:docMk/>
            <pc:sldMk cId="3807795133" sldId="257"/>
            <ac:picMk id="168" creationId="{BF01D7D8-0B99-55B9-00C2-0462B04BB0C2}"/>
          </ac:picMkLst>
        </pc:pic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12" creationId="{A7145383-571D-2504-D35B-9865FD800E98}"/>
          </ac:cxnSpMkLst>
        </pc:cxn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13" creationId="{0720EE35-B132-6160-82F1-3B0C4E4B4EE1}"/>
          </ac:cxnSpMkLst>
        </pc:cxnChg>
        <pc:cxnChg chg="mod">
          <ac:chgData name="Reza Amini Hounejani" userId="36cb0b73-58b2-4568-a1ab-00cd49301806" providerId="ADAL" clId="{DA8FEA81-1A63-884F-A1C6-520C766F400F}" dt="2022-11-16T12:42:45.248" v="9129" actId="1036"/>
          <ac:cxnSpMkLst>
            <pc:docMk/>
            <pc:sldMk cId="3807795133" sldId="257"/>
            <ac:cxnSpMk id="14" creationId="{86E68FC2-DE3D-45AA-4A4B-0728E3F31CE8}"/>
          </ac:cxnSpMkLst>
        </pc:cxnChg>
        <pc:cxnChg chg="del mod">
          <ac:chgData name="Reza Amini Hounejani" userId="36cb0b73-58b2-4568-a1ab-00cd49301806" providerId="ADAL" clId="{DA8FEA81-1A63-884F-A1C6-520C766F400F}" dt="2022-11-16T12:44:03.476" v="9136" actId="478"/>
          <ac:cxnSpMkLst>
            <pc:docMk/>
            <pc:sldMk cId="3807795133" sldId="257"/>
            <ac:cxnSpMk id="16" creationId="{F98DF14B-264F-23AE-4386-6983C4AB740D}"/>
          </ac:cxnSpMkLst>
        </pc:cxn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17" creationId="{7AC16CB8-3254-8987-9F63-021BA829CFC3}"/>
          </ac:cxnSpMkLst>
        </pc:cxnChg>
        <pc:cxnChg chg="mod topLvl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18" creationId="{B163FB57-E868-E242-BA81-8DB98A8957D5}"/>
          </ac:cxnSpMkLst>
        </pc:cxn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21" creationId="{ED1B71D5-6B54-D9B5-F4F4-B23DBFB6511D}"/>
          </ac:cxnSpMkLst>
        </pc:cxn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22" creationId="{228ECB94-69AC-D710-3471-B977943329B8}"/>
          </ac:cxnSpMkLst>
        </pc:cxnChg>
        <pc:cxnChg chg="mod">
          <ac:chgData name="Reza Amini Hounejani" userId="36cb0b73-58b2-4568-a1ab-00cd49301806" providerId="ADAL" clId="{DA8FEA81-1A63-884F-A1C6-520C766F400F}" dt="2022-11-16T12:27:56.592" v="8910" actId="14100"/>
          <ac:cxnSpMkLst>
            <pc:docMk/>
            <pc:sldMk cId="3807795133" sldId="257"/>
            <ac:cxnSpMk id="23" creationId="{DD7CA5C6-C913-A843-947C-49CEA02FDED7}"/>
          </ac:cxnSpMkLst>
        </pc:cxn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24" creationId="{3570F4CD-E1D9-21EA-50AE-5121F975348C}"/>
          </ac:cxnSpMkLst>
        </pc:cxn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25" creationId="{91D70CB6-ADCE-E213-5946-C3B36EC6E1D7}"/>
          </ac:cxnSpMkLst>
        </pc:cxn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26" creationId="{BD06CE01-D2DF-33BB-F0C5-7030C420FEA2}"/>
          </ac:cxnSpMkLst>
        </pc:cxn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29" creationId="{70AF433F-6D51-3BF2-31EC-6E7C6A4C7EBD}"/>
          </ac:cxnSpMkLst>
        </pc:cxn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33" creationId="{9162808B-CFF5-D4ED-B932-D9E392E14243}"/>
          </ac:cxnSpMkLst>
        </pc:cxn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35" creationId="{2BEC1BE7-35F7-8D9E-6BAC-6A3D391BF2C5}"/>
          </ac:cxnSpMkLst>
        </pc:cxn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37" creationId="{5DDE473E-1679-E28F-B2AC-3D93AEECFADE}"/>
          </ac:cxnSpMkLst>
        </pc:cxn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38" creationId="{F8D96074-3DFE-E77F-FC2C-9965953D10C7}"/>
          </ac:cxnSpMkLst>
        </pc:cxnChg>
        <pc:cxnChg chg="add 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41" creationId="{CF4A1FF8-515C-7526-3A40-58595C957DA4}"/>
          </ac:cxnSpMkLst>
        </pc:cxnChg>
        <pc:cxnChg chg="add del mod">
          <ac:chgData name="Reza Amini Hounejani" userId="36cb0b73-58b2-4568-a1ab-00cd49301806" providerId="ADAL" clId="{DA8FEA81-1A63-884F-A1C6-520C766F400F}" dt="2022-11-15T13:10:35.683" v="8906" actId="478"/>
          <ac:cxnSpMkLst>
            <pc:docMk/>
            <pc:sldMk cId="3807795133" sldId="257"/>
            <ac:cxnSpMk id="49" creationId="{96C9F9E0-527D-AD0F-2A41-6F68C5540552}"/>
          </ac:cxnSpMkLst>
        </pc:cxnChg>
        <pc:cxnChg chg="add mod">
          <ac:chgData name="Reza Amini Hounejani" userId="36cb0b73-58b2-4568-a1ab-00cd49301806" providerId="ADAL" clId="{DA8FEA81-1A63-884F-A1C6-520C766F400F}" dt="2022-11-16T12:44:53.557" v="9158" actId="13822"/>
          <ac:cxnSpMkLst>
            <pc:docMk/>
            <pc:sldMk cId="3807795133" sldId="257"/>
            <ac:cxnSpMk id="54" creationId="{456DA09B-6680-7066-0BBC-89A0CEA1E382}"/>
          </ac:cxnSpMkLst>
        </pc:cxnChg>
        <pc:cxnChg chg="mod">
          <ac:chgData name="Reza Amini Hounejani" userId="36cb0b73-58b2-4568-a1ab-00cd49301806" providerId="ADAL" clId="{DA8FEA81-1A63-884F-A1C6-520C766F400F}" dt="2022-07-19T09:20:44.470" v="11" actId="692"/>
          <ac:cxnSpMkLst>
            <pc:docMk/>
            <pc:sldMk cId="3807795133" sldId="257"/>
            <ac:cxnSpMk id="66" creationId="{00000000-0000-0000-0000-000000000000}"/>
          </ac:cxnSpMkLst>
        </pc:cxnChg>
        <pc:cxnChg chg="add mod">
          <ac:chgData name="Reza Amini Hounejani" userId="36cb0b73-58b2-4568-a1ab-00cd49301806" providerId="ADAL" clId="{DA8FEA81-1A63-884F-A1C6-520C766F400F}" dt="2022-11-16T12:46:35.157" v="9181" actId="14100"/>
          <ac:cxnSpMkLst>
            <pc:docMk/>
            <pc:sldMk cId="3807795133" sldId="257"/>
            <ac:cxnSpMk id="68" creationId="{FA3FDB09-C96C-8D66-6BF1-794340636450}"/>
          </ac:cxnSpMkLst>
        </pc:cxnChg>
        <pc:cxnChg chg="del mod">
          <ac:chgData name="Reza Amini Hounejani" userId="36cb0b73-58b2-4568-a1ab-00cd49301806" providerId="ADAL" clId="{DA8FEA81-1A63-884F-A1C6-520C766F400F}" dt="2022-09-12T17:11:15.212" v="2306" actId="478"/>
          <ac:cxnSpMkLst>
            <pc:docMk/>
            <pc:sldMk cId="3807795133" sldId="257"/>
            <ac:cxnSpMk id="76" creationId="{3449C452-AD09-0BC6-4D5D-11816BABA4D5}"/>
          </ac:cxnSpMkLst>
        </pc:cxnChg>
        <pc:cxnChg chg="mod">
          <ac:chgData name="Reza Amini Hounejani" userId="36cb0b73-58b2-4568-a1ab-00cd49301806" providerId="ADAL" clId="{DA8FEA81-1A63-884F-A1C6-520C766F400F}" dt="2022-09-19T08:45:58.318" v="2503" actId="13822"/>
          <ac:cxnSpMkLst>
            <pc:docMk/>
            <pc:sldMk cId="3807795133" sldId="257"/>
            <ac:cxnSpMk id="86" creationId="{00000000-0000-0000-0000-000000000000}"/>
          </ac:cxnSpMkLst>
        </pc:cxnChg>
        <pc:cxnChg chg="del">
          <ac:chgData name="Reza Amini Hounejani" userId="36cb0b73-58b2-4568-a1ab-00cd49301806" providerId="ADAL" clId="{DA8FEA81-1A63-884F-A1C6-520C766F400F}" dt="2022-09-19T08:27:48.282" v="2469" actId="478"/>
          <ac:cxnSpMkLst>
            <pc:docMk/>
            <pc:sldMk cId="3807795133" sldId="257"/>
            <ac:cxnSpMk id="87" creationId="{00000000-0000-0000-0000-000000000000}"/>
          </ac:cxnSpMkLst>
        </pc:cxnChg>
        <pc:cxnChg chg="mod topLvl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126" creationId="{0F8A1491-2CE0-2D10-3C23-5F3673162403}"/>
          </ac:cxnSpMkLst>
        </pc:cxnChg>
        <pc:cxnChg chg="mod">
          <ac:chgData name="Reza Amini Hounejani" userId="36cb0b73-58b2-4568-a1ab-00cd49301806" providerId="ADAL" clId="{DA8FEA81-1A63-884F-A1C6-520C766F400F}" dt="2022-11-16T12:42:45.248" v="9129" actId="1036"/>
          <ac:cxnSpMkLst>
            <pc:docMk/>
            <pc:sldMk cId="3807795133" sldId="257"/>
            <ac:cxnSpMk id="129" creationId="{B55D6244-A3DA-780B-5903-0EAD8FDD68E3}"/>
          </ac:cxnSpMkLst>
        </pc:cxnChg>
        <pc:cxnChg chg="mod">
          <ac:chgData name="Reza Amini Hounejani" userId="36cb0b73-58b2-4568-a1ab-00cd49301806" providerId="ADAL" clId="{DA8FEA81-1A63-884F-A1C6-520C766F400F}" dt="2022-11-16T12:46:30.511" v="9179" actId="14100"/>
          <ac:cxnSpMkLst>
            <pc:docMk/>
            <pc:sldMk cId="3807795133" sldId="257"/>
            <ac:cxnSpMk id="134" creationId="{F791F198-32C0-893D-688E-401B1BC08D3A}"/>
          </ac:cxnSpMkLst>
        </pc:cxnChg>
        <pc:cxnChg chg="mod">
          <ac:chgData name="Reza Amini Hounejani" userId="36cb0b73-58b2-4568-a1ab-00cd49301806" providerId="ADAL" clId="{DA8FEA81-1A63-884F-A1C6-520C766F400F}" dt="2022-07-19T09:20:44.470" v="11" actId="692"/>
          <ac:cxnSpMkLst>
            <pc:docMk/>
            <pc:sldMk cId="3807795133" sldId="257"/>
            <ac:cxnSpMk id="154" creationId="{755B5EAF-9DA1-B30B-0D3D-EB7F2815F1EB}"/>
          </ac:cxnSpMkLst>
        </pc:cxnChg>
        <pc:cxnChg chg="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186" creationId="{5D96C559-DFD8-624E-140B-644634883CB6}"/>
          </ac:cxnSpMkLst>
        </pc:cxnChg>
        <pc:cxnChg chg="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189" creationId="{942777E5-4352-EAA0-8569-B7ECC4DD6090}"/>
          </ac:cxnSpMkLst>
        </pc:cxnChg>
        <pc:cxnChg chg="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194" creationId="{0456B796-7670-3F9B-6307-228DFFC115ED}"/>
          </ac:cxnSpMkLst>
        </pc:cxnChg>
        <pc:cxnChg chg="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200" creationId="{3C331510-3079-88A2-49DC-1BA40BCE1ED4}"/>
          </ac:cxnSpMkLst>
        </pc:cxnChg>
        <pc:cxnChg chg="mod">
          <ac:chgData name="Reza Amini Hounejani" userId="36cb0b73-58b2-4568-a1ab-00cd49301806" providerId="ADAL" clId="{DA8FEA81-1A63-884F-A1C6-520C766F400F}" dt="2022-11-16T12:42:20.165" v="9114" actId="1036"/>
          <ac:cxnSpMkLst>
            <pc:docMk/>
            <pc:sldMk cId="3807795133" sldId="257"/>
            <ac:cxnSpMk id="208" creationId="{D0709831-0B4D-BDF4-2F87-34106960525F}"/>
          </ac:cxnSpMkLst>
        </pc:cxnChg>
      </pc:sldChg>
      <pc:sldChg chg="addSp delSp modSp mod">
        <pc:chgData name="Reza Amini Hounejani" userId="36cb0b73-58b2-4568-a1ab-00cd49301806" providerId="ADAL" clId="{DA8FEA81-1A63-884F-A1C6-520C766F400F}" dt="2022-11-24T10:24:51.661" v="11672" actId="164"/>
        <pc:sldMkLst>
          <pc:docMk/>
          <pc:sldMk cId="2229082649" sldId="258"/>
        </pc:sldMkLst>
        <pc:spChg chg="add 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2" creationId="{C6A669E1-E5A1-2CE4-CEA3-73203B7F28D5}"/>
          </ac:spMkLst>
        </pc:spChg>
        <pc:spChg chg="mod">
          <ac:chgData name="Reza Amini Hounejani" userId="36cb0b73-58b2-4568-a1ab-00cd49301806" providerId="ADAL" clId="{DA8FEA81-1A63-884F-A1C6-520C766F400F}" dt="2022-11-14T16:25:43.639" v="8661" actId="1076"/>
          <ac:spMkLst>
            <pc:docMk/>
            <pc:sldMk cId="2229082649" sldId="258"/>
            <ac:spMk id="3" creationId="{EEBACB06-9B98-0059-D61A-6E5969354BAC}"/>
          </ac:spMkLst>
        </pc:spChg>
        <pc:spChg chg="mod">
          <ac:chgData name="Reza Amini Hounejani" userId="36cb0b73-58b2-4568-a1ab-00cd49301806" providerId="ADAL" clId="{DA8FEA81-1A63-884F-A1C6-520C766F400F}" dt="2022-11-14T16:25:29.275" v="8658" actId="1076"/>
          <ac:spMkLst>
            <pc:docMk/>
            <pc:sldMk cId="2229082649" sldId="258"/>
            <ac:spMk id="4" creationId="{F2EB4C31-F29C-5285-CDD1-7778E0FA1E63}"/>
          </ac:spMkLst>
        </pc:spChg>
        <pc:spChg chg="add 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6" creationId="{AB9279C2-C2C3-2DAC-3576-B49B3C1D2EC4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7" creationId="{67A0F79B-2246-C629-5722-8D5CD7CB8249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8" creationId="{CD5D677F-E756-3332-DF58-F411201AB986}"/>
          </ac:spMkLst>
        </pc:spChg>
        <pc:spChg chg="add del mod">
          <ac:chgData name="Reza Amini Hounejani" userId="36cb0b73-58b2-4568-a1ab-00cd49301806" providerId="ADAL" clId="{DA8FEA81-1A63-884F-A1C6-520C766F400F}" dt="2022-11-24T10:24:24.227" v="11655" actId="478"/>
          <ac:spMkLst>
            <pc:docMk/>
            <pc:sldMk cId="2229082649" sldId="258"/>
            <ac:spMk id="10" creationId="{1FC7D5DE-87E0-7EB6-DC05-CEC1F2B8F7D8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11" creationId="{0978048D-5901-C5B7-3B4B-023FB62FD2AC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12" creationId="{AAEF71DA-9B7E-CCC6-2335-CB496EFB918B}"/>
          </ac:spMkLst>
        </pc:spChg>
        <pc:spChg chg="mod">
          <ac:chgData name="Reza Amini Hounejani" userId="36cb0b73-58b2-4568-a1ab-00cd49301806" providerId="ADAL" clId="{DA8FEA81-1A63-884F-A1C6-520C766F400F}" dt="2022-07-27T13:06:38.661" v="2105" actId="1076"/>
          <ac:spMkLst>
            <pc:docMk/>
            <pc:sldMk cId="2229082649" sldId="258"/>
            <ac:spMk id="13" creationId="{2AF3E4F1-1499-1065-CEB9-A14D716283B0}"/>
          </ac:spMkLst>
        </pc:spChg>
        <pc:spChg chg="mod">
          <ac:chgData name="Reza Amini Hounejani" userId="36cb0b73-58b2-4568-a1ab-00cd49301806" providerId="ADAL" clId="{DA8FEA81-1A63-884F-A1C6-520C766F400F}" dt="2022-11-14T16:26:42.217" v="8662" actId="1076"/>
          <ac:spMkLst>
            <pc:docMk/>
            <pc:sldMk cId="2229082649" sldId="258"/>
            <ac:spMk id="14" creationId="{3B58E536-25E8-2430-C140-583F2D869296}"/>
          </ac:spMkLst>
        </pc:spChg>
        <pc:spChg chg="mod">
          <ac:chgData name="Reza Amini Hounejani" userId="36cb0b73-58b2-4568-a1ab-00cd49301806" providerId="ADAL" clId="{DA8FEA81-1A63-884F-A1C6-520C766F400F}" dt="2022-11-24T10:24:32.270" v="11670" actId="1035"/>
          <ac:spMkLst>
            <pc:docMk/>
            <pc:sldMk cId="2229082649" sldId="258"/>
            <ac:spMk id="15" creationId="{178C1CCF-C845-3889-DD41-C4ACAA9FD9CD}"/>
          </ac:spMkLst>
        </pc:spChg>
        <pc:spChg chg="add del mod">
          <ac:chgData name="Reza Amini Hounejani" userId="36cb0b73-58b2-4568-a1ab-00cd49301806" providerId="ADAL" clId="{DA8FEA81-1A63-884F-A1C6-520C766F400F}" dt="2022-11-24T10:22:49.197" v="11654" actId="478"/>
          <ac:spMkLst>
            <pc:docMk/>
            <pc:sldMk cId="2229082649" sldId="258"/>
            <ac:spMk id="16" creationId="{43620568-7BF6-D833-6633-EE46CDF050CD}"/>
          </ac:spMkLst>
        </pc:spChg>
        <pc:spChg chg="add 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17" creationId="{7788E153-39E8-5A79-8852-03EADFABB57A}"/>
          </ac:spMkLst>
        </pc:spChg>
        <pc:spChg chg="add del mod">
          <ac:chgData name="Reza Amini Hounejani" userId="36cb0b73-58b2-4568-a1ab-00cd49301806" providerId="ADAL" clId="{DA8FEA81-1A63-884F-A1C6-520C766F400F}" dt="2022-09-19T11:13:43.085" v="2598" actId="478"/>
          <ac:spMkLst>
            <pc:docMk/>
            <pc:sldMk cId="2229082649" sldId="258"/>
            <ac:spMk id="17" creationId="{E526E9BB-0582-ADDE-EBAE-0FC829422A47}"/>
          </ac:spMkLst>
        </pc:spChg>
        <pc:spChg chg="mod">
          <ac:chgData name="Reza Amini Hounejani" userId="36cb0b73-58b2-4568-a1ab-00cd49301806" providerId="ADAL" clId="{DA8FEA81-1A63-884F-A1C6-520C766F400F}" dt="2022-11-24T10:24:32.270" v="11670" actId="1035"/>
          <ac:spMkLst>
            <pc:docMk/>
            <pc:sldMk cId="2229082649" sldId="258"/>
            <ac:spMk id="18" creationId="{B9ED5E41-12FA-82E4-2E8D-FA3511646DAC}"/>
          </ac:spMkLst>
        </pc:spChg>
        <pc:spChg chg="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19" creationId="{01E149AA-F640-EE3B-A707-7E7BC886F9D2}"/>
          </ac:spMkLst>
        </pc:spChg>
        <pc:spChg chg="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20" creationId="{248A4784-804B-30A3-97A6-E08B0C62B983}"/>
          </ac:spMkLst>
        </pc:spChg>
        <pc:spChg chg="del mod">
          <ac:chgData name="Reza Amini Hounejani" userId="36cb0b73-58b2-4568-a1ab-00cd49301806" providerId="ADAL" clId="{DA8FEA81-1A63-884F-A1C6-520C766F400F}" dt="2022-11-24T10:22:49.197" v="11654" actId="478"/>
          <ac:spMkLst>
            <pc:docMk/>
            <pc:sldMk cId="2229082649" sldId="258"/>
            <ac:spMk id="21" creationId="{2F6D9292-78DD-507D-7334-28E19413DCA1}"/>
          </ac:spMkLst>
        </pc:spChg>
        <pc:spChg chg="add del mod">
          <ac:chgData name="Reza Amini Hounejani" userId="36cb0b73-58b2-4568-a1ab-00cd49301806" providerId="ADAL" clId="{DA8FEA81-1A63-884F-A1C6-520C766F400F}" dt="2022-11-24T10:22:49.197" v="11654" actId="478"/>
          <ac:spMkLst>
            <pc:docMk/>
            <pc:sldMk cId="2229082649" sldId="258"/>
            <ac:spMk id="22" creationId="{D36BBDD6-AC3F-EFD1-1364-53CFA59F599B}"/>
          </ac:spMkLst>
        </pc:spChg>
        <pc:spChg chg="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23" creationId="{6038709E-3997-7481-1C1F-AC2DA6263C21}"/>
          </ac:spMkLst>
        </pc:spChg>
        <pc:spChg chg="del mod">
          <ac:chgData name="Reza Amini Hounejani" userId="36cb0b73-58b2-4568-a1ab-00cd49301806" providerId="ADAL" clId="{DA8FEA81-1A63-884F-A1C6-520C766F400F}" dt="2022-11-24T10:24:24.227" v="11655" actId="478"/>
          <ac:spMkLst>
            <pc:docMk/>
            <pc:sldMk cId="2229082649" sldId="258"/>
            <ac:spMk id="25" creationId="{836F9414-944E-E485-4985-1AD2028E13FA}"/>
          </ac:spMkLst>
        </pc:spChg>
        <pc:spChg chg="add mod">
          <ac:chgData name="Reza Amini Hounejani" userId="36cb0b73-58b2-4568-a1ab-00cd49301806" providerId="ADAL" clId="{DA8FEA81-1A63-884F-A1C6-520C766F400F}" dt="2022-11-24T10:21:26.548" v="11633" actId="1037"/>
          <ac:spMkLst>
            <pc:docMk/>
            <pc:sldMk cId="2229082649" sldId="258"/>
            <ac:spMk id="26" creationId="{ECE41BC3-9AFD-111B-738D-395DA43FB140}"/>
          </ac:spMkLst>
        </pc:spChg>
        <pc:spChg chg="del mod">
          <ac:chgData name="Reza Amini Hounejani" userId="36cb0b73-58b2-4568-a1ab-00cd49301806" providerId="ADAL" clId="{DA8FEA81-1A63-884F-A1C6-520C766F400F}" dt="2022-11-14T16:08:55.655" v="8503" actId="478"/>
          <ac:spMkLst>
            <pc:docMk/>
            <pc:sldMk cId="2229082649" sldId="258"/>
            <ac:spMk id="27" creationId="{731CA562-87F7-4FD5-5ACC-9859C3ACB5E6}"/>
          </ac:spMkLst>
        </pc:spChg>
        <pc:spChg chg="mod">
          <ac:chgData name="Reza Amini Hounejani" userId="36cb0b73-58b2-4568-a1ab-00cd49301806" providerId="ADAL" clId="{DA8FEA81-1A63-884F-A1C6-520C766F400F}" dt="2022-07-26T12:00:52.712" v="439" actId="20577"/>
          <ac:spMkLst>
            <pc:docMk/>
            <pc:sldMk cId="2229082649" sldId="258"/>
            <ac:spMk id="29" creationId="{17C6C5C1-ECAA-BDB9-3500-879D1DBE02AD}"/>
          </ac:spMkLst>
        </pc:spChg>
        <pc:spChg chg="mod">
          <ac:chgData name="Reza Amini Hounejani" userId="36cb0b73-58b2-4568-a1ab-00cd49301806" providerId="ADAL" clId="{DA8FEA81-1A63-884F-A1C6-520C766F400F}" dt="2022-11-15T12:47:58.230" v="8757" actId="1037"/>
          <ac:spMkLst>
            <pc:docMk/>
            <pc:sldMk cId="2229082649" sldId="258"/>
            <ac:spMk id="30" creationId="{C2BACFD9-AE81-8C95-D59D-0A3B7D98C432}"/>
          </ac:spMkLst>
        </pc:spChg>
        <pc:spChg chg="mod">
          <ac:chgData name="Reza Amini Hounejani" userId="36cb0b73-58b2-4568-a1ab-00cd49301806" providerId="ADAL" clId="{DA8FEA81-1A63-884F-A1C6-520C766F400F}" dt="2022-11-15T12:48:09.057" v="8758" actId="1076"/>
          <ac:spMkLst>
            <pc:docMk/>
            <pc:sldMk cId="2229082649" sldId="258"/>
            <ac:spMk id="31" creationId="{1FD19FFC-18B1-C733-056B-BC6F45FF8026}"/>
          </ac:spMkLst>
        </pc:spChg>
        <pc:spChg chg="mod">
          <ac:chgData name="Reza Amini Hounejani" userId="36cb0b73-58b2-4568-a1ab-00cd49301806" providerId="ADAL" clId="{DA8FEA81-1A63-884F-A1C6-520C766F400F}" dt="2022-11-10T11:04:46.208" v="7408" actId="552"/>
          <ac:spMkLst>
            <pc:docMk/>
            <pc:sldMk cId="2229082649" sldId="258"/>
            <ac:spMk id="32" creationId="{B16A542A-3692-B03C-E76B-4AF5ECB46A36}"/>
          </ac:spMkLst>
        </pc:spChg>
        <pc:spChg chg="mod">
          <ac:chgData name="Reza Amini Hounejani" userId="36cb0b73-58b2-4568-a1ab-00cd49301806" providerId="ADAL" clId="{DA8FEA81-1A63-884F-A1C6-520C766F400F}" dt="2022-11-10T11:04:46.208" v="7408" actId="552"/>
          <ac:spMkLst>
            <pc:docMk/>
            <pc:sldMk cId="2229082649" sldId="258"/>
            <ac:spMk id="33" creationId="{4A87FB38-EA2E-7BA9-3282-FE3201BA2362}"/>
          </ac:spMkLst>
        </pc:spChg>
        <pc:spChg chg="mod">
          <ac:chgData name="Reza Amini Hounejani" userId="36cb0b73-58b2-4568-a1ab-00cd49301806" providerId="ADAL" clId="{DA8FEA81-1A63-884F-A1C6-520C766F400F}" dt="2022-11-10T11:04:46.208" v="7408" actId="552"/>
          <ac:spMkLst>
            <pc:docMk/>
            <pc:sldMk cId="2229082649" sldId="258"/>
            <ac:spMk id="34" creationId="{EB48B3E8-EFED-0A84-50F2-EBCD9F831F53}"/>
          </ac:spMkLst>
        </pc:spChg>
        <pc:spChg chg="add del mod">
          <ac:chgData name="Reza Amini Hounejani" userId="36cb0b73-58b2-4568-a1ab-00cd49301806" providerId="ADAL" clId="{DA8FEA81-1A63-884F-A1C6-520C766F400F}" dt="2022-11-08T09:00:32.473" v="6502" actId="478"/>
          <ac:spMkLst>
            <pc:docMk/>
            <pc:sldMk cId="2229082649" sldId="258"/>
            <ac:spMk id="35" creationId="{C42520A7-E592-E654-B009-1A7FFAAADFA5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5" creationId="{CD251BB3-AF11-E3B3-96CB-F2F2C183EDCA}"/>
          </ac:spMkLst>
        </pc:spChg>
        <pc:spChg chg="mod">
          <ac:chgData name="Reza Amini Hounejani" userId="36cb0b73-58b2-4568-a1ab-00cd49301806" providerId="ADAL" clId="{DA8FEA81-1A63-884F-A1C6-520C766F400F}" dt="2022-11-10T11:04:46.208" v="7408" actId="552"/>
          <ac:spMkLst>
            <pc:docMk/>
            <pc:sldMk cId="2229082649" sldId="258"/>
            <ac:spMk id="36" creationId="{AFA4243B-B8F4-F813-B3E7-8A379BAF4423}"/>
          </ac:spMkLst>
        </pc:spChg>
        <pc:spChg chg="del mod">
          <ac:chgData name="Reza Amini Hounejani" userId="36cb0b73-58b2-4568-a1ab-00cd49301806" providerId="ADAL" clId="{DA8FEA81-1A63-884F-A1C6-520C766F400F}" dt="2022-07-27T09:42:00.143" v="1137" actId="478"/>
          <ac:spMkLst>
            <pc:docMk/>
            <pc:sldMk cId="2229082649" sldId="258"/>
            <ac:spMk id="37" creationId="{3E8E5B27-9DEB-F8EA-BA87-C39658CFDFCF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7" creationId="{94EA8DB7-8091-D0C9-5148-BD82294184D9}"/>
          </ac:spMkLst>
        </pc:spChg>
        <pc:spChg chg="add del mod">
          <ac:chgData name="Reza Amini Hounejani" userId="36cb0b73-58b2-4568-a1ab-00cd49301806" providerId="ADAL" clId="{DA8FEA81-1A63-884F-A1C6-520C766F400F}" dt="2022-11-08T09:01:05.271" v="6506" actId="478"/>
          <ac:spMkLst>
            <pc:docMk/>
            <pc:sldMk cId="2229082649" sldId="258"/>
            <ac:spMk id="37" creationId="{BC29BE97-294B-97DD-9E3F-541ED53B16C6}"/>
          </ac:spMkLst>
        </pc:spChg>
        <pc:spChg chg="mod">
          <ac:chgData name="Reza Amini Hounejani" userId="36cb0b73-58b2-4568-a1ab-00cd49301806" providerId="ADAL" clId="{DA8FEA81-1A63-884F-A1C6-520C766F400F}" dt="2022-11-10T11:00:11.305" v="7313" actId="14100"/>
          <ac:spMkLst>
            <pc:docMk/>
            <pc:sldMk cId="2229082649" sldId="258"/>
            <ac:spMk id="38" creationId="{72084DBE-F70A-FA90-0326-376A9F389F56}"/>
          </ac:spMkLst>
        </pc:spChg>
        <pc:spChg chg="mod">
          <ac:chgData name="Reza Amini Hounejani" userId="36cb0b73-58b2-4568-a1ab-00cd49301806" providerId="ADAL" clId="{DA8FEA81-1A63-884F-A1C6-520C766F400F}" dt="2022-11-10T11:01:21.403" v="7347" actId="1035"/>
          <ac:spMkLst>
            <pc:docMk/>
            <pc:sldMk cId="2229082649" sldId="258"/>
            <ac:spMk id="39" creationId="{056B172F-26CB-0712-47C3-9A88E9A27220}"/>
          </ac:spMkLst>
        </pc:spChg>
        <pc:spChg chg="mod">
          <ac:chgData name="Reza Amini Hounejani" userId="36cb0b73-58b2-4568-a1ab-00cd49301806" providerId="ADAL" clId="{DA8FEA81-1A63-884F-A1C6-520C766F400F}" dt="2022-11-10T10:59:58.013" v="7308" actId="1076"/>
          <ac:spMkLst>
            <pc:docMk/>
            <pc:sldMk cId="2229082649" sldId="258"/>
            <ac:spMk id="40" creationId="{BE4B1146-1FFC-811C-5362-1B3C2572D1D3}"/>
          </ac:spMkLst>
        </pc:spChg>
        <pc:spChg chg="mod">
          <ac:chgData name="Reza Amini Hounejani" userId="36cb0b73-58b2-4568-a1ab-00cd49301806" providerId="ADAL" clId="{DA8FEA81-1A63-884F-A1C6-520C766F400F}" dt="2022-11-10T10:59:54.108" v="7307" actId="1076"/>
          <ac:spMkLst>
            <pc:docMk/>
            <pc:sldMk cId="2229082649" sldId="258"/>
            <ac:spMk id="41" creationId="{6CFA5A3D-6B3F-DAFF-6F80-7105D5AF8494}"/>
          </ac:spMkLst>
        </pc:spChg>
        <pc:spChg chg="mod">
          <ac:chgData name="Reza Amini Hounejani" userId="36cb0b73-58b2-4568-a1ab-00cd49301806" providerId="ADAL" clId="{DA8FEA81-1A63-884F-A1C6-520C766F400F}" dt="2022-11-10T10:59:50.112" v="7306" actId="1076"/>
          <ac:spMkLst>
            <pc:docMk/>
            <pc:sldMk cId="2229082649" sldId="258"/>
            <ac:spMk id="42" creationId="{78C9E4DB-A2AA-F43D-4B13-882D0AF67393}"/>
          </ac:spMkLst>
        </pc:spChg>
        <pc:spChg chg="mod">
          <ac:chgData name="Reza Amini Hounejani" userId="36cb0b73-58b2-4568-a1ab-00cd49301806" providerId="ADAL" clId="{DA8FEA81-1A63-884F-A1C6-520C766F400F}" dt="2022-11-10T11:00:54.929" v="7316" actId="14100"/>
          <ac:spMkLst>
            <pc:docMk/>
            <pc:sldMk cId="2229082649" sldId="258"/>
            <ac:spMk id="43" creationId="{77FA97A0-FE82-CEFF-CDB7-02552E2096D9}"/>
          </ac:spMkLst>
        </pc:spChg>
        <pc:spChg chg="mod">
          <ac:chgData name="Reza Amini Hounejani" userId="36cb0b73-58b2-4568-a1ab-00cd49301806" providerId="ADAL" clId="{DA8FEA81-1A63-884F-A1C6-520C766F400F}" dt="2022-11-10T11:01:29.977" v="7355" actId="1035"/>
          <ac:spMkLst>
            <pc:docMk/>
            <pc:sldMk cId="2229082649" sldId="258"/>
            <ac:spMk id="44" creationId="{0EA58158-8B13-A0BE-B5DE-AABD368912D3}"/>
          </ac:spMkLst>
        </pc:spChg>
        <pc:spChg chg="mod">
          <ac:chgData name="Reza Amini Hounejani" userId="36cb0b73-58b2-4568-a1ab-00cd49301806" providerId="ADAL" clId="{DA8FEA81-1A63-884F-A1C6-520C766F400F}" dt="2022-11-10T11:01:29.977" v="7355" actId="1035"/>
          <ac:spMkLst>
            <pc:docMk/>
            <pc:sldMk cId="2229082649" sldId="258"/>
            <ac:spMk id="45" creationId="{71ACFDC4-6274-F00C-C922-6F2ABF736CF2}"/>
          </ac:spMkLst>
        </pc:spChg>
        <pc:spChg chg="mod">
          <ac:chgData name="Reza Amini Hounejani" userId="36cb0b73-58b2-4568-a1ab-00cd49301806" providerId="ADAL" clId="{DA8FEA81-1A63-884F-A1C6-520C766F400F}" dt="2022-11-10T11:01:34.660" v="7361" actId="1037"/>
          <ac:spMkLst>
            <pc:docMk/>
            <pc:sldMk cId="2229082649" sldId="258"/>
            <ac:spMk id="46" creationId="{92CC3238-DB26-DE42-EECF-69D5BDD47863}"/>
          </ac:spMkLst>
        </pc:spChg>
        <pc:spChg chg="mod">
          <ac:chgData name="Reza Amini Hounejani" userId="36cb0b73-58b2-4568-a1ab-00cd49301806" providerId="ADAL" clId="{DA8FEA81-1A63-884F-A1C6-520C766F400F}" dt="2022-11-10T11:04:16.193" v="7401" actId="14100"/>
          <ac:spMkLst>
            <pc:docMk/>
            <pc:sldMk cId="2229082649" sldId="258"/>
            <ac:spMk id="47" creationId="{1295B9E6-F677-D35B-DEBA-F065068A8E84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48" creationId="{0560F238-662A-5B8C-DBA2-6123E4DF5747}"/>
          </ac:spMkLst>
        </pc:spChg>
        <pc:spChg chg="add del mod">
          <ac:chgData name="Reza Amini Hounejani" userId="36cb0b73-58b2-4568-a1ab-00cd49301806" providerId="ADAL" clId="{DA8FEA81-1A63-884F-A1C6-520C766F400F}" dt="2022-11-08T15:01:43.661" v="6820" actId="478"/>
          <ac:spMkLst>
            <pc:docMk/>
            <pc:sldMk cId="2229082649" sldId="258"/>
            <ac:spMk id="48" creationId="{7FD99BDA-29AB-877D-2313-AE4C3D95015A}"/>
          </ac:spMkLst>
        </pc:spChg>
        <pc:spChg chg="add del mod">
          <ac:chgData name="Reza Amini Hounejani" userId="36cb0b73-58b2-4568-a1ab-00cd49301806" providerId="ADAL" clId="{DA8FEA81-1A63-884F-A1C6-520C766F400F}" dt="2022-11-04T17:17:35.110" v="6052" actId="478"/>
          <ac:spMkLst>
            <pc:docMk/>
            <pc:sldMk cId="2229082649" sldId="258"/>
            <ac:spMk id="48" creationId="{D4B1B7FA-7048-BA88-2ABE-62C31F2D817A}"/>
          </ac:spMkLst>
        </pc:spChg>
        <pc:spChg chg="mod">
          <ac:chgData name="Reza Amini Hounejani" userId="36cb0b73-58b2-4568-a1ab-00cd49301806" providerId="ADAL" clId="{DA8FEA81-1A63-884F-A1C6-520C766F400F}" dt="2022-11-10T11:04:02.736" v="7399" actId="14100"/>
          <ac:spMkLst>
            <pc:docMk/>
            <pc:sldMk cId="2229082649" sldId="258"/>
            <ac:spMk id="50" creationId="{6250A74A-0AD2-2D08-9C3C-AE563A19AF84}"/>
          </ac:spMkLst>
        </pc:spChg>
        <pc:spChg chg="mod">
          <ac:chgData name="Reza Amini Hounejani" userId="36cb0b73-58b2-4568-a1ab-00cd49301806" providerId="ADAL" clId="{DA8FEA81-1A63-884F-A1C6-520C766F400F}" dt="2022-11-10T10:58:20.549" v="7249" actId="465"/>
          <ac:spMkLst>
            <pc:docMk/>
            <pc:sldMk cId="2229082649" sldId="258"/>
            <ac:spMk id="51" creationId="{469216D3-2433-C447-F2CB-A99359750CED}"/>
          </ac:spMkLst>
        </pc:spChg>
        <pc:spChg chg="mod">
          <ac:chgData name="Reza Amini Hounejani" userId="36cb0b73-58b2-4568-a1ab-00cd49301806" providerId="ADAL" clId="{DA8FEA81-1A63-884F-A1C6-520C766F400F}" dt="2022-11-10T10:58:20.549" v="7249" actId="465"/>
          <ac:spMkLst>
            <pc:docMk/>
            <pc:sldMk cId="2229082649" sldId="258"/>
            <ac:spMk id="52" creationId="{2803228B-2D72-C11C-E0F9-10B11E745149}"/>
          </ac:spMkLst>
        </pc:spChg>
        <pc:spChg chg="mod">
          <ac:chgData name="Reza Amini Hounejani" userId="36cb0b73-58b2-4568-a1ab-00cd49301806" providerId="ADAL" clId="{DA8FEA81-1A63-884F-A1C6-520C766F400F}" dt="2022-11-10T10:58:20.549" v="7249" actId="465"/>
          <ac:spMkLst>
            <pc:docMk/>
            <pc:sldMk cId="2229082649" sldId="258"/>
            <ac:spMk id="53" creationId="{27BB11B9-8841-B91D-8BA8-813484C6F76D}"/>
          </ac:spMkLst>
        </pc:spChg>
        <pc:spChg chg="mod">
          <ac:chgData name="Reza Amini Hounejani" userId="36cb0b73-58b2-4568-a1ab-00cd49301806" providerId="ADAL" clId="{DA8FEA81-1A63-884F-A1C6-520C766F400F}" dt="2022-11-10T10:51:29.891" v="7169" actId="1076"/>
          <ac:spMkLst>
            <pc:docMk/>
            <pc:sldMk cId="2229082649" sldId="258"/>
            <ac:spMk id="54" creationId="{9919C0D0-E2C5-3060-5726-F5F04F0ACCAB}"/>
          </ac:spMkLst>
        </pc:spChg>
        <pc:spChg chg="mod">
          <ac:chgData name="Reza Amini Hounejani" userId="36cb0b73-58b2-4568-a1ab-00cd49301806" providerId="ADAL" clId="{DA8FEA81-1A63-884F-A1C6-520C766F400F}" dt="2022-11-10T10:51:25.584" v="7168" actId="1035"/>
          <ac:spMkLst>
            <pc:docMk/>
            <pc:sldMk cId="2229082649" sldId="258"/>
            <ac:spMk id="55" creationId="{FAFE58BC-C39A-5DA0-1374-4F14A0387135}"/>
          </ac:spMkLst>
        </pc:spChg>
        <pc:spChg chg="mod">
          <ac:chgData name="Reza Amini Hounejani" userId="36cb0b73-58b2-4568-a1ab-00cd49301806" providerId="ADAL" clId="{DA8FEA81-1A63-884F-A1C6-520C766F400F}" dt="2022-11-10T10:51:25.584" v="7168" actId="1035"/>
          <ac:spMkLst>
            <pc:docMk/>
            <pc:sldMk cId="2229082649" sldId="258"/>
            <ac:spMk id="56" creationId="{7B98D2B4-9377-968F-C63C-AE0411BBF510}"/>
          </ac:spMkLst>
        </pc:spChg>
        <pc:spChg chg="mod">
          <ac:chgData name="Reza Amini Hounejani" userId="36cb0b73-58b2-4568-a1ab-00cd49301806" providerId="ADAL" clId="{DA8FEA81-1A63-884F-A1C6-520C766F400F}" dt="2022-11-10T10:51:25.584" v="7168" actId="1035"/>
          <ac:spMkLst>
            <pc:docMk/>
            <pc:sldMk cId="2229082649" sldId="258"/>
            <ac:spMk id="57" creationId="{2269DAF7-94EA-327C-B605-F56AAA3284B6}"/>
          </ac:spMkLst>
        </pc:spChg>
        <pc:spChg chg="add del mod">
          <ac:chgData name="Reza Amini Hounejani" userId="36cb0b73-58b2-4568-a1ab-00cd49301806" providerId="ADAL" clId="{DA8FEA81-1A63-884F-A1C6-520C766F400F}" dt="2022-11-24T10:22:49.197" v="11654" actId="478"/>
          <ac:spMkLst>
            <pc:docMk/>
            <pc:sldMk cId="2229082649" sldId="258"/>
            <ac:spMk id="58" creationId="{3E99F201-1FF7-9EC2-FA1C-306F3157475C}"/>
          </ac:spMkLst>
        </pc:spChg>
        <pc:spChg chg="del mod">
          <ac:chgData name="Reza Amini Hounejani" userId="36cb0b73-58b2-4568-a1ab-00cd49301806" providerId="ADAL" clId="{DA8FEA81-1A63-884F-A1C6-520C766F400F}" dt="2022-07-27T09:56:47.135" v="1286" actId="478"/>
          <ac:spMkLst>
            <pc:docMk/>
            <pc:sldMk cId="2229082649" sldId="258"/>
            <ac:spMk id="58" creationId="{46C7DED6-77FA-25C7-1FDB-B2288A05E8D1}"/>
          </ac:spMkLst>
        </pc:spChg>
        <pc:spChg chg="mod">
          <ac:chgData name="Reza Amini Hounejani" userId="36cb0b73-58b2-4568-a1ab-00cd49301806" providerId="ADAL" clId="{DA8FEA81-1A63-884F-A1C6-520C766F400F}" dt="2022-11-10T11:04:11.194" v="7400" actId="14100"/>
          <ac:spMkLst>
            <pc:docMk/>
            <pc:sldMk cId="2229082649" sldId="258"/>
            <ac:spMk id="60" creationId="{9C219929-4D65-F593-1B05-D3556347280A}"/>
          </ac:spMkLst>
        </pc:spChg>
        <pc:spChg chg="mod">
          <ac:chgData name="Reza Amini Hounejani" userId="36cb0b73-58b2-4568-a1ab-00cd49301806" providerId="ADAL" clId="{DA8FEA81-1A63-884F-A1C6-520C766F400F}" dt="2022-11-10T11:02:54.064" v="7385" actId="1076"/>
          <ac:spMkLst>
            <pc:docMk/>
            <pc:sldMk cId="2229082649" sldId="258"/>
            <ac:spMk id="62" creationId="{AAE03A7D-EA6E-15C9-A5B2-206E8E452AC3}"/>
          </ac:spMkLst>
        </pc:spChg>
        <pc:spChg chg="mod">
          <ac:chgData name="Reza Amini Hounejani" userId="36cb0b73-58b2-4568-a1ab-00cd49301806" providerId="ADAL" clId="{DA8FEA81-1A63-884F-A1C6-520C766F400F}" dt="2022-11-15T12:47:35.314" v="8751" actId="1076"/>
          <ac:spMkLst>
            <pc:docMk/>
            <pc:sldMk cId="2229082649" sldId="258"/>
            <ac:spMk id="63" creationId="{34553138-D708-D026-DA0F-689C20F32BCE}"/>
          </ac:spMkLst>
        </pc:spChg>
        <pc:spChg chg="mod">
          <ac:chgData name="Reza Amini Hounejani" userId="36cb0b73-58b2-4568-a1ab-00cd49301806" providerId="ADAL" clId="{DA8FEA81-1A63-884F-A1C6-520C766F400F}" dt="2022-11-11T15:44:10.625" v="7524" actId="1038"/>
          <ac:spMkLst>
            <pc:docMk/>
            <pc:sldMk cId="2229082649" sldId="258"/>
            <ac:spMk id="64" creationId="{78087EF0-8905-E0E1-72FF-D905E48EB186}"/>
          </ac:spMkLst>
        </pc:spChg>
        <pc:spChg chg="mod">
          <ac:chgData name="Reza Amini Hounejani" userId="36cb0b73-58b2-4568-a1ab-00cd49301806" providerId="ADAL" clId="{DA8FEA81-1A63-884F-A1C6-520C766F400F}" dt="2022-11-11T15:44:10.625" v="7524" actId="1038"/>
          <ac:spMkLst>
            <pc:docMk/>
            <pc:sldMk cId="2229082649" sldId="258"/>
            <ac:spMk id="65" creationId="{C5F06705-FD20-BBA0-CCFD-52840C228F27}"/>
          </ac:spMkLst>
        </pc:spChg>
        <pc:spChg chg="mod">
          <ac:chgData name="Reza Amini Hounejani" userId="36cb0b73-58b2-4568-a1ab-00cd49301806" providerId="ADAL" clId="{DA8FEA81-1A63-884F-A1C6-520C766F400F}" dt="2022-11-11T15:44:10.625" v="7524" actId="1038"/>
          <ac:spMkLst>
            <pc:docMk/>
            <pc:sldMk cId="2229082649" sldId="258"/>
            <ac:spMk id="66" creationId="{EFB86822-C26A-0562-0AA8-4064C6079857}"/>
          </ac:spMkLst>
        </pc:spChg>
        <pc:spChg chg="add mod">
          <ac:chgData name="Reza Amini Hounejani" userId="36cb0b73-58b2-4568-a1ab-00cd49301806" providerId="ADAL" clId="{DA8FEA81-1A63-884F-A1C6-520C766F400F}" dt="2022-11-10T10:59:46.424" v="7305" actId="1076"/>
          <ac:spMkLst>
            <pc:docMk/>
            <pc:sldMk cId="2229082649" sldId="258"/>
            <ac:spMk id="67" creationId="{509F9F10-B734-26F7-FD32-67039DBB32DD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72" creationId="{B77B3ABB-F3C3-4952-F82C-6BB95EEBAFBF}"/>
          </ac:spMkLst>
        </pc:spChg>
        <pc:spChg chg="add mod">
          <ac:chgData name="Reza Amini Hounejani" userId="36cb0b73-58b2-4568-a1ab-00cd49301806" providerId="ADAL" clId="{DA8FEA81-1A63-884F-A1C6-520C766F400F}" dt="2022-11-04T16:57:06.976" v="4655" actId="164"/>
          <ac:spMkLst>
            <pc:docMk/>
            <pc:sldMk cId="2229082649" sldId="258"/>
            <ac:spMk id="76" creationId="{6672E647-3019-68F5-991A-F0760513A02F}"/>
          </ac:spMkLst>
        </pc:spChg>
        <pc:spChg chg="add mod">
          <ac:chgData name="Reza Amini Hounejani" userId="36cb0b73-58b2-4568-a1ab-00cd49301806" providerId="ADAL" clId="{DA8FEA81-1A63-884F-A1C6-520C766F400F}" dt="2022-11-10T10:58:20.549" v="7249" actId="465"/>
          <ac:spMkLst>
            <pc:docMk/>
            <pc:sldMk cId="2229082649" sldId="258"/>
            <ac:spMk id="77" creationId="{8EA99BB0-B39C-9D36-A0D2-8E6F900E37A4}"/>
          </ac:spMkLst>
        </pc:spChg>
        <pc:spChg chg="add mod">
          <ac:chgData name="Reza Amini Hounejani" userId="36cb0b73-58b2-4568-a1ab-00cd49301806" providerId="ADAL" clId="{DA8FEA81-1A63-884F-A1C6-520C766F400F}" dt="2022-11-04T16:57:00.580" v="4653" actId="164"/>
          <ac:spMkLst>
            <pc:docMk/>
            <pc:sldMk cId="2229082649" sldId="258"/>
            <ac:spMk id="78" creationId="{5A7B63D4-8CFE-760B-2D71-8C7ECCBFC419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81" creationId="{8B4A1B65-4A70-803E-EA7D-5E24D6FADDE7}"/>
          </ac:spMkLst>
        </pc:spChg>
        <pc:spChg chg="mod">
          <ac:chgData name="Reza Amini Hounejani" userId="36cb0b73-58b2-4568-a1ab-00cd49301806" providerId="ADAL" clId="{DA8FEA81-1A63-884F-A1C6-520C766F400F}" dt="2022-11-15T12:47:16.956" v="8749" actId="14100"/>
          <ac:spMkLst>
            <pc:docMk/>
            <pc:sldMk cId="2229082649" sldId="258"/>
            <ac:spMk id="82" creationId="{2F1B855A-8C5A-C664-9ACC-7650DC86D6ED}"/>
          </ac:spMkLst>
        </pc:spChg>
        <pc:spChg chg="mod">
          <ac:chgData name="Reza Amini Hounejani" userId="36cb0b73-58b2-4568-a1ab-00cd49301806" providerId="ADAL" clId="{DA8FEA81-1A63-884F-A1C6-520C766F400F}" dt="2022-11-15T12:48:12.649" v="8759" actId="1076"/>
          <ac:spMkLst>
            <pc:docMk/>
            <pc:sldMk cId="2229082649" sldId="258"/>
            <ac:spMk id="83" creationId="{062A0E21-AB10-02B4-CE22-88FFEEA2A403}"/>
          </ac:spMkLst>
        </pc:spChg>
        <pc:spChg chg="mod">
          <ac:chgData name="Reza Amini Hounejani" userId="36cb0b73-58b2-4568-a1ab-00cd49301806" providerId="ADAL" clId="{DA8FEA81-1A63-884F-A1C6-520C766F400F}" dt="2022-11-10T11:03:48.123" v="7396" actId="1076"/>
          <ac:spMkLst>
            <pc:docMk/>
            <pc:sldMk cId="2229082649" sldId="258"/>
            <ac:spMk id="84" creationId="{A499EC24-2518-574B-5894-3D87031332C4}"/>
          </ac:spMkLst>
        </pc:spChg>
        <pc:spChg chg="mod">
          <ac:chgData name="Reza Amini Hounejani" userId="36cb0b73-58b2-4568-a1ab-00cd49301806" providerId="ADAL" clId="{DA8FEA81-1A63-884F-A1C6-520C766F400F}" dt="2022-11-10T11:03:38.127" v="7391" actId="1076"/>
          <ac:spMkLst>
            <pc:docMk/>
            <pc:sldMk cId="2229082649" sldId="258"/>
            <ac:spMk id="85" creationId="{28C2F03E-ABDE-6756-33D4-C6D78E7E4385}"/>
          </ac:spMkLst>
        </pc:spChg>
        <pc:spChg chg="mod">
          <ac:chgData name="Reza Amini Hounejani" userId="36cb0b73-58b2-4568-a1ab-00cd49301806" providerId="ADAL" clId="{DA8FEA81-1A63-884F-A1C6-520C766F400F}" dt="2022-11-10T11:03:40.616" v="7392" actId="1076"/>
          <ac:spMkLst>
            <pc:docMk/>
            <pc:sldMk cId="2229082649" sldId="258"/>
            <ac:spMk id="86" creationId="{9B1B207A-3990-5044-D0C7-B9F8B65926AA}"/>
          </ac:spMkLst>
        </pc:spChg>
        <pc:spChg chg="mod">
          <ac:chgData name="Reza Amini Hounejani" userId="36cb0b73-58b2-4568-a1ab-00cd49301806" providerId="ADAL" clId="{DA8FEA81-1A63-884F-A1C6-520C766F400F}" dt="2022-11-10T11:03:42.756" v="7393" actId="1076"/>
          <ac:spMkLst>
            <pc:docMk/>
            <pc:sldMk cId="2229082649" sldId="258"/>
            <ac:spMk id="87" creationId="{507E6CEC-D643-5A62-E5E8-AFD5F497BF2C}"/>
          </ac:spMkLst>
        </pc:spChg>
        <pc:spChg chg="mod">
          <ac:chgData name="Reza Amini Hounejani" userId="36cb0b73-58b2-4568-a1ab-00cd49301806" providerId="ADAL" clId="{DA8FEA81-1A63-884F-A1C6-520C766F400F}" dt="2022-11-10T11:03:45.047" v="7394" actId="1076"/>
          <ac:spMkLst>
            <pc:docMk/>
            <pc:sldMk cId="2229082649" sldId="258"/>
            <ac:spMk id="88" creationId="{F62B323E-AD8B-EE45-3325-40D767ED505D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92" creationId="{8B52E74E-2817-7E9A-029E-B8D0B36F2092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93" creationId="{BE331EF5-E709-B10E-AEC5-C04DF9663821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94" creationId="{6C896F5F-B512-6F7A-9F7E-27DA59C985A9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95" creationId="{29C6951A-D25E-F2B1-9F25-0CB641E7AD39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96" creationId="{BBDC115C-E927-44F8-2B03-9B33B609770F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97" creationId="{1C1532D2-8846-F45D-9525-FE34DA0E6880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98" creationId="{BBB97B02-CF02-6C94-7348-B017F4A9909E}"/>
          </ac:spMkLst>
        </pc:spChg>
        <pc:spChg chg="del mod">
          <ac:chgData name="Reza Amini Hounejani" userId="36cb0b73-58b2-4568-a1ab-00cd49301806" providerId="ADAL" clId="{DA8FEA81-1A63-884F-A1C6-520C766F400F}" dt="2022-07-27T10:29:44.805" v="1571" actId="478"/>
          <ac:spMkLst>
            <pc:docMk/>
            <pc:sldMk cId="2229082649" sldId="258"/>
            <ac:spMk id="99" creationId="{4324E381-72C9-7913-A0A0-3E7A9103EEE8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99" creationId="{921217D7-33E5-FC0B-0B6F-EC6CE7E5BEF0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101" creationId="{2CA78303-1A8B-B000-BB6E-4DD7572E6AC0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102" creationId="{A28238C6-6232-11CC-40B5-5C28D99B773E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103" creationId="{95029A38-1E36-BD59-0F2B-B1F89FDB50F6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104" creationId="{799F5A16-FC02-9020-74B4-8ECA9A72D5FB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105" creationId="{93A531AA-222B-0F1C-B5C8-41028D1BD7F9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106" creationId="{F88AF606-4DFE-6E19-2A3F-4B7C3D4ACFCC}"/>
          </ac:spMkLst>
        </pc:spChg>
        <pc:spChg chg="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107" creationId="{91DCAB53-7390-26B6-4D91-00D51E6BFD1A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08" creationId="{D573FE87-7663-2CD8-04E2-095467A8883E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09" creationId="{8A72093E-705E-01F5-7045-30155D1F4000}"/>
          </ac:spMkLst>
        </pc:spChg>
        <pc:spChg chg="add 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10" creationId="{6E25DA2D-EE14-9177-FAC9-38E490C26B5C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11" creationId="{D559052E-F51C-B1E6-580D-08B77290BBFC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12" creationId="{20879400-08B9-9CE5-0BD2-0C3B84971945}"/>
          </ac:spMkLst>
        </pc:spChg>
        <pc:spChg chg="add 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13" creationId="{26C35C14-2087-3F6D-8067-EF6B0CC2A928}"/>
          </ac:spMkLst>
        </pc:spChg>
        <pc:spChg chg="add del mod">
          <ac:chgData name="Reza Amini Hounejani" userId="36cb0b73-58b2-4568-a1ab-00cd49301806" providerId="ADAL" clId="{DA8FEA81-1A63-884F-A1C6-520C766F400F}" dt="2022-07-27T12:48:38.416" v="1618" actId="11529"/>
          <ac:spMkLst>
            <pc:docMk/>
            <pc:sldMk cId="2229082649" sldId="258"/>
            <ac:spMk id="116" creationId="{F575FAE5-EE4D-32D6-5ADF-045235251B05}"/>
          </ac:spMkLst>
        </pc:spChg>
        <pc:spChg chg="add del mod">
          <ac:chgData name="Reza Amini Hounejani" userId="36cb0b73-58b2-4568-a1ab-00cd49301806" providerId="ADAL" clId="{DA8FEA81-1A63-884F-A1C6-520C766F400F}" dt="2022-07-27T12:50:17.426" v="1635" actId="478"/>
          <ac:spMkLst>
            <pc:docMk/>
            <pc:sldMk cId="2229082649" sldId="258"/>
            <ac:spMk id="117" creationId="{CB926ED5-E02B-75C6-5F52-B498C5C7924D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18" creationId="{3F0EE5F7-1E58-1254-D7C9-F0AA4F2ECB29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19" creationId="{684648CF-40EA-A01D-FA24-F9C68EF9AFFF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20" creationId="{820CF045-7A5A-07CA-9732-EE08173E0E8D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21" creationId="{8EDE9000-5DFE-5626-8BC2-C591744D94C5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22" creationId="{54A7F627-F80A-1038-F3CA-3C67D05B1379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23" creationId="{75E2F906-9802-E634-41F4-EB03210461F7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24" creationId="{7313AD67-FE59-6ACD-FB9E-9170D388E30E}"/>
          </ac:spMkLst>
        </pc:spChg>
        <pc:spChg chg="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125" creationId="{53003765-F36E-8A97-50FA-A84609DC618F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27" creationId="{E31A003A-3959-6047-951C-3B618390EB77}"/>
          </ac:spMkLst>
        </pc:spChg>
        <pc:spChg chg="add del mod">
          <ac:chgData name="Reza Amini Hounejani" userId="36cb0b73-58b2-4568-a1ab-00cd49301806" providerId="ADAL" clId="{DA8FEA81-1A63-884F-A1C6-520C766F400F}" dt="2022-07-27T12:50:17.426" v="1635" actId="478"/>
          <ac:spMkLst>
            <pc:docMk/>
            <pc:sldMk cId="2229082649" sldId="258"/>
            <ac:spMk id="128" creationId="{1865802A-7CF8-A64E-1F8A-CE150F77297E}"/>
          </ac:spMkLst>
        </pc:spChg>
        <pc:spChg chg="add mod">
          <ac:chgData name="Reza Amini Hounejani" userId="36cb0b73-58b2-4568-a1ab-00cd49301806" providerId="ADAL" clId="{DA8FEA81-1A63-884F-A1C6-520C766F400F}" dt="2022-11-24T10:21:26.548" v="11633" actId="1037"/>
          <ac:spMkLst>
            <pc:docMk/>
            <pc:sldMk cId="2229082649" sldId="258"/>
            <ac:spMk id="128" creationId="{8BDAEEFF-9F65-CED2-19D1-B6A6D1A555E1}"/>
          </ac:spMkLst>
        </pc:spChg>
        <pc:spChg chg="add del mod">
          <ac:chgData name="Reza Amini Hounejani" userId="36cb0b73-58b2-4568-a1ab-00cd49301806" providerId="ADAL" clId="{DA8FEA81-1A63-884F-A1C6-520C766F400F}" dt="2022-11-11T16:31:21.211" v="7729" actId="478"/>
          <ac:spMkLst>
            <pc:docMk/>
            <pc:sldMk cId="2229082649" sldId="258"/>
            <ac:spMk id="128" creationId="{F3C06FDB-7000-D5C8-77AB-3A7C4145720A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30" creationId="{1A092EA1-2A1F-8A50-804D-E4F01133E3F6}"/>
          </ac:spMkLst>
        </pc:spChg>
        <pc:spChg chg="add del mod">
          <ac:chgData name="Reza Amini Hounejani" userId="36cb0b73-58b2-4568-a1ab-00cd49301806" providerId="ADAL" clId="{DA8FEA81-1A63-884F-A1C6-520C766F400F}" dt="2022-07-27T12:50:17.426" v="1635" actId="478"/>
          <ac:spMkLst>
            <pc:docMk/>
            <pc:sldMk cId="2229082649" sldId="258"/>
            <ac:spMk id="130" creationId="{5470F4E7-025D-5DFC-3B08-902A704C5EDF}"/>
          </ac:spMkLst>
        </pc:spChg>
        <pc:spChg chg="add del mod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31" creationId="{77EE6008-6F51-4DAB-59DC-BEDB8B94984B}"/>
          </ac:spMkLst>
        </pc:spChg>
        <pc:spChg chg="add del mod">
          <ac:chgData name="Reza Amini Hounejani" userId="36cb0b73-58b2-4568-a1ab-00cd49301806" providerId="ADAL" clId="{DA8FEA81-1A63-884F-A1C6-520C766F400F}" dt="2022-07-27T12:50:17.426" v="1635" actId="478"/>
          <ac:spMkLst>
            <pc:docMk/>
            <pc:sldMk cId="2229082649" sldId="258"/>
            <ac:spMk id="131" creationId="{A023DEA8-F600-6545-DDCD-831B5B1648AB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31" creationId="{EA93D265-E793-BB4A-1D0F-47DF97E588D5}"/>
          </ac:spMkLst>
        </pc:spChg>
        <pc:spChg chg="add del mod">
          <ac:chgData name="Reza Amini Hounejani" userId="36cb0b73-58b2-4568-a1ab-00cd49301806" providerId="ADAL" clId="{DA8FEA81-1A63-884F-A1C6-520C766F400F}" dt="2022-11-24T08:37:36.861" v="11471" actId="478"/>
          <ac:spMkLst>
            <pc:docMk/>
            <pc:sldMk cId="2229082649" sldId="258"/>
            <ac:spMk id="132" creationId="{1BDE37B2-A7C5-BCA9-5CB0-8BA9134EF7B2}"/>
          </ac:spMkLst>
        </pc:spChg>
        <pc:spChg chg="add del mod">
          <ac:chgData name="Reza Amini Hounejani" userId="36cb0b73-58b2-4568-a1ab-00cd49301806" providerId="ADAL" clId="{DA8FEA81-1A63-884F-A1C6-520C766F400F}" dt="2022-07-27T12:50:17.426" v="1635" actId="478"/>
          <ac:spMkLst>
            <pc:docMk/>
            <pc:sldMk cId="2229082649" sldId="258"/>
            <ac:spMk id="132" creationId="{72D000EE-0E38-2B35-45C2-2F77925E29A6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33" creationId="{56F1D173-4BB3-DA3E-2CD7-C7BAD19EA3C4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34" creationId="{DA73AB77-A865-ED18-790A-F781A8C2EDFC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35" creationId="{0AF85183-6B50-44A0-8B37-AB995D0A149A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36" creationId="{3D555BAE-85B1-9885-A474-39C41DAC4A09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37" creationId="{808A5858-C935-0151-A886-113E9FD5ADBE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38" creationId="{9E3C6287-2F8B-B96E-C208-7278A03597AB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39" creationId="{8D3047B8-A411-90A8-43C0-E34AB449CB6C}"/>
          </ac:spMkLst>
        </pc:spChg>
        <pc:spChg chg="add mod">
          <ac:chgData name="Reza Amini Hounejani" userId="36cb0b73-58b2-4568-a1ab-00cd49301806" providerId="ADAL" clId="{DA8FEA81-1A63-884F-A1C6-520C766F400F}" dt="2022-07-27T12:53:34.908" v="1685" actId="571"/>
          <ac:spMkLst>
            <pc:docMk/>
            <pc:sldMk cId="2229082649" sldId="258"/>
            <ac:spMk id="140" creationId="{21FCD39F-79F2-83A7-81A0-6E12679E09A5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41" creationId="{94EC9B97-409F-0E58-6D14-752E976BAF0A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42" creationId="{A3EE1AD3-658B-6F11-D929-6D779141DA34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43" creationId="{13CAE978-3A02-3A04-A3E4-3C29FD85ACF3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44" creationId="{9208A080-6479-F548-35A8-232989D18BF0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45" creationId="{345D38F1-15B2-D47A-8209-B0DEC022E2D5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46" creationId="{4D9E0F68-6937-7ECC-FFE1-21D4798F541C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47" creationId="{21E3B047-1E55-11D9-42AE-587831270AE2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48" creationId="{F16C47C5-7BD5-56FE-25AD-33C9DF2A35BE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49" creationId="{6CABD99A-DA7C-8248-8517-939DC7FC3FB7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50" creationId="{D0AD323D-D52C-326A-02ED-B1FE614AF5ED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51" creationId="{6C518038-D7A8-AA0C-5E2D-F58BD793CDC8}"/>
          </ac:spMkLst>
        </pc:spChg>
        <pc:spChg chg="add del mod">
          <ac:chgData name="Reza Amini Hounejani" userId="36cb0b73-58b2-4568-a1ab-00cd49301806" providerId="ADAL" clId="{DA8FEA81-1A63-884F-A1C6-520C766F400F}" dt="2022-11-14T15:57:53.726" v="8478" actId="478"/>
          <ac:spMkLst>
            <pc:docMk/>
            <pc:sldMk cId="2229082649" sldId="258"/>
            <ac:spMk id="153" creationId="{1FD06020-8352-AE32-A938-822300092989}"/>
          </ac:spMkLst>
        </pc:spChg>
        <pc:spChg chg="add mod">
          <ac:chgData name="Reza Amini Hounejani" userId="36cb0b73-58b2-4568-a1ab-00cd49301806" providerId="ADAL" clId="{DA8FEA81-1A63-884F-A1C6-520C766F400F}" dt="2022-11-24T10:21:01.918" v="11609" actId="571"/>
          <ac:spMkLst>
            <pc:docMk/>
            <pc:sldMk cId="2229082649" sldId="258"/>
            <ac:spMk id="153" creationId="{A0CB3D8D-D34D-4BD3-84A3-A49A7B580857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54" creationId="{2A078BCE-439D-17FF-D8A4-569E10209E12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55" creationId="{32969FE7-A398-843D-5880-491C352D7E05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55" creationId="{FCD11873-2468-16D1-6B13-9194AEC2E8FD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56" creationId="{A12BEABB-548B-2847-07F9-AF1F0860DFA9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56" creationId="{EBD0E063-D98D-AB4C-779E-6E2840A6FE15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56" creationId="{FF5CBD5B-FD00-C59F-4961-A63B4B8544B4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57" creationId="{C5874F21-DAD8-9740-DD25-2CC9B61ECC5D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58" creationId="{B8E1B0B4-6677-D530-4E26-0FDA3D09B640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59" creationId="{E59FC05E-06DA-DD41-95E7-6BEAC48ACC16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60" creationId="{0792FF91-93BC-BE3B-B999-F6D98C808722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61" creationId="{251DF7D7-4830-AF84-7929-FCA4F492C0AA}"/>
          </ac:spMkLst>
        </pc:spChg>
        <pc:spChg chg="add del mod">
          <ac:chgData name="Reza Amini Hounejani" userId="36cb0b73-58b2-4568-a1ab-00cd49301806" providerId="ADAL" clId="{DA8FEA81-1A63-884F-A1C6-520C766F400F}" dt="2022-11-04T17:06:50.508" v="6008" actId="478"/>
          <ac:spMkLst>
            <pc:docMk/>
            <pc:sldMk cId="2229082649" sldId="258"/>
            <ac:spMk id="161" creationId="{2BE403B6-30AC-118F-DD1F-B89DC52058FF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61" creationId="{8039B6CA-4D51-E613-2B91-537430C47312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62" creationId="{AD8C1BFC-4D19-9E5B-2CC6-D4F4D7642A2D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62" creationId="{D3F84E3A-92E5-72CB-21DD-4D408AD73742}"/>
          </ac:spMkLst>
        </pc:spChg>
        <pc:spChg chg="add del mod">
          <ac:chgData name="Reza Amini Hounejani" userId="36cb0b73-58b2-4568-a1ab-00cd49301806" providerId="ADAL" clId="{DA8FEA81-1A63-884F-A1C6-520C766F400F}" dt="2022-11-04T17:06:49.234" v="6007" actId="478"/>
          <ac:spMkLst>
            <pc:docMk/>
            <pc:sldMk cId="2229082649" sldId="258"/>
            <ac:spMk id="162" creationId="{F262B9F2-A0C9-A39C-EBD7-DD293ACB1971}"/>
          </ac:spMkLst>
        </pc:spChg>
        <pc:spChg chg="del mod">
          <ac:chgData name="Reza Amini Hounejani" userId="36cb0b73-58b2-4568-a1ab-00cd49301806" providerId="ADAL" clId="{DA8FEA81-1A63-884F-A1C6-520C766F400F}" dt="2022-11-08T12:43:31.327" v="6771" actId="478"/>
          <ac:spMkLst>
            <pc:docMk/>
            <pc:sldMk cId="2229082649" sldId="258"/>
            <ac:spMk id="163" creationId="{9E0C286D-A280-1C47-5484-5273B0AAF3A6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63" creationId="{D2DB3C7B-3B16-727E-77B1-E907CC4B9328}"/>
          </ac:spMkLst>
        </pc:spChg>
        <pc:spChg chg="add del mod">
          <ac:chgData name="Reza Amini Hounejani" userId="36cb0b73-58b2-4568-a1ab-00cd49301806" providerId="ADAL" clId="{DA8FEA81-1A63-884F-A1C6-520C766F400F}" dt="2022-11-04T17:06:51.382" v="6009" actId="478"/>
          <ac:spMkLst>
            <pc:docMk/>
            <pc:sldMk cId="2229082649" sldId="258"/>
            <ac:spMk id="163" creationId="{EDD5E8A2-FC59-A3F2-25ED-A6BC0A72C858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63" creationId="{FC9147DD-6047-E979-9EDF-5E6D1BF320B2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64" creationId="{83FE84F7-CAE5-D408-7099-91948CAED850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64" creationId="{CA3EEA53-449F-DE91-A095-DD474DA600E7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65" creationId="{3E922304-E104-C94D-3D2C-1BC107B4BE0F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65" creationId="{B3B1F35E-3747-A2E6-B7C0-25B676E49806}"/>
          </ac:spMkLst>
        </pc:spChg>
        <pc:spChg chg="add del mod">
          <ac:chgData name="Reza Amini Hounejani" userId="36cb0b73-58b2-4568-a1ab-00cd49301806" providerId="ADAL" clId="{DA8FEA81-1A63-884F-A1C6-520C766F400F}" dt="2022-11-08T09:30:18.591" v="6596" actId="478"/>
          <ac:spMkLst>
            <pc:docMk/>
            <pc:sldMk cId="2229082649" sldId="258"/>
            <ac:spMk id="165" creationId="{DA83C5A2-F76F-C1D4-DDB6-3A11E11FB03D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66" creationId="{034B10B9-D6A3-D5A7-FEB3-986073FF8F41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66" creationId="{756DE6D3-9DF9-EF1A-FA07-7FCC6456BBF9}"/>
          </ac:spMkLst>
        </pc:spChg>
        <pc:spChg chg="add del mod topLvl">
          <ac:chgData name="Reza Amini Hounejani" userId="36cb0b73-58b2-4568-a1ab-00cd49301806" providerId="ADAL" clId="{DA8FEA81-1A63-884F-A1C6-520C766F400F}" dt="2022-11-08T09:35:57.570" v="6645" actId="478"/>
          <ac:spMkLst>
            <pc:docMk/>
            <pc:sldMk cId="2229082649" sldId="258"/>
            <ac:spMk id="166" creationId="{9A90A388-B5A4-BBF2-C769-2928B69C9C8E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67" creationId="{3966E64B-58A1-64CC-B00E-7990787820F0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67" creationId="{66DB860E-338C-24F0-1AD6-81E51F276F18}"/>
          </ac:spMkLst>
        </pc:spChg>
        <pc:spChg chg="add del mod">
          <ac:chgData name="Reza Amini Hounejani" userId="36cb0b73-58b2-4568-a1ab-00cd49301806" providerId="ADAL" clId="{DA8FEA81-1A63-884F-A1C6-520C766F400F}" dt="2022-11-04T17:24:44.911" v="6094" actId="478"/>
          <ac:spMkLst>
            <pc:docMk/>
            <pc:sldMk cId="2229082649" sldId="258"/>
            <ac:spMk id="167" creationId="{CDF636D3-7C69-CB47-C1A8-649EA4185E91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68" creationId="{154C9F8A-CDC3-0381-537B-3D5B005203E0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68" creationId="{534705B7-1536-6F03-685F-588169FFFD6B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68" creationId="{7878629E-1045-E835-65DD-BA054FC0AEE1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69" creationId="{186E495D-2E7A-A097-7EF1-7FF6AA73FA52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69" creationId="{A7CE7BF1-489C-E64D-BB9B-D736CDD087C7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69" creationId="{F3E4FDCF-1154-EA45-FF70-7255AC84CF11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70" creationId="{02E3D992-43BD-561A-83DE-A5FB1E664F46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70" creationId="{41EB574C-F9AF-F849-3508-59FF823003A6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70" creationId="{EED03FD8-272A-64CB-8A7E-67C7307E7234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71" creationId="{77B15698-E34F-029C-7BD8-7D47B639570B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71" creationId="{AB1B10A2-79F7-7134-01EA-B15F6FC9F115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71" creationId="{C558CA88-2F23-AE68-5FCE-E44F26B8DCDE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72" creationId="{48FA82DF-1D15-313B-CB31-10C3B5D32CEB}"/>
          </ac:spMkLst>
        </pc:spChg>
        <pc:spChg chg="add del mod">
          <ac:chgData name="Reza Amini Hounejani" userId="36cb0b73-58b2-4568-a1ab-00cd49301806" providerId="ADAL" clId="{DA8FEA81-1A63-884F-A1C6-520C766F400F}" dt="2022-11-08T09:30:18.591" v="6596" actId="478"/>
          <ac:spMkLst>
            <pc:docMk/>
            <pc:sldMk cId="2229082649" sldId="258"/>
            <ac:spMk id="172" creationId="{64E2B4DA-6F05-7D1A-F31A-7982AC9FD560}"/>
          </ac:spMkLst>
        </pc:spChg>
        <pc:spChg chg="mod">
          <ac:chgData name="Reza Amini Hounejani" userId="36cb0b73-58b2-4568-a1ab-00cd49301806" providerId="ADAL" clId="{DA8FEA81-1A63-884F-A1C6-520C766F400F}" dt="2022-07-27T13:01:58.891" v="2060"/>
          <ac:spMkLst>
            <pc:docMk/>
            <pc:sldMk cId="2229082649" sldId="258"/>
            <ac:spMk id="172" creationId="{877EB695-E2FC-0C0D-282D-81EFA8341549}"/>
          </ac:spMkLst>
        </pc:spChg>
        <pc:spChg chg="add del mod">
          <ac:chgData name="Reza Amini Hounejani" userId="36cb0b73-58b2-4568-a1ab-00cd49301806" providerId="ADAL" clId="{DA8FEA81-1A63-884F-A1C6-520C766F400F}" dt="2022-11-08T09:30:25.111" v="6599" actId="478"/>
          <ac:spMkLst>
            <pc:docMk/>
            <pc:sldMk cId="2229082649" sldId="258"/>
            <ac:spMk id="173" creationId="{5C91C9CE-E195-723C-F0E0-423291B58AE5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73" creationId="{C849211C-F3B7-8718-91A6-E127F4C02976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74" creationId="{40791A18-11A1-6F21-080E-BAFA1B3F7679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74" creationId="{AFA04C71-F143-E562-795F-EDB6A39DBB53}"/>
          </ac:spMkLst>
        </pc:spChg>
        <pc:spChg chg="add del mod">
          <ac:chgData name="Reza Amini Hounejani" userId="36cb0b73-58b2-4568-a1ab-00cd49301806" providerId="ADAL" clId="{DA8FEA81-1A63-884F-A1C6-520C766F400F}" dt="2022-11-08T09:30:18.591" v="6596" actId="478"/>
          <ac:spMkLst>
            <pc:docMk/>
            <pc:sldMk cId="2229082649" sldId="258"/>
            <ac:spMk id="174" creationId="{B151C746-0C8B-888B-F0CA-5A3ADF22C6E6}"/>
          </ac:spMkLst>
        </pc:spChg>
        <pc:spChg chg="add del mod">
          <ac:chgData name="Reza Amini Hounejani" userId="36cb0b73-58b2-4568-a1ab-00cd49301806" providerId="ADAL" clId="{DA8FEA81-1A63-884F-A1C6-520C766F400F}" dt="2022-11-08T09:30:18.591" v="6596" actId="478"/>
          <ac:spMkLst>
            <pc:docMk/>
            <pc:sldMk cId="2229082649" sldId="258"/>
            <ac:spMk id="175" creationId="{900CEB26-90F7-537F-E35D-FF4FB6D439F9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75" creationId="{E2ABEE37-0DB6-D5FE-F5B9-CFC7B49CD364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75" creationId="{F3D4C82C-4513-39BE-F914-FAEC350E099F}"/>
          </ac:spMkLst>
        </pc:spChg>
        <pc:spChg chg="add del mod">
          <ac:chgData name="Reza Amini Hounejani" userId="36cb0b73-58b2-4568-a1ab-00cd49301806" providerId="ADAL" clId="{DA8FEA81-1A63-884F-A1C6-520C766F400F}" dt="2022-11-08T09:30:18.591" v="6596" actId="478"/>
          <ac:spMkLst>
            <pc:docMk/>
            <pc:sldMk cId="2229082649" sldId="258"/>
            <ac:spMk id="176" creationId="{52391E18-0A9F-18F1-F3AD-DE290EE22F15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76" creationId="{AB9BE65B-9705-5ADB-026D-67F42A733986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76" creationId="{B3BE9D13-CCA0-0134-7A8B-A48CD4564DBC}"/>
          </ac:spMkLst>
        </pc:spChg>
        <pc:spChg chg="add del mod">
          <ac:chgData name="Reza Amini Hounejani" userId="36cb0b73-58b2-4568-a1ab-00cd49301806" providerId="ADAL" clId="{DA8FEA81-1A63-884F-A1C6-520C766F400F}" dt="2022-11-08T09:30:18.591" v="6596" actId="478"/>
          <ac:spMkLst>
            <pc:docMk/>
            <pc:sldMk cId="2229082649" sldId="258"/>
            <ac:spMk id="177" creationId="{2C1A7F64-3396-F2A0-AA01-0B5BE6475ECC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77" creationId="{4F52F69B-8147-1DDC-D93D-A1D998692C2F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77" creationId="{519C4778-E5BE-7B31-DCEB-2A548AB0A36E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78" creationId="{BA0DD8CF-4066-4274-E2CF-1FCD0EE3D88D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78" creationId="{BCDA752D-3C9F-4457-DE1A-1765519F3DC4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78" creationId="{FC25C6C3-291B-30C6-B63D-9C4DCC39F4B1}"/>
          </ac:spMkLst>
        </pc:spChg>
        <pc:spChg chg="add del mod">
          <ac:chgData name="Reza Amini Hounejani" userId="36cb0b73-58b2-4568-a1ab-00cd49301806" providerId="ADAL" clId="{DA8FEA81-1A63-884F-A1C6-520C766F400F}" dt="2022-11-08T09:29:46.226" v="6580" actId="478"/>
          <ac:spMkLst>
            <pc:docMk/>
            <pc:sldMk cId="2229082649" sldId="258"/>
            <ac:spMk id="179" creationId="{172E7D63-90DB-86C0-32EE-370E2054D21B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79" creationId="{A4455A56-CFC6-6974-D055-85A919A32072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79" creationId="{E8BEFEE9-F7FC-325D-5A14-D5082810171F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80" creationId="{B0933DC4-6416-EEAE-9B3F-51F3BE9C527E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80" creationId="{C3711566-CAAF-47C9-277A-3CF586B85E23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81" creationId="{3CFF1EDA-79AA-EC35-B12A-F0089BEB4A83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81" creationId="{A3C1BF7E-85C5-B5C4-0778-EC683E8B72A1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81" creationId="{B08FBE8D-8F7A-AC87-A15E-B1CFFD13475B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82" creationId="{51D24A0C-B393-C924-CCF3-5F754CAF7D7C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82" creationId="{54C8219F-B2AB-52C6-F565-6A6663EA5511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82" creationId="{A293E5F2-8D04-66C8-594C-27107214B57D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83" creationId="{861C00C6-62AE-CF73-6322-4198A9924EBE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83" creationId="{AA318128-7EB6-E6FA-2ECF-D464259CEB84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83" creationId="{C39A525F-7E6B-E0FE-549B-098B28CF0686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84" creationId="{39FC4C4A-FC93-A81B-8A55-A25ADDF11BC6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84" creationId="{980743B4-1D2E-F4A0-B3F0-49178254E8B6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84" creationId="{99A8A414-7893-C10F-7316-DA8962F9D76A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85" creationId="{748A9102-3C7D-6B42-EE31-8F6A1740B6A5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85" creationId="{A3556362-A7F0-4274-7FAC-CCE2CB816CCA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85" creationId="{DB6D53A8-1F63-150E-8F45-2CEA73A03115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86" creationId="{71E822F7-86DE-08FC-D17C-17D0BC5AFAC0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86" creationId="{816047C9-C753-103D-5148-5003F96E48CA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86" creationId="{976DF8FA-6717-A463-CCF9-ECB656B1D939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87" creationId="{1B095C51-EB2C-0D1E-9821-5B9084A62CEC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87" creationId="{8648211A-50BC-A720-F043-1DE72132AD3F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87" creationId="{C9F40B3F-D903-555F-4AD8-26E34262166D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88" creationId="{42B0F95B-118A-0394-27D1-A79DB4622CA8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88" creationId="{A689F19E-912A-FAD3-5224-8167C11F319B}"/>
          </ac:spMkLst>
        </pc:spChg>
        <pc:spChg chg="add del mod topLvl">
          <ac:chgData name="Reza Amini Hounejani" userId="36cb0b73-58b2-4568-a1ab-00cd49301806" providerId="ADAL" clId="{DA8FEA81-1A63-884F-A1C6-520C766F400F}" dt="2022-11-08T09:35:47.079" v="6644" actId="478"/>
          <ac:spMkLst>
            <pc:docMk/>
            <pc:sldMk cId="2229082649" sldId="258"/>
            <ac:spMk id="188" creationId="{FBC4056F-5554-D059-B2B7-5FF7D64C6F54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89" creationId="{A650F8B8-BD8E-E035-5CD4-ED4C872A7D71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89" creationId="{D84B6EC6-6B83-3DAA-292F-1ACF8869EDCE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90" creationId="{4EF53B11-E0A6-1D2F-4981-BC06E7BE26AB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90" creationId="{51C778E9-501F-F5E3-B37F-F5BF3EB1439E}"/>
          </ac:spMkLst>
        </pc:spChg>
        <pc:spChg chg="add del mod">
          <ac:chgData name="Reza Amini Hounejani" userId="36cb0b73-58b2-4568-a1ab-00cd49301806" providerId="ADAL" clId="{DA8FEA81-1A63-884F-A1C6-520C766F400F}" dt="2022-11-08T09:28:06.677" v="6550" actId="478"/>
          <ac:spMkLst>
            <pc:docMk/>
            <pc:sldMk cId="2229082649" sldId="258"/>
            <ac:spMk id="191" creationId="{3EA2400D-FD76-5067-8511-1EC1547CFB51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91" creationId="{8A6A1095-FA5D-5F67-7BAF-5AF846075559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91" creationId="{9302162E-513B-D9A7-59C5-13AEAE132009}"/>
          </ac:spMkLst>
        </pc:spChg>
        <pc:spChg chg="add mod topLvl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192" creationId="{3ED9BF21-9D29-B416-C7D7-F7E8585B8E49}"/>
          </ac:spMkLst>
        </pc:spChg>
        <pc:spChg chg="mod">
          <ac:chgData name="Reza Amini Hounejani" userId="36cb0b73-58b2-4568-a1ab-00cd49301806" providerId="ADAL" clId="{DA8FEA81-1A63-884F-A1C6-520C766F400F}" dt="2022-07-27T13:02:11.329" v="2062"/>
          <ac:spMkLst>
            <pc:docMk/>
            <pc:sldMk cId="2229082649" sldId="258"/>
            <ac:spMk id="192" creationId="{C8080E41-47E6-DBC4-D93D-CB4DE19CA22B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93" creationId="{DD5F979F-F484-1122-6510-912BB9D6DA4B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94" creationId="{0D03DCE8-004C-E07A-8E1F-79CC378B074F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95" creationId="{7E214A22-6C7E-621A-DCF1-41538A22492F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96" creationId="{526F113E-EAA1-51F8-2AD6-17183CE3B9E3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97" creationId="{FCAEDE73-B226-5496-7905-495E855EAD64}"/>
          </ac:spMkLst>
        </pc:spChg>
        <pc:spChg chg="add mod">
          <ac:chgData name="Reza Amini Hounejani" userId="36cb0b73-58b2-4568-a1ab-00cd49301806" providerId="ADAL" clId="{DA8FEA81-1A63-884F-A1C6-520C766F400F}" dt="2022-11-04T16:22:12.337" v="4644" actId="692"/>
          <ac:spMkLst>
            <pc:docMk/>
            <pc:sldMk cId="2229082649" sldId="258"/>
            <ac:spMk id="198" creationId="{E0218D42-EF39-5924-D2A2-85CD248090A4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00" creationId="{FBB7CF9F-CEEA-EA96-2CF6-A109A5C670F5}"/>
          </ac:spMkLst>
        </pc:spChg>
        <pc:spChg chg="del mod">
          <ac:chgData name="Reza Amini Hounejani" userId="36cb0b73-58b2-4568-a1ab-00cd49301806" providerId="ADAL" clId="{DA8FEA81-1A63-884F-A1C6-520C766F400F}" dt="2022-11-11T15:22:07.959" v="7460" actId="478"/>
          <ac:spMkLst>
            <pc:docMk/>
            <pc:sldMk cId="2229082649" sldId="258"/>
            <ac:spMk id="201" creationId="{039A1F3B-F02D-3790-9097-A4543C57E512}"/>
          </ac:spMkLst>
        </pc:spChg>
        <pc:spChg chg="add del mod">
          <ac:chgData name="Reza Amini Hounejani" userId="36cb0b73-58b2-4568-a1ab-00cd49301806" providerId="ADAL" clId="{DA8FEA81-1A63-884F-A1C6-520C766F400F}" dt="2022-11-14T16:24:24.385" v="8657" actId="478"/>
          <ac:spMkLst>
            <pc:docMk/>
            <pc:sldMk cId="2229082649" sldId="258"/>
            <ac:spMk id="202" creationId="{01C01F4A-94A5-F09B-CB9C-6F370F3EBCC1}"/>
          </ac:spMkLst>
        </pc:spChg>
        <pc:spChg chg="del mod topLvl">
          <ac:chgData name="Reza Amini Hounejani" userId="36cb0b73-58b2-4568-a1ab-00cd49301806" providerId="ADAL" clId="{DA8FEA81-1A63-884F-A1C6-520C766F400F}" dt="2022-11-11T15:24:18.989" v="7482" actId="478"/>
          <ac:spMkLst>
            <pc:docMk/>
            <pc:sldMk cId="2229082649" sldId="258"/>
            <ac:spMk id="202" creationId="{D1F1E798-7E12-777D-B86A-775E61F8C1AB}"/>
          </ac:spMkLst>
        </pc:spChg>
        <pc:spChg chg="del mod topLvl">
          <ac:chgData name="Reza Amini Hounejani" userId="36cb0b73-58b2-4568-a1ab-00cd49301806" providerId="ADAL" clId="{DA8FEA81-1A63-884F-A1C6-520C766F400F}" dt="2022-11-11T15:24:18.989" v="7482" actId="478"/>
          <ac:spMkLst>
            <pc:docMk/>
            <pc:sldMk cId="2229082649" sldId="258"/>
            <ac:spMk id="203" creationId="{88DF2311-EC5B-3C9C-51D1-0A3DCBE9BB90}"/>
          </ac:spMkLst>
        </pc:spChg>
        <pc:spChg chg="del mod topLvl">
          <ac:chgData name="Reza Amini Hounejani" userId="36cb0b73-58b2-4568-a1ab-00cd49301806" providerId="ADAL" clId="{DA8FEA81-1A63-884F-A1C6-520C766F400F}" dt="2022-11-11T15:24:18.989" v="7482" actId="478"/>
          <ac:spMkLst>
            <pc:docMk/>
            <pc:sldMk cId="2229082649" sldId="258"/>
            <ac:spMk id="204" creationId="{AE139059-7FCC-DD0B-D14F-F40328788D09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05" creationId="{8C7BAB65-A044-959B-1C57-4DD574A68CCE}"/>
          </ac:spMkLst>
        </pc:spChg>
        <pc:spChg chg="del mod topLvl">
          <ac:chgData name="Reza Amini Hounejani" userId="36cb0b73-58b2-4568-a1ab-00cd49301806" providerId="ADAL" clId="{DA8FEA81-1A63-884F-A1C6-520C766F400F}" dt="2022-11-11T15:24:18.989" v="7482" actId="478"/>
          <ac:spMkLst>
            <pc:docMk/>
            <pc:sldMk cId="2229082649" sldId="258"/>
            <ac:spMk id="205" creationId="{F55875BA-747F-79BA-AB97-22E3B65CD8A3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06" creationId="{749197FC-68D3-CEF5-EA93-A2CA9EDD5594}"/>
          </ac:spMkLst>
        </pc:spChg>
        <pc:spChg chg="del mod topLvl">
          <ac:chgData name="Reza Amini Hounejani" userId="36cb0b73-58b2-4568-a1ab-00cd49301806" providerId="ADAL" clId="{DA8FEA81-1A63-884F-A1C6-520C766F400F}" dt="2022-11-11T15:24:18.989" v="7482" actId="478"/>
          <ac:spMkLst>
            <pc:docMk/>
            <pc:sldMk cId="2229082649" sldId="258"/>
            <ac:spMk id="206" creationId="{C0AD7538-94DE-352F-21C2-0A0015DD7659}"/>
          </ac:spMkLst>
        </pc:spChg>
        <pc:spChg chg="del mod topLvl">
          <ac:chgData name="Reza Amini Hounejani" userId="36cb0b73-58b2-4568-a1ab-00cd49301806" providerId="ADAL" clId="{DA8FEA81-1A63-884F-A1C6-520C766F400F}" dt="2022-11-11T15:24:18.989" v="7482" actId="478"/>
          <ac:spMkLst>
            <pc:docMk/>
            <pc:sldMk cId="2229082649" sldId="258"/>
            <ac:spMk id="207" creationId="{AAEDFE54-2CB1-5D12-ED71-9FB825E2C6BE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07" creationId="{C6AA5891-9AD2-976B-338B-834068B0ACBA}"/>
          </ac:spMkLst>
        </pc:spChg>
        <pc:spChg chg="mod topLvl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08" creationId="{A0717219-60AE-0ED0-93E4-178D9AD32506}"/>
          </ac:spMkLst>
        </pc:spChg>
        <pc:spChg chg="mod topLvl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09" creationId="{1A5CA8AB-7CAD-76F9-0E0B-EBD76E20AB3B}"/>
          </ac:spMkLst>
        </pc:spChg>
        <pc:spChg chg="del mod topLvl">
          <ac:chgData name="Reza Amini Hounejani" userId="36cb0b73-58b2-4568-a1ab-00cd49301806" providerId="ADAL" clId="{DA8FEA81-1A63-884F-A1C6-520C766F400F}" dt="2022-11-04T17:06:14.171" v="5953" actId="478"/>
          <ac:spMkLst>
            <pc:docMk/>
            <pc:sldMk cId="2229082649" sldId="258"/>
            <ac:spMk id="210" creationId="{0CFA47E2-C337-64A4-9177-A9580707DF62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10" creationId="{5F49C263-D4EE-AAE3-12B2-0E83AFD82264}"/>
          </ac:spMkLst>
        </pc:spChg>
        <pc:spChg chg="del mod topLvl">
          <ac:chgData name="Reza Amini Hounejani" userId="36cb0b73-58b2-4568-a1ab-00cd49301806" providerId="ADAL" clId="{DA8FEA81-1A63-884F-A1C6-520C766F400F}" dt="2022-11-04T17:24:33.751" v="6092" actId="478"/>
          <ac:spMkLst>
            <pc:docMk/>
            <pc:sldMk cId="2229082649" sldId="258"/>
            <ac:spMk id="211" creationId="{21C28BC6-7012-6904-16AB-6545BC280E7A}"/>
          </ac:spMkLst>
        </pc:spChg>
        <pc:spChg chg="del mod">
          <ac:chgData name="Reza Amini Hounejani" userId="36cb0b73-58b2-4568-a1ab-00cd49301806" providerId="ADAL" clId="{DA8FEA81-1A63-884F-A1C6-520C766F400F}" dt="2022-11-11T15:21:08.726" v="7455" actId="478"/>
          <ac:spMkLst>
            <pc:docMk/>
            <pc:sldMk cId="2229082649" sldId="258"/>
            <ac:spMk id="211" creationId="{5DACF399-F247-1AD2-D5C2-B9E5E54EC7AD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11" creationId="{C88C1420-3953-74EB-4191-D27C360EE2BD}"/>
          </ac:spMkLst>
        </pc:spChg>
        <pc:spChg chg="del mod topLvl">
          <ac:chgData name="Reza Amini Hounejani" userId="36cb0b73-58b2-4568-a1ab-00cd49301806" providerId="ADAL" clId="{DA8FEA81-1A63-884F-A1C6-520C766F400F}" dt="2022-11-08T12:39:49.969" v="6746" actId="478"/>
          <ac:spMkLst>
            <pc:docMk/>
            <pc:sldMk cId="2229082649" sldId="258"/>
            <ac:spMk id="212" creationId="{58010327-0006-9688-387B-48DFB651C10A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12" creationId="{C499F875-64DC-D50D-D522-4E616B9F7188}"/>
          </ac:spMkLst>
        </pc:spChg>
        <pc:spChg chg="mod topLvl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13" creationId="{B9F42CFA-BC47-3733-5128-1DA93FE3E4F0}"/>
          </ac:spMkLst>
        </pc:spChg>
        <pc:spChg chg="mod topLvl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14" creationId="{E09D5499-A9FE-D4FF-549A-A8AEA5FC7B84}"/>
          </ac:spMkLst>
        </pc:spChg>
        <pc:spChg chg="mod topLvl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15" creationId="{5C15E69A-F276-21FC-6942-48AEB0EBABB0}"/>
          </ac:spMkLst>
        </pc:spChg>
        <pc:spChg chg="del mod topLvl">
          <ac:chgData name="Reza Amini Hounejani" userId="36cb0b73-58b2-4568-a1ab-00cd49301806" providerId="ADAL" clId="{DA8FEA81-1A63-884F-A1C6-520C766F400F}" dt="2022-11-11T15:23:46.255" v="7479" actId="478"/>
          <ac:spMkLst>
            <pc:docMk/>
            <pc:sldMk cId="2229082649" sldId="258"/>
            <ac:spMk id="216" creationId="{6DDD170C-5526-F5A5-E844-6606D0F1FBC9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16" creationId="{DA9F9767-54E3-9338-1CA7-09E23753B33D}"/>
          </ac:spMkLst>
        </pc:spChg>
        <pc:spChg chg="del mod topLvl">
          <ac:chgData name="Reza Amini Hounejani" userId="36cb0b73-58b2-4568-a1ab-00cd49301806" providerId="ADAL" clId="{DA8FEA81-1A63-884F-A1C6-520C766F400F}" dt="2022-11-04T17:35:25.342" v="6372" actId="478"/>
          <ac:spMkLst>
            <pc:docMk/>
            <pc:sldMk cId="2229082649" sldId="258"/>
            <ac:spMk id="217" creationId="{08C61A1E-0AD7-4D83-0661-B4034BF0066F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17" creationId="{8D36F1B0-24BB-365C-C3AA-8C97C9A80920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18" creationId="{BC8E1C0B-96CE-8DBA-5C2C-7B97F3A85FD9}"/>
          </ac:spMkLst>
        </pc:spChg>
        <pc:spChg chg="del mod topLvl">
          <ac:chgData name="Reza Amini Hounejani" userId="36cb0b73-58b2-4568-a1ab-00cd49301806" providerId="ADAL" clId="{DA8FEA81-1A63-884F-A1C6-520C766F400F}" dt="2022-11-04T17:35:25.342" v="6372" actId="478"/>
          <ac:spMkLst>
            <pc:docMk/>
            <pc:sldMk cId="2229082649" sldId="258"/>
            <ac:spMk id="218" creationId="{C0BF7CA5-2BE7-9E8C-A28E-F7C18DAE181A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19" creationId="{12BDCBB8-339A-3207-6FC6-67B2D5205B81}"/>
          </ac:spMkLst>
        </pc:spChg>
        <pc:spChg chg="del mod topLvl">
          <ac:chgData name="Reza Amini Hounejani" userId="36cb0b73-58b2-4568-a1ab-00cd49301806" providerId="ADAL" clId="{DA8FEA81-1A63-884F-A1C6-520C766F400F}" dt="2022-11-11T15:24:18.989" v="7482" actId="478"/>
          <ac:spMkLst>
            <pc:docMk/>
            <pc:sldMk cId="2229082649" sldId="258"/>
            <ac:spMk id="219" creationId="{1B176DD2-0837-5961-1C86-A1D5172C2B60}"/>
          </ac:spMkLst>
        </pc:spChg>
        <pc:spChg chg="del mod topLvl">
          <ac:chgData name="Reza Amini Hounejani" userId="36cb0b73-58b2-4568-a1ab-00cd49301806" providerId="ADAL" clId="{DA8FEA81-1A63-884F-A1C6-520C766F400F}" dt="2022-11-04T17:35:26.209" v="6373" actId="478"/>
          <ac:spMkLst>
            <pc:docMk/>
            <pc:sldMk cId="2229082649" sldId="258"/>
            <ac:spMk id="220" creationId="{51844D44-0A2D-EE39-2866-F3A6617265B8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20" creationId="{CBE0785F-B606-1638-9C0B-1FB731701AA4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21" creationId="{12252943-C963-2682-92D4-8DAFC72F37E8}"/>
          </ac:spMkLst>
        </pc:spChg>
        <pc:spChg chg="del mod topLvl">
          <ac:chgData name="Reza Amini Hounejani" userId="36cb0b73-58b2-4568-a1ab-00cd49301806" providerId="ADAL" clId="{DA8FEA81-1A63-884F-A1C6-520C766F400F}" dt="2022-11-04T17:29:24.480" v="6106" actId="478"/>
          <ac:spMkLst>
            <pc:docMk/>
            <pc:sldMk cId="2229082649" sldId="258"/>
            <ac:spMk id="221" creationId="{AED7A9B1-0F23-676F-7E99-DA6AD6BC53E2}"/>
          </ac:spMkLst>
        </pc:spChg>
        <pc:spChg chg="del mod topLvl">
          <ac:chgData name="Reza Amini Hounejani" userId="36cb0b73-58b2-4568-a1ab-00cd49301806" providerId="ADAL" clId="{DA8FEA81-1A63-884F-A1C6-520C766F400F}" dt="2022-11-04T17:29:24.480" v="6106" actId="478"/>
          <ac:spMkLst>
            <pc:docMk/>
            <pc:sldMk cId="2229082649" sldId="258"/>
            <ac:spMk id="222" creationId="{0DE82128-8963-28E9-3AAB-2E39F9F23FF2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22" creationId="{D5E6506B-9C77-F625-607D-E34BCBBDB562}"/>
          </ac:spMkLst>
        </pc:spChg>
        <pc:spChg chg="del mod topLvl">
          <ac:chgData name="Reza Amini Hounejani" userId="36cb0b73-58b2-4568-a1ab-00cd49301806" providerId="ADAL" clId="{DA8FEA81-1A63-884F-A1C6-520C766F400F}" dt="2022-11-04T17:29:24.480" v="6106" actId="478"/>
          <ac:spMkLst>
            <pc:docMk/>
            <pc:sldMk cId="2229082649" sldId="258"/>
            <ac:spMk id="223" creationId="{6BA9B052-32BD-608A-F2C2-F35355DDEF1D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23" creationId="{973410FE-9BE3-6C12-9318-217AAFE0AB6D}"/>
          </ac:spMkLst>
        </pc:spChg>
        <pc:spChg chg="del mod topLvl">
          <ac:chgData name="Reza Amini Hounejani" userId="36cb0b73-58b2-4568-a1ab-00cd49301806" providerId="ADAL" clId="{DA8FEA81-1A63-884F-A1C6-520C766F400F}" dt="2022-11-11T15:21:17.100" v="7456" actId="478"/>
          <ac:spMkLst>
            <pc:docMk/>
            <pc:sldMk cId="2229082649" sldId="258"/>
            <ac:spMk id="224" creationId="{168DFA2A-45C8-2AB7-220D-178856FA0252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24" creationId="{D39A61BE-8F8A-91E9-5222-3337AE44C9C8}"/>
          </ac:spMkLst>
        </pc:spChg>
        <pc:spChg chg="del mod topLvl">
          <ac:chgData name="Reza Amini Hounejani" userId="36cb0b73-58b2-4568-a1ab-00cd49301806" providerId="ADAL" clId="{DA8FEA81-1A63-884F-A1C6-520C766F400F}" dt="2022-11-11T15:24:18.989" v="7482" actId="478"/>
          <ac:spMkLst>
            <pc:docMk/>
            <pc:sldMk cId="2229082649" sldId="258"/>
            <ac:spMk id="225" creationId="{21FB528D-1804-03BA-C322-B244C38EA38A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25" creationId="{2E51FD53-AF96-CC3B-29E5-9985BDBD1079}"/>
          </ac:spMkLst>
        </pc:spChg>
        <pc:spChg chg="del mod topLvl">
          <ac:chgData name="Reza Amini Hounejani" userId="36cb0b73-58b2-4568-a1ab-00cd49301806" providerId="ADAL" clId="{DA8FEA81-1A63-884F-A1C6-520C766F400F}" dt="2022-11-11T15:24:18.989" v="7482" actId="478"/>
          <ac:spMkLst>
            <pc:docMk/>
            <pc:sldMk cId="2229082649" sldId="258"/>
            <ac:spMk id="226" creationId="{47483197-0D2D-9CE8-5D88-73D77B736903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26" creationId="{A86C5FED-7AB1-2F6F-0BDC-CC94E344D616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29" creationId="{482C0CDF-D71B-1533-36BD-922827ABFD1B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30" creationId="{EB5E4D51-1FDC-59DE-C0FF-891900B10ABF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31" creationId="{CC1A5D68-CCEA-791F-6BBE-E6EECD70F784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32" creationId="{0C059703-71FC-40AD-63E7-824E43C79F2B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33" creationId="{00F1A55B-21DF-007E-A06C-CF7B8206583E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34" creationId="{164791BC-BBF1-6494-1DFD-E9A1701F6802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35" creationId="{90B820F1-8184-406E-D2F2-8919552CAFCB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35" creationId="{CD019789-8A47-7283-0299-12B97F02759A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36" creationId="{15AE2A36-C841-A002-C4E4-80B7DF2EFF71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36" creationId="{D3157829-8276-6B52-D385-AA81D61DCA93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37" creationId="{1CA5510B-0C5D-C8E3-842F-D3DEFA155BFC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37" creationId="{61282BFD-A3D3-795B-B7E0-C2E1955896EF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38" creationId="{11298DE6-8B63-E1CD-A583-20FFE2ECDA4C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38" creationId="{5F49B250-13BE-910B-B229-E388B93B0026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39" creationId="{1FDC40F9-9582-B4AF-4AC8-1DF15AF06A0E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39" creationId="{26D4A6C6-9916-98D9-72EB-EBA2D64360AA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40" creationId="{6EAB45B7-91BA-53AD-31A0-18D755A85FCA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40" creationId="{CA63241D-E836-08ED-8F73-AA7460ACB426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41" creationId="{B9953C7C-6445-0C12-27EC-08EF4E7C0D2E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42" creationId="{C37F06E4-C3FE-9D51-C52F-EB6A80F55F9E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42" creationId="{D62A2B79-2336-8E56-9805-71974EAB857C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43" creationId="{56B0CCD4-6604-0BC1-30AF-E1ED429CE4B5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43" creationId="{C61F4787-23C5-5344-A34D-469F7449C301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44" creationId="{AD046D8A-6634-40EB-7A51-C4A487FB2102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44" creationId="{E5368337-C346-789F-D32F-7881D6B352B8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45" creationId="{67BBED9E-94A4-6990-97DD-50765AC90683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45" creationId="{FCF5E19B-F3BA-0309-30D2-1ABD552160AC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46" creationId="{88D14A9F-5488-ED5E-DA3C-AB0330D53CB3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46" creationId="{A5A522E8-435A-63FB-FB61-267A9400DBAC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47" creationId="{891E2FCD-7CE8-2DAF-8480-756EA07781CA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47" creationId="{9AD83643-580F-D9F9-4C0E-24232B40B9D9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48" creationId="{1D7023FB-DCB4-94F8-D6D3-7E33CD2C1E87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48" creationId="{E1E899E9-745C-BEBF-9CF4-70701E5E1838}"/>
          </ac:spMkLst>
        </pc:spChg>
        <pc:spChg chg="add del mod">
          <ac:chgData name="Reza Amini Hounejani" userId="36cb0b73-58b2-4568-a1ab-00cd49301806" providerId="ADAL" clId="{DA8FEA81-1A63-884F-A1C6-520C766F400F}" dt="2022-11-11T15:27:49.922" v="7507" actId="478"/>
          <ac:spMkLst>
            <pc:docMk/>
            <pc:sldMk cId="2229082649" sldId="258"/>
            <ac:spMk id="249" creationId="{55CAC35B-FDF3-9DD2-D7A3-8DAFCD1909DA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49" creationId="{A9B6B9D4-F5B9-BF6F-1897-417E2A1EEA96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50" creationId="{02A07AAE-1615-8BF7-C663-D67296A88660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51" creationId="{EE8073A2-0ECB-0ABB-B490-4CD67609B666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52" creationId="{76651A81-6544-D488-B7E5-B1B352BE2428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53" creationId="{18F0D659-C777-6396-DFB8-F92427760373}"/>
          </ac:spMkLst>
        </pc:spChg>
        <pc:spChg chg="add 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254" creationId="{C502AC93-3AA8-D8C5-BA35-E2F29BC4308F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55" creationId="{16E407B5-22F2-3E46-5880-BB929AF99275}"/>
          </ac:spMkLst>
        </pc:spChg>
        <pc:spChg chg="add mod">
          <ac:chgData name="Reza Amini Hounejani" userId="36cb0b73-58b2-4568-a1ab-00cd49301806" providerId="ADAL" clId="{DA8FEA81-1A63-884F-A1C6-520C766F400F}" dt="2022-07-27T13:45:09.976" v="2131" actId="571"/>
          <ac:spMkLst>
            <pc:docMk/>
            <pc:sldMk cId="2229082649" sldId="258"/>
            <ac:spMk id="255" creationId="{8AFA41D6-72D9-6E59-9B64-C89AE91116B9}"/>
          </ac:spMkLst>
        </pc:spChg>
        <pc:spChg chg="add 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256" creationId="{D07CB2C9-AE57-3B51-C03B-8EE661D6038D}"/>
          </ac:spMkLst>
        </pc:spChg>
        <pc:spChg chg="add 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257" creationId="{FDE4D47C-E573-7138-D832-E6DCBF591473}"/>
          </ac:spMkLst>
        </pc:spChg>
        <pc:spChg chg="add 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258" creationId="{47745678-A373-304E-9D53-38B9B2C736A8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59" creationId="{210AA1EC-2471-905C-F81C-3D2598A3866A}"/>
          </ac:spMkLst>
        </pc:spChg>
        <pc:spChg chg="add del mod">
          <ac:chgData name="Reza Amini Hounejani" userId="36cb0b73-58b2-4568-a1ab-00cd49301806" providerId="ADAL" clId="{DA8FEA81-1A63-884F-A1C6-520C766F400F}" dt="2022-11-24T10:24:24.227" v="11655" actId="478"/>
          <ac:spMkLst>
            <pc:docMk/>
            <pc:sldMk cId="2229082649" sldId="258"/>
            <ac:spMk id="260" creationId="{B35875C2-9BCE-817A-B9AA-DB6A1A5BC1B8}"/>
          </ac:spMkLst>
        </pc:spChg>
        <pc:spChg chg="add del mod">
          <ac:chgData name="Reza Amini Hounejani" userId="36cb0b73-58b2-4568-a1ab-00cd49301806" providerId="ADAL" clId="{DA8FEA81-1A63-884F-A1C6-520C766F400F}" dt="2022-11-24T10:22:49.197" v="11654" actId="478"/>
          <ac:spMkLst>
            <pc:docMk/>
            <pc:sldMk cId="2229082649" sldId="258"/>
            <ac:spMk id="261" creationId="{0A6E8E0A-3356-D6BC-AC5E-347F2CC4139B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62" creationId="{BEB22CAC-0847-6A6A-2DE5-A7DC7B751FFE}"/>
          </ac:spMkLst>
        </pc:spChg>
        <pc:spChg chg="add mod">
          <ac:chgData name="Reza Amini Hounejani" userId="36cb0b73-58b2-4568-a1ab-00cd49301806" providerId="ADAL" clId="{DA8FEA81-1A63-884F-A1C6-520C766F400F}" dt="2022-07-27T13:47:47.085" v="2176" actId="571"/>
          <ac:spMkLst>
            <pc:docMk/>
            <pc:sldMk cId="2229082649" sldId="258"/>
            <ac:spMk id="262" creationId="{D2714509-2F95-51D0-8F74-F597FD0BEF8C}"/>
          </ac:spMkLst>
        </pc:spChg>
        <pc:spChg chg="add mod">
          <ac:chgData name="Reza Amini Hounejani" userId="36cb0b73-58b2-4568-a1ab-00cd49301806" providerId="ADAL" clId="{DA8FEA81-1A63-884F-A1C6-520C766F400F}" dt="2022-07-27T13:47:50.873" v="2178" actId="571"/>
          <ac:spMkLst>
            <pc:docMk/>
            <pc:sldMk cId="2229082649" sldId="258"/>
            <ac:spMk id="263" creationId="{2FBFD0EB-7D50-BEFE-C86E-4F799BD731D0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65" creationId="{F9586B57-A490-21D5-586C-5AF0A24EE818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66" creationId="{22B4DD60-A689-9A93-6448-1ABF1D981A71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67" creationId="{44A28396-ADD5-56FA-29E0-20867C66FB12}"/>
          </ac:spMkLst>
        </pc:spChg>
        <pc:spChg chg="del mod topLvl">
          <ac:chgData name="Reza Amini Hounejani" userId="36cb0b73-58b2-4568-a1ab-00cd49301806" providerId="ADAL" clId="{DA8FEA81-1A63-884F-A1C6-520C766F400F}" dt="2022-11-04T17:31:04.316" v="6332" actId="478"/>
          <ac:spMkLst>
            <pc:docMk/>
            <pc:sldMk cId="2229082649" sldId="258"/>
            <ac:spMk id="269" creationId="{AE3BFDDB-8D8B-DB49-02BA-23F80E3B0415}"/>
          </ac:spMkLst>
        </pc:spChg>
        <pc:spChg chg="add 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71" creationId="{F58570E1-7ADE-7FBE-A68B-C0399FB719E6}"/>
          </ac:spMkLst>
        </pc:spChg>
        <pc:spChg chg="add del">
          <ac:chgData name="Reza Amini Hounejani" userId="36cb0b73-58b2-4568-a1ab-00cd49301806" providerId="ADAL" clId="{DA8FEA81-1A63-884F-A1C6-520C766F400F}" dt="2022-11-04T17:31:21.950" v="6336" actId="478"/>
          <ac:spMkLst>
            <pc:docMk/>
            <pc:sldMk cId="2229082649" sldId="258"/>
            <ac:spMk id="272" creationId="{2E5DEE1F-2382-5A05-B42C-4E8E1B712831}"/>
          </ac:spMkLst>
        </pc:spChg>
        <pc:spChg chg="add 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272" creationId="{31CDEFCD-A271-38DA-3C3B-D0BFAADA0407}"/>
          </ac:spMkLst>
        </pc:spChg>
        <pc:spChg chg="add del mod">
          <ac:chgData name="Reza Amini Hounejani" userId="36cb0b73-58b2-4568-a1ab-00cd49301806" providerId="ADAL" clId="{DA8FEA81-1A63-884F-A1C6-520C766F400F}" dt="2022-11-04T17:31:41.148" v="6339" actId="478"/>
          <ac:spMkLst>
            <pc:docMk/>
            <pc:sldMk cId="2229082649" sldId="258"/>
            <ac:spMk id="273" creationId="{048D0695-7208-3B64-F227-E22AC7C7DCCF}"/>
          </ac:spMkLst>
        </pc:spChg>
        <pc:spChg chg="add del mod">
          <ac:chgData name="Reza Amini Hounejani" userId="36cb0b73-58b2-4568-a1ab-00cd49301806" providerId="ADAL" clId="{DA8FEA81-1A63-884F-A1C6-520C766F400F}" dt="2022-11-08T08:58:32.697" v="6492" actId="478"/>
          <ac:spMkLst>
            <pc:docMk/>
            <pc:sldMk cId="2229082649" sldId="258"/>
            <ac:spMk id="274" creationId="{0F262054-A130-156F-DF8F-D1BC3C4BAB5D}"/>
          </ac:spMkLst>
        </pc:spChg>
        <pc:spChg chg="add mod">
          <ac:chgData name="Reza Amini Hounejani" userId="36cb0b73-58b2-4568-a1ab-00cd49301806" providerId="ADAL" clId="{DA8FEA81-1A63-884F-A1C6-520C766F400F}" dt="2022-11-11T16:22:42.121" v="7561" actId="571"/>
          <ac:spMkLst>
            <pc:docMk/>
            <pc:sldMk cId="2229082649" sldId="258"/>
            <ac:spMk id="275" creationId="{7AF910C1-5438-D2D3-DED2-BDD9A72F6A7F}"/>
          </ac:spMkLst>
        </pc:spChg>
        <pc:spChg chg="add del mod">
          <ac:chgData name="Reza Amini Hounejani" userId="36cb0b73-58b2-4568-a1ab-00cd49301806" providerId="ADAL" clId="{DA8FEA81-1A63-884F-A1C6-520C766F400F}" dt="2022-11-24T10:24:24.227" v="11655" actId="478"/>
          <ac:spMkLst>
            <pc:docMk/>
            <pc:sldMk cId="2229082649" sldId="258"/>
            <ac:spMk id="277" creationId="{FFBC9BEC-2692-B8C1-0C4D-97F38D22CE48}"/>
          </ac:spMkLst>
        </pc:spChg>
        <pc:spChg chg="add mod">
          <ac:chgData name="Reza Amini Hounejani" userId="36cb0b73-58b2-4568-a1ab-00cd49301806" providerId="ADAL" clId="{DA8FEA81-1A63-884F-A1C6-520C766F400F}" dt="2022-11-24T10:21:26.548" v="11633" actId="1037"/>
          <ac:spMkLst>
            <pc:docMk/>
            <pc:sldMk cId="2229082649" sldId="258"/>
            <ac:spMk id="278" creationId="{165F1796-17D9-C356-9D67-60B23A3B3B36}"/>
          </ac:spMkLst>
        </pc:spChg>
        <pc:spChg chg="add del mod">
          <ac:chgData name="Reza Amini Hounejani" userId="36cb0b73-58b2-4568-a1ab-00cd49301806" providerId="ADAL" clId="{DA8FEA81-1A63-884F-A1C6-520C766F400F}" dt="2022-11-11T16:33:03.660" v="8209" actId="478"/>
          <ac:spMkLst>
            <pc:docMk/>
            <pc:sldMk cId="2229082649" sldId="258"/>
            <ac:spMk id="280" creationId="{CF470561-13DA-7A82-CE10-7A55E1BFDCB8}"/>
          </ac:spMkLst>
        </pc:spChg>
        <pc:spChg chg="add del mod">
          <ac:chgData name="Reza Amini Hounejani" userId="36cb0b73-58b2-4568-a1ab-00cd49301806" providerId="ADAL" clId="{DA8FEA81-1A63-884F-A1C6-520C766F400F}" dt="2022-11-08T09:40:04.786" v="6720" actId="478"/>
          <ac:spMkLst>
            <pc:docMk/>
            <pc:sldMk cId="2229082649" sldId="258"/>
            <ac:spMk id="281" creationId="{7B9FF85C-B178-9479-9256-C21D1E0ABA4E}"/>
          </ac:spMkLst>
        </pc:spChg>
        <pc:spChg chg="add del mod">
          <ac:chgData name="Reza Amini Hounejani" userId="36cb0b73-58b2-4568-a1ab-00cd49301806" providerId="ADAL" clId="{DA8FEA81-1A63-884F-A1C6-520C766F400F}" dt="2022-11-11T16:39:32.633" v="8258" actId="478"/>
          <ac:spMkLst>
            <pc:docMk/>
            <pc:sldMk cId="2229082649" sldId="258"/>
            <ac:spMk id="281" creationId="{803B48E6-4BD9-1476-7542-01B6BDDD0BDB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81" creationId="{BC5B59D3-DF23-2715-3D3F-E506B79CCD25}"/>
          </ac:spMkLst>
        </pc:spChg>
        <pc:spChg chg="add del mod">
          <ac:chgData name="Reza Amini Hounejani" userId="36cb0b73-58b2-4568-a1ab-00cd49301806" providerId="ADAL" clId="{DA8FEA81-1A63-884F-A1C6-520C766F400F}" dt="2022-11-11T16:39:33.617" v="8259" actId="478"/>
          <ac:spMkLst>
            <pc:docMk/>
            <pc:sldMk cId="2229082649" sldId="258"/>
            <ac:spMk id="283" creationId="{1FAAAA0A-C2A8-DE71-FA07-F031B399818B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83" creationId="{FC2A4629-4AEF-D573-FF92-74D3610E0D92}"/>
          </ac:spMkLst>
        </pc:spChg>
        <pc:spChg chg="add del mod">
          <ac:chgData name="Reza Amini Hounejani" userId="36cb0b73-58b2-4568-a1ab-00cd49301806" providerId="ADAL" clId="{DA8FEA81-1A63-884F-A1C6-520C766F400F}" dt="2022-11-04T17:39:52.842" v="6413" actId="478"/>
          <ac:spMkLst>
            <pc:docMk/>
            <pc:sldMk cId="2229082649" sldId="258"/>
            <ac:spMk id="284" creationId="{50E4C81A-55AC-1C3D-1441-A9A7699AF70F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84" creationId="{809A6EAB-3BB7-C334-4EDD-6ED53239AB33}"/>
          </ac:spMkLst>
        </pc:spChg>
        <pc:spChg chg="add del mod">
          <ac:chgData name="Reza Amini Hounejani" userId="36cb0b73-58b2-4568-a1ab-00cd49301806" providerId="ADAL" clId="{DA8FEA81-1A63-884F-A1C6-520C766F400F}" dt="2022-11-11T16:35:38.261" v="8221" actId="478"/>
          <ac:spMkLst>
            <pc:docMk/>
            <pc:sldMk cId="2229082649" sldId="258"/>
            <ac:spMk id="284" creationId="{E0CB4111-094A-FDEF-2E75-ECB260981784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85" creationId="{4651B0B5-9D15-5020-5010-A75137E577DB}"/>
          </ac:spMkLst>
        </pc:spChg>
        <pc:spChg chg="add del mod">
          <ac:chgData name="Reza Amini Hounejani" userId="36cb0b73-58b2-4568-a1ab-00cd49301806" providerId="ADAL" clId="{DA8FEA81-1A63-884F-A1C6-520C766F400F}" dt="2022-11-11T16:37:48.662" v="8246" actId="478"/>
          <ac:spMkLst>
            <pc:docMk/>
            <pc:sldMk cId="2229082649" sldId="258"/>
            <ac:spMk id="285" creationId="{4CA7C97A-1143-842C-CD8A-E55EBCF7B019}"/>
          </ac:spMkLst>
        </pc:spChg>
        <pc:spChg chg="add mod">
          <ac:chgData name="Reza Amini Hounejani" userId="36cb0b73-58b2-4568-a1ab-00cd49301806" providerId="ADAL" clId="{DA8FEA81-1A63-884F-A1C6-520C766F400F}" dt="2022-11-11T16:40:50.755" v="8265" actId="164"/>
          <ac:spMkLst>
            <pc:docMk/>
            <pc:sldMk cId="2229082649" sldId="258"/>
            <ac:spMk id="286" creationId="{7304B383-2B08-BCE2-9387-7F0845DB7C73}"/>
          </ac:spMkLst>
        </pc:spChg>
        <pc:spChg chg="add del mod">
          <ac:chgData name="Reza Amini Hounejani" userId="36cb0b73-58b2-4568-a1ab-00cd49301806" providerId="ADAL" clId="{DA8FEA81-1A63-884F-A1C6-520C766F400F}" dt="2022-11-08T12:44:29.197" v="6774" actId="478"/>
          <ac:spMkLst>
            <pc:docMk/>
            <pc:sldMk cId="2229082649" sldId="258"/>
            <ac:spMk id="289" creationId="{A696B98E-F31E-3E11-9162-F591AF8D0715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89" creationId="{DCA50B3B-8473-59D6-EB97-2E94EE0FE135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90" creationId="{AEF22425-9E06-6073-85E6-40D96F3D9F12}"/>
          </ac:spMkLst>
        </pc:spChg>
        <pc:spChg chg="add del mod">
          <ac:chgData name="Reza Amini Hounejani" userId="36cb0b73-58b2-4568-a1ab-00cd49301806" providerId="ADAL" clId="{DA8FEA81-1A63-884F-A1C6-520C766F400F}" dt="2022-11-08T12:44:33.215" v="6777" actId="478"/>
          <ac:spMkLst>
            <pc:docMk/>
            <pc:sldMk cId="2229082649" sldId="258"/>
            <ac:spMk id="290" creationId="{C1389D81-49C4-6575-7F17-886366FADECD}"/>
          </ac:spMkLst>
        </pc:spChg>
        <pc:spChg chg="add 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291" creationId="{1F7B38F9-6B29-6D77-1D67-432FC5D0EA28}"/>
          </ac:spMkLst>
        </pc:spChg>
        <pc:spChg chg="add 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292" creationId="{D7EDDC28-CCCC-F820-32BF-E35678B33AC1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93" creationId="{A4A3625C-E49F-F8C4-6DAF-D226EF6C290D}"/>
          </ac:spMkLst>
        </pc:spChg>
        <pc:spChg chg="add del mod">
          <ac:chgData name="Reza Amini Hounejani" userId="36cb0b73-58b2-4568-a1ab-00cd49301806" providerId="ADAL" clId="{DA8FEA81-1A63-884F-A1C6-520C766F400F}" dt="2022-11-24T10:24:24.227" v="11655" actId="478"/>
          <ac:spMkLst>
            <pc:docMk/>
            <pc:sldMk cId="2229082649" sldId="258"/>
            <ac:spMk id="294" creationId="{5CCAF781-DAD9-E6E6-0E0C-058F376996B8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95" creationId="{49AE5F24-0258-1650-EF6D-68F29EE9D27E}"/>
          </ac:spMkLst>
        </pc:spChg>
        <pc:spChg chg="add del mod">
          <ac:chgData name="Reza Amini Hounejani" userId="36cb0b73-58b2-4568-a1ab-00cd49301806" providerId="ADAL" clId="{DA8FEA81-1A63-884F-A1C6-520C766F400F}" dt="2022-11-11T15:20:39.653" v="7448" actId="478"/>
          <ac:spMkLst>
            <pc:docMk/>
            <pc:sldMk cId="2229082649" sldId="258"/>
            <ac:spMk id="295" creationId="{C3764A40-974E-8A22-E6E8-825366833897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96" creationId="{E7AE8941-D32A-EF09-775B-7113EAFD23EA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97" creationId="{545C9BCA-679F-2D63-F36D-77775A7A1FA2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98" creationId="{4E8AE545-FA2B-6F58-D276-7B84AAF21925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299" creationId="{E9F81986-CAF7-944B-7202-2BF92C73D6B9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00" creationId="{DC04F542-6619-DD63-2EC5-D66CA60ACDEB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01" creationId="{6FA827BF-0583-FE65-D53D-12C348A11018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02" creationId="{B2340E83-2721-B024-DEED-3A44713B0ECA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04" creationId="{7742391F-AA77-1DA6-0F9D-01DED5E8690F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05" creationId="{97381771-255D-0C14-8804-8194AFA938A6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06" creationId="{DEE46335-6323-4032-6A6E-E18F9E37574A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07" creationId="{09B848FD-AB8A-35AD-2747-3FFFD7C3AD7C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08" creationId="{51CC608A-024B-3C98-CDBF-0D234295D243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09" creationId="{1CD6E823-691F-E75A-C78F-F2AB594D352C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10" creationId="{EE50E06B-D0ED-6630-6D33-8BD32ED1CDC1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11" creationId="{5A12B62A-D113-9926-B82A-D8B900261394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12" creationId="{F4AFFC44-C809-2880-30D8-3A1DE4B5C3BC}"/>
          </ac:spMkLst>
        </pc:spChg>
        <pc:spChg chg="mod">
          <ac:chgData name="Reza Amini Hounejani" userId="36cb0b73-58b2-4568-a1ab-00cd49301806" providerId="ADAL" clId="{DA8FEA81-1A63-884F-A1C6-520C766F400F}" dt="2022-11-14T16:33:40.180" v="8671" actId="1582"/>
          <ac:spMkLst>
            <pc:docMk/>
            <pc:sldMk cId="2229082649" sldId="258"/>
            <ac:spMk id="313" creationId="{9B9EE0B4-BC6C-1423-D3A8-BE2A8AAC761F}"/>
          </ac:spMkLst>
        </pc:spChg>
        <pc:spChg chg="add mod">
          <ac:chgData name="Reza Amini Hounejani" userId="36cb0b73-58b2-4568-a1ab-00cd49301806" providerId="ADAL" clId="{DA8FEA81-1A63-884F-A1C6-520C766F400F}" dt="2022-11-16T12:51:11.436" v="9224" actId="571"/>
          <ac:spMkLst>
            <pc:docMk/>
            <pc:sldMk cId="2229082649" sldId="258"/>
            <ac:spMk id="314" creationId="{076152BB-0004-1016-BEF2-584D137E35C6}"/>
          </ac:spMkLst>
        </pc:spChg>
        <pc:spChg chg="add mod">
          <ac:chgData name="Reza Amini Hounejani" userId="36cb0b73-58b2-4568-a1ab-00cd49301806" providerId="ADAL" clId="{DA8FEA81-1A63-884F-A1C6-520C766F400F}" dt="2022-11-24T10:22:23.760" v="11653" actId="1076"/>
          <ac:spMkLst>
            <pc:docMk/>
            <pc:sldMk cId="2229082649" sldId="258"/>
            <ac:spMk id="316" creationId="{F8572690-42CF-0AD9-8CD9-8D6A67398AEB}"/>
          </ac:spMkLst>
        </pc:spChg>
        <pc:spChg chg="add mod">
          <ac:chgData name="Reza Amini Hounejani" userId="36cb0b73-58b2-4568-a1ab-00cd49301806" providerId="ADAL" clId="{DA8FEA81-1A63-884F-A1C6-520C766F400F}" dt="2022-11-24T10:21:26.548" v="11633" actId="1037"/>
          <ac:spMkLst>
            <pc:docMk/>
            <pc:sldMk cId="2229082649" sldId="258"/>
            <ac:spMk id="323" creationId="{54B7998B-D12F-C1D8-E52C-8D85B65A317C}"/>
          </ac:spMkLst>
        </pc:spChg>
        <pc:spChg chg="add mod">
          <ac:chgData name="Reza Amini Hounejani" userId="36cb0b73-58b2-4568-a1ab-00cd49301806" providerId="ADAL" clId="{DA8FEA81-1A63-884F-A1C6-520C766F400F}" dt="2022-11-24T10:21:26.548" v="11633" actId="1037"/>
          <ac:spMkLst>
            <pc:docMk/>
            <pc:sldMk cId="2229082649" sldId="258"/>
            <ac:spMk id="324" creationId="{4AA4C047-9E46-52F2-3D2E-F5495776A7E9}"/>
          </ac:spMkLst>
        </pc:spChg>
        <pc:spChg chg="add del mod">
          <ac:chgData name="Reza Amini Hounejani" userId="36cb0b73-58b2-4568-a1ab-00cd49301806" providerId="ADAL" clId="{DA8FEA81-1A63-884F-A1C6-520C766F400F}" dt="2022-11-16T15:54:40.370" v="9699" actId="478"/>
          <ac:spMkLst>
            <pc:docMk/>
            <pc:sldMk cId="2229082649" sldId="258"/>
            <ac:spMk id="325" creationId="{9963006C-3A8C-7188-AB30-4027C3DE3615}"/>
          </ac:spMkLst>
        </pc:spChg>
        <pc:spChg chg="add del mod">
          <ac:chgData name="Reza Amini Hounejani" userId="36cb0b73-58b2-4568-a1ab-00cd49301806" providerId="ADAL" clId="{DA8FEA81-1A63-884F-A1C6-520C766F400F}" dt="2022-11-14T16:18:47.521" v="8559" actId="478"/>
          <ac:spMkLst>
            <pc:docMk/>
            <pc:sldMk cId="2229082649" sldId="258"/>
            <ac:spMk id="326" creationId="{31F8630C-7105-1E26-849C-DF08B73A6EE4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26" creationId="{FCCF24CC-03E0-18F6-0636-C7E29FA24CCA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27" creationId="{99EAFB41-3254-64C6-2AD6-8C0B7F841E96}"/>
          </ac:spMkLst>
        </pc:spChg>
        <pc:spChg chg="add mod">
          <ac:chgData name="Reza Amini Hounejani" userId="36cb0b73-58b2-4568-a1ab-00cd49301806" providerId="ADAL" clId="{DA8FEA81-1A63-884F-A1C6-520C766F400F}" dt="2022-11-24T10:21:26.548" v="11633" actId="1037"/>
          <ac:spMkLst>
            <pc:docMk/>
            <pc:sldMk cId="2229082649" sldId="258"/>
            <ac:spMk id="329" creationId="{EAD581ED-0046-8ABA-75A9-BC5C579ADFD1}"/>
          </ac:spMkLst>
        </pc:spChg>
        <pc:spChg chg="add mod">
          <ac:chgData name="Reza Amini Hounejani" userId="36cb0b73-58b2-4568-a1ab-00cd49301806" providerId="ADAL" clId="{DA8FEA81-1A63-884F-A1C6-520C766F400F}" dt="2022-11-24T10:21:21.848" v="11626" actId="1037"/>
          <ac:spMkLst>
            <pc:docMk/>
            <pc:sldMk cId="2229082649" sldId="258"/>
            <ac:spMk id="330" creationId="{F88CCEAB-7466-9821-85AD-3E780B3DC8C8}"/>
          </ac:spMkLst>
        </pc:spChg>
        <pc:spChg chg="add mod">
          <ac:chgData name="Reza Amini Hounejani" userId="36cb0b73-58b2-4568-a1ab-00cd49301806" providerId="ADAL" clId="{DA8FEA81-1A63-884F-A1C6-520C766F400F}" dt="2022-11-24T10:21:06.720" v="11617" actId="1037"/>
          <ac:spMkLst>
            <pc:docMk/>
            <pc:sldMk cId="2229082649" sldId="258"/>
            <ac:spMk id="331" creationId="{5C96E350-6390-24A7-6524-84CC5EFC7295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32" creationId="{CF3597B9-C0CC-32BC-8151-6BC507C39E77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33" creationId="{D570F92A-E802-E09C-5EA5-F0E769B76590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34" creationId="{BD198627-0AC4-D6A8-7BA2-6AD92A4B5063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35" creationId="{F1F21630-A38B-51E1-D01B-736273CE8858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36" creationId="{A6C82040-8B3B-C141-851F-7547C9312E59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37" creationId="{67F4BC2B-E5BA-6630-0FCD-8CCD78C8BFD8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38" creationId="{A5C01765-7A8F-2AAC-4108-7D98EBAFBFFE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39" creationId="{5102BFE5-DBDD-93C2-CDEA-63F2ACB22798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40" creationId="{36D553AB-F8D0-76EF-CAA8-E9A6AA8B695C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41" creationId="{6828FCE9-91EA-C60C-B6D7-811624E966E1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42" creationId="{1D0D826B-D725-DD4D-543D-6E36D5604CA3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43" creationId="{9BFDCA4D-3753-B64B-5777-1962AC11BF1E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44" creationId="{0378FD7E-1F09-8291-E669-81FEA6391F4C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45" creationId="{F848AC78-D0C4-4FD7-E5AD-571D198293DA}"/>
          </ac:spMkLst>
        </pc:spChg>
        <pc:spChg chg="mod">
          <ac:chgData name="Reza Amini Hounejani" userId="36cb0b73-58b2-4568-a1ab-00cd49301806" providerId="ADAL" clId="{DA8FEA81-1A63-884F-A1C6-520C766F400F}" dt="2022-11-16T12:51:06.167" v="9223" actId="571"/>
          <ac:spMkLst>
            <pc:docMk/>
            <pc:sldMk cId="2229082649" sldId="258"/>
            <ac:spMk id="346" creationId="{C2036795-D334-B55E-37FE-7C168D5FD9C1}"/>
          </ac:spMkLst>
        </pc:spChg>
        <pc:spChg chg="add mod">
          <ac:chgData name="Reza Amini Hounejani" userId="36cb0b73-58b2-4568-a1ab-00cd49301806" providerId="ADAL" clId="{DA8FEA81-1A63-884F-A1C6-520C766F400F}" dt="2022-11-16T12:51:14.700" v="9234" actId="20577"/>
          <ac:spMkLst>
            <pc:docMk/>
            <pc:sldMk cId="2229082649" sldId="258"/>
            <ac:spMk id="347" creationId="{5DF20D76-EB1E-9823-67EA-D838A675613A}"/>
          </ac:spMkLst>
        </pc:spChg>
        <pc:spChg chg="add mod">
          <ac:chgData name="Reza Amini Hounejani" userId="36cb0b73-58b2-4568-a1ab-00cd49301806" providerId="ADAL" clId="{DA8FEA81-1A63-884F-A1C6-520C766F400F}" dt="2022-11-16T12:51:52.434" v="9248" actId="571"/>
          <ac:spMkLst>
            <pc:docMk/>
            <pc:sldMk cId="2229082649" sldId="258"/>
            <ac:spMk id="350" creationId="{C1CA828C-C68B-38E9-7164-EFB0316215AE}"/>
          </ac:spMkLst>
        </pc:spChg>
        <pc:spChg chg="add mod">
          <ac:chgData name="Reza Amini Hounejani" userId="36cb0b73-58b2-4568-a1ab-00cd49301806" providerId="ADAL" clId="{DA8FEA81-1A63-884F-A1C6-520C766F400F}" dt="2022-11-16T12:52:04.086" v="9259" actId="1076"/>
          <ac:spMkLst>
            <pc:docMk/>
            <pc:sldMk cId="2229082649" sldId="258"/>
            <ac:spMk id="351" creationId="{346C002A-3C34-F1E3-628D-50879A809B42}"/>
          </ac:spMkLst>
        </pc:spChg>
        <pc:spChg chg="add del mod">
          <ac:chgData name="Reza Amini Hounejani" userId="36cb0b73-58b2-4568-a1ab-00cd49301806" providerId="ADAL" clId="{DA8FEA81-1A63-884F-A1C6-520C766F400F}" dt="2022-11-16T15:54:41.562" v="9700" actId="478"/>
          <ac:spMkLst>
            <pc:docMk/>
            <pc:sldMk cId="2229082649" sldId="258"/>
            <ac:spMk id="352" creationId="{C6F7C41D-C14E-395C-6567-A803E00652B5}"/>
          </ac:spMkLst>
        </pc:spChg>
        <pc:grpChg chg="mod">
          <ac:chgData name="Reza Amini Hounejani" userId="36cb0b73-58b2-4568-a1ab-00cd49301806" providerId="ADAL" clId="{DA8FEA81-1A63-884F-A1C6-520C766F400F}" dt="2022-11-16T12:51:11.436" v="9224" actId="571"/>
          <ac:grpSpMkLst>
            <pc:docMk/>
            <pc:sldMk cId="2229082649" sldId="258"/>
            <ac:grpSpMk id="5" creationId="{CDAD44DC-F58D-CE82-6BDA-0E825E7C349C}"/>
          </ac:grpSpMkLst>
        </pc:grpChg>
        <pc:grpChg chg="mod">
          <ac:chgData name="Reza Amini Hounejani" userId="36cb0b73-58b2-4568-a1ab-00cd49301806" providerId="ADAL" clId="{DA8FEA81-1A63-884F-A1C6-520C766F400F}" dt="2022-11-16T12:51:52.434" v="9248" actId="571"/>
          <ac:grpSpMkLst>
            <pc:docMk/>
            <pc:sldMk cId="2229082649" sldId="258"/>
            <ac:grpSpMk id="9" creationId="{4FA02364-CA3B-BC98-E7FA-9BF84594DCDB}"/>
          </ac:grpSpMkLst>
        </pc:grpChg>
        <pc:grpChg chg="del">
          <ac:chgData name="Reza Amini Hounejani" userId="36cb0b73-58b2-4568-a1ab-00cd49301806" providerId="ADAL" clId="{DA8FEA81-1A63-884F-A1C6-520C766F400F}" dt="2022-07-27T09:56:47.135" v="1286" actId="478"/>
          <ac:grpSpMkLst>
            <pc:docMk/>
            <pc:sldMk cId="2229082649" sldId="258"/>
            <ac:grpSpMk id="48" creationId="{7F8F1C15-8124-13AB-92C0-62BE8CB98835}"/>
          </ac:grpSpMkLst>
        </pc:grpChg>
        <pc:grpChg chg="mod">
          <ac:chgData name="Reza Amini Hounejani" userId="36cb0b73-58b2-4568-a1ab-00cd49301806" providerId="ADAL" clId="{DA8FEA81-1A63-884F-A1C6-520C766F400F}" dt="2022-11-10T10:58:20.549" v="7249" actId="465"/>
          <ac:grpSpMkLst>
            <pc:docMk/>
            <pc:sldMk cId="2229082649" sldId="258"/>
            <ac:grpSpMk id="59" creationId="{478FB034-8E37-A271-84A0-C7A7B541C99B}"/>
          </ac:grpSpMkLst>
        </pc:grpChg>
        <pc:grpChg chg="add mod">
          <ac:chgData name="Reza Amini Hounejani" userId="36cb0b73-58b2-4568-a1ab-00cd49301806" providerId="ADAL" clId="{DA8FEA81-1A63-884F-A1C6-520C766F400F}" dt="2022-11-04T16:57:06.976" v="4655" actId="164"/>
          <ac:grpSpMkLst>
            <pc:docMk/>
            <pc:sldMk cId="2229082649" sldId="258"/>
            <ac:grpSpMk id="68" creationId="{E22394D5-FF73-5563-881A-1B54E65A60A6}"/>
          </ac:grpSpMkLst>
        </pc:grpChg>
        <pc:grpChg chg="mod">
          <ac:chgData name="Reza Amini Hounejani" userId="36cb0b73-58b2-4568-a1ab-00cd49301806" providerId="ADAL" clId="{DA8FEA81-1A63-884F-A1C6-520C766F400F}" dt="2022-07-27T09:58:51.313" v="1326" actId="164"/>
          <ac:grpSpMkLst>
            <pc:docMk/>
            <pc:sldMk cId="2229082649" sldId="258"/>
            <ac:grpSpMk id="69" creationId="{1894084B-402F-55D0-DDA6-5D566BE56643}"/>
          </ac:grpSpMkLst>
        </pc:grpChg>
        <pc:grpChg chg="add mod">
          <ac:chgData name="Reza Amini Hounejani" userId="36cb0b73-58b2-4568-a1ab-00cd49301806" providerId="ADAL" clId="{DA8FEA81-1A63-884F-A1C6-520C766F400F}" dt="2022-11-08T09:28:34.994" v="6555" actId="164"/>
          <ac:grpSpMkLst>
            <pc:docMk/>
            <pc:sldMk cId="2229082649" sldId="258"/>
            <ac:grpSpMk id="72" creationId="{F91D1A22-6058-402E-269D-375E8A240076}"/>
          </ac:grpSpMkLst>
        </pc:grpChg>
        <pc:grpChg chg="add mod">
          <ac:chgData name="Reza Amini Hounejani" userId="36cb0b73-58b2-4568-a1ab-00cd49301806" providerId="ADAL" clId="{DA8FEA81-1A63-884F-A1C6-520C766F400F}" dt="2022-11-10T10:58:20.549" v="7249" actId="465"/>
          <ac:grpSpMkLst>
            <pc:docMk/>
            <pc:sldMk cId="2229082649" sldId="258"/>
            <ac:grpSpMk id="74" creationId="{960F5CEB-FBBF-6923-4F1E-7478CC92C9C7}"/>
          </ac:grpSpMkLst>
        </pc:grpChg>
        <pc:grpChg chg="add mod">
          <ac:chgData name="Reza Amini Hounejani" userId="36cb0b73-58b2-4568-a1ab-00cd49301806" providerId="ADAL" clId="{DA8FEA81-1A63-884F-A1C6-520C766F400F}" dt="2022-11-04T16:57:00.580" v="4653" actId="164"/>
          <ac:grpSpMkLst>
            <pc:docMk/>
            <pc:sldMk cId="2229082649" sldId="258"/>
            <ac:grpSpMk id="75" creationId="{614A958B-5100-BCF9-B2B5-20998DE375FA}"/>
          </ac:grpSpMkLst>
        </pc:grpChg>
        <pc:grpChg chg="add mod">
          <ac:chgData name="Reza Amini Hounejani" userId="36cb0b73-58b2-4568-a1ab-00cd49301806" providerId="ADAL" clId="{DA8FEA81-1A63-884F-A1C6-520C766F400F}" dt="2022-11-11T15:25:01.964" v="7493" actId="164"/>
          <ac:grpSpMkLst>
            <pc:docMk/>
            <pc:sldMk cId="2229082649" sldId="258"/>
            <ac:grpSpMk id="79" creationId="{EB2E2D83-AB5B-5AF0-6FB8-445141F8D0E8}"/>
          </ac:grpSpMkLst>
        </pc:grpChg>
        <pc:grpChg chg="mod">
          <ac:chgData name="Reza Amini Hounejani" userId="36cb0b73-58b2-4568-a1ab-00cd49301806" providerId="ADAL" clId="{DA8FEA81-1A63-884F-A1C6-520C766F400F}" dt="2022-07-27T09:43:39.687" v="1173" actId="164"/>
          <ac:grpSpMkLst>
            <pc:docMk/>
            <pc:sldMk cId="2229082649" sldId="258"/>
            <ac:grpSpMk id="89" creationId="{7E14266A-CA80-05F8-209F-743FE9F63F04}"/>
          </ac:grpSpMkLst>
        </pc:grpChg>
        <pc:grpChg chg="mod">
          <ac:chgData name="Reza Amini Hounejani" userId="36cb0b73-58b2-4568-a1ab-00cd49301806" providerId="ADAL" clId="{DA8FEA81-1A63-884F-A1C6-520C766F400F}" dt="2022-11-10T10:58:20.549" v="7249" actId="465"/>
          <ac:grpSpMkLst>
            <pc:docMk/>
            <pc:sldMk cId="2229082649" sldId="258"/>
            <ac:grpSpMk id="90" creationId="{BFA41BAB-209E-BD49-74FE-4B473856FFC0}"/>
          </ac:grpSpMkLst>
        </pc:grpChg>
        <pc:grpChg chg="mod">
          <ac:chgData name="Reza Amini Hounejani" userId="36cb0b73-58b2-4568-a1ab-00cd49301806" providerId="ADAL" clId="{DA8FEA81-1A63-884F-A1C6-520C766F400F}" dt="2022-11-10T10:58:20.549" v="7249" actId="465"/>
          <ac:grpSpMkLst>
            <pc:docMk/>
            <pc:sldMk cId="2229082649" sldId="258"/>
            <ac:grpSpMk id="91" creationId="{37B77F7C-96E6-2EEF-4364-C907BC6072D3}"/>
          </ac:grpSpMkLst>
        </pc:grpChg>
        <pc:grpChg chg="add mod">
          <ac:chgData name="Reza Amini Hounejani" userId="36cb0b73-58b2-4568-a1ab-00cd49301806" providerId="ADAL" clId="{DA8FEA81-1A63-884F-A1C6-520C766F400F}" dt="2022-11-24T10:24:44.469" v="11671" actId="164"/>
          <ac:grpSpMkLst>
            <pc:docMk/>
            <pc:sldMk cId="2229082649" sldId="258"/>
            <ac:grpSpMk id="114" creationId="{A7070165-87F2-72B8-BE5D-2D4A6C67D087}"/>
          </ac:grpSpMkLst>
        </pc:grpChg>
        <pc:grpChg chg="add mod">
          <ac:chgData name="Reza Amini Hounejani" userId="36cb0b73-58b2-4568-a1ab-00cd49301806" providerId="ADAL" clId="{DA8FEA81-1A63-884F-A1C6-520C766F400F}" dt="2022-11-24T10:24:51.661" v="11672" actId="164"/>
          <ac:grpSpMkLst>
            <pc:docMk/>
            <pc:sldMk cId="2229082649" sldId="258"/>
            <ac:grpSpMk id="115" creationId="{2744C18A-324A-637D-9023-62193871F124}"/>
          </ac:grpSpMkLst>
        </pc:grpChg>
        <pc:grpChg chg="mod">
          <ac:chgData name="Reza Amini Hounejani" userId="36cb0b73-58b2-4568-a1ab-00cd49301806" providerId="ADAL" clId="{DA8FEA81-1A63-884F-A1C6-520C766F400F}" dt="2022-11-16T12:51:11.436" v="9224" actId="571"/>
          <ac:grpSpMkLst>
            <pc:docMk/>
            <pc:sldMk cId="2229082649" sldId="258"/>
            <ac:grpSpMk id="126" creationId="{1CD12DAC-696F-E995-8292-4CAF6DA5596C}"/>
          </ac:grpSpMkLst>
        </pc:grpChg>
        <pc:grpChg chg="mod">
          <ac:chgData name="Reza Amini Hounejani" userId="36cb0b73-58b2-4568-a1ab-00cd49301806" providerId="ADAL" clId="{DA8FEA81-1A63-884F-A1C6-520C766F400F}" dt="2022-11-16T12:51:52.434" v="9248" actId="571"/>
          <ac:grpSpMkLst>
            <pc:docMk/>
            <pc:sldMk cId="2229082649" sldId="258"/>
            <ac:grpSpMk id="129" creationId="{1D115048-BD5D-84C7-63F2-D305BE9786EC}"/>
          </ac:grpSpMkLst>
        </pc:grpChg>
        <pc:grpChg chg="add mod">
          <ac:chgData name="Reza Amini Hounejani" userId="36cb0b73-58b2-4568-a1ab-00cd49301806" providerId="ADAL" clId="{DA8FEA81-1A63-884F-A1C6-520C766F400F}" dt="2022-09-19T09:02:33.961" v="2540" actId="465"/>
          <ac:grpSpMkLst>
            <pc:docMk/>
            <pc:sldMk cId="2229082649" sldId="258"/>
            <ac:grpSpMk id="152" creationId="{8C9FB91D-D091-AA32-CDCE-1CE359AAAC95}"/>
          </ac:grpSpMkLst>
        </pc:grpChg>
        <pc:grpChg chg="add del mod">
          <ac:chgData name="Reza Amini Hounejani" userId="36cb0b73-58b2-4568-a1ab-00cd49301806" providerId="ADAL" clId="{DA8FEA81-1A63-884F-A1C6-520C766F400F}" dt="2022-07-27T13:02:23.664" v="2064" actId="478"/>
          <ac:grpSpMkLst>
            <pc:docMk/>
            <pc:sldMk cId="2229082649" sldId="258"/>
            <ac:grpSpMk id="153" creationId="{00556308-E8A7-E79B-770E-9476D007AA2E}"/>
          </ac:grpSpMkLst>
        </pc:grpChg>
        <pc:grpChg chg="add mod">
          <ac:chgData name="Reza Amini Hounejani" userId="36cb0b73-58b2-4568-a1ab-00cd49301806" providerId="ADAL" clId="{DA8FEA81-1A63-884F-A1C6-520C766F400F}" dt="2022-11-14T16:25:29.275" v="8658" actId="1076"/>
          <ac:grpSpMkLst>
            <pc:docMk/>
            <pc:sldMk cId="2229082649" sldId="258"/>
            <ac:grpSpMk id="157" creationId="{6B267AA3-410C-C08A-A4EC-478C88398CB0}"/>
          </ac:grpSpMkLst>
        </pc:grpChg>
        <pc:grpChg chg="add mod">
          <ac:chgData name="Reza Amini Hounejani" userId="36cb0b73-58b2-4568-a1ab-00cd49301806" providerId="ADAL" clId="{DA8FEA81-1A63-884F-A1C6-520C766F400F}" dt="2022-11-14T16:25:29.275" v="8658" actId="1076"/>
          <ac:grpSpMkLst>
            <pc:docMk/>
            <pc:sldMk cId="2229082649" sldId="258"/>
            <ac:grpSpMk id="158" creationId="{9EC5AF0D-A162-B762-56C3-826CDA114AD6}"/>
          </ac:grpSpMkLst>
        </pc:grpChg>
        <pc:grpChg chg="add mod">
          <ac:chgData name="Reza Amini Hounejani" userId="36cb0b73-58b2-4568-a1ab-00cd49301806" providerId="ADAL" clId="{DA8FEA81-1A63-884F-A1C6-520C766F400F}" dt="2022-11-15T12:47:40.112" v="8753" actId="1076"/>
          <ac:grpSpMkLst>
            <pc:docMk/>
            <pc:sldMk cId="2229082649" sldId="258"/>
            <ac:grpSpMk id="159" creationId="{45FBD98D-3692-E2E3-821A-4089F87602B3}"/>
          </ac:grpSpMkLst>
        </pc:grpChg>
        <pc:grpChg chg="add mod">
          <ac:chgData name="Reza Amini Hounejani" userId="36cb0b73-58b2-4568-a1ab-00cd49301806" providerId="ADAL" clId="{DA8FEA81-1A63-884F-A1C6-520C766F400F}" dt="2022-11-11T15:22:41.648" v="7462" actId="571"/>
          <ac:grpSpMkLst>
            <pc:docMk/>
            <pc:sldMk cId="2229082649" sldId="258"/>
            <ac:grpSpMk id="160" creationId="{AEA5CBC1-6F0C-4DA7-E146-EBA79ADC3A95}"/>
          </ac:grpSpMkLst>
        </pc:grpChg>
        <pc:grpChg chg="add del mod">
          <ac:chgData name="Reza Amini Hounejani" userId="36cb0b73-58b2-4568-a1ab-00cd49301806" providerId="ADAL" clId="{DA8FEA81-1A63-884F-A1C6-520C766F400F}" dt="2022-07-27T13:02:24.610" v="2065" actId="478"/>
          <ac:grpSpMkLst>
            <pc:docMk/>
            <pc:sldMk cId="2229082649" sldId="258"/>
            <ac:grpSpMk id="173" creationId="{444E73F3-D4E4-1C6E-3A56-62B430CC7A92}"/>
          </ac:grpSpMkLst>
        </pc:grpChg>
        <pc:grpChg chg="add mod">
          <ac:chgData name="Reza Amini Hounejani" userId="36cb0b73-58b2-4568-a1ab-00cd49301806" providerId="ADAL" clId="{DA8FEA81-1A63-884F-A1C6-520C766F400F}" dt="2022-11-24T10:21:21.848" v="11626" actId="1037"/>
          <ac:grpSpMkLst>
            <pc:docMk/>
            <pc:sldMk cId="2229082649" sldId="258"/>
            <ac:grpSpMk id="180" creationId="{038E9F00-F26E-3BEC-96BF-22BEC3C8AFDC}"/>
          </ac:grpSpMkLst>
        </pc:grpChg>
        <pc:grpChg chg="add del mod">
          <ac:chgData name="Reza Amini Hounejani" userId="36cb0b73-58b2-4568-a1ab-00cd49301806" providerId="ADAL" clId="{DA8FEA81-1A63-884F-A1C6-520C766F400F}" dt="2022-11-24T10:24:24.227" v="11655" actId="478"/>
          <ac:grpSpMkLst>
            <pc:docMk/>
            <pc:sldMk cId="2229082649" sldId="258"/>
            <ac:grpSpMk id="199" creationId="{0DC26656-3D00-2AA9-75DD-217FA56D68E0}"/>
          </ac:grpSpMkLst>
        </pc:grpChg>
        <pc:grpChg chg="add del mod">
          <ac:chgData name="Reza Amini Hounejani" userId="36cb0b73-58b2-4568-a1ab-00cd49301806" providerId="ADAL" clId="{DA8FEA81-1A63-884F-A1C6-520C766F400F}" dt="2022-11-04T16:58:38.101" v="4669" actId="165"/>
          <ac:grpSpMkLst>
            <pc:docMk/>
            <pc:sldMk cId="2229082649" sldId="258"/>
            <ac:grpSpMk id="200" creationId="{2E0B332B-D097-ED70-4E6D-AB68E77FA8E7}"/>
          </ac:grpSpMkLst>
        </pc:grpChg>
        <pc:grpChg chg="del mod topLvl">
          <ac:chgData name="Reza Amini Hounejani" userId="36cb0b73-58b2-4568-a1ab-00cd49301806" providerId="ADAL" clId="{DA8FEA81-1A63-884F-A1C6-520C766F400F}" dt="2022-11-04T16:58:43.074" v="4670" actId="165"/>
          <ac:grpSpMkLst>
            <pc:docMk/>
            <pc:sldMk cId="2229082649" sldId="258"/>
            <ac:grpSpMk id="201" creationId="{4A623BB4-3069-14BB-75A6-9D4F0BDF239F}"/>
          </ac:grpSpMkLst>
        </pc:grpChg>
        <pc:grpChg chg="add mod">
          <ac:chgData name="Reza Amini Hounejani" userId="36cb0b73-58b2-4568-a1ab-00cd49301806" providerId="ADAL" clId="{DA8FEA81-1A63-884F-A1C6-520C766F400F}" dt="2022-11-24T10:21:26.548" v="11633" actId="1037"/>
          <ac:grpSpMkLst>
            <pc:docMk/>
            <pc:sldMk cId="2229082649" sldId="258"/>
            <ac:grpSpMk id="203" creationId="{D6FE0F62-CA46-1256-B9C2-FFCAAEABC973}"/>
          </ac:grpSpMkLst>
        </pc:grpChg>
        <pc:grpChg chg="mod">
          <ac:chgData name="Reza Amini Hounejani" userId="36cb0b73-58b2-4568-a1ab-00cd49301806" providerId="ADAL" clId="{DA8FEA81-1A63-884F-A1C6-520C766F400F}" dt="2022-11-14T16:03:46.644" v="8500" actId="571"/>
          <ac:grpSpMkLst>
            <pc:docMk/>
            <pc:sldMk cId="2229082649" sldId="258"/>
            <ac:grpSpMk id="204" creationId="{841E62A1-CD3A-BC0E-1F81-24EDEB16EE16}"/>
          </ac:grpSpMkLst>
        </pc:grpChg>
        <pc:grpChg chg="add mod">
          <ac:chgData name="Reza Amini Hounejani" userId="36cb0b73-58b2-4568-a1ab-00cd49301806" providerId="ADAL" clId="{DA8FEA81-1A63-884F-A1C6-520C766F400F}" dt="2022-11-11T15:28:28.822" v="7514" actId="164"/>
          <ac:grpSpMkLst>
            <pc:docMk/>
            <pc:sldMk cId="2229082649" sldId="258"/>
            <ac:grpSpMk id="227" creationId="{DAAA6564-1F1D-5DAA-C13B-D62F5EBD1166}"/>
          </ac:grpSpMkLst>
        </pc:grpChg>
        <pc:grpChg chg="mod">
          <ac:chgData name="Reza Amini Hounejani" userId="36cb0b73-58b2-4568-a1ab-00cd49301806" providerId="ADAL" clId="{DA8FEA81-1A63-884F-A1C6-520C766F400F}" dt="2022-09-19T09:02:33.961" v="2540" actId="465"/>
          <ac:grpSpMkLst>
            <pc:docMk/>
            <pc:sldMk cId="2229082649" sldId="258"/>
            <ac:grpSpMk id="228" creationId="{9BA4EBFC-0849-7CB9-AB59-A366224FA8DB}"/>
          </ac:grpSpMkLst>
        </pc:grpChg>
        <pc:grpChg chg="mod">
          <ac:chgData name="Reza Amini Hounejani" userId="36cb0b73-58b2-4568-a1ab-00cd49301806" providerId="ADAL" clId="{DA8FEA81-1A63-884F-A1C6-520C766F400F}" dt="2022-11-14T16:03:46.644" v="8500" actId="571"/>
          <ac:grpSpMkLst>
            <pc:docMk/>
            <pc:sldMk cId="2229082649" sldId="258"/>
            <ac:grpSpMk id="241" creationId="{D45DF182-4F3E-79F5-EF04-3EE7542E161F}"/>
          </ac:grpSpMkLst>
        </pc:grpChg>
        <pc:grpChg chg="add del mod">
          <ac:chgData name="Reza Amini Hounejani" userId="36cb0b73-58b2-4568-a1ab-00cd49301806" providerId="ADAL" clId="{DA8FEA81-1A63-884F-A1C6-520C766F400F}" dt="2022-11-08T09:35:37.557" v="6643" actId="165"/>
          <ac:grpSpMkLst>
            <pc:docMk/>
            <pc:sldMk cId="2229082649" sldId="258"/>
            <ac:grpSpMk id="255" creationId="{8EBEA5CF-7279-3906-E9EF-67F7731B645E}"/>
          </ac:grpSpMkLst>
        </pc:grpChg>
        <pc:grpChg chg="add del mod">
          <ac:chgData name="Reza Amini Hounejani" userId="36cb0b73-58b2-4568-a1ab-00cd49301806" providerId="ADAL" clId="{DA8FEA81-1A63-884F-A1C6-520C766F400F}" dt="2022-11-04T17:29:18.842" v="6105" actId="165"/>
          <ac:grpSpMkLst>
            <pc:docMk/>
            <pc:sldMk cId="2229082649" sldId="258"/>
            <ac:grpSpMk id="259" creationId="{54F1ECE8-FBDC-7CA8-BCCE-A0588A016861}"/>
          </ac:grpSpMkLst>
        </pc:grpChg>
        <pc:grpChg chg="add del mod">
          <ac:chgData name="Reza Amini Hounejani" userId="36cb0b73-58b2-4568-a1ab-00cd49301806" providerId="ADAL" clId="{DA8FEA81-1A63-884F-A1C6-520C766F400F}" dt="2022-11-08T09:28:39.355" v="6557" actId="478"/>
          <ac:grpSpMkLst>
            <pc:docMk/>
            <pc:sldMk cId="2229082649" sldId="258"/>
            <ac:grpSpMk id="262" creationId="{E013E5E2-5747-7AE1-6C80-8439F2F517AD}"/>
          </ac:grpSpMkLst>
        </pc:grpChg>
        <pc:grpChg chg="add mod">
          <ac:chgData name="Reza Amini Hounejani" userId="36cb0b73-58b2-4568-a1ab-00cd49301806" providerId="ADAL" clId="{DA8FEA81-1A63-884F-A1C6-520C766F400F}" dt="2022-11-11T16:40:50.755" v="8265" actId="164"/>
          <ac:grpSpMkLst>
            <pc:docMk/>
            <pc:sldMk cId="2229082649" sldId="258"/>
            <ac:grpSpMk id="263" creationId="{6971CDDC-EC6D-4203-1BAC-9274E4CD3312}"/>
          </ac:grpSpMkLst>
        </pc:grpChg>
        <pc:grpChg chg="add del mod">
          <ac:chgData name="Reza Amini Hounejani" userId="36cb0b73-58b2-4568-a1ab-00cd49301806" providerId="ADAL" clId="{DA8FEA81-1A63-884F-A1C6-520C766F400F}" dt="2022-11-04T17:31:01.622" v="6331" actId="165"/>
          <ac:grpSpMkLst>
            <pc:docMk/>
            <pc:sldMk cId="2229082649" sldId="258"/>
            <ac:grpSpMk id="265" creationId="{FC943523-8F02-04A3-5BE3-233187EC0F19}"/>
          </ac:grpSpMkLst>
        </pc:grpChg>
        <pc:grpChg chg="add mod">
          <ac:chgData name="Reza Amini Hounejani" userId="36cb0b73-58b2-4568-a1ab-00cd49301806" providerId="ADAL" clId="{DA8FEA81-1A63-884F-A1C6-520C766F400F}" dt="2022-11-24T10:21:21.848" v="11626" actId="1037"/>
          <ac:grpSpMkLst>
            <pc:docMk/>
            <pc:sldMk cId="2229082649" sldId="258"/>
            <ac:grpSpMk id="269" creationId="{535E0A49-A7E8-967A-1C73-3A26502AA946}"/>
          </ac:grpSpMkLst>
        </pc:grpChg>
        <pc:grpChg chg="add mod">
          <ac:chgData name="Reza Amini Hounejani" userId="36cb0b73-58b2-4568-a1ab-00cd49301806" providerId="ADAL" clId="{DA8FEA81-1A63-884F-A1C6-520C766F400F}" dt="2022-11-24T10:21:26.548" v="11633" actId="1037"/>
          <ac:grpSpMkLst>
            <pc:docMk/>
            <pc:sldMk cId="2229082649" sldId="258"/>
            <ac:grpSpMk id="274" creationId="{C86B7724-ADC1-4A77-F7F1-27316F5C6295}"/>
          </ac:grpSpMkLst>
        </pc:grpChg>
        <pc:grpChg chg="add mod">
          <ac:chgData name="Reza Amini Hounejani" userId="36cb0b73-58b2-4568-a1ab-00cd49301806" providerId="ADAL" clId="{DA8FEA81-1A63-884F-A1C6-520C766F400F}" dt="2022-11-24T10:21:26.548" v="11633" actId="1037"/>
          <ac:grpSpMkLst>
            <pc:docMk/>
            <pc:sldMk cId="2229082649" sldId="258"/>
            <ac:grpSpMk id="279" creationId="{8E6ACFC9-5DFE-343C-5F2D-7F66672CA0AA}"/>
          </ac:grpSpMkLst>
        </pc:grpChg>
        <pc:grpChg chg="mod">
          <ac:chgData name="Reza Amini Hounejani" userId="36cb0b73-58b2-4568-a1ab-00cd49301806" providerId="ADAL" clId="{DA8FEA81-1A63-884F-A1C6-520C766F400F}" dt="2022-11-14T16:03:51.107" v="8501" actId="571"/>
          <ac:grpSpMkLst>
            <pc:docMk/>
            <pc:sldMk cId="2229082649" sldId="258"/>
            <ac:grpSpMk id="280" creationId="{8DBD6B8B-93F6-B70D-2CAD-CA7D87386EBD}"/>
          </ac:grpSpMkLst>
        </pc:grpChg>
        <pc:grpChg chg="add mod">
          <ac:chgData name="Reza Amini Hounejani" userId="36cb0b73-58b2-4568-a1ab-00cd49301806" providerId="ADAL" clId="{DA8FEA81-1A63-884F-A1C6-520C766F400F}" dt="2022-11-24T10:21:21.848" v="11626" actId="1037"/>
          <ac:grpSpMkLst>
            <pc:docMk/>
            <pc:sldMk cId="2229082649" sldId="258"/>
            <ac:grpSpMk id="287" creationId="{28DEE83F-C879-1C75-13DE-45512669A3CC}"/>
          </ac:grpSpMkLst>
        </pc:grpChg>
        <pc:grpChg chg="mod">
          <ac:chgData name="Reza Amini Hounejani" userId="36cb0b73-58b2-4568-a1ab-00cd49301806" providerId="ADAL" clId="{DA8FEA81-1A63-884F-A1C6-520C766F400F}" dt="2022-11-14T16:03:51.107" v="8501" actId="571"/>
          <ac:grpSpMkLst>
            <pc:docMk/>
            <pc:sldMk cId="2229082649" sldId="258"/>
            <ac:grpSpMk id="303" creationId="{B0313067-4C5A-2FC0-4945-DACAAD9E130F}"/>
          </ac:grpSpMkLst>
        </pc:grpChg>
        <pc:grpChg chg="add mod">
          <ac:chgData name="Reza Amini Hounejani" userId="36cb0b73-58b2-4568-a1ab-00cd49301806" providerId="ADAL" clId="{DA8FEA81-1A63-884F-A1C6-520C766F400F}" dt="2022-11-16T12:51:06.167" v="9223" actId="571"/>
          <ac:grpSpMkLst>
            <pc:docMk/>
            <pc:sldMk cId="2229082649" sldId="258"/>
            <ac:grpSpMk id="318" creationId="{12586FC7-2C1C-496A-1025-D79BAE0363B8}"/>
          </ac:grpSpMkLst>
        </pc:grpChg>
        <pc:grpChg chg="add mod">
          <ac:chgData name="Reza Amini Hounejani" userId="36cb0b73-58b2-4568-a1ab-00cd49301806" providerId="ADAL" clId="{DA8FEA81-1A63-884F-A1C6-520C766F400F}" dt="2022-11-24T10:24:44.469" v="11671" actId="164"/>
          <ac:grpSpMkLst>
            <pc:docMk/>
            <pc:sldMk cId="2229082649" sldId="258"/>
            <ac:grpSpMk id="321" creationId="{A0EB5EA8-D87E-C2A6-815D-B12AB2A531C9}"/>
          </ac:grpSpMkLst>
        </pc:grpChg>
        <pc:grpChg chg="mod">
          <ac:chgData name="Reza Amini Hounejani" userId="36cb0b73-58b2-4568-a1ab-00cd49301806" providerId="ADAL" clId="{DA8FEA81-1A63-884F-A1C6-520C766F400F}" dt="2022-11-16T12:51:06.167" v="9223" actId="571"/>
          <ac:grpSpMkLst>
            <pc:docMk/>
            <pc:sldMk cId="2229082649" sldId="258"/>
            <ac:grpSpMk id="321" creationId="{DEABEB59-CBD9-B653-662B-E745783EC386}"/>
          </ac:grpSpMkLst>
        </pc:grpChg>
        <pc:grpChg chg="mod">
          <ac:chgData name="Reza Amini Hounejani" userId="36cb0b73-58b2-4568-a1ab-00cd49301806" providerId="ADAL" clId="{DA8FEA81-1A63-884F-A1C6-520C766F400F}" dt="2022-11-16T12:51:06.167" v="9223" actId="571"/>
          <ac:grpSpMkLst>
            <pc:docMk/>
            <pc:sldMk cId="2229082649" sldId="258"/>
            <ac:grpSpMk id="322" creationId="{469AA5D2-80C6-73F9-5F0F-15366AB17724}"/>
          </ac:grpSpMkLst>
        </pc:grpChg>
        <pc:grpChg chg="add mod">
          <ac:chgData name="Reza Amini Hounejani" userId="36cb0b73-58b2-4568-a1ab-00cd49301806" providerId="ADAL" clId="{DA8FEA81-1A63-884F-A1C6-520C766F400F}" dt="2022-11-24T10:24:51.661" v="11672" actId="164"/>
          <ac:grpSpMkLst>
            <pc:docMk/>
            <pc:sldMk cId="2229082649" sldId="258"/>
            <ac:grpSpMk id="322" creationId="{60368697-6E00-27AB-BD96-66CBC3EA8D94}"/>
          </ac:grpSpMkLst>
        </pc:grpChg>
        <pc:picChg chg="del">
          <ac:chgData name="Reza Amini Hounejani" userId="36cb0b73-58b2-4568-a1ab-00cd49301806" providerId="ADAL" clId="{DA8FEA81-1A63-884F-A1C6-520C766F400F}" dt="2022-07-27T09:37:58.040" v="1053" actId="478"/>
          <ac:picMkLst>
            <pc:docMk/>
            <pc:sldMk cId="2229082649" sldId="258"/>
            <ac:picMk id="2" creationId="{4F478D0B-C8D4-CE0B-18F4-E32B217C9B06}"/>
          </ac:picMkLst>
        </pc:picChg>
        <pc:picChg chg="del">
          <ac:chgData name="Reza Amini Hounejani" userId="36cb0b73-58b2-4568-a1ab-00cd49301806" providerId="ADAL" clId="{DA8FEA81-1A63-884F-A1C6-520C766F400F}" dt="2022-07-27T10:08:15.903" v="1413" actId="478"/>
          <ac:picMkLst>
            <pc:docMk/>
            <pc:sldMk cId="2229082649" sldId="258"/>
            <ac:picMk id="6" creationId="{330DED52-DE49-7487-C47F-0EF4AC128F31}"/>
          </ac:picMkLst>
        </pc:picChg>
        <pc:picChg chg="del">
          <ac:chgData name="Reza Amini Hounejani" userId="36cb0b73-58b2-4568-a1ab-00cd49301806" providerId="ADAL" clId="{DA8FEA81-1A63-884F-A1C6-520C766F400F}" dt="2022-07-27T10:08:14.469" v="1412" actId="478"/>
          <ac:picMkLst>
            <pc:docMk/>
            <pc:sldMk cId="2229082649" sldId="258"/>
            <ac:picMk id="10" creationId="{80DA87BE-EAE2-5E9C-3E94-519E671112E7}"/>
          </ac:picMkLst>
        </pc:picChg>
        <pc:picChg chg="del">
          <ac:chgData name="Reza Amini Hounejani" userId="36cb0b73-58b2-4568-a1ab-00cd49301806" providerId="ADAL" clId="{DA8FEA81-1A63-884F-A1C6-520C766F400F}" dt="2022-07-27T09:37:59.628" v="1054" actId="478"/>
          <ac:picMkLst>
            <pc:docMk/>
            <pc:sldMk cId="2229082649" sldId="258"/>
            <ac:picMk id="16" creationId="{3695A838-E720-1951-D238-DA6C8BA34816}"/>
          </ac:picMkLst>
        </pc:picChg>
        <pc:picChg chg="del">
          <ac:chgData name="Reza Amini Hounejani" userId="36cb0b73-58b2-4568-a1ab-00cd49301806" providerId="ADAL" clId="{DA8FEA81-1A63-884F-A1C6-520C766F400F}" dt="2022-07-27T09:37:55.023" v="1052" actId="478"/>
          <ac:picMkLst>
            <pc:docMk/>
            <pc:sldMk cId="2229082649" sldId="258"/>
            <ac:picMk id="17" creationId="{6DF05CBD-F6D8-7B51-D1DD-5544F8668811}"/>
          </ac:picMkLst>
        </pc:picChg>
        <pc:picChg chg="add del mod">
          <ac:chgData name="Reza Amini Hounejani" userId="36cb0b73-58b2-4568-a1ab-00cd49301806" providerId="ADAL" clId="{DA8FEA81-1A63-884F-A1C6-520C766F400F}" dt="2022-07-27T13:06:33.219" v="2104" actId="478"/>
          <ac:picMkLst>
            <pc:docMk/>
            <pc:sldMk cId="2229082649" sldId="258"/>
            <ac:picMk id="22" creationId="{02ADCB77-B707-4617-FE41-6F4DA37B2978}"/>
          </ac:picMkLst>
        </pc:picChg>
        <pc:picChg chg="add mod">
          <ac:chgData name="Reza Amini Hounejani" userId="36cb0b73-58b2-4568-a1ab-00cd49301806" providerId="ADAL" clId="{DA8FEA81-1A63-884F-A1C6-520C766F400F}" dt="2022-11-10T10:50:37.727" v="7114" actId="14100"/>
          <ac:picMkLst>
            <pc:docMk/>
            <pc:sldMk cId="2229082649" sldId="258"/>
            <ac:picMk id="49" creationId="{2D7F75FB-0F62-9BE8-2975-3E47D9DD72BC}"/>
          </ac:picMkLst>
        </pc:picChg>
        <pc:picChg chg="add mod">
          <ac:chgData name="Reza Amini Hounejani" userId="36cb0b73-58b2-4568-a1ab-00cd49301806" providerId="ADAL" clId="{DA8FEA81-1A63-884F-A1C6-520C766F400F}" dt="2022-11-10T10:58:20.549" v="7249" actId="465"/>
          <ac:picMkLst>
            <pc:docMk/>
            <pc:sldMk cId="2229082649" sldId="258"/>
            <ac:picMk id="71" creationId="{DC44CD90-6AF2-8C43-0FE1-70A423238874}"/>
          </ac:picMkLst>
        </pc:picChg>
        <pc:picChg chg="add mod">
          <ac:chgData name="Reza Amini Hounejani" userId="36cb0b73-58b2-4568-a1ab-00cd49301806" providerId="ADAL" clId="{DA8FEA81-1A63-884F-A1C6-520C766F400F}" dt="2022-11-10T10:50:49.548" v="7116" actId="14100"/>
          <ac:picMkLst>
            <pc:docMk/>
            <pc:sldMk cId="2229082649" sldId="258"/>
            <ac:picMk id="73" creationId="{78D55AEA-3908-7A79-83DF-C8801F893D95}"/>
          </ac:picMkLst>
        </pc:picChg>
        <pc:picChg chg="add mod">
          <ac:chgData name="Reza Amini Hounejani" userId="36cb0b73-58b2-4568-a1ab-00cd49301806" providerId="ADAL" clId="{DA8FEA81-1A63-884F-A1C6-520C766F400F}" dt="2022-11-16T12:51:11.436" v="9224" actId="571"/>
          <ac:picMkLst>
            <pc:docMk/>
            <pc:sldMk cId="2229082649" sldId="258"/>
            <ac:picMk id="80" creationId="{575F0B6B-BF6C-1C83-A55C-582FB3F52FA6}"/>
          </ac:picMkLst>
        </pc:picChg>
        <pc:picChg chg="add mod">
          <ac:chgData name="Reza Amini Hounejani" userId="36cb0b73-58b2-4568-a1ab-00cd49301806" providerId="ADAL" clId="{DA8FEA81-1A63-884F-A1C6-520C766F400F}" dt="2022-11-16T12:51:52.434" v="9248" actId="571"/>
          <ac:picMkLst>
            <pc:docMk/>
            <pc:sldMk cId="2229082649" sldId="258"/>
            <ac:picMk id="100" creationId="{1A10765D-5EE4-A7FD-87D4-27B1CCC7DF45}"/>
          </ac:picMkLst>
        </pc:picChg>
        <pc:picChg chg="mod">
          <ac:chgData name="Reza Amini Hounejani" userId="36cb0b73-58b2-4568-a1ab-00cd49301806" providerId="ADAL" clId="{DA8FEA81-1A63-884F-A1C6-520C766F400F}" dt="2022-11-16T12:51:06.167" v="9223" actId="571"/>
          <ac:picMkLst>
            <pc:docMk/>
            <pc:sldMk cId="2229082649" sldId="258"/>
            <ac:picMk id="320" creationId="{7E15568E-A0D4-EA97-9C31-073C0C745037}"/>
          </ac:picMkLst>
        </pc:picChg>
        <pc:cxnChg chg="add del mod">
          <ac:chgData name="Reza Amini Hounejani" userId="36cb0b73-58b2-4568-a1ab-00cd49301806" providerId="ADAL" clId="{DA8FEA81-1A63-884F-A1C6-520C766F400F}" dt="2022-11-04T17:17:34.809" v="6051" actId="478"/>
          <ac:cxnSpMkLst>
            <pc:docMk/>
            <pc:sldMk cId="2229082649" sldId="258"/>
            <ac:cxnSpMk id="6" creationId="{4EF71841-FC9D-D8E4-D200-980C97FFAC3D}"/>
          </ac:cxnSpMkLst>
        </pc:cxnChg>
        <pc:cxnChg chg="del mod">
          <ac:chgData name="Reza Amini Hounejani" userId="36cb0b73-58b2-4568-a1ab-00cd49301806" providerId="ADAL" clId="{DA8FEA81-1A63-884F-A1C6-520C766F400F}" dt="2022-11-11T15:20:53.506" v="7452" actId="478"/>
          <ac:cxnSpMkLst>
            <pc:docMk/>
            <pc:sldMk cId="2229082649" sldId="258"/>
            <ac:cxnSpMk id="24" creationId="{9AF383BB-7CCF-F5FD-74B0-376CFBB958E3}"/>
          </ac:cxnSpMkLst>
        </pc:cxnChg>
        <pc:cxnChg chg="add mod">
          <ac:chgData name="Reza Amini Hounejani" userId="36cb0b73-58b2-4568-a1ab-00cd49301806" providerId="ADAL" clId="{DA8FEA81-1A63-884F-A1C6-520C766F400F}" dt="2022-11-24T10:21:26.548" v="11633" actId="1037"/>
          <ac:cxnSpMkLst>
            <pc:docMk/>
            <pc:sldMk cId="2229082649" sldId="258"/>
            <ac:cxnSpMk id="24" creationId="{EEC1D3EA-BCB7-FB53-537B-16CE2ECAADE8}"/>
          </ac:cxnSpMkLst>
        </pc:cxnChg>
        <pc:cxnChg chg="del mod">
          <ac:chgData name="Reza Amini Hounejani" userId="36cb0b73-58b2-4568-a1ab-00cd49301806" providerId="ADAL" clId="{DA8FEA81-1A63-884F-A1C6-520C766F400F}" dt="2022-11-14T16:08:56.454" v="8504" actId="478"/>
          <ac:cxnSpMkLst>
            <pc:docMk/>
            <pc:sldMk cId="2229082649" sldId="258"/>
            <ac:cxnSpMk id="26" creationId="{BB201028-D781-DE47-8994-BC8BD4A45A77}"/>
          </ac:cxnSpMkLst>
        </pc:cxnChg>
        <pc:cxnChg chg="add mod">
          <ac:chgData name="Reza Amini Hounejani" userId="36cb0b73-58b2-4568-a1ab-00cd49301806" providerId="ADAL" clId="{DA8FEA81-1A63-884F-A1C6-520C766F400F}" dt="2022-11-24T10:21:26.548" v="11633" actId="1037"/>
          <ac:cxnSpMkLst>
            <pc:docMk/>
            <pc:sldMk cId="2229082649" sldId="258"/>
            <ac:cxnSpMk id="27" creationId="{3C2428D7-85D3-D5EF-12B3-1AA66E48E498}"/>
          </ac:cxnSpMkLst>
        </pc:cxnChg>
        <pc:cxnChg chg="add del mod">
          <ac:chgData name="Reza Amini Hounejani" userId="36cb0b73-58b2-4568-a1ab-00cd49301806" providerId="ADAL" clId="{DA8FEA81-1A63-884F-A1C6-520C766F400F}" dt="2022-11-04T17:17:36.031" v="6053" actId="478"/>
          <ac:cxnSpMkLst>
            <pc:docMk/>
            <pc:sldMk cId="2229082649" sldId="258"/>
            <ac:cxnSpMk id="35" creationId="{68E5BD9A-AB55-8D47-93EC-797C07E0370E}"/>
          </ac:cxnSpMkLst>
        </pc:cxnChg>
        <pc:cxnChg chg="add del mod">
          <ac:chgData name="Reza Amini Hounejani" userId="36cb0b73-58b2-4568-a1ab-00cd49301806" providerId="ADAL" clId="{DA8FEA81-1A63-884F-A1C6-520C766F400F}" dt="2022-11-24T10:22:49.197" v="11654" actId="478"/>
          <ac:cxnSpMkLst>
            <pc:docMk/>
            <pc:sldMk cId="2229082649" sldId="258"/>
            <ac:cxnSpMk id="70" creationId="{113767D1-9BBC-31A1-4E3C-BC7673027E48}"/>
          </ac:cxnSpMkLst>
        </pc:cxnChg>
        <pc:cxnChg chg="add mod">
          <ac:chgData name="Reza Amini Hounejani" userId="36cb0b73-58b2-4568-a1ab-00cd49301806" providerId="ADAL" clId="{DA8FEA81-1A63-884F-A1C6-520C766F400F}" dt="2022-11-24T08:39:39.653" v="11512" actId="13822"/>
          <ac:cxnSpMkLst>
            <pc:docMk/>
            <pc:sldMk cId="2229082649" sldId="258"/>
            <ac:cxnSpMk id="116" creationId="{93B6CE7C-D177-F4FF-015F-D008FE9FC124}"/>
          </ac:cxnSpMkLst>
        </pc:cxnChg>
        <pc:cxnChg chg="add mod">
          <ac:chgData name="Reza Amini Hounejani" userId="36cb0b73-58b2-4568-a1ab-00cd49301806" providerId="ADAL" clId="{DA8FEA81-1A63-884F-A1C6-520C766F400F}" dt="2022-11-24T08:39:39.653" v="11512" actId="13822"/>
          <ac:cxnSpMkLst>
            <pc:docMk/>
            <pc:sldMk cId="2229082649" sldId="258"/>
            <ac:cxnSpMk id="117" creationId="{1904BC5E-C611-F862-03EB-21DE52ADEE39}"/>
          </ac:cxnSpMkLst>
        </pc:cxnChg>
        <pc:cxnChg chg="add del mod">
          <ac:chgData name="Reza Amini Hounejani" userId="36cb0b73-58b2-4568-a1ab-00cd49301806" providerId="ADAL" clId="{DA8FEA81-1A63-884F-A1C6-520C766F400F}" dt="2022-11-14T15:57:54.198" v="8479" actId="478"/>
          <ac:cxnSpMkLst>
            <pc:docMk/>
            <pc:sldMk cId="2229082649" sldId="258"/>
            <ac:cxnSpMk id="132" creationId="{FC574389-FC67-64C6-DD9B-B8D92381DB8C}"/>
          </ac:cxnSpMkLst>
        </pc:cxnChg>
        <pc:cxnChg chg="add del mod">
          <ac:chgData name="Reza Amini Hounejani" userId="36cb0b73-58b2-4568-a1ab-00cd49301806" providerId="ADAL" clId="{DA8FEA81-1A63-884F-A1C6-520C766F400F}" dt="2022-11-14T15:57:52.677" v="8477" actId="478"/>
          <ac:cxnSpMkLst>
            <pc:docMk/>
            <pc:sldMk cId="2229082649" sldId="258"/>
            <ac:cxnSpMk id="140" creationId="{9A01DD9E-F109-2A85-0053-24DF345C84F0}"/>
          </ac:cxnSpMkLst>
        </pc:cxnChg>
        <pc:cxnChg chg="add mod topLvl">
          <ac:chgData name="Reza Amini Hounejani" userId="36cb0b73-58b2-4568-a1ab-00cd49301806" providerId="ADAL" clId="{DA8FEA81-1A63-884F-A1C6-520C766F400F}" dt="2022-11-24T10:21:21.848" v="11626" actId="1037"/>
          <ac:cxnSpMkLst>
            <pc:docMk/>
            <pc:sldMk cId="2229082649" sldId="258"/>
            <ac:cxnSpMk id="154" creationId="{B96CD1E6-A7C6-F43E-C0D9-1081BBDF9F1D}"/>
          </ac:cxnSpMkLst>
        </pc:cxnChg>
        <pc:cxnChg chg="add del mod">
          <ac:chgData name="Reza Amini Hounejani" userId="36cb0b73-58b2-4568-a1ab-00cd49301806" providerId="ADAL" clId="{DA8FEA81-1A63-884F-A1C6-520C766F400F}" dt="2022-11-08T09:33:08.031" v="6633" actId="478"/>
          <ac:cxnSpMkLst>
            <pc:docMk/>
            <pc:sldMk cId="2229082649" sldId="258"/>
            <ac:cxnSpMk id="155" creationId="{510E049D-A566-D489-460C-18B80CD5233B}"/>
          </ac:cxnSpMkLst>
        </pc:cxnChg>
        <pc:cxnChg chg="add del mod topLvl">
          <ac:chgData name="Reza Amini Hounejani" userId="36cb0b73-58b2-4568-a1ab-00cd49301806" providerId="ADAL" clId="{DA8FEA81-1A63-884F-A1C6-520C766F400F}" dt="2022-11-08T09:28:39.355" v="6557" actId="478"/>
          <ac:cxnSpMkLst>
            <pc:docMk/>
            <pc:sldMk cId="2229082649" sldId="258"/>
            <ac:cxnSpMk id="189" creationId="{0441C24A-FB79-4A12-8147-F5FC82E2C46C}"/>
          </ac:cxnSpMkLst>
        </pc:cxnChg>
        <pc:cxnChg chg="add del mod">
          <ac:chgData name="Reza Amini Hounejani" userId="36cb0b73-58b2-4568-a1ab-00cd49301806" providerId="ADAL" clId="{DA8FEA81-1A63-884F-A1C6-520C766F400F}" dt="2022-11-08T09:28:02.297" v="6547" actId="478"/>
          <ac:cxnSpMkLst>
            <pc:docMk/>
            <pc:sldMk cId="2229082649" sldId="258"/>
            <ac:cxnSpMk id="190" creationId="{BC0122CD-F153-2D9F-D8C8-E87DF4929176}"/>
          </ac:cxnSpMkLst>
        </pc:cxnChg>
        <pc:cxnChg chg="add del mod">
          <ac:chgData name="Reza Amini Hounejani" userId="36cb0b73-58b2-4568-a1ab-00cd49301806" providerId="ADAL" clId="{DA8FEA81-1A63-884F-A1C6-520C766F400F}" dt="2022-11-14T16:24:21.875" v="8656" actId="478"/>
          <ac:cxnSpMkLst>
            <pc:docMk/>
            <pc:sldMk cId="2229082649" sldId="258"/>
            <ac:cxnSpMk id="201" creationId="{7AB2D660-BF1F-948C-037D-078FDD95EC36}"/>
          </ac:cxnSpMkLst>
        </pc:cxnChg>
        <pc:cxnChg chg="add mod">
          <ac:chgData name="Reza Amini Hounejani" userId="36cb0b73-58b2-4568-a1ab-00cd49301806" providerId="ADAL" clId="{DA8FEA81-1A63-884F-A1C6-520C766F400F}" dt="2022-11-24T10:24:51.661" v="11672" actId="164"/>
          <ac:cxnSpMkLst>
            <pc:docMk/>
            <pc:sldMk cId="2229082649" sldId="258"/>
            <ac:cxnSpMk id="201" creationId="{9F7C67EA-4129-568B-9428-261F04B767FF}"/>
          </ac:cxnSpMkLst>
        </pc:cxnChg>
        <pc:cxnChg chg="add mod">
          <ac:chgData name="Reza Amini Hounejani" userId="36cb0b73-58b2-4568-a1ab-00cd49301806" providerId="ADAL" clId="{DA8FEA81-1A63-884F-A1C6-520C766F400F}" dt="2022-11-24T10:24:51.661" v="11672" actId="164"/>
          <ac:cxnSpMkLst>
            <pc:docMk/>
            <pc:sldMk cId="2229082649" sldId="258"/>
            <ac:cxnSpMk id="202" creationId="{442BBABB-0D8D-2C9F-7EE9-D00AD678A3DE}"/>
          </ac:cxnSpMkLst>
        </pc:cxnChg>
        <pc:cxnChg chg="add del mod">
          <ac:chgData name="Reza Amini Hounejani" userId="36cb0b73-58b2-4568-a1ab-00cd49301806" providerId="ADAL" clId="{DA8FEA81-1A63-884F-A1C6-520C766F400F}" dt="2022-11-24T10:24:24.227" v="11655" actId="478"/>
          <ac:cxnSpMkLst>
            <pc:docMk/>
            <pc:sldMk cId="2229082649" sldId="258"/>
            <ac:cxnSpMk id="264" creationId="{A537E2B2-CD8E-57B3-F2C1-7863216CB610}"/>
          </ac:cxnSpMkLst>
        </pc:cxnChg>
        <pc:cxnChg chg="del mod topLvl">
          <ac:chgData name="Reza Amini Hounejani" userId="36cb0b73-58b2-4568-a1ab-00cd49301806" providerId="ADAL" clId="{DA8FEA81-1A63-884F-A1C6-520C766F400F}" dt="2022-11-11T15:20:41.153" v="7450" actId="478"/>
          <ac:cxnSpMkLst>
            <pc:docMk/>
            <pc:sldMk cId="2229082649" sldId="258"/>
            <ac:cxnSpMk id="266" creationId="{8A59DE41-EC7D-658E-4A5C-41C806956302}"/>
          </ac:cxnSpMkLst>
        </pc:cxnChg>
        <pc:cxnChg chg="del mod topLvl">
          <ac:chgData name="Reza Amini Hounejani" userId="36cb0b73-58b2-4568-a1ab-00cd49301806" providerId="ADAL" clId="{DA8FEA81-1A63-884F-A1C6-520C766F400F}" dt="2022-11-11T15:20:40.317" v="7449" actId="478"/>
          <ac:cxnSpMkLst>
            <pc:docMk/>
            <pc:sldMk cId="2229082649" sldId="258"/>
            <ac:cxnSpMk id="267" creationId="{757CD23B-EA5B-17DD-DB00-8FFCDB25E6F5}"/>
          </ac:cxnSpMkLst>
        </pc:cxnChg>
        <pc:cxnChg chg="add del mod">
          <ac:chgData name="Reza Amini Hounejani" userId="36cb0b73-58b2-4568-a1ab-00cd49301806" providerId="ADAL" clId="{DA8FEA81-1A63-884F-A1C6-520C766F400F}" dt="2022-11-24T10:22:49.197" v="11654" actId="478"/>
          <ac:cxnSpMkLst>
            <pc:docMk/>
            <pc:sldMk cId="2229082649" sldId="258"/>
            <ac:cxnSpMk id="268" creationId="{A5A16797-5264-32E8-BCCD-A938686D6480}"/>
          </ac:cxnSpMkLst>
        </pc:cxnChg>
        <pc:cxnChg chg="add del mod">
          <ac:chgData name="Reza Amini Hounejani" userId="36cb0b73-58b2-4568-a1ab-00cd49301806" providerId="ADAL" clId="{DA8FEA81-1A63-884F-A1C6-520C766F400F}" dt="2022-11-24T10:24:24.227" v="11655" actId="478"/>
          <ac:cxnSpMkLst>
            <pc:docMk/>
            <pc:sldMk cId="2229082649" sldId="258"/>
            <ac:cxnSpMk id="270" creationId="{8FFBDDF0-F774-4036-3484-B686ABE0E9A6}"/>
          </ac:cxnSpMkLst>
        </pc:cxnChg>
        <pc:cxnChg chg="add mod">
          <ac:chgData name="Reza Amini Hounejani" userId="36cb0b73-58b2-4568-a1ab-00cd49301806" providerId="ADAL" clId="{DA8FEA81-1A63-884F-A1C6-520C766F400F}" dt="2022-11-24T10:21:21.848" v="11626" actId="1037"/>
          <ac:cxnSpMkLst>
            <pc:docMk/>
            <pc:sldMk cId="2229082649" sldId="258"/>
            <ac:cxnSpMk id="273" creationId="{47718E9A-0E9F-82FD-38B9-443476DE8244}"/>
          </ac:cxnSpMkLst>
        </pc:cxnChg>
        <pc:cxnChg chg="add mod">
          <ac:chgData name="Reza Amini Hounejani" userId="36cb0b73-58b2-4568-a1ab-00cd49301806" providerId="ADAL" clId="{DA8FEA81-1A63-884F-A1C6-520C766F400F}" dt="2022-11-24T10:21:26.548" v="11633" actId="1037"/>
          <ac:cxnSpMkLst>
            <pc:docMk/>
            <pc:sldMk cId="2229082649" sldId="258"/>
            <ac:cxnSpMk id="275" creationId="{A4499165-12A5-E07F-5BD6-54947361FF03}"/>
          </ac:cxnSpMkLst>
        </pc:cxnChg>
        <pc:cxnChg chg="add del mod">
          <ac:chgData name="Reza Amini Hounejani" userId="36cb0b73-58b2-4568-a1ab-00cd49301806" providerId="ADAL" clId="{DA8FEA81-1A63-884F-A1C6-520C766F400F}" dt="2022-11-24T10:22:49.197" v="11654" actId="478"/>
          <ac:cxnSpMkLst>
            <pc:docMk/>
            <pc:sldMk cId="2229082649" sldId="258"/>
            <ac:cxnSpMk id="276" creationId="{49323BB7-C6A3-3244-C384-2A0EC8EB6892}"/>
          </ac:cxnSpMkLst>
        </pc:cxnChg>
        <pc:cxnChg chg="add del mod">
          <ac:chgData name="Reza Amini Hounejani" userId="36cb0b73-58b2-4568-a1ab-00cd49301806" providerId="ADAL" clId="{DA8FEA81-1A63-884F-A1C6-520C766F400F}" dt="2022-11-08T09:40:04.786" v="6720" actId="478"/>
          <ac:cxnSpMkLst>
            <pc:docMk/>
            <pc:sldMk cId="2229082649" sldId="258"/>
            <ac:cxnSpMk id="279" creationId="{4E0159F1-EA63-C715-7539-2AF050CC96CF}"/>
          </ac:cxnSpMkLst>
        </pc:cxnChg>
        <pc:cxnChg chg="add mod">
          <ac:chgData name="Reza Amini Hounejani" userId="36cb0b73-58b2-4568-a1ab-00cd49301806" providerId="ADAL" clId="{DA8FEA81-1A63-884F-A1C6-520C766F400F}" dt="2022-11-24T10:21:21.848" v="11626" actId="1037"/>
          <ac:cxnSpMkLst>
            <pc:docMk/>
            <pc:sldMk cId="2229082649" sldId="258"/>
            <ac:cxnSpMk id="282" creationId="{6F50B5D3-88DE-C69D-18FD-142E5FC7FF61}"/>
          </ac:cxnSpMkLst>
        </pc:cxnChg>
        <pc:cxnChg chg="add del mod">
          <ac:chgData name="Reza Amini Hounejani" userId="36cb0b73-58b2-4568-a1ab-00cd49301806" providerId="ADAL" clId="{DA8FEA81-1A63-884F-A1C6-520C766F400F}" dt="2022-11-08T12:44:30.420" v="6775" actId="478"/>
          <ac:cxnSpMkLst>
            <pc:docMk/>
            <pc:sldMk cId="2229082649" sldId="258"/>
            <ac:cxnSpMk id="285" creationId="{9ED5FC16-04DA-C629-A889-A5440EF517D9}"/>
          </ac:cxnSpMkLst>
        </pc:cxnChg>
        <pc:cxnChg chg="add del mod">
          <ac:chgData name="Reza Amini Hounejani" userId="36cb0b73-58b2-4568-a1ab-00cd49301806" providerId="ADAL" clId="{DA8FEA81-1A63-884F-A1C6-520C766F400F}" dt="2022-11-08T12:44:31.452" v="6776" actId="478"/>
          <ac:cxnSpMkLst>
            <pc:docMk/>
            <pc:sldMk cId="2229082649" sldId="258"/>
            <ac:cxnSpMk id="286" creationId="{B1405EF9-3645-A413-F54E-002627D45984}"/>
          </ac:cxnSpMkLst>
        </pc:cxnChg>
        <pc:cxnChg chg="add mod">
          <ac:chgData name="Reza Amini Hounejani" userId="36cb0b73-58b2-4568-a1ab-00cd49301806" providerId="ADAL" clId="{DA8FEA81-1A63-884F-A1C6-520C766F400F}" dt="2022-11-24T10:21:21.848" v="11626" actId="1037"/>
          <ac:cxnSpMkLst>
            <pc:docMk/>
            <pc:sldMk cId="2229082649" sldId="258"/>
            <ac:cxnSpMk id="288" creationId="{148E3120-18DE-F834-A00F-48308890C71E}"/>
          </ac:cxnSpMkLst>
        </pc:cxnChg>
        <pc:cxnChg chg="add mod">
          <ac:chgData name="Reza Amini Hounejani" userId="36cb0b73-58b2-4568-a1ab-00cd49301806" providerId="ADAL" clId="{DA8FEA81-1A63-884F-A1C6-520C766F400F}" dt="2022-11-24T10:22:08.706" v="11651" actId="692"/>
          <ac:cxnSpMkLst>
            <pc:docMk/>
            <pc:sldMk cId="2229082649" sldId="258"/>
            <ac:cxnSpMk id="315" creationId="{3DEAA74E-5EF6-9987-0E91-78228108F75E}"/>
          </ac:cxnSpMkLst>
        </pc:cxnChg>
        <pc:cxnChg chg="add mod">
          <ac:chgData name="Reza Amini Hounejani" userId="36cb0b73-58b2-4568-a1ab-00cd49301806" providerId="ADAL" clId="{DA8FEA81-1A63-884F-A1C6-520C766F400F}" dt="2022-11-24T10:21:26.548" v="11633" actId="1037"/>
          <ac:cxnSpMkLst>
            <pc:docMk/>
            <pc:sldMk cId="2229082649" sldId="258"/>
            <ac:cxnSpMk id="317" creationId="{6D11462D-4C61-BDB0-4899-78CC5A4A15C7}"/>
          </ac:cxnSpMkLst>
        </pc:cxnChg>
        <pc:cxnChg chg="add mod">
          <ac:chgData name="Reza Amini Hounejani" userId="36cb0b73-58b2-4568-a1ab-00cd49301806" providerId="ADAL" clId="{DA8FEA81-1A63-884F-A1C6-520C766F400F}" dt="2022-11-24T10:21:26.548" v="11633" actId="1037"/>
          <ac:cxnSpMkLst>
            <pc:docMk/>
            <pc:sldMk cId="2229082649" sldId="258"/>
            <ac:cxnSpMk id="319" creationId="{07CED1F1-D389-4AB6-E02E-158A4B7D0143}"/>
          </ac:cxnSpMkLst>
        </pc:cxnChg>
        <pc:cxnChg chg="add mod">
          <ac:chgData name="Reza Amini Hounejani" userId="36cb0b73-58b2-4568-a1ab-00cd49301806" providerId="ADAL" clId="{DA8FEA81-1A63-884F-A1C6-520C766F400F}" dt="2022-11-24T10:21:26.548" v="11633" actId="1037"/>
          <ac:cxnSpMkLst>
            <pc:docMk/>
            <pc:sldMk cId="2229082649" sldId="258"/>
            <ac:cxnSpMk id="328" creationId="{A5CDCAB5-77A2-1638-50B5-64827785FA7F}"/>
          </ac:cxnSpMkLst>
        </pc:cxnChg>
        <pc:cxnChg chg="add mod">
          <ac:chgData name="Reza Amini Hounejani" userId="36cb0b73-58b2-4568-a1ab-00cd49301806" providerId="ADAL" clId="{DA8FEA81-1A63-884F-A1C6-520C766F400F}" dt="2022-11-24T10:24:44.469" v="11671" actId="164"/>
          <ac:cxnSpMkLst>
            <pc:docMk/>
            <pc:sldMk cId="2229082649" sldId="258"/>
            <ac:cxnSpMk id="348" creationId="{1B04DD3D-4749-9ABC-3F26-7594BD31EA4E}"/>
          </ac:cxnSpMkLst>
        </pc:cxnChg>
        <pc:cxnChg chg="add mod">
          <ac:chgData name="Reza Amini Hounejani" userId="36cb0b73-58b2-4568-a1ab-00cd49301806" providerId="ADAL" clId="{DA8FEA81-1A63-884F-A1C6-520C766F400F}" dt="2022-11-24T10:24:44.469" v="11671" actId="164"/>
          <ac:cxnSpMkLst>
            <pc:docMk/>
            <pc:sldMk cId="2229082649" sldId="258"/>
            <ac:cxnSpMk id="349" creationId="{C614F72D-81E8-78C9-485C-C5D1C9905C57}"/>
          </ac:cxnSpMkLst>
        </pc:cxnChg>
        <pc:cxnChg chg="add mod">
          <ac:chgData name="Reza Amini Hounejani" userId="36cb0b73-58b2-4568-a1ab-00cd49301806" providerId="ADAL" clId="{DA8FEA81-1A63-884F-A1C6-520C766F400F}" dt="2022-11-24T10:21:21.848" v="11626" actId="1037"/>
          <ac:cxnSpMkLst>
            <pc:docMk/>
            <pc:sldMk cId="2229082649" sldId="258"/>
            <ac:cxnSpMk id="353" creationId="{0993A5F6-7BC8-D5C7-6DBC-48BE82F7A9F0}"/>
          </ac:cxnSpMkLst>
        </pc:cxnChg>
      </pc:sldChg>
      <pc:sldChg chg="addSp delSp modSp mod">
        <pc:chgData name="Reza Amini Hounejani" userId="36cb0b73-58b2-4568-a1ab-00cd49301806" providerId="ADAL" clId="{DA8FEA81-1A63-884F-A1C6-520C766F400F}" dt="2022-11-25T13:19:33.907" v="11930" actId="732"/>
        <pc:sldMkLst>
          <pc:docMk/>
          <pc:sldMk cId="715266389" sldId="259"/>
        </pc:sldMkLst>
        <pc:spChg chg="add del mod">
          <ac:chgData name="Reza Amini Hounejani" userId="36cb0b73-58b2-4568-a1ab-00cd49301806" providerId="ADAL" clId="{DA8FEA81-1A63-884F-A1C6-520C766F400F}" dt="2022-07-27T14:51:21.092" v="2247" actId="478"/>
          <ac:spMkLst>
            <pc:docMk/>
            <pc:sldMk cId="715266389" sldId="259"/>
            <ac:spMk id="3" creationId="{21C872F1-E794-E1EA-121B-51A789F53E8A}"/>
          </ac:spMkLst>
        </pc:spChg>
        <pc:spChg chg="mod">
          <ac:chgData name="Reza Amini Hounejani" userId="36cb0b73-58b2-4568-a1ab-00cd49301806" providerId="ADAL" clId="{DA8FEA81-1A63-884F-A1C6-520C766F400F}" dt="2022-07-26T12:01:28.445" v="494" actId="20577"/>
          <ac:spMkLst>
            <pc:docMk/>
            <pc:sldMk cId="715266389" sldId="259"/>
            <ac:spMk id="5" creationId="{AE772983-2A36-7A06-830E-1BFFFBC6C2AD}"/>
          </ac:spMkLst>
        </pc:spChg>
        <pc:spChg chg="mod topLvl">
          <ac:chgData name="Reza Amini Hounejani" userId="36cb0b73-58b2-4568-a1ab-00cd49301806" providerId="ADAL" clId="{DA8FEA81-1A63-884F-A1C6-520C766F400F}" dt="2022-09-19T15:04:35.585" v="2712" actId="1076"/>
          <ac:spMkLst>
            <pc:docMk/>
            <pc:sldMk cId="715266389" sldId="259"/>
            <ac:spMk id="10" creationId="{13A089A5-562F-2C06-E2EC-BB73E2FCC13F}"/>
          </ac:spMkLst>
        </pc:spChg>
        <pc:spChg chg="mod topLvl">
          <ac:chgData name="Reza Amini Hounejani" userId="36cb0b73-58b2-4568-a1ab-00cd49301806" providerId="ADAL" clId="{DA8FEA81-1A63-884F-A1C6-520C766F400F}" dt="2022-09-19T15:04:05.910" v="2687" actId="165"/>
          <ac:spMkLst>
            <pc:docMk/>
            <pc:sldMk cId="715266389" sldId="259"/>
            <ac:spMk id="14" creationId="{0342B42E-46C5-193E-68D1-7D94112CE584}"/>
          </ac:spMkLst>
        </pc:spChg>
        <pc:spChg chg="mod">
          <ac:chgData name="Reza Amini Hounejani" userId="36cb0b73-58b2-4568-a1ab-00cd49301806" providerId="ADAL" clId="{DA8FEA81-1A63-884F-A1C6-520C766F400F}" dt="2022-11-16T15:47:51.832" v="9697" actId="1076"/>
          <ac:spMkLst>
            <pc:docMk/>
            <pc:sldMk cId="715266389" sldId="259"/>
            <ac:spMk id="15" creationId="{E5F8449B-4680-8665-89C6-FECC870E685D}"/>
          </ac:spMkLst>
        </pc:spChg>
        <pc:spChg chg="mod">
          <ac:chgData name="Reza Amini Hounejani" userId="36cb0b73-58b2-4568-a1ab-00cd49301806" providerId="ADAL" clId="{DA8FEA81-1A63-884F-A1C6-520C766F400F}" dt="2022-11-16T15:47:54.681" v="9698" actId="1076"/>
          <ac:spMkLst>
            <pc:docMk/>
            <pc:sldMk cId="715266389" sldId="259"/>
            <ac:spMk id="17" creationId="{40D517F0-A4C8-73EA-C431-EE477349735B}"/>
          </ac:spMkLst>
        </pc:spChg>
        <pc:spChg chg="mod">
          <ac:chgData name="Reza Amini Hounejani" userId="36cb0b73-58b2-4568-a1ab-00cd49301806" providerId="ADAL" clId="{DA8FEA81-1A63-884F-A1C6-520C766F400F}" dt="2022-11-16T12:35:32.961" v="8966" actId="1076"/>
          <ac:spMkLst>
            <pc:docMk/>
            <pc:sldMk cId="715266389" sldId="259"/>
            <ac:spMk id="18" creationId="{9362455C-FEE5-1FD6-E9B2-308B837EF089}"/>
          </ac:spMkLst>
        </pc:spChg>
        <pc:spChg chg="add del mod">
          <ac:chgData name="Reza Amini Hounejani" userId="36cb0b73-58b2-4568-a1ab-00cd49301806" providerId="ADAL" clId="{DA8FEA81-1A63-884F-A1C6-520C766F400F}" dt="2022-09-19T15:40:17.523" v="2773" actId="478"/>
          <ac:spMkLst>
            <pc:docMk/>
            <pc:sldMk cId="715266389" sldId="259"/>
            <ac:spMk id="22" creationId="{F7D55F88-0D6A-C74E-BE90-7EE5488171DD}"/>
          </ac:spMkLst>
        </pc:spChg>
        <pc:spChg chg="add del">
          <ac:chgData name="Reza Amini Hounejani" userId="36cb0b73-58b2-4568-a1ab-00cd49301806" providerId="ADAL" clId="{DA8FEA81-1A63-884F-A1C6-520C766F400F}" dt="2022-09-19T15:40:33.966" v="2775" actId="478"/>
          <ac:spMkLst>
            <pc:docMk/>
            <pc:sldMk cId="715266389" sldId="259"/>
            <ac:spMk id="23" creationId="{58C18072-EDAC-A204-A97C-2C9A7AE43DC8}"/>
          </ac:spMkLst>
        </pc:spChg>
        <pc:spChg chg="add mod">
          <ac:chgData name="Reza Amini Hounejani" userId="36cb0b73-58b2-4568-a1ab-00cd49301806" providerId="ADAL" clId="{DA8FEA81-1A63-884F-A1C6-520C766F400F}" dt="2022-11-25T13:18:46.527" v="11917" actId="1035"/>
          <ac:spMkLst>
            <pc:docMk/>
            <pc:sldMk cId="715266389" sldId="259"/>
            <ac:spMk id="24" creationId="{C5F50F07-857A-7EB6-54D9-EE6CB76762DF}"/>
          </ac:spMkLst>
        </pc:spChg>
        <pc:spChg chg="add mod">
          <ac:chgData name="Reza Amini Hounejani" userId="36cb0b73-58b2-4568-a1ab-00cd49301806" providerId="ADAL" clId="{DA8FEA81-1A63-884F-A1C6-520C766F400F}" dt="2022-11-18T14:47:39.421" v="9778" actId="12788"/>
          <ac:spMkLst>
            <pc:docMk/>
            <pc:sldMk cId="715266389" sldId="259"/>
            <ac:spMk id="25" creationId="{120D0515-4B8D-04F1-695F-8ACA6EA67ADB}"/>
          </ac:spMkLst>
        </pc:spChg>
        <pc:spChg chg="add mod">
          <ac:chgData name="Reza Amini Hounejani" userId="36cb0b73-58b2-4568-a1ab-00cd49301806" providerId="ADAL" clId="{DA8FEA81-1A63-884F-A1C6-520C766F400F}" dt="2022-11-16T12:37:13.505" v="8986" actId="571"/>
          <ac:spMkLst>
            <pc:docMk/>
            <pc:sldMk cId="715266389" sldId="259"/>
            <ac:spMk id="27" creationId="{AF8D1384-F981-5638-9FCA-2A92F532C798}"/>
          </ac:spMkLst>
        </pc:spChg>
        <pc:spChg chg="add mod">
          <ac:chgData name="Reza Amini Hounejani" userId="36cb0b73-58b2-4568-a1ab-00cd49301806" providerId="ADAL" clId="{DA8FEA81-1A63-884F-A1C6-520C766F400F}" dt="2022-11-16T12:37:36.967" v="8994" actId="12788"/>
          <ac:spMkLst>
            <pc:docMk/>
            <pc:sldMk cId="715266389" sldId="259"/>
            <ac:spMk id="28" creationId="{083BE831-2F7D-31DE-09EE-CB56249D522A}"/>
          </ac:spMkLst>
        </pc:spChg>
        <pc:spChg chg="add mod">
          <ac:chgData name="Reza Amini Hounejani" userId="36cb0b73-58b2-4568-a1ab-00cd49301806" providerId="ADAL" clId="{DA8FEA81-1A63-884F-A1C6-520C766F400F}" dt="2022-11-25T13:18:46.527" v="11917" actId="1035"/>
          <ac:spMkLst>
            <pc:docMk/>
            <pc:sldMk cId="715266389" sldId="259"/>
            <ac:spMk id="31" creationId="{63A079C3-D6EF-82FA-76FA-AB8F24882CB2}"/>
          </ac:spMkLst>
        </pc:spChg>
        <pc:spChg chg="add del mod">
          <ac:chgData name="Reza Amini Hounejani" userId="36cb0b73-58b2-4568-a1ab-00cd49301806" providerId="ADAL" clId="{DA8FEA81-1A63-884F-A1C6-520C766F400F}" dt="2022-09-20T07:19:14.091" v="2853" actId="478"/>
          <ac:spMkLst>
            <pc:docMk/>
            <pc:sldMk cId="715266389" sldId="259"/>
            <ac:spMk id="32" creationId="{CB13FD04-BCDB-D38F-003B-8E44B60346A5}"/>
          </ac:spMkLst>
        </pc:spChg>
        <pc:spChg chg="mod">
          <ac:chgData name="Reza Amini Hounejani" userId="36cb0b73-58b2-4568-a1ab-00cd49301806" providerId="ADAL" clId="{DA8FEA81-1A63-884F-A1C6-520C766F400F}" dt="2022-11-25T13:14:57.706" v="11899" actId="1035"/>
          <ac:spMkLst>
            <pc:docMk/>
            <pc:sldMk cId="715266389" sldId="259"/>
            <ac:spMk id="80" creationId="{AC337463-6C6F-80D1-F395-08B4142B5E88}"/>
          </ac:spMkLst>
        </pc:spChg>
        <pc:spChg chg="mod">
          <ac:chgData name="Reza Amini Hounejani" userId="36cb0b73-58b2-4568-a1ab-00cd49301806" providerId="ADAL" clId="{DA8FEA81-1A63-884F-A1C6-520C766F400F}" dt="2022-11-25T13:18:03.742" v="11907" actId="553"/>
          <ac:spMkLst>
            <pc:docMk/>
            <pc:sldMk cId="715266389" sldId="259"/>
            <ac:spMk id="81" creationId="{3D920564-D991-4FC5-BC05-553DAC8B2481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82" creationId="{C42573DD-98C4-3385-439A-7584DE6701B8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83" creationId="{B8648ED8-D362-57E0-DC9F-80F0283F2A47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84" creationId="{3A45D2E4-3B14-08D7-5C0F-2C73A89732BF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85" creationId="{4F5409C6-EB9F-D6CC-5068-3A395547DE99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86" creationId="{3B4EAA58-9CC8-0025-F93B-F40224D6D2E4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87" creationId="{96B5713C-68CD-E046-2AF0-4D0ADD8FF64F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89" creationId="{30D09389-972D-E76A-E6BF-1513EA44EECA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90" creationId="{363A7A91-7B66-F638-6C31-87AE928DA157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91" creationId="{2C2DAFDD-DF8C-33E8-658E-7E4B523DFDAF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92" creationId="{00FFF396-D122-A2F2-5C0D-A0E8152351E6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93" creationId="{198A7CC8-4D0C-9087-FB4C-23755092815C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94" creationId="{0DF84C9D-485E-E488-03FA-E2AC8C93A878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95" creationId="{8B0CA24F-DC14-9993-FE10-552271A54204}"/>
          </ac:spMkLst>
        </pc:spChg>
        <pc:spChg chg="mod">
          <ac:chgData name="Reza Amini Hounejani" userId="36cb0b73-58b2-4568-a1ab-00cd49301806" providerId="ADAL" clId="{DA8FEA81-1A63-884F-A1C6-520C766F400F}" dt="2022-07-26T15:38:25.311" v="745" actId="164"/>
          <ac:spMkLst>
            <pc:docMk/>
            <pc:sldMk cId="715266389" sldId="259"/>
            <ac:spMk id="96" creationId="{244F2A99-C0FC-149C-94D9-ABFFC94B016B}"/>
          </ac:spMkLst>
        </pc:spChg>
        <pc:spChg chg="mod">
          <ac:chgData name="Reza Amini Hounejani" userId="36cb0b73-58b2-4568-a1ab-00cd49301806" providerId="ADAL" clId="{DA8FEA81-1A63-884F-A1C6-520C766F400F}" dt="2022-11-16T12:53:09.176" v="9270" actId="1037"/>
          <ac:spMkLst>
            <pc:docMk/>
            <pc:sldMk cId="715266389" sldId="259"/>
            <ac:spMk id="97" creationId="{D5F75C0D-E417-307C-AAE8-6C40B088B868}"/>
          </ac:spMkLst>
        </pc:spChg>
        <pc:spChg chg="mod">
          <ac:chgData name="Reza Amini Hounejani" userId="36cb0b73-58b2-4568-a1ab-00cd49301806" providerId="ADAL" clId="{DA8FEA81-1A63-884F-A1C6-520C766F400F}" dt="2022-11-16T12:53:09.567" v="9271" actId="1076"/>
          <ac:spMkLst>
            <pc:docMk/>
            <pc:sldMk cId="715266389" sldId="259"/>
            <ac:spMk id="98" creationId="{AE1FE19B-F365-ABA0-AE40-1B65EB77B199}"/>
          </ac:spMkLst>
        </pc:spChg>
        <pc:spChg chg="mod">
          <ac:chgData name="Reza Amini Hounejani" userId="36cb0b73-58b2-4568-a1ab-00cd49301806" providerId="ADAL" clId="{DA8FEA81-1A63-884F-A1C6-520C766F400F}" dt="2022-09-19T15:39:36.109" v="2753" actId="1037"/>
          <ac:spMkLst>
            <pc:docMk/>
            <pc:sldMk cId="715266389" sldId="259"/>
            <ac:spMk id="108" creationId="{731751E8-2999-1830-A31F-7F4F1ACDD594}"/>
          </ac:spMkLst>
        </pc:spChg>
        <pc:spChg chg="mod">
          <ac:chgData name="Reza Amini Hounejani" userId="36cb0b73-58b2-4568-a1ab-00cd49301806" providerId="ADAL" clId="{DA8FEA81-1A63-884F-A1C6-520C766F400F}" dt="2022-09-20T07:19:19.301" v="2854" actId="1076"/>
          <ac:spMkLst>
            <pc:docMk/>
            <pc:sldMk cId="715266389" sldId="259"/>
            <ac:spMk id="109" creationId="{08B8EFC7-4744-F512-BCE7-A531F2E322C7}"/>
          </ac:spMkLst>
        </pc:spChg>
        <pc:spChg chg="mod">
          <ac:chgData name="Reza Amini Hounejani" userId="36cb0b73-58b2-4568-a1ab-00cd49301806" providerId="ADAL" clId="{DA8FEA81-1A63-884F-A1C6-520C766F400F}" dt="2022-11-16T12:33:10.770" v="8939" actId="14100"/>
          <ac:spMkLst>
            <pc:docMk/>
            <pc:sldMk cId="715266389" sldId="259"/>
            <ac:spMk id="112" creationId="{0A732C2D-FA0F-9FD5-F815-D68FB8837589}"/>
          </ac:spMkLst>
        </pc:spChg>
        <pc:spChg chg="mod">
          <ac:chgData name="Reza Amini Hounejani" userId="36cb0b73-58b2-4568-a1ab-00cd49301806" providerId="ADAL" clId="{DA8FEA81-1A63-884F-A1C6-520C766F400F}" dt="2022-11-16T12:35:14.819" v="8962" actId="14100"/>
          <ac:spMkLst>
            <pc:docMk/>
            <pc:sldMk cId="715266389" sldId="259"/>
            <ac:spMk id="115" creationId="{BCE0C066-DCE1-59E7-948B-E44D47D19FA0}"/>
          </ac:spMkLst>
        </pc:spChg>
        <pc:spChg chg="mod">
          <ac:chgData name="Reza Amini Hounejani" userId="36cb0b73-58b2-4568-a1ab-00cd49301806" providerId="ADAL" clId="{DA8FEA81-1A63-884F-A1C6-520C766F400F}" dt="2022-11-16T12:35:23.177" v="8964" actId="1076"/>
          <ac:spMkLst>
            <pc:docMk/>
            <pc:sldMk cId="715266389" sldId="259"/>
            <ac:spMk id="117" creationId="{442B6392-47F9-6E40-31D6-44181278A794}"/>
          </ac:spMkLst>
        </pc:spChg>
        <pc:spChg chg="mod">
          <ac:chgData name="Reza Amini Hounejani" userId="36cb0b73-58b2-4568-a1ab-00cd49301806" providerId="ADAL" clId="{DA8FEA81-1A63-884F-A1C6-520C766F400F}" dt="2022-11-16T12:33:57.730" v="8948" actId="1076"/>
          <ac:spMkLst>
            <pc:docMk/>
            <pc:sldMk cId="715266389" sldId="259"/>
            <ac:spMk id="122" creationId="{9AE78721-CD3E-0483-3000-A0BEEC98DB00}"/>
          </ac:spMkLst>
        </pc:spChg>
        <pc:spChg chg="mod">
          <ac:chgData name="Reza Amini Hounejani" userId="36cb0b73-58b2-4568-a1ab-00cd49301806" providerId="ADAL" clId="{DA8FEA81-1A63-884F-A1C6-520C766F400F}" dt="2022-11-16T12:33:53.946" v="8947" actId="1076"/>
          <ac:spMkLst>
            <pc:docMk/>
            <pc:sldMk cId="715266389" sldId="259"/>
            <ac:spMk id="123" creationId="{31E59622-4596-4101-3CF0-C9F8A41D8A04}"/>
          </ac:spMkLst>
        </pc:spChg>
        <pc:spChg chg="mod">
          <ac:chgData name="Reza Amini Hounejani" userId="36cb0b73-58b2-4568-a1ab-00cd49301806" providerId="ADAL" clId="{DA8FEA81-1A63-884F-A1C6-520C766F400F}" dt="2022-11-16T12:33:46.581" v="8946" actId="1076"/>
          <ac:spMkLst>
            <pc:docMk/>
            <pc:sldMk cId="715266389" sldId="259"/>
            <ac:spMk id="124" creationId="{BA6D541F-CE00-5319-2AC8-FA464F863BFB}"/>
          </ac:spMkLst>
        </pc:spChg>
        <pc:spChg chg="mod">
          <ac:chgData name="Reza Amini Hounejani" userId="36cb0b73-58b2-4568-a1ab-00cd49301806" providerId="ADAL" clId="{DA8FEA81-1A63-884F-A1C6-520C766F400F}" dt="2022-11-16T12:34:23.481" v="8953" actId="1076"/>
          <ac:spMkLst>
            <pc:docMk/>
            <pc:sldMk cId="715266389" sldId="259"/>
            <ac:spMk id="125" creationId="{E35573ED-6426-2110-336D-0A16AF1E5908}"/>
          </ac:spMkLst>
        </pc:spChg>
        <pc:spChg chg="mod">
          <ac:chgData name="Reza Amini Hounejani" userId="36cb0b73-58b2-4568-a1ab-00cd49301806" providerId="ADAL" clId="{DA8FEA81-1A63-884F-A1C6-520C766F400F}" dt="2022-11-16T12:34:18.157" v="8952" actId="1076"/>
          <ac:spMkLst>
            <pc:docMk/>
            <pc:sldMk cId="715266389" sldId="259"/>
            <ac:spMk id="126" creationId="{B3CDB82E-0FCB-FF06-514A-04E6CC8C4633}"/>
          </ac:spMkLst>
        </pc:spChg>
        <pc:spChg chg="mod">
          <ac:chgData name="Reza Amini Hounejani" userId="36cb0b73-58b2-4568-a1ab-00cd49301806" providerId="ADAL" clId="{DA8FEA81-1A63-884F-A1C6-520C766F400F}" dt="2022-11-16T12:34:12.994" v="8951" actId="1076"/>
          <ac:spMkLst>
            <pc:docMk/>
            <pc:sldMk cId="715266389" sldId="259"/>
            <ac:spMk id="127" creationId="{C259B4C7-118F-CC17-4B17-6B19F5DF517B}"/>
          </ac:spMkLst>
        </pc:spChg>
        <pc:spChg chg="mod">
          <ac:chgData name="Reza Amini Hounejani" userId="36cb0b73-58b2-4568-a1ab-00cd49301806" providerId="ADAL" clId="{DA8FEA81-1A63-884F-A1C6-520C766F400F}" dt="2022-11-16T12:33:21.594" v="8940" actId="1076"/>
          <ac:spMkLst>
            <pc:docMk/>
            <pc:sldMk cId="715266389" sldId="259"/>
            <ac:spMk id="128" creationId="{68856021-18C0-9887-AFD8-85013CEE81AC}"/>
          </ac:spMkLst>
        </pc:spChg>
        <pc:spChg chg="mod">
          <ac:chgData name="Reza Amini Hounejani" userId="36cb0b73-58b2-4568-a1ab-00cd49301806" providerId="ADAL" clId="{DA8FEA81-1A63-884F-A1C6-520C766F400F}" dt="2022-11-16T12:33:25.706" v="8941" actId="1076"/>
          <ac:spMkLst>
            <pc:docMk/>
            <pc:sldMk cId="715266389" sldId="259"/>
            <ac:spMk id="129" creationId="{DD3F5574-DA10-3D0B-E4F4-ED2539FD4FDC}"/>
          </ac:spMkLst>
        </pc:spChg>
        <pc:spChg chg="mod">
          <ac:chgData name="Reza Amini Hounejani" userId="36cb0b73-58b2-4568-a1ab-00cd49301806" providerId="ADAL" clId="{DA8FEA81-1A63-884F-A1C6-520C766F400F}" dt="2022-11-16T12:33:29.250" v="8942" actId="1076"/>
          <ac:spMkLst>
            <pc:docMk/>
            <pc:sldMk cId="715266389" sldId="259"/>
            <ac:spMk id="130" creationId="{5C043BF9-B7A2-E55B-243E-B2C91B53D490}"/>
          </ac:spMkLst>
        </pc:spChg>
        <pc:spChg chg="mod">
          <ac:chgData name="Reza Amini Hounejani" userId="36cb0b73-58b2-4568-a1ab-00cd49301806" providerId="ADAL" clId="{DA8FEA81-1A63-884F-A1C6-520C766F400F}" dt="2022-11-16T12:33:33.578" v="8943" actId="1076"/>
          <ac:spMkLst>
            <pc:docMk/>
            <pc:sldMk cId="715266389" sldId="259"/>
            <ac:spMk id="132" creationId="{2877BAF6-9941-8EEC-DF7F-5A005F4D2F65}"/>
          </ac:spMkLst>
        </pc:spChg>
        <pc:spChg chg="mod">
          <ac:chgData name="Reza Amini Hounejani" userId="36cb0b73-58b2-4568-a1ab-00cd49301806" providerId="ADAL" clId="{DA8FEA81-1A63-884F-A1C6-520C766F400F}" dt="2022-11-16T12:34:45.402" v="8956" actId="1076"/>
          <ac:spMkLst>
            <pc:docMk/>
            <pc:sldMk cId="715266389" sldId="259"/>
            <ac:spMk id="134" creationId="{35890859-0E28-4264-52A2-01F209D622AC}"/>
          </ac:spMkLst>
        </pc:spChg>
        <pc:spChg chg="mod">
          <ac:chgData name="Reza Amini Hounejani" userId="36cb0b73-58b2-4568-a1ab-00cd49301806" providerId="ADAL" clId="{DA8FEA81-1A63-884F-A1C6-520C766F400F}" dt="2022-11-16T12:34:49.145" v="8957" actId="1076"/>
          <ac:spMkLst>
            <pc:docMk/>
            <pc:sldMk cId="715266389" sldId="259"/>
            <ac:spMk id="135" creationId="{61F9FB0F-21C1-394B-D249-42630D480F92}"/>
          </ac:spMkLst>
        </pc:spChg>
        <pc:spChg chg="mod">
          <ac:chgData name="Reza Amini Hounejani" userId="36cb0b73-58b2-4568-a1ab-00cd49301806" providerId="ADAL" clId="{DA8FEA81-1A63-884F-A1C6-520C766F400F}" dt="2022-11-16T12:35:02.457" v="8960" actId="1076"/>
          <ac:spMkLst>
            <pc:docMk/>
            <pc:sldMk cId="715266389" sldId="259"/>
            <ac:spMk id="136" creationId="{4C90CE5E-5449-D741-31C7-1340B6E3BE15}"/>
          </ac:spMkLst>
        </pc:spChg>
        <pc:spChg chg="mod">
          <ac:chgData name="Reza Amini Hounejani" userId="36cb0b73-58b2-4568-a1ab-00cd49301806" providerId="ADAL" clId="{DA8FEA81-1A63-884F-A1C6-520C766F400F}" dt="2022-11-16T12:34:58.655" v="8959" actId="1076"/>
          <ac:spMkLst>
            <pc:docMk/>
            <pc:sldMk cId="715266389" sldId="259"/>
            <ac:spMk id="137" creationId="{BD0E778B-C534-9FE1-1FFD-E5929002DC2B}"/>
          </ac:spMkLst>
        </pc:spChg>
        <pc:spChg chg="mod">
          <ac:chgData name="Reza Amini Hounejani" userId="36cb0b73-58b2-4568-a1ab-00cd49301806" providerId="ADAL" clId="{DA8FEA81-1A63-884F-A1C6-520C766F400F}" dt="2022-11-16T12:34:56.018" v="8958" actId="1076"/>
          <ac:spMkLst>
            <pc:docMk/>
            <pc:sldMk cId="715266389" sldId="259"/>
            <ac:spMk id="138" creationId="{48D43CE3-A3D8-BF57-1D6D-ED7E5AAD7170}"/>
          </ac:spMkLst>
        </pc:spChg>
        <pc:grpChg chg="add mod">
          <ac:chgData name="Reza Amini Hounejani" userId="36cb0b73-58b2-4568-a1ab-00cd49301806" providerId="ADAL" clId="{DA8FEA81-1A63-884F-A1C6-520C766F400F}" dt="2022-07-26T15:38:31.092" v="746" actId="1076"/>
          <ac:grpSpMkLst>
            <pc:docMk/>
            <pc:sldMk cId="715266389" sldId="259"/>
            <ac:grpSpMk id="2" creationId="{49D5FFA1-B816-18E6-085A-017DBE0CEFA8}"/>
          </ac:grpSpMkLst>
        </pc:grpChg>
        <pc:grpChg chg="del">
          <ac:chgData name="Reza Amini Hounejani" userId="36cb0b73-58b2-4568-a1ab-00cd49301806" providerId="ADAL" clId="{DA8FEA81-1A63-884F-A1C6-520C766F400F}" dt="2022-09-19T15:03:05.027" v="2677" actId="165"/>
          <ac:grpSpMkLst>
            <pc:docMk/>
            <pc:sldMk cId="715266389" sldId="259"/>
            <ac:grpSpMk id="7" creationId="{D944246D-9992-1990-E758-37257111A4FE}"/>
          </ac:grpSpMkLst>
        </pc:grpChg>
        <pc:grpChg chg="del mod">
          <ac:chgData name="Reza Amini Hounejani" userId="36cb0b73-58b2-4568-a1ab-00cd49301806" providerId="ADAL" clId="{DA8FEA81-1A63-884F-A1C6-520C766F400F}" dt="2022-09-19T15:04:05.910" v="2687" actId="165"/>
          <ac:grpSpMkLst>
            <pc:docMk/>
            <pc:sldMk cId="715266389" sldId="259"/>
            <ac:grpSpMk id="11" creationId="{D0C4F43D-4406-18C2-9F32-E4BB761C5A83}"/>
          </ac:grpSpMkLst>
        </pc:grpChg>
        <pc:grpChg chg="mod">
          <ac:chgData name="Reza Amini Hounejani" userId="36cb0b73-58b2-4568-a1ab-00cd49301806" providerId="ADAL" clId="{DA8FEA81-1A63-884F-A1C6-520C766F400F}" dt="2022-11-25T13:19:06.252" v="11928" actId="12789"/>
          <ac:grpSpMkLst>
            <pc:docMk/>
            <pc:sldMk cId="715266389" sldId="259"/>
            <ac:grpSpMk id="102" creationId="{4A6A3860-0966-FFA4-8A85-19F56CE99D85}"/>
          </ac:grpSpMkLst>
        </pc:grpChg>
        <pc:grpChg chg="mod">
          <ac:chgData name="Reza Amini Hounejani" userId="36cb0b73-58b2-4568-a1ab-00cd49301806" providerId="ADAL" clId="{DA8FEA81-1A63-884F-A1C6-520C766F400F}" dt="2022-11-25T13:19:06.252" v="11928" actId="12789"/>
          <ac:grpSpMkLst>
            <pc:docMk/>
            <pc:sldMk cId="715266389" sldId="259"/>
            <ac:grpSpMk id="142" creationId="{16726547-532C-DF24-68D1-1C99A80BCEA1}"/>
          </ac:grpSpMkLst>
        </pc:grpChg>
        <pc:grpChg chg="mod">
          <ac:chgData name="Reza Amini Hounejani" userId="36cb0b73-58b2-4568-a1ab-00cd49301806" providerId="ADAL" clId="{DA8FEA81-1A63-884F-A1C6-520C766F400F}" dt="2022-11-25T13:19:06.252" v="11928" actId="12789"/>
          <ac:grpSpMkLst>
            <pc:docMk/>
            <pc:sldMk cId="715266389" sldId="259"/>
            <ac:grpSpMk id="143" creationId="{F925CB43-F4E5-6934-3E7F-34153AE38067}"/>
          </ac:grpSpMkLst>
        </pc:grpChg>
        <pc:picChg chg="mod">
          <ac:chgData name="Reza Amini Hounejani" userId="36cb0b73-58b2-4568-a1ab-00cd49301806" providerId="ADAL" clId="{DA8FEA81-1A63-884F-A1C6-520C766F400F}" dt="2022-11-16T12:52:46.256" v="9264" actId="1076"/>
          <ac:picMkLst>
            <pc:docMk/>
            <pc:sldMk cId="715266389" sldId="259"/>
            <ac:picMk id="6" creationId="{96DEA376-28FB-B1EE-3EDC-4EF895E16E4A}"/>
          </ac:picMkLst>
        </pc:picChg>
        <pc:picChg chg="del mod topLvl">
          <ac:chgData name="Reza Amini Hounejani" userId="36cb0b73-58b2-4568-a1ab-00cd49301806" providerId="ADAL" clId="{DA8FEA81-1A63-884F-A1C6-520C766F400F}" dt="2022-11-24T08:35:53.756" v="11456" actId="478"/>
          <ac:picMkLst>
            <pc:docMk/>
            <pc:sldMk cId="715266389" sldId="259"/>
            <ac:picMk id="8" creationId="{17620379-B6AA-0708-BFF2-F0B2B266FA2A}"/>
          </ac:picMkLst>
        </pc:picChg>
        <pc:picChg chg="add mod modCrop">
          <ac:chgData name="Reza Amini Hounejani" userId="36cb0b73-58b2-4568-a1ab-00cd49301806" providerId="ADAL" clId="{DA8FEA81-1A63-884F-A1C6-520C766F400F}" dt="2022-11-25T13:18:03.742" v="11907" actId="553"/>
          <ac:picMkLst>
            <pc:docMk/>
            <pc:sldMk cId="715266389" sldId="259"/>
            <ac:picMk id="9" creationId="{B23D0F72-C346-6F3D-E0AC-49B8A6BAC7E2}"/>
          </ac:picMkLst>
        </pc:picChg>
        <pc:picChg chg="mod topLvl">
          <ac:chgData name="Reza Amini Hounejani" userId="36cb0b73-58b2-4568-a1ab-00cd49301806" providerId="ADAL" clId="{DA8FEA81-1A63-884F-A1C6-520C766F400F}" dt="2022-09-19T15:04:18.135" v="2709" actId="1035"/>
          <ac:picMkLst>
            <pc:docMk/>
            <pc:sldMk cId="715266389" sldId="259"/>
            <ac:picMk id="12" creationId="{54E96ECB-2536-89B2-F778-BA77D7E07C30}"/>
          </ac:picMkLst>
        </pc:picChg>
        <pc:picChg chg="add mod modCrop">
          <ac:chgData name="Reza Amini Hounejani" userId="36cb0b73-58b2-4568-a1ab-00cd49301806" providerId="ADAL" clId="{DA8FEA81-1A63-884F-A1C6-520C766F400F}" dt="2022-11-25T13:19:33.907" v="11930" actId="732"/>
          <ac:picMkLst>
            <pc:docMk/>
            <pc:sldMk cId="715266389" sldId="259"/>
            <ac:picMk id="13" creationId="{9E6A2084-9BF0-D9CA-F3C0-9398B8CFEC57}"/>
          </ac:picMkLst>
        </pc:picChg>
        <pc:picChg chg="mod">
          <ac:chgData name="Reza Amini Hounejani" userId="36cb0b73-58b2-4568-a1ab-00cd49301806" providerId="ADAL" clId="{DA8FEA81-1A63-884F-A1C6-520C766F400F}" dt="2022-11-16T12:35:41.490" v="8967" actId="14100"/>
          <ac:picMkLst>
            <pc:docMk/>
            <pc:sldMk cId="715266389" sldId="259"/>
            <ac:picMk id="78" creationId="{B5ABA07D-66B9-F95C-3747-9C23D97CA3A1}"/>
          </ac:picMkLst>
        </pc:picChg>
        <pc:picChg chg="mod">
          <ac:chgData name="Reza Amini Hounejani" userId="36cb0b73-58b2-4568-a1ab-00cd49301806" providerId="ADAL" clId="{DA8FEA81-1A63-884F-A1C6-520C766F400F}" dt="2022-11-25T13:18:15.505" v="11910" actId="1037"/>
          <ac:picMkLst>
            <pc:docMk/>
            <pc:sldMk cId="715266389" sldId="259"/>
            <ac:picMk id="79" creationId="{95A926AE-56B1-CBB6-CFF1-DCE96131D57C}"/>
          </ac:picMkLst>
        </pc:picChg>
        <pc:picChg chg="mod">
          <ac:chgData name="Reza Amini Hounejani" userId="36cb0b73-58b2-4568-a1ab-00cd49301806" providerId="ADAL" clId="{DA8FEA81-1A63-884F-A1C6-520C766F400F}" dt="2022-11-16T12:25:04.425" v="8907" actId="14100"/>
          <ac:picMkLst>
            <pc:docMk/>
            <pc:sldMk cId="715266389" sldId="259"/>
            <ac:picMk id="99" creationId="{17EE0E86-FD2E-DF5D-AAE6-47DE0419D678}"/>
          </ac:picMkLst>
        </pc:picChg>
        <pc:picChg chg="add del mod">
          <ac:chgData name="Reza Amini Hounejani" userId="36cb0b73-58b2-4568-a1ab-00cd49301806" providerId="ADAL" clId="{DA8FEA81-1A63-884F-A1C6-520C766F400F}" dt="2022-11-24T08:35:54.618" v="11457" actId="478"/>
          <ac:picMkLst>
            <pc:docMk/>
            <pc:sldMk cId="715266389" sldId="259"/>
            <ac:picMk id="101" creationId="{63F35991-18DB-72BC-8A69-0BDDEA7A88D3}"/>
          </ac:picMkLst>
        </pc:picChg>
        <pc:picChg chg="mod modCrop">
          <ac:chgData name="Reza Amini Hounejani" userId="36cb0b73-58b2-4568-a1ab-00cd49301806" providerId="ADAL" clId="{DA8FEA81-1A63-884F-A1C6-520C766F400F}" dt="2022-11-25T13:19:25.900" v="11929" actId="732"/>
          <ac:picMkLst>
            <pc:docMk/>
            <pc:sldMk cId="715266389" sldId="259"/>
            <ac:picMk id="103" creationId="{82F45378-B17D-07E7-299E-201229FC8BC0}"/>
          </ac:picMkLst>
        </pc:picChg>
        <pc:cxnChg chg="add mod">
          <ac:chgData name="Reza Amini Hounejani" userId="36cb0b73-58b2-4568-a1ab-00cd49301806" providerId="ADAL" clId="{DA8FEA81-1A63-884F-A1C6-520C766F400F}" dt="2022-11-18T14:47:39.421" v="9778" actId="12788"/>
          <ac:cxnSpMkLst>
            <pc:docMk/>
            <pc:sldMk cId="715266389" sldId="259"/>
            <ac:cxnSpMk id="7" creationId="{AB5B0267-BC00-708C-3DCE-E56FA7E5709A}"/>
          </ac:cxnSpMkLst>
        </pc:cxnChg>
        <pc:cxnChg chg="add mod">
          <ac:chgData name="Reza Amini Hounejani" userId="36cb0b73-58b2-4568-a1ab-00cd49301806" providerId="ADAL" clId="{DA8FEA81-1A63-884F-A1C6-520C766F400F}" dt="2022-11-16T12:37:36.967" v="8994" actId="12788"/>
          <ac:cxnSpMkLst>
            <pc:docMk/>
            <pc:sldMk cId="715266389" sldId="259"/>
            <ac:cxnSpMk id="11" creationId="{39BABF1A-BBF7-054C-6067-8AFB3695976B}"/>
          </ac:cxnSpMkLst>
        </pc:cxnChg>
        <pc:cxnChg chg="add mod">
          <ac:chgData name="Reza Amini Hounejani" userId="36cb0b73-58b2-4568-a1ab-00cd49301806" providerId="ADAL" clId="{DA8FEA81-1A63-884F-A1C6-520C766F400F}" dt="2022-11-25T13:18:46.527" v="11917" actId="1035"/>
          <ac:cxnSpMkLst>
            <pc:docMk/>
            <pc:sldMk cId="715266389" sldId="259"/>
            <ac:cxnSpMk id="19" creationId="{77A2E765-CF53-1DA8-2C8B-54B7702F803E}"/>
          </ac:cxnSpMkLst>
        </pc:cxnChg>
        <pc:cxnChg chg="add mod">
          <ac:chgData name="Reza Amini Hounejani" userId="36cb0b73-58b2-4568-a1ab-00cd49301806" providerId="ADAL" clId="{DA8FEA81-1A63-884F-A1C6-520C766F400F}" dt="2022-11-25T13:18:46.527" v="11917" actId="1035"/>
          <ac:cxnSpMkLst>
            <pc:docMk/>
            <pc:sldMk cId="715266389" sldId="259"/>
            <ac:cxnSpMk id="20" creationId="{8C9BC1CC-74AE-EA44-3A7B-3005E42EED7E}"/>
          </ac:cxnSpMkLst>
        </pc:cxnChg>
        <pc:cxnChg chg="add mod">
          <ac:chgData name="Reza Amini Hounejani" userId="36cb0b73-58b2-4568-a1ab-00cd49301806" providerId="ADAL" clId="{DA8FEA81-1A63-884F-A1C6-520C766F400F}" dt="2022-11-25T13:18:46.527" v="11917" actId="1035"/>
          <ac:cxnSpMkLst>
            <pc:docMk/>
            <pc:sldMk cId="715266389" sldId="259"/>
            <ac:cxnSpMk id="21" creationId="{5335BC14-43D9-D351-CCF9-1627D09B38C5}"/>
          </ac:cxnSpMkLst>
        </pc:cxnChg>
        <pc:cxnChg chg="add mod">
          <ac:chgData name="Reza Amini Hounejani" userId="36cb0b73-58b2-4568-a1ab-00cd49301806" providerId="ADAL" clId="{DA8FEA81-1A63-884F-A1C6-520C766F400F}" dt="2022-11-16T12:37:13.505" v="8986" actId="571"/>
          <ac:cxnSpMkLst>
            <pc:docMk/>
            <pc:sldMk cId="715266389" sldId="259"/>
            <ac:cxnSpMk id="26" creationId="{AA23804F-EA9D-014B-F593-F7A5E7E97D04}"/>
          </ac:cxnSpMkLst>
        </pc:cxnChg>
        <pc:cxnChg chg="add mod">
          <ac:chgData name="Reza Amini Hounejani" userId="36cb0b73-58b2-4568-a1ab-00cd49301806" providerId="ADAL" clId="{DA8FEA81-1A63-884F-A1C6-520C766F400F}" dt="2022-11-25T13:18:46.527" v="11917" actId="1035"/>
          <ac:cxnSpMkLst>
            <pc:docMk/>
            <pc:sldMk cId="715266389" sldId="259"/>
            <ac:cxnSpMk id="33" creationId="{23B8A696-FD47-AB74-B00D-EE81030CA530}"/>
          </ac:cxnSpMkLst>
        </pc:cxnChg>
      </pc:sldChg>
      <pc:sldChg chg="addSp delSp modSp mod">
        <pc:chgData name="Reza Amini Hounejani" userId="36cb0b73-58b2-4568-a1ab-00cd49301806" providerId="ADAL" clId="{DA8FEA81-1A63-884F-A1C6-520C766F400F}" dt="2022-11-25T13:04:24.876" v="11868" actId="478"/>
        <pc:sldMkLst>
          <pc:docMk/>
          <pc:sldMk cId="1578300178" sldId="260"/>
        </pc:sldMkLst>
        <pc:spChg chg="add del">
          <ac:chgData name="Reza Amini Hounejani" userId="36cb0b73-58b2-4568-a1ab-00cd49301806" providerId="ADAL" clId="{DA8FEA81-1A63-884F-A1C6-520C766F400F}" dt="2022-09-21T08:32:19.750" v="2858" actId="478"/>
          <ac:spMkLst>
            <pc:docMk/>
            <pc:sldMk cId="1578300178" sldId="260"/>
            <ac:spMk id="2" creationId="{414C1EAD-1695-5D69-E0CA-F4FB263C25FA}"/>
          </ac:spMkLst>
        </pc:spChg>
        <pc:spChg chg="add del mod">
          <ac:chgData name="Reza Amini Hounejani" userId="36cb0b73-58b2-4568-a1ab-00cd49301806" providerId="ADAL" clId="{DA8FEA81-1A63-884F-A1C6-520C766F400F}" dt="2022-09-16T15:01:52.331" v="2342" actId="478"/>
          <ac:spMkLst>
            <pc:docMk/>
            <pc:sldMk cId="1578300178" sldId="260"/>
            <ac:spMk id="2" creationId="{62113778-4E1F-2441-9485-62384F7EF8EA}"/>
          </ac:spMkLst>
        </pc:spChg>
        <pc:spChg chg="mod">
          <ac:chgData name="Reza Amini Hounejani" userId="36cb0b73-58b2-4568-a1ab-00cd49301806" providerId="ADAL" clId="{DA8FEA81-1A63-884F-A1C6-520C766F400F}" dt="2022-11-24T13:00:52.526" v="11825" actId="1036"/>
          <ac:spMkLst>
            <pc:docMk/>
            <pc:sldMk cId="1578300178" sldId="260"/>
            <ac:spMk id="3" creationId="{008E26B9-192E-8774-1FC9-8081C81DCAD4}"/>
          </ac:spMkLst>
        </pc:spChg>
        <pc:spChg chg="add del mod">
          <ac:chgData name="Reza Amini Hounejani" userId="36cb0b73-58b2-4568-a1ab-00cd49301806" providerId="ADAL" clId="{DA8FEA81-1A63-884F-A1C6-520C766F400F}" dt="2022-10-17T14:07:51.553" v="3461" actId="478"/>
          <ac:spMkLst>
            <pc:docMk/>
            <pc:sldMk cId="1578300178" sldId="260"/>
            <ac:spMk id="3" creationId="{3427B6AB-E9EA-CDB5-79A9-C8D12727F92A}"/>
          </ac:spMkLst>
        </pc:spChg>
        <pc:spChg chg="mod">
          <ac:chgData name="Reza Amini Hounejani" userId="36cb0b73-58b2-4568-a1ab-00cd49301806" providerId="ADAL" clId="{DA8FEA81-1A63-884F-A1C6-520C766F400F}" dt="2022-11-16T14:06:08.711" v="9373" actId="1076"/>
          <ac:spMkLst>
            <pc:docMk/>
            <pc:sldMk cId="1578300178" sldId="260"/>
            <ac:spMk id="5" creationId="{2C5D0E98-E0C9-E32E-03F9-C590E33230B9}"/>
          </ac:spMkLst>
        </pc:spChg>
        <pc:spChg chg="mod">
          <ac:chgData name="Reza Amini Hounejani" userId="36cb0b73-58b2-4568-a1ab-00cd49301806" providerId="ADAL" clId="{DA8FEA81-1A63-884F-A1C6-520C766F400F}" dt="2022-07-26T15:35:47.411" v="735" actId="1076"/>
          <ac:spMkLst>
            <pc:docMk/>
            <pc:sldMk cId="1578300178" sldId="260"/>
            <ac:spMk id="6" creationId="{2A8E23EB-B440-5B60-4125-5191CB01B5A0}"/>
          </ac:spMkLst>
        </pc:spChg>
        <pc:spChg chg="mod">
          <ac:chgData name="Reza Amini Hounejani" userId="36cb0b73-58b2-4568-a1ab-00cd49301806" providerId="ADAL" clId="{DA8FEA81-1A63-884F-A1C6-520C766F400F}" dt="2022-10-17T14:29:16.289" v="3584" actId="1076"/>
          <ac:spMkLst>
            <pc:docMk/>
            <pc:sldMk cId="1578300178" sldId="260"/>
            <ac:spMk id="7" creationId="{6C7691A5-AEF6-A81E-0170-F6A151022C46}"/>
          </ac:spMkLst>
        </pc:spChg>
        <pc:spChg chg="add del mod">
          <ac:chgData name="Reza Amini Hounejani" userId="36cb0b73-58b2-4568-a1ab-00cd49301806" providerId="ADAL" clId="{DA8FEA81-1A63-884F-A1C6-520C766F400F}" dt="2022-10-17T14:07:52.198" v="3462" actId="478"/>
          <ac:spMkLst>
            <pc:docMk/>
            <pc:sldMk cId="1578300178" sldId="260"/>
            <ac:spMk id="8" creationId="{237240E5-ABF4-80C1-8D64-6393B5762196}"/>
          </ac:spMkLst>
        </pc:spChg>
        <pc:spChg chg="mod">
          <ac:chgData name="Reza Amini Hounejani" userId="36cb0b73-58b2-4568-a1ab-00cd49301806" providerId="ADAL" clId="{DA8FEA81-1A63-884F-A1C6-520C766F400F}" dt="2022-11-24T12:59:51.299" v="11810" actId="1036"/>
          <ac:spMkLst>
            <pc:docMk/>
            <pc:sldMk cId="1578300178" sldId="260"/>
            <ac:spMk id="8" creationId="{8A034749-DE88-7C18-5D42-D9C96A9053E2}"/>
          </ac:spMkLst>
        </pc:spChg>
        <pc:spChg chg="mod">
          <ac:chgData name="Reza Amini Hounejani" userId="36cb0b73-58b2-4568-a1ab-00cd49301806" providerId="ADAL" clId="{DA8FEA81-1A63-884F-A1C6-520C766F400F}" dt="2022-11-24T13:01:02.938" v="11830" actId="1036"/>
          <ac:spMkLst>
            <pc:docMk/>
            <pc:sldMk cId="1578300178" sldId="260"/>
            <ac:spMk id="9" creationId="{B5E7B76D-2E2A-AB18-C1C0-A011F77C2B2C}"/>
          </ac:spMkLst>
        </pc:spChg>
        <pc:spChg chg="add del">
          <ac:chgData name="Reza Amini Hounejani" userId="36cb0b73-58b2-4568-a1ab-00cd49301806" providerId="ADAL" clId="{DA8FEA81-1A63-884F-A1C6-520C766F400F}" dt="2022-09-21T08:37:13.944" v="2887" actId="478"/>
          <ac:spMkLst>
            <pc:docMk/>
            <pc:sldMk cId="1578300178" sldId="260"/>
            <ac:spMk id="10" creationId="{15EC13BE-9E4D-BBF9-68C9-D22F67EE13EA}"/>
          </ac:spMkLst>
        </pc:spChg>
        <pc:spChg chg="del mod">
          <ac:chgData name="Reza Amini Hounejani" userId="36cb0b73-58b2-4568-a1ab-00cd49301806" providerId="ADAL" clId="{DA8FEA81-1A63-884F-A1C6-520C766F400F}" dt="2022-09-16T13:46:08.726" v="2339" actId="478"/>
          <ac:spMkLst>
            <pc:docMk/>
            <pc:sldMk cId="1578300178" sldId="260"/>
            <ac:spMk id="11" creationId="{62719C60-F237-F16B-74B1-88EFAA7CEB34}"/>
          </ac:spMkLst>
        </pc:spChg>
        <pc:spChg chg="add del mod topLvl">
          <ac:chgData name="Reza Amini Hounejani" userId="36cb0b73-58b2-4568-a1ab-00cd49301806" providerId="ADAL" clId="{DA8FEA81-1A63-884F-A1C6-520C766F400F}" dt="2022-11-23T13:06:11.867" v="10895" actId="478"/>
          <ac:spMkLst>
            <pc:docMk/>
            <pc:sldMk cId="1578300178" sldId="260"/>
            <ac:spMk id="12" creationId="{A0F863F2-38A7-F44D-BC27-EA1BD603B575}"/>
          </ac:spMkLst>
        </pc:spChg>
        <pc:spChg chg="mod">
          <ac:chgData name="Reza Amini Hounejani" userId="36cb0b73-58b2-4568-a1ab-00cd49301806" providerId="ADAL" clId="{DA8FEA81-1A63-884F-A1C6-520C766F400F}" dt="2022-09-16T13:46:03.395" v="2337"/>
          <ac:spMkLst>
            <pc:docMk/>
            <pc:sldMk cId="1578300178" sldId="260"/>
            <ac:spMk id="12" creationId="{D4056EA7-5764-9CD4-5B24-92155AAB4603}"/>
          </ac:spMkLst>
        </pc:spChg>
        <pc:spChg chg="mod">
          <ac:chgData name="Reza Amini Hounejani" userId="36cb0b73-58b2-4568-a1ab-00cd49301806" providerId="ADAL" clId="{DA8FEA81-1A63-884F-A1C6-520C766F400F}" dt="2022-11-24T13:01:09.295" v="11832" actId="1038"/>
          <ac:spMkLst>
            <pc:docMk/>
            <pc:sldMk cId="1578300178" sldId="260"/>
            <ac:spMk id="13" creationId="{46C081A2-D284-483E-4F77-DC13945AD93C}"/>
          </ac:spMkLst>
        </pc:spChg>
        <pc:spChg chg="mod">
          <ac:chgData name="Reza Amini Hounejani" userId="36cb0b73-58b2-4568-a1ab-00cd49301806" providerId="ADAL" clId="{DA8FEA81-1A63-884F-A1C6-520C766F400F}" dt="2022-09-16T13:46:03.395" v="2337"/>
          <ac:spMkLst>
            <pc:docMk/>
            <pc:sldMk cId="1578300178" sldId="260"/>
            <ac:spMk id="13" creationId="{52C3F0FB-1F8C-60B3-4D61-E6B52714BF17}"/>
          </ac:spMkLst>
        </pc:spChg>
        <pc:spChg chg="add mod">
          <ac:chgData name="Reza Amini Hounejani" userId="36cb0b73-58b2-4568-a1ab-00cd49301806" providerId="ADAL" clId="{DA8FEA81-1A63-884F-A1C6-520C766F400F}" dt="2022-09-16T15:05:43.699" v="2372" actId="571"/>
          <ac:spMkLst>
            <pc:docMk/>
            <pc:sldMk cId="1578300178" sldId="260"/>
            <ac:spMk id="13" creationId="{87B21BB9-FF71-8380-79D4-47403CB2669A}"/>
          </ac:spMkLst>
        </pc:spChg>
        <pc:spChg chg="add del">
          <ac:chgData name="Reza Amini Hounejani" userId="36cb0b73-58b2-4568-a1ab-00cd49301806" providerId="ADAL" clId="{DA8FEA81-1A63-884F-A1C6-520C766F400F}" dt="2022-09-21T08:37:54.934" v="2891" actId="478"/>
          <ac:spMkLst>
            <pc:docMk/>
            <pc:sldMk cId="1578300178" sldId="260"/>
            <ac:spMk id="13" creationId="{DE9EEDB0-42F0-676F-DFE6-96E46CFA6841}"/>
          </ac:spMkLst>
        </pc:spChg>
        <pc:spChg chg="add mod">
          <ac:chgData name="Reza Amini Hounejani" userId="36cb0b73-58b2-4568-a1ab-00cd49301806" providerId="ADAL" clId="{DA8FEA81-1A63-884F-A1C6-520C766F400F}" dt="2022-09-16T15:05:42.636" v="2371" actId="571"/>
          <ac:spMkLst>
            <pc:docMk/>
            <pc:sldMk cId="1578300178" sldId="260"/>
            <ac:spMk id="14" creationId="{22B3F0A8-7B13-2806-0CD5-F76D2D6853F2}"/>
          </ac:spMkLst>
        </pc:spChg>
        <pc:spChg chg="mod">
          <ac:chgData name="Reza Amini Hounejani" userId="36cb0b73-58b2-4568-a1ab-00cd49301806" providerId="ADAL" clId="{DA8FEA81-1A63-884F-A1C6-520C766F400F}" dt="2022-09-16T13:46:03.395" v="2337"/>
          <ac:spMkLst>
            <pc:docMk/>
            <pc:sldMk cId="1578300178" sldId="260"/>
            <ac:spMk id="14" creationId="{E471F58C-7C23-5C27-C9E4-C7E968CBF458}"/>
          </ac:spMkLst>
        </pc:spChg>
        <pc:spChg chg="add del mod">
          <ac:chgData name="Reza Amini Hounejani" userId="36cb0b73-58b2-4568-a1ab-00cd49301806" providerId="ADAL" clId="{DA8FEA81-1A63-884F-A1C6-520C766F400F}" dt="2022-09-21T08:38:56.797" v="2910" actId="478"/>
          <ac:spMkLst>
            <pc:docMk/>
            <pc:sldMk cId="1578300178" sldId="260"/>
            <ac:spMk id="14" creationId="{F118E8C6-DAF6-F0C5-245B-C47EDCF1283C}"/>
          </ac:spMkLst>
        </pc:spChg>
        <pc:spChg chg="mod">
          <ac:chgData name="Reza Amini Hounejani" userId="36cb0b73-58b2-4568-a1ab-00cd49301806" providerId="ADAL" clId="{DA8FEA81-1A63-884F-A1C6-520C766F400F}" dt="2022-09-16T13:46:03.395" v="2337"/>
          <ac:spMkLst>
            <pc:docMk/>
            <pc:sldMk cId="1578300178" sldId="260"/>
            <ac:spMk id="15" creationId="{184E5607-150F-00AB-A02A-7A7E58793C1F}"/>
          </ac:spMkLst>
        </pc:spChg>
        <pc:spChg chg="add mod">
          <ac:chgData name="Reza Amini Hounejani" userId="36cb0b73-58b2-4568-a1ab-00cd49301806" providerId="ADAL" clId="{DA8FEA81-1A63-884F-A1C6-520C766F400F}" dt="2022-09-16T15:05:42.188" v="2370" actId="571"/>
          <ac:spMkLst>
            <pc:docMk/>
            <pc:sldMk cId="1578300178" sldId="260"/>
            <ac:spMk id="15" creationId="{264D1BB8-7FBE-2278-B364-8839A76E0436}"/>
          </ac:spMkLst>
        </pc:spChg>
        <pc:spChg chg="add mod">
          <ac:chgData name="Reza Amini Hounejani" userId="36cb0b73-58b2-4568-a1ab-00cd49301806" providerId="ADAL" clId="{DA8FEA81-1A63-884F-A1C6-520C766F400F}" dt="2022-11-16T14:32:43.880" v="9544" actId="1036"/>
          <ac:spMkLst>
            <pc:docMk/>
            <pc:sldMk cId="1578300178" sldId="260"/>
            <ac:spMk id="15" creationId="{41676A1D-B17E-96C6-15E9-D98F1284E65A}"/>
          </ac:spMkLst>
        </pc:spChg>
        <pc:spChg chg="mod">
          <ac:chgData name="Reza Amini Hounejani" userId="36cb0b73-58b2-4568-a1ab-00cd49301806" providerId="ADAL" clId="{DA8FEA81-1A63-884F-A1C6-520C766F400F}" dt="2022-09-16T13:46:03.395" v="2337"/>
          <ac:spMkLst>
            <pc:docMk/>
            <pc:sldMk cId="1578300178" sldId="260"/>
            <ac:spMk id="16" creationId="{10E5D83E-9FCD-EF55-2545-34CB1524A43A}"/>
          </ac:spMkLst>
        </pc:spChg>
        <pc:spChg chg="add del mod topLvl">
          <ac:chgData name="Reza Amini Hounejani" userId="36cb0b73-58b2-4568-a1ab-00cd49301806" providerId="ADAL" clId="{DA8FEA81-1A63-884F-A1C6-520C766F400F}" dt="2022-11-23T13:06:10.983" v="10894" actId="478"/>
          <ac:spMkLst>
            <pc:docMk/>
            <pc:sldMk cId="1578300178" sldId="260"/>
            <ac:spMk id="16" creationId="{C8ABB884-8F2C-2277-CBA9-EB7A2F7BED74}"/>
          </ac:spMkLst>
        </pc:spChg>
        <pc:spChg chg="mod">
          <ac:chgData name="Reza Amini Hounejani" userId="36cb0b73-58b2-4568-a1ab-00cd49301806" providerId="ADAL" clId="{DA8FEA81-1A63-884F-A1C6-520C766F400F}" dt="2022-09-16T13:46:03.395" v="2337"/>
          <ac:spMkLst>
            <pc:docMk/>
            <pc:sldMk cId="1578300178" sldId="260"/>
            <ac:spMk id="17" creationId="{1D5FCCCC-D264-B2A3-9138-8C3B40A2E5E2}"/>
          </ac:spMkLst>
        </pc:spChg>
        <pc:spChg chg="add mod topLvl">
          <ac:chgData name="Reza Amini Hounejani" userId="36cb0b73-58b2-4568-a1ab-00cd49301806" providerId="ADAL" clId="{DA8FEA81-1A63-884F-A1C6-520C766F400F}" dt="2022-11-16T13:41:24.945" v="9344" actId="1076"/>
          <ac:spMkLst>
            <pc:docMk/>
            <pc:sldMk cId="1578300178" sldId="260"/>
            <ac:spMk id="17" creationId="{800548BB-6858-0DA6-05DE-91328253BEC8}"/>
          </ac:spMkLst>
        </pc:spChg>
        <pc:spChg chg="add del mod topLvl">
          <ac:chgData name="Reza Amini Hounejani" userId="36cb0b73-58b2-4568-a1ab-00cd49301806" providerId="ADAL" clId="{DA8FEA81-1A63-884F-A1C6-520C766F400F}" dt="2022-11-16T13:40:40.100" v="9320" actId="478"/>
          <ac:spMkLst>
            <pc:docMk/>
            <pc:sldMk cId="1578300178" sldId="260"/>
            <ac:spMk id="18" creationId="{62781C53-83EB-468A-4575-35A7B60D32C9}"/>
          </ac:spMkLst>
        </pc:spChg>
        <pc:spChg chg="add mod topLvl">
          <ac:chgData name="Reza Amini Hounejani" userId="36cb0b73-58b2-4568-a1ab-00cd49301806" providerId="ADAL" clId="{DA8FEA81-1A63-884F-A1C6-520C766F400F}" dt="2022-11-16T14:28:41.712" v="9500" actId="1076"/>
          <ac:spMkLst>
            <pc:docMk/>
            <pc:sldMk cId="1578300178" sldId="260"/>
            <ac:spMk id="19" creationId="{530C66ED-9A2D-F53E-8479-A054157E5EA1}"/>
          </ac:spMkLst>
        </pc:spChg>
        <pc:spChg chg="add del mod topLvl">
          <ac:chgData name="Reza Amini Hounejani" userId="36cb0b73-58b2-4568-a1ab-00cd49301806" providerId="ADAL" clId="{DA8FEA81-1A63-884F-A1C6-520C766F400F}" dt="2022-11-16T14:28:56.809" v="9506" actId="478"/>
          <ac:spMkLst>
            <pc:docMk/>
            <pc:sldMk cId="1578300178" sldId="260"/>
            <ac:spMk id="20" creationId="{45C2A43A-4CBA-1D40-6077-4EC0AD3E96BA}"/>
          </ac:spMkLst>
        </pc:spChg>
        <pc:spChg chg="add mod topLvl">
          <ac:chgData name="Reza Amini Hounejani" userId="36cb0b73-58b2-4568-a1ab-00cd49301806" providerId="ADAL" clId="{DA8FEA81-1A63-884F-A1C6-520C766F400F}" dt="2022-11-16T13:40:09.466" v="9310" actId="1076"/>
          <ac:spMkLst>
            <pc:docMk/>
            <pc:sldMk cId="1578300178" sldId="260"/>
            <ac:spMk id="21" creationId="{438CC62D-DE1F-F3D8-B1D3-C94D561BF87B}"/>
          </ac:spMkLst>
        </pc:spChg>
        <pc:spChg chg="mod">
          <ac:chgData name="Reza Amini Hounejani" userId="36cb0b73-58b2-4568-a1ab-00cd49301806" providerId="ADAL" clId="{DA8FEA81-1A63-884F-A1C6-520C766F400F}" dt="2022-11-16T14:32:25.835" v="9536" actId="14100"/>
          <ac:spMkLst>
            <pc:docMk/>
            <pc:sldMk cId="1578300178" sldId="260"/>
            <ac:spMk id="27" creationId="{DCAE6EE9-EFD9-31E9-3F9B-229275AAF5EA}"/>
          </ac:spMkLst>
        </pc:spChg>
        <pc:spChg chg="mod">
          <ac:chgData name="Reza Amini Hounejani" userId="36cb0b73-58b2-4568-a1ab-00cd49301806" providerId="ADAL" clId="{DA8FEA81-1A63-884F-A1C6-520C766F400F}" dt="2022-11-16T14:32:25.835" v="9536" actId="14100"/>
          <ac:spMkLst>
            <pc:docMk/>
            <pc:sldMk cId="1578300178" sldId="260"/>
            <ac:spMk id="28" creationId="{6A2109EA-DCEC-F550-72E8-64677F60F243}"/>
          </ac:spMkLst>
        </pc:spChg>
        <pc:spChg chg="mod">
          <ac:chgData name="Reza Amini Hounejani" userId="36cb0b73-58b2-4568-a1ab-00cd49301806" providerId="ADAL" clId="{DA8FEA81-1A63-884F-A1C6-520C766F400F}" dt="2022-11-16T14:32:25.835" v="9536" actId="14100"/>
          <ac:spMkLst>
            <pc:docMk/>
            <pc:sldMk cId="1578300178" sldId="260"/>
            <ac:spMk id="29" creationId="{A542E066-6591-9635-D85E-537D4F8853F3}"/>
          </ac:spMkLst>
        </pc:spChg>
        <pc:spChg chg="mod">
          <ac:chgData name="Reza Amini Hounejani" userId="36cb0b73-58b2-4568-a1ab-00cd49301806" providerId="ADAL" clId="{DA8FEA81-1A63-884F-A1C6-520C766F400F}" dt="2022-11-16T14:32:25.835" v="9536" actId="14100"/>
          <ac:spMkLst>
            <pc:docMk/>
            <pc:sldMk cId="1578300178" sldId="260"/>
            <ac:spMk id="30" creationId="{6CFBE1C6-1328-F57A-686E-D2B2BF6059DB}"/>
          </ac:spMkLst>
        </pc:spChg>
        <pc:spChg chg="mod">
          <ac:chgData name="Reza Amini Hounejani" userId="36cb0b73-58b2-4568-a1ab-00cd49301806" providerId="ADAL" clId="{DA8FEA81-1A63-884F-A1C6-520C766F400F}" dt="2022-11-16T14:32:25.835" v="9536" actId="14100"/>
          <ac:spMkLst>
            <pc:docMk/>
            <pc:sldMk cId="1578300178" sldId="260"/>
            <ac:spMk id="31" creationId="{5FE4141A-8725-3268-4F39-9C683A5410DF}"/>
          </ac:spMkLst>
        </pc:spChg>
        <pc:spChg chg="mod">
          <ac:chgData name="Reza Amini Hounejani" userId="36cb0b73-58b2-4568-a1ab-00cd49301806" providerId="ADAL" clId="{DA8FEA81-1A63-884F-A1C6-520C766F400F}" dt="2022-11-16T14:32:25.835" v="9536" actId="14100"/>
          <ac:spMkLst>
            <pc:docMk/>
            <pc:sldMk cId="1578300178" sldId="260"/>
            <ac:spMk id="32" creationId="{69A2571B-4FB0-343B-5E84-84C2C414BBEA}"/>
          </ac:spMkLst>
        </pc:spChg>
        <pc:spChg chg="mod">
          <ac:chgData name="Reza Amini Hounejani" userId="36cb0b73-58b2-4568-a1ab-00cd49301806" providerId="ADAL" clId="{DA8FEA81-1A63-884F-A1C6-520C766F400F}" dt="2022-09-21T08:39:16.817" v="2912" actId="12789"/>
          <ac:spMkLst>
            <pc:docMk/>
            <pc:sldMk cId="1578300178" sldId="260"/>
            <ac:spMk id="34" creationId="{3CA9AD51-F21F-7BBC-2797-C9C5441FE882}"/>
          </ac:spMkLst>
        </pc:spChg>
        <pc:spChg chg="mod">
          <ac:chgData name="Reza Amini Hounejani" userId="36cb0b73-58b2-4568-a1ab-00cd49301806" providerId="ADAL" clId="{DA8FEA81-1A63-884F-A1C6-520C766F400F}" dt="2022-09-21T08:39:45.574" v="2915" actId="554"/>
          <ac:spMkLst>
            <pc:docMk/>
            <pc:sldMk cId="1578300178" sldId="260"/>
            <ac:spMk id="35" creationId="{73DC7CE9-C568-F0B3-8D69-3D8C944265AC}"/>
          </ac:spMkLst>
        </pc:spChg>
        <pc:spChg chg="mod">
          <ac:chgData name="Reza Amini Hounejani" userId="36cb0b73-58b2-4568-a1ab-00cd49301806" providerId="ADAL" clId="{DA8FEA81-1A63-884F-A1C6-520C766F400F}" dt="2022-09-21T08:39:40.304" v="2914" actId="555"/>
          <ac:spMkLst>
            <pc:docMk/>
            <pc:sldMk cId="1578300178" sldId="260"/>
            <ac:spMk id="36" creationId="{4ED63D0A-7248-C402-75A1-D0FC9DF7BB7B}"/>
          </ac:spMkLst>
        </pc:spChg>
        <pc:spChg chg="mod">
          <ac:chgData name="Reza Amini Hounejani" userId="36cb0b73-58b2-4568-a1ab-00cd49301806" providerId="ADAL" clId="{DA8FEA81-1A63-884F-A1C6-520C766F400F}" dt="2022-09-21T08:39:16.817" v="2912" actId="12789"/>
          <ac:spMkLst>
            <pc:docMk/>
            <pc:sldMk cId="1578300178" sldId="260"/>
            <ac:spMk id="37" creationId="{21993026-13F9-9D8C-62D0-3BD71DCB4DDF}"/>
          </ac:spMkLst>
        </pc:spChg>
        <pc:spChg chg="mod">
          <ac:chgData name="Reza Amini Hounejani" userId="36cb0b73-58b2-4568-a1ab-00cd49301806" providerId="ADAL" clId="{DA8FEA81-1A63-884F-A1C6-520C766F400F}" dt="2022-09-21T08:39:55.081" v="2916" actId="1037"/>
          <ac:spMkLst>
            <pc:docMk/>
            <pc:sldMk cId="1578300178" sldId="260"/>
            <ac:spMk id="38" creationId="{EE042C2D-6559-90F2-F288-B96F8AF067B5}"/>
          </ac:spMkLst>
        </pc:spChg>
        <pc:spChg chg="mod">
          <ac:chgData name="Reza Amini Hounejani" userId="36cb0b73-58b2-4568-a1ab-00cd49301806" providerId="ADAL" clId="{DA8FEA81-1A63-884F-A1C6-520C766F400F}" dt="2022-09-21T08:39:40.304" v="2914" actId="555"/>
          <ac:spMkLst>
            <pc:docMk/>
            <pc:sldMk cId="1578300178" sldId="260"/>
            <ac:spMk id="39" creationId="{9A5C63BB-4012-3431-DCD8-9739E541F9A2}"/>
          </ac:spMkLst>
        </pc:spChg>
        <pc:spChg chg="mod">
          <ac:chgData name="Reza Amini Hounejani" userId="36cb0b73-58b2-4568-a1ab-00cd49301806" providerId="ADAL" clId="{DA8FEA81-1A63-884F-A1C6-520C766F400F}" dt="2022-09-21T08:39:45.574" v="2915" actId="554"/>
          <ac:spMkLst>
            <pc:docMk/>
            <pc:sldMk cId="1578300178" sldId="260"/>
            <ac:spMk id="40" creationId="{7AA25998-8728-424F-091E-C9C72D1DA802}"/>
          </ac:spMkLst>
        </pc:spChg>
        <pc:spChg chg="del mod">
          <ac:chgData name="Reza Amini Hounejani" userId="36cb0b73-58b2-4568-a1ab-00cd49301806" providerId="ADAL" clId="{DA8FEA81-1A63-884F-A1C6-520C766F400F}" dt="2022-11-16T13:07:04.022" v="9290" actId="478"/>
          <ac:spMkLst>
            <pc:docMk/>
            <pc:sldMk cId="1578300178" sldId="260"/>
            <ac:spMk id="41" creationId="{A32D5EB0-28F2-837E-5DB6-534B3492C171}"/>
          </ac:spMkLst>
        </pc:spChg>
        <pc:spChg chg="del mod">
          <ac:chgData name="Reza Amini Hounejani" userId="36cb0b73-58b2-4568-a1ab-00cd49301806" providerId="ADAL" clId="{DA8FEA81-1A63-884F-A1C6-520C766F400F}" dt="2022-11-16T13:07:00.817" v="9289" actId="478"/>
          <ac:spMkLst>
            <pc:docMk/>
            <pc:sldMk cId="1578300178" sldId="260"/>
            <ac:spMk id="44" creationId="{8191AFA7-1710-152C-F916-E2AB2000A20C}"/>
          </ac:spMkLst>
        </pc:spChg>
        <pc:spChg chg="mod">
          <ac:chgData name="Reza Amini Hounejani" userId="36cb0b73-58b2-4568-a1ab-00cd49301806" providerId="ADAL" clId="{DA8FEA81-1A63-884F-A1C6-520C766F400F}" dt="2022-11-16T14:31:35.930" v="9531" actId="14100"/>
          <ac:spMkLst>
            <pc:docMk/>
            <pc:sldMk cId="1578300178" sldId="260"/>
            <ac:spMk id="46" creationId="{98521A9E-576D-59D4-EC81-17691428EC0A}"/>
          </ac:spMkLst>
        </pc:spChg>
        <pc:spChg chg="mod">
          <ac:chgData name="Reza Amini Hounejani" userId="36cb0b73-58b2-4568-a1ab-00cd49301806" providerId="ADAL" clId="{DA8FEA81-1A63-884F-A1C6-520C766F400F}" dt="2022-11-16T13:06:48.604" v="9287" actId="571"/>
          <ac:spMkLst>
            <pc:docMk/>
            <pc:sldMk cId="1578300178" sldId="260"/>
            <ac:spMk id="60" creationId="{CD46462E-9DF5-3F07-02D9-67B7D31E170C}"/>
          </ac:spMkLst>
        </pc:spChg>
        <pc:spChg chg="mod">
          <ac:chgData name="Reza Amini Hounejani" userId="36cb0b73-58b2-4568-a1ab-00cd49301806" providerId="ADAL" clId="{DA8FEA81-1A63-884F-A1C6-520C766F400F}" dt="2022-11-16T13:06:48.604" v="9287" actId="571"/>
          <ac:spMkLst>
            <pc:docMk/>
            <pc:sldMk cId="1578300178" sldId="260"/>
            <ac:spMk id="61" creationId="{FAADCAEF-0B28-9251-1819-1EFEDE4AB724}"/>
          </ac:spMkLst>
        </pc:spChg>
        <pc:spChg chg="mod">
          <ac:chgData name="Reza Amini Hounejani" userId="36cb0b73-58b2-4568-a1ab-00cd49301806" providerId="ADAL" clId="{DA8FEA81-1A63-884F-A1C6-520C766F400F}" dt="2022-11-16T13:06:48.604" v="9287" actId="571"/>
          <ac:spMkLst>
            <pc:docMk/>
            <pc:sldMk cId="1578300178" sldId="260"/>
            <ac:spMk id="62" creationId="{AD4E210B-7E6E-4DE0-CBAF-067F14659DF4}"/>
          </ac:spMkLst>
        </pc:spChg>
        <pc:spChg chg="add mod">
          <ac:chgData name="Reza Amini Hounejani" userId="36cb0b73-58b2-4568-a1ab-00cd49301806" providerId="ADAL" clId="{DA8FEA81-1A63-884F-A1C6-520C766F400F}" dt="2022-11-24T13:06:05.464" v="11857" actId="1076"/>
          <ac:spMkLst>
            <pc:docMk/>
            <pc:sldMk cId="1578300178" sldId="260"/>
            <ac:spMk id="63" creationId="{0E8F94DF-E45B-44CE-99DD-7812ABE3862C}"/>
          </ac:spMkLst>
        </pc:spChg>
        <pc:spChg chg="del mod">
          <ac:chgData name="Reza Amini Hounejani" userId="36cb0b73-58b2-4568-a1ab-00cd49301806" providerId="ADAL" clId="{DA8FEA81-1A63-884F-A1C6-520C766F400F}" dt="2022-11-16T14:23:21.200" v="9398" actId="478"/>
          <ac:spMkLst>
            <pc:docMk/>
            <pc:sldMk cId="1578300178" sldId="260"/>
            <ac:spMk id="63" creationId="{4002EBEE-09FC-5BBE-FE43-79E60FAB8F75}"/>
          </ac:spMkLst>
        </pc:spChg>
        <pc:spChg chg="mod">
          <ac:chgData name="Reza Amini Hounejani" userId="36cb0b73-58b2-4568-a1ab-00cd49301806" providerId="ADAL" clId="{DA8FEA81-1A63-884F-A1C6-520C766F400F}" dt="2022-11-16T14:23:38.864" v="9413" actId="1037"/>
          <ac:spMkLst>
            <pc:docMk/>
            <pc:sldMk cId="1578300178" sldId="260"/>
            <ac:spMk id="64" creationId="{FF5879AE-CDEB-5CE9-14BD-4C782CC38F26}"/>
          </ac:spMkLst>
        </pc:spChg>
        <pc:spChg chg="mod">
          <ac:chgData name="Reza Amini Hounejani" userId="36cb0b73-58b2-4568-a1ab-00cd49301806" providerId="ADAL" clId="{DA8FEA81-1A63-884F-A1C6-520C766F400F}" dt="2022-11-16T14:23:28.962" v="9404" actId="1037"/>
          <ac:spMkLst>
            <pc:docMk/>
            <pc:sldMk cId="1578300178" sldId="260"/>
            <ac:spMk id="65" creationId="{36D1D954-E215-F3FE-5C5D-D9946C100DF6}"/>
          </ac:spMkLst>
        </pc:spChg>
        <pc:spChg chg="add mod">
          <ac:chgData name="Reza Amini Hounejani" userId="36cb0b73-58b2-4568-a1ab-00cd49301806" providerId="ADAL" clId="{DA8FEA81-1A63-884F-A1C6-520C766F400F}" dt="2022-11-24T13:01:45.216" v="11837" actId="571"/>
          <ac:spMkLst>
            <pc:docMk/>
            <pc:sldMk cId="1578300178" sldId="260"/>
            <ac:spMk id="66" creationId="{2DA70C5D-4C2B-F60F-FE2A-87B907B232F6}"/>
          </ac:spMkLst>
        </pc:spChg>
        <pc:spChg chg="del mod">
          <ac:chgData name="Reza Amini Hounejani" userId="36cb0b73-58b2-4568-a1ab-00cd49301806" providerId="ADAL" clId="{DA8FEA81-1A63-884F-A1C6-520C766F400F}" dt="2022-11-16T14:23:23.384" v="9399" actId="478"/>
          <ac:spMkLst>
            <pc:docMk/>
            <pc:sldMk cId="1578300178" sldId="260"/>
            <ac:spMk id="66" creationId="{537E4846-648A-F48B-6688-6F19D860FE62}"/>
          </ac:spMkLst>
        </pc:spChg>
        <pc:spChg chg="add mod">
          <ac:chgData name="Reza Amini Hounejani" userId="36cb0b73-58b2-4568-a1ab-00cd49301806" providerId="ADAL" clId="{DA8FEA81-1A63-884F-A1C6-520C766F400F}" dt="2022-11-24T13:08:09.077" v="11867" actId="1076"/>
          <ac:spMkLst>
            <pc:docMk/>
            <pc:sldMk cId="1578300178" sldId="260"/>
            <ac:spMk id="67" creationId="{6B0C4AF9-B38C-A528-D0D9-4B4E7CBEC4DF}"/>
          </ac:spMkLst>
        </pc:spChg>
        <pc:spChg chg="add mod">
          <ac:chgData name="Reza Amini Hounejani" userId="36cb0b73-58b2-4568-a1ab-00cd49301806" providerId="ADAL" clId="{DA8FEA81-1A63-884F-A1C6-520C766F400F}" dt="2022-11-24T13:05:58.280" v="11854" actId="1076"/>
          <ac:spMkLst>
            <pc:docMk/>
            <pc:sldMk cId="1578300178" sldId="260"/>
            <ac:spMk id="68" creationId="{DBDB680E-C463-A96B-FD26-951D642B4946}"/>
          </ac:spMkLst>
        </pc:spChg>
        <pc:spChg chg="add mod">
          <ac:chgData name="Reza Amini Hounejani" userId="36cb0b73-58b2-4568-a1ab-00cd49301806" providerId="ADAL" clId="{DA8FEA81-1A63-884F-A1C6-520C766F400F}" dt="2022-11-24T13:07:56.300" v="11866" actId="571"/>
          <ac:spMkLst>
            <pc:docMk/>
            <pc:sldMk cId="1578300178" sldId="260"/>
            <ac:spMk id="69" creationId="{69ED12F2-79FD-9708-B3BD-F723516BF512}"/>
          </ac:spMkLst>
        </pc:spChg>
        <pc:spChg chg="add mod">
          <ac:chgData name="Reza Amini Hounejani" userId="36cb0b73-58b2-4568-a1ab-00cd49301806" providerId="ADAL" clId="{DA8FEA81-1A63-884F-A1C6-520C766F400F}" dt="2022-11-24T13:00:59.947" v="11828" actId="1036"/>
          <ac:spMkLst>
            <pc:docMk/>
            <pc:sldMk cId="1578300178" sldId="260"/>
            <ac:spMk id="77" creationId="{DBFA2A50-DA58-23C5-B051-410E4D0F5600}"/>
          </ac:spMkLst>
        </pc:spChg>
        <pc:spChg chg="add mod">
          <ac:chgData name="Reza Amini Hounejani" userId="36cb0b73-58b2-4568-a1ab-00cd49301806" providerId="ADAL" clId="{DA8FEA81-1A63-884F-A1C6-520C766F400F}" dt="2022-11-16T14:31:35.930" v="9531" actId="14100"/>
          <ac:spMkLst>
            <pc:docMk/>
            <pc:sldMk cId="1578300178" sldId="260"/>
            <ac:spMk id="78" creationId="{7BDADEBE-8D5F-BED3-5C51-2736DC4DC563}"/>
          </ac:spMkLst>
        </pc:spChg>
        <pc:spChg chg="mod topLvl">
          <ac:chgData name="Reza Amini Hounejani" userId="36cb0b73-58b2-4568-a1ab-00cd49301806" providerId="ADAL" clId="{DA8FEA81-1A63-884F-A1C6-520C766F400F}" dt="2022-10-17T14:25:25.795" v="3583" actId="164"/>
          <ac:spMkLst>
            <pc:docMk/>
            <pc:sldMk cId="1578300178" sldId="260"/>
            <ac:spMk id="79" creationId="{C1F57F28-36DB-A420-7147-7503463A2A89}"/>
          </ac:spMkLst>
        </pc:spChg>
        <pc:spChg chg="mod topLvl">
          <ac:chgData name="Reza Amini Hounejani" userId="36cb0b73-58b2-4568-a1ab-00cd49301806" providerId="ADAL" clId="{DA8FEA81-1A63-884F-A1C6-520C766F400F}" dt="2022-10-18T09:14:15.821" v="4014" actId="20577"/>
          <ac:spMkLst>
            <pc:docMk/>
            <pc:sldMk cId="1578300178" sldId="260"/>
            <ac:spMk id="80" creationId="{0DEF2151-470A-BE79-6946-51D35C46D6F2}"/>
          </ac:spMkLst>
        </pc:spChg>
        <pc:spChg chg="add mod">
          <ac:chgData name="Reza Amini Hounejani" userId="36cb0b73-58b2-4568-a1ab-00cd49301806" providerId="ADAL" clId="{DA8FEA81-1A63-884F-A1C6-520C766F400F}" dt="2022-11-16T14:24:39.116" v="9462" actId="1037"/>
          <ac:spMkLst>
            <pc:docMk/>
            <pc:sldMk cId="1578300178" sldId="260"/>
            <ac:spMk id="81" creationId="{CEE0CDC1-4AB9-D36F-9BDB-A734D4C26D2D}"/>
          </ac:spMkLst>
        </pc:spChg>
        <pc:spChg chg="mod topLvl">
          <ac:chgData name="Reza Amini Hounejani" userId="36cb0b73-58b2-4568-a1ab-00cd49301806" providerId="ADAL" clId="{DA8FEA81-1A63-884F-A1C6-520C766F400F}" dt="2022-10-17T14:25:25.795" v="3583" actId="164"/>
          <ac:spMkLst>
            <pc:docMk/>
            <pc:sldMk cId="1578300178" sldId="260"/>
            <ac:spMk id="82" creationId="{0F740824-E22D-9756-D207-4EB9D83C3903}"/>
          </ac:spMkLst>
        </pc:spChg>
        <pc:spChg chg="mod topLvl">
          <ac:chgData name="Reza Amini Hounejani" userId="36cb0b73-58b2-4568-a1ab-00cd49301806" providerId="ADAL" clId="{DA8FEA81-1A63-884F-A1C6-520C766F400F}" dt="2022-10-17T14:25:25.795" v="3583" actId="164"/>
          <ac:spMkLst>
            <pc:docMk/>
            <pc:sldMk cId="1578300178" sldId="260"/>
            <ac:spMk id="84" creationId="{CCDE919E-FE4F-D09B-EA8B-F423F46B0BC6}"/>
          </ac:spMkLst>
        </pc:spChg>
        <pc:spChg chg="del mod topLvl">
          <ac:chgData name="Reza Amini Hounejani" userId="36cb0b73-58b2-4568-a1ab-00cd49301806" providerId="ADAL" clId="{DA8FEA81-1A63-884F-A1C6-520C766F400F}" dt="2022-11-16T13:40:20.779" v="9311" actId="478"/>
          <ac:spMkLst>
            <pc:docMk/>
            <pc:sldMk cId="1578300178" sldId="260"/>
            <ac:spMk id="87" creationId="{86946B89-C04A-E701-1D03-2580FC2EB90A}"/>
          </ac:spMkLst>
        </pc:spChg>
        <pc:spChg chg="del mod topLvl">
          <ac:chgData name="Reza Amini Hounejani" userId="36cb0b73-58b2-4568-a1ab-00cd49301806" providerId="ADAL" clId="{DA8FEA81-1A63-884F-A1C6-520C766F400F}" dt="2022-11-16T13:40:25.245" v="9312" actId="478"/>
          <ac:spMkLst>
            <pc:docMk/>
            <pc:sldMk cId="1578300178" sldId="260"/>
            <ac:spMk id="88" creationId="{4AA1481B-7BC9-923E-95D2-AA45A176821C}"/>
          </ac:spMkLst>
        </pc:spChg>
        <pc:spChg chg="del mod topLvl">
          <ac:chgData name="Reza Amini Hounejani" userId="36cb0b73-58b2-4568-a1ab-00cd49301806" providerId="ADAL" clId="{DA8FEA81-1A63-884F-A1C6-520C766F400F}" dt="2022-09-16T15:08:32.389" v="2398" actId="478"/>
          <ac:spMkLst>
            <pc:docMk/>
            <pc:sldMk cId="1578300178" sldId="260"/>
            <ac:spMk id="89" creationId="{B104FFF0-4730-31E2-CBCC-562C81813881}"/>
          </ac:spMkLst>
        </pc:spChg>
        <pc:spChg chg="mod topLvl">
          <ac:chgData name="Reza Amini Hounejani" userId="36cb0b73-58b2-4568-a1ab-00cd49301806" providerId="ADAL" clId="{DA8FEA81-1A63-884F-A1C6-520C766F400F}" dt="2022-11-16T14:29:29.124" v="9517" actId="20577"/>
          <ac:spMkLst>
            <pc:docMk/>
            <pc:sldMk cId="1578300178" sldId="260"/>
            <ac:spMk id="90" creationId="{2B7D3EA7-173D-F3E3-B0A2-48B44AB4292C}"/>
          </ac:spMkLst>
        </pc:spChg>
        <pc:spChg chg="mod topLvl">
          <ac:chgData name="Reza Amini Hounejani" userId="36cb0b73-58b2-4568-a1ab-00cd49301806" providerId="ADAL" clId="{DA8FEA81-1A63-884F-A1C6-520C766F400F}" dt="2022-11-16T14:29:31.136" v="9519" actId="20577"/>
          <ac:spMkLst>
            <pc:docMk/>
            <pc:sldMk cId="1578300178" sldId="260"/>
            <ac:spMk id="91" creationId="{9E15DB25-B5AA-9F5E-0208-A68F96CEF87A}"/>
          </ac:spMkLst>
        </pc:spChg>
        <pc:spChg chg="mod topLvl">
          <ac:chgData name="Reza Amini Hounejani" userId="36cb0b73-58b2-4568-a1ab-00cd49301806" providerId="ADAL" clId="{DA8FEA81-1A63-884F-A1C6-520C766F400F}" dt="2022-11-16T14:29:33.822" v="9521" actId="20577"/>
          <ac:spMkLst>
            <pc:docMk/>
            <pc:sldMk cId="1578300178" sldId="260"/>
            <ac:spMk id="92" creationId="{DA4A5B26-0763-1159-0D34-3A4359088715}"/>
          </ac:spMkLst>
        </pc:spChg>
        <pc:spChg chg="del mod topLvl">
          <ac:chgData name="Reza Amini Hounejani" userId="36cb0b73-58b2-4568-a1ab-00cd49301806" providerId="ADAL" clId="{DA8FEA81-1A63-884F-A1C6-520C766F400F}" dt="2022-09-16T15:08:32.389" v="2398" actId="478"/>
          <ac:spMkLst>
            <pc:docMk/>
            <pc:sldMk cId="1578300178" sldId="260"/>
            <ac:spMk id="93" creationId="{9F635B4C-33DC-12D0-D687-5FC803CE2CB0}"/>
          </ac:spMkLst>
        </pc:spChg>
        <pc:spChg chg="mod topLvl">
          <ac:chgData name="Reza Amini Hounejani" userId="36cb0b73-58b2-4568-a1ab-00cd49301806" providerId="ADAL" clId="{DA8FEA81-1A63-884F-A1C6-520C766F400F}" dt="2022-11-16T14:29:36.375" v="9523" actId="20577"/>
          <ac:spMkLst>
            <pc:docMk/>
            <pc:sldMk cId="1578300178" sldId="260"/>
            <ac:spMk id="94" creationId="{34573D3E-377B-2B17-17C9-09DFB66356EA}"/>
          </ac:spMkLst>
        </pc:spChg>
        <pc:spChg chg="add mod">
          <ac:chgData name="Reza Amini Hounejani" userId="36cb0b73-58b2-4568-a1ab-00cd49301806" providerId="ADAL" clId="{DA8FEA81-1A63-884F-A1C6-520C766F400F}" dt="2022-09-21T09:44:50.881" v="3000" actId="14100"/>
          <ac:spMkLst>
            <pc:docMk/>
            <pc:sldMk cId="1578300178" sldId="260"/>
            <ac:spMk id="96" creationId="{2F3B068E-92F4-9335-384D-42385CCD0CC3}"/>
          </ac:spMkLst>
        </pc:spChg>
        <pc:spChg chg="del mod topLvl">
          <ac:chgData name="Reza Amini Hounejani" userId="36cb0b73-58b2-4568-a1ab-00cd49301806" providerId="ADAL" clId="{DA8FEA81-1A63-884F-A1C6-520C766F400F}" dt="2022-11-16T14:28:45.547" v="9502" actId="478"/>
          <ac:spMkLst>
            <pc:docMk/>
            <pc:sldMk cId="1578300178" sldId="260"/>
            <ac:spMk id="97" creationId="{38B55CB9-2207-1602-11AA-0F7A06E8B55C}"/>
          </ac:spMkLst>
        </pc:spChg>
        <pc:spChg chg="add mod">
          <ac:chgData name="Reza Amini Hounejani" userId="36cb0b73-58b2-4568-a1ab-00cd49301806" providerId="ADAL" clId="{DA8FEA81-1A63-884F-A1C6-520C766F400F}" dt="2022-09-21T11:35:29.829" v="3122" actId="1076"/>
          <ac:spMkLst>
            <pc:docMk/>
            <pc:sldMk cId="1578300178" sldId="260"/>
            <ac:spMk id="98" creationId="{B8CB5601-7207-9412-2E93-539A3B941F2B}"/>
          </ac:spMkLst>
        </pc:spChg>
        <pc:spChg chg="add mod">
          <ac:chgData name="Reza Amini Hounejani" userId="36cb0b73-58b2-4568-a1ab-00cd49301806" providerId="ADAL" clId="{DA8FEA81-1A63-884F-A1C6-520C766F400F}" dt="2022-09-21T10:50:11.572" v="3071" actId="553"/>
          <ac:spMkLst>
            <pc:docMk/>
            <pc:sldMk cId="1578300178" sldId="260"/>
            <ac:spMk id="100" creationId="{FC199E83-662B-A6D4-5CD0-B45C1235971D}"/>
          </ac:spMkLst>
        </pc:spChg>
        <pc:spChg chg="add mod">
          <ac:chgData name="Reza Amini Hounejani" userId="36cb0b73-58b2-4568-a1ab-00cd49301806" providerId="ADAL" clId="{DA8FEA81-1A63-884F-A1C6-520C766F400F}" dt="2022-09-21T11:07:20.212" v="3081" actId="20577"/>
          <ac:spMkLst>
            <pc:docMk/>
            <pc:sldMk cId="1578300178" sldId="260"/>
            <ac:spMk id="101" creationId="{5A361756-16EB-2ADA-C4FC-DACF0D6C4763}"/>
          </ac:spMkLst>
        </pc:spChg>
        <pc:spChg chg="add mod">
          <ac:chgData name="Reza Amini Hounejani" userId="36cb0b73-58b2-4568-a1ab-00cd49301806" providerId="ADAL" clId="{DA8FEA81-1A63-884F-A1C6-520C766F400F}" dt="2022-11-16T14:24:39.116" v="9462" actId="1037"/>
          <ac:spMkLst>
            <pc:docMk/>
            <pc:sldMk cId="1578300178" sldId="260"/>
            <ac:spMk id="103" creationId="{8FF58A74-B754-300D-07EB-701BC820E7B1}"/>
          </ac:spMkLst>
        </pc:spChg>
        <pc:spChg chg="add mod">
          <ac:chgData name="Reza Amini Hounejani" userId="36cb0b73-58b2-4568-a1ab-00cd49301806" providerId="ADAL" clId="{DA8FEA81-1A63-884F-A1C6-520C766F400F}" dt="2022-11-16T14:32:43.880" v="9544" actId="1036"/>
          <ac:spMkLst>
            <pc:docMk/>
            <pc:sldMk cId="1578300178" sldId="260"/>
            <ac:spMk id="106" creationId="{A7E829E4-C1DF-4DE1-B21D-3DE3FACA5F7F}"/>
          </ac:spMkLst>
        </pc:spChg>
        <pc:spChg chg="add del mod">
          <ac:chgData name="Reza Amini Hounejani" userId="36cb0b73-58b2-4568-a1ab-00cd49301806" providerId="ADAL" clId="{DA8FEA81-1A63-884F-A1C6-520C766F400F}" dt="2022-11-24T13:01:28.435" v="11833" actId="478"/>
          <ac:spMkLst>
            <pc:docMk/>
            <pc:sldMk cId="1578300178" sldId="260"/>
            <ac:spMk id="108" creationId="{9C66BCC0-8A53-DD44-BA68-0D11154EA063}"/>
          </ac:spMkLst>
        </pc:spChg>
        <pc:spChg chg="add del mod">
          <ac:chgData name="Reza Amini Hounejani" userId="36cb0b73-58b2-4568-a1ab-00cd49301806" providerId="ADAL" clId="{DA8FEA81-1A63-884F-A1C6-520C766F400F}" dt="2022-11-25T13:04:24.876" v="11868" actId="478"/>
          <ac:spMkLst>
            <pc:docMk/>
            <pc:sldMk cId="1578300178" sldId="260"/>
            <ac:spMk id="109" creationId="{6EF7CCCB-3AB0-2EA5-E3B8-1B3F549F9269}"/>
          </ac:spMkLst>
        </pc:spChg>
        <pc:spChg chg="add mod">
          <ac:chgData name="Reza Amini Hounejani" userId="36cb0b73-58b2-4568-a1ab-00cd49301806" providerId="ADAL" clId="{DA8FEA81-1A63-884F-A1C6-520C766F400F}" dt="2022-11-16T14:24:39.116" v="9462" actId="1037"/>
          <ac:spMkLst>
            <pc:docMk/>
            <pc:sldMk cId="1578300178" sldId="260"/>
            <ac:spMk id="110" creationId="{339FE3F8-820F-A962-FAFD-1D948FF556D3}"/>
          </ac:spMkLst>
        </pc:spChg>
        <pc:spChg chg="add mod">
          <ac:chgData name="Reza Amini Hounejani" userId="36cb0b73-58b2-4568-a1ab-00cd49301806" providerId="ADAL" clId="{DA8FEA81-1A63-884F-A1C6-520C766F400F}" dt="2022-11-16T14:32:43.880" v="9544" actId="1036"/>
          <ac:spMkLst>
            <pc:docMk/>
            <pc:sldMk cId="1578300178" sldId="260"/>
            <ac:spMk id="111" creationId="{22811382-9EDA-7A93-8D87-174565685876}"/>
          </ac:spMkLst>
        </pc:spChg>
        <pc:spChg chg="add mod">
          <ac:chgData name="Reza Amini Hounejani" userId="36cb0b73-58b2-4568-a1ab-00cd49301806" providerId="ADAL" clId="{DA8FEA81-1A63-884F-A1C6-520C766F400F}" dt="2022-11-16T15:47:31.048" v="9694" actId="1035"/>
          <ac:spMkLst>
            <pc:docMk/>
            <pc:sldMk cId="1578300178" sldId="260"/>
            <ac:spMk id="113" creationId="{03C5566C-1327-F148-06B5-D2F3244C74AA}"/>
          </ac:spMkLst>
        </pc:spChg>
        <pc:spChg chg="add mod">
          <ac:chgData name="Reza Amini Hounejani" userId="36cb0b73-58b2-4568-a1ab-00cd49301806" providerId="ADAL" clId="{DA8FEA81-1A63-884F-A1C6-520C766F400F}" dt="2022-11-16T15:47:11.420" v="9689" actId="554"/>
          <ac:spMkLst>
            <pc:docMk/>
            <pc:sldMk cId="1578300178" sldId="260"/>
            <ac:spMk id="114" creationId="{5DE2DB46-4680-7B0F-88C0-3E9F78811CF1}"/>
          </ac:spMkLst>
        </pc:spChg>
        <pc:spChg chg="add mod">
          <ac:chgData name="Reza Amini Hounejani" userId="36cb0b73-58b2-4568-a1ab-00cd49301806" providerId="ADAL" clId="{DA8FEA81-1A63-884F-A1C6-520C766F400F}" dt="2022-11-16T14:32:43.880" v="9544" actId="1036"/>
          <ac:spMkLst>
            <pc:docMk/>
            <pc:sldMk cId="1578300178" sldId="260"/>
            <ac:spMk id="117" creationId="{9D3C1A8A-534F-744E-1480-7DDD26C71F4B}"/>
          </ac:spMkLst>
        </pc:spChg>
        <pc:spChg chg="add mod">
          <ac:chgData name="Reza Amini Hounejani" userId="36cb0b73-58b2-4568-a1ab-00cd49301806" providerId="ADAL" clId="{DA8FEA81-1A63-884F-A1C6-520C766F400F}" dt="2022-11-16T14:29:24.360" v="9515" actId="20577"/>
          <ac:spMkLst>
            <pc:docMk/>
            <pc:sldMk cId="1578300178" sldId="260"/>
            <ac:spMk id="120" creationId="{67093CDC-EDA6-9062-0A56-D4EC96EE4506}"/>
          </ac:spMkLst>
        </pc:spChg>
        <pc:spChg chg="add mod">
          <ac:chgData name="Reza Amini Hounejani" userId="36cb0b73-58b2-4568-a1ab-00cd49301806" providerId="ADAL" clId="{DA8FEA81-1A63-884F-A1C6-520C766F400F}" dt="2022-11-16T15:47:31.048" v="9694" actId="1035"/>
          <ac:spMkLst>
            <pc:docMk/>
            <pc:sldMk cId="1578300178" sldId="260"/>
            <ac:spMk id="125" creationId="{BD3AFF4F-BE02-12A2-EF72-FD0C8AD4A2FC}"/>
          </ac:spMkLst>
        </pc:spChg>
        <pc:spChg chg="add mod">
          <ac:chgData name="Reza Amini Hounejani" userId="36cb0b73-58b2-4568-a1ab-00cd49301806" providerId="ADAL" clId="{DA8FEA81-1A63-884F-A1C6-520C766F400F}" dt="2022-11-16T15:47:31.048" v="9694" actId="1035"/>
          <ac:spMkLst>
            <pc:docMk/>
            <pc:sldMk cId="1578300178" sldId="260"/>
            <ac:spMk id="131" creationId="{80B910EC-A192-13B2-2A03-828ACD485DD5}"/>
          </ac:spMkLst>
        </pc:spChg>
        <pc:spChg chg="add mod">
          <ac:chgData name="Reza Amini Hounejani" userId="36cb0b73-58b2-4568-a1ab-00cd49301806" providerId="ADAL" clId="{DA8FEA81-1A63-884F-A1C6-520C766F400F}" dt="2022-11-16T15:47:31.048" v="9694" actId="1035"/>
          <ac:spMkLst>
            <pc:docMk/>
            <pc:sldMk cId="1578300178" sldId="260"/>
            <ac:spMk id="132" creationId="{AFFD9B5F-0483-8FC9-0012-1190BCE695B5}"/>
          </ac:spMkLst>
        </pc:spChg>
        <pc:spChg chg="add mod">
          <ac:chgData name="Reza Amini Hounejani" userId="36cb0b73-58b2-4568-a1ab-00cd49301806" providerId="ADAL" clId="{DA8FEA81-1A63-884F-A1C6-520C766F400F}" dt="2022-11-16T15:47:31.048" v="9694" actId="1035"/>
          <ac:spMkLst>
            <pc:docMk/>
            <pc:sldMk cId="1578300178" sldId="260"/>
            <ac:spMk id="133" creationId="{14A99DAE-2B2E-664F-3996-7D3300BD5B79}"/>
          </ac:spMkLst>
        </pc:spChg>
        <pc:spChg chg="add mod">
          <ac:chgData name="Reza Amini Hounejani" userId="36cb0b73-58b2-4568-a1ab-00cd49301806" providerId="ADAL" clId="{DA8FEA81-1A63-884F-A1C6-520C766F400F}" dt="2022-11-16T15:47:31.048" v="9694" actId="1035"/>
          <ac:spMkLst>
            <pc:docMk/>
            <pc:sldMk cId="1578300178" sldId="260"/>
            <ac:spMk id="134" creationId="{C6B85742-D532-6921-4642-CEE9ABE7567A}"/>
          </ac:spMkLst>
        </pc:spChg>
        <pc:spChg chg="add mod">
          <ac:chgData name="Reza Amini Hounejani" userId="36cb0b73-58b2-4568-a1ab-00cd49301806" providerId="ADAL" clId="{DA8FEA81-1A63-884F-A1C6-520C766F400F}" dt="2022-11-16T15:47:11.420" v="9689" actId="554"/>
          <ac:spMkLst>
            <pc:docMk/>
            <pc:sldMk cId="1578300178" sldId="260"/>
            <ac:spMk id="135" creationId="{022946AC-1738-47D3-49C1-09FFB3D9FB24}"/>
          </ac:spMkLst>
        </pc:spChg>
        <pc:spChg chg="add mod">
          <ac:chgData name="Reza Amini Hounejani" userId="36cb0b73-58b2-4568-a1ab-00cd49301806" providerId="ADAL" clId="{DA8FEA81-1A63-884F-A1C6-520C766F400F}" dt="2022-11-16T15:47:11.420" v="9689" actId="554"/>
          <ac:spMkLst>
            <pc:docMk/>
            <pc:sldMk cId="1578300178" sldId="260"/>
            <ac:spMk id="137" creationId="{805BCC31-2AD2-F341-0E5F-3EED1EEC7A52}"/>
          </ac:spMkLst>
        </pc:spChg>
        <pc:spChg chg="add mod">
          <ac:chgData name="Reza Amini Hounejani" userId="36cb0b73-58b2-4568-a1ab-00cd49301806" providerId="ADAL" clId="{DA8FEA81-1A63-884F-A1C6-520C766F400F}" dt="2022-11-16T15:47:11.420" v="9689" actId="554"/>
          <ac:spMkLst>
            <pc:docMk/>
            <pc:sldMk cId="1578300178" sldId="260"/>
            <ac:spMk id="138" creationId="{1BD70D6E-E3FA-F712-7A38-2497BCCBFE57}"/>
          </ac:spMkLst>
        </pc:spChg>
        <pc:spChg chg="add mod">
          <ac:chgData name="Reza Amini Hounejani" userId="36cb0b73-58b2-4568-a1ab-00cd49301806" providerId="ADAL" clId="{DA8FEA81-1A63-884F-A1C6-520C766F400F}" dt="2022-11-16T15:47:11.420" v="9689" actId="554"/>
          <ac:spMkLst>
            <pc:docMk/>
            <pc:sldMk cId="1578300178" sldId="260"/>
            <ac:spMk id="139" creationId="{5A8CB3F0-B5E5-604F-D15E-068C689FD4EA}"/>
          </ac:spMkLst>
        </pc:spChg>
        <pc:spChg chg="add mod">
          <ac:chgData name="Reza Amini Hounejani" userId="36cb0b73-58b2-4568-a1ab-00cd49301806" providerId="ADAL" clId="{DA8FEA81-1A63-884F-A1C6-520C766F400F}" dt="2022-10-18T09:20:02.953" v="4065" actId="1036"/>
          <ac:spMkLst>
            <pc:docMk/>
            <pc:sldMk cId="1578300178" sldId="260"/>
            <ac:spMk id="151" creationId="{572A2175-0969-609F-D88E-FCF4B90F0B31}"/>
          </ac:spMkLst>
        </pc:spChg>
        <pc:spChg chg="add mod">
          <ac:chgData name="Reza Amini Hounejani" userId="36cb0b73-58b2-4568-a1ab-00cd49301806" providerId="ADAL" clId="{DA8FEA81-1A63-884F-A1C6-520C766F400F}" dt="2022-10-18T09:20:02.953" v="4065" actId="1036"/>
          <ac:spMkLst>
            <pc:docMk/>
            <pc:sldMk cId="1578300178" sldId="260"/>
            <ac:spMk id="152" creationId="{EAE7A08D-88E5-6B54-0A20-A50D7BA185CC}"/>
          </ac:spMkLst>
        </pc:spChg>
        <pc:spChg chg="add mod">
          <ac:chgData name="Reza Amini Hounejani" userId="36cb0b73-58b2-4568-a1ab-00cd49301806" providerId="ADAL" clId="{DA8FEA81-1A63-884F-A1C6-520C766F400F}" dt="2022-10-18T09:20:02.953" v="4065" actId="1036"/>
          <ac:spMkLst>
            <pc:docMk/>
            <pc:sldMk cId="1578300178" sldId="260"/>
            <ac:spMk id="153" creationId="{B7B9FB47-FB7B-0FDA-55B3-72A1A414EA4D}"/>
          </ac:spMkLst>
        </pc:spChg>
        <pc:spChg chg="add mod">
          <ac:chgData name="Reza Amini Hounejani" userId="36cb0b73-58b2-4568-a1ab-00cd49301806" providerId="ADAL" clId="{DA8FEA81-1A63-884F-A1C6-520C766F400F}" dt="2022-11-16T15:47:11.420" v="9689" actId="554"/>
          <ac:spMkLst>
            <pc:docMk/>
            <pc:sldMk cId="1578300178" sldId="260"/>
            <ac:spMk id="155" creationId="{42118672-5AF3-D053-2EE9-7404D57B835D}"/>
          </ac:spMkLst>
        </pc:spChg>
        <pc:grpChg chg="add mod">
          <ac:chgData name="Reza Amini Hounejani" userId="36cb0b73-58b2-4568-a1ab-00cd49301806" providerId="ADAL" clId="{DA8FEA81-1A63-884F-A1C6-520C766F400F}" dt="2022-11-24T12:57:51.771" v="11708" actId="688"/>
          <ac:grpSpMkLst>
            <pc:docMk/>
            <pc:sldMk cId="1578300178" sldId="260"/>
            <ac:grpSpMk id="2" creationId="{9C5784DB-6D37-DEC9-3933-22747AEAAB46}"/>
          </ac:grpSpMkLst>
        </pc:grpChg>
        <pc:grpChg chg="add del mod">
          <ac:chgData name="Reza Amini Hounejani" userId="36cb0b73-58b2-4568-a1ab-00cd49301806" providerId="ADAL" clId="{DA8FEA81-1A63-884F-A1C6-520C766F400F}" dt="2022-10-17T14:24:50.731" v="3579" actId="165"/>
          <ac:grpSpMkLst>
            <pc:docMk/>
            <pc:sldMk cId="1578300178" sldId="260"/>
            <ac:grpSpMk id="9" creationId="{6BFA1BCF-6552-B2C8-21CE-DB7B71EDB0FF}"/>
          </ac:grpSpMkLst>
        </pc:grpChg>
        <pc:grpChg chg="add del mod">
          <ac:chgData name="Reza Amini Hounejani" userId="36cb0b73-58b2-4568-a1ab-00cd49301806" providerId="ADAL" clId="{DA8FEA81-1A63-884F-A1C6-520C766F400F}" dt="2022-09-16T13:48:17.243" v="2341" actId="478"/>
          <ac:grpSpMkLst>
            <pc:docMk/>
            <pc:sldMk cId="1578300178" sldId="260"/>
            <ac:grpSpMk id="10" creationId="{EA89B140-5681-5B1D-04CB-99BFAF78F031}"/>
          </ac:grpSpMkLst>
        </pc:grpChg>
        <pc:grpChg chg="add del mod">
          <ac:chgData name="Reza Amini Hounejani" userId="36cb0b73-58b2-4568-a1ab-00cd49301806" providerId="ADAL" clId="{DA8FEA81-1A63-884F-A1C6-520C766F400F}" dt="2022-11-16T13:40:04.147" v="9309" actId="165"/>
          <ac:grpSpMkLst>
            <pc:docMk/>
            <pc:sldMk cId="1578300178" sldId="260"/>
            <ac:grpSpMk id="22" creationId="{888C0755-212E-6270-818A-D23D98709ED3}"/>
          </ac:grpSpMkLst>
        </pc:grpChg>
        <pc:grpChg chg="mod">
          <ac:chgData name="Reza Amini Hounejani" userId="36cb0b73-58b2-4568-a1ab-00cd49301806" providerId="ADAL" clId="{DA8FEA81-1A63-884F-A1C6-520C766F400F}" dt="2022-11-16T14:32:43.880" v="9544" actId="1036"/>
          <ac:grpSpMkLst>
            <pc:docMk/>
            <pc:sldMk cId="1578300178" sldId="260"/>
            <ac:grpSpMk id="26" creationId="{8E7E4A29-6B87-5898-0837-840CD5C6474E}"/>
          </ac:grpSpMkLst>
        </pc:grpChg>
        <pc:grpChg chg="mod">
          <ac:chgData name="Reza Amini Hounejani" userId="36cb0b73-58b2-4568-a1ab-00cd49301806" providerId="ADAL" clId="{DA8FEA81-1A63-884F-A1C6-520C766F400F}" dt="2022-11-16T14:30:34.489" v="9526" actId="14100"/>
          <ac:grpSpMkLst>
            <pc:docMk/>
            <pc:sldMk cId="1578300178" sldId="260"/>
            <ac:grpSpMk id="33" creationId="{F0445089-395E-4367-99BF-C838553B8262}"/>
          </ac:grpSpMkLst>
        </pc:grpChg>
        <pc:grpChg chg="mod topLvl">
          <ac:chgData name="Reza Amini Hounejani" userId="36cb0b73-58b2-4568-a1ab-00cd49301806" providerId="ADAL" clId="{DA8FEA81-1A63-884F-A1C6-520C766F400F}" dt="2022-10-17T14:25:25.795" v="3583" actId="164"/>
          <ac:grpSpMkLst>
            <pc:docMk/>
            <pc:sldMk cId="1578300178" sldId="260"/>
            <ac:grpSpMk id="43" creationId="{B893CFF6-AE6C-280B-1A2C-A1E231E065DA}"/>
          </ac:grpSpMkLst>
        </pc:grpChg>
        <pc:grpChg chg="del mod">
          <ac:chgData name="Reza Amini Hounejani" userId="36cb0b73-58b2-4568-a1ab-00cd49301806" providerId="ADAL" clId="{DA8FEA81-1A63-884F-A1C6-520C766F400F}" dt="2022-11-24T13:01:28.435" v="11833" actId="478"/>
          <ac:grpSpMkLst>
            <pc:docMk/>
            <pc:sldMk cId="1578300178" sldId="260"/>
            <ac:grpSpMk id="48" creationId="{6DC65874-9E4D-754C-EE7C-C9C4F6C2B3E3}"/>
          </ac:grpSpMkLst>
        </pc:grpChg>
        <pc:grpChg chg="add mod">
          <ac:chgData name="Reza Amini Hounejani" userId="36cb0b73-58b2-4568-a1ab-00cd49301806" providerId="ADAL" clId="{DA8FEA81-1A63-884F-A1C6-520C766F400F}" dt="2022-11-16T14:49:52.815" v="9551" actId="1076"/>
          <ac:grpSpMkLst>
            <pc:docMk/>
            <pc:sldMk cId="1578300178" sldId="260"/>
            <ac:grpSpMk id="59" creationId="{18930409-10F3-F52C-E51C-8B5B5D855623}"/>
          </ac:grpSpMkLst>
        </pc:grpChg>
        <pc:grpChg chg="del mod">
          <ac:chgData name="Reza Amini Hounejani" userId="36cb0b73-58b2-4568-a1ab-00cd49301806" providerId="ADAL" clId="{DA8FEA81-1A63-884F-A1C6-520C766F400F}" dt="2022-10-17T16:02:51.136" v="3586" actId="478"/>
          <ac:grpSpMkLst>
            <pc:docMk/>
            <pc:sldMk cId="1578300178" sldId="260"/>
            <ac:grpSpMk id="59" creationId="{2ECFB6CE-B35C-C8C0-FF32-2F4683CDAC1E}"/>
          </ac:grpSpMkLst>
        </pc:grpChg>
        <pc:grpChg chg="add mod">
          <ac:chgData name="Reza Amini Hounejani" userId="36cb0b73-58b2-4568-a1ab-00cd49301806" providerId="ADAL" clId="{DA8FEA81-1A63-884F-A1C6-520C766F400F}" dt="2022-10-18T09:20:35.425" v="4067" actId="1076"/>
          <ac:grpSpMkLst>
            <pc:docMk/>
            <pc:sldMk cId="1578300178" sldId="260"/>
            <ac:grpSpMk id="89" creationId="{1D297159-3423-E8C0-BC79-2B0F5221C9A9}"/>
          </ac:grpSpMkLst>
        </pc:grpChg>
        <pc:grpChg chg="del mod">
          <ac:chgData name="Reza Amini Hounejani" userId="36cb0b73-58b2-4568-a1ab-00cd49301806" providerId="ADAL" clId="{DA8FEA81-1A63-884F-A1C6-520C766F400F}" dt="2022-09-16T15:04:55.070" v="2359" actId="165"/>
          <ac:grpSpMkLst>
            <pc:docMk/>
            <pc:sldMk cId="1578300178" sldId="260"/>
            <ac:grpSpMk id="108" creationId="{3629EDF1-109A-EF86-D43B-EB5E4B277BC3}"/>
          </ac:grpSpMkLst>
        </pc:grpChg>
        <pc:grpChg chg="add mod">
          <ac:chgData name="Reza Amini Hounejani" userId="36cb0b73-58b2-4568-a1ab-00cd49301806" providerId="ADAL" clId="{DA8FEA81-1A63-884F-A1C6-520C766F400F}" dt="2022-10-18T09:21:34.470" v="4070" actId="164"/>
          <ac:grpSpMkLst>
            <pc:docMk/>
            <pc:sldMk cId="1578300178" sldId="260"/>
            <ac:grpSpMk id="130" creationId="{9217570C-7221-8599-D75E-333C835EEAB6}"/>
          </ac:grpSpMkLst>
        </pc:grpChg>
        <pc:grpChg chg="add mod">
          <ac:chgData name="Reza Amini Hounejani" userId="36cb0b73-58b2-4568-a1ab-00cd49301806" providerId="ADAL" clId="{DA8FEA81-1A63-884F-A1C6-520C766F400F}" dt="2022-11-16T15:43:28.905" v="9677" actId="164"/>
          <ac:grpSpMkLst>
            <pc:docMk/>
            <pc:sldMk cId="1578300178" sldId="260"/>
            <ac:grpSpMk id="154" creationId="{058F0CD0-3F1D-EE38-CD11-C77DF12C23A5}"/>
          </ac:grpSpMkLst>
        </pc:grpChg>
        <pc:grpChg chg="add mod">
          <ac:chgData name="Reza Amini Hounejani" userId="36cb0b73-58b2-4568-a1ab-00cd49301806" providerId="ADAL" clId="{DA8FEA81-1A63-884F-A1C6-520C766F400F}" dt="2022-11-16T15:47:34.647" v="9696" actId="1076"/>
          <ac:grpSpMkLst>
            <pc:docMk/>
            <pc:sldMk cId="1578300178" sldId="260"/>
            <ac:grpSpMk id="156" creationId="{1C35E0CD-19A5-F7A6-5624-F23D63ACB3B6}"/>
          </ac:grpSpMkLst>
        </pc:grpChg>
        <pc:picChg chg="add mod modCrop">
          <ac:chgData name="Reza Amini Hounejani" userId="36cb0b73-58b2-4568-a1ab-00cd49301806" providerId="ADAL" clId="{DA8FEA81-1A63-884F-A1C6-520C766F400F}" dt="2022-10-18T09:17:07.058" v="4017" actId="732"/>
          <ac:picMkLst>
            <pc:docMk/>
            <pc:sldMk cId="1578300178" sldId="260"/>
            <ac:picMk id="10" creationId="{05D58E15-D8C5-6B46-9229-72E6938FAD9F}"/>
          </ac:picMkLst>
        </pc:picChg>
        <pc:picChg chg="add del mod modCrop">
          <ac:chgData name="Reza Amini Hounejani" userId="36cb0b73-58b2-4568-a1ab-00cd49301806" providerId="ADAL" clId="{DA8FEA81-1A63-884F-A1C6-520C766F400F}" dt="2022-11-16T13:38:30.831" v="9291" actId="478"/>
          <ac:picMkLst>
            <pc:docMk/>
            <pc:sldMk cId="1578300178" sldId="260"/>
            <ac:picMk id="11" creationId="{D85DD99A-8935-B693-40AA-6FA39A84BE3A}"/>
          </ac:picMkLst>
        </pc:picChg>
        <pc:picChg chg="add mod">
          <ac:chgData name="Reza Amini Hounejani" userId="36cb0b73-58b2-4568-a1ab-00cd49301806" providerId="ADAL" clId="{DA8FEA81-1A63-884F-A1C6-520C766F400F}" dt="2022-11-24T13:06:30.354" v="11862" actId="14100"/>
          <ac:picMkLst>
            <pc:docMk/>
            <pc:sldMk cId="1578300178" sldId="260"/>
            <ac:picMk id="12" creationId="{BEB8C6CF-10E4-6D34-6A10-9BAA1913DC7A}"/>
          </ac:picMkLst>
        </pc:picChg>
        <pc:picChg chg="add mod modCrop">
          <ac:chgData name="Reza Amini Hounejani" userId="36cb0b73-58b2-4568-a1ab-00cd49301806" providerId="ADAL" clId="{DA8FEA81-1A63-884F-A1C6-520C766F400F}" dt="2022-10-18T09:20:47.793" v="4069" actId="1076"/>
          <ac:picMkLst>
            <pc:docMk/>
            <pc:sldMk cId="1578300178" sldId="260"/>
            <ac:picMk id="14" creationId="{3CED9357-B031-CB29-A3B4-F0AAE87174D7}"/>
          </ac:picMkLst>
        </pc:picChg>
        <pc:picChg chg="add mod">
          <ac:chgData name="Reza Amini Hounejani" userId="36cb0b73-58b2-4568-a1ab-00cd49301806" providerId="ADAL" clId="{DA8FEA81-1A63-884F-A1C6-520C766F400F}" dt="2022-11-24T13:04:41.235" v="11844" actId="14100"/>
          <ac:picMkLst>
            <pc:docMk/>
            <pc:sldMk cId="1578300178" sldId="260"/>
            <ac:picMk id="18" creationId="{51ED32BC-693E-BBC1-A490-3F15A9F65E2B}"/>
          </ac:picMkLst>
        </pc:picChg>
        <pc:picChg chg="mod">
          <ac:chgData name="Reza Amini Hounejani" userId="36cb0b73-58b2-4568-a1ab-00cd49301806" providerId="ADAL" clId="{DA8FEA81-1A63-884F-A1C6-520C766F400F}" dt="2022-09-21T10:50:11.572" v="3071" actId="553"/>
          <ac:picMkLst>
            <pc:docMk/>
            <pc:sldMk cId="1578300178" sldId="260"/>
            <ac:picMk id="24" creationId="{73C9C822-9F4A-6E08-389C-927C069B818F}"/>
          </ac:picMkLst>
        </pc:picChg>
        <pc:picChg chg="mod">
          <ac:chgData name="Reza Amini Hounejani" userId="36cb0b73-58b2-4568-a1ab-00cd49301806" providerId="ADAL" clId="{DA8FEA81-1A63-884F-A1C6-520C766F400F}" dt="2022-11-16T15:43:43.035" v="9680" actId="552"/>
          <ac:picMkLst>
            <pc:docMk/>
            <pc:sldMk cId="1578300178" sldId="260"/>
            <ac:picMk id="25" creationId="{AAF86A59-9732-DE66-B3C0-122D91691247}"/>
          </ac:picMkLst>
        </pc:picChg>
        <pc:picChg chg="del mod">
          <ac:chgData name="Reza Amini Hounejani" userId="36cb0b73-58b2-4568-a1ab-00cd49301806" providerId="ADAL" clId="{DA8FEA81-1A63-884F-A1C6-520C766F400F}" dt="2022-09-21T11:21:25.286" v="3093" actId="478"/>
          <ac:picMkLst>
            <pc:docMk/>
            <pc:sldMk cId="1578300178" sldId="260"/>
            <ac:picMk id="41" creationId="{347B9494-001B-D4C6-7B74-F63515134F62}"/>
          </ac:picMkLst>
        </pc:picChg>
        <pc:picChg chg="mod">
          <ac:chgData name="Reza Amini Hounejani" userId="36cb0b73-58b2-4568-a1ab-00cd49301806" providerId="ADAL" clId="{DA8FEA81-1A63-884F-A1C6-520C766F400F}" dt="2022-11-16T14:24:39.116" v="9462" actId="1037"/>
          <ac:picMkLst>
            <pc:docMk/>
            <pc:sldMk cId="1578300178" sldId="260"/>
            <ac:picMk id="42" creationId="{EDE3902D-761E-CB92-698E-96122C9505BF}"/>
          </ac:picMkLst>
        </pc:picChg>
        <pc:picChg chg="del">
          <ac:chgData name="Reza Amini Hounejani" userId="36cb0b73-58b2-4568-a1ab-00cd49301806" providerId="ADAL" clId="{DA8FEA81-1A63-884F-A1C6-520C766F400F}" dt="2022-10-17T14:07:50.292" v="3460" actId="478"/>
          <ac:picMkLst>
            <pc:docMk/>
            <pc:sldMk cId="1578300178" sldId="260"/>
            <ac:picMk id="44" creationId="{51668A79-854F-F889-B26F-F6E1631953CB}"/>
          </ac:picMkLst>
        </pc:picChg>
        <pc:picChg chg="del mod">
          <ac:chgData name="Reza Amini Hounejani" userId="36cb0b73-58b2-4568-a1ab-00cd49301806" providerId="ADAL" clId="{DA8FEA81-1A63-884F-A1C6-520C766F400F}" dt="2022-11-24T13:01:28.435" v="11833" actId="478"/>
          <ac:picMkLst>
            <pc:docMk/>
            <pc:sldMk cId="1578300178" sldId="260"/>
            <ac:picMk id="47" creationId="{065039FA-95E6-CCFA-B06A-D3128A20F725}"/>
          </ac:picMkLst>
        </pc:picChg>
        <pc:picChg chg="add del mod modCrop">
          <ac:chgData name="Reza Amini Hounejani" userId="36cb0b73-58b2-4568-a1ab-00cd49301806" providerId="ADAL" clId="{DA8FEA81-1A63-884F-A1C6-520C766F400F}" dt="2022-11-16T14:27:31.267" v="9485" actId="478"/>
          <ac:picMkLst>
            <pc:docMk/>
            <pc:sldMk cId="1578300178" sldId="260"/>
            <ac:picMk id="68" creationId="{45283ADA-0BD6-A5DE-334C-9B836DAEFC12}"/>
          </ac:picMkLst>
        </pc:picChg>
        <pc:picChg chg="add del mod">
          <ac:chgData name="Reza Amini Hounejani" userId="36cb0b73-58b2-4568-a1ab-00cd49301806" providerId="ADAL" clId="{DA8FEA81-1A63-884F-A1C6-520C766F400F}" dt="2022-11-24T12:55:45.184" v="11680" actId="478"/>
          <ac:picMkLst>
            <pc:docMk/>
            <pc:sldMk cId="1578300178" sldId="260"/>
            <ac:picMk id="76" creationId="{FE86D1ED-0226-E9F7-D07C-E8C2BEE301D8}"/>
          </ac:picMkLst>
        </pc:picChg>
        <pc:picChg chg="add mod modCrop">
          <ac:chgData name="Reza Amini Hounejani" userId="36cb0b73-58b2-4568-a1ab-00cd49301806" providerId="ADAL" clId="{DA8FEA81-1A63-884F-A1C6-520C766F400F}" dt="2022-10-18T09:20:44.600" v="4068" actId="1076"/>
          <ac:picMkLst>
            <pc:docMk/>
            <pc:sldMk cId="1578300178" sldId="260"/>
            <ac:picMk id="85" creationId="{CB14D602-AB1E-A39A-5A6C-243B3BD95171}"/>
          </ac:picMkLst>
        </pc:picChg>
        <pc:picChg chg="del mod topLvl">
          <ac:chgData name="Reza Amini Hounejani" userId="36cb0b73-58b2-4568-a1ab-00cd49301806" providerId="ADAL" clId="{DA8FEA81-1A63-884F-A1C6-520C766F400F}" dt="2022-09-16T15:08:32.389" v="2398" actId="478"/>
          <ac:picMkLst>
            <pc:docMk/>
            <pc:sldMk cId="1578300178" sldId="260"/>
            <ac:picMk id="96" creationId="{AB0F0AC3-56DA-4AD2-262A-2A49F9199911}"/>
          </ac:picMkLst>
        </pc:picChg>
        <pc:picChg chg="add mod">
          <ac:chgData name="Reza Amini Hounejani" userId="36cb0b73-58b2-4568-a1ab-00cd49301806" providerId="ADAL" clId="{DA8FEA81-1A63-884F-A1C6-520C766F400F}" dt="2022-11-16T14:50:08.072" v="9560" actId="1037"/>
          <ac:picMkLst>
            <pc:docMk/>
            <pc:sldMk cId="1578300178" sldId="260"/>
            <ac:picMk id="105" creationId="{B247A515-A41C-BB88-8F70-A23EDA50AD09}"/>
          </ac:picMkLst>
        </pc:picChg>
        <pc:picChg chg="add mod">
          <ac:chgData name="Reza Amini Hounejani" userId="36cb0b73-58b2-4568-a1ab-00cd49301806" providerId="ADAL" clId="{DA8FEA81-1A63-884F-A1C6-520C766F400F}" dt="2022-10-17T16:08:07.099" v="3658" actId="164"/>
          <ac:picMkLst>
            <pc:docMk/>
            <pc:sldMk cId="1578300178" sldId="260"/>
            <ac:picMk id="112" creationId="{F66A1643-BB80-5238-CB0B-B56D0A5F0162}"/>
          </ac:picMkLst>
        </pc:picChg>
        <pc:picChg chg="add del mod">
          <ac:chgData name="Reza Amini Hounejani" userId="36cb0b73-58b2-4568-a1ab-00cd49301806" providerId="ADAL" clId="{DA8FEA81-1A63-884F-A1C6-520C766F400F}" dt="2022-11-24T11:26:21.874" v="11677" actId="478"/>
          <ac:picMkLst>
            <pc:docMk/>
            <pc:sldMk cId="1578300178" sldId="260"/>
            <ac:picMk id="115" creationId="{E33AAF2C-AD56-0D26-616B-A6EAA08B7132}"/>
          </ac:picMkLst>
        </pc:picChg>
        <pc:picChg chg="add mod modCrop">
          <ac:chgData name="Reza Amini Hounejani" userId="36cb0b73-58b2-4568-a1ab-00cd49301806" providerId="ADAL" clId="{DA8FEA81-1A63-884F-A1C6-520C766F400F}" dt="2022-11-16T14:28:30.888" v="9498" actId="1076"/>
          <ac:picMkLst>
            <pc:docMk/>
            <pc:sldMk cId="1578300178" sldId="260"/>
            <ac:picMk id="123" creationId="{1E6F72B5-00D7-E764-37BD-EFF938A197D2}"/>
          </ac:picMkLst>
        </pc:picChg>
        <pc:cxnChg chg="add del mod">
          <ac:chgData name="Reza Amini Hounejani" userId="36cb0b73-58b2-4568-a1ab-00cd49301806" providerId="ADAL" clId="{DA8FEA81-1A63-884F-A1C6-520C766F400F}" dt="2022-11-24T13:00:37.886" v="11819" actId="478"/>
          <ac:cxnSpMkLst>
            <pc:docMk/>
            <pc:sldMk cId="1578300178" sldId="260"/>
            <ac:cxnSpMk id="22" creationId="{147EFEF7-1A01-58EC-D28E-412B3D8F6EFE}"/>
          </ac:cxnSpMkLst>
        </pc:cxnChg>
        <pc:cxnChg chg="add del mod topLvl">
          <ac:chgData name="Reza Amini Hounejani" userId="36cb0b73-58b2-4568-a1ab-00cd49301806" providerId="ADAL" clId="{DA8FEA81-1A63-884F-A1C6-520C766F400F}" dt="2022-11-16T14:28:48.439" v="9503" actId="478"/>
          <ac:cxnSpMkLst>
            <pc:docMk/>
            <pc:sldMk cId="1578300178" sldId="260"/>
            <ac:cxnSpMk id="23" creationId="{17E1C8C1-F69D-8B2D-5D6A-7ED309CD84D8}"/>
          </ac:cxnSpMkLst>
        </pc:cxnChg>
        <pc:cxnChg chg="mod">
          <ac:chgData name="Reza Amini Hounejani" userId="36cb0b73-58b2-4568-a1ab-00cd49301806" providerId="ADAL" clId="{DA8FEA81-1A63-884F-A1C6-520C766F400F}" dt="2022-10-17T14:24:50.731" v="3579" actId="165"/>
          <ac:cxnSpMkLst>
            <pc:docMk/>
            <pc:sldMk cId="1578300178" sldId="260"/>
            <ac:cxnSpMk id="45" creationId="{3E735CAB-A7EB-1839-797B-79C8E6DA0B70}"/>
          </ac:cxnSpMkLst>
        </pc:cxnChg>
        <pc:cxnChg chg="del">
          <ac:chgData name="Reza Amini Hounejani" userId="36cb0b73-58b2-4568-a1ab-00cd49301806" providerId="ADAL" clId="{DA8FEA81-1A63-884F-A1C6-520C766F400F}" dt="2022-10-17T14:12:51.941" v="3532" actId="478"/>
          <ac:cxnSpMkLst>
            <pc:docMk/>
            <pc:sldMk cId="1578300178" sldId="260"/>
            <ac:cxnSpMk id="46" creationId="{F18B2FB3-B53E-8231-9100-E7E58DC8F6EE}"/>
          </ac:cxnSpMkLst>
        </pc:cxnChg>
        <pc:cxnChg chg="add mod">
          <ac:chgData name="Reza Amini Hounejani" userId="36cb0b73-58b2-4568-a1ab-00cd49301806" providerId="ADAL" clId="{DA8FEA81-1A63-884F-A1C6-520C766F400F}" dt="2022-11-16T14:32:43.880" v="9544" actId="1036"/>
          <ac:cxnSpMkLst>
            <pc:docMk/>
            <pc:sldMk cId="1578300178" sldId="260"/>
            <ac:cxnSpMk id="83" creationId="{1C20496C-1971-0633-2DA6-F2EB57672F8B}"/>
          </ac:cxnSpMkLst>
        </pc:cxnChg>
        <pc:cxnChg chg="mod">
          <ac:chgData name="Reza Amini Hounejani" userId="36cb0b73-58b2-4568-a1ab-00cd49301806" providerId="ADAL" clId="{DA8FEA81-1A63-884F-A1C6-520C766F400F}" dt="2022-10-17T14:24:50.731" v="3579" actId="165"/>
          <ac:cxnSpMkLst>
            <pc:docMk/>
            <pc:sldMk cId="1578300178" sldId="260"/>
            <ac:cxnSpMk id="86" creationId="{E6832EA3-B464-9DF5-8FA3-2DBD21209AB8}"/>
          </ac:cxnSpMkLst>
        </pc:cxnChg>
        <pc:cxnChg chg="add mod">
          <ac:chgData name="Reza Amini Hounejani" userId="36cb0b73-58b2-4568-a1ab-00cd49301806" providerId="ADAL" clId="{DA8FEA81-1A63-884F-A1C6-520C766F400F}" dt="2022-11-16T14:24:39.116" v="9462" actId="1037"/>
          <ac:cxnSpMkLst>
            <pc:docMk/>
            <pc:sldMk cId="1578300178" sldId="260"/>
            <ac:cxnSpMk id="93" creationId="{72616FBF-491A-5772-3B48-C66A0C78EDDC}"/>
          </ac:cxnSpMkLst>
        </pc:cxnChg>
        <pc:cxnChg chg="add mod topLvl">
          <ac:chgData name="Reza Amini Hounejani" userId="36cb0b73-58b2-4568-a1ab-00cd49301806" providerId="ADAL" clId="{DA8FEA81-1A63-884F-A1C6-520C766F400F}" dt="2022-11-16T14:29:57.980" v="9525" actId="1037"/>
          <ac:cxnSpMkLst>
            <pc:docMk/>
            <pc:sldMk cId="1578300178" sldId="260"/>
            <ac:cxnSpMk id="95" creationId="{A85CA60F-6ABB-A73F-1698-3290A443B3BC}"/>
          </ac:cxnSpMkLst>
        </pc:cxnChg>
        <pc:cxnChg chg="mod topLvl">
          <ac:chgData name="Reza Amini Hounejani" userId="36cb0b73-58b2-4568-a1ab-00cd49301806" providerId="ADAL" clId="{DA8FEA81-1A63-884F-A1C6-520C766F400F}" dt="2022-11-16T14:29:08.103" v="9509" actId="13822"/>
          <ac:cxnSpMkLst>
            <pc:docMk/>
            <pc:sldMk cId="1578300178" sldId="260"/>
            <ac:cxnSpMk id="99" creationId="{7FF79671-27F0-2CD2-7014-ABA26D182D23}"/>
          </ac:cxnSpMkLst>
        </pc:cxnChg>
        <pc:cxnChg chg="del mod topLvl">
          <ac:chgData name="Reza Amini Hounejani" userId="36cb0b73-58b2-4568-a1ab-00cd49301806" providerId="ADAL" clId="{DA8FEA81-1A63-884F-A1C6-520C766F400F}" dt="2022-09-16T15:08:32.389" v="2398" actId="478"/>
          <ac:cxnSpMkLst>
            <pc:docMk/>
            <pc:sldMk cId="1578300178" sldId="260"/>
            <ac:cxnSpMk id="101" creationId="{452BA1D9-D1B2-34E6-5B86-789269AD0C85}"/>
          </ac:cxnSpMkLst>
        </pc:cxnChg>
        <pc:cxnChg chg="add del mod topLvl">
          <ac:chgData name="Reza Amini Hounejani" userId="36cb0b73-58b2-4568-a1ab-00cd49301806" providerId="ADAL" clId="{DA8FEA81-1A63-884F-A1C6-520C766F400F}" dt="2022-11-16T13:40:31.762" v="9316" actId="478"/>
          <ac:cxnSpMkLst>
            <pc:docMk/>
            <pc:sldMk cId="1578300178" sldId="260"/>
            <ac:cxnSpMk id="102" creationId="{7735633A-9078-B7FC-CD92-0A2EFAEC4110}"/>
          </ac:cxnSpMkLst>
        </pc:cxnChg>
        <pc:cxnChg chg="del mod topLvl">
          <ac:chgData name="Reza Amini Hounejani" userId="36cb0b73-58b2-4568-a1ab-00cd49301806" providerId="ADAL" clId="{DA8FEA81-1A63-884F-A1C6-520C766F400F}" dt="2022-09-16T15:08:32.389" v="2398" actId="478"/>
          <ac:cxnSpMkLst>
            <pc:docMk/>
            <pc:sldMk cId="1578300178" sldId="260"/>
            <ac:cxnSpMk id="104" creationId="{2E9AE153-9B77-4F09-8927-8A40B93C56E8}"/>
          </ac:cxnSpMkLst>
        </pc:cxnChg>
        <pc:cxnChg chg="del mod topLvl">
          <ac:chgData name="Reza Amini Hounejani" userId="36cb0b73-58b2-4568-a1ab-00cd49301806" providerId="ADAL" clId="{DA8FEA81-1A63-884F-A1C6-520C766F400F}" dt="2022-09-16T15:08:32.389" v="2398" actId="478"/>
          <ac:cxnSpMkLst>
            <pc:docMk/>
            <pc:sldMk cId="1578300178" sldId="260"/>
            <ac:cxnSpMk id="105" creationId="{6642E819-DA5D-49DF-1C04-C7A658A3E9D3}"/>
          </ac:cxnSpMkLst>
        </pc:cxnChg>
        <pc:cxnChg chg="add del mod topLvl">
          <ac:chgData name="Reza Amini Hounejani" userId="36cb0b73-58b2-4568-a1ab-00cd49301806" providerId="ADAL" clId="{DA8FEA81-1A63-884F-A1C6-520C766F400F}" dt="2022-11-16T13:40:30.744" v="9315" actId="478"/>
          <ac:cxnSpMkLst>
            <pc:docMk/>
            <pc:sldMk cId="1578300178" sldId="260"/>
            <ac:cxnSpMk id="107" creationId="{81AC6F01-3537-5498-8B39-7674FE90AF68}"/>
          </ac:cxnSpMkLst>
        </pc:cxnChg>
        <pc:cxnChg chg="add mod">
          <ac:chgData name="Reza Amini Hounejani" userId="36cb0b73-58b2-4568-a1ab-00cd49301806" providerId="ADAL" clId="{DA8FEA81-1A63-884F-A1C6-520C766F400F}" dt="2022-10-17T16:08:07.099" v="3658" actId="164"/>
          <ac:cxnSpMkLst>
            <pc:docMk/>
            <pc:sldMk cId="1578300178" sldId="260"/>
            <ac:cxnSpMk id="116" creationId="{5EAAE5DA-77B6-B0D1-5DE8-C03A4B8F80F4}"/>
          </ac:cxnSpMkLst>
        </pc:cxnChg>
        <pc:cxnChg chg="add mod">
          <ac:chgData name="Reza Amini Hounejani" userId="36cb0b73-58b2-4568-a1ab-00cd49301806" providerId="ADAL" clId="{DA8FEA81-1A63-884F-A1C6-520C766F400F}" dt="2022-10-17T16:08:07.099" v="3658" actId="164"/>
          <ac:cxnSpMkLst>
            <pc:docMk/>
            <pc:sldMk cId="1578300178" sldId="260"/>
            <ac:cxnSpMk id="118" creationId="{77F5BE42-B6DC-E0B4-25C2-F6EE11693C7A}"/>
          </ac:cxnSpMkLst>
        </pc:cxnChg>
        <pc:cxnChg chg="add mod">
          <ac:chgData name="Reza Amini Hounejani" userId="36cb0b73-58b2-4568-a1ab-00cd49301806" providerId="ADAL" clId="{DA8FEA81-1A63-884F-A1C6-520C766F400F}" dt="2022-11-16T14:32:43.880" v="9544" actId="1036"/>
          <ac:cxnSpMkLst>
            <pc:docMk/>
            <pc:sldMk cId="1578300178" sldId="260"/>
            <ac:cxnSpMk id="119" creationId="{F7743A77-EE40-C8DA-6597-1E53D3E37769}"/>
          </ac:cxnSpMkLst>
        </pc:cxnChg>
        <pc:cxnChg chg="add mod">
          <ac:chgData name="Reza Amini Hounejani" userId="36cb0b73-58b2-4568-a1ab-00cd49301806" providerId="ADAL" clId="{DA8FEA81-1A63-884F-A1C6-520C766F400F}" dt="2022-11-16T14:26:07.531" v="9482" actId="571"/>
          <ac:cxnSpMkLst>
            <pc:docMk/>
            <pc:sldMk cId="1578300178" sldId="260"/>
            <ac:cxnSpMk id="121" creationId="{37E1EF90-75B2-32DF-B604-5423EA0C61AC}"/>
          </ac:cxnSpMkLst>
        </pc:cxnChg>
        <pc:cxnChg chg="add mod">
          <ac:chgData name="Reza Amini Hounejani" userId="36cb0b73-58b2-4568-a1ab-00cd49301806" providerId="ADAL" clId="{DA8FEA81-1A63-884F-A1C6-520C766F400F}" dt="2022-10-17T16:08:07.099" v="3658" actId="164"/>
          <ac:cxnSpMkLst>
            <pc:docMk/>
            <pc:sldMk cId="1578300178" sldId="260"/>
            <ac:cxnSpMk id="126" creationId="{9B415436-20CA-0474-97D6-09CDA6865C2C}"/>
          </ac:cxnSpMkLst>
        </pc:cxnChg>
        <pc:cxnChg chg="add mod">
          <ac:chgData name="Reza Amini Hounejani" userId="36cb0b73-58b2-4568-a1ab-00cd49301806" providerId="ADAL" clId="{DA8FEA81-1A63-884F-A1C6-520C766F400F}" dt="2022-10-17T16:08:07.099" v="3658" actId="164"/>
          <ac:cxnSpMkLst>
            <pc:docMk/>
            <pc:sldMk cId="1578300178" sldId="260"/>
            <ac:cxnSpMk id="127" creationId="{6FE00A8F-4758-AA52-452A-FB6C3F4504BE}"/>
          </ac:cxnSpMkLst>
        </pc:cxnChg>
        <pc:cxnChg chg="add mod">
          <ac:chgData name="Reza Amini Hounejani" userId="36cb0b73-58b2-4568-a1ab-00cd49301806" providerId="ADAL" clId="{DA8FEA81-1A63-884F-A1C6-520C766F400F}" dt="2022-10-17T16:08:07.099" v="3658" actId="164"/>
          <ac:cxnSpMkLst>
            <pc:docMk/>
            <pc:sldMk cId="1578300178" sldId="260"/>
            <ac:cxnSpMk id="128" creationId="{FE5042A0-BD30-E934-AFB4-A99444F808DB}"/>
          </ac:cxnSpMkLst>
        </pc:cxnChg>
        <pc:cxnChg chg="add mod">
          <ac:chgData name="Reza Amini Hounejani" userId="36cb0b73-58b2-4568-a1ab-00cd49301806" providerId="ADAL" clId="{DA8FEA81-1A63-884F-A1C6-520C766F400F}" dt="2022-10-17T16:08:07.099" v="3658" actId="164"/>
          <ac:cxnSpMkLst>
            <pc:docMk/>
            <pc:sldMk cId="1578300178" sldId="260"/>
            <ac:cxnSpMk id="129" creationId="{7ABB7E56-983A-7740-996F-13A9B7800E5A}"/>
          </ac:cxnSpMkLst>
        </pc:cxnChg>
        <pc:cxnChg chg="add del mod">
          <ac:chgData name="Reza Amini Hounejani" userId="36cb0b73-58b2-4568-a1ab-00cd49301806" providerId="ADAL" clId="{DA8FEA81-1A63-884F-A1C6-520C766F400F}" dt="2022-10-17T16:10:17.745" v="3721" actId="478"/>
          <ac:cxnSpMkLst>
            <pc:docMk/>
            <pc:sldMk cId="1578300178" sldId="260"/>
            <ac:cxnSpMk id="132" creationId="{AACF7DD1-6632-095F-D361-CF523CB46D4C}"/>
          </ac:cxnSpMkLst>
        </pc:cxnChg>
        <pc:cxnChg chg="add del mod">
          <ac:chgData name="Reza Amini Hounejani" userId="36cb0b73-58b2-4568-a1ab-00cd49301806" providerId="ADAL" clId="{DA8FEA81-1A63-884F-A1C6-520C766F400F}" dt="2022-10-17T16:10:16.599" v="3720" actId="478"/>
          <ac:cxnSpMkLst>
            <pc:docMk/>
            <pc:sldMk cId="1578300178" sldId="260"/>
            <ac:cxnSpMk id="134" creationId="{EADCD4F9-3DF0-9B28-D0E4-4D2FABCB2CEE}"/>
          </ac:cxnSpMkLst>
        </pc:cxnChg>
        <pc:cxnChg chg="add del mod">
          <ac:chgData name="Reza Amini Hounejani" userId="36cb0b73-58b2-4568-a1ab-00cd49301806" providerId="ADAL" clId="{DA8FEA81-1A63-884F-A1C6-520C766F400F}" dt="2022-10-17T16:10:15.719" v="3719" actId="478"/>
          <ac:cxnSpMkLst>
            <pc:docMk/>
            <pc:sldMk cId="1578300178" sldId="260"/>
            <ac:cxnSpMk id="135" creationId="{1AB663FA-9394-C3C8-9ECB-CA063EB06534}"/>
          </ac:cxnSpMkLst>
        </pc:cxnChg>
        <pc:cxnChg chg="add mod">
          <ac:chgData name="Reza Amini Hounejani" userId="36cb0b73-58b2-4568-a1ab-00cd49301806" providerId="ADAL" clId="{DA8FEA81-1A63-884F-A1C6-520C766F400F}" dt="2022-10-18T09:22:30.663" v="4074" actId="14100"/>
          <ac:cxnSpMkLst>
            <pc:docMk/>
            <pc:sldMk cId="1578300178" sldId="260"/>
            <ac:cxnSpMk id="136" creationId="{E188EAAE-4F94-51BB-D594-451C4823B37C}"/>
          </ac:cxnSpMkLst>
        </pc:cxnChg>
        <pc:cxnChg chg="add del mod">
          <ac:chgData name="Reza Amini Hounejani" userId="36cb0b73-58b2-4568-a1ab-00cd49301806" providerId="ADAL" clId="{DA8FEA81-1A63-884F-A1C6-520C766F400F}" dt="2022-10-17T16:10:39.869" v="3737"/>
          <ac:cxnSpMkLst>
            <pc:docMk/>
            <pc:sldMk cId="1578300178" sldId="260"/>
            <ac:cxnSpMk id="138" creationId="{61630FAB-9F1A-0424-3DDD-17EA71AF8B0E}"/>
          </ac:cxnSpMkLst>
        </pc:cxnChg>
        <pc:cxnChg chg="add del mod">
          <ac:chgData name="Reza Amini Hounejani" userId="36cb0b73-58b2-4568-a1ab-00cd49301806" providerId="ADAL" clId="{DA8FEA81-1A63-884F-A1C6-520C766F400F}" dt="2022-10-17T16:10:38.831" v="3735"/>
          <ac:cxnSpMkLst>
            <pc:docMk/>
            <pc:sldMk cId="1578300178" sldId="260"/>
            <ac:cxnSpMk id="139" creationId="{3BDA58CA-FC67-461E-64BD-F7F446A8F67E}"/>
          </ac:cxnSpMkLst>
        </pc:cxnChg>
        <pc:cxnChg chg="add mod">
          <ac:chgData name="Reza Amini Hounejani" userId="36cb0b73-58b2-4568-a1ab-00cd49301806" providerId="ADAL" clId="{DA8FEA81-1A63-884F-A1C6-520C766F400F}" dt="2022-10-18T09:22:30.663" v="4074" actId="14100"/>
          <ac:cxnSpMkLst>
            <pc:docMk/>
            <pc:sldMk cId="1578300178" sldId="260"/>
            <ac:cxnSpMk id="140" creationId="{CDF3DF67-B2E5-8B6B-E3D8-438522D5D351}"/>
          </ac:cxnSpMkLst>
        </pc:cxnChg>
        <pc:cxnChg chg="add mod">
          <ac:chgData name="Reza Amini Hounejani" userId="36cb0b73-58b2-4568-a1ab-00cd49301806" providerId="ADAL" clId="{DA8FEA81-1A63-884F-A1C6-520C766F400F}" dt="2022-10-18T09:22:30.663" v="4074" actId="14100"/>
          <ac:cxnSpMkLst>
            <pc:docMk/>
            <pc:sldMk cId="1578300178" sldId="260"/>
            <ac:cxnSpMk id="141" creationId="{3E8F62C0-11CB-68AE-B733-E5B7195CC08F}"/>
          </ac:cxnSpMkLst>
        </pc:cxnChg>
        <pc:cxnChg chg="add mod">
          <ac:chgData name="Reza Amini Hounejani" userId="36cb0b73-58b2-4568-a1ab-00cd49301806" providerId="ADAL" clId="{DA8FEA81-1A63-884F-A1C6-520C766F400F}" dt="2022-10-18T09:22:30.663" v="4074" actId="14100"/>
          <ac:cxnSpMkLst>
            <pc:docMk/>
            <pc:sldMk cId="1578300178" sldId="260"/>
            <ac:cxnSpMk id="142" creationId="{3B36FBDF-FE8F-5B02-5884-51DDD6CF474B}"/>
          </ac:cxnSpMkLst>
        </pc:cxnChg>
        <pc:cxnChg chg="add mod">
          <ac:chgData name="Reza Amini Hounejani" userId="36cb0b73-58b2-4568-a1ab-00cd49301806" providerId="ADAL" clId="{DA8FEA81-1A63-884F-A1C6-520C766F400F}" dt="2022-10-18T09:22:30.663" v="4074" actId="14100"/>
          <ac:cxnSpMkLst>
            <pc:docMk/>
            <pc:sldMk cId="1578300178" sldId="260"/>
            <ac:cxnSpMk id="143" creationId="{2EABE4F4-298D-6BC7-1606-5A4E412D9588}"/>
          </ac:cxnSpMkLst>
        </pc:cxnChg>
        <pc:cxnChg chg="add mod">
          <ac:chgData name="Reza Amini Hounejani" userId="36cb0b73-58b2-4568-a1ab-00cd49301806" providerId="ADAL" clId="{DA8FEA81-1A63-884F-A1C6-520C766F400F}" dt="2022-10-18T09:22:30.663" v="4074" actId="14100"/>
          <ac:cxnSpMkLst>
            <pc:docMk/>
            <pc:sldMk cId="1578300178" sldId="260"/>
            <ac:cxnSpMk id="144" creationId="{581A0DB6-EBDA-7012-68EA-630EA486D806}"/>
          </ac:cxnSpMkLst>
        </pc:cxnChg>
        <pc:cxnChg chg="add mod">
          <ac:chgData name="Reza Amini Hounejani" userId="36cb0b73-58b2-4568-a1ab-00cd49301806" providerId="ADAL" clId="{DA8FEA81-1A63-884F-A1C6-520C766F400F}" dt="2022-10-18T09:22:30.663" v="4074" actId="14100"/>
          <ac:cxnSpMkLst>
            <pc:docMk/>
            <pc:sldMk cId="1578300178" sldId="260"/>
            <ac:cxnSpMk id="145" creationId="{6CB51ABD-C14F-166F-9C73-098028061CA2}"/>
          </ac:cxnSpMkLst>
        </pc:cxnChg>
        <pc:cxnChg chg="add mod">
          <ac:chgData name="Reza Amini Hounejani" userId="36cb0b73-58b2-4568-a1ab-00cd49301806" providerId="ADAL" clId="{DA8FEA81-1A63-884F-A1C6-520C766F400F}" dt="2022-10-18T09:22:30.663" v="4074" actId="14100"/>
          <ac:cxnSpMkLst>
            <pc:docMk/>
            <pc:sldMk cId="1578300178" sldId="260"/>
            <ac:cxnSpMk id="146" creationId="{12AEF143-AD87-04C1-B968-2FF2D1B64955}"/>
          </ac:cxnSpMkLst>
        </pc:cxnChg>
        <pc:cxnChg chg="add mod">
          <ac:chgData name="Reza Amini Hounejani" userId="36cb0b73-58b2-4568-a1ab-00cd49301806" providerId="ADAL" clId="{DA8FEA81-1A63-884F-A1C6-520C766F400F}" dt="2022-10-18T09:22:30.663" v="4074" actId="14100"/>
          <ac:cxnSpMkLst>
            <pc:docMk/>
            <pc:sldMk cId="1578300178" sldId="260"/>
            <ac:cxnSpMk id="147" creationId="{27B9A043-A5F5-386F-876C-7BCE2308ECE4}"/>
          </ac:cxnSpMkLst>
        </pc:cxnChg>
        <pc:cxnChg chg="add mod">
          <ac:chgData name="Reza Amini Hounejani" userId="36cb0b73-58b2-4568-a1ab-00cd49301806" providerId="ADAL" clId="{DA8FEA81-1A63-884F-A1C6-520C766F400F}" dt="2022-10-18T09:22:30.663" v="4074" actId="14100"/>
          <ac:cxnSpMkLst>
            <pc:docMk/>
            <pc:sldMk cId="1578300178" sldId="260"/>
            <ac:cxnSpMk id="148" creationId="{200A3F2A-CBAA-F012-1D50-E70B3CFA54B6}"/>
          </ac:cxnSpMkLst>
        </pc:cxnChg>
        <pc:cxnChg chg="add mod">
          <ac:chgData name="Reza Amini Hounejani" userId="36cb0b73-58b2-4568-a1ab-00cd49301806" providerId="ADAL" clId="{DA8FEA81-1A63-884F-A1C6-520C766F400F}" dt="2022-10-18T09:22:30.663" v="4074" actId="14100"/>
          <ac:cxnSpMkLst>
            <pc:docMk/>
            <pc:sldMk cId="1578300178" sldId="260"/>
            <ac:cxnSpMk id="149" creationId="{0899FB3D-29B3-350F-31C7-41BC5778A715}"/>
          </ac:cxnSpMkLst>
        </pc:cxnChg>
        <pc:cxnChg chg="add mod">
          <ac:chgData name="Reza Amini Hounejani" userId="36cb0b73-58b2-4568-a1ab-00cd49301806" providerId="ADAL" clId="{DA8FEA81-1A63-884F-A1C6-520C766F400F}" dt="2022-10-18T09:22:30.663" v="4074" actId="14100"/>
          <ac:cxnSpMkLst>
            <pc:docMk/>
            <pc:sldMk cId="1578300178" sldId="260"/>
            <ac:cxnSpMk id="150" creationId="{8D61F765-BD68-9E39-ABF3-814DC9FDECC4}"/>
          </ac:cxnSpMkLst>
        </pc:cxnChg>
      </pc:sldChg>
      <pc:sldChg chg="addSp delSp modSp new mod">
        <pc:chgData name="Reza Amini Hounejani" userId="36cb0b73-58b2-4568-a1ab-00cd49301806" providerId="ADAL" clId="{DA8FEA81-1A63-884F-A1C6-520C766F400F}" dt="2022-11-24T10:26:33.342" v="11674" actId="20577"/>
        <pc:sldMkLst>
          <pc:docMk/>
          <pc:sldMk cId="269800214" sldId="261"/>
        </pc:sldMkLst>
        <pc:spChg chg="del">
          <ac:chgData name="Reza Amini Hounejani" userId="36cb0b73-58b2-4568-a1ab-00cd49301806" providerId="ADAL" clId="{DA8FEA81-1A63-884F-A1C6-520C766F400F}" dt="2022-11-18T14:34:26.518" v="9702" actId="478"/>
          <ac:spMkLst>
            <pc:docMk/>
            <pc:sldMk cId="269800214" sldId="261"/>
            <ac:spMk id="2" creationId="{14EB0654-54D1-F011-6BE9-8B19781D9380}"/>
          </ac:spMkLst>
        </pc:spChg>
        <pc:spChg chg="del">
          <ac:chgData name="Reza Amini Hounejani" userId="36cb0b73-58b2-4568-a1ab-00cd49301806" providerId="ADAL" clId="{DA8FEA81-1A63-884F-A1C6-520C766F400F}" dt="2022-11-18T14:34:27.871" v="9703" actId="478"/>
          <ac:spMkLst>
            <pc:docMk/>
            <pc:sldMk cId="269800214" sldId="261"/>
            <ac:spMk id="3" creationId="{06F98239-8C7E-85F2-321A-2633B45627B7}"/>
          </ac:spMkLst>
        </pc:spChg>
        <pc:spChg chg="add mod">
          <ac:chgData name="Reza Amini Hounejani" userId="36cb0b73-58b2-4568-a1ab-00cd49301806" providerId="ADAL" clId="{DA8FEA81-1A63-884F-A1C6-520C766F400F}" dt="2022-11-24T10:26:33.342" v="11674" actId="20577"/>
          <ac:spMkLst>
            <pc:docMk/>
            <pc:sldMk cId="269800214" sldId="261"/>
            <ac:spMk id="5" creationId="{09854D5C-DCC4-B81B-8CD9-EDDACDBDE5D9}"/>
          </ac:spMkLst>
        </pc:spChg>
        <pc:spChg chg="add mod">
          <ac:chgData name="Reza Amini Hounejani" userId="36cb0b73-58b2-4568-a1ab-00cd49301806" providerId="ADAL" clId="{DA8FEA81-1A63-884F-A1C6-520C766F400F}" dt="2022-11-23T16:45:35.168" v="11386" actId="553"/>
          <ac:spMkLst>
            <pc:docMk/>
            <pc:sldMk cId="269800214" sldId="261"/>
            <ac:spMk id="8" creationId="{4107B0A9-3BD7-3359-E9D8-CE39FA55F2C3}"/>
          </ac:spMkLst>
        </pc:spChg>
        <pc:spChg chg="add mod">
          <ac:chgData name="Reza Amini Hounejani" userId="36cb0b73-58b2-4568-a1ab-00cd49301806" providerId="ADAL" clId="{DA8FEA81-1A63-884F-A1C6-520C766F400F}" dt="2022-11-23T16:45:35.168" v="11386" actId="553"/>
          <ac:spMkLst>
            <pc:docMk/>
            <pc:sldMk cId="269800214" sldId="261"/>
            <ac:spMk id="9" creationId="{28BBB0D4-A16B-4231-7D5D-F8FB27D4A52B}"/>
          </ac:spMkLst>
        </pc:spChg>
        <pc:spChg chg="add mod">
          <ac:chgData name="Reza Amini Hounejani" userId="36cb0b73-58b2-4568-a1ab-00cd49301806" providerId="ADAL" clId="{DA8FEA81-1A63-884F-A1C6-520C766F400F}" dt="2022-11-23T16:45:35.168" v="11386" actId="553"/>
          <ac:spMkLst>
            <pc:docMk/>
            <pc:sldMk cId="269800214" sldId="261"/>
            <ac:spMk id="10" creationId="{A9218915-FDC9-F634-4E32-A64B61A392AD}"/>
          </ac:spMkLst>
        </pc:spChg>
        <pc:spChg chg="add mod">
          <ac:chgData name="Reza Amini Hounejani" userId="36cb0b73-58b2-4568-a1ab-00cd49301806" providerId="ADAL" clId="{DA8FEA81-1A63-884F-A1C6-520C766F400F}" dt="2022-11-23T16:44:52.125" v="11368" actId="571"/>
          <ac:spMkLst>
            <pc:docMk/>
            <pc:sldMk cId="269800214" sldId="261"/>
            <ac:spMk id="11" creationId="{16E4DDC9-F880-6798-FC5A-8897D5F4918E}"/>
          </ac:spMkLst>
        </pc:spChg>
        <pc:spChg chg="add mod">
          <ac:chgData name="Reza Amini Hounejani" userId="36cb0b73-58b2-4568-a1ab-00cd49301806" providerId="ADAL" clId="{DA8FEA81-1A63-884F-A1C6-520C766F400F}" dt="2022-11-23T16:45:35.168" v="11386" actId="553"/>
          <ac:spMkLst>
            <pc:docMk/>
            <pc:sldMk cId="269800214" sldId="261"/>
            <ac:spMk id="12" creationId="{A9EAC924-BA3B-341A-8434-B18DA907D5C0}"/>
          </ac:spMkLst>
        </pc:spChg>
        <pc:spChg chg="add mod">
          <ac:chgData name="Reza Amini Hounejani" userId="36cb0b73-58b2-4568-a1ab-00cd49301806" providerId="ADAL" clId="{DA8FEA81-1A63-884F-A1C6-520C766F400F}" dt="2022-11-23T16:45:35.168" v="11386" actId="553"/>
          <ac:spMkLst>
            <pc:docMk/>
            <pc:sldMk cId="269800214" sldId="261"/>
            <ac:spMk id="13" creationId="{556BC88D-2DF8-4F4B-33DC-15994BD950BE}"/>
          </ac:spMkLst>
        </pc:spChg>
        <pc:spChg chg="add mod">
          <ac:chgData name="Reza Amini Hounejani" userId="36cb0b73-58b2-4568-a1ab-00cd49301806" providerId="ADAL" clId="{DA8FEA81-1A63-884F-A1C6-520C766F400F}" dt="2022-11-23T16:46:27.197" v="11410" actId="553"/>
          <ac:spMkLst>
            <pc:docMk/>
            <pc:sldMk cId="269800214" sldId="261"/>
            <ac:spMk id="14" creationId="{6966B0C9-DD13-5D15-57D9-AF413EEE8299}"/>
          </ac:spMkLst>
        </pc:spChg>
        <pc:spChg chg="add mod">
          <ac:chgData name="Reza Amini Hounejani" userId="36cb0b73-58b2-4568-a1ab-00cd49301806" providerId="ADAL" clId="{DA8FEA81-1A63-884F-A1C6-520C766F400F}" dt="2022-11-23T16:46:27.197" v="11410" actId="553"/>
          <ac:spMkLst>
            <pc:docMk/>
            <pc:sldMk cId="269800214" sldId="261"/>
            <ac:spMk id="15" creationId="{3759AD00-291B-3E41-D50B-AC51A150EFC2}"/>
          </ac:spMkLst>
        </pc:spChg>
        <pc:spChg chg="add mod">
          <ac:chgData name="Reza Amini Hounejani" userId="36cb0b73-58b2-4568-a1ab-00cd49301806" providerId="ADAL" clId="{DA8FEA81-1A63-884F-A1C6-520C766F400F}" dt="2022-11-23T16:46:27.197" v="11410" actId="553"/>
          <ac:spMkLst>
            <pc:docMk/>
            <pc:sldMk cId="269800214" sldId="261"/>
            <ac:spMk id="16" creationId="{6C41E1E8-6169-945F-B897-F23B0B8ED97B}"/>
          </ac:spMkLst>
        </pc:spChg>
        <pc:spChg chg="add mod">
          <ac:chgData name="Reza Amini Hounejani" userId="36cb0b73-58b2-4568-a1ab-00cd49301806" providerId="ADAL" clId="{DA8FEA81-1A63-884F-A1C6-520C766F400F}" dt="2022-11-23T16:46:27.197" v="11410" actId="553"/>
          <ac:spMkLst>
            <pc:docMk/>
            <pc:sldMk cId="269800214" sldId="261"/>
            <ac:spMk id="17" creationId="{8BFF4042-363C-8DEB-E497-EB5B3E8ADDF8}"/>
          </ac:spMkLst>
        </pc:spChg>
        <pc:spChg chg="add del mod">
          <ac:chgData name="Reza Amini Hounejani" userId="36cb0b73-58b2-4568-a1ab-00cd49301806" providerId="ADAL" clId="{DA8FEA81-1A63-884F-A1C6-520C766F400F}" dt="2022-11-22T16:05:09.284" v="10872" actId="478"/>
          <ac:spMkLst>
            <pc:docMk/>
            <pc:sldMk cId="269800214" sldId="261"/>
            <ac:spMk id="24" creationId="{E88BAFD6-7E4A-5A0A-C3B3-5B829BE3EDCF}"/>
          </ac:spMkLst>
        </pc:spChg>
        <pc:spChg chg="add del mod">
          <ac:chgData name="Reza Amini Hounejani" userId="36cb0b73-58b2-4568-a1ab-00cd49301806" providerId="ADAL" clId="{DA8FEA81-1A63-884F-A1C6-520C766F400F}" dt="2022-11-22T16:05:09.284" v="10872" actId="478"/>
          <ac:spMkLst>
            <pc:docMk/>
            <pc:sldMk cId="269800214" sldId="261"/>
            <ac:spMk id="25" creationId="{7857AB6F-2F43-A3F7-239A-C74F1DC76076}"/>
          </ac:spMkLst>
        </pc:spChg>
        <pc:spChg chg="add del mod">
          <ac:chgData name="Reza Amini Hounejani" userId="36cb0b73-58b2-4568-a1ab-00cd49301806" providerId="ADAL" clId="{DA8FEA81-1A63-884F-A1C6-520C766F400F}" dt="2022-11-22T16:05:09.284" v="10872" actId="478"/>
          <ac:spMkLst>
            <pc:docMk/>
            <pc:sldMk cId="269800214" sldId="261"/>
            <ac:spMk id="26" creationId="{1A34CC83-5787-21B7-82D7-418AF0B0FD16}"/>
          </ac:spMkLst>
        </pc:spChg>
        <pc:spChg chg="add del mod">
          <ac:chgData name="Reza Amini Hounejani" userId="36cb0b73-58b2-4568-a1ab-00cd49301806" providerId="ADAL" clId="{DA8FEA81-1A63-884F-A1C6-520C766F400F}" dt="2022-11-18T14:55:55.026" v="9792" actId="478"/>
          <ac:spMkLst>
            <pc:docMk/>
            <pc:sldMk cId="269800214" sldId="261"/>
            <ac:spMk id="27" creationId="{D8733997-7C5D-F15A-BAC7-C2905A7ADEC8}"/>
          </ac:spMkLst>
        </pc:spChg>
        <pc:spChg chg="mod">
          <ac:chgData name="Reza Amini Hounejani" userId="36cb0b73-58b2-4568-a1ab-00cd49301806" providerId="ADAL" clId="{DA8FEA81-1A63-884F-A1C6-520C766F400F}" dt="2022-11-19T17:13:47.371" v="10178" actId="164"/>
          <ac:spMkLst>
            <pc:docMk/>
            <pc:sldMk cId="269800214" sldId="261"/>
            <ac:spMk id="38" creationId="{734DA0E3-C091-76A9-FF80-8D272B0DBC1F}"/>
          </ac:spMkLst>
        </pc:spChg>
        <pc:spChg chg="mod">
          <ac:chgData name="Reza Amini Hounejani" userId="36cb0b73-58b2-4568-a1ab-00cd49301806" providerId="ADAL" clId="{DA8FEA81-1A63-884F-A1C6-520C766F400F}" dt="2022-11-19T17:13:55.749" v="10180" actId="1076"/>
          <ac:spMkLst>
            <pc:docMk/>
            <pc:sldMk cId="269800214" sldId="261"/>
            <ac:spMk id="39" creationId="{56C6EAFF-761E-2B90-9CD7-4BAA60275BA1}"/>
          </ac:spMkLst>
        </pc:spChg>
        <pc:spChg chg="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42" creationId="{E2C43627-401D-531C-E444-1EFA7C50DDF8}"/>
          </ac:spMkLst>
        </pc:spChg>
        <pc:spChg chg="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43" creationId="{AE38F548-E086-9AF2-851B-DED5935176DD}"/>
          </ac:spMkLst>
        </pc:spChg>
        <pc:spChg chg="mod">
          <ac:chgData name="Reza Amini Hounejani" userId="36cb0b73-58b2-4568-a1ab-00cd49301806" providerId="ADAL" clId="{DA8FEA81-1A63-884F-A1C6-520C766F400F}" dt="2022-11-22T15:52:20.827" v="10671" actId="1076"/>
          <ac:spMkLst>
            <pc:docMk/>
            <pc:sldMk cId="269800214" sldId="261"/>
            <ac:spMk id="46" creationId="{170FE39F-B1D3-9815-BDF3-FD22D6228E5A}"/>
          </ac:spMkLst>
        </pc:spChg>
        <pc:spChg chg="add del">
          <ac:chgData name="Reza Amini Hounejani" userId="36cb0b73-58b2-4568-a1ab-00cd49301806" providerId="ADAL" clId="{DA8FEA81-1A63-884F-A1C6-520C766F400F}" dt="2022-11-18T16:17:38.079" v="9819" actId="478"/>
          <ac:spMkLst>
            <pc:docMk/>
            <pc:sldMk cId="269800214" sldId="261"/>
            <ac:spMk id="48" creationId="{16D1BABE-0A07-30BB-BFC8-73475B6F9846}"/>
          </ac:spMkLst>
        </pc:spChg>
        <pc:spChg chg="add del mod">
          <ac:chgData name="Reza Amini Hounejani" userId="36cb0b73-58b2-4568-a1ab-00cd49301806" providerId="ADAL" clId="{DA8FEA81-1A63-884F-A1C6-520C766F400F}" dt="2022-11-19T17:34:10.829" v="10316" actId="478"/>
          <ac:spMkLst>
            <pc:docMk/>
            <pc:sldMk cId="269800214" sldId="261"/>
            <ac:spMk id="52" creationId="{290E85D1-B4C4-69D9-05C0-714A05F3A97D}"/>
          </ac:spMkLst>
        </pc:spChg>
        <pc:spChg chg="add del mod">
          <ac:chgData name="Reza Amini Hounejani" userId="36cb0b73-58b2-4568-a1ab-00cd49301806" providerId="ADAL" clId="{DA8FEA81-1A63-884F-A1C6-520C766F400F}" dt="2022-11-19T17:34:15.527" v="10319" actId="478"/>
          <ac:spMkLst>
            <pc:docMk/>
            <pc:sldMk cId="269800214" sldId="261"/>
            <ac:spMk id="53" creationId="{D2BB9E5B-F770-1F74-11C4-3749FBAD7E01}"/>
          </ac:spMkLst>
        </pc:spChg>
        <pc:spChg chg="add del mod">
          <ac:chgData name="Reza Amini Hounejani" userId="36cb0b73-58b2-4568-a1ab-00cd49301806" providerId="ADAL" clId="{DA8FEA81-1A63-884F-A1C6-520C766F400F}" dt="2022-11-23T15:39:40.565" v="10903" actId="21"/>
          <ac:spMkLst>
            <pc:docMk/>
            <pc:sldMk cId="269800214" sldId="261"/>
            <ac:spMk id="54" creationId="{62F6ED82-A686-538B-D53A-3D20D8B555AD}"/>
          </ac:spMkLst>
        </pc:spChg>
        <pc:spChg chg="add del mod">
          <ac:chgData name="Reza Amini Hounejani" userId="36cb0b73-58b2-4568-a1ab-00cd49301806" providerId="ADAL" clId="{DA8FEA81-1A63-884F-A1C6-520C766F400F}" dt="2022-11-23T15:39:40.565" v="10903" actId="21"/>
          <ac:spMkLst>
            <pc:docMk/>
            <pc:sldMk cId="269800214" sldId="261"/>
            <ac:spMk id="55" creationId="{FC544111-EA62-92AF-039D-876821DB884B}"/>
          </ac:spMkLst>
        </pc:spChg>
        <pc:spChg chg="add mod">
          <ac:chgData name="Reza Amini Hounejani" userId="36cb0b73-58b2-4568-a1ab-00cd49301806" providerId="ADAL" clId="{DA8FEA81-1A63-884F-A1C6-520C766F400F}" dt="2022-11-23T16:45:53.393" v="11390" actId="571"/>
          <ac:spMkLst>
            <pc:docMk/>
            <pc:sldMk cId="269800214" sldId="261"/>
            <ac:spMk id="56" creationId="{7C937CE2-867F-6AFB-E8D4-BFA49A6EBD4C}"/>
          </ac:spMkLst>
        </pc:spChg>
        <pc:spChg chg="add mod">
          <ac:chgData name="Reza Amini Hounejani" userId="36cb0b73-58b2-4568-a1ab-00cd49301806" providerId="ADAL" clId="{DA8FEA81-1A63-884F-A1C6-520C766F400F}" dt="2022-11-23T16:45:53.393" v="11390" actId="571"/>
          <ac:spMkLst>
            <pc:docMk/>
            <pc:sldMk cId="269800214" sldId="261"/>
            <ac:spMk id="57" creationId="{65932EA0-2F2B-582B-0FF4-F5A22AADDF8A}"/>
          </ac:spMkLst>
        </pc:spChg>
        <pc:spChg chg="add mod">
          <ac:chgData name="Reza Amini Hounejani" userId="36cb0b73-58b2-4568-a1ab-00cd49301806" providerId="ADAL" clId="{DA8FEA81-1A63-884F-A1C6-520C766F400F}" dt="2022-11-23T16:45:53.393" v="11390" actId="571"/>
          <ac:spMkLst>
            <pc:docMk/>
            <pc:sldMk cId="269800214" sldId="261"/>
            <ac:spMk id="58" creationId="{55F542B6-EEE9-FF89-5762-01CF36E8E860}"/>
          </ac:spMkLst>
        </pc:spChg>
        <pc:spChg chg="add mod">
          <ac:chgData name="Reza Amini Hounejani" userId="36cb0b73-58b2-4568-a1ab-00cd49301806" providerId="ADAL" clId="{DA8FEA81-1A63-884F-A1C6-520C766F400F}" dt="2022-11-23T16:45:53.393" v="11390" actId="571"/>
          <ac:spMkLst>
            <pc:docMk/>
            <pc:sldMk cId="269800214" sldId="261"/>
            <ac:spMk id="59" creationId="{84F62275-2ED3-4A2A-D34E-E4E4A31D6C99}"/>
          </ac:spMkLst>
        </pc:spChg>
        <pc:spChg chg="add mod">
          <ac:chgData name="Reza Amini Hounejani" userId="36cb0b73-58b2-4568-a1ab-00cd49301806" providerId="ADAL" clId="{DA8FEA81-1A63-884F-A1C6-520C766F400F}" dt="2022-11-23T16:45:53.393" v="11390" actId="571"/>
          <ac:spMkLst>
            <pc:docMk/>
            <pc:sldMk cId="269800214" sldId="261"/>
            <ac:spMk id="60" creationId="{0899B095-13CE-C4DF-D68D-DC4DAEAE2FC0}"/>
          </ac:spMkLst>
        </pc:spChg>
        <pc:spChg chg="add mod">
          <ac:chgData name="Reza Amini Hounejani" userId="36cb0b73-58b2-4568-a1ab-00cd49301806" providerId="ADAL" clId="{DA8FEA81-1A63-884F-A1C6-520C766F400F}" dt="2022-11-23T16:45:53.393" v="11390" actId="571"/>
          <ac:spMkLst>
            <pc:docMk/>
            <pc:sldMk cId="269800214" sldId="261"/>
            <ac:spMk id="61" creationId="{0B24528A-D29F-1EF2-D421-DE45246BCAB1}"/>
          </ac:spMkLst>
        </pc:spChg>
        <pc:spChg chg="add mod">
          <ac:chgData name="Reza Amini Hounejani" userId="36cb0b73-58b2-4568-a1ab-00cd49301806" providerId="ADAL" clId="{DA8FEA81-1A63-884F-A1C6-520C766F400F}" dt="2022-11-23T16:45:53.393" v="11390" actId="571"/>
          <ac:spMkLst>
            <pc:docMk/>
            <pc:sldMk cId="269800214" sldId="261"/>
            <ac:spMk id="62" creationId="{78DE8071-3648-34AB-B9D9-4E45E4A84927}"/>
          </ac:spMkLst>
        </pc:spChg>
        <pc:spChg chg="add mod">
          <ac:chgData name="Reza Amini Hounejani" userId="36cb0b73-58b2-4568-a1ab-00cd49301806" providerId="ADAL" clId="{DA8FEA81-1A63-884F-A1C6-520C766F400F}" dt="2022-11-23T16:45:53.393" v="11390" actId="571"/>
          <ac:spMkLst>
            <pc:docMk/>
            <pc:sldMk cId="269800214" sldId="261"/>
            <ac:spMk id="63" creationId="{FA2699CD-F8D7-84A9-98D4-6FD51EC8D461}"/>
          </ac:spMkLst>
        </pc:spChg>
        <pc:spChg chg="add del mod">
          <ac:chgData name="Reza Amini Hounejani" userId="36cb0b73-58b2-4568-a1ab-00cd49301806" providerId="ADAL" clId="{DA8FEA81-1A63-884F-A1C6-520C766F400F}" dt="2022-11-23T16:27:20.607" v="10999" actId="478"/>
          <ac:spMkLst>
            <pc:docMk/>
            <pc:sldMk cId="269800214" sldId="261"/>
            <ac:spMk id="64" creationId="{CF97D410-C03E-5B36-2553-20B548FF46E2}"/>
          </ac:spMkLst>
        </pc:spChg>
        <pc:spChg chg="add mod">
          <ac:chgData name="Reza Amini Hounejani" userId="36cb0b73-58b2-4568-a1ab-00cd49301806" providerId="ADAL" clId="{DA8FEA81-1A63-884F-A1C6-520C766F400F}" dt="2022-11-23T16:46:27.197" v="11410" actId="553"/>
          <ac:spMkLst>
            <pc:docMk/>
            <pc:sldMk cId="269800214" sldId="261"/>
            <ac:spMk id="65" creationId="{995AB49B-FE61-960A-84F8-F0A5A3C8312D}"/>
          </ac:spMkLst>
        </pc:spChg>
        <pc:spChg chg="add del mod">
          <ac:chgData name="Reza Amini Hounejani" userId="36cb0b73-58b2-4568-a1ab-00cd49301806" providerId="ADAL" clId="{DA8FEA81-1A63-884F-A1C6-520C766F400F}" dt="2022-11-23T16:28:08.269" v="11019" actId="478"/>
          <ac:spMkLst>
            <pc:docMk/>
            <pc:sldMk cId="269800214" sldId="261"/>
            <ac:spMk id="66" creationId="{0EF4334C-D35D-65F8-3E39-F02257BB240A}"/>
          </ac:spMkLst>
        </pc:spChg>
        <pc:spChg chg="add mod">
          <ac:chgData name="Reza Amini Hounejani" userId="36cb0b73-58b2-4568-a1ab-00cd49301806" providerId="ADAL" clId="{DA8FEA81-1A63-884F-A1C6-520C766F400F}" dt="2022-11-23T16:46:27.197" v="11410" actId="553"/>
          <ac:spMkLst>
            <pc:docMk/>
            <pc:sldMk cId="269800214" sldId="261"/>
            <ac:spMk id="67" creationId="{F719078E-E7E2-2DEB-9E1C-5CA6130DCCC4}"/>
          </ac:spMkLst>
        </pc:spChg>
        <pc:spChg chg="add mod">
          <ac:chgData name="Reza Amini Hounejani" userId="36cb0b73-58b2-4568-a1ab-00cd49301806" providerId="ADAL" clId="{DA8FEA81-1A63-884F-A1C6-520C766F400F}" dt="2022-11-23T16:46:27.197" v="11410" actId="553"/>
          <ac:spMkLst>
            <pc:docMk/>
            <pc:sldMk cId="269800214" sldId="261"/>
            <ac:spMk id="68" creationId="{543F45AD-3715-E79A-EFC8-94C9A38AA594}"/>
          </ac:spMkLst>
        </pc:spChg>
        <pc:spChg chg="add mod">
          <ac:chgData name="Reza Amini Hounejani" userId="36cb0b73-58b2-4568-a1ab-00cd49301806" providerId="ADAL" clId="{DA8FEA81-1A63-884F-A1C6-520C766F400F}" dt="2022-11-23T16:46:27.197" v="11410" actId="553"/>
          <ac:spMkLst>
            <pc:docMk/>
            <pc:sldMk cId="269800214" sldId="261"/>
            <ac:spMk id="69" creationId="{64591331-C874-2B95-99B8-5C3A4EF8A9D1}"/>
          </ac:spMkLst>
        </pc:spChg>
        <pc:spChg chg="add mod">
          <ac:chgData name="Reza Amini Hounejani" userId="36cb0b73-58b2-4568-a1ab-00cd49301806" providerId="ADAL" clId="{DA8FEA81-1A63-884F-A1C6-520C766F400F}" dt="2022-11-18T16:48:33.724" v="9964" actId="571"/>
          <ac:spMkLst>
            <pc:docMk/>
            <pc:sldMk cId="269800214" sldId="261"/>
            <ac:spMk id="70" creationId="{DEBE9C91-F4BB-1960-636D-999954C9897B}"/>
          </ac:spMkLst>
        </pc:spChg>
        <pc:spChg chg="add del mod">
          <ac:chgData name="Reza Amini Hounejani" userId="36cb0b73-58b2-4568-a1ab-00cd49301806" providerId="ADAL" clId="{DA8FEA81-1A63-884F-A1C6-520C766F400F}" dt="2022-11-23T16:29:07.983" v="11044" actId="478"/>
          <ac:spMkLst>
            <pc:docMk/>
            <pc:sldMk cId="269800214" sldId="261"/>
            <ac:spMk id="71" creationId="{B16C8FD2-C42F-E536-B606-FE11EBA9A8D5}"/>
          </ac:spMkLst>
        </pc:spChg>
        <pc:spChg chg="add del mod">
          <ac:chgData name="Reza Amini Hounejani" userId="36cb0b73-58b2-4568-a1ab-00cd49301806" providerId="ADAL" clId="{DA8FEA81-1A63-884F-A1C6-520C766F400F}" dt="2022-11-23T16:29:09.630" v="11045" actId="478"/>
          <ac:spMkLst>
            <pc:docMk/>
            <pc:sldMk cId="269800214" sldId="261"/>
            <ac:spMk id="72" creationId="{A58C39C2-83B1-15F7-EE44-4CB89340CB84}"/>
          </ac:spMkLst>
        </pc:spChg>
        <pc:spChg chg="add mod">
          <ac:chgData name="Reza Amini Hounejani" userId="36cb0b73-58b2-4568-a1ab-00cd49301806" providerId="ADAL" clId="{DA8FEA81-1A63-884F-A1C6-520C766F400F}" dt="2022-11-23T16:46:27.197" v="11410" actId="553"/>
          <ac:spMkLst>
            <pc:docMk/>
            <pc:sldMk cId="269800214" sldId="261"/>
            <ac:spMk id="73" creationId="{82687445-DD90-0D8F-E1CB-774F75C3B686}"/>
          </ac:spMkLst>
        </pc:spChg>
        <pc:spChg chg="add del mod">
          <ac:chgData name="Reza Amini Hounejani" userId="36cb0b73-58b2-4568-a1ab-00cd49301806" providerId="ADAL" clId="{DA8FEA81-1A63-884F-A1C6-520C766F400F}" dt="2022-11-23T16:25:59.429" v="10956" actId="478"/>
          <ac:spMkLst>
            <pc:docMk/>
            <pc:sldMk cId="269800214" sldId="261"/>
            <ac:spMk id="74" creationId="{899B55D9-46DA-BCCE-4587-FF192360DAC3}"/>
          </ac:spMkLst>
        </pc:spChg>
        <pc:spChg chg="add mod">
          <ac:chgData name="Reza Amini Hounejani" userId="36cb0b73-58b2-4568-a1ab-00cd49301806" providerId="ADAL" clId="{DA8FEA81-1A63-884F-A1C6-520C766F400F}" dt="2022-11-19T17:14:20.600" v="10185" actId="164"/>
          <ac:spMkLst>
            <pc:docMk/>
            <pc:sldMk cId="269800214" sldId="261"/>
            <ac:spMk id="75" creationId="{2C4C3764-24E4-8CB3-3329-F4C487931512}"/>
          </ac:spMkLst>
        </pc:spChg>
        <pc:spChg chg="add mod">
          <ac:chgData name="Reza Amini Hounejani" userId="36cb0b73-58b2-4568-a1ab-00cd49301806" providerId="ADAL" clId="{DA8FEA81-1A63-884F-A1C6-520C766F400F}" dt="2022-11-19T17:14:20.600" v="10185" actId="164"/>
          <ac:spMkLst>
            <pc:docMk/>
            <pc:sldMk cId="269800214" sldId="261"/>
            <ac:spMk id="76" creationId="{8619BDF1-DEAB-713F-F711-74CC2DA432CD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77" creationId="{D5E63A82-E9FA-A27E-28D0-201337654F52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78" creationId="{15D65DE8-A384-1A48-093E-60CE87ECCC56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79" creationId="{CA4266E7-DF60-AACD-2C21-12A5D1C2D36E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80" creationId="{B81E22CC-AEDB-956B-67D8-F5108DCB04C5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81" creationId="{5248D931-54DC-A583-05DE-C513B47A842B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82" creationId="{6D78C950-63F5-D8FA-A9BE-F325F6EB8BF7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83" creationId="{17C943D7-0B9A-31A0-A4F7-8F73022C8723}"/>
          </ac:spMkLst>
        </pc:spChg>
        <pc:spChg chg="add mod">
          <ac:chgData name="Reza Amini Hounejani" userId="36cb0b73-58b2-4568-a1ab-00cd49301806" providerId="ADAL" clId="{DA8FEA81-1A63-884F-A1C6-520C766F400F}" dt="2022-11-19T17:11:15.261" v="10108" actId="571"/>
          <ac:spMkLst>
            <pc:docMk/>
            <pc:sldMk cId="269800214" sldId="261"/>
            <ac:spMk id="84" creationId="{A6F9FC42-E247-D064-15CA-A1CA6BEC5C7D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85" creationId="{495E5BF3-1ACA-43C3-AF00-3602C397D141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86" creationId="{4E6EA6E1-1707-B702-54E9-1561587C2A3D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87" creationId="{13B03E4F-C204-A6F4-C1DF-202A7C209491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88" creationId="{743F00E5-DCEA-D991-0B25-309C141B470A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89" creationId="{E37A0CDE-0104-CDED-B80E-39AD3CF6CED3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90" creationId="{25FC20D6-467F-B2DD-63E2-98E8A2712F38}"/>
          </ac:spMkLst>
        </pc:spChg>
        <pc:spChg chg="add mod">
          <ac:chgData name="Reza Amini Hounejani" userId="36cb0b73-58b2-4568-a1ab-00cd49301806" providerId="ADAL" clId="{DA8FEA81-1A63-884F-A1C6-520C766F400F}" dt="2022-11-19T17:14:50.107" v="10189" actId="164"/>
          <ac:spMkLst>
            <pc:docMk/>
            <pc:sldMk cId="269800214" sldId="261"/>
            <ac:spMk id="91" creationId="{66BD9DDB-F4E7-D804-C774-EE6EA58AFBEA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95" creationId="{F8D2F648-5274-FFAC-66E4-4398F3E7C211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96" creationId="{3FB7B97A-4C3E-55DD-9655-0AF8467E921C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97" creationId="{D468DD85-F494-D7C7-E9B6-D7F4F9487CF3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98" creationId="{6DB42AD4-3EF8-EB32-70C1-A982E523D133}"/>
          </ac:spMkLst>
        </pc:spChg>
        <pc:spChg chg="add del mod">
          <ac:chgData name="Reza Amini Hounejani" userId="36cb0b73-58b2-4568-a1ab-00cd49301806" providerId="ADAL" clId="{DA8FEA81-1A63-884F-A1C6-520C766F400F}" dt="2022-11-22T15:43:19.443" v="10507" actId="478"/>
          <ac:spMkLst>
            <pc:docMk/>
            <pc:sldMk cId="269800214" sldId="261"/>
            <ac:spMk id="99" creationId="{4A48C1DA-CCF4-F24F-173B-00E68130453C}"/>
          </ac:spMkLst>
        </pc:spChg>
        <pc:spChg chg="add del mod">
          <ac:chgData name="Reza Amini Hounejani" userId="36cb0b73-58b2-4568-a1ab-00cd49301806" providerId="ADAL" clId="{DA8FEA81-1A63-884F-A1C6-520C766F400F}" dt="2022-11-22T15:43:17.319" v="10506" actId="478"/>
          <ac:spMkLst>
            <pc:docMk/>
            <pc:sldMk cId="269800214" sldId="261"/>
            <ac:spMk id="100" creationId="{A38147E3-392F-DC5E-7F5F-CD4CBFE01288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01" creationId="{F17DDE89-5136-0F41-988D-6C26ED5C0CBB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02" creationId="{8C479203-A03D-FEC3-5356-7A68350F798E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03" creationId="{EAD6522A-3166-2386-4D90-94F619F06FBF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04" creationId="{3D9A4359-9D4B-9A59-C06C-5195B5E1A11F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05" creationId="{0BCD9791-1427-C28F-6A15-2EA6E27D0439}"/>
          </ac:spMkLst>
        </pc:spChg>
        <pc:spChg chg="add del mod">
          <ac:chgData name="Reza Amini Hounejani" userId="36cb0b73-58b2-4568-a1ab-00cd49301806" providerId="ADAL" clId="{DA8FEA81-1A63-884F-A1C6-520C766F400F}" dt="2022-11-19T17:17:17.357" v="10223" actId="478"/>
          <ac:spMkLst>
            <pc:docMk/>
            <pc:sldMk cId="269800214" sldId="261"/>
            <ac:spMk id="106" creationId="{516C7ADD-D9ED-2EEF-394A-94E4EDC332C3}"/>
          </ac:spMkLst>
        </pc:spChg>
        <pc:spChg chg="add del mod">
          <ac:chgData name="Reza Amini Hounejani" userId="36cb0b73-58b2-4568-a1ab-00cd49301806" providerId="ADAL" clId="{DA8FEA81-1A63-884F-A1C6-520C766F400F}" dt="2022-11-19T17:17:17.958" v="10224" actId="478"/>
          <ac:spMkLst>
            <pc:docMk/>
            <pc:sldMk cId="269800214" sldId="261"/>
            <ac:spMk id="107" creationId="{92848DEF-7B2F-0C16-EBCB-7580E7748B0A}"/>
          </ac:spMkLst>
        </pc:spChg>
        <pc:spChg chg="add del mod">
          <ac:chgData name="Reza Amini Hounejani" userId="36cb0b73-58b2-4568-a1ab-00cd49301806" providerId="ADAL" clId="{DA8FEA81-1A63-884F-A1C6-520C766F400F}" dt="2022-11-19T17:17:19.248" v="10225" actId="478"/>
          <ac:spMkLst>
            <pc:docMk/>
            <pc:sldMk cId="269800214" sldId="261"/>
            <ac:spMk id="108" creationId="{D902B1FB-D1B8-42A2-F3C4-6639A87A0C3A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09" creationId="{4D3F3D05-3A12-59BB-82C0-948099B25401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10" creationId="{A4F973A4-AEE1-2E4E-E3FA-9CC4F02FAF72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11" creationId="{E300B438-C2C0-F8D2-3AC0-E248BEE146E1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13" creationId="{E9047E8F-E566-569F-EEA7-FBD4A5E653E0}"/>
          </ac:spMkLst>
        </pc:spChg>
        <pc:spChg chg="add mod">
          <ac:chgData name="Reza Amini Hounejani" userId="36cb0b73-58b2-4568-a1ab-00cd49301806" providerId="ADAL" clId="{DA8FEA81-1A63-884F-A1C6-520C766F400F}" dt="2022-11-19T17:34:08.896" v="10315"/>
          <ac:spMkLst>
            <pc:docMk/>
            <pc:sldMk cId="269800214" sldId="261"/>
            <ac:spMk id="114" creationId="{F7D323BC-7669-8E39-3C86-2191659678EF}"/>
          </ac:spMkLst>
        </pc:spChg>
        <pc:spChg chg="add mod">
          <ac:chgData name="Reza Amini Hounejani" userId="36cb0b73-58b2-4568-a1ab-00cd49301806" providerId="ADAL" clId="{DA8FEA81-1A63-884F-A1C6-520C766F400F}" dt="2022-11-19T17:34:30.445" v="10326" actId="1076"/>
          <ac:spMkLst>
            <pc:docMk/>
            <pc:sldMk cId="269800214" sldId="261"/>
            <ac:spMk id="115" creationId="{63F97AB8-C9CD-67D8-6612-12AE8A178CB3}"/>
          </ac:spMkLst>
        </pc:spChg>
        <pc:spChg chg="add mod">
          <ac:chgData name="Reza Amini Hounejani" userId="36cb0b73-58b2-4568-a1ab-00cd49301806" providerId="ADAL" clId="{DA8FEA81-1A63-884F-A1C6-520C766F400F}" dt="2022-11-23T16:44:59.072" v="11370" actId="571"/>
          <ac:spMkLst>
            <pc:docMk/>
            <pc:sldMk cId="269800214" sldId="261"/>
            <ac:spMk id="119" creationId="{CA781EB6-2506-661C-ABC4-013870D3D4AC}"/>
          </ac:spMkLst>
        </pc:spChg>
        <pc:spChg chg="add mod">
          <ac:chgData name="Reza Amini Hounejani" userId="36cb0b73-58b2-4568-a1ab-00cd49301806" providerId="ADAL" clId="{DA8FEA81-1A63-884F-A1C6-520C766F400F}" dt="2022-11-23T16:45:35.168" v="11386" actId="553"/>
          <ac:spMkLst>
            <pc:docMk/>
            <pc:sldMk cId="269800214" sldId="261"/>
            <ac:spMk id="120" creationId="{47DC6C1E-BD95-1EE7-30A4-F4AA3EB6996F}"/>
          </ac:spMkLst>
        </pc:spChg>
        <pc:spChg chg="add mod">
          <ac:chgData name="Reza Amini Hounejani" userId="36cb0b73-58b2-4568-a1ab-00cd49301806" providerId="ADAL" clId="{DA8FEA81-1A63-884F-A1C6-520C766F400F}" dt="2022-11-23T16:44:59.072" v="11370" actId="571"/>
          <ac:spMkLst>
            <pc:docMk/>
            <pc:sldMk cId="269800214" sldId="261"/>
            <ac:spMk id="121" creationId="{7367E09A-747F-07CA-6A79-CBA33EDB012A}"/>
          </ac:spMkLst>
        </pc:spChg>
        <pc:spChg chg="add mod">
          <ac:chgData name="Reza Amini Hounejani" userId="36cb0b73-58b2-4568-a1ab-00cd49301806" providerId="ADAL" clId="{DA8FEA81-1A63-884F-A1C6-520C766F400F}" dt="2022-11-23T16:44:59.072" v="11370" actId="571"/>
          <ac:spMkLst>
            <pc:docMk/>
            <pc:sldMk cId="269800214" sldId="261"/>
            <ac:spMk id="122" creationId="{877284A1-C1C0-AA45-CB24-79306D9A8998}"/>
          </ac:spMkLst>
        </pc:spChg>
        <pc:spChg chg="add mod">
          <ac:chgData name="Reza Amini Hounejani" userId="36cb0b73-58b2-4568-a1ab-00cd49301806" providerId="ADAL" clId="{DA8FEA81-1A63-884F-A1C6-520C766F400F}" dt="2022-11-23T16:44:59.072" v="11370" actId="571"/>
          <ac:spMkLst>
            <pc:docMk/>
            <pc:sldMk cId="269800214" sldId="261"/>
            <ac:spMk id="124" creationId="{9A5A2823-5D2E-6098-75C7-19AFB39682CB}"/>
          </ac:spMkLst>
        </pc:spChg>
        <pc:spChg chg="add mod">
          <ac:chgData name="Reza Amini Hounejani" userId="36cb0b73-58b2-4568-a1ab-00cd49301806" providerId="ADAL" clId="{DA8FEA81-1A63-884F-A1C6-520C766F400F}" dt="2022-11-23T16:44:59.072" v="11370" actId="571"/>
          <ac:spMkLst>
            <pc:docMk/>
            <pc:sldMk cId="269800214" sldId="261"/>
            <ac:spMk id="125" creationId="{41911E68-5387-C85C-7347-5621EFC8695B}"/>
          </ac:spMkLst>
        </pc:spChg>
        <pc:spChg chg="add mod">
          <ac:chgData name="Reza Amini Hounejani" userId="36cb0b73-58b2-4568-a1ab-00cd49301806" providerId="ADAL" clId="{DA8FEA81-1A63-884F-A1C6-520C766F400F}" dt="2022-11-23T16:44:59.072" v="11370" actId="571"/>
          <ac:spMkLst>
            <pc:docMk/>
            <pc:sldMk cId="269800214" sldId="261"/>
            <ac:spMk id="126" creationId="{EEBE429C-59D6-82D1-B119-77BF1B8DAE59}"/>
          </ac:spMkLst>
        </pc:spChg>
        <pc:spChg chg="add mod">
          <ac:chgData name="Reza Amini Hounejani" userId="36cb0b73-58b2-4568-a1ab-00cd49301806" providerId="ADAL" clId="{DA8FEA81-1A63-884F-A1C6-520C766F400F}" dt="2022-11-23T16:44:59.072" v="11370" actId="571"/>
          <ac:spMkLst>
            <pc:docMk/>
            <pc:sldMk cId="269800214" sldId="261"/>
            <ac:spMk id="127" creationId="{4BB0F239-C14D-841D-097C-D32C26E3ACEC}"/>
          </ac:spMkLst>
        </pc:spChg>
        <pc:spChg chg="add del mod">
          <ac:chgData name="Reza Amini Hounejani" userId="36cb0b73-58b2-4568-a1ab-00cd49301806" providerId="ADAL" clId="{DA8FEA81-1A63-884F-A1C6-520C766F400F}" dt="2022-11-23T16:44:02.052" v="11342" actId="478"/>
          <ac:spMkLst>
            <pc:docMk/>
            <pc:sldMk cId="269800214" sldId="261"/>
            <ac:spMk id="128" creationId="{FA3BF1CA-C5C1-BC0A-0D40-099B3C935DC8}"/>
          </ac:spMkLst>
        </pc:spChg>
        <pc:spChg chg="add mod">
          <ac:chgData name="Reza Amini Hounejani" userId="36cb0b73-58b2-4568-a1ab-00cd49301806" providerId="ADAL" clId="{DA8FEA81-1A63-884F-A1C6-520C766F400F}" dt="2022-11-23T16:45:35.168" v="11386" actId="553"/>
          <ac:spMkLst>
            <pc:docMk/>
            <pc:sldMk cId="269800214" sldId="261"/>
            <ac:spMk id="129" creationId="{883E47B9-E2D6-63E2-96A9-9453D5808C86}"/>
          </ac:spMkLst>
        </pc:spChg>
        <pc:spChg chg="add del mod">
          <ac:chgData name="Reza Amini Hounejani" userId="36cb0b73-58b2-4568-a1ab-00cd49301806" providerId="ADAL" clId="{DA8FEA81-1A63-884F-A1C6-520C766F400F}" dt="2022-11-23T16:44:09.533" v="11344" actId="478"/>
          <ac:spMkLst>
            <pc:docMk/>
            <pc:sldMk cId="269800214" sldId="261"/>
            <ac:spMk id="130" creationId="{68FDF405-ED4C-2E9E-F3EB-935A801CB231}"/>
          </ac:spMkLst>
        </pc:spChg>
        <pc:spChg chg="add mod">
          <ac:chgData name="Reza Amini Hounejani" userId="36cb0b73-58b2-4568-a1ab-00cd49301806" providerId="ADAL" clId="{DA8FEA81-1A63-884F-A1C6-520C766F400F}" dt="2022-11-23T16:45:35.168" v="11386" actId="553"/>
          <ac:spMkLst>
            <pc:docMk/>
            <pc:sldMk cId="269800214" sldId="261"/>
            <ac:spMk id="131" creationId="{26687ACC-CFD0-1031-1A88-406829F5248C}"/>
          </ac:spMkLst>
        </pc:spChg>
        <pc:spChg chg="add del mod">
          <ac:chgData name="Reza Amini Hounejani" userId="36cb0b73-58b2-4568-a1ab-00cd49301806" providerId="ADAL" clId="{DA8FEA81-1A63-884F-A1C6-520C766F400F}" dt="2022-11-23T16:44:26.009" v="11362" actId="478"/>
          <ac:spMkLst>
            <pc:docMk/>
            <pc:sldMk cId="269800214" sldId="261"/>
            <ac:spMk id="132" creationId="{160B8696-A7B8-F0ED-FC84-72811CF73752}"/>
          </ac:spMkLst>
        </pc:spChg>
        <pc:spChg chg="add mod">
          <ac:chgData name="Reza Amini Hounejani" userId="36cb0b73-58b2-4568-a1ab-00cd49301806" providerId="ADAL" clId="{DA8FEA81-1A63-884F-A1C6-520C766F400F}" dt="2022-11-23T16:46:47.713" v="11412" actId="1076"/>
          <ac:spMkLst>
            <pc:docMk/>
            <pc:sldMk cId="269800214" sldId="261"/>
            <ac:spMk id="133" creationId="{A5CD06CB-8095-7B9D-EE8E-7D73B22549F2}"/>
          </ac:spMkLst>
        </pc:spChg>
        <pc:spChg chg="add mod">
          <ac:chgData name="Reza Amini Hounejani" userId="36cb0b73-58b2-4568-a1ab-00cd49301806" providerId="ADAL" clId="{DA8FEA81-1A63-884F-A1C6-520C766F400F}" dt="2022-11-23T16:46:44.596" v="11411" actId="1076"/>
          <ac:spMkLst>
            <pc:docMk/>
            <pc:sldMk cId="269800214" sldId="261"/>
            <ac:spMk id="134" creationId="{13B655E6-08F6-FFBD-8255-BA625751B9D9}"/>
          </ac:spMkLst>
        </pc:spChg>
        <pc:spChg chg="add del mod">
          <ac:chgData name="Reza Amini Hounejani" userId="36cb0b73-58b2-4568-a1ab-00cd49301806" providerId="ADAL" clId="{DA8FEA81-1A63-884F-A1C6-520C766F400F}" dt="2022-11-22T15:46:11.533" v="10548" actId="478"/>
          <ac:spMkLst>
            <pc:docMk/>
            <pc:sldMk cId="269800214" sldId="261"/>
            <ac:spMk id="145" creationId="{D563DC0C-60B1-26AD-90F9-9A48D2673AA9}"/>
          </ac:spMkLst>
        </pc:spChg>
        <pc:spChg chg="add mod">
          <ac:chgData name="Reza Amini Hounejani" userId="36cb0b73-58b2-4568-a1ab-00cd49301806" providerId="ADAL" clId="{DA8FEA81-1A63-884F-A1C6-520C766F400F}" dt="2022-11-23T09:51:52.918" v="10876" actId="14100"/>
          <ac:spMkLst>
            <pc:docMk/>
            <pc:sldMk cId="269800214" sldId="261"/>
            <ac:spMk id="147" creationId="{EDC7F003-892D-1328-9AAE-779395035463}"/>
          </ac:spMkLst>
        </pc:spChg>
        <pc:spChg chg="add mod">
          <ac:chgData name="Reza Amini Hounejani" userId="36cb0b73-58b2-4568-a1ab-00cd49301806" providerId="ADAL" clId="{DA8FEA81-1A63-884F-A1C6-520C766F400F}" dt="2022-11-23T09:51:43.440" v="10873" actId="1038"/>
          <ac:spMkLst>
            <pc:docMk/>
            <pc:sldMk cId="269800214" sldId="261"/>
            <ac:spMk id="148" creationId="{3117E936-B24F-CA45-EFA2-22E50F9E400A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52" creationId="{D87CAE94-91E1-B76E-5554-0BFA55C138A7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53" creationId="{C6E0C038-F1D6-80DC-559F-9ACB5C07EE9B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59" creationId="{27D0F404-0170-EB20-EC22-322A94215147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60" creationId="{36AD7991-1A76-5268-C66C-728CA43E1A44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61" creationId="{50C160F3-C905-21C4-8C46-39E0DDCD23D6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62" creationId="{E4F53E5D-B616-0508-AF8A-128F8C67C649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63" creationId="{8B7A7743-845C-31FC-B616-81C26EE301E8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64" creationId="{C954E92D-86D3-00B3-AB72-DF89E89B65DA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65" creationId="{D43A7020-7E36-1F7C-75A0-07D916C64E10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66" creationId="{8B524243-9615-62AA-FB46-CA77D0353625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67" creationId="{0D19D99E-D0FB-8825-D947-6C42DBCCFBA3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68" creationId="{4B835E8C-08CF-1EF8-E1A0-307938468D20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69" creationId="{44103B16-1246-667E-40D8-DEA20AA4CF9E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71" creationId="{158E1E73-7105-BF3D-AFAE-0C784D2CAB36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72" creationId="{5356297D-49CC-886F-6FF6-68213F7D4F7F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73" creationId="{3F83CF94-E5FD-E5EB-EBF6-EEB5ADEB3678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74" creationId="{39CF1E4F-9665-4C54-CD9F-D3AE45CD0F86}"/>
          </ac:spMkLst>
        </pc:spChg>
        <pc:spChg chg="mod">
          <ac:chgData name="Reza Amini Hounejani" userId="36cb0b73-58b2-4568-a1ab-00cd49301806" providerId="ADAL" clId="{DA8FEA81-1A63-884F-A1C6-520C766F400F}" dt="2022-11-22T15:47:25.205" v="10572" actId="571"/>
          <ac:spMkLst>
            <pc:docMk/>
            <pc:sldMk cId="269800214" sldId="261"/>
            <ac:spMk id="175" creationId="{1D6D938B-2F67-3D09-0E99-BA799ECC9AFC}"/>
          </ac:spMkLst>
        </pc:spChg>
        <pc:spChg chg="add del mod">
          <ac:chgData name="Reza Amini Hounejani" userId="36cb0b73-58b2-4568-a1ab-00cd49301806" providerId="ADAL" clId="{DA8FEA81-1A63-884F-A1C6-520C766F400F}" dt="2022-11-22T15:47:46.330" v="10576" actId="478"/>
          <ac:spMkLst>
            <pc:docMk/>
            <pc:sldMk cId="269800214" sldId="261"/>
            <ac:spMk id="176" creationId="{6D35E589-E699-0C5F-4765-0EEA84B36F02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77" creationId="{09C9C804-1F81-ACD7-C5BE-9FC7D4130326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78" creationId="{710E140C-7166-C691-045E-3D25357CFB58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79" creationId="{AC2544DD-26DC-E8D9-CF34-8192E0052A73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80" creationId="{3709937E-D379-8F71-A487-3DD7A3D333F6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81" creationId="{C2632B1E-4D25-9D08-5D09-A5A94EEF0F9F}"/>
          </ac:spMkLst>
        </pc:spChg>
        <pc:spChg chg="add mod">
          <ac:chgData name="Reza Amini Hounejani" userId="36cb0b73-58b2-4568-a1ab-00cd49301806" providerId="ADAL" clId="{DA8FEA81-1A63-884F-A1C6-520C766F400F}" dt="2022-11-22T15:52:02.807" v="10667" actId="571"/>
          <ac:spMkLst>
            <pc:docMk/>
            <pc:sldMk cId="269800214" sldId="261"/>
            <ac:spMk id="182" creationId="{2150D47E-DE03-4D93-7558-6B4EA7825F10}"/>
          </ac:spMkLst>
        </pc:spChg>
        <pc:spChg chg="add mod">
          <ac:chgData name="Reza Amini Hounejani" userId="36cb0b73-58b2-4568-a1ab-00cd49301806" providerId="ADAL" clId="{DA8FEA81-1A63-884F-A1C6-520C766F400F}" dt="2022-11-22T15:58:19.334" v="10724" actId="1036"/>
          <ac:spMkLst>
            <pc:docMk/>
            <pc:sldMk cId="269800214" sldId="261"/>
            <ac:spMk id="184" creationId="{185C3557-D8DC-DB8D-A4BE-9625B0E70AF4}"/>
          </ac:spMkLst>
        </pc:spChg>
        <pc:spChg chg="add mod">
          <ac:chgData name="Reza Amini Hounejani" userId="36cb0b73-58b2-4568-a1ab-00cd49301806" providerId="ADAL" clId="{DA8FEA81-1A63-884F-A1C6-520C766F400F}" dt="2022-11-22T15:58:08.906" v="10721" actId="1036"/>
          <ac:spMkLst>
            <pc:docMk/>
            <pc:sldMk cId="269800214" sldId="261"/>
            <ac:spMk id="185" creationId="{BFC1C7E5-ED44-4479-E4B7-4B598112AC5F}"/>
          </ac:spMkLst>
        </pc:spChg>
        <pc:spChg chg="add mod">
          <ac:chgData name="Reza Amini Hounejani" userId="36cb0b73-58b2-4568-a1ab-00cd49301806" providerId="ADAL" clId="{DA8FEA81-1A63-884F-A1C6-520C766F400F}" dt="2022-11-22T15:58:19.334" v="10724" actId="1036"/>
          <ac:spMkLst>
            <pc:docMk/>
            <pc:sldMk cId="269800214" sldId="261"/>
            <ac:spMk id="186" creationId="{4F1875FA-71EC-5048-6B01-05061CBBBF34}"/>
          </ac:spMkLst>
        </pc:spChg>
        <pc:spChg chg="add mod">
          <ac:chgData name="Reza Amini Hounejani" userId="36cb0b73-58b2-4568-a1ab-00cd49301806" providerId="ADAL" clId="{DA8FEA81-1A63-884F-A1C6-520C766F400F}" dt="2022-11-22T15:58:08.906" v="10721" actId="1036"/>
          <ac:spMkLst>
            <pc:docMk/>
            <pc:sldMk cId="269800214" sldId="261"/>
            <ac:spMk id="187" creationId="{12C5F12A-CF64-4B47-05BB-851190773E26}"/>
          </ac:spMkLst>
        </pc:spChg>
        <pc:spChg chg="add del mod">
          <ac:chgData name="Reza Amini Hounejani" userId="36cb0b73-58b2-4568-a1ab-00cd49301806" providerId="ADAL" clId="{DA8FEA81-1A63-884F-A1C6-520C766F400F}" dt="2022-11-23T16:25:23.361" v="10919" actId="478"/>
          <ac:spMkLst>
            <pc:docMk/>
            <pc:sldMk cId="269800214" sldId="261"/>
            <ac:spMk id="202" creationId="{5BC79489-398F-90F7-D579-F227A3C0A84E}"/>
          </ac:spMkLst>
        </pc:spChg>
        <pc:spChg chg="add del mod">
          <ac:chgData name="Reza Amini Hounejani" userId="36cb0b73-58b2-4568-a1ab-00cd49301806" providerId="ADAL" clId="{DA8FEA81-1A63-884F-A1C6-520C766F400F}" dt="2022-11-23T16:25:22.206" v="10918" actId="478"/>
          <ac:spMkLst>
            <pc:docMk/>
            <pc:sldMk cId="269800214" sldId="261"/>
            <ac:spMk id="203" creationId="{7F4CA1C1-174F-6DA2-5687-A87AA63E18D9}"/>
          </ac:spMkLst>
        </pc:spChg>
        <pc:grpChg chg="add mod">
          <ac:chgData name="Reza Amini Hounejani" userId="36cb0b73-58b2-4568-a1ab-00cd49301806" providerId="ADAL" clId="{DA8FEA81-1A63-884F-A1C6-520C766F400F}" dt="2022-11-23T16:47:10.473" v="11441" actId="1035"/>
          <ac:grpSpMkLst>
            <pc:docMk/>
            <pc:sldMk cId="269800214" sldId="261"/>
            <ac:grpSpMk id="18" creationId="{B5AB4227-8BBA-E360-5A62-C6AD3BD14F55}"/>
          </ac:grpSpMkLst>
        </pc:grpChg>
        <pc:grpChg chg="add mod">
          <ac:chgData name="Reza Amini Hounejani" userId="36cb0b73-58b2-4568-a1ab-00cd49301806" providerId="ADAL" clId="{DA8FEA81-1A63-884F-A1C6-520C766F400F}" dt="2022-11-23T16:47:10.473" v="11441" actId="1035"/>
          <ac:grpSpMkLst>
            <pc:docMk/>
            <pc:sldMk cId="269800214" sldId="261"/>
            <ac:grpSpMk id="19" creationId="{4B0F7488-0FAF-21C7-430E-F5FAFCD9E9C5}"/>
          </ac:grpSpMkLst>
        </pc:grpChg>
        <pc:grpChg chg="add del mod">
          <ac:chgData name="Reza Amini Hounejani" userId="36cb0b73-58b2-4568-a1ab-00cd49301806" providerId="ADAL" clId="{DA8FEA81-1A63-884F-A1C6-520C766F400F}" dt="2022-11-23T09:54:02.227" v="10889" actId="478"/>
          <ac:grpSpMkLst>
            <pc:docMk/>
            <pc:sldMk cId="269800214" sldId="261"/>
            <ac:grpSpMk id="23" creationId="{E03955C3-1BD2-7C56-1A40-BF1E6F355D7A}"/>
          </ac:grpSpMkLst>
        </pc:grpChg>
        <pc:grpChg chg="add mod">
          <ac:chgData name="Reza Amini Hounejani" userId="36cb0b73-58b2-4568-a1ab-00cd49301806" providerId="ADAL" clId="{DA8FEA81-1A63-884F-A1C6-520C766F400F}" dt="2022-11-19T17:14:20.600" v="10185" actId="164"/>
          <ac:grpSpMkLst>
            <pc:docMk/>
            <pc:sldMk cId="269800214" sldId="261"/>
            <ac:grpSpMk id="36" creationId="{6EFAE6A0-1FC1-43C6-F04D-E99DB70FF75E}"/>
          </ac:grpSpMkLst>
        </pc:grpChg>
        <pc:grpChg chg="add mod">
          <ac:chgData name="Reza Amini Hounejani" userId="36cb0b73-58b2-4568-a1ab-00cd49301806" providerId="ADAL" clId="{DA8FEA81-1A63-884F-A1C6-520C766F400F}" dt="2022-11-22T15:52:02.807" v="10667" actId="571"/>
          <ac:grpSpMkLst>
            <pc:docMk/>
            <pc:sldMk cId="269800214" sldId="261"/>
            <ac:grpSpMk id="40" creationId="{C6C5669F-32E4-7BF0-16AB-959689A9637D}"/>
          </ac:grpSpMkLst>
        </pc:grpChg>
        <pc:grpChg chg="del mod">
          <ac:chgData name="Reza Amini Hounejani" userId="36cb0b73-58b2-4568-a1ab-00cd49301806" providerId="ADAL" clId="{DA8FEA81-1A63-884F-A1C6-520C766F400F}" dt="2022-11-22T14:41:35.006" v="10492" actId="478"/>
          <ac:grpSpMkLst>
            <pc:docMk/>
            <pc:sldMk cId="269800214" sldId="261"/>
            <ac:grpSpMk id="41" creationId="{EAD0AD02-91CA-907C-A3F2-7EC4095C795C}"/>
          </ac:grpSpMkLst>
        </pc:grpChg>
        <pc:grpChg chg="add mod">
          <ac:chgData name="Reza Amini Hounejani" userId="36cb0b73-58b2-4568-a1ab-00cd49301806" providerId="ADAL" clId="{DA8FEA81-1A63-884F-A1C6-520C766F400F}" dt="2022-11-19T17:13:47.371" v="10178" actId="164"/>
          <ac:grpSpMkLst>
            <pc:docMk/>
            <pc:sldMk cId="269800214" sldId="261"/>
            <ac:grpSpMk id="92" creationId="{B31B0E94-7130-EF02-DF68-C94C3A152528}"/>
          </ac:grpSpMkLst>
        </pc:grpChg>
        <pc:grpChg chg="add mod">
          <ac:chgData name="Reza Amini Hounejani" userId="36cb0b73-58b2-4568-a1ab-00cd49301806" providerId="ADAL" clId="{DA8FEA81-1A63-884F-A1C6-520C766F400F}" dt="2022-11-19T17:14:50.107" v="10189" actId="164"/>
          <ac:grpSpMkLst>
            <pc:docMk/>
            <pc:sldMk cId="269800214" sldId="261"/>
            <ac:grpSpMk id="93" creationId="{58ED4744-8685-3359-4045-9D2CDF802BD0}"/>
          </ac:grpSpMkLst>
        </pc:grpChg>
        <pc:grpChg chg="add del mod">
          <ac:chgData name="Reza Amini Hounejani" userId="36cb0b73-58b2-4568-a1ab-00cd49301806" providerId="ADAL" clId="{DA8FEA81-1A63-884F-A1C6-520C766F400F}" dt="2022-11-23T15:39:40.565" v="10903" actId="21"/>
          <ac:grpSpMkLst>
            <pc:docMk/>
            <pc:sldMk cId="269800214" sldId="261"/>
            <ac:grpSpMk id="94" creationId="{ACA3615A-2059-5CB9-06E0-2D5959E0E25D}"/>
          </ac:grpSpMkLst>
        </pc:grpChg>
        <pc:grpChg chg="add mod">
          <ac:chgData name="Reza Amini Hounejani" userId="36cb0b73-58b2-4568-a1ab-00cd49301806" providerId="ADAL" clId="{DA8FEA81-1A63-884F-A1C6-520C766F400F}" dt="2022-11-22T15:52:02.807" v="10667" actId="571"/>
          <ac:grpSpMkLst>
            <pc:docMk/>
            <pc:sldMk cId="269800214" sldId="261"/>
            <ac:grpSpMk id="112" creationId="{6A040198-EAF0-36EE-0E92-050DFA0BD960}"/>
          </ac:grpSpMkLst>
        </pc:grpChg>
        <pc:grpChg chg="add mod">
          <ac:chgData name="Reza Amini Hounejani" userId="36cb0b73-58b2-4568-a1ab-00cd49301806" providerId="ADAL" clId="{DA8FEA81-1A63-884F-A1C6-520C766F400F}" dt="2022-11-22T15:52:02.807" v="10667" actId="571"/>
          <ac:grpSpMkLst>
            <pc:docMk/>
            <pc:sldMk cId="269800214" sldId="261"/>
            <ac:grpSpMk id="116" creationId="{EA0B530A-2FD3-56E7-117D-47761681981D}"/>
          </ac:grpSpMkLst>
        </pc:grpChg>
        <pc:grpChg chg="add mod">
          <ac:chgData name="Reza Amini Hounejani" userId="36cb0b73-58b2-4568-a1ab-00cd49301806" providerId="ADAL" clId="{DA8FEA81-1A63-884F-A1C6-520C766F400F}" dt="2022-11-23T16:44:59.072" v="11370" actId="571"/>
          <ac:grpSpMkLst>
            <pc:docMk/>
            <pc:sldMk cId="269800214" sldId="261"/>
            <ac:grpSpMk id="123" creationId="{9D57E546-3E19-32B2-1434-4D740B537761}"/>
          </ac:grpSpMkLst>
        </pc:grpChg>
        <pc:grpChg chg="add mod">
          <ac:chgData name="Reza Amini Hounejani" userId="36cb0b73-58b2-4568-a1ab-00cd49301806" providerId="ADAL" clId="{DA8FEA81-1A63-884F-A1C6-520C766F400F}" dt="2022-11-23T16:47:04.517" v="11414" actId="164"/>
          <ac:grpSpMkLst>
            <pc:docMk/>
            <pc:sldMk cId="269800214" sldId="261"/>
            <ac:grpSpMk id="135" creationId="{A286BC48-D662-2E8A-26D9-7CEE8EF0CD80}"/>
          </ac:grpSpMkLst>
        </pc:grpChg>
        <pc:grpChg chg="add mod">
          <ac:chgData name="Reza Amini Hounejani" userId="36cb0b73-58b2-4568-a1ab-00cd49301806" providerId="ADAL" clId="{DA8FEA81-1A63-884F-A1C6-520C766F400F}" dt="2022-11-22T15:52:02.807" v="10667" actId="571"/>
          <ac:grpSpMkLst>
            <pc:docMk/>
            <pc:sldMk cId="269800214" sldId="261"/>
            <ac:grpSpMk id="144" creationId="{15675BF7-5EFF-5361-CEE8-7ADA8C72E689}"/>
          </ac:grpSpMkLst>
        </pc:grpChg>
        <pc:grpChg chg="add mod">
          <ac:chgData name="Reza Amini Hounejani" userId="36cb0b73-58b2-4568-a1ab-00cd49301806" providerId="ADAL" clId="{DA8FEA81-1A63-884F-A1C6-520C766F400F}" dt="2022-11-22T15:52:02.807" v="10667" actId="571"/>
          <ac:grpSpMkLst>
            <pc:docMk/>
            <pc:sldMk cId="269800214" sldId="261"/>
            <ac:grpSpMk id="146" creationId="{E30D56F7-FDD2-96A7-31DB-5B62470535E5}"/>
          </ac:grpSpMkLst>
        </pc:grpChg>
        <pc:grpChg chg="add mod">
          <ac:chgData name="Reza Amini Hounejani" userId="36cb0b73-58b2-4568-a1ab-00cd49301806" providerId="ADAL" clId="{DA8FEA81-1A63-884F-A1C6-520C766F400F}" dt="2022-11-22T15:52:02.807" v="10667" actId="571"/>
          <ac:grpSpMkLst>
            <pc:docMk/>
            <pc:sldMk cId="269800214" sldId="261"/>
            <ac:grpSpMk id="149" creationId="{3DF193E5-0C71-508D-8D87-716E2C1F8D7D}"/>
          </ac:grpSpMkLst>
        </pc:grpChg>
        <pc:grpChg chg="add mod">
          <ac:chgData name="Reza Amini Hounejani" userId="36cb0b73-58b2-4568-a1ab-00cd49301806" providerId="ADAL" clId="{DA8FEA81-1A63-884F-A1C6-520C766F400F}" dt="2022-11-22T15:47:25.205" v="10572" actId="571"/>
          <ac:grpSpMkLst>
            <pc:docMk/>
            <pc:sldMk cId="269800214" sldId="261"/>
            <ac:grpSpMk id="150" creationId="{A3A56B45-B67F-1960-EA77-408898A677F6}"/>
          </ac:grpSpMkLst>
        </pc:grpChg>
        <pc:grpChg chg="mod">
          <ac:chgData name="Reza Amini Hounejani" userId="36cb0b73-58b2-4568-a1ab-00cd49301806" providerId="ADAL" clId="{DA8FEA81-1A63-884F-A1C6-520C766F400F}" dt="2022-11-22T15:47:25.205" v="10572" actId="571"/>
          <ac:grpSpMkLst>
            <pc:docMk/>
            <pc:sldMk cId="269800214" sldId="261"/>
            <ac:grpSpMk id="151" creationId="{60D315FB-BDA0-8C46-F670-5122CEC1413B}"/>
          </ac:grpSpMkLst>
        </pc:grpChg>
        <pc:grpChg chg="mod">
          <ac:chgData name="Reza Amini Hounejani" userId="36cb0b73-58b2-4568-a1ab-00cd49301806" providerId="ADAL" clId="{DA8FEA81-1A63-884F-A1C6-520C766F400F}" dt="2022-11-22T15:47:25.205" v="10572" actId="571"/>
          <ac:grpSpMkLst>
            <pc:docMk/>
            <pc:sldMk cId="269800214" sldId="261"/>
            <ac:grpSpMk id="154" creationId="{5F8FCD15-504C-A92B-4E24-C23E72454659}"/>
          </ac:grpSpMkLst>
        </pc:grpChg>
        <pc:grpChg chg="mod">
          <ac:chgData name="Reza Amini Hounejani" userId="36cb0b73-58b2-4568-a1ab-00cd49301806" providerId="ADAL" clId="{DA8FEA81-1A63-884F-A1C6-520C766F400F}" dt="2022-11-22T15:47:25.205" v="10572" actId="571"/>
          <ac:grpSpMkLst>
            <pc:docMk/>
            <pc:sldMk cId="269800214" sldId="261"/>
            <ac:grpSpMk id="157" creationId="{1553A5CD-8B37-38AC-DB0F-B9231F6A5B06}"/>
          </ac:grpSpMkLst>
        </pc:grpChg>
        <pc:grpChg chg="mod">
          <ac:chgData name="Reza Amini Hounejani" userId="36cb0b73-58b2-4568-a1ab-00cd49301806" providerId="ADAL" clId="{DA8FEA81-1A63-884F-A1C6-520C766F400F}" dt="2022-11-22T15:47:25.205" v="10572" actId="571"/>
          <ac:grpSpMkLst>
            <pc:docMk/>
            <pc:sldMk cId="269800214" sldId="261"/>
            <ac:grpSpMk id="158" creationId="{6C89EF61-0DDA-5E79-31E4-8E992C84D0B8}"/>
          </ac:grpSpMkLst>
        </pc:grpChg>
        <pc:grpChg chg="mod">
          <ac:chgData name="Reza Amini Hounejani" userId="36cb0b73-58b2-4568-a1ab-00cd49301806" providerId="ADAL" clId="{DA8FEA81-1A63-884F-A1C6-520C766F400F}" dt="2022-11-22T15:47:25.205" v="10572" actId="571"/>
          <ac:grpSpMkLst>
            <pc:docMk/>
            <pc:sldMk cId="269800214" sldId="261"/>
            <ac:grpSpMk id="170" creationId="{C222B87C-2D52-EFA1-E101-9E7827324F9B}"/>
          </ac:grpSpMkLst>
        </pc:grpChg>
        <pc:grpChg chg="add mod">
          <ac:chgData name="Reza Amini Hounejani" userId="36cb0b73-58b2-4568-a1ab-00cd49301806" providerId="ADAL" clId="{DA8FEA81-1A63-884F-A1C6-520C766F400F}" dt="2022-11-22T15:57:58.853" v="10715" actId="164"/>
          <ac:grpSpMkLst>
            <pc:docMk/>
            <pc:sldMk cId="269800214" sldId="261"/>
            <ac:grpSpMk id="183" creationId="{9FDE3879-32CE-4890-988D-E9B59877FAF7}"/>
          </ac:grpSpMkLst>
        </pc:grpChg>
        <pc:grpChg chg="add del mod">
          <ac:chgData name="Reza Amini Hounejani" userId="36cb0b73-58b2-4568-a1ab-00cd49301806" providerId="ADAL" clId="{DA8FEA81-1A63-884F-A1C6-520C766F400F}" dt="2022-11-23T09:54:04.891" v="10890" actId="478"/>
          <ac:grpSpMkLst>
            <pc:docMk/>
            <pc:sldMk cId="269800214" sldId="261"/>
            <ac:grpSpMk id="188" creationId="{90DA8DF2-8560-D332-8D69-81E5A351ACC3}"/>
          </ac:grpSpMkLst>
        </pc:grpChg>
        <pc:grpChg chg="add mod">
          <ac:chgData name="Reza Amini Hounejani" userId="36cb0b73-58b2-4568-a1ab-00cd49301806" providerId="ADAL" clId="{DA8FEA81-1A63-884F-A1C6-520C766F400F}" dt="2022-11-22T15:57:08.850" v="10712" actId="164"/>
          <ac:grpSpMkLst>
            <pc:docMk/>
            <pc:sldMk cId="269800214" sldId="261"/>
            <ac:grpSpMk id="189" creationId="{D8E83B55-6FAF-F916-222A-C0669F3FB568}"/>
          </ac:grpSpMkLst>
        </pc:grpChg>
        <pc:grpChg chg="add mod">
          <ac:chgData name="Reza Amini Hounejani" userId="36cb0b73-58b2-4568-a1ab-00cd49301806" providerId="ADAL" clId="{DA8FEA81-1A63-884F-A1C6-520C766F400F}" dt="2022-11-22T15:57:06.651" v="10710" actId="164"/>
          <ac:grpSpMkLst>
            <pc:docMk/>
            <pc:sldMk cId="269800214" sldId="261"/>
            <ac:grpSpMk id="190" creationId="{43ED19CE-8118-8EEE-4F7B-DD503418F75D}"/>
          </ac:grpSpMkLst>
        </pc:grpChg>
        <pc:grpChg chg="add mod">
          <ac:chgData name="Reza Amini Hounejani" userId="36cb0b73-58b2-4568-a1ab-00cd49301806" providerId="ADAL" clId="{DA8FEA81-1A63-884F-A1C6-520C766F400F}" dt="2022-11-23T16:47:00.566" v="11413" actId="164"/>
          <ac:grpSpMkLst>
            <pc:docMk/>
            <pc:sldMk cId="269800214" sldId="261"/>
            <ac:grpSpMk id="191" creationId="{77DA745D-3DD7-2930-7E54-0ED8F48DC2DF}"/>
          </ac:grpSpMkLst>
        </pc:grpChg>
        <pc:grpChg chg="add del mod">
          <ac:chgData name="Reza Amini Hounejani" userId="36cb0b73-58b2-4568-a1ab-00cd49301806" providerId="ADAL" clId="{DA8FEA81-1A63-884F-A1C6-520C766F400F}" dt="2022-11-23T15:39:40.565" v="10903" actId="21"/>
          <ac:grpSpMkLst>
            <pc:docMk/>
            <pc:sldMk cId="269800214" sldId="261"/>
            <ac:grpSpMk id="192" creationId="{2F0678AA-8439-63C5-CB70-EB89AD66442A}"/>
          </ac:grpSpMkLst>
        </pc:grpChg>
        <pc:picChg chg="add mod">
          <ac:chgData name="Reza Amini Hounejani" userId="36cb0b73-58b2-4568-a1ab-00cd49301806" providerId="ADAL" clId="{DA8FEA81-1A63-884F-A1C6-520C766F400F}" dt="2022-11-23T16:47:00.566" v="11413" actId="164"/>
          <ac:picMkLst>
            <pc:docMk/>
            <pc:sldMk cId="269800214" sldId="261"/>
            <ac:picMk id="3" creationId="{57E94F07-EAD6-7D99-1223-C864EF8E547C}"/>
          </ac:picMkLst>
        </pc:picChg>
        <pc:picChg chg="add del mod">
          <ac:chgData name="Reza Amini Hounejani" userId="36cb0b73-58b2-4568-a1ab-00cd49301806" providerId="ADAL" clId="{DA8FEA81-1A63-884F-A1C6-520C766F400F}" dt="2022-11-18T16:21:54.701" v="9824" actId="478"/>
          <ac:picMkLst>
            <pc:docMk/>
            <pc:sldMk cId="269800214" sldId="261"/>
            <ac:picMk id="6" creationId="{3AE689EF-C79D-3E53-68FA-B63E13C8D312}"/>
          </ac:picMkLst>
        </pc:picChg>
        <pc:picChg chg="add mod">
          <ac:chgData name="Reza Amini Hounejani" userId="36cb0b73-58b2-4568-a1ab-00cd49301806" providerId="ADAL" clId="{DA8FEA81-1A63-884F-A1C6-520C766F400F}" dt="2022-11-23T16:47:04.517" v="11414" actId="164"/>
          <ac:picMkLst>
            <pc:docMk/>
            <pc:sldMk cId="269800214" sldId="261"/>
            <ac:picMk id="7" creationId="{DB642707-E22A-D4FC-EB27-382FC2623D5C}"/>
          </ac:picMkLst>
        </pc:picChg>
        <pc:picChg chg="add del mod">
          <ac:chgData name="Reza Amini Hounejani" userId="36cb0b73-58b2-4568-a1ab-00cd49301806" providerId="ADAL" clId="{DA8FEA81-1A63-884F-A1C6-520C766F400F}" dt="2022-11-22T16:05:01.331" v="10871" actId="478"/>
          <ac:picMkLst>
            <pc:docMk/>
            <pc:sldMk cId="269800214" sldId="261"/>
            <ac:picMk id="22" creationId="{DC5CD275-3974-D0EE-4970-2216B4F10159}"/>
          </ac:picMkLst>
        </pc:picChg>
        <pc:picChg chg="mod">
          <ac:chgData name="Reza Amini Hounejani" userId="36cb0b73-58b2-4568-a1ab-00cd49301806" providerId="ADAL" clId="{DA8FEA81-1A63-884F-A1C6-520C766F400F}" dt="2022-11-19T17:13:47.371" v="10178" actId="164"/>
          <ac:picMkLst>
            <pc:docMk/>
            <pc:sldMk cId="269800214" sldId="261"/>
            <ac:picMk id="37" creationId="{BB4281F2-CD73-8F9D-841C-95C37FBBCA93}"/>
          </ac:picMkLst>
        </pc:picChg>
        <pc:picChg chg="del mod">
          <ac:chgData name="Reza Amini Hounejani" userId="36cb0b73-58b2-4568-a1ab-00cd49301806" providerId="ADAL" clId="{DA8FEA81-1A63-884F-A1C6-520C766F400F}" dt="2022-11-22T14:41:37.398" v="10493" actId="478"/>
          <ac:picMkLst>
            <pc:docMk/>
            <pc:sldMk cId="269800214" sldId="261"/>
            <ac:picMk id="44" creationId="{A200922B-8783-7FF0-DD60-5AE24192326B}"/>
          </ac:picMkLst>
        </pc:picChg>
        <pc:picChg chg="del mod">
          <ac:chgData name="Reza Amini Hounejani" userId="36cb0b73-58b2-4568-a1ab-00cd49301806" providerId="ADAL" clId="{DA8FEA81-1A63-884F-A1C6-520C766F400F}" dt="2022-11-22T14:41:35.006" v="10492" actId="478"/>
          <ac:picMkLst>
            <pc:docMk/>
            <pc:sldMk cId="269800214" sldId="261"/>
            <ac:picMk id="45" creationId="{1601A867-CD27-7104-09A0-82F26BBD2CBA}"/>
          </ac:picMkLst>
        </pc:picChg>
        <pc:picChg chg="add del mod">
          <ac:chgData name="Reza Amini Hounejani" userId="36cb0b73-58b2-4568-a1ab-00cd49301806" providerId="ADAL" clId="{DA8FEA81-1A63-884F-A1C6-520C766F400F}" dt="2022-11-23T16:25:20.882" v="10917" actId="478"/>
          <ac:picMkLst>
            <pc:docMk/>
            <pc:sldMk cId="269800214" sldId="261"/>
            <ac:picMk id="49" creationId="{EEBC2E27-E42D-5586-66F6-C8F0DE41C269}"/>
          </ac:picMkLst>
        </pc:picChg>
        <pc:picChg chg="add del mod">
          <ac:chgData name="Reza Amini Hounejani" userId="36cb0b73-58b2-4568-a1ab-00cd49301806" providerId="ADAL" clId="{DA8FEA81-1A63-884F-A1C6-520C766F400F}" dt="2022-11-23T16:25:29.627" v="10921" actId="478"/>
          <ac:picMkLst>
            <pc:docMk/>
            <pc:sldMk cId="269800214" sldId="261"/>
            <ac:picMk id="118" creationId="{EEC2F044-D134-0839-61FD-98FCAF7FF29D}"/>
          </ac:picMkLst>
        </pc:picChg>
        <pc:picChg chg="add del mod">
          <ac:chgData name="Reza Amini Hounejani" userId="36cb0b73-58b2-4568-a1ab-00cd49301806" providerId="ADAL" clId="{DA8FEA81-1A63-884F-A1C6-520C766F400F}" dt="2022-11-22T14:41:44.846" v="10495"/>
          <ac:picMkLst>
            <pc:docMk/>
            <pc:sldMk cId="269800214" sldId="261"/>
            <ac:picMk id="137" creationId="{DAD56E3B-232A-70DB-E898-9E32D2ED4DE6}"/>
          </ac:picMkLst>
        </pc:picChg>
        <pc:picChg chg="add del mod">
          <ac:chgData name="Reza Amini Hounejani" userId="36cb0b73-58b2-4568-a1ab-00cd49301806" providerId="ADAL" clId="{DA8FEA81-1A63-884F-A1C6-520C766F400F}" dt="2022-11-22T14:41:44.846" v="10495"/>
          <ac:picMkLst>
            <pc:docMk/>
            <pc:sldMk cId="269800214" sldId="261"/>
            <ac:picMk id="139" creationId="{4D49249A-7EC5-EB17-BAD1-B5319C361E5D}"/>
          </ac:picMkLst>
        </pc:picChg>
        <pc:picChg chg="add mod">
          <ac:chgData name="Reza Amini Hounejani" userId="36cb0b73-58b2-4568-a1ab-00cd49301806" providerId="ADAL" clId="{DA8FEA81-1A63-884F-A1C6-520C766F400F}" dt="2022-11-22T15:52:02.807" v="10667" actId="571"/>
          <ac:picMkLst>
            <pc:docMk/>
            <pc:sldMk cId="269800214" sldId="261"/>
            <ac:picMk id="141" creationId="{41BCDBC1-7B0D-709D-4AFE-A4733D1013E5}"/>
          </ac:picMkLst>
        </pc:picChg>
        <pc:picChg chg="add mod">
          <ac:chgData name="Reza Amini Hounejani" userId="36cb0b73-58b2-4568-a1ab-00cd49301806" providerId="ADAL" clId="{DA8FEA81-1A63-884F-A1C6-520C766F400F}" dt="2022-11-22T15:52:02.807" v="10667" actId="571"/>
          <ac:picMkLst>
            <pc:docMk/>
            <pc:sldMk cId="269800214" sldId="261"/>
            <ac:picMk id="143" creationId="{D96F08BF-37CD-A6F2-8779-00C750070A8B}"/>
          </ac:picMkLst>
        </pc:picChg>
        <pc:picChg chg="mod">
          <ac:chgData name="Reza Amini Hounejani" userId="36cb0b73-58b2-4568-a1ab-00cd49301806" providerId="ADAL" clId="{DA8FEA81-1A63-884F-A1C6-520C766F400F}" dt="2022-11-22T15:47:25.205" v="10572" actId="571"/>
          <ac:picMkLst>
            <pc:docMk/>
            <pc:sldMk cId="269800214" sldId="261"/>
            <ac:picMk id="155" creationId="{C78A4621-1080-E2D3-8C2D-82750A229277}"/>
          </ac:picMkLst>
        </pc:picChg>
        <pc:picChg chg="mod">
          <ac:chgData name="Reza Amini Hounejani" userId="36cb0b73-58b2-4568-a1ab-00cd49301806" providerId="ADAL" clId="{DA8FEA81-1A63-884F-A1C6-520C766F400F}" dt="2022-11-22T15:47:25.205" v="10572" actId="571"/>
          <ac:picMkLst>
            <pc:docMk/>
            <pc:sldMk cId="269800214" sldId="261"/>
            <ac:picMk id="156" creationId="{A97928C7-0576-AFF3-8F02-75FA5BA88CBC}"/>
          </ac:picMkLst>
        </pc:picChg>
        <pc:cxnChg chg="add mod">
          <ac:chgData name="Reza Amini Hounejani" userId="36cb0b73-58b2-4568-a1ab-00cd49301806" providerId="ADAL" clId="{DA8FEA81-1A63-884F-A1C6-520C766F400F}" dt="2022-11-18T14:34:34.757" v="9704"/>
          <ac:cxnSpMkLst>
            <pc:docMk/>
            <pc:sldMk cId="269800214" sldId="261"/>
            <ac:cxnSpMk id="4" creationId="{5AD529EF-BDDE-ECB4-4D98-CDFCF120A519}"/>
          </ac:cxnSpMkLst>
        </pc:cxnChg>
        <pc:cxnChg chg="add del mod">
          <ac:chgData name="Reza Amini Hounejani" userId="36cb0b73-58b2-4568-a1ab-00cd49301806" providerId="ADAL" clId="{DA8FEA81-1A63-884F-A1C6-520C766F400F}" dt="2022-11-23T09:53:44.578" v="10887" actId="478"/>
          <ac:cxnSpMkLst>
            <pc:docMk/>
            <pc:sldMk cId="269800214" sldId="261"/>
            <ac:cxnSpMk id="8" creationId="{7041D265-5D24-7D14-812B-A975068FF249}"/>
          </ac:cxnSpMkLst>
        </pc:cxnChg>
        <pc:cxnChg chg="add del mod">
          <ac:chgData name="Reza Amini Hounejani" userId="36cb0b73-58b2-4568-a1ab-00cd49301806" providerId="ADAL" clId="{DA8FEA81-1A63-884F-A1C6-520C766F400F}" dt="2022-11-23T09:53:42.053" v="10886" actId="478"/>
          <ac:cxnSpMkLst>
            <pc:docMk/>
            <pc:sldMk cId="269800214" sldId="261"/>
            <ac:cxnSpMk id="10" creationId="{2DCD60B0-8546-8617-75B4-C006FA0DABEB}"/>
          </ac:cxnSpMkLst>
        </pc:cxnChg>
        <pc:cxnChg chg="add del mod">
          <ac:chgData name="Reza Amini Hounejani" userId="36cb0b73-58b2-4568-a1ab-00cd49301806" providerId="ADAL" clId="{DA8FEA81-1A63-884F-A1C6-520C766F400F}" dt="2022-11-18T14:40:17.424" v="9760" actId="478"/>
          <ac:cxnSpMkLst>
            <pc:docMk/>
            <pc:sldMk cId="269800214" sldId="261"/>
            <ac:cxnSpMk id="12" creationId="{218201C6-E33A-B90F-B1D3-00CEAD3EEA11}"/>
          </ac:cxnSpMkLst>
        </pc:cxnChg>
        <pc:cxnChg chg="add del mod">
          <ac:chgData name="Reza Amini Hounejani" userId="36cb0b73-58b2-4568-a1ab-00cd49301806" providerId="ADAL" clId="{DA8FEA81-1A63-884F-A1C6-520C766F400F}" dt="2022-11-23T09:54:02.227" v="10889" actId="478"/>
          <ac:cxnSpMkLst>
            <pc:docMk/>
            <pc:sldMk cId="269800214" sldId="261"/>
            <ac:cxnSpMk id="19" creationId="{6CEF382B-733B-5B23-A0CD-1D73667CAA7B}"/>
          </ac:cxnSpMkLst>
        </pc:cxnChg>
        <pc:cxnChg chg="add del mod">
          <ac:chgData name="Reza Amini Hounejani" userId="36cb0b73-58b2-4568-a1ab-00cd49301806" providerId="ADAL" clId="{DA8FEA81-1A63-884F-A1C6-520C766F400F}" dt="2022-11-23T09:54:04.891" v="10890" actId="478"/>
          <ac:cxnSpMkLst>
            <pc:docMk/>
            <pc:sldMk cId="269800214" sldId="261"/>
            <ac:cxnSpMk id="20" creationId="{82D704CA-2146-B7B2-55E0-FDB7FAFDEE7A}"/>
          </ac:cxnSpMkLst>
        </pc:cxnChg>
        <pc:cxnChg chg="add del mod">
          <ac:chgData name="Reza Amini Hounejani" userId="36cb0b73-58b2-4568-a1ab-00cd49301806" providerId="ADAL" clId="{DA8FEA81-1A63-884F-A1C6-520C766F400F}" dt="2022-11-22T16:05:09.284" v="10872" actId="478"/>
          <ac:cxnSpMkLst>
            <pc:docMk/>
            <pc:sldMk cId="269800214" sldId="261"/>
            <ac:cxnSpMk id="28" creationId="{39CBAD17-7BB8-BD04-0BB9-D8CB85628A7C}"/>
          </ac:cxnSpMkLst>
        </pc:cxnChg>
        <pc:cxnChg chg="add del mod">
          <ac:chgData name="Reza Amini Hounejani" userId="36cb0b73-58b2-4568-a1ab-00cd49301806" providerId="ADAL" clId="{DA8FEA81-1A63-884F-A1C6-520C766F400F}" dt="2022-11-22T16:05:09.284" v="10872" actId="478"/>
          <ac:cxnSpMkLst>
            <pc:docMk/>
            <pc:sldMk cId="269800214" sldId="261"/>
            <ac:cxnSpMk id="29" creationId="{E44DFAC2-E577-C706-4F9C-7D44D9D7C782}"/>
          </ac:cxnSpMkLst>
        </pc:cxnChg>
        <pc:cxnChg chg="add del mod">
          <ac:chgData name="Reza Amini Hounejani" userId="36cb0b73-58b2-4568-a1ab-00cd49301806" providerId="ADAL" clId="{DA8FEA81-1A63-884F-A1C6-520C766F400F}" dt="2022-11-22T16:04:02.801" v="10856" actId="478"/>
          <ac:cxnSpMkLst>
            <pc:docMk/>
            <pc:sldMk cId="269800214" sldId="261"/>
            <ac:cxnSpMk id="198" creationId="{518E9E97-CB98-8AEF-F551-9B0351070FBA}"/>
          </ac:cxnSpMkLst>
        </pc:cxnChg>
        <pc:cxnChg chg="add del mod">
          <ac:chgData name="Reza Amini Hounejani" userId="36cb0b73-58b2-4568-a1ab-00cd49301806" providerId="ADAL" clId="{DA8FEA81-1A63-884F-A1C6-520C766F400F}" dt="2022-11-22T16:04:53.355" v="10870" actId="478"/>
          <ac:cxnSpMkLst>
            <pc:docMk/>
            <pc:sldMk cId="269800214" sldId="261"/>
            <ac:cxnSpMk id="201" creationId="{C5264301-3EE1-0379-2F7B-C6B9915B3F9C}"/>
          </ac:cxnSpMkLst>
        </pc:cxnChg>
      </pc:sldChg>
      <pc:sldChg chg="addSp delSp modSp new mod">
        <pc:chgData name="Reza Amini Hounejani" userId="36cb0b73-58b2-4568-a1ab-00cd49301806" providerId="ADAL" clId="{DA8FEA81-1A63-884F-A1C6-520C766F400F}" dt="2022-11-24T10:26:36.909" v="11676" actId="20577"/>
        <pc:sldMkLst>
          <pc:docMk/>
          <pc:sldMk cId="1450487343" sldId="262"/>
        </pc:sldMkLst>
        <pc:spChg chg="del">
          <ac:chgData name="Reza Amini Hounejani" userId="36cb0b73-58b2-4568-a1ab-00cd49301806" providerId="ADAL" clId="{DA8FEA81-1A63-884F-A1C6-520C766F400F}" dt="2022-11-23T15:39:32.191" v="10899" actId="478"/>
          <ac:spMkLst>
            <pc:docMk/>
            <pc:sldMk cId="1450487343" sldId="262"/>
            <ac:spMk id="2" creationId="{DB89E2E7-46C3-4742-3357-97B2C827803F}"/>
          </ac:spMkLst>
        </pc:spChg>
        <pc:spChg chg="del">
          <ac:chgData name="Reza Amini Hounejani" userId="36cb0b73-58b2-4568-a1ab-00cd49301806" providerId="ADAL" clId="{DA8FEA81-1A63-884F-A1C6-520C766F400F}" dt="2022-11-23T15:39:32.191" v="10899" actId="478"/>
          <ac:spMkLst>
            <pc:docMk/>
            <pc:sldMk cId="1450487343" sldId="262"/>
            <ac:spMk id="3" creationId="{CB880D2F-5652-85AE-D853-A0CF80D16516}"/>
          </ac:spMkLst>
        </pc:spChg>
        <pc:spChg chg="add mod">
          <ac:chgData name="Reza Amini Hounejani" userId="36cb0b73-58b2-4568-a1ab-00cd49301806" providerId="ADAL" clId="{DA8FEA81-1A63-884F-A1C6-520C766F400F}" dt="2022-11-24T10:26:36.909" v="11676" actId="20577"/>
          <ac:spMkLst>
            <pc:docMk/>
            <pc:sldMk cId="1450487343" sldId="262"/>
            <ac:spMk id="5" creationId="{48512B39-9534-A3DC-5959-9DBC5D1FD662}"/>
          </ac:spMkLst>
        </pc:spChg>
        <pc:spChg chg="add mod">
          <ac:chgData name="Reza Amini Hounejani" userId="36cb0b73-58b2-4568-a1ab-00cd49301806" providerId="ADAL" clId="{DA8FEA81-1A63-884F-A1C6-520C766F400F}" dt="2022-11-23T15:39:51.139" v="10908" actId="20577"/>
          <ac:spMkLst>
            <pc:docMk/>
            <pc:sldMk cId="1450487343" sldId="262"/>
            <ac:spMk id="6" creationId="{4BE5E06E-05AC-1B9B-DE4B-4AF7FCBC4F5D}"/>
          </ac:spMkLst>
        </pc:spChg>
        <pc:spChg chg="add mod">
          <ac:chgData name="Reza Amini Hounejani" userId="36cb0b73-58b2-4568-a1ab-00cd49301806" providerId="ADAL" clId="{DA8FEA81-1A63-884F-A1C6-520C766F400F}" dt="2022-11-23T15:39:53.705" v="10910" actId="20577"/>
          <ac:spMkLst>
            <pc:docMk/>
            <pc:sldMk cId="1450487343" sldId="262"/>
            <ac:spMk id="7" creationId="{0918E1AF-96E9-F808-7E8C-7A6DC93EC111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10" creationId="{D62BBA95-E77D-1D32-0C34-8B0AB0979219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11" creationId="{75B4F4A2-4BE2-2FBB-BBB9-E53E09196D91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12" creationId="{CC1F71CD-8B72-0C51-DE63-86E1F0987F03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13" creationId="{26CA9CD0-59E2-F3B0-377C-28F39CA5CC7B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14" creationId="{0000FD60-39C0-6724-4065-A1A98A557EFE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15" creationId="{78A155B6-4D0C-AD48-B1CA-31C45EA7CB46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16" creationId="{8E84C809-232F-F3F7-6312-EED254F19AA8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17" creationId="{F40F6B45-C845-0667-C12D-EC3BBA0CF75D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18" creationId="{23D40A93-DD1B-35E0-79A5-72FD8A78FDBA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19" creationId="{9C099E10-0926-A347-CFDE-45E9E9C3F03C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20" creationId="{21EEFC56-BD2C-2D67-502A-75DEF5403B69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21" creationId="{976FFA13-1AC7-4B6E-6054-78DDC2114909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22" creationId="{71544578-ABEE-BC0F-7CE9-1590E780AF4C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23" creationId="{25182A02-EEB0-00C6-9539-342138AE9218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25" creationId="{B1E790A6-6204-2D16-2AF0-D74A475BB3AA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26" creationId="{87141DBD-170F-B444-AE70-F44CDCBAE271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28" creationId="{CB1A8611-47BC-F73D-0F19-9B1580AA1F93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29" creationId="{F61C94EC-88D9-090B-863F-9A28FE07677A}"/>
          </ac:spMkLst>
        </pc:spChg>
        <pc:spChg chg="del mod topLvl">
          <ac:chgData name="Reza Amini Hounejani" userId="36cb0b73-58b2-4568-a1ab-00cd49301806" providerId="ADAL" clId="{DA8FEA81-1A63-884F-A1C6-520C766F400F}" dt="2022-11-24T08:33:54.472" v="11444" actId="478"/>
          <ac:spMkLst>
            <pc:docMk/>
            <pc:sldMk cId="1450487343" sldId="262"/>
            <ac:spMk id="32" creationId="{9049AEAD-B445-6D48-153D-587AF6955392}"/>
          </ac:spMkLst>
        </pc:spChg>
        <pc:spChg chg="del mod">
          <ac:chgData name="Reza Amini Hounejani" userId="36cb0b73-58b2-4568-a1ab-00cd49301806" providerId="ADAL" clId="{DA8FEA81-1A63-884F-A1C6-520C766F400F}" dt="2022-11-24T08:33:52.487" v="11443" actId="478"/>
          <ac:spMkLst>
            <pc:docMk/>
            <pc:sldMk cId="1450487343" sldId="262"/>
            <ac:spMk id="33" creationId="{B86B54E3-71AD-976F-487E-CD35A90EFEA8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35" creationId="{93FF6C11-D71E-5EE1-87E3-EBE8A56F8714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36" creationId="{A4F2C3F0-E7C3-5932-9009-DA1599B48A4C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37" creationId="{F2C628D0-4F0E-6023-BD5D-319929CCA183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38" creationId="{9115BBED-D935-50D3-6647-65B8E9FF0B22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39" creationId="{47016499-94DF-455D-3473-7A5050E818A9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40" creationId="{B9CC7B9B-69C7-298E-1F45-CE7881FB4B3F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42" creationId="{DFCB1E18-C3E7-9B9A-EA6F-47D8A02933E6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43" creationId="{3EF1E179-5E45-9963-C206-A25E013B3A1D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49" creationId="{5F39F296-4D13-0A47-8CAB-EACDEC2F0B63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50" creationId="{B955B351-7CDD-312B-011B-10354968FF1B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51" creationId="{1401B6F1-CB9B-7600-DEB8-A2413D8959B7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52" creationId="{D6C43710-80E4-2A05-0E6F-116A2C1CA681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53" creationId="{4E42BCB4-960D-62CB-669E-0D3F34868F6C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54" creationId="{FF745962-6C7C-6ADC-10A4-7E4F89537D7A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55" creationId="{7B644CE5-88E0-A65A-247B-3156D7233772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56" creationId="{72A3D254-2A4F-A962-F218-13AA6DB22C69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57" creationId="{07863456-E4B8-B62A-480B-403BD210A7DE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58" creationId="{B07A87D2-E7C0-D3BA-BB14-BEEEB02F5364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59" creationId="{3E9F1A4E-A1BD-C921-DBB1-8DEFF6AB3C97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61" creationId="{364A29B2-9928-230B-DE24-4EEF107B9D4A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62" creationId="{F49D101D-3AE5-914A-8F8F-7B2A234B050F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63" creationId="{465D20F9-5A8F-CD00-A944-6A52EFEBE4E9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64" creationId="{02357686-A688-A7AD-7BB8-007E2313D7F6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65" creationId="{92C217BC-C387-45B1-BD06-6EEFEF323EF9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66" creationId="{63A4D2BD-0492-0FDD-C0BA-A934D43F6419}"/>
          </ac:spMkLst>
        </pc:spChg>
        <pc:spChg chg="mod">
          <ac:chgData name="Reza Amini Hounejani" userId="36cb0b73-58b2-4568-a1ab-00cd49301806" providerId="ADAL" clId="{DA8FEA81-1A63-884F-A1C6-520C766F400F}" dt="2022-11-23T15:39:43.678" v="10904"/>
          <ac:spMkLst>
            <pc:docMk/>
            <pc:sldMk cId="1450487343" sldId="262"/>
            <ac:spMk id="67" creationId="{6D6E2B44-468B-8F64-45CA-FE059975932A}"/>
          </ac:spMkLst>
        </pc:spChg>
        <pc:grpChg chg="add mod">
          <ac:chgData name="Reza Amini Hounejani" userId="36cb0b73-58b2-4568-a1ab-00cd49301806" providerId="ADAL" clId="{DA8FEA81-1A63-884F-A1C6-520C766F400F}" dt="2022-11-23T15:39:47.891" v="10906" actId="1076"/>
          <ac:grpSpMkLst>
            <pc:docMk/>
            <pc:sldMk cId="1450487343" sldId="262"/>
            <ac:grpSpMk id="8" creationId="{8E8107F5-1AA2-9E1B-625B-2466673DACC9}"/>
          </ac:grpSpMkLst>
        </pc:grpChg>
        <pc:grpChg chg="mod">
          <ac:chgData name="Reza Amini Hounejani" userId="36cb0b73-58b2-4568-a1ab-00cd49301806" providerId="ADAL" clId="{DA8FEA81-1A63-884F-A1C6-520C766F400F}" dt="2022-11-23T15:39:43.678" v="10904"/>
          <ac:grpSpMkLst>
            <pc:docMk/>
            <pc:sldMk cId="1450487343" sldId="262"/>
            <ac:grpSpMk id="9" creationId="{CF9E55A9-60A6-FC93-7EA5-CEA473C8C5AF}"/>
          </ac:grpSpMkLst>
        </pc:grpChg>
        <pc:grpChg chg="mod">
          <ac:chgData name="Reza Amini Hounejani" userId="36cb0b73-58b2-4568-a1ab-00cd49301806" providerId="ADAL" clId="{DA8FEA81-1A63-884F-A1C6-520C766F400F}" dt="2022-11-23T15:39:43.678" v="10904"/>
          <ac:grpSpMkLst>
            <pc:docMk/>
            <pc:sldMk cId="1450487343" sldId="262"/>
            <ac:grpSpMk id="24" creationId="{30557901-5FF3-DF03-7E2A-0A7150210D69}"/>
          </ac:grpSpMkLst>
        </pc:grpChg>
        <pc:grpChg chg="add del mod">
          <ac:chgData name="Reza Amini Hounejani" userId="36cb0b73-58b2-4568-a1ab-00cd49301806" providerId="ADAL" clId="{DA8FEA81-1A63-884F-A1C6-520C766F400F}" dt="2022-11-24T08:33:54.472" v="11444" actId="478"/>
          <ac:grpSpMkLst>
            <pc:docMk/>
            <pc:sldMk cId="1450487343" sldId="262"/>
            <ac:grpSpMk id="30" creationId="{3287928C-1C04-18AC-D1CF-F7DB6CCDFBAE}"/>
          </ac:grpSpMkLst>
        </pc:grpChg>
        <pc:grpChg chg="mod topLvl">
          <ac:chgData name="Reza Amini Hounejani" userId="36cb0b73-58b2-4568-a1ab-00cd49301806" providerId="ADAL" clId="{DA8FEA81-1A63-884F-A1C6-520C766F400F}" dt="2022-11-24T08:34:43.350" v="11455" actId="164"/>
          <ac:grpSpMkLst>
            <pc:docMk/>
            <pc:sldMk cId="1450487343" sldId="262"/>
            <ac:grpSpMk id="31" creationId="{5C13CCF8-03FF-D061-F61C-5010A9CCEA80}"/>
          </ac:grpSpMkLst>
        </pc:grpChg>
        <pc:grpChg chg="mod">
          <ac:chgData name="Reza Amini Hounejani" userId="36cb0b73-58b2-4568-a1ab-00cd49301806" providerId="ADAL" clId="{DA8FEA81-1A63-884F-A1C6-520C766F400F}" dt="2022-11-23T15:39:43.678" v="10904"/>
          <ac:grpSpMkLst>
            <pc:docMk/>
            <pc:sldMk cId="1450487343" sldId="262"/>
            <ac:grpSpMk id="34" creationId="{5720719D-5C6D-A551-A0B9-AC627D81E6DE}"/>
          </ac:grpSpMkLst>
        </pc:grpChg>
        <pc:grpChg chg="mod">
          <ac:chgData name="Reza Amini Hounejani" userId="36cb0b73-58b2-4568-a1ab-00cd49301806" providerId="ADAL" clId="{DA8FEA81-1A63-884F-A1C6-520C766F400F}" dt="2022-11-23T15:39:43.678" v="10904"/>
          <ac:grpSpMkLst>
            <pc:docMk/>
            <pc:sldMk cId="1450487343" sldId="262"/>
            <ac:grpSpMk id="41" creationId="{9D84A7B3-5CBE-E72F-AB12-467A61C2BC92}"/>
          </ac:grpSpMkLst>
        </pc:grpChg>
        <pc:grpChg chg="mod">
          <ac:chgData name="Reza Amini Hounejani" userId="36cb0b73-58b2-4568-a1ab-00cd49301806" providerId="ADAL" clId="{DA8FEA81-1A63-884F-A1C6-520C766F400F}" dt="2022-11-23T15:39:43.678" v="10904"/>
          <ac:grpSpMkLst>
            <pc:docMk/>
            <pc:sldMk cId="1450487343" sldId="262"/>
            <ac:grpSpMk id="44" creationId="{EB7724D2-46A3-9251-343A-CFEE18567952}"/>
          </ac:grpSpMkLst>
        </pc:grpChg>
        <pc:grpChg chg="mod">
          <ac:chgData name="Reza Amini Hounejani" userId="36cb0b73-58b2-4568-a1ab-00cd49301806" providerId="ADAL" clId="{DA8FEA81-1A63-884F-A1C6-520C766F400F}" dt="2022-11-23T15:39:43.678" v="10904"/>
          <ac:grpSpMkLst>
            <pc:docMk/>
            <pc:sldMk cId="1450487343" sldId="262"/>
            <ac:grpSpMk id="47" creationId="{23A3F5E0-9CBB-8263-859C-06A64316A86D}"/>
          </ac:grpSpMkLst>
        </pc:grpChg>
        <pc:grpChg chg="mod">
          <ac:chgData name="Reza Amini Hounejani" userId="36cb0b73-58b2-4568-a1ab-00cd49301806" providerId="ADAL" clId="{DA8FEA81-1A63-884F-A1C6-520C766F400F}" dt="2022-11-23T15:39:43.678" v="10904"/>
          <ac:grpSpMkLst>
            <pc:docMk/>
            <pc:sldMk cId="1450487343" sldId="262"/>
            <ac:grpSpMk id="48" creationId="{280918B2-84F6-75F3-317B-7B9BEA659C20}"/>
          </ac:grpSpMkLst>
        </pc:grpChg>
        <pc:grpChg chg="mod">
          <ac:chgData name="Reza Amini Hounejani" userId="36cb0b73-58b2-4568-a1ab-00cd49301806" providerId="ADAL" clId="{DA8FEA81-1A63-884F-A1C6-520C766F400F}" dt="2022-11-23T15:39:43.678" v="10904"/>
          <ac:grpSpMkLst>
            <pc:docMk/>
            <pc:sldMk cId="1450487343" sldId="262"/>
            <ac:grpSpMk id="60" creationId="{59DDD1AF-8424-698B-A6AB-1A464DD6553D}"/>
          </ac:grpSpMkLst>
        </pc:grpChg>
        <pc:grpChg chg="add mod">
          <ac:chgData name="Reza Amini Hounejani" userId="36cb0b73-58b2-4568-a1ab-00cd49301806" providerId="ADAL" clId="{DA8FEA81-1A63-884F-A1C6-520C766F400F}" dt="2022-11-24T08:34:43.350" v="11455" actId="164"/>
          <ac:grpSpMkLst>
            <pc:docMk/>
            <pc:sldMk cId="1450487343" sldId="262"/>
            <ac:grpSpMk id="74" creationId="{F3C39970-6813-AB0B-B58C-30640EFDC56A}"/>
          </ac:grpSpMkLst>
        </pc:grpChg>
        <pc:picChg chg="mod">
          <ac:chgData name="Reza Amini Hounejani" userId="36cb0b73-58b2-4568-a1ab-00cd49301806" providerId="ADAL" clId="{DA8FEA81-1A63-884F-A1C6-520C766F400F}" dt="2022-11-23T15:39:43.678" v="10904"/>
          <ac:picMkLst>
            <pc:docMk/>
            <pc:sldMk cId="1450487343" sldId="262"/>
            <ac:picMk id="27" creationId="{3DB39F34-348C-0783-FFEF-54FDB5AC84E7}"/>
          </ac:picMkLst>
        </pc:picChg>
        <pc:picChg chg="mod">
          <ac:chgData name="Reza Amini Hounejani" userId="36cb0b73-58b2-4568-a1ab-00cd49301806" providerId="ADAL" clId="{DA8FEA81-1A63-884F-A1C6-520C766F400F}" dt="2022-11-23T15:39:43.678" v="10904"/>
          <ac:picMkLst>
            <pc:docMk/>
            <pc:sldMk cId="1450487343" sldId="262"/>
            <ac:picMk id="45" creationId="{B9A92A59-80F5-E705-F1C7-82C9DC6F3209}"/>
          </ac:picMkLst>
        </pc:picChg>
        <pc:picChg chg="mod">
          <ac:chgData name="Reza Amini Hounejani" userId="36cb0b73-58b2-4568-a1ab-00cd49301806" providerId="ADAL" clId="{DA8FEA81-1A63-884F-A1C6-520C766F400F}" dt="2022-11-23T15:39:43.678" v="10904"/>
          <ac:picMkLst>
            <pc:docMk/>
            <pc:sldMk cId="1450487343" sldId="262"/>
            <ac:picMk id="46" creationId="{4DE96B88-CA92-27CF-3811-71221292C14F}"/>
          </ac:picMkLst>
        </pc:picChg>
        <pc:cxnChg chg="add mod">
          <ac:chgData name="Reza Amini Hounejani" userId="36cb0b73-58b2-4568-a1ab-00cd49301806" providerId="ADAL" clId="{DA8FEA81-1A63-884F-A1C6-520C766F400F}" dt="2022-11-23T15:39:33.191" v="10900"/>
          <ac:cxnSpMkLst>
            <pc:docMk/>
            <pc:sldMk cId="1450487343" sldId="262"/>
            <ac:cxnSpMk id="4" creationId="{C55E4053-C4CC-7CA8-54F1-DB7B52266221}"/>
          </ac:cxnSpMkLst>
        </pc:cxnChg>
        <pc:cxnChg chg="add mod">
          <ac:chgData name="Reza Amini Hounejani" userId="36cb0b73-58b2-4568-a1ab-00cd49301806" providerId="ADAL" clId="{DA8FEA81-1A63-884F-A1C6-520C766F400F}" dt="2022-11-24T08:34:43.350" v="11455" actId="164"/>
          <ac:cxnSpMkLst>
            <pc:docMk/>
            <pc:sldMk cId="1450487343" sldId="262"/>
            <ac:cxnSpMk id="69" creationId="{DA68FB13-BB27-1CF7-1046-0F3612596237}"/>
          </ac:cxnSpMkLst>
        </pc:cxnChg>
        <pc:cxnChg chg="add mod">
          <ac:chgData name="Reza Amini Hounejani" userId="36cb0b73-58b2-4568-a1ab-00cd49301806" providerId="ADAL" clId="{DA8FEA81-1A63-884F-A1C6-520C766F400F}" dt="2022-11-24T08:34:43.350" v="11455" actId="164"/>
          <ac:cxnSpMkLst>
            <pc:docMk/>
            <pc:sldMk cId="1450487343" sldId="262"/>
            <ac:cxnSpMk id="73" creationId="{AE7AEF68-9C65-CFE4-8BB3-6A0CAD168F71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E3DA87-70E0-2B40-AE7B-7F778A4D3E04}" type="datetimeFigureOut">
              <a:rPr lang="en-NL" smtClean="0"/>
              <a:t>02/08/2023</a:t>
            </a:fld>
            <a:endParaRPr lang="en-N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173D94-8EC4-F640-836F-1C89E3C9F34A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605439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F173D94-8EC4-F640-836F-1C89E3C9F34A}" type="slidenum">
              <a:rPr lang="en-NL" smtClean="0"/>
              <a:t>1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41254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62F18-FFAB-4078-97D6-50FFF940E0C6}" type="datetimeFigureOut">
              <a:rPr lang="en-GB" smtClean="0"/>
              <a:t>02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A3BBC-820C-45C7-B5E4-D0AB057A1D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0406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62F18-FFAB-4078-97D6-50FFF940E0C6}" type="datetimeFigureOut">
              <a:rPr lang="en-GB" smtClean="0"/>
              <a:t>02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A3BBC-820C-45C7-B5E4-D0AB057A1D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6593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62F18-FFAB-4078-97D6-50FFF940E0C6}" type="datetimeFigureOut">
              <a:rPr lang="en-GB" smtClean="0"/>
              <a:t>02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A3BBC-820C-45C7-B5E4-D0AB057A1D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5703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62F18-FFAB-4078-97D6-50FFF940E0C6}" type="datetimeFigureOut">
              <a:rPr lang="en-GB" smtClean="0"/>
              <a:t>02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A3BBC-820C-45C7-B5E4-D0AB057A1D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4518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62F18-FFAB-4078-97D6-50FFF940E0C6}" type="datetimeFigureOut">
              <a:rPr lang="en-GB" smtClean="0"/>
              <a:t>02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A3BBC-820C-45C7-B5E4-D0AB057A1D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1674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62F18-FFAB-4078-97D6-50FFF940E0C6}" type="datetimeFigureOut">
              <a:rPr lang="en-GB" smtClean="0"/>
              <a:t>02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A3BBC-820C-45C7-B5E4-D0AB057A1D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34802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62F18-FFAB-4078-97D6-50FFF940E0C6}" type="datetimeFigureOut">
              <a:rPr lang="en-GB" smtClean="0"/>
              <a:t>02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A3BBC-820C-45C7-B5E4-D0AB057A1D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66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62F18-FFAB-4078-97D6-50FFF940E0C6}" type="datetimeFigureOut">
              <a:rPr lang="en-GB" smtClean="0"/>
              <a:t>02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A3BBC-820C-45C7-B5E4-D0AB057A1D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3695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62F18-FFAB-4078-97D6-50FFF940E0C6}" type="datetimeFigureOut">
              <a:rPr lang="en-GB" smtClean="0"/>
              <a:t>02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A3BBC-820C-45C7-B5E4-D0AB057A1D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3510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62F18-FFAB-4078-97D6-50FFF940E0C6}" type="datetimeFigureOut">
              <a:rPr lang="en-GB" smtClean="0"/>
              <a:t>02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A3BBC-820C-45C7-B5E4-D0AB057A1D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6113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62F18-FFAB-4078-97D6-50FFF940E0C6}" type="datetimeFigureOut">
              <a:rPr lang="en-GB" smtClean="0"/>
              <a:t>02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A3BBC-820C-45C7-B5E4-D0AB057A1D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6839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62F18-FFAB-4078-97D6-50FFF940E0C6}" type="datetimeFigureOut">
              <a:rPr lang="en-GB" smtClean="0"/>
              <a:t>02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3A3BBC-820C-45C7-B5E4-D0AB057A1D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1871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5AD529EF-BDDE-ECB4-4D98-CDFCF120A519}"/>
              </a:ext>
            </a:extLst>
          </p:cNvPr>
          <p:cNvCxnSpPr/>
          <p:nvPr/>
        </p:nvCxnSpPr>
        <p:spPr>
          <a:xfrm>
            <a:off x="28509" y="350520"/>
            <a:ext cx="670757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09854D5C-DCC4-B81B-8CD9-EDDACDBDE5D9}"/>
              </a:ext>
            </a:extLst>
          </p:cNvPr>
          <p:cNvSpPr txBox="1"/>
          <p:nvPr/>
        </p:nvSpPr>
        <p:spPr>
          <a:xfrm>
            <a:off x="2657035" y="77738"/>
            <a:ext cx="1604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NL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72747FE3-7718-BF19-47A8-9DB8E340AF91}"/>
              </a:ext>
            </a:extLst>
          </p:cNvPr>
          <p:cNvGrpSpPr/>
          <p:nvPr/>
        </p:nvGrpSpPr>
        <p:grpSpPr>
          <a:xfrm>
            <a:off x="371703" y="385567"/>
            <a:ext cx="2863578" cy="2560468"/>
            <a:chOff x="371703" y="385567"/>
            <a:chExt cx="2863578" cy="2560468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AB0D053-FDE7-256D-DDD1-253E73E5302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1985" y="734556"/>
              <a:ext cx="2633296" cy="1976400"/>
            </a:xfrm>
            <a:prstGeom prst="rect">
              <a:avLst/>
            </a:prstGeom>
          </p:spPr>
        </p:pic>
        <p:grpSp>
          <p:nvGrpSpPr>
            <p:cNvPr id="191" name="Group 190">
              <a:extLst>
                <a:ext uri="{FF2B5EF4-FFF2-40B4-BE49-F238E27FC236}">
                  <a16:creationId xmlns:a16="http://schemas.microsoft.com/office/drawing/2014/main" id="{77DA745D-3DD7-2930-7E54-0ED8F48DC2DF}"/>
                </a:ext>
              </a:extLst>
            </p:cNvPr>
            <p:cNvGrpSpPr/>
            <p:nvPr/>
          </p:nvGrpSpPr>
          <p:grpSpPr>
            <a:xfrm>
              <a:off x="371703" y="385567"/>
              <a:ext cx="2797822" cy="2560468"/>
              <a:chOff x="363516" y="756357"/>
              <a:chExt cx="2797822" cy="2560468"/>
            </a:xfrm>
          </p:grpSpPr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65932EA0-2F2B-582B-0FF4-F5A22AADDF8A}"/>
                  </a:ext>
                </a:extLst>
              </p:cNvPr>
              <p:cNvSpPr/>
              <p:nvPr/>
            </p:nvSpPr>
            <p:spPr>
              <a:xfrm>
                <a:off x="844903" y="2895118"/>
                <a:ext cx="2222447" cy="1878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algn="ctr" defTabSz="457200" rtl="0" eaLnBrk="1" latinLnBrk="0" hangingPunct="1"/>
                <a:endParaRPr lang="en-NL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7C937CE2-867F-6AFB-E8D4-BFA49A6EBD4C}"/>
                  </a:ext>
                </a:extLst>
              </p:cNvPr>
              <p:cNvSpPr txBox="1"/>
              <p:nvPr/>
            </p:nvSpPr>
            <p:spPr>
              <a:xfrm>
                <a:off x="1231479" y="3070604"/>
                <a:ext cx="15295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rowth speed (µm/min) </a:t>
                </a:r>
              </a:p>
            </p:txBody>
          </p:sp>
          <p:sp>
            <p:nvSpPr>
              <p:cNvPr id="58" name="Rounded Rectangle 57">
                <a:extLst>
                  <a:ext uri="{FF2B5EF4-FFF2-40B4-BE49-F238E27FC236}">
                    <a16:creationId xmlns:a16="http://schemas.microsoft.com/office/drawing/2014/main" id="{55F542B6-EEE9-FF89-5762-01CF36E8E860}"/>
                  </a:ext>
                </a:extLst>
              </p:cNvPr>
              <p:cNvSpPr/>
              <p:nvPr/>
            </p:nvSpPr>
            <p:spPr>
              <a:xfrm>
                <a:off x="719316" y="1139071"/>
                <a:ext cx="165509" cy="1816986"/>
              </a:xfrm>
              <a:prstGeom prst="round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algn="ctr" defTabSz="457200" rtl="1" eaLnBrk="1" latinLnBrk="0" hangingPunct="1"/>
                <a:endParaRPr lang="en-NL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84F62275-2ED3-4A2A-D34E-E4E4A31D6C99}"/>
                  </a:ext>
                </a:extLst>
              </p:cNvPr>
              <p:cNvSpPr txBox="1"/>
              <p:nvPr/>
            </p:nvSpPr>
            <p:spPr>
              <a:xfrm rot="16200000">
                <a:off x="-20243" y="1988213"/>
                <a:ext cx="102143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rowth time (s)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0899B095-13CE-C4DF-D68D-DC4DAEAE2FC0}"/>
                  </a:ext>
                </a:extLst>
              </p:cNvPr>
              <p:cNvSpPr txBox="1"/>
              <p:nvPr/>
            </p:nvSpPr>
            <p:spPr>
              <a:xfrm>
                <a:off x="1138463" y="2869580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0B24528A-D29F-1EF2-D421-DE45246BCAB1}"/>
                  </a:ext>
                </a:extLst>
              </p:cNvPr>
              <p:cNvSpPr txBox="1"/>
              <p:nvPr/>
            </p:nvSpPr>
            <p:spPr>
              <a:xfrm>
                <a:off x="1609918" y="286958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78DE8071-3648-34AB-B9D9-4E45E4A84927}"/>
                  </a:ext>
                </a:extLst>
              </p:cNvPr>
              <p:cNvSpPr txBox="1"/>
              <p:nvPr/>
            </p:nvSpPr>
            <p:spPr>
              <a:xfrm>
                <a:off x="1954272" y="2869580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FA2699CD-F8D7-84A9-98D4-6FD51EC8D461}"/>
                  </a:ext>
                </a:extLst>
              </p:cNvPr>
              <p:cNvSpPr txBox="1"/>
              <p:nvPr/>
            </p:nvSpPr>
            <p:spPr>
              <a:xfrm>
                <a:off x="2444757" y="286958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82687445-DD90-0D8F-E1CB-774F75C3B686}"/>
                  </a:ext>
                </a:extLst>
              </p:cNvPr>
              <p:cNvSpPr txBox="1"/>
              <p:nvPr/>
            </p:nvSpPr>
            <p:spPr>
              <a:xfrm>
                <a:off x="566994" y="2465757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6966B0C9-DD13-5D15-57D9-AF413EEE8299}"/>
                  </a:ext>
                </a:extLst>
              </p:cNvPr>
              <p:cNvSpPr txBox="1"/>
              <p:nvPr/>
            </p:nvSpPr>
            <p:spPr>
              <a:xfrm>
                <a:off x="566994" y="2195613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3759AD00-291B-3E41-D50B-AC51A150EFC2}"/>
                  </a:ext>
                </a:extLst>
              </p:cNvPr>
              <p:cNvSpPr txBox="1"/>
              <p:nvPr/>
            </p:nvSpPr>
            <p:spPr>
              <a:xfrm>
                <a:off x="566994" y="1935673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6C41E1E8-6169-945F-B897-F23B0B8ED97B}"/>
                  </a:ext>
                </a:extLst>
              </p:cNvPr>
              <p:cNvSpPr txBox="1"/>
              <p:nvPr/>
            </p:nvSpPr>
            <p:spPr>
              <a:xfrm>
                <a:off x="566994" y="1657874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BFF4042-363C-8DEB-E497-EB5B3E8ADDF8}"/>
                  </a:ext>
                </a:extLst>
              </p:cNvPr>
              <p:cNvSpPr txBox="1"/>
              <p:nvPr/>
            </p:nvSpPr>
            <p:spPr>
              <a:xfrm>
                <a:off x="566994" y="1400299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1BFA74D5-29E5-7580-FF3E-B3DB131A1645}"/>
                  </a:ext>
                </a:extLst>
              </p:cNvPr>
              <p:cNvSpPr txBox="1"/>
              <p:nvPr/>
            </p:nvSpPr>
            <p:spPr>
              <a:xfrm>
                <a:off x="794727" y="286958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F060A642-2007-4400-5240-8F3723D50B2D}"/>
                  </a:ext>
                </a:extLst>
              </p:cNvPr>
              <p:cNvSpPr txBox="1"/>
              <p:nvPr/>
            </p:nvSpPr>
            <p:spPr>
              <a:xfrm>
                <a:off x="708058" y="273198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BAC20769-9E36-E28D-C42A-2C6AF98541FB}"/>
                  </a:ext>
                </a:extLst>
              </p:cNvPr>
              <p:cNvSpPr txBox="1"/>
              <p:nvPr/>
            </p:nvSpPr>
            <p:spPr>
              <a:xfrm>
                <a:off x="1871858" y="1101059"/>
                <a:ext cx="106311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Janson et al. [24]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6D08FB89-A2DC-0BD3-E578-FB1E155EE7E3}"/>
                  </a:ext>
                </a:extLst>
              </p:cNvPr>
              <p:cNvSpPr txBox="1"/>
              <p:nvPr/>
            </p:nvSpPr>
            <p:spPr>
              <a:xfrm>
                <a:off x="1884139" y="928708"/>
                <a:ext cx="8899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Kok et al. [11]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FCC12FB6-58CB-2D10-DF24-6D09B679B5B2}"/>
                  </a:ext>
                </a:extLst>
              </p:cNvPr>
              <p:cNvSpPr txBox="1"/>
              <p:nvPr/>
            </p:nvSpPr>
            <p:spPr>
              <a:xfrm>
                <a:off x="1873192" y="756357"/>
                <a:ext cx="4732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MTs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3334FAF7-842F-A2B9-C826-7A7D2EFC7402}"/>
                  </a:ext>
                </a:extLst>
              </p:cNvPr>
              <p:cNvSpPr txBox="1"/>
              <p:nvPr/>
            </p:nvSpPr>
            <p:spPr>
              <a:xfrm>
                <a:off x="2800342" y="2865374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</a:p>
            </p:txBody>
          </p:sp>
        </p:grpSp>
      </p:grpSp>
      <p:sp>
        <p:nvSpPr>
          <p:cNvPr id="114" name="TextBox 113">
            <a:extLst>
              <a:ext uri="{FF2B5EF4-FFF2-40B4-BE49-F238E27FC236}">
                <a16:creationId xmlns:a16="http://schemas.microsoft.com/office/drawing/2014/main" id="{F7D323BC-7669-8E39-3C86-2191659678EF}"/>
              </a:ext>
            </a:extLst>
          </p:cNvPr>
          <p:cNvSpPr txBox="1"/>
          <p:nvPr/>
        </p:nvSpPr>
        <p:spPr>
          <a:xfrm>
            <a:off x="105113" y="37628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63F97AB8-C9CD-67D8-6612-12AE8A178CB3}"/>
              </a:ext>
            </a:extLst>
          </p:cNvPr>
          <p:cNvSpPr txBox="1"/>
          <p:nvPr/>
        </p:nvSpPr>
        <p:spPr>
          <a:xfrm>
            <a:off x="3478921" y="39894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algn="l" defTabSz="457200" eaLnBrk="1" latinLnBrk="0" hangingPunct="1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N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24308102-C625-282C-2EB2-63959F71B0A5}"/>
              </a:ext>
            </a:extLst>
          </p:cNvPr>
          <p:cNvGrpSpPr/>
          <p:nvPr/>
        </p:nvGrpSpPr>
        <p:grpSpPr>
          <a:xfrm>
            <a:off x="3545160" y="465380"/>
            <a:ext cx="2950895" cy="2422788"/>
            <a:chOff x="3569033" y="475506"/>
            <a:chExt cx="2950895" cy="2422788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57659CB-5E6C-4738-4BCE-8F79E2FC8DF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86632" y="717861"/>
              <a:ext cx="2633296" cy="1976400"/>
            </a:xfrm>
            <a:prstGeom prst="rect">
              <a:avLst/>
            </a:prstGeom>
          </p:spPr>
        </p:pic>
        <p:grpSp>
          <p:nvGrpSpPr>
            <p:cNvPr id="123" name="Group 122">
              <a:extLst>
                <a:ext uri="{FF2B5EF4-FFF2-40B4-BE49-F238E27FC236}">
                  <a16:creationId xmlns:a16="http://schemas.microsoft.com/office/drawing/2014/main" id="{9D57E546-3E19-32B2-1434-4D740B537761}"/>
                </a:ext>
              </a:extLst>
            </p:cNvPr>
            <p:cNvGrpSpPr/>
            <p:nvPr/>
          </p:nvGrpSpPr>
          <p:grpSpPr>
            <a:xfrm>
              <a:off x="3955504" y="682585"/>
              <a:ext cx="2344885" cy="1980523"/>
              <a:chOff x="3695665" y="1048433"/>
              <a:chExt cx="2344885" cy="1980523"/>
            </a:xfrm>
          </p:grpSpPr>
          <p:sp>
            <p:nvSpPr>
              <p:cNvPr id="121" name="Rectangle 120">
                <a:extLst>
                  <a:ext uri="{FF2B5EF4-FFF2-40B4-BE49-F238E27FC236}">
                    <a16:creationId xmlns:a16="http://schemas.microsoft.com/office/drawing/2014/main" id="{7367E09A-747F-07CA-6A79-CBA33EDB012A}"/>
                  </a:ext>
                </a:extLst>
              </p:cNvPr>
              <p:cNvSpPr/>
              <p:nvPr/>
            </p:nvSpPr>
            <p:spPr>
              <a:xfrm>
                <a:off x="3876471" y="2870231"/>
                <a:ext cx="2164079" cy="1587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algn="ctr" defTabSz="457200" rtl="0" eaLnBrk="1" latinLnBrk="0" hangingPunct="1"/>
                <a:endParaRPr lang="en-NL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Rectangle 121">
                <a:extLst>
                  <a:ext uri="{FF2B5EF4-FFF2-40B4-BE49-F238E27FC236}">
                    <a16:creationId xmlns:a16="http://schemas.microsoft.com/office/drawing/2014/main" id="{877284A1-C1C0-AA45-CB24-79306D9A8998}"/>
                  </a:ext>
                </a:extLst>
              </p:cNvPr>
              <p:cNvSpPr/>
              <p:nvPr/>
            </p:nvSpPr>
            <p:spPr>
              <a:xfrm rot="16200000">
                <a:off x="2835627" y="1908471"/>
                <a:ext cx="1939354" cy="2192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algn="ctr" defTabSz="457200" rtl="0" eaLnBrk="1" latinLnBrk="0" hangingPunct="1"/>
                <a:endParaRPr lang="en-NL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47DC6C1E-BD95-1EE7-30A4-F4AA3EB6996F}"/>
                </a:ext>
              </a:extLst>
            </p:cNvPr>
            <p:cNvSpPr txBox="1"/>
            <p:nvPr/>
          </p:nvSpPr>
          <p:spPr>
            <a:xfrm>
              <a:off x="3987590" y="2344051"/>
              <a:ext cx="25359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CA781EB6-2506-661C-ABC4-013870D3D4AC}"/>
                </a:ext>
              </a:extLst>
            </p:cNvPr>
            <p:cNvSpPr txBox="1"/>
            <p:nvPr/>
          </p:nvSpPr>
          <p:spPr>
            <a:xfrm>
              <a:off x="4434007" y="246936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9A5A2823-5D2E-6098-75C7-19AFB39682CB}"/>
                </a:ext>
              </a:extLst>
            </p:cNvPr>
            <p:cNvSpPr txBox="1"/>
            <p:nvPr/>
          </p:nvSpPr>
          <p:spPr>
            <a:xfrm>
              <a:off x="4899997" y="246936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41911E68-5387-C85C-7347-5621EFC8695B}"/>
                </a:ext>
              </a:extLst>
            </p:cNvPr>
            <p:cNvSpPr txBox="1"/>
            <p:nvPr/>
          </p:nvSpPr>
          <p:spPr>
            <a:xfrm>
              <a:off x="5255123" y="246936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EEBE429C-59D6-82D1-B119-77BF1B8DAE59}"/>
                </a:ext>
              </a:extLst>
            </p:cNvPr>
            <p:cNvSpPr txBox="1"/>
            <p:nvPr/>
          </p:nvSpPr>
          <p:spPr>
            <a:xfrm>
              <a:off x="5709700" y="246936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4BB0F239-C14D-841D-097C-D32C26E3ACEC}"/>
                </a:ext>
              </a:extLst>
            </p:cNvPr>
            <p:cNvSpPr txBox="1"/>
            <p:nvPr/>
          </p:nvSpPr>
          <p:spPr>
            <a:xfrm>
              <a:off x="6089072" y="246936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883E47B9-E2D6-63E2-96A9-9453D5808C86}"/>
                </a:ext>
              </a:extLst>
            </p:cNvPr>
            <p:cNvSpPr txBox="1"/>
            <p:nvPr/>
          </p:nvSpPr>
          <p:spPr>
            <a:xfrm>
              <a:off x="3774392" y="1960624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26687ACC-CFD0-1031-1A88-406829F5248C}"/>
                </a:ext>
              </a:extLst>
            </p:cNvPr>
            <p:cNvSpPr txBox="1"/>
            <p:nvPr/>
          </p:nvSpPr>
          <p:spPr>
            <a:xfrm>
              <a:off x="3774392" y="1189330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3000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A5CD06CB-8095-7B9D-EE8E-7D73B22549F2}"/>
                </a:ext>
              </a:extLst>
            </p:cNvPr>
            <p:cNvSpPr txBox="1"/>
            <p:nvPr/>
          </p:nvSpPr>
          <p:spPr>
            <a:xfrm>
              <a:off x="4490330" y="2652073"/>
              <a:ext cx="15295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growth speed (µm/min) 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13B655E6-08F6-FFBD-8255-BA625751B9D9}"/>
                </a:ext>
              </a:extLst>
            </p:cNvPr>
            <p:cNvSpPr txBox="1"/>
            <p:nvPr/>
          </p:nvSpPr>
          <p:spPr>
            <a:xfrm rot="16200000">
              <a:off x="2863231" y="1623432"/>
              <a:ext cx="16578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diffusion constant (nm</a:t>
              </a:r>
              <a:r>
                <a:rPr lang="en-NL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/s) 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107B0A9-3BD7-3359-E9D8-CE39FA55F2C3}"/>
                </a:ext>
              </a:extLst>
            </p:cNvPr>
            <p:cNvSpPr txBox="1"/>
            <p:nvPr/>
          </p:nvSpPr>
          <p:spPr>
            <a:xfrm>
              <a:off x="3774392" y="1580420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200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8BBB0D4-A16B-4231-7D5D-F8FB27D4A52B}"/>
                </a:ext>
              </a:extLst>
            </p:cNvPr>
            <p:cNvSpPr txBox="1"/>
            <p:nvPr/>
          </p:nvSpPr>
          <p:spPr>
            <a:xfrm>
              <a:off x="3774392" y="1000135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9218915-FDC9-F634-4E32-A64B61A392AD}"/>
                </a:ext>
              </a:extLst>
            </p:cNvPr>
            <p:cNvSpPr txBox="1"/>
            <p:nvPr/>
          </p:nvSpPr>
          <p:spPr>
            <a:xfrm>
              <a:off x="3774392" y="1385782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250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9EAC924-BA3B-341A-8434-B18DA907D5C0}"/>
                </a:ext>
              </a:extLst>
            </p:cNvPr>
            <p:cNvSpPr txBox="1"/>
            <p:nvPr/>
          </p:nvSpPr>
          <p:spPr>
            <a:xfrm>
              <a:off x="3774392" y="1752677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150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56BC88D-2DF8-4F4B-33DC-15994BD950BE}"/>
                </a:ext>
              </a:extLst>
            </p:cNvPr>
            <p:cNvSpPr txBox="1"/>
            <p:nvPr/>
          </p:nvSpPr>
          <p:spPr>
            <a:xfrm>
              <a:off x="3844924" y="215326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FA5128A-FEE8-FF72-6037-C18517EE01C5}"/>
                </a:ext>
              </a:extLst>
            </p:cNvPr>
            <p:cNvSpPr txBox="1"/>
            <p:nvPr/>
          </p:nvSpPr>
          <p:spPr>
            <a:xfrm>
              <a:off x="4089475" y="2465518"/>
              <a:ext cx="25359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1C67A44-33D3-996A-FDE2-9C32F22046FC}"/>
                </a:ext>
              </a:extLst>
            </p:cNvPr>
            <p:cNvSpPr txBox="1"/>
            <p:nvPr/>
          </p:nvSpPr>
          <p:spPr>
            <a:xfrm>
              <a:off x="5261028" y="671127"/>
              <a:ext cx="11785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Gardner et al. 2001</a:t>
              </a:r>
              <a:endParaRPr lang="en-NL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4654BF1-D8FC-36B9-75E5-23DAEFA003F5}"/>
                </a:ext>
              </a:extLst>
            </p:cNvPr>
            <p:cNvSpPr txBox="1"/>
            <p:nvPr/>
          </p:nvSpPr>
          <p:spPr>
            <a:xfrm>
              <a:off x="5261028" y="475506"/>
              <a:ext cx="112723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Janson et al. 2003</a:t>
              </a:r>
              <a:endParaRPr lang="en-NL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01F7FBD-E1A0-05B1-4255-DBE6F9E3C77D}"/>
                </a:ext>
              </a:extLst>
            </p:cNvPr>
            <p:cNvSpPr txBox="1"/>
            <p:nvPr/>
          </p:nvSpPr>
          <p:spPr>
            <a:xfrm>
              <a:off x="4278078" y="672256"/>
              <a:ext cx="9541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ok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et al. 2021</a:t>
              </a:r>
              <a:endParaRPr lang="en-NL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5B8DB23-28C0-E817-65B9-F12473F6AC5E}"/>
                </a:ext>
              </a:extLst>
            </p:cNvPr>
            <p:cNvSpPr txBox="1"/>
            <p:nvPr/>
          </p:nvSpPr>
          <p:spPr>
            <a:xfrm>
              <a:off x="4273029" y="477844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bMTs</a:t>
              </a:r>
              <a:endParaRPr lang="en-NL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F568064F-47CD-DBE3-0C0C-8B44A9AA1B03}"/>
                </a:ext>
              </a:extLst>
            </p:cNvPr>
            <p:cNvSpPr/>
            <p:nvPr/>
          </p:nvSpPr>
          <p:spPr>
            <a:xfrm>
              <a:off x="5216082" y="770013"/>
              <a:ext cx="45719" cy="45719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algn="ctr" defTabSz="457200" rtl="0" eaLnBrk="1" latinLnBrk="0" hangingPunct="1"/>
              <a:endParaRPr lang="en-NL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AB1D4753-16C0-FBA9-DE6A-9ADE606378E2}"/>
                </a:ext>
              </a:extLst>
            </p:cNvPr>
            <p:cNvSpPr/>
            <p:nvPr/>
          </p:nvSpPr>
          <p:spPr>
            <a:xfrm>
              <a:off x="5216082" y="569762"/>
              <a:ext cx="45719" cy="45719"/>
            </a:xfrm>
            <a:prstGeom prst="ellipse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algn="ctr" defTabSz="457200" rtl="0" eaLnBrk="1" latinLnBrk="0" hangingPunct="1"/>
              <a:endParaRPr lang="en-NL"/>
            </a:p>
          </p:txBody>
        </p:sp>
        <p:sp>
          <p:nvSpPr>
            <p:cNvPr id="28" name="Oval 27">
              <a:extLst>
                <a:ext uri="{FF2B5EF4-FFF2-40B4-BE49-F238E27FC236}">
                  <a16:creationId xmlns:a16="http://schemas.microsoft.com/office/drawing/2014/main" id="{4D5472F8-AD9A-EDD8-EAB0-482682EA287D}"/>
                </a:ext>
              </a:extLst>
            </p:cNvPr>
            <p:cNvSpPr/>
            <p:nvPr/>
          </p:nvSpPr>
          <p:spPr>
            <a:xfrm>
              <a:off x="4227640" y="770013"/>
              <a:ext cx="45719" cy="45719"/>
            </a:xfrm>
            <a:prstGeom prst="ellipse">
              <a:avLst/>
            </a:prstGeom>
            <a:solidFill>
              <a:srgbClr val="9840DE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algn="ctr" defTabSz="457200" rtl="0" eaLnBrk="1" latinLnBrk="0" hangingPunct="1"/>
              <a:endParaRPr lang="en-NL"/>
            </a:p>
          </p:txBody>
        </p:sp>
        <p:sp>
          <p:nvSpPr>
            <p:cNvPr id="29" name="Oval 28">
              <a:extLst>
                <a:ext uri="{FF2B5EF4-FFF2-40B4-BE49-F238E27FC236}">
                  <a16:creationId xmlns:a16="http://schemas.microsoft.com/office/drawing/2014/main" id="{1849EA63-FE75-4C13-646D-751DCEBF84C6}"/>
                </a:ext>
              </a:extLst>
            </p:cNvPr>
            <p:cNvSpPr/>
            <p:nvPr/>
          </p:nvSpPr>
          <p:spPr>
            <a:xfrm>
              <a:off x="4229013" y="569762"/>
              <a:ext cx="45719" cy="45719"/>
            </a:xfrm>
            <a:prstGeom prst="ellipse">
              <a:avLst/>
            </a:prstGeom>
            <a:solidFill>
              <a:srgbClr val="F9070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algn="ctr" defTabSz="457200" rtl="0" eaLnBrk="1" latinLnBrk="0" hangingPunct="1"/>
              <a:endParaRPr lang="en-NL"/>
            </a:p>
          </p:txBody>
        </p:sp>
      </p:grpSp>
      <p:sp>
        <p:nvSpPr>
          <p:cNvPr id="35" name="Oval 34">
            <a:extLst>
              <a:ext uri="{FF2B5EF4-FFF2-40B4-BE49-F238E27FC236}">
                <a16:creationId xmlns:a16="http://schemas.microsoft.com/office/drawing/2014/main" id="{50D3A2BC-6755-6A66-F09E-05C544AC8866}"/>
              </a:ext>
            </a:extLst>
          </p:cNvPr>
          <p:cNvSpPr/>
          <p:nvPr/>
        </p:nvSpPr>
        <p:spPr>
          <a:xfrm>
            <a:off x="1833212" y="658988"/>
            <a:ext cx="45719" cy="45719"/>
          </a:xfrm>
          <a:prstGeom prst="ellipse">
            <a:avLst/>
          </a:prstGeom>
          <a:solidFill>
            <a:srgbClr val="9840D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algn="ctr" defTabSz="457200" rtl="1" eaLnBrk="1" latinLnBrk="0" hangingPunct="1"/>
            <a:endParaRPr lang="en-NL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7B069632-FC09-7BE7-28D9-3708BA9242D0}"/>
              </a:ext>
            </a:extLst>
          </p:cNvPr>
          <p:cNvSpPr/>
          <p:nvPr/>
        </p:nvSpPr>
        <p:spPr>
          <a:xfrm>
            <a:off x="1833212" y="831772"/>
            <a:ext cx="45719" cy="45719"/>
          </a:xfrm>
          <a:prstGeom prst="ellipse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algn="ctr" defTabSz="457200" rtl="0" eaLnBrk="1" latinLnBrk="0" hangingPunct="1"/>
            <a:endParaRPr lang="en-NL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917B6BE6-5A4F-56EE-56DB-8D794B7005D5}"/>
              </a:ext>
            </a:extLst>
          </p:cNvPr>
          <p:cNvSpPr/>
          <p:nvPr/>
        </p:nvSpPr>
        <p:spPr>
          <a:xfrm>
            <a:off x="1833212" y="490426"/>
            <a:ext cx="45719" cy="45719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algn="ctr" defTabSz="457200" rtl="0" eaLnBrk="1" latinLnBrk="0" hangingPunct="1"/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698002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C55E4053-C4CC-7CA8-54F1-DB7B52266221}"/>
              </a:ext>
            </a:extLst>
          </p:cNvPr>
          <p:cNvCxnSpPr/>
          <p:nvPr/>
        </p:nvCxnSpPr>
        <p:spPr>
          <a:xfrm>
            <a:off x="28509" y="350520"/>
            <a:ext cx="670757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48512B39-9534-A3DC-5959-9DBC5D1FD662}"/>
              </a:ext>
            </a:extLst>
          </p:cNvPr>
          <p:cNvSpPr txBox="1"/>
          <p:nvPr/>
        </p:nvSpPr>
        <p:spPr>
          <a:xfrm>
            <a:off x="2657035" y="77738"/>
            <a:ext cx="1604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n-NL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B227EA7-2802-6E8B-12DA-D2D22078B99B}"/>
              </a:ext>
            </a:extLst>
          </p:cNvPr>
          <p:cNvSpPr txBox="1"/>
          <p:nvPr/>
        </p:nvSpPr>
        <p:spPr>
          <a:xfrm>
            <a:off x="529416" y="54757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3D2720E9-347D-C9BA-544B-C63F2B5ED33F}"/>
              </a:ext>
            </a:extLst>
          </p:cNvPr>
          <p:cNvSpPr txBox="1"/>
          <p:nvPr/>
        </p:nvSpPr>
        <p:spPr>
          <a:xfrm>
            <a:off x="3528694" y="54630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L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935C5173-B608-1A14-6918-2331333547E5}"/>
              </a:ext>
            </a:extLst>
          </p:cNvPr>
          <p:cNvGrpSpPr/>
          <p:nvPr/>
        </p:nvGrpSpPr>
        <p:grpSpPr>
          <a:xfrm>
            <a:off x="3867248" y="450968"/>
            <a:ext cx="2625655" cy="2210330"/>
            <a:chOff x="3480214" y="199680"/>
            <a:chExt cx="2625655" cy="2210330"/>
          </a:xfrm>
        </p:grpSpPr>
        <p:grpSp>
          <p:nvGrpSpPr>
            <p:cNvPr id="109" name="Group 108">
              <a:extLst>
                <a:ext uri="{FF2B5EF4-FFF2-40B4-BE49-F238E27FC236}">
                  <a16:creationId xmlns:a16="http://schemas.microsoft.com/office/drawing/2014/main" id="{D3FE8EA8-1BDE-1D18-420A-EE09560041E9}"/>
                </a:ext>
              </a:extLst>
            </p:cNvPr>
            <p:cNvGrpSpPr/>
            <p:nvPr/>
          </p:nvGrpSpPr>
          <p:grpSpPr>
            <a:xfrm>
              <a:off x="3480214" y="379544"/>
              <a:ext cx="2625655" cy="2030466"/>
              <a:chOff x="3480214" y="379544"/>
              <a:chExt cx="2625655" cy="2030466"/>
            </a:xfrm>
          </p:grpSpPr>
          <p:pic>
            <p:nvPicPr>
              <p:cNvPr id="114" name="Picture 113">
                <a:extLst>
                  <a:ext uri="{FF2B5EF4-FFF2-40B4-BE49-F238E27FC236}">
                    <a16:creationId xmlns:a16="http://schemas.microsoft.com/office/drawing/2014/main" id="{BA437742-C493-CACE-5F83-3BFA4D186B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45975" y="379544"/>
                <a:ext cx="2359894" cy="1771200"/>
              </a:xfrm>
              <a:prstGeom prst="rect">
                <a:avLst/>
              </a:prstGeom>
            </p:spPr>
          </p:pic>
          <p:grpSp>
            <p:nvGrpSpPr>
              <p:cNvPr id="115" name="Group 114">
                <a:extLst>
                  <a:ext uri="{FF2B5EF4-FFF2-40B4-BE49-F238E27FC236}">
                    <a16:creationId xmlns:a16="http://schemas.microsoft.com/office/drawing/2014/main" id="{4CFB4101-D9F6-3327-D624-23E064AFFBA6}"/>
                  </a:ext>
                </a:extLst>
              </p:cNvPr>
              <p:cNvGrpSpPr/>
              <p:nvPr/>
            </p:nvGrpSpPr>
            <p:grpSpPr>
              <a:xfrm>
                <a:off x="3480214" y="445900"/>
                <a:ext cx="2427933" cy="1964110"/>
                <a:chOff x="3702805" y="3731318"/>
                <a:chExt cx="2427933" cy="1964110"/>
              </a:xfrm>
            </p:grpSpPr>
            <p:grpSp>
              <p:nvGrpSpPr>
                <p:cNvPr id="116" name="Group 115">
                  <a:extLst>
                    <a:ext uri="{FF2B5EF4-FFF2-40B4-BE49-F238E27FC236}">
                      <a16:creationId xmlns:a16="http://schemas.microsoft.com/office/drawing/2014/main" id="{8B1F7D6D-ACB7-F0ED-EEA9-166F75114C60}"/>
                    </a:ext>
                  </a:extLst>
                </p:cNvPr>
                <p:cNvGrpSpPr/>
                <p:nvPr/>
              </p:nvGrpSpPr>
              <p:grpSpPr>
                <a:xfrm>
                  <a:off x="3702805" y="3731318"/>
                  <a:ext cx="2427933" cy="1964110"/>
                  <a:chOff x="3702805" y="3731318"/>
                  <a:chExt cx="2427933" cy="1964110"/>
                </a:xfrm>
              </p:grpSpPr>
              <p:grpSp>
                <p:nvGrpSpPr>
                  <p:cNvPr id="129" name="Group 128">
                    <a:extLst>
                      <a:ext uri="{FF2B5EF4-FFF2-40B4-BE49-F238E27FC236}">
                        <a16:creationId xmlns:a16="http://schemas.microsoft.com/office/drawing/2014/main" id="{A01D12B7-8001-19C5-A125-EDEB7B52BEE5}"/>
                      </a:ext>
                    </a:extLst>
                  </p:cNvPr>
                  <p:cNvGrpSpPr/>
                  <p:nvPr/>
                </p:nvGrpSpPr>
                <p:grpSpPr>
                  <a:xfrm>
                    <a:off x="3702805" y="3978199"/>
                    <a:ext cx="2147197" cy="1717229"/>
                    <a:chOff x="2858197" y="199202"/>
                    <a:chExt cx="2147197" cy="1717229"/>
                  </a:xfrm>
                </p:grpSpPr>
                <p:sp>
                  <p:nvSpPr>
                    <p:cNvPr id="132" name="TextBox 131">
                      <a:extLst>
                        <a:ext uri="{FF2B5EF4-FFF2-40B4-BE49-F238E27FC236}">
                          <a16:creationId xmlns:a16="http://schemas.microsoft.com/office/drawing/2014/main" id="{0CBA386A-A42A-DA0C-3489-177D18D0A4D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82971" y="1670210"/>
                      <a:ext cx="1122423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NL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T length (nm)</a:t>
                      </a:r>
                    </a:p>
                  </p:txBody>
                </p:sp>
                <p:sp>
                  <p:nvSpPr>
                    <p:cNvPr id="133" name="TextBox 132">
                      <a:extLst>
                        <a:ext uri="{FF2B5EF4-FFF2-40B4-BE49-F238E27FC236}">
                          <a16:creationId xmlns:a16="http://schemas.microsoft.com/office/drawing/2014/main" id="{033C397B-407E-4387-8FAD-A870D7D14C69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2388838" y="668561"/>
                      <a:ext cx="118494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NL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per length (nm)</a:t>
                      </a:r>
                    </a:p>
                  </p:txBody>
                </p:sp>
              </p:grpSp>
              <p:sp>
                <p:nvSpPr>
                  <p:cNvPr id="130" name="Rectangle 129">
                    <a:extLst>
                      <a:ext uri="{FF2B5EF4-FFF2-40B4-BE49-F238E27FC236}">
                        <a16:creationId xmlns:a16="http://schemas.microsoft.com/office/drawing/2014/main" id="{7C78835A-CB5F-3C81-5246-6A08D12E2B4B}"/>
                      </a:ext>
                    </a:extLst>
                  </p:cNvPr>
                  <p:cNvSpPr/>
                  <p:nvPr/>
                </p:nvSpPr>
                <p:spPr>
                  <a:xfrm>
                    <a:off x="4194187" y="5267053"/>
                    <a:ext cx="1936551" cy="16784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NL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" name="Rectangle 130">
                    <a:extLst>
                      <a:ext uri="{FF2B5EF4-FFF2-40B4-BE49-F238E27FC236}">
                        <a16:creationId xmlns:a16="http://schemas.microsoft.com/office/drawing/2014/main" id="{6282E8A0-13FD-5754-3475-D8671544CD6E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337730" y="4487686"/>
                    <a:ext cx="1656414" cy="14367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NL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id="{E6A72699-5BDE-094E-FA83-40F922784DBA}"/>
                    </a:ext>
                  </a:extLst>
                </p:cNvPr>
                <p:cNvSpPr txBox="1"/>
                <p:nvPr/>
              </p:nvSpPr>
              <p:spPr>
                <a:xfrm>
                  <a:off x="4548649" y="5262689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</a:p>
              </p:txBody>
            </p:sp>
            <p:sp>
              <p:nvSpPr>
                <p:cNvPr id="118" name="TextBox 117">
                  <a:extLst>
                    <a:ext uri="{FF2B5EF4-FFF2-40B4-BE49-F238E27FC236}">
                      <a16:creationId xmlns:a16="http://schemas.microsoft.com/office/drawing/2014/main" id="{343F39D4-364C-8A94-84F2-56541188C3B0}"/>
                    </a:ext>
                  </a:extLst>
                </p:cNvPr>
                <p:cNvSpPr txBox="1"/>
                <p:nvPr/>
              </p:nvSpPr>
              <p:spPr>
                <a:xfrm>
                  <a:off x="5015710" y="5262689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0</a:t>
                  </a:r>
                </a:p>
              </p:txBody>
            </p:sp>
            <p:sp>
              <p:nvSpPr>
                <p:cNvPr id="119" name="TextBox 118">
                  <a:extLst>
                    <a:ext uri="{FF2B5EF4-FFF2-40B4-BE49-F238E27FC236}">
                      <a16:creationId xmlns:a16="http://schemas.microsoft.com/office/drawing/2014/main" id="{E71A81A3-F38B-DD0A-2953-C8AACEBDB78E}"/>
                    </a:ext>
                  </a:extLst>
                </p:cNvPr>
                <p:cNvSpPr txBox="1"/>
                <p:nvPr/>
              </p:nvSpPr>
              <p:spPr>
                <a:xfrm>
                  <a:off x="5511194" y="5262689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0</a:t>
                  </a:r>
                </a:p>
              </p:txBody>
            </p:sp>
            <p:sp>
              <p:nvSpPr>
                <p:cNvPr id="120" name="TextBox 119">
                  <a:extLst>
                    <a:ext uri="{FF2B5EF4-FFF2-40B4-BE49-F238E27FC236}">
                      <a16:creationId xmlns:a16="http://schemas.microsoft.com/office/drawing/2014/main" id="{C6E052CA-3D9F-C8AB-E993-EEEF9C8DAFFC}"/>
                    </a:ext>
                  </a:extLst>
                </p:cNvPr>
                <p:cNvSpPr txBox="1"/>
                <p:nvPr/>
              </p:nvSpPr>
              <p:spPr>
                <a:xfrm>
                  <a:off x="4037031" y="5090627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8B88FFEC-CB61-3AC1-BE8D-734921588CB5}"/>
                    </a:ext>
                  </a:extLst>
                </p:cNvPr>
                <p:cNvSpPr txBox="1"/>
                <p:nvPr/>
              </p:nvSpPr>
              <p:spPr>
                <a:xfrm>
                  <a:off x="3966499" y="4908115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99148817-CBF1-E448-7AB4-12D1DA330433}"/>
                    </a:ext>
                  </a:extLst>
                </p:cNvPr>
                <p:cNvSpPr txBox="1"/>
                <p:nvPr/>
              </p:nvSpPr>
              <p:spPr>
                <a:xfrm>
                  <a:off x="3966499" y="4736753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</p:txBody>
            </p:sp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403EA154-3CC9-20E0-6AF4-543735297C35}"/>
                    </a:ext>
                  </a:extLst>
                </p:cNvPr>
                <p:cNvSpPr txBox="1"/>
                <p:nvPr/>
              </p:nvSpPr>
              <p:spPr>
                <a:xfrm>
                  <a:off x="3966499" y="4550562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</p:txBody>
            </p:sp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4B91B533-1760-660B-6290-66760706FB63}"/>
                    </a:ext>
                  </a:extLst>
                </p:cNvPr>
                <p:cNvSpPr txBox="1"/>
                <p:nvPr/>
              </p:nvSpPr>
              <p:spPr>
                <a:xfrm>
                  <a:off x="3966499" y="4376211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0</a:t>
                  </a:r>
                </a:p>
              </p:txBody>
            </p:sp>
            <p:sp>
              <p:nvSpPr>
                <p:cNvPr id="125" name="TextBox 124">
                  <a:extLst>
                    <a:ext uri="{FF2B5EF4-FFF2-40B4-BE49-F238E27FC236}">
                      <a16:creationId xmlns:a16="http://schemas.microsoft.com/office/drawing/2014/main" id="{19C41DC1-7351-F6B9-D452-638316CB3C9D}"/>
                    </a:ext>
                  </a:extLst>
                </p:cNvPr>
                <p:cNvSpPr txBox="1"/>
                <p:nvPr/>
              </p:nvSpPr>
              <p:spPr>
                <a:xfrm>
                  <a:off x="3895967" y="4183123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126" name="TextBox 125">
                  <a:extLst>
                    <a:ext uri="{FF2B5EF4-FFF2-40B4-BE49-F238E27FC236}">
                      <a16:creationId xmlns:a16="http://schemas.microsoft.com/office/drawing/2014/main" id="{04D59625-8861-C504-27DD-C3FF29700AF9}"/>
                    </a:ext>
                  </a:extLst>
                </p:cNvPr>
                <p:cNvSpPr txBox="1"/>
                <p:nvPr/>
              </p:nvSpPr>
              <p:spPr>
                <a:xfrm>
                  <a:off x="3895967" y="4017334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0</a:t>
                  </a:r>
                </a:p>
              </p:txBody>
            </p:sp>
            <p:sp>
              <p:nvSpPr>
                <p:cNvPr id="127" name="TextBox 126">
                  <a:extLst>
                    <a:ext uri="{FF2B5EF4-FFF2-40B4-BE49-F238E27FC236}">
                      <a16:creationId xmlns:a16="http://schemas.microsoft.com/office/drawing/2014/main" id="{C6A46D74-E27A-E48A-DC10-3599C1319171}"/>
                    </a:ext>
                  </a:extLst>
                </p:cNvPr>
                <p:cNvSpPr txBox="1"/>
                <p:nvPr/>
              </p:nvSpPr>
              <p:spPr>
                <a:xfrm>
                  <a:off x="3895967" y="3836716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0</a:t>
                  </a:r>
                </a:p>
              </p:txBody>
            </p:sp>
            <p:sp>
              <p:nvSpPr>
                <p:cNvPr id="128" name="TextBox 127">
                  <a:extLst>
                    <a:ext uri="{FF2B5EF4-FFF2-40B4-BE49-F238E27FC236}">
                      <a16:creationId xmlns:a16="http://schemas.microsoft.com/office/drawing/2014/main" id="{4608DCF4-A180-080D-033F-30AC6CD63B9B}"/>
                    </a:ext>
                  </a:extLst>
                </p:cNvPr>
                <p:cNvSpPr txBox="1"/>
                <p:nvPr/>
              </p:nvSpPr>
              <p:spPr>
                <a:xfrm>
                  <a:off x="4136733" y="5262689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</p:grpSp>
        </p:grpSp>
        <p:sp>
          <p:nvSpPr>
            <p:cNvPr id="110" name="Oval 109">
              <a:extLst>
                <a:ext uri="{FF2B5EF4-FFF2-40B4-BE49-F238E27FC236}">
                  <a16:creationId xmlns:a16="http://schemas.microsoft.com/office/drawing/2014/main" id="{0A33AAAF-3B64-E409-5C7D-A1B8C30F69BC}"/>
                </a:ext>
              </a:extLst>
            </p:cNvPr>
            <p:cNvSpPr/>
            <p:nvPr/>
          </p:nvSpPr>
          <p:spPr>
            <a:xfrm>
              <a:off x="4814118" y="299931"/>
              <a:ext cx="45719" cy="46800"/>
            </a:xfrm>
            <a:prstGeom prst="ellipse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L" dirty="0"/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C769D494-CAE7-DF9B-354B-86FAEC87BBDD}"/>
                </a:ext>
              </a:extLst>
            </p:cNvPr>
            <p:cNvSpPr txBox="1"/>
            <p:nvPr/>
          </p:nvSpPr>
          <p:spPr>
            <a:xfrm>
              <a:off x="4906634" y="199680"/>
              <a:ext cx="9348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known length</a:t>
              </a:r>
            </a:p>
          </p:txBody>
        </p:sp>
        <p:sp>
          <p:nvSpPr>
            <p:cNvPr id="112" name="Oval 111">
              <a:extLst>
                <a:ext uri="{FF2B5EF4-FFF2-40B4-BE49-F238E27FC236}">
                  <a16:creationId xmlns:a16="http://schemas.microsoft.com/office/drawing/2014/main" id="{57E11962-BFD5-BB2F-9268-069864E3CB76}"/>
                </a:ext>
              </a:extLst>
            </p:cNvPr>
            <p:cNvSpPr/>
            <p:nvPr/>
          </p:nvSpPr>
          <p:spPr>
            <a:xfrm>
              <a:off x="4814118" y="445841"/>
              <a:ext cx="45719" cy="45719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L"/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35600AF2-0CD4-50BE-EE07-42A83835C5CD}"/>
                </a:ext>
              </a:extLst>
            </p:cNvPr>
            <p:cNvSpPr txBox="1"/>
            <p:nvPr/>
          </p:nvSpPr>
          <p:spPr>
            <a:xfrm>
              <a:off x="4906633" y="345589"/>
              <a:ext cx="10759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L" sz="1000" dirty="0">
                  <a:latin typeface="Arial" panose="020B0604020202020204" pitchFamily="34" charset="0"/>
                  <a:cs typeface="Arial" panose="020B0604020202020204" pitchFamily="34" charset="0"/>
                </a:rPr>
                <a:t>unknown length</a:t>
              </a:r>
            </a:p>
          </p:txBody>
        </p:sp>
      </p:grpSp>
      <p:grpSp>
        <p:nvGrpSpPr>
          <p:cNvPr id="136" name="Group 135">
            <a:extLst>
              <a:ext uri="{FF2B5EF4-FFF2-40B4-BE49-F238E27FC236}">
                <a16:creationId xmlns:a16="http://schemas.microsoft.com/office/drawing/2014/main" id="{FE3A3AD8-CD7F-2E68-EF1B-F2F8A02996BC}"/>
              </a:ext>
            </a:extLst>
          </p:cNvPr>
          <p:cNvGrpSpPr/>
          <p:nvPr/>
        </p:nvGrpSpPr>
        <p:grpSpPr>
          <a:xfrm>
            <a:off x="570776" y="670909"/>
            <a:ext cx="2444080" cy="1955115"/>
            <a:chOff x="3473984" y="330920"/>
            <a:chExt cx="2444080" cy="1955115"/>
          </a:xfrm>
        </p:grpSpPr>
        <p:pic>
          <p:nvPicPr>
            <p:cNvPr id="137" name="Picture 136">
              <a:extLst>
                <a:ext uri="{FF2B5EF4-FFF2-40B4-BE49-F238E27FC236}">
                  <a16:creationId xmlns:a16="http://schemas.microsoft.com/office/drawing/2014/main" id="{C771407E-B30D-74FB-ADCD-2F607F236EC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58873" y="409154"/>
              <a:ext cx="2059191" cy="1564143"/>
            </a:xfrm>
            <a:prstGeom prst="rect">
              <a:avLst/>
            </a:prstGeom>
          </p:spPr>
        </p:pic>
        <p:grpSp>
          <p:nvGrpSpPr>
            <p:cNvPr id="138" name="Group 137">
              <a:extLst>
                <a:ext uri="{FF2B5EF4-FFF2-40B4-BE49-F238E27FC236}">
                  <a16:creationId xmlns:a16="http://schemas.microsoft.com/office/drawing/2014/main" id="{CF2D9D61-80BF-DD6B-6C6B-9F6708647737}"/>
                </a:ext>
              </a:extLst>
            </p:cNvPr>
            <p:cNvGrpSpPr/>
            <p:nvPr/>
          </p:nvGrpSpPr>
          <p:grpSpPr>
            <a:xfrm>
              <a:off x="3473984" y="330920"/>
              <a:ext cx="2382025" cy="1955115"/>
              <a:chOff x="3393729" y="493589"/>
              <a:chExt cx="2382025" cy="1955115"/>
            </a:xfrm>
          </p:grpSpPr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A44BEFCE-4304-F2FC-8FF4-CB31D174501C}"/>
                  </a:ext>
                </a:extLst>
              </p:cNvPr>
              <p:cNvSpPr txBox="1"/>
              <p:nvPr/>
            </p:nvSpPr>
            <p:spPr>
              <a:xfrm rot="16200000">
                <a:off x="3102303" y="1224369"/>
                <a:ext cx="82907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unt (a.u.)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43EAC9C1-69EC-7F93-A3DF-99375907DE32}"/>
                  </a:ext>
                </a:extLst>
              </p:cNvPr>
              <p:cNvSpPr txBox="1"/>
              <p:nvPr/>
            </p:nvSpPr>
            <p:spPr>
              <a:xfrm>
                <a:off x="4650858" y="2202483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s)</a:t>
                </a: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80C1025C-6FB7-CAA5-CA9E-4E956F129FB3}"/>
                  </a:ext>
                </a:extLst>
              </p:cNvPr>
              <p:cNvSpPr txBox="1"/>
              <p:nvPr/>
            </p:nvSpPr>
            <p:spPr>
              <a:xfrm>
                <a:off x="5128061" y="679470"/>
                <a:ext cx="43152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ata</a:t>
                </a:r>
              </a:p>
            </p:txBody>
          </p: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86C7C646-5C1F-2CB4-FEEB-0880F3210414}"/>
                  </a:ext>
                </a:extLst>
              </p:cNvPr>
              <p:cNvSpPr txBox="1"/>
              <p:nvPr/>
            </p:nvSpPr>
            <p:spPr>
              <a:xfrm>
                <a:off x="5128060" y="834071"/>
                <a:ext cx="2840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it</a:t>
                </a:r>
              </a:p>
            </p:txBody>
          </p:sp>
          <p:cxnSp>
            <p:nvCxnSpPr>
              <p:cNvPr id="143" name="Straight Connector 142">
                <a:extLst>
                  <a:ext uri="{FF2B5EF4-FFF2-40B4-BE49-F238E27FC236}">
                    <a16:creationId xmlns:a16="http://schemas.microsoft.com/office/drawing/2014/main" id="{A4850183-0AC6-EDB6-FF35-ED9B908148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41938" y="810159"/>
                <a:ext cx="110394" cy="0"/>
              </a:xfrm>
              <a:prstGeom prst="line">
                <a:avLst/>
              </a:prstGeom>
              <a:ln w="31750">
                <a:solidFill>
                  <a:srgbClr val="F18080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44" name="Straight Connector 143">
                <a:extLst>
                  <a:ext uri="{FF2B5EF4-FFF2-40B4-BE49-F238E27FC236}">
                    <a16:creationId xmlns:a16="http://schemas.microsoft.com/office/drawing/2014/main" id="{B948EF85-C919-FDD1-DB4A-F06050D2EA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41938" y="959507"/>
                <a:ext cx="110394" cy="0"/>
              </a:xfrm>
              <a:prstGeom prst="line">
                <a:avLst/>
              </a:prstGeom>
              <a:ln>
                <a:solidFill>
                  <a:srgbClr val="00B0F0"/>
                </a:solidFill>
              </a:ln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5" name="Rectangle 144">
                <a:extLst>
                  <a:ext uri="{FF2B5EF4-FFF2-40B4-BE49-F238E27FC236}">
                    <a16:creationId xmlns:a16="http://schemas.microsoft.com/office/drawing/2014/main" id="{27B4B3C5-1F92-A97F-56D5-219EBD969718}"/>
                  </a:ext>
                </a:extLst>
              </p:cNvPr>
              <p:cNvSpPr/>
              <p:nvPr/>
            </p:nvSpPr>
            <p:spPr>
              <a:xfrm rot="5400000">
                <a:off x="4720457" y="1169746"/>
                <a:ext cx="168477" cy="189838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L"/>
              </a:p>
            </p:txBody>
          </p:sp>
          <p:sp>
            <p:nvSpPr>
              <p:cNvPr id="146" name="Rectangle 145">
                <a:extLst>
                  <a:ext uri="{FF2B5EF4-FFF2-40B4-BE49-F238E27FC236}">
                    <a16:creationId xmlns:a16="http://schemas.microsoft.com/office/drawing/2014/main" id="{096713DD-0B99-5880-D3AE-B4FE01ABB5E2}"/>
                  </a:ext>
                </a:extLst>
              </p:cNvPr>
              <p:cNvSpPr/>
              <p:nvPr/>
            </p:nvSpPr>
            <p:spPr>
              <a:xfrm>
                <a:off x="3720598" y="493589"/>
                <a:ext cx="168477" cy="158071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NL"/>
              </a:p>
            </p:txBody>
          </p:sp>
          <p:grpSp>
            <p:nvGrpSpPr>
              <p:cNvPr id="147" name="Group 146">
                <a:extLst>
                  <a:ext uri="{FF2B5EF4-FFF2-40B4-BE49-F238E27FC236}">
                    <a16:creationId xmlns:a16="http://schemas.microsoft.com/office/drawing/2014/main" id="{51B69215-A93C-86AA-F285-4189C09CF088}"/>
                  </a:ext>
                </a:extLst>
              </p:cNvPr>
              <p:cNvGrpSpPr/>
              <p:nvPr/>
            </p:nvGrpSpPr>
            <p:grpSpPr>
              <a:xfrm>
                <a:off x="3886756" y="2005121"/>
                <a:ext cx="1888998" cy="260397"/>
                <a:chOff x="3647379" y="2763725"/>
                <a:chExt cx="1888998" cy="260397"/>
              </a:xfrm>
            </p:grpSpPr>
            <p:sp>
              <p:nvSpPr>
                <p:cNvPr id="152" name="TextBox 151">
                  <a:extLst>
                    <a:ext uri="{FF2B5EF4-FFF2-40B4-BE49-F238E27FC236}">
                      <a16:creationId xmlns:a16="http://schemas.microsoft.com/office/drawing/2014/main" id="{A38C4116-EA93-0501-6406-83DB1A960102}"/>
                    </a:ext>
                  </a:extLst>
                </p:cNvPr>
                <p:cNvSpPr txBox="1"/>
                <p:nvPr/>
              </p:nvSpPr>
              <p:spPr>
                <a:xfrm>
                  <a:off x="3981555" y="2763725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</a:p>
              </p:txBody>
            </p:sp>
            <p:sp>
              <p:nvSpPr>
                <p:cNvPr id="153" name="TextBox 152">
                  <a:extLst>
                    <a:ext uri="{FF2B5EF4-FFF2-40B4-BE49-F238E27FC236}">
                      <a16:creationId xmlns:a16="http://schemas.microsoft.com/office/drawing/2014/main" id="{BEE3E6D8-6169-05B9-F0DA-2609424AEA17}"/>
                    </a:ext>
                  </a:extLst>
                </p:cNvPr>
                <p:cNvSpPr txBox="1"/>
                <p:nvPr/>
              </p:nvSpPr>
              <p:spPr>
                <a:xfrm>
                  <a:off x="4367473" y="2763725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0</a:t>
                  </a:r>
                </a:p>
              </p:txBody>
            </p:sp>
            <p:sp>
              <p:nvSpPr>
                <p:cNvPr id="154" name="TextBox 153">
                  <a:extLst>
                    <a:ext uri="{FF2B5EF4-FFF2-40B4-BE49-F238E27FC236}">
                      <a16:creationId xmlns:a16="http://schemas.microsoft.com/office/drawing/2014/main" id="{F6B95231-1FA1-A1D1-D0E4-52D2A9121817}"/>
                    </a:ext>
                  </a:extLst>
                </p:cNvPr>
                <p:cNvSpPr txBox="1"/>
                <p:nvPr/>
              </p:nvSpPr>
              <p:spPr>
                <a:xfrm>
                  <a:off x="4763951" y="2777901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0</a:t>
                  </a:r>
                </a:p>
              </p:txBody>
            </p:sp>
            <p:sp>
              <p:nvSpPr>
                <p:cNvPr id="155" name="TextBox 154">
                  <a:extLst>
                    <a:ext uri="{FF2B5EF4-FFF2-40B4-BE49-F238E27FC236}">
                      <a16:creationId xmlns:a16="http://schemas.microsoft.com/office/drawing/2014/main" id="{1CDFE9AA-301F-A5D9-C72F-B4F3AC697E46}"/>
                    </a:ext>
                  </a:extLst>
                </p:cNvPr>
                <p:cNvSpPr txBox="1"/>
                <p:nvPr/>
              </p:nvSpPr>
              <p:spPr>
                <a:xfrm>
                  <a:off x="5140115" y="2773570"/>
                  <a:ext cx="396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00</a:t>
                  </a:r>
                </a:p>
              </p:txBody>
            </p:sp>
            <p:sp>
              <p:nvSpPr>
                <p:cNvPr id="156" name="TextBox 155">
                  <a:extLst>
                    <a:ext uri="{FF2B5EF4-FFF2-40B4-BE49-F238E27FC236}">
                      <a16:creationId xmlns:a16="http://schemas.microsoft.com/office/drawing/2014/main" id="{4E831B51-4B18-ADCB-C9DE-9F018819F3B4}"/>
                    </a:ext>
                  </a:extLst>
                </p:cNvPr>
                <p:cNvSpPr txBox="1"/>
                <p:nvPr/>
              </p:nvSpPr>
              <p:spPr>
                <a:xfrm>
                  <a:off x="3647379" y="2769204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NL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</p:grp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C5773A15-C5F0-D819-0579-AED34A65CCF1}"/>
                  </a:ext>
                </a:extLst>
              </p:cNvPr>
              <p:cNvSpPr txBox="1"/>
              <p:nvPr/>
            </p:nvSpPr>
            <p:spPr>
              <a:xfrm>
                <a:off x="3695326" y="187610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879E807B-1D82-0522-5954-799AFA320529}"/>
                  </a:ext>
                </a:extLst>
              </p:cNvPr>
              <p:cNvSpPr txBox="1"/>
              <p:nvPr/>
            </p:nvSpPr>
            <p:spPr>
              <a:xfrm>
                <a:off x="3624794" y="149953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4913B31C-6F76-7F93-1D0B-78D60E4B5C5E}"/>
                  </a:ext>
                </a:extLst>
              </p:cNvPr>
              <p:cNvSpPr txBox="1"/>
              <p:nvPr/>
            </p:nvSpPr>
            <p:spPr>
              <a:xfrm>
                <a:off x="3624794" y="1108914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6F3AA8DC-86EC-D919-367A-E6BD3463C7D7}"/>
                  </a:ext>
                </a:extLst>
              </p:cNvPr>
              <p:cNvSpPr txBox="1"/>
              <p:nvPr/>
            </p:nvSpPr>
            <p:spPr>
              <a:xfrm>
                <a:off x="3624794" y="741122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L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504873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 2013 - 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203</TotalTime>
  <Words>143</Words>
  <Application>Microsoft Macintosh PowerPoint</Application>
  <PresentationFormat>A4 Paper (210x297 mm)</PresentationFormat>
  <Paragraphs>73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ladimir Volkov</dc:creator>
  <cp:lastModifiedBy>Reza Amini Hounejani</cp:lastModifiedBy>
  <cp:revision>5</cp:revision>
  <cp:lastPrinted>2022-11-14T16:29:18Z</cp:lastPrinted>
  <dcterms:created xsi:type="dcterms:W3CDTF">2022-06-23T13:28:10Z</dcterms:created>
  <dcterms:modified xsi:type="dcterms:W3CDTF">2023-08-02T15:28:28Z</dcterms:modified>
</cp:coreProperties>
</file>